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tags/tag1.xml" ContentType="application/vnd.openxmlformats-officedocument.presentationml.tags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2"/>
  </p:notesMasterIdLst>
  <p:sldIdLst>
    <p:sldId id="803" r:id="rId2"/>
    <p:sldId id="814" r:id="rId3"/>
    <p:sldId id="822" r:id="rId4"/>
    <p:sldId id="823" r:id="rId5"/>
    <p:sldId id="818" r:id="rId6"/>
    <p:sldId id="780" r:id="rId7"/>
    <p:sldId id="817" r:id="rId8"/>
    <p:sldId id="805" r:id="rId9"/>
    <p:sldId id="815" r:id="rId10"/>
    <p:sldId id="816" r:id="rId11"/>
  </p:sldIdLst>
  <p:sldSz cx="6840538" cy="8891588"/>
  <p:notesSz cx="6797675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figure" id="{FECDE5EF-E283-4D6B-99F7-6BC1549E1ABE}">
          <p14:sldIdLst>
            <p14:sldId id="803"/>
            <p14:sldId id="814"/>
            <p14:sldId id="822"/>
            <p14:sldId id="823"/>
            <p14:sldId id="818"/>
            <p14:sldId id="780"/>
            <p14:sldId id="817"/>
          </p14:sldIdLst>
        </p14:section>
        <p14:section name="supplementary" id="{F8CB0F4D-3650-466E-B935-74F1A39ED2BC}">
          <p14:sldIdLst>
            <p14:sldId id="805"/>
            <p14:sldId id="815"/>
            <p14:sldId id="81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BE7A"/>
    <a:srgbClr val="36AB9C"/>
    <a:srgbClr val="FA7F6F"/>
    <a:srgbClr val="ADDEAD"/>
    <a:srgbClr val="8ECFC9"/>
    <a:srgbClr val="999999"/>
    <a:srgbClr val="F2F2F2"/>
    <a:srgbClr val="E7DAD2"/>
    <a:srgbClr val="82B0D2"/>
    <a:srgbClr val="BEB8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2054" autoAdjust="0"/>
  </p:normalViewPr>
  <p:slideViewPr>
    <p:cSldViewPr snapToGrid="0">
      <p:cViewPr varScale="1">
        <p:scale>
          <a:sx n="79" d="100"/>
          <a:sy n="79" d="100"/>
        </p:scale>
        <p:origin x="315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F56473-C3BC-4E22-9DA5-BE42F4E1DE2D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1241425"/>
            <a:ext cx="25781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8722"/>
            <a:ext cx="543814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D0DA29-33A6-41B9-A326-1B37C65832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24309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cs typeface="+mn-ea"/>
                <a:sym typeface="+mn-lt"/>
              </a:rPr>
              <a:t>Figure S1. Gene editing efficiency of single AAV-mediated Nme</a:t>
            </a:r>
            <a:r>
              <a:rPr lang="en-US" altLang="zh-CN" sz="1200" baseline="-25000" dirty="0">
                <a:cs typeface="+mn-ea"/>
                <a:sym typeface="+mn-lt"/>
              </a:rPr>
              <a:t>2</a:t>
            </a:r>
            <a:r>
              <a:rPr lang="en-US" altLang="zh-CN" sz="1200" dirty="0">
                <a:cs typeface="+mn-ea"/>
                <a:sym typeface="+mn-lt"/>
              </a:rPr>
              <a:t>Cas9 targeting </a:t>
            </a:r>
            <a:r>
              <a:rPr lang="en-US" altLang="zh-CN" sz="1200" i="1" dirty="0">
                <a:cs typeface="+mn-ea"/>
                <a:sym typeface="+mn-lt"/>
              </a:rPr>
              <a:t>Vegfr2</a:t>
            </a:r>
            <a:r>
              <a:rPr lang="en-US" altLang="zh-CN" sz="1200" dirty="0">
                <a:cs typeface="+mn-ea"/>
                <a:sym typeface="+mn-lt"/>
              </a:rPr>
              <a:t>-g3 post 15 days. </a:t>
            </a:r>
            <a:endParaRPr lang="zh-CN" altLang="en-US" sz="1200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DA29-33A6-41B9-A326-1B37C658323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71803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dirty="0">
                <a:cs typeface="+mn-ea"/>
                <a:sym typeface="+mn-lt"/>
              </a:rPr>
              <a:t>Figure S2. CNV progress after laser treatment. </a:t>
            </a:r>
            <a:endParaRPr lang="zh-CN" altLang="en-US" sz="1800" dirty="0"/>
          </a:p>
          <a:p>
            <a:pPr algn="just">
              <a:lnSpc>
                <a:spcPct val="200000"/>
              </a:lnSpc>
            </a:pP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D0DA29-33A6-41B9-A326-1B37C658323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43301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09788" y="1241425"/>
            <a:ext cx="2578100" cy="3351213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/>
              <a:t>Figure S3. Safety assessment of single AAV-mediated Nme</a:t>
            </a:r>
            <a:r>
              <a:rPr lang="en-US" altLang="zh-CN" sz="1200" baseline="-25000" dirty="0"/>
              <a:t>2</a:t>
            </a:r>
            <a:r>
              <a:rPr lang="en-US" altLang="zh-CN" sz="1200" dirty="0"/>
              <a:t>Cas9 targeting </a:t>
            </a:r>
            <a:r>
              <a:rPr lang="en-US" altLang="zh-CN" sz="1200" i="1" dirty="0"/>
              <a:t>Hif1</a:t>
            </a:r>
            <a:r>
              <a:rPr lang="el-GR" altLang="zh-CN" sz="1200" i="1" dirty="0"/>
              <a:t>α</a:t>
            </a:r>
            <a:r>
              <a:rPr lang="en-US" altLang="zh-CN" sz="1200" dirty="0"/>
              <a:t> and </a:t>
            </a:r>
            <a:r>
              <a:rPr lang="en-US" altLang="zh-CN" sz="1200" i="1" dirty="0"/>
              <a:t>Vegfr2 in vivo</a:t>
            </a:r>
            <a:r>
              <a:rPr lang="en-US" altLang="zh-CN" sz="1200" dirty="0"/>
              <a:t>.</a:t>
            </a:r>
            <a:endParaRPr lang="zh-CN" altLang="en-US" sz="1200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B5B12B-903E-4727-B969-6387A9BC3592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94430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55175"/>
            <a:ext cx="5814457" cy="3095590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670142"/>
            <a:ext cx="5130404" cy="2146742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3170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063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73395"/>
            <a:ext cx="1474991" cy="753521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73395"/>
            <a:ext cx="4339466" cy="753521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1084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0049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216725"/>
            <a:ext cx="5899964" cy="3698653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950369"/>
            <a:ext cx="5899964" cy="1945034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3404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366974"/>
            <a:ext cx="2907229" cy="564163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366974"/>
            <a:ext cx="2907229" cy="564163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858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73397"/>
            <a:ext cx="5899964" cy="171862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179675"/>
            <a:ext cx="2893868" cy="1068225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247899"/>
            <a:ext cx="2893868" cy="477717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179675"/>
            <a:ext cx="2908120" cy="1068225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247899"/>
            <a:ext cx="2908120" cy="477717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8117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3724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6234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92772"/>
            <a:ext cx="2206252" cy="2074704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280226"/>
            <a:ext cx="3463022" cy="6318791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667476"/>
            <a:ext cx="2206252" cy="4941830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96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92772"/>
            <a:ext cx="2206252" cy="2074704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280226"/>
            <a:ext cx="3463022" cy="6318791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667476"/>
            <a:ext cx="2206252" cy="4941830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934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73397"/>
            <a:ext cx="5899964" cy="17186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366974"/>
            <a:ext cx="5899964" cy="56416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241187"/>
            <a:ext cx="1539121" cy="4733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84CC84-7F2E-47CE-88FD-4D02C52DCC9F}" type="datetimeFigureOut">
              <a:rPr lang="zh-CN" altLang="en-US" smtClean="0"/>
              <a:t>2023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241187"/>
            <a:ext cx="2308682" cy="4733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241187"/>
            <a:ext cx="1539121" cy="4733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7F9A5D-41B4-4355-AB45-AAC68A3D7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7300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"/><Relationship Id="rId3" Type="http://schemas.openxmlformats.org/officeDocument/2006/relationships/image" Target="../media/image4.png"/><Relationship Id="rId7" Type="http://schemas.openxmlformats.org/officeDocument/2006/relationships/image" Target="../media/image8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"/><Relationship Id="rId5" Type="http://schemas.openxmlformats.org/officeDocument/2006/relationships/image" Target="../media/image6.tif"/><Relationship Id="rId10" Type="http://schemas.openxmlformats.org/officeDocument/2006/relationships/image" Target="../media/image11.tif"/><Relationship Id="rId4" Type="http://schemas.openxmlformats.org/officeDocument/2006/relationships/image" Target="../media/image5.tif"/><Relationship Id="rId9" Type="http://schemas.openxmlformats.org/officeDocument/2006/relationships/image" Target="../media/image10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"/><Relationship Id="rId5" Type="http://schemas.openxmlformats.org/officeDocument/2006/relationships/image" Target="../media/image15.tif"/><Relationship Id="rId4" Type="http://schemas.openxmlformats.org/officeDocument/2006/relationships/image" Target="../media/image14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tif"/><Relationship Id="rId4" Type="http://schemas.openxmlformats.org/officeDocument/2006/relationships/image" Target="../media/image19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tif"/><Relationship Id="rId5" Type="http://schemas.openxmlformats.org/officeDocument/2006/relationships/image" Target="../media/image24.tif"/><Relationship Id="rId4" Type="http://schemas.openxmlformats.org/officeDocument/2006/relationships/image" Target="../media/image23.ti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tif"/><Relationship Id="rId13" Type="http://schemas.openxmlformats.org/officeDocument/2006/relationships/image" Target="../media/image35.ti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29.tif"/><Relationship Id="rId12" Type="http://schemas.openxmlformats.org/officeDocument/2006/relationships/image" Target="../media/image34.tif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6" Type="http://schemas.openxmlformats.org/officeDocument/2006/relationships/image" Target="../media/image28.tif"/><Relationship Id="rId11" Type="http://schemas.openxmlformats.org/officeDocument/2006/relationships/image" Target="../media/image33.tif"/><Relationship Id="rId5" Type="http://schemas.openxmlformats.org/officeDocument/2006/relationships/image" Target="../media/image27.png"/><Relationship Id="rId10" Type="http://schemas.openxmlformats.org/officeDocument/2006/relationships/image" Target="../media/image32.tif"/><Relationship Id="rId4" Type="http://schemas.openxmlformats.org/officeDocument/2006/relationships/image" Target="../media/image26.png"/><Relationship Id="rId9" Type="http://schemas.openxmlformats.org/officeDocument/2006/relationships/image" Target="../media/image31.ti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>
            <a:extLst>
              <a:ext uri="{FF2B5EF4-FFF2-40B4-BE49-F238E27FC236}">
                <a16:creationId xmlns:a16="http://schemas.microsoft.com/office/drawing/2014/main" id="{8D40A087-8EDB-E136-3575-2E333979492E}"/>
              </a:ext>
            </a:extLst>
          </p:cNvPr>
          <p:cNvSpPr txBox="1"/>
          <p:nvPr/>
        </p:nvSpPr>
        <p:spPr>
          <a:xfrm>
            <a:off x="449769" y="175029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B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DFB34B8-C3E3-88A9-1C95-8EF12CC9086C}"/>
              </a:ext>
            </a:extLst>
          </p:cNvPr>
          <p:cNvSpPr txBox="1"/>
          <p:nvPr/>
        </p:nvSpPr>
        <p:spPr>
          <a:xfrm>
            <a:off x="2021987" y="174749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C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49CA9EF-2B04-FCE9-4A9B-DEBD9CE52243}"/>
              </a:ext>
            </a:extLst>
          </p:cNvPr>
          <p:cNvSpPr txBox="1"/>
          <p:nvPr/>
        </p:nvSpPr>
        <p:spPr>
          <a:xfrm>
            <a:off x="449769" y="52706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A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86ED6A97-63A3-5E64-BA54-FDC592A75ED2}"/>
              </a:ext>
            </a:extLst>
          </p:cNvPr>
          <p:cNvSpPr txBox="1"/>
          <p:nvPr/>
        </p:nvSpPr>
        <p:spPr>
          <a:xfrm>
            <a:off x="3451348" y="174749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D</a:t>
            </a:r>
            <a:endParaRPr lang="zh-CN" altLang="en-US" sz="1600" b="1" dirty="0">
              <a:cs typeface="+mn-ea"/>
              <a:sym typeface="+mn-lt"/>
            </a:endParaRPr>
          </a:p>
        </p:txBody>
      </p:sp>
      <p:pic>
        <p:nvPicPr>
          <p:cNvPr id="220" name="图片 219">
            <a:extLst>
              <a:ext uri="{FF2B5EF4-FFF2-40B4-BE49-F238E27FC236}">
                <a16:creationId xmlns:a16="http://schemas.microsoft.com/office/drawing/2014/main" id="{E86C3373-E7E9-E9CD-C8E6-25BA2EFB66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0560" y="2004376"/>
            <a:ext cx="2669113" cy="1031248"/>
          </a:xfrm>
          <a:prstGeom prst="rect">
            <a:avLst/>
          </a:prstGeom>
        </p:spPr>
      </p:pic>
      <p:grpSp>
        <p:nvGrpSpPr>
          <p:cNvPr id="13" name="组合 12">
            <a:extLst>
              <a:ext uri="{FF2B5EF4-FFF2-40B4-BE49-F238E27FC236}">
                <a16:creationId xmlns:a16="http://schemas.microsoft.com/office/drawing/2014/main" id="{B18C7F67-719B-7A46-BC1B-28F281FC51FC}"/>
              </a:ext>
            </a:extLst>
          </p:cNvPr>
          <p:cNvGrpSpPr/>
          <p:nvPr/>
        </p:nvGrpSpPr>
        <p:grpSpPr>
          <a:xfrm>
            <a:off x="771335" y="637968"/>
            <a:ext cx="4301755" cy="1149687"/>
            <a:chOff x="848147" y="1320139"/>
            <a:chExt cx="4301755" cy="1149687"/>
          </a:xfrm>
        </p:grpSpPr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ECEB746D-1F6C-D0F3-595A-F778CC10D826}"/>
                </a:ext>
              </a:extLst>
            </p:cNvPr>
            <p:cNvSpPr txBox="1"/>
            <p:nvPr/>
          </p:nvSpPr>
          <p:spPr>
            <a:xfrm>
              <a:off x="2170044" y="1996697"/>
              <a:ext cx="827409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dirty="0">
                  <a:cs typeface="+mn-ea"/>
                  <a:sym typeface="+mn-lt"/>
                </a:rPr>
                <a:t>RPECs</a:t>
              </a:r>
              <a:r>
                <a:rPr lang="zh-CN" altLang="en-US" sz="1200" dirty="0">
                  <a:cs typeface="+mn-ea"/>
                  <a:sym typeface="+mn-lt"/>
                </a:rPr>
                <a:t> </a:t>
              </a:r>
              <a:endParaRPr lang="en-US" altLang="zh-CN" sz="1200" dirty="0">
                <a:cs typeface="+mn-ea"/>
                <a:sym typeface="+mn-lt"/>
              </a:endParaRPr>
            </a:p>
            <a:p>
              <a:pPr algn="ctr"/>
              <a:r>
                <a:rPr lang="en-US" altLang="zh-CN" sz="1200" dirty="0">
                  <a:cs typeface="+mn-ea"/>
                  <a:sym typeface="+mn-lt"/>
                </a:rPr>
                <a:t>isolation</a:t>
              </a: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EE301F1E-18F6-5FAA-C0CA-2243E3FAED19}"/>
                </a:ext>
              </a:extLst>
            </p:cNvPr>
            <p:cNvSpPr txBox="1"/>
            <p:nvPr/>
          </p:nvSpPr>
          <p:spPr>
            <a:xfrm>
              <a:off x="1103099" y="1320139"/>
              <a:ext cx="262904" cy="2053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cs typeface="+mn-ea"/>
                  <a:sym typeface="+mn-lt"/>
                </a:rPr>
                <a:t>d0</a:t>
              </a:r>
              <a:endParaRPr lang="zh-CN" altLang="en-US" sz="1200" dirty="0">
                <a:cs typeface="+mn-ea"/>
                <a:sym typeface="+mn-lt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6A8E4A48-6E01-B72C-06E5-68DEAC87B1A2}"/>
                </a:ext>
              </a:extLst>
            </p:cNvPr>
            <p:cNvSpPr txBox="1"/>
            <p:nvPr/>
          </p:nvSpPr>
          <p:spPr>
            <a:xfrm>
              <a:off x="2310527" y="132677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cs typeface="+mn-ea"/>
                  <a:sym typeface="+mn-lt"/>
                </a:rPr>
                <a:t>d15</a:t>
              </a:r>
              <a:endParaRPr lang="zh-CN" altLang="en-US" sz="1200" dirty="0">
                <a:cs typeface="+mn-ea"/>
                <a:sym typeface="+mn-lt"/>
              </a:endParaRPr>
            </a:p>
          </p:txBody>
        </p:sp>
        <p:sp>
          <p:nvSpPr>
            <p:cNvPr id="118" name="矩形 117">
              <a:extLst>
                <a:ext uri="{FF2B5EF4-FFF2-40B4-BE49-F238E27FC236}">
                  <a16:creationId xmlns:a16="http://schemas.microsoft.com/office/drawing/2014/main" id="{EF74814F-9026-5283-26EB-B5D06C0A16F7}"/>
                </a:ext>
              </a:extLst>
            </p:cNvPr>
            <p:cNvSpPr/>
            <p:nvPr/>
          </p:nvSpPr>
          <p:spPr>
            <a:xfrm>
              <a:off x="848147" y="2004285"/>
              <a:ext cx="917239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200" dirty="0">
                  <a:cs typeface="+mn-ea"/>
                  <a:sym typeface="+mn-lt"/>
                </a:rPr>
                <a:t>Subretinal </a:t>
              </a:r>
            </a:p>
            <a:p>
              <a:pPr algn="ctr"/>
              <a:r>
                <a:rPr lang="en-US" altLang="zh-CN" sz="1200" dirty="0">
                  <a:cs typeface="+mn-ea"/>
                  <a:sym typeface="+mn-lt"/>
                </a:rPr>
                <a:t>injection</a:t>
              </a:r>
              <a:endParaRPr lang="zh-CN" altLang="en-US" sz="1200" dirty="0">
                <a:cs typeface="+mn-ea"/>
                <a:sym typeface="+mn-lt"/>
              </a:endParaRPr>
            </a:p>
          </p:txBody>
        </p:sp>
        <p:grpSp>
          <p:nvGrpSpPr>
            <p:cNvPr id="119" name="组合 118">
              <a:extLst>
                <a:ext uri="{FF2B5EF4-FFF2-40B4-BE49-F238E27FC236}">
                  <a16:creationId xmlns:a16="http://schemas.microsoft.com/office/drawing/2014/main" id="{49205594-F4C7-1D2B-4331-F173088E3A9E}"/>
                </a:ext>
              </a:extLst>
            </p:cNvPr>
            <p:cNvGrpSpPr/>
            <p:nvPr/>
          </p:nvGrpSpPr>
          <p:grpSpPr>
            <a:xfrm>
              <a:off x="1648890" y="1558382"/>
              <a:ext cx="107121" cy="116713"/>
              <a:chOff x="-1207022" y="2342961"/>
              <a:chExt cx="1476700" cy="1608927"/>
            </a:xfrm>
            <a:solidFill>
              <a:srgbClr val="FFBE7A"/>
            </a:solidFill>
          </p:grpSpPr>
          <p:sp>
            <p:nvSpPr>
              <p:cNvPr id="120" name="shield_348433">
                <a:extLst>
                  <a:ext uri="{FF2B5EF4-FFF2-40B4-BE49-F238E27FC236}">
                    <a16:creationId xmlns:a16="http://schemas.microsoft.com/office/drawing/2014/main" id="{5A00F1CA-14A7-EFAD-E45E-DFBBC6E9E5B2}"/>
                  </a:ext>
                </a:extLst>
              </p:cNvPr>
              <p:cNvSpPr/>
              <p:nvPr/>
            </p:nvSpPr>
            <p:spPr>
              <a:xfrm>
                <a:off x="-1207022" y="2342961"/>
                <a:ext cx="1476700" cy="1608927"/>
              </a:xfrm>
              <a:custGeom>
                <a:avLst/>
                <a:gdLst>
                  <a:gd name="connsiteX0" fmla="*/ 373273 h 605239"/>
                  <a:gd name="connsiteY0" fmla="*/ 373273 h 605239"/>
                  <a:gd name="connsiteX1" fmla="*/ 373273 h 605239"/>
                  <a:gd name="connsiteY1" fmla="*/ 373273 h 605239"/>
                  <a:gd name="connsiteX2" fmla="*/ 373273 h 605239"/>
                  <a:gd name="connsiteY2" fmla="*/ 373273 h 605239"/>
                  <a:gd name="connsiteX3" fmla="*/ 373273 h 605239"/>
                  <a:gd name="connsiteY3" fmla="*/ 373273 h 605239"/>
                  <a:gd name="connsiteX4" fmla="*/ 373273 h 605239"/>
                  <a:gd name="connsiteY4" fmla="*/ 373273 h 605239"/>
                  <a:gd name="connsiteX5" fmla="*/ 373273 h 605239"/>
                  <a:gd name="connsiteY5" fmla="*/ 373273 h 605239"/>
                  <a:gd name="connsiteX6" fmla="*/ 373273 h 605239"/>
                  <a:gd name="connsiteY6" fmla="*/ 373273 h 605239"/>
                  <a:gd name="connsiteX7" fmla="*/ 373273 h 605239"/>
                  <a:gd name="connsiteY7" fmla="*/ 373273 h 605239"/>
                  <a:gd name="connsiteX8" fmla="*/ 373273 h 605239"/>
                  <a:gd name="connsiteY8" fmla="*/ 373273 h 605239"/>
                  <a:gd name="connsiteX9" fmla="*/ 373273 h 605239"/>
                  <a:gd name="connsiteY9" fmla="*/ 373273 h 605239"/>
                  <a:gd name="connsiteX10" fmla="*/ 373273 h 605239"/>
                  <a:gd name="connsiteY10" fmla="*/ 373273 h 605239"/>
                  <a:gd name="connsiteX11" fmla="*/ 373273 h 605239"/>
                  <a:gd name="connsiteY11" fmla="*/ 373273 h 605239"/>
                  <a:gd name="connsiteX12" fmla="*/ 373273 h 605239"/>
                  <a:gd name="connsiteY12" fmla="*/ 373273 h 605239"/>
                  <a:gd name="connsiteX13" fmla="*/ 373273 h 605239"/>
                  <a:gd name="connsiteY13" fmla="*/ 373273 h 605239"/>
                  <a:gd name="connsiteX14" fmla="*/ 373273 h 605239"/>
                  <a:gd name="connsiteY14" fmla="*/ 373273 h 605239"/>
                  <a:gd name="connsiteX15" fmla="*/ 373273 h 605239"/>
                  <a:gd name="connsiteY15" fmla="*/ 373273 h 605239"/>
                  <a:gd name="connsiteX16" fmla="*/ 373273 h 605239"/>
                  <a:gd name="connsiteY16" fmla="*/ 373273 h 605239"/>
                  <a:gd name="connsiteX17" fmla="*/ 373273 h 605239"/>
                  <a:gd name="connsiteY17" fmla="*/ 373273 h 605239"/>
                  <a:gd name="connsiteX18" fmla="*/ 373273 h 605239"/>
                  <a:gd name="connsiteY18" fmla="*/ 373273 h 605239"/>
                  <a:gd name="connsiteX19" fmla="*/ 373273 h 605239"/>
                  <a:gd name="connsiteY19" fmla="*/ 373273 h 605239"/>
                  <a:gd name="connsiteX20" fmla="*/ 373273 h 605239"/>
                  <a:gd name="connsiteY20" fmla="*/ 373273 h 605239"/>
                  <a:gd name="connsiteX21" fmla="*/ 373273 h 605239"/>
                  <a:gd name="connsiteY21" fmla="*/ 373273 h 605239"/>
                  <a:gd name="connsiteX22" fmla="*/ 373273 h 605239"/>
                  <a:gd name="connsiteY22" fmla="*/ 373273 h 605239"/>
                  <a:gd name="connsiteX23" fmla="*/ 373273 h 605239"/>
                  <a:gd name="connsiteY23" fmla="*/ 373273 h 605239"/>
                  <a:gd name="connsiteX24" fmla="*/ 373273 h 605239"/>
                  <a:gd name="connsiteY24" fmla="*/ 373273 h 605239"/>
                  <a:gd name="connsiteX25" fmla="*/ 373273 h 605239"/>
                  <a:gd name="connsiteY25" fmla="*/ 373273 h 605239"/>
                  <a:gd name="connsiteX26" fmla="*/ 373273 h 605239"/>
                  <a:gd name="connsiteY26" fmla="*/ 373273 h 605239"/>
                  <a:gd name="connsiteX27" fmla="*/ 373273 h 605239"/>
                  <a:gd name="connsiteY27" fmla="*/ 373273 h 605239"/>
                  <a:gd name="connsiteX28" fmla="*/ 373273 h 605239"/>
                  <a:gd name="connsiteY28" fmla="*/ 373273 h 605239"/>
                  <a:gd name="connsiteX29" fmla="*/ 373273 h 605239"/>
                  <a:gd name="connsiteY29" fmla="*/ 373273 h 605239"/>
                  <a:gd name="connsiteX30" fmla="*/ 373273 h 605239"/>
                  <a:gd name="connsiteY30" fmla="*/ 373273 h 605239"/>
                  <a:gd name="connsiteX31" fmla="*/ 373273 h 605239"/>
                  <a:gd name="connsiteY31" fmla="*/ 373273 h 605239"/>
                  <a:gd name="connsiteX32" fmla="*/ 373273 h 605239"/>
                  <a:gd name="connsiteY32" fmla="*/ 373273 h 605239"/>
                  <a:gd name="connsiteX33" fmla="*/ 373273 h 605239"/>
                  <a:gd name="connsiteY33" fmla="*/ 373273 h 605239"/>
                  <a:gd name="connsiteX34" fmla="*/ 373273 h 605239"/>
                  <a:gd name="connsiteY34" fmla="*/ 373273 h 605239"/>
                  <a:gd name="connsiteX35" fmla="*/ 373273 h 605239"/>
                  <a:gd name="connsiteY35" fmla="*/ 373273 h 605239"/>
                  <a:gd name="connsiteX36" fmla="*/ 373273 h 605239"/>
                  <a:gd name="connsiteY36" fmla="*/ 373273 h 605239"/>
                  <a:gd name="connsiteX37" fmla="*/ 373273 h 605239"/>
                  <a:gd name="connsiteY37" fmla="*/ 373273 h 605239"/>
                  <a:gd name="connsiteX38" fmla="*/ 373273 h 605239"/>
                  <a:gd name="connsiteY38" fmla="*/ 373273 h 605239"/>
                  <a:gd name="connsiteX39" fmla="*/ 373273 h 605239"/>
                  <a:gd name="connsiteY39" fmla="*/ 373273 h 605239"/>
                  <a:gd name="connsiteX40" fmla="*/ 373273 h 605239"/>
                  <a:gd name="connsiteY40" fmla="*/ 373273 h 605239"/>
                  <a:gd name="connsiteX41" fmla="*/ 373273 h 605239"/>
                  <a:gd name="connsiteY41" fmla="*/ 373273 h 605239"/>
                  <a:gd name="connsiteX42" fmla="*/ 373273 h 605239"/>
                  <a:gd name="connsiteY42" fmla="*/ 373273 h 605239"/>
                  <a:gd name="connsiteX43" fmla="*/ 373273 h 605239"/>
                  <a:gd name="connsiteY43" fmla="*/ 373273 h 605239"/>
                  <a:gd name="connsiteX44" fmla="*/ 373273 h 605239"/>
                  <a:gd name="connsiteY44" fmla="*/ 373273 h 605239"/>
                  <a:gd name="connsiteX45" fmla="*/ 373273 h 605239"/>
                  <a:gd name="connsiteY45" fmla="*/ 373273 h 605239"/>
                  <a:gd name="connsiteX46" fmla="*/ 373273 h 605239"/>
                  <a:gd name="connsiteY46" fmla="*/ 373273 h 605239"/>
                  <a:gd name="connsiteX47" fmla="*/ 373273 h 605239"/>
                  <a:gd name="connsiteY47" fmla="*/ 373273 h 605239"/>
                  <a:gd name="connsiteX48" fmla="*/ 373273 h 605239"/>
                  <a:gd name="connsiteY48" fmla="*/ 373273 h 605239"/>
                  <a:gd name="connsiteX49" fmla="*/ 373273 h 605239"/>
                  <a:gd name="connsiteY49" fmla="*/ 373273 h 605239"/>
                  <a:gd name="connsiteX50" fmla="*/ 373273 h 605239"/>
                  <a:gd name="connsiteY50" fmla="*/ 373273 h 605239"/>
                  <a:gd name="connsiteX51" fmla="*/ 373273 h 605239"/>
                  <a:gd name="connsiteY51" fmla="*/ 373273 h 605239"/>
                  <a:gd name="connsiteX52" fmla="*/ 373273 h 605239"/>
                  <a:gd name="connsiteY52" fmla="*/ 373273 h 605239"/>
                  <a:gd name="connsiteX53" fmla="*/ 373273 h 605239"/>
                  <a:gd name="connsiteY53" fmla="*/ 373273 h 605239"/>
                  <a:gd name="connsiteX54" fmla="*/ 373273 h 605239"/>
                  <a:gd name="connsiteY54" fmla="*/ 373273 h 605239"/>
                  <a:gd name="connsiteX55" fmla="*/ 373273 h 605239"/>
                  <a:gd name="connsiteY55" fmla="*/ 373273 h 605239"/>
                  <a:gd name="connsiteX56" fmla="*/ 373273 h 605239"/>
                  <a:gd name="connsiteY56" fmla="*/ 373273 h 605239"/>
                  <a:gd name="connsiteX57" fmla="*/ 373273 h 605239"/>
                  <a:gd name="connsiteY57" fmla="*/ 373273 h 605239"/>
                  <a:gd name="connsiteX58" fmla="*/ 373273 h 605239"/>
                  <a:gd name="connsiteY58" fmla="*/ 373273 h 605239"/>
                  <a:gd name="connsiteX59" fmla="*/ 373273 h 605239"/>
                  <a:gd name="connsiteY59" fmla="*/ 373273 h 605239"/>
                  <a:gd name="connsiteX60" fmla="*/ 373273 h 605239"/>
                  <a:gd name="connsiteY60" fmla="*/ 373273 h 605239"/>
                  <a:gd name="connsiteX61" fmla="*/ 373273 h 605239"/>
                  <a:gd name="connsiteY61" fmla="*/ 373273 h 605239"/>
                  <a:gd name="connsiteX62" fmla="*/ 373273 h 605239"/>
                  <a:gd name="connsiteY62" fmla="*/ 373273 h 605239"/>
                  <a:gd name="connsiteX63" fmla="*/ 373273 h 605239"/>
                  <a:gd name="connsiteY63" fmla="*/ 373273 h 605239"/>
                  <a:gd name="connsiteX64" fmla="*/ 373273 h 605239"/>
                  <a:gd name="connsiteY64" fmla="*/ 373273 h 605239"/>
                  <a:gd name="connsiteX65" fmla="*/ 373273 h 605239"/>
                  <a:gd name="connsiteY65" fmla="*/ 373273 h 605239"/>
                  <a:gd name="connsiteX66" fmla="*/ 373273 h 605239"/>
                  <a:gd name="connsiteY66" fmla="*/ 373273 h 605239"/>
                  <a:gd name="connsiteX67" fmla="*/ 373273 h 605239"/>
                  <a:gd name="connsiteY67" fmla="*/ 373273 h 605239"/>
                  <a:gd name="connsiteX68" fmla="*/ 373273 h 605239"/>
                  <a:gd name="connsiteY68" fmla="*/ 373273 h 605239"/>
                  <a:gd name="connsiteX69" fmla="*/ 373273 h 605239"/>
                  <a:gd name="connsiteY69" fmla="*/ 373273 h 605239"/>
                  <a:gd name="connsiteX70" fmla="*/ 373273 h 605239"/>
                  <a:gd name="connsiteY70" fmla="*/ 373273 h 605239"/>
                  <a:gd name="connsiteX71" fmla="*/ 373273 h 605239"/>
                  <a:gd name="connsiteY71" fmla="*/ 373273 h 605239"/>
                  <a:gd name="connsiteX72" fmla="*/ 373273 h 605239"/>
                  <a:gd name="connsiteY72" fmla="*/ 373273 h 605239"/>
                  <a:gd name="connsiteX73" fmla="*/ 373273 h 605239"/>
                  <a:gd name="connsiteY73" fmla="*/ 373273 h 605239"/>
                  <a:gd name="connsiteX74" fmla="*/ 373273 h 605239"/>
                  <a:gd name="connsiteY74" fmla="*/ 373273 h 605239"/>
                  <a:gd name="connsiteX75" fmla="*/ 373273 h 605239"/>
                  <a:gd name="connsiteY75" fmla="*/ 373273 h 605239"/>
                  <a:gd name="connsiteX76" fmla="*/ 373273 h 605239"/>
                  <a:gd name="connsiteY76" fmla="*/ 373273 h 605239"/>
                  <a:gd name="connsiteX77" fmla="*/ 373273 h 605239"/>
                  <a:gd name="connsiteY77" fmla="*/ 373273 h 605239"/>
                  <a:gd name="connsiteX78" fmla="*/ 373273 h 605239"/>
                  <a:gd name="connsiteY78" fmla="*/ 373273 h 605239"/>
                  <a:gd name="connsiteX79" fmla="*/ 373273 h 605239"/>
                  <a:gd name="connsiteY79" fmla="*/ 373273 h 605239"/>
                  <a:gd name="connsiteX80" fmla="*/ 373273 h 605239"/>
                  <a:gd name="connsiteY80" fmla="*/ 373273 h 605239"/>
                  <a:gd name="connsiteX81" fmla="*/ 373273 h 605239"/>
                  <a:gd name="connsiteY81" fmla="*/ 373273 h 605239"/>
                  <a:gd name="connsiteX82" fmla="*/ 373273 h 605239"/>
                  <a:gd name="connsiteY82" fmla="*/ 373273 h 605239"/>
                  <a:gd name="connsiteX83" fmla="*/ 373273 h 605239"/>
                  <a:gd name="connsiteY83" fmla="*/ 373273 h 605239"/>
                  <a:gd name="connsiteX84" fmla="*/ 373273 h 605239"/>
                  <a:gd name="connsiteY84" fmla="*/ 373273 h 605239"/>
                  <a:gd name="connsiteX85" fmla="*/ 373273 h 605239"/>
                  <a:gd name="connsiteY85" fmla="*/ 373273 h 605239"/>
                  <a:gd name="connsiteX86" fmla="*/ 373273 h 605239"/>
                  <a:gd name="connsiteY86" fmla="*/ 373273 h 605239"/>
                  <a:gd name="connsiteX87" fmla="*/ 373273 h 605239"/>
                  <a:gd name="connsiteY87" fmla="*/ 373273 h 605239"/>
                  <a:gd name="connsiteX88" fmla="*/ 373273 h 605239"/>
                  <a:gd name="connsiteY88" fmla="*/ 373273 h 605239"/>
                  <a:gd name="connsiteX89" fmla="*/ 373273 h 605239"/>
                  <a:gd name="connsiteY89" fmla="*/ 373273 h 605239"/>
                  <a:gd name="connsiteX90" fmla="*/ 373273 h 605239"/>
                  <a:gd name="connsiteY90" fmla="*/ 373273 h 605239"/>
                  <a:gd name="connsiteX91" fmla="*/ 373273 h 605239"/>
                  <a:gd name="connsiteY91" fmla="*/ 373273 h 605239"/>
                  <a:gd name="connsiteX92" fmla="*/ 373273 h 605239"/>
                  <a:gd name="connsiteY92" fmla="*/ 373273 h 605239"/>
                  <a:gd name="connsiteX93" fmla="*/ 373273 h 605239"/>
                  <a:gd name="connsiteY93" fmla="*/ 373273 h 605239"/>
                  <a:gd name="connsiteX94" fmla="*/ 373273 h 605239"/>
                  <a:gd name="connsiteY94" fmla="*/ 373273 h 605239"/>
                  <a:gd name="connsiteX95" fmla="*/ 373273 h 605239"/>
                  <a:gd name="connsiteY95" fmla="*/ 373273 h 605239"/>
                  <a:gd name="connsiteX96" fmla="*/ 373273 h 605239"/>
                  <a:gd name="connsiteY96" fmla="*/ 373273 h 605239"/>
                  <a:gd name="connsiteX97" fmla="*/ 373273 h 605239"/>
                  <a:gd name="connsiteY97" fmla="*/ 373273 h 605239"/>
                  <a:gd name="connsiteX98" fmla="*/ 373273 h 605239"/>
                  <a:gd name="connsiteY98" fmla="*/ 373273 h 605239"/>
                  <a:gd name="connsiteX99" fmla="*/ 373273 h 605239"/>
                  <a:gd name="connsiteY99" fmla="*/ 373273 h 605239"/>
                  <a:gd name="connsiteX100" fmla="*/ 373273 h 605239"/>
                  <a:gd name="connsiteY100" fmla="*/ 373273 h 605239"/>
                  <a:gd name="connsiteX101" fmla="*/ 373273 h 605239"/>
                  <a:gd name="connsiteY101" fmla="*/ 373273 h 605239"/>
                  <a:gd name="connsiteX102" fmla="*/ 373273 h 605239"/>
                  <a:gd name="connsiteY102" fmla="*/ 373273 h 605239"/>
                  <a:gd name="connsiteX103" fmla="*/ 373273 h 605239"/>
                  <a:gd name="connsiteY103" fmla="*/ 373273 h 605239"/>
                  <a:gd name="connsiteX104" fmla="*/ 373273 h 605239"/>
                  <a:gd name="connsiteY104" fmla="*/ 373273 h 605239"/>
                  <a:gd name="connsiteX105" fmla="*/ 373273 h 605239"/>
                  <a:gd name="connsiteY105" fmla="*/ 373273 h 605239"/>
                  <a:gd name="connsiteX106" fmla="*/ 373273 h 605239"/>
                  <a:gd name="connsiteY106" fmla="*/ 373273 h 605239"/>
                  <a:gd name="connsiteX107" fmla="*/ 373273 h 605239"/>
                  <a:gd name="connsiteY107" fmla="*/ 373273 h 605239"/>
                  <a:gd name="connsiteX108" fmla="*/ 373273 h 605239"/>
                  <a:gd name="connsiteY108" fmla="*/ 373273 h 605239"/>
                  <a:gd name="connsiteX109" fmla="*/ 373273 h 605239"/>
                  <a:gd name="connsiteY109" fmla="*/ 373273 h 605239"/>
                  <a:gd name="connsiteX110" fmla="*/ 373273 h 605239"/>
                  <a:gd name="connsiteY110" fmla="*/ 373273 h 605239"/>
                  <a:gd name="connsiteX111" fmla="*/ 373273 h 605239"/>
                  <a:gd name="connsiteY111" fmla="*/ 373273 h 605239"/>
                  <a:gd name="connsiteX112" fmla="*/ 373273 h 605239"/>
                  <a:gd name="connsiteY112" fmla="*/ 373273 h 605239"/>
                  <a:gd name="connsiteX113" fmla="*/ 373273 h 605239"/>
                  <a:gd name="connsiteY113" fmla="*/ 373273 h 605239"/>
                  <a:gd name="connsiteX114" fmla="*/ 373273 h 605239"/>
                  <a:gd name="connsiteY114" fmla="*/ 373273 h 605239"/>
                  <a:gd name="connsiteX115" fmla="*/ 373273 h 605239"/>
                  <a:gd name="connsiteY115" fmla="*/ 373273 h 605239"/>
                  <a:gd name="connsiteX116" fmla="*/ 373273 h 605239"/>
                  <a:gd name="connsiteY116" fmla="*/ 373273 h 605239"/>
                  <a:gd name="connsiteX117" fmla="*/ 373273 h 605239"/>
                  <a:gd name="connsiteY117" fmla="*/ 373273 h 605239"/>
                  <a:gd name="connsiteX118" fmla="*/ 373273 h 605239"/>
                  <a:gd name="connsiteY118" fmla="*/ 373273 h 605239"/>
                  <a:gd name="connsiteX119" fmla="*/ 373273 h 605239"/>
                  <a:gd name="connsiteY119" fmla="*/ 373273 h 605239"/>
                  <a:gd name="connsiteX120" fmla="*/ 373273 h 605239"/>
                  <a:gd name="connsiteY120" fmla="*/ 373273 h 605239"/>
                  <a:gd name="connsiteX121" fmla="*/ 373273 h 605239"/>
                  <a:gd name="connsiteY121" fmla="*/ 373273 h 605239"/>
                  <a:gd name="connsiteX122" fmla="*/ 373273 h 605239"/>
                  <a:gd name="connsiteY122" fmla="*/ 373273 h 605239"/>
                  <a:gd name="connsiteX123" fmla="*/ 373273 h 605239"/>
                  <a:gd name="connsiteY123" fmla="*/ 373273 h 605239"/>
                  <a:gd name="connsiteX124" fmla="*/ 373273 h 605239"/>
                  <a:gd name="connsiteY124" fmla="*/ 373273 h 605239"/>
                  <a:gd name="connsiteX125" fmla="*/ 373273 h 605239"/>
                  <a:gd name="connsiteY125" fmla="*/ 373273 h 605239"/>
                  <a:gd name="connsiteX126" fmla="*/ 373273 h 605239"/>
                  <a:gd name="connsiteY126" fmla="*/ 373273 h 605239"/>
                  <a:gd name="connsiteX127" fmla="*/ 373273 h 605239"/>
                  <a:gd name="connsiteY127" fmla="*/ 373273 h 605239"/>
                  <a:gd name="connsiteX128" fmla="*/ 373273 h 605239"/>
                  <a:gd name="connsiteY128" fmla="*/ 373273 h 605239"/>
                  <a:gd name="connsiteX129" fmla="*/ 373273 h 605239"/>
                  <a:gd name="connsiteY129" fmla="*/ 373273 h 605239"/>
                  <a:gd name="connsiteX130" fmla="*/ 373273 h 605239"/>
                  <a:gd name="connsiteY130" fmla="*/ 373273 h 605239"/>
                  <a:gd name="connsiteX131" fmla="*/ 373273 h 605239"/>
                  <a:gd name="connsiteY131" fmla="*/ 373273 h 605239"/>
                  <a:gd name="connsiteX132" fmla="*/ 373273 h 605239"/>
                  <a:gd name="connsiteY132" fmla="*/ 373273 h 605239"/>
                  <a:gd name="connsiteX133" fmla="*/ 373273 h 605239"/>
                  <a:gd name="connsiteY133" fmla="*/ 373273 h 605239"/>
                  <a:gd name="connsiteX134" fmla="*/ 373273 h 605239"/>
                  <a:gd name="connsiteY134" fmla="*/ 373273 h 605239"/>
                  <a:gd name="connsiteX135" fmla="*/ 373273 h 605239"/>
                  <a:gd name="connsiteY135" fmla="*/ 373273 h 605239"/>
                  <a:gd name="connsiteX136" fmla="*/ 373273 h 605239"/>
                  <a:gd name="connsiteY136" fmla="*/ 373273 h 605239"/>
                  <a:gd name="connsiteX137" fmla="*/ 373273 h 605239"/>
                  <a:gd name="connsiteY137" fmla="*/ 373273 h 605239"/>
                  <a:gd name="connsiteX138" fmla="*/ 373273 h 605239"/>
                  <a:gd name="connsiteY138" fmla="*/ 373273 h 605239"/>
                  <a:gd name="connsiteX139" fmla="*/ 373273 h 605239"/>
                  <a:gd name="connsiteY139" fmla="*/ 373273 h 605239"/>
                  <a:gd name="connsiteX140" fmla="*/ 373273 h 605239"/>
                  <a:gd name="connsiteY140" fmla="*/ 373273 h 605239"/>
                  <a:gd name="connsiteX141" fmla="*/ 373273 h 605239"/>
                  <a:gd name="connsiteY141" fmla="*/ 373273 h 605239"/>
                  <a:gd name="connsiteX142" fmla="*/ 373273 h 605239"/>
                  <a:gd name="connsiteY142" fmla="*/ 373273 h 605239"/>
                  <a:gd name="connsiteX143" fmla="*/ 373273 h 605239"/>
                  <a:gd name="connsiteY143" fmla="*/ 373273 h 605239"/>
                  <a:gd name="connsiteX144" fmla="*/ 373273 h 605239"/>
                  <a:gd name="connsiteY144" fmla="*/ 373273 h 605239"/>
                  <a:gd name="connsiteX145" fmla="*/ 373273 h 605239"/>
                  <a:gd name="connsiteY145" fmla="*/ 373273 h 605239"/>
                  <a:gd name="connsiteX146" fmla="*/ 373273 h 605239"/>
                  <a:gd name="connsiteY146" fmla="*/ 373273 h 605239"/>
                  <a:gd name="connsiteX147" fmla="*/ 373273 h 605239"/>
                  <a:gd name="connsiteY147" fmla="*/ 373273 h 605239"/>
                  <a:gd name="connsiteX148" fmla="*/ 373273 h 605239"/>
                  <a:gd name="connsiteY148" fmla="*/ 373273 h 605239"/>
                  <a:gd name="connsiteX149" fmla="*/ 373273 h 605239"/>
                  <a:gd name="connsiteY149" fmla="*/ 373273 h 605239"/>
                  <a:gd name="connsiteX150" fmla="*/ 373273 h 605239"/>
                  <a:gd name="connsiteY150" fmla="*/ 373273 h 605239"/>
                  <a:gd name="connsiteX151" fmla="*/ 373273 h 605239"/>
                  <a:gd name="connsiteY151" fmla="*/ 373273 h 605239"/>
                  <a:gd name="connsiteX152" fmla="*/ 373273 h 605239"/>
                  <a:gd name="connsiteY152" fmla="*/ 373273 h 605239"/>
                  <a:gd name="connsiteX153" fmla="*/ 373273 h 605239"/>
                  <a:gd name="connsiteY153" fmla="*/ 373273 h 605239"/>
                  <a:gd name="connsiteX154" fmla="*/ 373273 h 605239"/>
                  <a:gd name="connsiteY154" fmla="*/ 373273 h 605239"/>
                  <a:gd name="connsiteX155" fmla="*/ 373273 h 605239"/>
                  <a:gd name="connsiteY155" fmla="*/ 373273 h 605239"/>
                  <a:gd name="connsiteX156" fmla="*/ 373273 h 605239"/>
                  <a:gd name="connsiteY156" fmla="*/ 373273 h 605239"/>
                  <a:gd name="connsiteX157" fmla="*/ 373273 h 605239"/>
                  <a:gd name="connsiteY157" fmla="*/ 373273 h 605239"/>
                  <a:gd name="connsiteX158" fmla="*/ 373273 h 605239"/>
                  <a:gd name="connsiteY158" fmla="*/ 373273 h 605239"/>
                  <a:gd name="connsiteX159" fmla="*/ 373273 h 605239"/>
                  <a:gd name="connsiteY159" fmla="*/ 373273 h 605239"/>
                  <a:gd name="connsiteX160" fmla="*/ 373273 h 605239"/>
                  <a:gd name="connsiteY160" fmla="*/ 373273 h 605239"/>
                  <a:gd name="connsiteX161" fmla="*/ 373273 h 605239"/>
                  <a:gd name="connsiteY161" fmla="*/ 373273 h 605239"/>
                  <a:gd name="connsiteX162" fmla="*/ 373273 h 605239"/>
                  <a:gd name="connsiteY162" fmla="*/ 373273 h 605239"/>
                  <a:gd name="connsiteX163" fmla="*/ 373273 h 605239"/>
                  <a:gd name="connsiteY163" fmla="*/ 373273 h 605239"/>
                  <a:gd name="connsiteX164" fmla="*/ 373273 h 605239"/>
                  <a:gd name="connsiteY164" fmla="*/ 373273 h 605239"/>
                  <a:gd name="connsiteX165" fmla="*/ 373273 h 605239"/>
                  <a:gd name="connsiteY165" fmla="*/ 373273 h 605239"/>
                  <a:gd name="connsiteX166" fmla="*/ 373273 h 605239"/>
                  <a:gd name="connsiteY166" fmla="*/ 373273 h 605239"/>
                  <a:gd name="connsiteX167" fmla="*/ 373273 h 605239"/>
                  <a:gd name="connsiteY167" fmla="*/ 373273 h 605239"/>
                  <a:gd name="connsiteX168" fmla="*/ 373273 h 605239"/>
                  <a:gd name="connsiteY168" fmla="*/ 373273 h 605239"/>
                  <a:gd name="connsiteX169" fmla="*/ 373273 h 605239"/>
                  <a:gd name="connsiteY169" fmla="*/ 373273 h 605239"/>
                  <a:gd name="connsiteX170" fmla="*/ 373273 h 605239"/>
                  <a:gd name="connsiteY170" fmla="*/ 373273 h 605239"/>
                  <a:gd name="connsiteX171" fmla="*/ 373273 h 605239"/>
                  <a:gd name="connsiteY171" fmla="*/ 373273 h 605239"/>
                  <a:gd name="connsiteX172" fmla="*/ 373273 h 605239"/>
                  <a:gd name="connsiteY172" fmla="*/ 373273 h 605239"/>
                  <a:gd name="connsiteX173" fmla="*/ 373273 h 605239"/>
                  <a:gd name="connsiteY173" fmla="*/ 373273 h 605239"/>
                  <a:gd name="connsiteX174" fmla="*/ 373273 h 605239"/>
                  <a:gd name="connsiteY174" fmla="*/ 373273 h 605239"/>
                  <a:gd name="connsiteX175" fmla="*/ 373273 h 605239"/>
                  <a:gd name="connsiteY175" fmla="*/ 373273 h 605239"/>
                  <a:gd name="connsiteX176" fmla="*/ 373273 h 605239"/>
                  <a:gd name="connsiteY176" fmla="*/ 373273 h 605239"/>
                  <a:gd name="connsiteX177" fmla="*/ 373273 h 605239"/>
                  <a:gd name="connsiteY177" fmla="*/ 373273 h 605239"/>
                  <a:gd name="connsiteX178" fmla="*/ 373273 h 605239"/>
                  <a:gd name="connsiteY178" fmla="*/ 373273 h 605239"/>
                  <a:gd name="connsiteX179" fmla="*/ 373273 h 605239"/>
                  <a:gd name="connsiteY179" fmla="*/ 373273 h 605239"/>
                  <a:gd name="connsiteX180" fmla="*/ 373273 h 605239"/>
                  <a:gd name="connsiteY180" fmla="*/ 373273 h 605239"/>
                  <a:gd name="connsiteX181" fmla="*/ 373273 h 605239"/>
                  <a:gd name="connsiteY181" fmla="*/ 373273 h 605239"/>
                  <a:gd name="connsiteX182" fmla="*/ 373273 h 605239"/>
                  <a:gd name="connsiteY182" fmla="*/ 373273 h 605239"/>
                  <a:gd name="connsiteX183" fmla="*/ 373273 h 605239"/>
                  <a:gd name="connsiteY183" fmla="*/ 373273 h 605239"/>
                  <a:gd name="connsiteX184" fmla="*/ 373273 h 605239"/>
                  <a:gd name="connsiteY184" fmla="*/ 373273 h 605239"/>
                  <a:gd name="connsiteX185" fmla="*/ 373273 h 605239"/>
                  <a:gd name="connsiteY185" fmla="*/ 373273 h 605239"/>
                  <a:gd name="connsiteX186" fmla="*/ 373273 h 605239"/>
                  <a:gd name="connsiteY186" fmla="*/ 373273 h 605239"/>
                  <a:gd name="connsiteX187" fmla="*/ 373273 h 605239"/>
                  <a:gd name="connsiteY187" fmla="*/ 373273 h 605239"/>
                  <a:gd name="connsiteX188" fmla="*/ 373273 h 605239"/>
                  <a:gd name="connsiteY188" fmla="*/ 373273 h 605239"/>
                  <a:gd name="connsiteX189" fmla="*/ 373273 h 605239"/>
                  <a:gd name="connsiteY189" fmla="*/ 373273 h 605239"/>
                  <a:gd name="connsiteX190" fmla="*/ 373273 h 605239"/>
                  <a:gd name="connsiteY190" fmla="*/ 373273 h 605239"/>
                  <a:gd name="connsiteX191" fmla="*/ 373273 h 605239"/>
                  <a:gd name="connsiteY191" fmla="*/ 373273 h 605239"/>
                  <a:gd name="connsiteX192" fmla="*/ 373273 h 605239"/>
                  <a:gd name="connsiteY192" fmla="*/ 373273 h 605239"/>
                  <a:gd name="connsiteX193" fmla="*/ 373273 h 605239"/>
                  <a:gd name="connsiteY193" fmla="*/ 373273 h 605239"/>
                  <a:gd name="connsiteX194" fmla="*/ 373273 h 605239"/>
                  <a:gd name="connsiteY194" fmla="*/ 373273 h 605239"/>
                  <a:gd name="connsiteX195" fmla="*/ 373273 h 605239"/>
                  <a:gd name="connsiteY195" fmla="*/ 373273 h 605239"/>
                  <a:gd name="connsiteX196" fmla="*/ 373273 h 605239"/>
                  <a:gd name="connsiteY196" fmla="*/ 373273 h 605239"/>
                  <a:gd name="connsiteX197" fmla="*/ 373273 h 605239"/>
                  <a:gd name="connsiteY197" fmla="*/ 373273 h 605239"/>
                  <a:gd name="connsiteX198" fmla="*/ 373273 h 605239"/>
                  <a:gd name="connsiteY198" fmla="*/ 373273 h 605239"/>
                  <a:gd name="connsiteX199" fmla="*/ 373273 h 605239"/>
                  <a:gd name="connsiteY199" fmla="*/ 373273 h 605239"/>
                  <a:gd name="connsiteX200" fmla="*/ 373273 h 605239"/>
                  <a:gd name="connsiteY200" fmla="*/ 373273 h 605239"/>
                  <a:gd name="connsiteX201" fmla="*/ 373273 h 605239"/>
                  <a:gd name="connsiteY201" fmla="*/ 373273 h 605239"/>
                  <a:gd name="connsiteX202" fmla="*/ 373273 h 605239"/>
                  <a:gd name="connsiteY202" fmla="*/ 373273 h 605239"/>
                  <a:gd name="connsiteX203" fmla="*/ 373273 h 605239"/>
                  <a:gd name="connsiteY203" fmla="*/ 373273 h 605239"/>
                  <a:gd name="connsiteX204" fmla="*/ 373273 h 605239"/>
                  <a:gd name="connsiteY204" fmla="*/ 373273 h 605239"/>
                  <a:gd name="connsiteX205" fmla="*/ 373273 h 605239"/>
                  <a:gd name="connsiteY205" fmla="*/ 373273 h 605239"/>
                  <a:gd name="connsiteX206" fmla="*/ 373273 h 605239"/>
                  <a:gd name="connsiteY206" fmla="*/ 373273 h 605239"/>
                  <a:gd name="connsiteX207" fmla="*/ 373273 h 605239"/>
                  <a:gd name="connsiteY207" fmla="*/ 373273 h 605239"/>
                  <a:gd name="connsiteX208" fmla="*/ 373273 h 605239"/>
                  <a:gd name="connsiteY208" fmla="*/ 373273 h 605239"/>
                  <a:gd name="connsiteX209" fmla="*/ 373273 h 605239"/>
                  <a:gd name="connsiteY209" fmla="*/ 373273 h 605239"/>
                  <a:gd name="connsiteX210" fmla="*/ 373273 h 605239"/>
                  <a:gd name="connsiteY210" fmla="*/ 373273 h 605239"/>
                  <a:gd name="connsiteX211" fmla="*/ 373273 h 605239"/>
                  <a:gd name="connsiteY211" fmla="*/ 373273 h 605239"/>
                  <a:gd name="connsiteX212" fmla="*/ 373273 h 605239"/>
                  <a:gd name="connsiteY212" fmla="*/ 373273 h 605239"/>
                  <a:gd name="connsiteX213" fmla="*/ 373273 h 605239"/>
                  <a:gd name="connsiteY213" fmla="*/ 373273 h 605239"/>
                  <a:gd name="connsiteX214" fmla="*/ 373273 h 605239"/>
                  <a:gd name="connsiteY214" fmla="*/ 373273 h 605239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428340 h 606087"/>
                  <a:gd name="connsiteX6" fmla="*/ 278159 w 556277"/>
                  <a:gd name="connsiteY6" fmla="*/ 430167 h 606087"/>
                  <a:gd name="connsiteX7" fmla="*/ 273728 w 556277"/>
                  <a:gd name="connsiteY7" fmla="*/ 428340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428340 h 606087"/>
                  <a:gd name="connsiteX6" fmla="*/ 278159 w 556277"/>
                  <a:gd name="connsiteY6" fmla="*/ 430167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428340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0418 w 556277"/>
                  <a:gd name="connsiteY0" fmla="*/ 23611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0418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0418 w 556277"/>
                  <a:gd name="connsiteY0" fmla="*/ 236110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0418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0418 w 556277"/>
                  <a:gd name="connsiteY0" fmla="*/ 236110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0418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2353 w 556277"/>
                  <a:gd name="connsiteY0" fmla="*/ 255462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2353 w 556277"/>
                  <a:gd name="connsiteY12" fmla="*/ 255462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68483 w 556277"/>
                  <a:gd name="connsiteY0" fmla="*/ 236110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68483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68483 w 556277"/>
                  <a:gd name="connsiteY0" fmla="*/ 236110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68483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6224 w 556277"/>
                  <a:gd name="connsiteY0" fmla="*/ 230305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6224 w 556277"/>
                  <a:gd name="connsiteY12" fmla="*/ 230305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6224 w 556277"/>
                  <a:gd name="connsiteY0" fmla="*/ 230305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91145 w 556277"/>
                  <a:gd name="connsiteY7" fmla="*/ 285138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6224 w 556277"/>
                  <a:gd name="connsiteY12" fmla="*/ 230305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6224 w 556277"/>
                  <a:gd name="connsiteY0" fmla="*/ 230305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96951 w 556277"/>
                  <a:gd name="connsiteY7" fmla="*/ 292879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6224 w 556277"/>
                  <a:gd name="connsiteY12" fmla="*/ 230305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  <a:cxn ang="0">
                    <a:pos x="connsiteX169" y="connsiteY169"/>
                  </a:cxn>
                  <a:cxn ang="0">
                    <a:pos x="connsiteX170" y="connsiteY170"/>
                  </a:cxn>
                  <a:cxn ang="0">
                    <a:pos x="connsiteX171" y="connsiteY171"/>
                  </a:cxn>
                  <a:cxn ang="0">
                    <a:pos x="connsiteX172" y="connsiteY172"/>
                  </a:cxn>
                  <a:cxn ang="0">
                    <a:pos x="connsiteX173" y="connsiteY173"/>
                  </a:cxn>
                  <a:cxn ang="0">
                    <a:pos x="connsiteX174" y="connsiteY174"/>
                  </a:cxn>
                  <a:cxn ang="0">
                    <a:pos x="connsiteX175" y="connsiteY175"/>
                  </a:cxn>
                  <a:cxn ang="0">
                    <a:pos x="connsiteX176" y="connsiteY176"/>
                  </a:cxn>
                  <a:cxn ang="0">
                    <a:pos x="connsiteX177" y="connsiteY177"/>
                  </a:cxn>
                  <a:cxn ang="0">
                    <a:pos x="connsiteX178" y="connsiteY178"/>
                  </a:cxn>
                  <a:cxn ang="0">
                    <a:pos x="connsiteX179" y="connsiteY179"/>
                  </a:cxn>
                  <a:cxn ang="0">
                    <a:pos x="connsiteX180" y="connsiteY180"/>
                  </a:cxn>
                  <a:cxn ang="0">
                    <a:pos x="connsiteX181" y="connsiteY181"/>
                  </a:cxn>
                  <a:cxn ang="0">
                    <a:pos x="connsiteX182" y="connsiteY182"/>
                  </a:cxn>
                  <a:cxn ang="0">
                    <a:pos x="connsiteX183" y="connsiteY183"/>
                  </a:cxn>
                  <a:cxn ang="0">
                    <a:pos x="connsiteX184" y="connsiteY184"/>
                  </a:cxn>
                  <a:cxn ang="0">
                    <a:pos x="connsiteX185" y="connsiteY185"/>
                  </a:cxn>
                  <a:cxn ang="0">
                    <a:pos x="connsiteX186" y="connsiteY186"/>
                  </a:cxn>
                  <a:cxn ang="0">
                    <a:pos x="connsiteX187" y="connsiteY187"/>
                  </a:cxn>
                  <a:cxn ang="0">
                    <a:pos x="connsiteX188" y="connsiteY188"/>
                  </a:cxn>
                  <a:cxn ang="0">
                    <a:pos x="connsiteX189" y="connsiteY189"/>
                  </a:cxn>
                  <a:cxn ang="0">
                    <a:pos x="connsiteX190" y="connsiteY190"/>
                  </a:cxn>
                  <a:cxn ang="0">
                    <a:pos x="connsiteX191" y="connsiteY191"/>
                  </a:cxn>
                  <a:cxn ang="0">
                    <a:pos x="connsiteX192" y="connsiteY192"/>
                  </a:cxn>
                  <a:cxn ang="0">
                    <a:pos x="connsiteX193" y="connsiteY193"/>
                  </a:cxn>
                  <a:cxn ang="0">
                    <a:pos x="connsiteX194" y="connsiteY194"/>
                  </a:cxn>
                  <a:cxn ang="0">
                    <a:pos x="connsiteX195" y="connsiteY195"/>
                  </a:cxn>
                  <a:cxn ang="0">
                    <a:pos x="connsiteX196" y="connsiteY196"/>
                  </a:cxn>
                  <a:cxn ang="0">
                    <a:pos x="connsiteX197" y="connsiteY197"/>
                  </a:cxn>
                  <a:cxn ang="0">
                    <a:pos x="connsiteX198" y="connsiteY198"/>
                  </a:cxn>
                  <a:cxn ang="0">
                    <a:pos x="connsiteX199" y="connsiteY199"/>
                  </a:cxn>
                  <a:cxn ang="0">
                    <a:pos x="connsiteX200" y="connsiteY200"/>
                  </a:cxn>
                  <a:cxn ang="0">
                    <a:pos x="connsiteX201" y="connsiteY201"/>
                  </a:cxn>
                  <a:cxn ang="0">
                    <a:pos x="connsiteX202" y="connsiteY202"/>
                  </a:cxn>
                  <a:cxn ang="0">
                    <a:pos x="connsiteX203" y="connsiteY203"/>
                  </a:cxn>
                  <a:cxn ang="0">
                    <a:pos x="connsiteX204" y="connsiteY204"/>
                  </a:cxn>
                  <a:cxn ang="0">
                    <a:pos x="connsiteX205" y="connsiteY205"/>
                  </a:cxn>
                  <a:cxn ang="0">
                    <a:pos x="connsiteX206" y="connsiteY206"/>
                  </a:cxn>
                  <a:cxn ang="0">
                    <a:pos x="connsiteX207" y="connsiteY207"/>
                  </a:cxn>
                  <a:cxn ang="0">
                    <a:pos x="connsiteX208" y="connsiteY208"/>
                  </a:cxn>
                  <a:cxn ang="0">
                    <a:pos x="connsiteX209" y="connsiteY209"/>
                  </a:cxn>
                  <a:cxn ang="0">
                    <a:pos x="connsiteX210" y="connsiteY210"/>
                  </a:cxn>
                  <a:cxn ang="0">
                    <a:pos x="connsiteX211" y="connsiteY211"/>
                  </a:cxn>
                  <a:cxn ang="0">
                    <a:pos x="connsiteX212" y="connsiteY212"/>
                  </a:cxn>
                  <a:cxn ang="0">
                    <a:pos x="connsiteX213" y="connsiteY213"/>
                  </a:cxn>
                  <a:cxn ang="0">
                    <a:pos x="connsiteX214" y="connsiteY214"/>
                  </a:cxn>
                  <a:cxn ang="0">
                    <a:pos x="connsiteX215" y="connsiteY215"/>
                  </a:cxn>
                </a:cxnLst>
                <a:rect l="l" t="t" r="r" b="b"/>
                <a:pathLst>
                  <a:path w="556277" h="606087">
                    <a:moveTo>
                      <a:pt x="276224" y="230305"/>
                    </a:moveTo>
                    <a:lnTo>
                      <a:pt x="279087" y="224644"/>
                    </a:lnTo>
                    <a:cubicBezTo>
                      <a:pt x="279184" y="224932"/>
                      <a:pt x="316594" y="206774"/>
                      <a:pt x="394620" y="227257"/>
                    </a:cubicBezTo>
                    <a:lnTo>
                      <a:pt x="402904" y="229373"/>
                    </a:lnTo>
                    <a:cubicBezTo>
                      <a:pt x="403257" y="232258"/>
                      <a:pt x="397805" y="240948"/>
                      <a:pt x="398158" y="243833"/>
                    </a:cubicBezTo>
                    <a:cubicBezTo>
                      <a:pt x="398254" y="245179"/>
                      <a:pt x="418606" y="241623"/>
                      <a:pt x="282590" y="292879"/>
                    </a:cubicBezTo>
                    <a:lnTo>
                      <a:pt x="282029" y="290836"/>
                    </a:lnTo>
                    <a:lnTo>
                      <a:pt x="296951" y="292879"/>
                    </a:lnTo>
                    <a:lnTo>
                      <a:pt x="152257" y="238028"/>
                    </a:lnTo>
                    <a:lnTo>
                      <a:pt x="153317" y="229373"/>
                    </a:lnTo>
                    <a:lnTo>
                      <a:pt x="161601" y="227257"/>
                    </a:lnTo>
                    <a:cubicBezTo>
                      <a:pt x="239723" y="206774"/>
                      <a:pt x="269296" y="228803"/>
                      <a:pt x="269489" y="228515"/>
                    </a:cubicBezTo>
                    <a:cubicBezTo>
                      <a:pt x="269799" y="247173"/>
                      <a:pt x="275914" y="211647"/>
                      <a:pt x="276224" y="230305"/>
                    </a:cubicBezTo>
                    <a:close/>
                    <a:moveTo>
                      <a:pt x="230104" y="104060"/>
                    </a:moveTo>
                    <a:lnTo>
                      <a:pt x="122343" y="160995"/>
                    </a:lnTo>
                    <a:cubicBezTo>
                      <a:pt x="122632" y="161475"/>
                      <a:pt x="122632" y="162149"/>
                      <a:pt x="122824" y="162630"/>
                    </a:cubicBezTo>
                    <a:cubicBezTo>
                      <a:pt x="123210" y="163880"/>
                      <a:pt x="123787" y="165130"/>
                      <a:pt x="124173" y="166380"/>
                    </a:cubicBezTo>
                    <a:cubicBezTo>
                      <a:pt x="124365" y="167631"/>
                      <a:pt x="124654" y="168881"/>
                      <a:pt x="124847" y="170035"/>
                    </a:cubicBezTo>
                    <a:cubicBezTo>
                      <a:pt x="125232" y="171478"/>
                      <a:pt x="125521" y="172728"/>
                      <a:pt x="125810" y="173979"/>
                    </a:cubicBezTo>
                    <a:cubicBezTo>
                      <a:pt x="126002" y="175710"/>
                      <a:pt x="126195" y="177537"/>
                      <a:pt x="126291" y="179268"/>
                    </a:cubicBezTo>
                    <a:cubicBezTo>
                      <a:pt x="126291" y="180807"/>
                      <a:pt x="126387" y="182153"/>
                      <a:pt x="126291" y="183596"/>
                    </a:cubicBezTo>
                    <a:cubicBezTo>
                      <a:pt x="126291" y="185327"/>
                      <a:pt x="126291" y="187154"/>
                      <a:pt x="126195" y="188885"/>
                    </a:cubicBezTo>
                    <a:cubicBezTo>
                      <a:pt x="126002" y="189847"/>
                      <a:pt x="125906" y="190905"/>
                      <a:pt x="125617" y="191867"/>
                    </a:cubicBezTo>
                    <a:cubicBezTo>
                      <a:pt x="125521" y="193502"/>
                      <a:pt x="125136" y="195233"/>
                      <a:pt x="124847" y="196868"/>
                    </a:cubicBezTo>
                    <a:cubicBezTo>
                      <a:pt x="124654" y="197830"/>
                      <a:pt x="124365" y="198695"/>
                      <a:pt x="124173" y="199753"/>
                    </a:cubicBezTo>
                    <a:cubicBezTo>
                      <a:pt x="123595" y="201484"/>
                      <a:pt x="123113" y="203119"/>
                      <a:pt x="122535" y="204947"/>
                    </a:cubicBezTo>
                    <a:cubicBezTo>
                      <a:pt x="122150" y="205716"/>
                      <a:pt x="121861" y="206581"/>
                      <a:pt x="121476" y="207351"/>
                    </a:cubicBezTo>
                    <a:cubicBezTo>
                      <a:pt x="120513" y="209851"/>
                      <a:pt x="119357" y="212256"/>
                      <a:pt x="117913" y="214660"/>
                    </a:cubicBezTo>
                    <a:cubicBezTo>
                      <a:pt x="116565" y="216872"/>
                      <a:pt x="115024" y="219180"/>
                      <a:pt x="113387" y="221296"/>
                    </a:cubicBezTo>
                    <a:cubicBezTo>
                      <a:pt x="112905" y="222065"/>
                      <a:pt x="112135" y="222835"/>
                      <a:pt x="111653" y="223604"/>
                    </a:cubicBezTo>
                    <a:lnTo>
                      <a:pt x="108187" y="227355"/>
                    </a:lnTo>
                    <a:cubicBezTo>
                      <a:pt x="107416" y="228124"/>
                      <a:pt x="106549" y="228894"/>
                      <a:pt x="105683" y="229663"/>
                    </a:cubicBezTo>
                    <a:cubicBezTo>
                      <a:pt x="104623" y="230625"/>
                      <a:pt x="103564" y="231683"/>
                      <a:pt x="102408" y="232548"/>
                    </a:cubicBezTo>
                    <a:cubicBezTo>
                      <a:pt x="101349" y="233318"/>
                      <a:pt x="100386" y="233991"/>
                      <a:pt x="99519" y="234664"/>
                    </a:cubicBezTo>
                    <a:cubicBezTo>
                      <a:pt x="98364" y="235434"/>
                      <a:pt x="97112" y="236395"/>
                      <a:pt x="95956" y="237069"/>
                    </a:cubicBezTo>
                    <a:cubicBezTo>
                      <a:pt x="94801" y="237742"/>
                      <a:pt x="93838" y="238223"/>
                      <a:pt x="92778" y="238704"/>
                    </a:cubicBezTo>
                    <a:cubicBezTo>
                      <a:pt x="91526" y="239473"/>
                      <a:pt x="90274" y="240146"/>
                      <a:pt x="89023" y="240627"/>
                    </a:cubicBezTo>
                    <a:cubicBezTo>
                      <a:pt x="87867" y="241108"/>
                      <a:pt x="86711" y="241685"/>
                      <a:pt x="85556" y="242070"/>
                    </a:cubicBezTo>
                    <a:cubicBezTo>
                      <a:pt x="84304" y="242550"/>
                      <a:pt x="82956" y="243031"/>
                      <a:pt x="81607" y="243416"/>
                    </a:cubicBezTo>
                    <a:cubicBezTo>
                      <a:pt x="80548" y="243801"/>
                      <a:pt x="79296" y="244089"/>
                      <a:pt x="78140" y="244282"/>
                    </a:cubicBezTo>
                    <a:cubicBezTo>
                      <a:pt x="76696" y="244666"/>
                      <a:pt x="75348" y="244955"/>
                      <a:pt x="73903" y="245147"/>
                    </a:cubicBezTo>
                    <a:cubicBezTo>
                      <a:pt x="72844" y="245436"/>
                      <a:pt x="71496" y="245532"/>
                      <a:pt x="70436" y="245724"/>
                    </a:cubicBezTo>
                    <a:cubicBezTo>
                      <a:pt x="69859" y="245820"/>
                      <a:pt x="69377" y="245917"/>
                      <a:pt x="68992" y="245917"/>
                    </a:cubicBezTo>
                    <a:lnTo>
                      <a:pt x="68992" y="360075"/>
                    </a:lnTo>
                    <a:cubicBezTo>
                      <a:pt x="69859" y="360075"/>
                      <a:pt x="70822" y="360363"/>
                      <a:pt x="71785" y="360459"/>
                    </a:cubicBezTo>
                    <a:cubicBezTo>
                      <a:pt x="72651" y="360556"/>
                      <a:pt x="73711" y="360748"/>
                      <a:pt x="74674" y="360844"/>
                    </a:cubicBezTo>
                    <a:cubicBezTo>
                      <a:pt x="76696" y="361229"/>
                      <a:pt x="78718" y="361710"/>
                      <a:pt x="80644" y="362383"/>
                    </a:cubicBezTo>
                    <a:cubicBezTo>
                      <a:pt x="81415" y="362479"/>
                      <a:pt x="82185" y="362768"/>
                      <a:pt x="82956" y="362960"/>
                    </a:cubicBezTo>
                    <a:cubicBezTo>
                      <a:pt x="85556" y="363826"/>
                      <a:pt x="88252" y="364883"/>
                      <a:pt x="90756" y="366038"/>
                    </a:cubicBezTo>
                    <a:cubicBezTo>
                      <a:pt x="91237" y="366230"/>
                      <a:pt x="91623" y="366518"/>
                      <a:pt x="92104" y="366807"/>
                    </a:cubicBezTo>
                    <a:cubicBezTo>
                      <a:pt x="94126" y="367865"/>
                      <a:pt x="96149" y="369019"/>
                      <a:pt x="98075" y="370269"/>
                    </a:cubicBezTo>
                    <a:cubicBezTo>
                      <a:pt x="98845" y="370846"/>
                      <a:pt x="99712" y="371423"/>
                      <a:pt x="100482" y="372000"/>
                    </a:cubicBezTo>
                    <a:cubicBezTo>
                      <a:pt x="102023" y="373058"/>
                      <a:pt x="103371" y="374212"/>
                      <a:pt x="104912" y="375463"/>
                    </a:cubicBezTo>
                    <a:cubicBezTo>
                      <a:pt x="105683" y="376232"/>
                      <a:pt x="106453" y="376905"/>
                      <a:pt x="107224" y="377675"/>
                    </a:cubicBezTo>
                    <a:cubicBezTo>
                      <a:pt x="108572" y="379021"/>
                      <a:pt x="109824" y="380367"/>
                      <a:pt x="111268" y="381906"/>
                    </a:cubicBezTo>
                    <a:cubicBezTo>
                      <a:pt x="111750" y="382676"/>
                      <a:pt x="112424" y="383349"/>
                      <a:pt x="113002" y="384118"/>
                    </a:cubicBezTo>
                    <a:cubicBezTo>
                      <a:pt x="114735" y="386330"/>
                      <a:pt x="116468" y="388735"/>
                      <a:pt x="117913" y="391427"/>
                    </a:cubicBezTo>
                    <a:cubicBezTo>
                      <a:pt x="119357" y="393832"/>
                      <a:pt x="120513" y="396236"/>
                      <a:pt x="121476" y="398737"/>
                    </a:cubicBezTo>
                    <a:cubicBezTo>
                      <a:pt x="121861" y="399506"/>
                      <a:pt x="122150" y="400275"/>
                      <a:pt x="122343" y="400949"/>
                    </a:cubicBezTo>
                    <a:cubicBezTo>
                      <a:pt x="123017" y="402776"/>
                      <a:pt x="123595" y="404507"/>
                      <a:pt x="124173" y="406334"/>
                    </a:cubicBezTo>
                    <a:lnTo>
                      <a:pt x="124750" y="408931"/>
                    </a:lnTo>
                    <a:cubicBezTo>
                      <a:pt x="125136" y="410758"/>
                      <a:pt x="125521" y="412489"/>
                      <a:pt x="125810" y="414413"/>
                    </a:cubicBezTo>
                    <a:cubicBezTo>
                      <a:pt x="125906" y="415182"/>
                      <a:pt x="126002" y="416048"/>
                      <a:pt x="126002" y="416817"/>
                    </a:cubicBezTo>
                    <a:cubicBezTo>
                      <a:pt x="126291" y="419222"/>
                      <a:pt x="126387" y="421434"/>
                      <a:pt x="126387" y="423838"/>
                    </a:cubicBezTo>
                    <a:lnTo>
                      <a:pt x="126387" y="424607"/>
                    </a:lnTo>
                    <a:cubicBezTo>
                      <a:pt x="126291" y="427300"/>
                      <a:pt x="126002" y="429801"/>
                      <a:pt x="125617" y="432397"/>
                    </a:cubicBezTo>
                    <a:cubicBezTo>
                      <a:pt x="125521" y="433167"/>
                      <a:pt x="125424" y="433936"/>
                      <a:pt x="125136" y="434706"/>
                    </a:cubicBezTo>
                    <a:cubicBezTo>
                      <a:pt x="124847" y="436437"/>
                      <a:pt x="124365" y="438360"/>
                      <a:pt x="123884" y="440091"/>
                    </a:cubicBezTo>
                    <a:cubicBezTo>
                      <a:pt x="123595" y="441053"/>
                      <a:pt x="123402" y="441919"/>
                      <a:pt x="123113" y="442784"/>
                    </a:cubicBezTo>
                    <a:cubicBezTo>
                      <a:pt x="122824" y="443457"/>
                      <a:pt x="122632" y="444131"/>
                      <a:pt x="122343" y="444900"/>
                    </a:cubicBezTo>
                    <a:lnTo>
                      <a:pt x="230104" y="501835"/>
                    </a:lnTo>
                    <a:cubicBezTo>
                      <a:pt x="230682" y="501162"/>
                      <a:pt x="231452" y="500488"/>
                      <a:pt x="232127" y="499719"/>
                    </a:cubicBezTo>
                    <a:cubicBezTo>
                      <a:pt x="232608" y="499238"/>
                      <a:pt x="233090" y="498565"/>
                      <a:pt x="233764" y="498084"/>
                    </a:cubicBezTo>
                    <a:cubicBezTo>
                      <a:pt x="235112" y="496545"/>
                      <a:pt x="236749" y="495199"/>
                      <a:pt x="238386" y="493949"/>
                    </a:cubicBezTo>
                    <a:cubicBezTo>
                      <a:pt x="238771" y="493564"/>
                      <a:pt x="239060" y="493275"/>
                      <a:pt x="239542" y="492891"/>
                    </a:cubicBezTo>
                    <a:cubicBezTo>
                      <a:pt x="241564" y="491352"/>
                      <a:pt x="243683" y="489909"/>
                      <a:pt x="245898" y="488659"/>
                    </a:cubicBezTo>
                    <a:cubicBezTo>
                      <a:pt x="246379" y="488371"/>
                      <a:pt x="246764" y="488082"/>
                      <a:pt x="247150" y="487890"/>
                    </a:cubicBezTo>
                    <a:cubicBezTo>
                      <a:pt x="249076" y="486832"/>
                      <a:pt x="250809" y="485966"/>
                      <a:pt x="252735" y="485101"/>
                    </a:cubicBezTo>
                    <a:cubicBezTo>
                      <a:pt x="253505" y="484812"/>
                      <a:pt x="254372" y="484427"/>
                      <a:pt x="255143" y="484235"/>
                    </a:cubicBezTo>
                    <a:cubicBezTo>
                      <a:pt x="256780" y="483562"/>
                      <a:pt x="258417" y="482985"/>
                      <a:pt x="260054" y="482408"/>
                    </a:cubicBezTo>
                    <a:cubicBezTo>
                      <a:pt x="260921" y="482215"/>
                      <a:pt x="261787" y="481927"/>
                      <a:pt x="262654" y="481831"/>
                    </a:cubicBezTo>
                    <a:cubicBezTo>
                      <a:pt x="264291" y="481254"/>
                      <a:pt x="266121" y="480965"/>
                      <a:pt x="267854" y="480677"/>
                    </a:cubicBezTo>
                    <a:cubicBezTo>
                      <a:pt x="268625" y="480580"/>
                      <a:pt x="269492" y="480388"/>
                      <a:pt x="270262" y="480292"/>
                    </a:cubicBezTo>
                    <a:cubicBezTo>
                      <a:pt x="272958" y="479907"/>
                      <a:pt x="275462" y="479811"/>
                      <a:pt x="278159" y="479811"/>
                    </a:cubicBezTo>
                    <a:cubicBezTo>
                      <a:pt x="280759" y="479811"/>
                      <a:pt x="283263" y="479907"/>
                      <a:pt x="285959" y="480292"/>
                    </a:cubicBezTo>
                    <a:cubicBezTo>
                      <a:pt x="286729" y="480388"/>
                      <a:pt x="287596" y="480580"/>
                      <a:pt x="288367" y="480677"/>
                    </a:cubicBezTo>
                    <a:cubicBezTo>
                      <a:pt x="290100" y="480965"/>
                      <a:pt x="291930" y="481254"/>
                      <a:pt x="293567" y="481831"/>
                    </a:cubicBezTo>
                    <a:cubicBezTo>
                      <a:pt x="294434" y="481927"/>
                      <a:pt x="295300" y="482215"/>
                      <a:pt x="296167" y="482600"/>
                    </a:cubicBezTo>
                    <a:cubicBezTo>
                      <a:pt x="297804" y="482985"/>
                      <a:pt x="299441" y="483562"/>
                      <a:pt x="301175" y="484235"/>
                    </a:cubicBezTo>
                    <a:cubicBezTo>
                      <a:pt x="301849" y="484427"/>
                      <a:pt x="302812" y="484812"/>
                      <a:pt x="303486" y="485197"/>
                    </a:cubicBezTo>
                    <a:cubicBezTo>
                      <a:pt x="305412" y="485966"/>
                      <a:pt x="307242" y="486832"/>
                      <a:pt x="308975" y="487890"/>
                    </a:cubicBezTo>
                    <a:cubicBezTo>
                      <a:pt x="309360" y="488082"/>
                      <a:pt x="309842" y="488371"/>
                      <a:pt x="310323" y="488659"/>
                    </a:cubicBezTo>
                    <a:cubicBezTo>
                      <a:pt x="312538" y="489909"/>
                      <a:pt x="314657" y="491352"/>
                      <a:pt x="316679" y="492891"/>
                    </a:cubicBezTo>
                    <a:cubicBezTo>
                      <a:pt x="317161" y="493275"/>
                      <a:pt x="317546" y="493660"/>
                      <a:pt x="317931" y="494045"/>
                    </a:cubicBezTo>
                    <a:cubicBezTo>
                      <a:pt x="319568" y="495295"/>
                      <a:pt x="321109" y="496545"/>
                      <a:pt x="322457" y="498084"/>
                    </a:cubicBezTo>
                    <a:lnTo>
                      <a:pt x="324094" y="499719"/>
                    </a:lnTo>
                    <a:cubicBezTo>
                      <a:pt x="324769" y="500488"/>
                      <a:pt x="325539" y="501162"/>
                      <a:pt x="326117" y="501835"/>
                    </a:cubicBezTo>
                    <a:lnTo>
                      <a:pt x="433878" y="444900"/>
                    </a:lnTo>
                    <a:cubicBezTo>
                      <a:pt x="433589" y="444419"/>
                      <a:pt x="433493" y="443938"/>
                      <a:pt x="433397" y="443457"/>
                    </a:cubicBezTo>
                    <a:cubicBezTo>
                      <a:pt x="433011" y="442111"/>
                      <a:pt x="432530" y="440765"/>
                      <a:pt x="432145" y="439514"/>
                    </a:cubicBezTo>
                    <a:cubicBezTo>
                      <a:pt x="431856" y="438360"/>
                      <a:pt x="431567" y="437110"/>
                      <a:pt x="431182" y="435860"/>
                    </a:cubicBezTo>
                    <a:cubicBezTo>
                      <a:pt x="430989" y="434609"/>
                      <a:pt x="430700" y="433359"/>
                      <a:pt x="430508" y="432013"/>
                    </a:cubicBezTo>
                    <a:cubicBezTo>
                      <a:pt x="430219" y="430282"/>
                      <a:pt x="430122" y="428358"/>
                      <a:pt x="429930" y="426627"/>
                    </a:cubicBezTo>
                    <a:cubicBezTo>
                      <a:pt x="429930" y="425281"/>
                      <a:pt x="429834" y="423838"/>
                      <a:pt x="429930" y="422492"/>
                    </a:cubicBezTo>
                    <a:cubicBezTo>
                      <a:pt x="429930" y="420568"/>
                      <a:pt x="429930" y="418837"/>
                      <a:pt x="430122" y="417010"/>
                    </a:cubicBezTo>
                    <a:cubicBezTo>
                      <a:pt x="430219" y="416048"/>
                      <a:pt x="430315" y="414990"/>
                      <a:pt x="430604" y="414028"/>
                    </a:cubicBezTo>
                    <a:cubicBezTo>
                      <a:pt x="430700" y="412393"/>
                      <a:pt x="431085" y="410758"/>
                      <a:pt x="431374" y="409220"/>
                    </a:cubicBezTo>
                    <a:cubicBezTo>
                      <a:pt x="431567" y="408162"/>
                      <a:pt x="431856" y="407200"/>
                      <a:pt x="432145" y="406142"/>
                    </a:cubicBezTo>
                    <a:cubicBezTo>
                      <a:pt x="432626" y="404507"/>
                      <a:pt x="433108" y="402776"/>
                      <a:pt x="433782" y="401141"/>
                    </a:cubicBezTo>
                    <a:cubicBezTo>
                      <a:pt x="434167" y="400372"/>
                      <a:pt x="434360" y="399506"/>
                      <a:pt x="434745" y="398737"/>
                    </a:cubicBezTo>
                    <a:cubicBezTo>
                      <a:pt x="435804" y="396236"/>
                      <a:pt x="436960" y="393832"/>
                      <a:pt x="438308" y="391427"/>
                    </a:cubicBezTo>
                    <a:cubicBezTo>
                      <a:pt x="439656" y="388831"/>
                      <a:pt x="441486" y="386330"/>
                      <a:pt x="443219" y="384118"/>
                    </a:cubicBezTo>
                    <a:cubicBezTo>
                      <a:pt x="443701" y="383445"/>
                      <a:pt x="444375" y="382772"/>
                      <a:pt x="444857" y="382195"/>
                    </a:cubicBezTo>
                    <a:cubicBezTo>
                      <a:pt x="446301" y="380560"/>
                      <a:pt x="447649" y="379021"/>
                      <a:pt x="449190" y="377482"/>
                    </a:cubicBezTo>
                    <a:cubicBezTo>
                      <a:pt x="449768" y="376905"/>
                      <a:pt x="450442" y="376424"/>
                      <a:pt x="451212" y="375751"/>
                    </a:cubicBezTo>
                    <a:cubicBezTo>
                      <a:pt x="452850" y="374405"/>
                      <a:pt x="454487" y="372962"/>
                      <a:pt x="456220" y="371712"/>
                    </a:cubicBezTo>
                    <a:cubicBezTo>
                      <a:pt x="456798" y="371327"/>
                      <a:pt x="457376" y="370846"/>
                      <a:pt x="457857" y="370462"/>
                    </a:cubicBezTo>
                    <a:cubicBezTo>
                      <a:pt x="462865" y="367192"/>
                      <a:pt x="467969" y="364595"/>
                      <a:pt x="473554" y="362864"/>
                    </a:cubicBezTo>
                    <a:cubicBezTo>
                      <a:pt x="474036" y="362768"/>
                      <a:pt x="474614" y="362575"/>
                      <a:pt x="475095" y="362479"/>
                    </a:cubicBezTo>
                    <a:cubicBezTo>
                      <a:pt x="477406" y="361902"/>
                      <a:pt x="479525" y="361229"/>
                      <a:pt x="481836" y="360844"/>
                    </a:cubicBezTo>
                    <a:lnTo>
                      <a:pt x="484436" y="360459"/>
                    </a:lnTo>
                    <a:cubicBezTo>
                      <a:pt x="485303" y="360363"/>
                      <a:pt x="486362" y="360075"/>
                      <a:pt x="487229" y="360075"/>
                    </a:cubicBezTo>
                    <a:lnTo>
                      <a:pt x="487229" y="245917"/>
                    </a:lnTo>
                    <a:cubicBezTo>
                      <a:pt x="486844" y="245917"/>
                      <a:pt x="486362" y="245820"/>
                      <a:pt x="485881" y="245724"/>
                    </a:cubicBezTo>
                    <a:cubicBezTo>
                      <a:pt x="484725" y="245532"/>
                      <a:pt x="483473" y="245436"/>
                      <a:pt x="482318" y="245147"/>
                    </a:cubicBezTo>
                    <a:cubicBezTo>
                      <a:pt x="480873" y="244955"/>
                      <a:pt x="479525" y="244666"/>
                      <a:pt x="478081" y="244282"/>
                    </a:cubicBezTo>
                    <a:cubicBezTo>
                      <a:pt x="477021" y="244089"/>
                      <a:pt x="475769" y="243801"/>
                      <a:pt x="474614" y="243416"/>
                    </a:cubicBezTo>
                    <a:cubicBezTo>
                      <a:pt x="473362" y="243031"/>
                      <a:pt x="471917" y="242550"/>
                      <a:pt x="470665" y="242070"/>
                    </a:cubicBezTo>
                    <a:cubicBezTo>
                      <a:pt x="469510" y="241685"/>
                      <a:pt x="468354" y="241108"/>
                      <a:pt x="467295" y="240627"/>
                    </a:cubicBezTo>
                    <a:cubicBezTo>
                      <a:pt x="465947" y="240146"/>
                      <a:pt x="464695" y="239473"/>
                      <a:pt x="463443" y="238896"/>
                    </a:cubicBezTo>
                    <a:cubicBezTo>
                      <a:pt x="462480" y="238223"/>
                      <a:pt x="461420" y="237742"/>
                      <a:pt x="460265" y="237069"/>
                    </a:cubicBezTo>
                    <a:cubicBezTo>
                      <a:pt x="459205" y="236395"/>
                      <a:pt x="457857" y="235434"/>
                      <a:pt x="456798" y="234664"/>
                    </a:cubicBezTo>
                    <a:cubicBezTo>
                      <a:pt x="455835" y="234087"/>
                      <a:pt x="454872" y="233318"/>
                      <a:pt x="453813" y="232548"/>
                    </a:cubicBezTo>
                    <a:cubicBezTo>
                      <a:pt x="452753" y="231683"/>
                      <a:pt x="451598" y="230625"/>
                      <a:pt x="450538" y="229663"/>
                    </a:cubicBezTo>
                    <a:cubicBezTo>
                      <a:pt x="449672" y="228894"/>
                      <a:pt x="448805" y="228124"/>
                      <a:pt x="448034" y="227355"/>
                    </a:cubicBezTo>
                    <a:cubicBezTo>
                      <a:pt x="446879" y="226105"/>
                      <a:pt x="445723" y="224854"/>
                      <a:pt x="444664" y="223604"/>
                    </a:cubicBezTo>
                    <a:cubicBezTo>
                      <a:pt x="444086" y="222835"/>
                      <a:pt x="443316" y="222065"/>
                      <a:pt x="442834" y="221296"/>
                    </a:cubicBezTo>
                    <a:cubicBezTo>
                      <a:pt x="441197" y="219180"/>
                      <a:pt x="439656" y="217064"/>
                      <a:pt x="438308" y="214660"/>
                    </a:cubicBezTo>
                    <a:cubicBezTo>
                      <a:pt x="436960" y="212256"/>
                      <a:pt x="435804" y="209851"/>
                      <a:pt x="434745" y="207351"/>
                    </a:cubicBezTo>
                    <a:cubicBezTo>
                      <a:pt x="434360" y="206581"/>
                      <a:pt x="434167" y="205812"/>
                      <a:pt x="433878" y="205043"/>
                    </a:cubicBezTo>
                    <a:cubicBezTo>
                      <a:pt x="433204" y="203312"/>
                      <a:pt x="432626" y="201484"/>
                      <a:pt x="432145" y="199753"/>
                    </a:cubicBezTo>
                    <a:cubicBezTo>
                      <a:pt x="431856" y="198695"/>
                      <a:pt x="431567" y="197830"/>
                      <a:pt x="431471" y="196964"/>
                    </a:cubicBezTo>
                    <a:cubicBezTo>
                      <a:pt x="431085" y="195233"/>
                      <a:pt x="430700" y="193406"/>
                      <a:pt x="430508" y="191675"/>
                    </a:cubicBezTo>
                    <a:cubicBezTo>
                      <a:pt x="430315" y="190809"/>
                      <a:pt x="430219" y="190040"/>
                      <a:pt x="430219" y="189174"/>
                    </a:cubicBezTo>
                    <a:cubicBezTo>
                      <a:pt x="429930" y="186770"/>
                      <a:pt x="429834" y="184462"/>
                      <a:pt x="429834" y="182057"/>
                    </a:cubicBezTo>
                    <a:lnTo>
                      <a:pt x="429834" y="181288"/>
                    </a:lnTo>
                    <a:cubicBezTo>
                      <a:pt x="429930" y="178691"/>
                      <a:pt x="430219" y="176094"/>
                      <a:pt x="430604" y="173594"/>
                    </a:cubicBezTo>
                    <a:cubicBezTo>
                      <a:pt x="430700" y="172728"/>
                      <a:pt x="430989" y="171958"/>
                      <a:pt x="431085" y="171093"/>
                    </a:cubicBezTo>
                    <a:cubicBezTo>
                      <a:pt x="431471" y="169266"/>
                      <a:pt x="431856" y="167534"/>
                      <a:pt x="432337" y="165899"/>
                    </a:cubicBezTo>
                    <a:cubicBezTo>
                      <a:pt x="432626" y="164842"/>
                      <a:pt x="432915" y="163976"/>
                      <a:pt x="433204" y="163110"/>
                    </a:cubicBezTo>
                    <a:cubicBezTo>
                      <a:pt x="433493" y="162341"/>
                      <a:pt x="433589" y="161764"/>
                      <a:pt x="433878" y="160995"/>
                    </a:cubicBezTo>
                    <a:lnTo>
                      <a:pt x="326213" y="104060"/>
                    </a:lnTo>
                    <a:cubicBezTo>
                      <a:pt x="325539" y="104829"/>
                      <a:pt x="324865" y="105406"/>
                      <a:pt x="324287" y="106079"/>
                    </a:cubicBezTo>
                    <a:cubicBezTo>
                      <a:pt x="323613" y="106656"/>
                      <a:pt x="323131" y="107426"/>
                      <a:pt x="322457" y="108099"/>
                    </a:cubicBezTo>
                    <a:cubicBezTo>
                      <a:pt x="321109" y="109349"/>
                      <a:pt x="319568" y="110600"/>
                      <a:pt x="318220" y="111850"/>
                    </a:cubicBezTo>
                    <a:cubicBezTo>
                      <a:pt x="317739" y="112235"/>
                      <a:pt x="317161" y="112715"/>
                      <a:pt x="316679" y="113100"/>
                    </a:cubicBezTo>
                    <a:cubicBezTo>
                      <a:pt x="314657" y="114639"/>
                      <a:pt x="312538" y="115985"/>
                      <a:pt x="310323" y="117428"/>
                    </a:cubicBezTo>
                    <a:lnTo>
                      <a:pt x="308879" y="118197"/>
                    </a:lnTo>
                    <a:cubicBezTo>
                      <a:pt x="307049" y="119159"/>
                      <a:pt x="305316" y="120025"/>
                      <a:pt x="303582" y="120794"/>
                    </a:cubicBezTo>
                    <a:cubicBezTo>
                      <a:pt x="302812" y="121179"/>
                      <a:pt x="301849" y="121467"/>
                      <a:pt x="300982" y="121852"/>
                    </a:cubicBezTo>
                    <a:cubicBezTo>
                      <a:pt x="299441" y="122429"/>
                      <a:pt x="297804" y="123006"/>
                      <a:pt x="296360" y="123487"/>
                    </a:cubicBezTo>
                    <a:cubicBezTo>
                      <a:pt x="295397" y="123679"/>
                      <a:pt x="294434" y="123968"/>
                      <a:pt x="293567" y="124256"/>
                    </a:cubicBezTo>
                    <a:cubicBezTo>
                      <a:pt x="291930" y="124641"/>
                      <a:pt x="290100" y="125026"/>
                      <a:pt x="288367" y="125218"/>
                    </a:cubicBezTo>
                    <a:lnTo>
                      <a:pt x="285959" y="125795"/>
                    </a:lnTo>
                    <a:cubicBezTo>
                      <a:pt x="283263" y="125987"/>
                      <a:pt x="280759" y="126276"/>
                      <a:pt x="278159" y="126276"/>
                    </a:cubicBezTo>
                    <a:cubicBezTo>
                      <a:pt x="275462" y="126276"/>
                      <a:pt x="272958" y="125987"/>
                      <a:pt x="270262" y="125795"/>
                    </a:cubicBezTo>
                    <a:lnTo>
                      <a:pt x="267854" y="125218"/>
                    </a:lnTo>
                    <a:cubicBezTo>
                      <a:pt x="266121" y="125026"/>
                      <a:pt x="264388" y="124641"/>
                      <a:pt x="262654" y="124256"/>
                    </a:cubicBezTo>
                    <a:cubicBezTo>
                      <a:pt x="261787" y="123968"/>
                      <a:pt x="260824" y="123679"/>
                      <a:pt x="259958" y="123487"/>
                    </a:cubicBezTo>
                    <a:cubicBezTo>
                      <a:pt x="258417" y="123006"/>
                      <a:pt x="256780" y="122429"/>
                      <a:pt x="255239" y="121852"/>
                    </a:cubicBezTo>
                    <a:cubicBezTo>
                      <a:pt x="254372" y="121467"/>
                      <a:pt x="253505" y="121179"/>
                      <a:pt x="252735" y="120794"/>
                    </a:cubicBezTo>
                    <a:cubicBezTo>
                      <a:pt x="250905" y="120025"/>
                      <a:pt x="249172" y="119159"/>
                      <a:pt x="247535" y="118197"/>
                    </a:cubicBezTo>
                    <a:cubicBezTo>
                      <a:pt x="246861" y="117909"/>
                      <a:pt x="246379" y="117620"/>
                      <a:pt x="245898" y="117332"/>
                    </a:cubicBezTo>
                    <a:cubicBezTo>
                      <a:pt x="243779" y="115985"/>
                      <a:pt x="241564" y="114639"/>
                      <a:pt x="239542" y="113100"/>
                    </a:cubicBezTo>
                    <a:cubicBezTo>
                      <a:pt x="239060" y="112619"/>
                      <a:pt x="238579" y="112235"/>
                      <a:pt x="238001" y="111754"/>
                    </a:cubicBezTo>
                    <a:cubicBezTo>
                      <a:pt x="236556" y="110600"/>
                      <a:pt x="235112" y="109349"/>
                      <a:pt x="233860" y="108099"/>
                    </a:cubicBezTo>
                    <a:cubicBezTo>
                      <a:pt x="233282" y="107426"/>
                      <a:pt x="232608" y="106656"/>
                      <a:pt x="231934" y="106079"/>
                    </a:cubicBezTo>
                    <a:cubicBezTo>
                      <a:pt x="231356" y="105406"/>
                      <a:pt x="230586" y="104829"/>
                      <a:pt x="230104" y="104060"/>
                    </a:cubicBezTo>
                    <a:close/>
                    <a:moveTo>
                      <a:pt x="278159" y="0"/>
                    </a:moveTo>
                    <a:cubicBezTo>
                      <a:pt x="313020" y="0"/>
                      <a:pt x="341332" y="28275"/>
                      <a:pt x="341332" y="63090"/>
                    </a:cubicBezTo>
                    <a:cubicBezTo>
                      <a:pt x="341332" y="69533"/>
                      <a:pt x="340177" y="75881"/>
                      <a:pt x="338347" y="81940"/>
                    </a:cubicBezTo>
                    <a:lnTo>
                      <a:pt x="447264" y="139548"/>
                    </a:lnTo>
                    <a:cubicBezTo>
                      <a:pt x="451309" y="135316"/>
                      <a:pt x="456028" y="131565"/>
                      <a:pt x="461324" y="128392"/>
                    </a:cubicBezTo>
                    <a:cubicBezTo>
                      <a:pt x="491563" y="111080"/>
                      <a:pt x="530180" y="121371"/>
                      <a:pt x="547803" y="151473"/>
                    </a:cubicBezTo>
                    <a:cubicBezTo>
                      <a:pt x="556277" y="166188"/>
                      <a:pt x="558396" y="183211"/>
                      <a:pt x="553966" y="199465"/>
                    </a:cubicBezTo>
                    <a:cubicBezTo>
                      <a:pt x="549729" y="215814"/>
                      <a:pt x="539232" y="229278"/>
                      <a:pt x="524498" y="237646"/>
                    </a:cubicBezTo>
                    <a:cubicBezTo>
                      <a:pt x="520742" y="239858"/>
                      <a:pt x="516697" y="241493"/>
                      <a:pt x="512556" y="242935"/>
                    </a:cubicBezTo>
                    <a:lnTo>
                      <a:pt x="512556" y="362960"/>
                    </a:lnTo>
                    <a:cubicBezTo>
                      <a:pt x="516794" y="364403"/>
                      <a:pt x="520838" y="366134"/>
                      <a:pt x="524690" y="368442"/>
                    </a:cubicBezTo>
                    <a:cubicBezTo>
                      <a:pt x="539232" y="376617"/>
                      <a:pt x="549729" y="390273"/>
                      <a:pt x="553966" y="406527"/>
                    </a:cubicBezTo>
                    <a:cubicBezTo>
                      <a:pt x="555507" y="412105"/>
                      <a:pt x="556277" y="417683"/>
                      <a:pt x="556277" y="423261"/>
                    </a:cubicBezTo>
                    <a:cubicBezTo>
                      <a:pt x="556277" y="434032"/>
                      <a:pt x="553388" y="444804"/>
                      <a:pt x="547803" y="454517"/>
                    </a:cubicBezTo>
                    <a:cubicBezTo>
                      <a:pt x="536054" y="474714"/>
                      <a:pt x="514675" y="485966"/>
                      <a:pt x="492911" y="485966"/>
                    </a:cubicBezTo>
                    <a:cubicBezTo>
                      <a:pt x="482125" y="485966"/>
                      <a:pt x="471339" y="483273"/>
                      <a:pt x="461324" y="477503"/>
                    </a:cubicBezTo>
                    <a:cubicBezTo>
                      <a:pt x="456028" y="474522"/>
                      <a:pt x="451405" y="470675"/>
                      <a:pt x="447360" y="466443"/>
                    </a:cubicBezTo>
                    <a:lnTo>
                      <a:pt x="338251" y="524051"/>
                    </a:lnTo>
                    <a:cubicBezTo>
                      <a:pt x="340177" y="530110"/>
                      <a:pt x="341332" y="536457"/>
                      <a:pt x="341332" y="542901"/>
                    </a:cubicBezTo>
                    <a:cubicBezTo>
                      <a:pt x="341332" y="577620"/>
                      <a:pt x="313020" y="606087"/>
                      <a:pt x="278159" y="606087"/>
                    </a:cubicBezTo>
                    <a:cubicBezTo>
                      <a:pt x="243201" y="606087"/>
                      <a:pt x="214889" y="577620"/>
                      <a:pt x="214889" y="542901"/>
                    </a:cubicBezTo>
                    <a:cubicBezTo>
                      <a:pt x="214889" y="536457"/>
                      <a:pt x="216044" y="530110"/>
                      <a:pt x="217970" y="524051"/>
                    </a:cubicBezTo>
                    <a:lnTo>
                      <a:pt x="108861" y="466443"/>
                    </a:lnTo>
                    <a:cubicBezTo>
                      <a:pt x="104816" y="470675"/>
                      <a:pt x="100193" y="474522"/>
                      <a:pt x="94897" y="477503"/>
                    </a:cubicBezTo>
                    <a:cubicBezTo>
                      <a:pt x="84978" y="483273"/>
                      <a:pt x="74096" y="485966"/>
                      <a:pt x="63310" y="485966"/>
                    </a:cubicBezTo>
                    <a:cubicBezTo>
                      <a:pt x="41546" y="485966"/>
                      <a:pt x="20167" y="474714"/>
                      <a:pt x="8418" y="454517"/>
                    </a:cubicBezTo>
                    <a:cubicBezTo>
                      <a:pt x="-56" y="439899"/>
                      <a:pt x="-2175" y="422876"/>
                      <a:pt x="2255" y="406527"/>
                    </a:cubicBezTo>
                    <a:cubicBezTo>
                      <a:pt x="6588" y="390273"/>
                      <a:pt x="17085" y="376617"/>
                      <a:pt x="31723" y="368250"/>
                    </a:cubicBezTo>
                    <a:cubicBezTo>
                      <a:pt x="35479" y="366134"/>
                      <a:pt x="39524" y="364403"/>
                      <a:pt x="43761" y="362960"/>
                    </a:cubicBezTo>
                    <a:lnTo>
                      <a:pt x="43761" y="242935"/>
                    </a:lnTo>
                    <a:cubicBezTo>
                      <a:pt x="39427" y="241493"/>
                      <a:pt x="35383" y="239858"/>
                      <a:pt x="31627" y="237646"/>
                    </a:cubicBezTo>
                    <a:cubicBezTo>
                      <a:pt x="17085" y="229278"/>
                      <a:pt x="6588" y="215814"/>
                      <a:pt x="2255" y="199465"/>
                    </a:cubicBezTo>
                    <a:cubicBezTo>
                      <a:pt x="-2175" y="183211"/>
                      <a:pt x="-56" y="166188"/>
                      <a:pt x="8418" y="151473"/>
                    </a:cubicBezTo>
                    <a:cubicBezTo>
                      <a:pt x="26041" y="121371"/>
                      <a:pt x="64755" y="111080"/>
                      <a:pt x="94897" y="128392"/>
                    </a:cubicBezTo>
                    <a:cubicBezTo>
                      <a:pt x="100193" y="131565"/>
                      <a:pt x="104816" y="135316"/>
                      <a:pt x="108861" y="139548"/>
                    </a:cubicBezTo>
                    <a:lnTo>
                      <a:pt x="217970" y="81940"/>
                    </a:lnTo>
                    <a:cubicBezTo>
                      <a:pt x="216044" y="75881"/>
                      <a:pt x="214889" y="69533"/>
                      <a:pt x="214889" y="63090"/>
                    </a:cubicBezTo>
                    <a:cubicBezTo>
                      <a:pt x="214889" y="28275"/>
                      <a:pt x="243201" y="0"/>
                      <a:pt x="278159" y="0"/>
                    </a:cubicBezTo>
                    <a:close/>
                  </a:path>
                </a:pathLst>
              </a:cu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1" name="椭圆 120">
                <a:extLst>
                  <a:ext uri="{FF2B5EF4-FFF2-40B4-BE49-F238E27FC236}">
                    <a16:creationId xmlns:a16="http://schemas.microsoft.com/office/drawing/2014/main" id="{5742E481-D817-57E3-E9EE-81D7530438A2}"/>
                  </a:ext>
                </a:extLst>
              </p:cNvPr>
              <p:cNvSpPr/>
              <p:nvPr/>
            </p:nvSpPr>
            <p:spPr>
              <a:xfrm>
                <a:off x="-853081" y="2880834"/>
                <a:ext cx="764608" cy="240078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122" name="组合 121">
                <a:extLst>
                  <a:ext uri="{FF2B5EF4-FFF2-40B4-BE49-F238E27FC236}">
                    <a16:creationId xmlns:a16="http://schemas.microsoft.com/office/drawing/2014/main" id="{26DC27DC-1BB8-2FFC-0321-21844A34266B}"/>
                  </a:ext>
                </a:extLst>
              </p:cNvPr>
              <p:cNvGrpSpPr/>
              <p:nvPr/>
            </p:nvGrpSpPr>
            <p:grpSpPr>
              <a:xfrm>
                <a:off x="-817573" y="3006063"/>
                <a:ext cx="693591" cy="254633"/>
                <a:chOff x="-1250413" y="4133558"/>
                <a:chExt cx="1118956" cy="585932"/>
              </a:xfrm>
              <a:grpFill/>
            </p:grpSpPr>
            <p:cxnSp>
              <p:nvCxnSpPr>
                <p:cNvPr id="123" name="直接连接符 122">
                  <a:extLst>
                    <a:ext uri="{FF2B5EF4-FFF2-40B4-BE49-F238E27FC236}">
                      <a16:creationId xmlns:a16="http://schemas.microsoft.com/office/drawing/2014/main" id="{B88477AE-E8E7-414C-461C-A762787F63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207022" y="4445794"/>
                  <a:ext cx="1032361" cy="0"/>
                </a:xfrm>
                <a:prstGeom prst="line">
                  <a:avLst/>
                </a:prstGeom>
                <a:grpFill/>
                <a:ln w="6350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24" name="任意多边形: 形状 123">
                  <a:extLst>
                    <a:ext uri="{FF2B5EF4-FFF2-40B4-BE49-F238E27FC236}">
                      <a16:creationId xmlns:a16="http://schemas.microsoft.com/office/drawing/2014/main" id="{6086F375-6C68-4783-5435-AB5F1FDAA90C}"/>
                    </a:ext>
                  </a:extLst>
                </p:cNvPr>
                <p:cNvSpPr/>
                <p:nvPr/>
              </p:nvSpPr>
              <p:spPr>
                <a:xfrm>
                  <a:off x="-181477" y="4133558"/>
                  <a:ext cx="50020" cy="580795"/>
                </a:xfrm>
                <a:custGeom>
                  <a:avLst/>
                  <a:gdLst>
                    <a:gd name="connsiteX0" fmla="*/ 6816 w 50020"/>
                    <a:gd name="connsiteY0" fmla="*/ 304878 h 580795"/>
                    <a:gd name="connsiteX1" fmla="*/ 1679 w 50020"/>
                    <a:gd name="connsiteY1" fmla="*/ 48024 h 580795"/>
                    <a:gd name="connsiteX2" fmla="*/ 32502 w 50020"/>
                    <a:gd name="connsiteY2" fmla="*/ 6927 h 580795"/>
                    <a:gd name="connsiteX3" fmla="*/ 42776 w 50020"/>
                    <a:gd name="connsiteY3" fmla="*/ 135354 h 580795"/>
                    <a:gd name="connsiteX4" fmla="*/ 47913 w 50020"/>
                    <a:gd name="connsiteY4" fmla="*/ 351112 h 580795"/>
                    <a:gd name="connsiteX5" fmla="*/ 47913 w 50020"/>
                    <a:gd name="connsiteY5" fmla="*/ 541184 h 580795"/>
                    <a:gd name="connsiteX6" fmla="*/ 22228 w 50020"/>
                    <a:gd name="connsiteY6" fmla="*/ 577143 h 580795"/>
                    <a:gd name="connsiteX7" fmla="*/ 11953 w 50020"/>
                    <a:gd name="connsiteY7" fmla="*/ 484676 h 580795"/>
                    <a:gd name="connsiteX8" fmla="*/ 11953 w 50020"/>
                    <a:gd name="connsiteY8" fmla="*/ 361386 h 580795"/>
                    <a:gd name="connsiteX9" fmla="*/ 11953 w 50020"/>
                    <a:gd name="connsiteY9" fmla="*/ 361386 h 58079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0020" h="580795">
                      <a:moveTo>
                        <a:pt x="6816" y="304878"/>
                      </a:moveTo>
                      <a:cubicBezTo>
                        <a:pt x="2107" y="201280"/>
                        <a:pt x="-2602" y="97682"/>
                        <a:pt x="1679" y="48024"/>
                      </a:cubicBezTo>
                      <a:cubicBezTo>
                        <a:pt x="5960" y="-1634"/>
                        <a:pt x="25653" y="-7628"/>
                        <a:pt x="32502" y="6927"/>
                      </a:cubicBezTo>
                      <a:cubicBezTo>
                        <a:pt x="39352" y="21482"/>
                        <a:pt x="40208" y="77990"/>
                        <a:pt x="42776" y="135354"/>
                      </a:cubicBezTo>
                      <a:cubicBezTo>
                        <a:pt x="45344" y="192718"/>
                        <a:pt x="47057" y="283474"/>
                        <a:pt x="47913" y="351112"/>
                      </a:cubicBezTo>
                      <a:cubicBezTo>
                        <a:pt x="48769" y="418750"/>
                        <a:pt x="52194" y="503512"/>
                        <a:pt x="47913" y="541184"/>
                      </a:cubicBezTo>
                      <a:cubicBezTo>
                        <a:pt x="43632" y="578856"/>
                        <a:pt x="28221" y="586561"/>
                        <a:pt x="22228" y="577143"/>
                      </a:cubicBezTo>
                      <a:cubicBezTo>
                        <a:pt x="16235" y="567725"/>
                        <a:pt x="13665" y="520635"/>
                        <a:pt x="11953" y="484676"/>
                      </a:cubicBezTo>
                      <a:cubicBezTo>
                        <a:pt x="10241" y="448717"/>
                        <a:pt x="11953" y="361386"/>
                        <a:pt x="11953" y="361386"/>
                      </a:cubicBezTo>
                      <a:lnTo>
                        <a:pt x="11953" y="361386"/>
                      </a:lnTo>
                    </a:path>
                  </a:pathLst>
                </a:custGeom>
                <a:grpFill/>
                <a:ln w="3175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25" name="任意多边形: 形状 124">
                  <a:extLst>
                    <a:ext uri="{FF2B5EF4-FFF2-40B4-BE49-F238E27FC236}">
                      <a16:creationId xmlns:a16="http://schemas.microsoft.com/office/drawing/2014/main" id="{C614DA16-A27D-B019-0013-C3D776A1B80A}"/>
                    </a:ext>
                  </a:extLst>
                </p:cNvPr>
                <p:cNvSpPr/>
                <p:nvPr/>
              </p:nvSpPr>
              <p:spPr>
                <a:xfrm flipH="1">
                  <a:off x="-1250413" y="4138695"/>
                  <a:ext cx="50020" cy="580795"/>
                </a:xfrm>
                <a:custGeom>
                  <a:avLst/>
                  <a:gdLst>
                    <a:gd name="connsiteX0" fmla="*/ 6816 w 50020"/>
                    <a:gd name="connsiteY0" fmla="*/ 304878 h 580795"/>
                    <a:gd name="connsiteX1" fmla="*/ 1679 w 50020"/>
                    <a:gd name="connsiteY1" fmla="*/ 48024 h 580795"/>
                    <a:gd name="connsiteX2" fmla="*/ 32502 w 50020"/>
                    <a:gd name="connsiteY2" fmla="*/ 6927 h 580795"/>
                    <a:gd name="connsiteX3" fmla="*/ 42776 w 50020"/>
                    <a:gd name="connsiteY3" fmla="*/ 135354 h 580795"/>
                    <a:gd name="connsiteX4" fmla="*/ 47913 w 50020"/>
                    <a:gd name="connsiteY4" fmla="*/ 351112 h 580795"/>
                    <a:gd name="connsiteX5" fmla="*/ 47913 w 50020"/>
                    <a:gd name="connsiteY5" fmla="*/ 541184 h 580795"/>
                    <a:gd name="connsiteX6" fmla="*/ 22228 w 50020"/>
                    <a:gd name="connsiteY6" fmla="*/ 577143 h 580795"/>
                    <a:gd name="connsiteX7" fmla="*/ 11953 w 50020"/>
                    <a:gd name="connsiteY7" fmla="*/ 484676 h 580795"/>
                    <a:gd name="connsiteX8" fmla="*/ 11953 w 50020"/>
                    <a:gd name="connsiteY8" fmla="*/ 361386 h 580795"/>
                    <a:gd name="connsiteX9" fmla="*/ 11953 w 50020"/>
                    <a:gd name="connsiteY9" fmla="*/ 361386 h 58079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0020" h="580795">
                      <a:moveTo>
                        <a:pt x="6816" y="304878"/>
                      </a:moveTo>
                      <a:cubicBezTo>
                        <a:pt x="2107" y="201280"/>
                        <a:pt x="-2602" y="97682"/>
                        <a:pt x="1679" y="48024"/>
                      </a:cubicBezTo>
                      <a:cubicBezTo>
                        <a:pt x="5960" y="-1634"/>
                        <a:pt x="25653" y="-7628"/>
                        <a:pt x="32502" y="6927"/>
                      </a:cubicBezTo>
                      <a:cubicBezTo>
                        <a:pt x="39352" y="21482"/>
                        <a:pt x="40208" y="77990"/>
                        <a:pt x="42776" y="135354"/>
                      </a:cubicBezTo>
                      <a:cubicBezTo>
                        <a:pt x="45344" y="192718"/>
                        <a:pt x="47057" y="283474"/>
                        <a:pt x="47913" y="351112"/>
                      </a:cubicBezTo>
                      <a:cubicBezTo>
                        <a:pt x="48769" y="418750"/>
                        <a:pt x="52194" y="503512"/>
                        <a:pt x="47913" y="541184"/>
                      </a:cubicBezTo>
                      <a:cubicBezTo>
                        <a:pt x="43632" y="578856"/>
                        <a:pt x="28221" y="586561"/>
                        <a:pt x="22228" y="577143"/>
                      </a:cubicBezTo>
                      <a:cubicBezTo>
                        <a:pt x="16235" y="567725"/>
                        <a:pt x="13665" y="520635"/>
                        <a:pt x="11953" y="484676"/>
                      </a:cubicBezTo>
                      <a:cubicBezTo>
                        <a:pt x="10241" y="448717"/>
                        <a:pt x="11953" y="361386"/>
                        <a:pt x="11953" y="361386"/>
                      </a:cubicBezTo>
                      <a:lnTo>
                        <a:pt x="11953" y="361386"/>
                      </a:lnTo>
                    </a:path>
                  </a:pathLst>
                </a:custGeom>
                <a:grpFill/>
                <a:ln w="3175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grpSp>
          <p:nvGrpSpPr>
            <p:cNvPr id="126" name="组合 125">
              <a:extLst>
                <a:ext uri="{FF2B5EF4-FFF2-40B4-BE49-F238E27FC236}">
                  <a16:creationId xmlns:a16="http://schemas.microsoft.com/office/drawing/2014/main" id="{58DACEB6-476B-2EAA-B52B-7D3CD0C3C1F2}"/>
                </a:ext>
              </a:extLst>
            </p:cNvPr>
            <p:cNvGrpSpPr/>
            <p:nvPr/>
          </p:nvGrpSpPr>
          <p:grpSpPr>
            <a:xfrm>
              <a:off x="1536916" y="1586493"/>
              <a:ext cx="107121" cy="116713"/>
              <a:chOff x="-1207022" y="2342961"/>
              <a:chExt cx="1476700" cy="1608927"/>
            </a:xfrm>
            <a:solidFill>
              <a:srgbClr val="FFBE7A"/>
            </a:solidFill>
          </p:grpSpPr>
          <p:sp>
            <p:nvSpPr>
              <p:cNvPr id="127" name="shield_348433">
                <a:extLst>
                  <a:ext uri="{FF2B5EF4-FFF2-40B4-BE49-F238E27FC236}">
                    <a16:creationId xmlns:a16="http://schemas.microsoft.com/office/drawing/2014/main" id="{D3A45583-F34D-3999-AEC2-6D8F538A4A13}"/>
                  </a:ext>
                </a:extLst>
              </p:cNvPr>
              <p:cNvSpPr/>
              <p:nvPr/>
            </p:nvSpPr>
            <p:spPr>
              <a:xfrm>
                <a:off x="-1207022" y="2342961"/>
                <a:ext cx="1476700" cy="1608927"/>
              </a:xfrm>
              <a:custGeom>
                <a:avLst/>
                <a:gdLst>
                  <a:gd name="connsiteX0" fmla="*/ 373273 h 605239"/>
                  <a:gd name="connsiteY0" fmla="*/ 373273 h 605239"/>
                  <a:gd name="connsiteX1" fmla="*/ 373273 h 605239"/>
                  <a:gd name="connsiteY1" fmla="*/ 373273 h 605239"/>
                  <a:gd name="connsiteX2" fmla="*/ 373273 h 605239"/>
                  <a:gd name="connsiteY2" fmla="*/ 373273 h 605239"/>
                  <a:gd name="connsiteX3" fmla="*/ 373273 h 605239"/>
                  <a:gd name="connsiteY3" fmla="*/ 373273 h 605239"/>
                  <a:gd name="connsiteX4" fmla="*/ 373273 h 605239"/>
                  <a:gd name="connsiteY4" fmla="*/ 373273 h 605239"/>
                  <a:gd name="connsiteX5" fmla="*/ 373273 h 605239"/>
                  <a:gd name="connsiteY5" fmla="*/ 373273 h 605239"/>
                  <a:gd name="connsiteX6" fmla="*/ 373273 h 605239"/>
                  <a:gd name="connsiteY6" fmla="*/ 373273 h 605239"/>
                  <a:gd name="connsiteX7" fmla="*/ 373273 h 605239"/>
                  <a:gd name="connsiteY7" fmla="*/ 373273 h 605239"/>
                  <a:gd name="connsiteX8" fmla="*/ 373273 h 605239"/>
                  <a:gd name="connsiteY8" fmla="*/ 373273 h 605239"/>
                  <a:gd name="connsiteX9" fmla="*/ 373273 h 605239"/>
                  <a:gd name="connsiteY9" fmla="*/ 373273 h 605239"/>
                  <a:gd name="connsiteX10" fmla="*/ 373273 h 605239"/>
                  <a:gd name="connsiteY10" fmla="*/ 373273 h 605239"/>
                  <a:gd name="connsiteX11" fmla="*/ 373273 h 605239"/>
                  <a:gd name="connsiteY11" fmla="*/ 373273 h 605239"/>
                  <a:gd name="connsiteX12" fmla="*/ 373273 h 605239"/>
                  <a:gd name="connsiteY12" fmla="*/ 373273 h 605239"/>
                  <a:gd name="connsiteX13" fmla="*/ 373273 h 605239"/>
                  <a:gd name="connsiteY13" fmla="*/ 373273 h 605239"/>
                  <a:gd name="connsiteX14" fmla="*/ 373273 h 605239"/>
                  <a:gd name="connsiteY14" fmla="*/ 373273 h 605239"/>
                  <a:gd name="connsiteX15" fmla="*/ 373273 h 605239"/>
                  <a:gd name="connsiteY15" fmla="*/ 373273 h 605239"/>
                  <a:gd name="connsiteX16" fmla="*/ 373273 h 605239"/>
                  <a:gd name="connsiteY16" fmla="*/ 373273 h 605239"/>
                  <a:gd name="connsiteX17" fmla="*/ 373273 h 605239"/>
                  <a:gd name="connsiteY17" fmla="*/ 373273 h 605239"/>
                  <a:gd name="connsiteX18" fmla="*/ 373273 h 605239"/>
                  <a:gd name="connsiteY18" fmla="*/ 373273 h 605239"/>
                  <a:gd name="connsiteX19" fmla="*/ 373273 h 605239"/>
                  <a:gd name="connsiteY19" fmla="*/ 373273 h 605239"/>
                  <a:gd name="connsiteX20" fmla="*/ 373273 h 605239"/>
                  <a:gd name="connsiteY20" fmla="*/ 373273 h 605239"/>
                  <a:gd name="connsiteX21" fmla="*/ 373273 h 605239"/>
                  <a:gd name="connsiteY21" fmla="*/ 373273 h 605239"/>
                  <a:gd name="connsiteX22" fmla="*/ 373273 h 605239"/>
                  <a:gd name="connsiteY22" fmla="*/ 373273 h 605239"/>
                  <a:gd name="connsiteX23" fmla="*/ 373273 h 605239"/>
                  <a:gd name="connsiteY23" fmla="*/ 373273 h 605239"/>
                  <a:gd name="connsiteX24" fmla="*/ 373273 h 605239"/>
                  <a:gd name="connsiteY24" fmla="*/ 373273 h 605239"/>
                  <a:gd name="connsiteX25" fmla="*/ 373273 h 605239"/>
                  <a:gd name="connsiteY25" fmla="*/ 373273 h 605239"/>
                  <a:gd name="connsiteX26" fmla="*/ 373273 h 605239"/>
                  <a:gd name="connsiteY26" fmla="*/ 373273 h 605239"/>
                  <a:gd name="connsiteX27" fmla="*/ 373273 h 605239"/>
                  <a:gd name="connsiteY27" fmla="*/ 373273 h 605239"/>
                  <a:gd name="connsiteX28" fmla="*/ 373273 h 605239"/>
                  <a:gd name="connsiteY28" fmla="*/ 373273 h 605239"/>
                  <a:gd name="connsiteX29" fmla="*/ 373273 h 605239"/>
                  <a:gd name="connsiteY29" fmla="*/ 373273 h 605239"/>
                  <a:gd name="connsiteX30" fmla="*/ 373273 h 605239"/>
                  <a:gd name="connsiteY30" fmla="*/ 373273 h 605239"/>
                  <a:gd name="connsiteX31" fmla="*/ 373273 h 605239"/>
                  <a:gd name="connsiteY31" fmla="*/ 373273 h 605239"/>
                  <a:gd name="connsiteX32" fmla="*/ 373273 h 605239"/>
                  <a:gd name="connsiteY32" fmla="*/ 373273 h 605239"/>
                  <a:gd name="connsiteX33" fmla="*/ 373273 h 605239"/>
                  <a:gd name="connsiteY33" fmla="*/ 373273 h 605239"/>
                  <a:gd name="connsiteX34" fmla="*/ 373273 h 605239"/>
                  <a:gd name="connsiteY34" fmla="*/ 373273 h 605239"/>
                  <a:gd name="connsiteX35" fmla="*/ 373273 h 605239"/>
                  <a:gd name="connsiteY35" fmla="*/ 373273 h 605239"/>
                  <a:gd name="connsiteX36" fmla="*/ 373273 h 605239"/>
                  <a:gd name="connsiteY36" fmla="*/ 373273 h 605239"/>
                  <a:gd name="connsiteX37" fmla="*/ 373273 h 605239"/>
                  <a:gd name="connsiteY37" fmla="*/ 373273 h 605239"/>
                  <a:gd name="connsiteX38" fmla="*/ 373273 h 605239"/>
                  <a:gd name="connsiteY38" fmla="*/ 373273 h 605239"/>
                  <a:gd name="connsiteX39" fmla="*/ 373273 h 605239"/>
                  <a:gd name="connsiteY39" fmla="*/ 373273 h 605239"/>
                  <a:gd name="connsiteX40" fmla="*/ 373273 h 605239"/>
                  <a:gd name="connsiteY40" fmla="*/ 373273 h 605239"/>
                  <a:gd name="connsiteX41" fmla="*/ 373273 h 605239"/>
                  <a:gd name="connsiteY41" fmla="*/ 373273 h 605239"/>
                  <a:gd name="connsiteX42" fmla="*/ 373273 h 605239"/>
                  <a:gd name="connsiteY42" fmla="*/ 373273 h 605239"/>
                  <a:gd name="connsiteX43" fmla="*/ 373273 h 605239"/>
                  <a:gd name="connsiteY43" fmla="*/ 373273 h 605239"/>
                  <a:gd name="connsiteX44" fmla="*/ 373273 h 605239"/>
                  <a:gd name="connsiteY44" fmla="*/ 373273 h 605239"/>
                  <a:gd name="connsiteX45" fmla="*/ 373273 h 605239"/>
                  <a:gd name="connsiteY45" fmla="*/ 373273 h 605239"/>
                  <a:gd name="connsiteX46" fmla="*/ 373273 h 605239"/>
                  <a:gd name="connsiteY46" fmla="*/ 373273 h 605239"/>
                  <a:gd name="connsiteX47" fmla="*/ 373273 h 605239"/>
                  <a:gd name="connsiteY47" fmla="*/ 373273 h 605239"/>
                  <a:gd name="connsiteX48" fmla="*/ 373273 h 605239"/>
                  <a:gd name="connsiteY48" fmla="*/ 373273 h 605239"/>
                  <a:gd name="connsiteX49" fmla="*/ 373273 h 605239"/>
                  <a:gd name="connsiteY49" fmla="*/ 373273 h 605239"/>
                  <a:gd name="connsiteX50" fmla="*/ 373273 h 605239"/>
                  <a:gd name="connsiteY50" fmla="*/ 373273 h 605239"/>
                  <a:gd name="connsiteX51" fmla="*/ 373273 h 605239"/>
                  <a:gd name="connsiteY51" fmla="*/ 373273 h 605239"/>
                  <a:gd name="connsiteX52" fmla="*/ 373273 h 605239"/>
                  <a:gd name="connsiteY52" fmla="*/ 373273 h 605239"/>
                  <a:gd name="connsiteX53" fmla="*/ 373273 h 605239"/>
                  <a:gd name="connsiteY53" fmla="*/ 373273 h 605239"/>
                  <a:gd name="connsiteX54" fmla="*/ 373273 h 605239"/>
                  <a:gd name="connsiteY54" fmla="*/ 373273 h 605239"/>
                  <a:gd name="connsiteX55" fmla="*/ 373273 h 605239"/>
                  <a:gd name="connsiteY55" fmla="*/ 373273 h 605239"/>
                  <a:gd name="connsiteX56" fmla="*/ 373273 h 605239"/>
                  <a:gd name="connsiteY56" fmla="*/ 373273 h 605239"/>
                  <a:gd name="connsiteX57" fmla="*/ 373273 h 605239"/>
                  <a:gd name="connsiteY57" fmla="*/ 373273 h 605239"/>
                  <a:gd name="connsiteX58" fmla="*/ 373273 h 605239"/>
                  <a:gd name="connsiteY58" fmla="*/ 373273 h 605239"/>
                  <a:gd name="connsiteX59" fmla="*/ 373273 h 605239"/>
                  <a:gd name="connsiteY59" fmla="*/ 373273 h 605239"/>
                  <a:gd name="connsiteX60" fmla="*/ 373273 h 605239"/>
                  <a:gd name="connsiteY60" fmla="*/ 373273 h 605239"/>
                  <a:gd name="connsiteX61" fmla="*/ 373273 h 605239"/>
                  <a:gd name="connsiteY61" fmla="*/ 373273 h 605239"/>
                  <a:gd name="connsiteX62" fmla="*/ 373273 h 605239"/>
                  <a:gd name="connsiteY62" fmla="*/ 373273 h 605239"/>
                  <a:gd name="connsiteX63" fmla="*/ 373273 h 605239"/>
                  <a:gd name="connsiteY63" fmla="*/ 373273 h 605239"/>
                  <a:gd name="connsiteX64" fmla="*/ 373273 h 605239"/>
                  <a:gd name="connsiteY64" fmla="*/ 373273 h 605239"/>
                  <a:gd name="connsiteX65" fmla="*/ 373273 h 605239"/>
                  <a:gd name="connsiteY65" fmla="*/ 373273 h 605239"/>
                  <a:gd name="connsiteX66" fmla="*/ 373273 h 605239"/>
                  <a:gd name="connsiteY66" fmla="*/ 373273 h 605239"/>
                  <a:gd name="connsiteX67" fmla="*/ 373273 h 605239"/>
                  <a:gd name="connsiteY67" fmla="*/ 373273 h 605239"/>
                  <a:gd name="connsiteX68" fmla="*/ 373273 h 605239"/>
                  <a:gd name="connsiteY68" fmla="*/ 373273 h 605239"/>
                  <a:gd name="connsiteX69" fmla="*/ 373273 h 605239"/>
                  <a:gd name="connsiteY69" fmla="*/ 373273 h 605239"/>
                  <a:gd name="connsiteX70" fmla="*/ 373273 h 605239"/>
                  <a:gd name="connsiteY70" fmla="*/ 373273 h 605239"/>
                  <a:gd name="connsiteX71" fmla="*/ 373273 h 605239"/>
                  <a:gd name="connsiteY71" fmla="*/ 373273 h 605239"/>
                  <a:gd name="connsiteX72" fmla="*/ 373273 h 605239"/>
                  <a:gd name="connsiteY72" fmla="*/ 373273 h 605239"/>
                  <a:gd name="connsiteX73" fmla="*/ 373273 h 605239"/>
                  <a:gd name="connsiteY73" fmla="*/ 373273 h 605239"/>
                  <a:gd name="connsiteX74" fmla="*/ 373273 h 605239"/>
                  <a:gd name="connsiteY74" fmla="*/ 373273 h 605239"/>
                  <a:gd name="connsiteX75" fmla="*/ 373273 h 605239"/>
                  <a:gd name="connsiteY75" fmla="*/ 373273 h 605239"/>
                  <a:gd name="connsiteX76" fmla="*/ 373273 h 605239"/>
                  <a:gd name="connsiteY76" fmla="*/ 373273 h 605239"/>
                  <a:gd name="connsiteX77" fmla="*/ 373273 h 605239"/>
                  <a:gd name="connsiteY77" fmla="*/ 373273 h 605239"/>
                  <a:gd name="connsiteX78" fmla="*/ 373273 h 605239"/>
                  <a:gd name="connsiteY78" fmla="*/ 373273 h 605239"/>
                  <a:gd name="connsiteX79" fmla="*/ 373273 h 605239"/>
                  <a:gd name="connsiteY79" fmla="*/ 373273 h 605239"/>
                  <a:gd name="connsiteX80" fmla="*/ 373273 h 605239"/>
                  <a:gd name="connsiteY80" fmla="*/ 373273 h 605239"/>
                  <a:gd name="connsiteX81" fmla="*/ 373273 h 605239"/>
                  <a:gd name="connsiteY81" fmla="*/ 373273 h 605239"/>
                  <a:gd name="connsiteX82" fmla="*/ 373273 h 605239"/>
                  <a:gd name="connsiteY82" fmla="*/ 373273 h 605239"/>
                  <a:gd name="connsiteX83" fmla="*/ 373273 h 605239"/>
                  <a:gd name="connsiteY83" fmla="*/ 373273 h 605239"/>
                  <a:gd name="connsiteX84" fmla="*/ 373273 h 605239"/>
                  <a:gd name="connsiteY84" fmla="*/ 373273 h 605239"/>
                  <a:gd name="connsiteX85" fmla="*/ 373273 h 605239"/>
                  <a:gd name="connsiteY85" fmla="*/ 373273 h 605239"/>
                  <a:gd name="connsiteX86" fmla="*/ 373273 h 605239"/>
                  <a:gd name="connsiteY86" fmla="*/ 373273 h 605239"/>
                  <a:gd name="connsiteX87" fmla="*/ 373273 h 605239"/>
                  <a:gd name="connsiteY87" fmla="*/ 373273 h 605239"/>
                  <a:gd name="connsiteX88" fmla="*/ 373273 h 605239"/>
                  <a:gd name="connsiteY88" fmla="*/ 373273 h 605239"/>
                  <a:gd name="connsiteX89" fmla="*/ 373273 h 605239"/>
                  <a:gd name="connsiteY89" fmla="*/ 373273 h 605239"/>
                  <a:gd name="connsiteX90" fmla="*/ 373273 h 605239"/>
                  <a:gd name="connsiteY90" fmla="*/ 373273 h 605239"/>
                  <a:gd name="connsiteX91" fmla="*/ 373273 h 605239"/>
                  <a:gd name="connsiteY91" fmla="*/ 373273 h 605239"/>
                  <a:gd name="connsiteX92" fmla="*/ 373273 h 605239"/>
                  <a:gd name="connsiteY92" fmla="*/ 373273 h 605239"/>
                  <a:gd name="connsiteX93" fmla="*/ 373273 h 605239"/>
                  <a:gd name="connsiteY93" fmla="*/ 373273 h 605239"/>
                  <a:gd name="connsiteX94" fmla="*/ 373273 h 605239"/>
                  <a:gd name="connsiteY94" fmla="*/ 373273 h 605239"/>
                  <a:gd name="connsiteX95" fmla="*/ 373273 h 605239"/>
                  <a:gd name="connsiteY95" fmla="*/ 373273 h 605239"/>
                  <a:gd name="connsiteX96" fmla="*/ 373273 h 605239"/>
                  <a:gd name="connsiteY96" fmla="*/ 373273 h 605239"/>
                  <a:gd name="connsiteX97" fmla="*/ 373273 h 605239"/>
                  <a:gd name="connsiteY97" fmla="*/ 373273 h 605239"/>
                  <a:gd name="connsiteX98" fmla="*/ 373273 h 605239"/>
                  <a:gd name="connsiteY98" fmla="*/ 373273 h 605239"/>
                  <a:gd name="connsiteX99" fmla="*/ 373273 h 605239"/>
                  <a:gd name="connsiteY99" fmla="*/ 373273 h 605239"/>
                  <a:gd name="connsiteX100" fmla="*/ 373273 h 605239"/>
                  <a:gd name="connsiteY100" fmla="*/ 373273 h 605239"/>
                  <a:gd name="connsiteX101" fmla="*/ 373273 h 605239"/>
                  <a:gd name="connsiteY101" fmla="*/ 373273 h 605239"/>
                  <a:gd name="connsiteX102" fmla="*/ 373273 h 605239"/>
                  <a:gd name="connsiteY102" fmla="*/ 373273 h 605239"/>
                  <a:gd name="connsiteX103" fmla="*/ 373273 h 605239"/>
                  <a:gd name="connsiteY103" fmla="*/ 373273 h 605239"/>
                  <a:gd name="connsiteX104" fmla="*/ 373273 h 605239"/>
                  <a:gd name="connsiteY104" fmla="*/ 373273 h 605239"/>
                  <a:gd name="connsiteX105" fmla="*/ 373273 h 605239"/>
                  <a:gd name="connsiteY105" fmla="*/ 373273 h 605239"/>
                  <a:gd name="connsiteX106" fmla="*/ 373273 h 605239"/>
                  <a:gd name="connsiteY106" fmla="*/ 373273 h 605239"/>
                  <a:gd name="connsiteX107" fmla="*/ 373273 h 605239"/>
                  <a:gd name="connsiteY107" fmla="*/ 373273 h 605239"/>
                  <a:gd name="connsiteX108" fmla="*/ 373273 h 605239"/>
                  <a:gd name="connsiteY108" fmla="*/ 373273 h 605239"/>
                  <a:gd name="connsiteX109" fmla="*/ 373273 h 605239"/>
                  <a:gd name="connsiteY109" fmla="*/ 373273 h 605239"/>
                  <a:gd name="connsiteX110" fmla="*/ 373273 h 605239"/>
                  <a:gd name="connsiteY110" fmla="*/ 373273 h 605239"/>
                  <a:gd name="connsiteX111" fmla="*/ 373273 h 605239"/>
                  <a:gd name="connsiteY111" fmla="*/ 373273 h 605239"/>
                  <a:gd name="connsiteX112" fmla="*/ 373273 h 605239"/>
                  <a:gd name="connsiteY112" fmla="*/ 373273 h 605239"/>
                  <a:gd name="connsiteX113" fmla="*/ 373273 h 605239"/>
                  <a:gd name="connsiteY113" fmla="*/ 373273 h 605239"/>
                  <a:gd name="connsiteX114" fmla="*/ 373273 h 605239"/>
                  <a:gd name="connsiteY114" fmla="*/ 373273 h 605239"/>
                  <a:gd name="connsiteX115" fmla="*/ 373273 h 605239"/>
                  <a:gd name="connsiteY115" fmla="*/ 373273 h 605239"/>
                  <a:gd name="connsiteX116" fmla="*/ 373273 h 605239"/>
                  <a:gd name="connsiteY116" fmla="*/ 373273 h 605239"/>
                  <a:gd name="connsiteX117" fmla="*/ 373273 h 605239"/>
                  <a:gd name="connsiteY117" fmla="*/ 373273 h 605239"/>
                  <a:gd name="connsiteX118" fmla="*/ 373273 h 605239"/>
                  <a:gd name="connsiteY118" fmla="*/ 373273 h 605239"/>
                  <a:gd name="connsiteX119" fmla="*/ 373273 h 605239"/>
                  <a:gd name="connsiteY119" fmla="*/ 373273 h 605239"/>
                  <a:gd name="connsiteX120" fmla="*/ 373273 h 605239"/>
                  <a:gd name="connsiteY120" fmla="*/ 373273 h 605239"/>
                  <a:gd name="connsiteX121" fmla="*/ 373273 h 605239"/>
                  <a:gd name="connsiteY121" fmla="*/ 373273 h 605239"/>
                  <a:gd name="connsiteX122" fmla="*/ 373273 h 605239"/>
                  <a:gd name="connsiteY122" fmla="*/ 373273 h 605239"/>
                  <a:gd name="connsiteX123" fmla="*/ 373273 h 605239"/>
                  <a:gd name="connsiteY123" fmla="*/ 373273 h 605239"/>
                  <a:gd name="connsiteX124" fmla="*/ 373273 h 605239"/>
                  <a:gd name="connsiteY124" fmla="*/ 373273 h 605239"/>
                  <a:gd name="connsiteX125" fmla="*/ 373273 h 605239"/>
                  <a:gd name="connsiteY125" fmla="*/ 373273 h 605239"/>
                  <a:gd name="connsiteX126" fmla="*/ 373273 h 605239"/>
                  <a:gd name="connsiteY126" fmla="*/ 373273 h 605239"/>
                  <a:gd name="connsiteX127" fmla="*/ 373273 h 605239"/>
                  <a:gd name="connsiteY127" fmla="*/ 373273 h 605239"/>
                  <a:gd name="connsiteX128" fmla="*/ 373273 h 605239"/>
                  <a:gd name="connsiteY128" fmla="*/ 373273 h 605239"/>
                  <a:gd name="connsiteX129" fmla="*/ 373273 h 605239"/>
                  <a:gd name="connsiteY129" fmla="*/ 373273 h 605239"/>
                  <a:gd name="connsiteX130" fmla="*/ 373273 h 605239"/>
                  <a:gd name="connsiteY130" fmla="*/ 373273 h 605239"/>
                  <a:gd name="connsiteX131" fmla="*/ 373273 h 605239"/>
                  <a:gd name="connsiteY131" fmla="*/ 373273 h 605239"/>
                  <a:gd name="connsiteX132" fmla="*/ 373273 h 605239"/>
                  <a:gd name="connsiteY132" fmla="*/ 373273 h 605239"/>
                  <a:gd name="connsiteX133" fmla="*/ 373273 h 605239"/>
                  <a:gd name="connsiteY133" fmla="*/ 373273 h 605239"/>
                  <a:gd name="connsiteX134" fmla="*/ 373273 h 605239"/>
                  <a:gd name="connsiteY134" fmla="*/ 373273 h 605239"/>
                  <a:gd name="connsiteX135" fmla="*/ 373273 h 605239"/>
                  <a:gd name="connsiteY135" fmla="*/ 373273 h 605239"/>
                  <a:gd name="connsiteX136" fmla="*/ 373273 h 605239"/>
                  <a:gd name="connsiteY136" fmla="*/ 373273 h 605239"/>
                  <a:gd name="connsiteX137" fmla="*/ 373273 h 605239"/>
                  <a:gd name="connsiteY137" fmla="*/ 373273 h 605239"/>
                  <a:gd name="connsiteX138" fmla="*/ 373273 h 605239"/>
                  <a:gd name="connsiteY138" fmla="*/ 373273 h 605239"/>
                  <a:gd name="connsiteX139" fmla="*/ 373273 h 605239"/>
                  <a:gd name="connsiteY139" fmla="*/ 373273 h 605239"/>
                  <a:gd name="connsiteX140" fmla="*/ 373273 h 605239"/>
                  <a:gd name="connsiteY140" fmla="*/ 373273 h 605239"/>
                  <a:gd name="connsiteX141" fmla="*/ 373273 h 605239"/>
                  <a:gd name="connsiteY141" fmla="*/ 373273 h 605239"/>
                  <a:gd name="connsiteX142" fmla="*/ 373273 h 605239"/>
                  <a:gd name="connsiteY142" fmla="*/ 373273 h 605239"/>
                  <a:gd name="connsiteX143" fmla="*/ 373273 h 605239"/>
                  <a:gd name="connsiteY143" fmla="*/ 373273 h 605239"/>
                  <a:gd name="connsiteX144" fmla="*/ 373273 h 605239"/>
                  <a:gd name="connsiteY144" fmla="*/ 373273 h 605239"/>
                  <a:gd name="connsiteX145" fmla="*/ 373273 h 605239"/>
                  <a:gd name="connsiteY145" fmla="*/ 373273 h 605239"/>
                  <a:gd name="connsiteX146" fmla="*/ 373273 h 605239"/>
                  <a:gd name="connsiteY146" fmla="*/ 373273 h 605239"/>
                  <a:gd name="connsiteX147" fmla="*/ 373273 h 605239"/>
                  <a:gd name="connsiteY147" fmla="*/ 373273 h 605239"/>
                  <a:gd name="connsiteX148" fmla="*/ 373273 h 605239"/>
                  <a:gd name="connsiteY148" fmla="*/ 373273 h 605239"/>
                  <a:gd name="connsiteX149" fmla="*/ 373273 h 605239"/>
                  <a:gd name="connsiteY149" fmla="*/ 373273 h 605239"/>
                  <a:gd name="connsiteX150" fmla="*/ 373273 h 605239"/>
                  <a:gd name="connsiteY150" fmla="*/ 373273 h 605239"/>
                  <a:gd name="connsiteX151" fmla="*/ 373273 h 605239"/>
                  <a:gd name="connsiteY151" fmla="*/ 373273 h 605239"/>
                  <a:gd name="connsiteX152" fmla="*/ 373273 h 605239"/>
                  <a:gd name="connsiteY152" fmla="*/ 373273 h 605239"/>
                  <a:gd name="connsiteX153" fmla="*/ 373273 h 605239"/>
                  <a:gd name="connsiteY153" fmla="*/ 373273 h 605239"/>
                  <a:gd name="connsiteX154" fmla="*/ 373273 h 605239"/>
                  <a:gd name="connsiteY154" fmla="*/ 373273 h 605239"/>
                  <a:gd name="connsiteX155" fmla="*/ 373273 h 605239"/>
                  <a:gd name="connsiteY155" fmla="*/ 373273 h 605239"/>
                  <a:gd name="connsiteX156" fmla="*/ 373273 h 605239"/>
                  <a:gd name="connsiteY156" fmla="*/ 373273 h 605239"/>
                  <a:gd name="connsiteX157" fmla="*/ 373273 h 605239"/>
                  <a:gd name="connsiteY157" fmla="*/ 373273 h 605239"/>
                  <a:gd name="connsiteX158" fmla="*/ 373273 h 605239"/>
                  <a:gd name="connsiteY158" fmla="*/ 373273 h 605239"/>
                  <a:gd name="connsiteX159" fmla="*/ 373273 h 605239"/>
                  <a:gd name="connsiteY159" fmla="*/ 373273 h 605239"/>
                  <a:gd name="connsiteX160" fmla="*/ 373273 h 605239"/>
                  <a:gd name="connsiteY160" fmla="*/ 373273 h 605239"/>
                  <a:gd name="connsiteX161" fmla="*/ 373273 h 605239"/>
                  <a:gd name="connsiteY161" fmla="*/ 373273 h 605239"/>
                  <a:gd name="connsiteX162" fmla="*/ 373273 h 605239"/>
                  <a:gd name="connsiteY162" fmla="*/ 373273 h 605239"/>
                  <a:gd name="connsiteX163" fmla="*/ 373273 h 605239"/>
                  <a:gd name="connsiteY163" fmla="*/ 373273 h 605239"/>
                  <a:gd name="connsiteX164" fmla="*/ 373273 h 605239"/>
                  <a:gd name="connsiteY164" fmla="*/ 373273 h 605239"/>
                  <a:gd name="connsiteX165" fmla="*/ 373273 h 605239"/>
                  <a:gd name="connsiteY165" fmla="*/ 373273 h 605239"/>
                  <a:gd name="connsiteX166" fmla="*/ 373273 h 605239"/>
                  <a:gd name="connsiteY166" fmla="*/ 373273 h 605239"/>
                  <a:gd name="connsiteX167" fmla="*/ 373273 h 605239"/>
                  <a:gd name="connsiteY167" fmla="*/ 373273 h 605239"/>
                  <a:gd name="connsiteX168" fmla="*/ 373273 h 605239"/>
                  <a:gd name="connsiteY168" fmla="*/ 373273 h 605239"/>
                  <a:gd name="connsiteX169" fmla="*/ 373273 h 605239"/>
                  <a:gd name="connsiteY169" fmla="*/ 373273 h 605239"/>
                  <a:gd name="connsiteX170" fmla="*/ 373273 h 605239"/>
                  <a:gd name="connsiteY170" fmla="*/ 373273 h 605239"/>
                  <a:gd name="connsiteX171" fmla="*/ 373273 h 605239"/>
                  <a:gd name="connsiteY171" fmla="*/ 373273 h 605239"/>
                  <a:gd name="connsiteX172" fmla="*/ 373273 h 605239"/>
                  <a:gd name="connsiteY172" fmla="*/ 373273 h 605239"/>
                  <a:gd name="connsiteX173" fmla="*/ 373273 h 605239"/>
                  <a:gd name="connsiteY173" fmla="*/ 373273 h 605239"/>
                  <a:gd name="connsiteX174" fmla="*/ 373273 h 605239"/>
                  <a:gd name="connsiteY174" fmla="*/ 373273 h 605239"/>
                  <a:gd name="connsiteX175" fmla="*/ 373273 h 605239"/>
                  <a:gd name="connsiteY175" fmla="*/ 373273 h 605239"/>
                  <a:gd name="connsiteX176" fmla="*/ 373273 h 605239"/>
                  <a:gd name="connsiteY176" fmla="*/ 373273 h 605239"/>
                  <a:gd name="connsiteX177" fmla="*/ 373273 h 605239"/>
                  <a:gd name="connsiteY177" fmla="*/ 373273 h 605239"/>
                  <a:gd name="connsiteX178" fmla="*/ 373273 h 605239"/>
                  <a:gd name="connsiteY178" fmla="*/ 373273 h 605239"/>
                  <a:gd name="connsiteX179" fmla="*/ 373273 h 605239"/>
                  <a:gd name="connsiteY179" fmla="*/ 373273 h 605239"/>
                  <a:gd name="connsiteX180" fmla="*/ 373273 h 605239"/>
                  <a:gd name="connsiteY180" fmla="*/ 373273 h 605239"/>
                  <a:gd name="connsiteX181" fmla="*/ 373273 h 605239"/>
                  <a:gd name="connsiteY181" fmla="*/ 373273 h 605239"/>
                  <a:gd name="connsiteX182" fmla="*/ 373273 h 605239"/>
                  <a:gd name="connsiteY182" fmla="*/ 373273 h 605239"/>
                  <a:gd name="connsiteX183" fmla="*/ 373273 h 605239"/>
                  <a:gd name="connsiteY183" fmla="*/ 373273 h 605239"/>
                  <a:gd name="connsiteX184" fmla="*/ 373273 h 605239"/>
                  <a:gd name="connsiteY184" fmla="*/ 373273 h 605239"/>
                  <a:gd name="connsiteX185" fmla="*/ 373273 h 605239"/>
                  <a:gd name="connsiteY185" fmla="*/ 373273 h 605239"/>
                  <a:gd name="connsiteX186" fmla="*/ 373273 h 605239"/>
                  <a:gd name="connsiteY186" fmla="*/ 373273 h 605239"/>
                  <a:gd name="connsiteX187" fmla="*/ 373273 h 605239"/>
                  <a:gd name="connsiteY187" fmla="*/ 373273 h 605239"/>
                  <a:gd name="connsiteX188" fmla="*/ 373273 h 605239"/>
                  <a:gd name="connsiteY188" fmla="*/ 373273 h 605239"/>
                  <a:gd name="connsiteX189" fmla="*/ 373273 h 605239"/>
                  <a:gd name="connsiteY189" fmla="*/ 373273 h 605239"/>
                  <a:gd name="connsiteX190" fmla="*/ 373273 h 605239"/>
                  <a:gd name="connsiteY190" fmla="*/ 373273 h 605239"/>
                  <a:gd name="connsiteX191" fmla="*/ 373273 h 605239"/>
                  <a:gd name="connsiteY191" fmla="*/ 373273 h 605239"/>
                  <a:gd name="connsiteX192" fmla="*/ 373273 h 605239"/>
                  <a:gd name="connsiteY192" fmla="*/ 373273 h 605239"/>
                  <a:gd name="connsiteX193" fmla="*/ 373273 h 605239"/>
                  <a:gd name="connsiteY193" fmla="*/ 373273 h 605239"/>
                  <a:gd name="connsiteX194" fmla="*/ 373273 h 605239"/>
                  <a:gd name="connsiteY194" fmla="*/ 373273 h 605239"/>
                  <a:gd name="connsiteX195" fmla="*/ 373273 h 605239"/>
                  <a:gd name="connsiteY195" fmla="*/ 373273 h 605239"/>
                  <a:gd name="connsiteX196" fmla="*/ 373273 h 605239"/>
                  <a:gd name="connsiteY196" fmla="*/ 373273 h 605239"/>
                  <a:gd name="connsiteX197" fmla="*/ 373273 h 605239"/>
                  <a:gd name="connsiteY197" fmla="*/ 373273 h 605239"/>
                  <a:gd name="connsiteX198" fmla="*/ 373273 h 605239"/>
                  <a:gd name="connsiteY198" fmla="*/ 373273 h 605239"/>
                  <a:gd name="connsiteX199" fmla="*/ 373273 h 605239"/>
                  <a:gd name="connsiteY199" fmla="*/ 373273 h 605239"/>
                  <a:gd name="connsiteX200" fmla="*/ 373273 h 605239"/>
                  <a:gd name="connsiteY200" fmla="*/ 373273 h 605239"/>
                  <a:gd name="connsiteX201" fmla="*/ 373273 h 605239"/>
                  <a:gd name="connsiteY201" fmla="*/ 373273 h 605239"/>
                  <a:gd name="connsiteX202" fmla="*/ 373273 h 605239"/>
                  <a:gd name="connsiteY202" fmla="*/ 373273 h 605239"/>
                  <a:gd name="connsiteX203" fmla="*/ 373273 h 605239"/>
                  <a:gd name="connsiteY203" fmla="*/ 373273 h 605239"/>
                  <a:gd name="connsiteX204" fmla="*/ 373273 h 605239"/>
                  <a:gd name="connsiteY204" fmla="*/ 373273 h 605239"/>
                  <a:gd name="connsiteX205" fmla="*/ 373273 h 605239"/>
                  <a:gd name="connsiteY205" fmla="*/ 373273 h 605239"/>
                  <a:gd name="connsiteX206" fmla="*/ 373273 h 605239"/>
                  <a:gd name="connsiteY206" fmla="*/ 373273 h 605239"/>
                  <a:gd name="connsiteX207" fmla="*/ 373273 h 605239"/>
                  <a:gd name="connsiteY207" fmla="*/ 373273 h 605239"/>
                  <a:gd name="connsiteX208" fmla="*/ 373273 h 605239"/>
                  <a:gd name="connsiteY208" fmla="*/ 373273 h 605239"/>
                  <a:gd name="connsiteX209" fmla="*/ 373273 h 605239"/>
                  <a:gd name="connsiteY209" fmla="*/ 373273 h 605239"/>
                  <a:gd name="connsiteX210" fmla="*/ 373273 h 605239"/>
                  <a:gd name="connsiteY210" fmla="*/ 373273 h 605239"/>
                  <a:gd name="connsiteX211" fmla="*/ 373273 h 605239"/>
                  <a:gd name="connsiteY211" fmla="*/ 373273 h 605239"/>
                  <a:gd name="connsiteX212" fmla="*/ 373273 h 605239"/>
                  <a:gd name="connsiteY212" fmla="*/ 373273 h 605239"/>
                  <a:gd name="connsiteX213" fmla="*/ 373273 h 605239"/>
                  <a:gd name="connsiteY213" fmla="*/ 373273 h 605239"/>
                  <a:gd name="connsiteX214" fmla="*/ 373273 h 605239"/>
                  <a:gd name="connsiteY214" fmla="*/ 373273 h 605239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428340 h 606087"/>
                  <a:gd name="connsiteX6" fmla="*/ 278159 w 556277"/>
                  <a:gd name="connsiteY6" fmla="*/ 430167 h 606087"/>
                  <a:gd name="connsiteX7" fmla="*/ 273728 w 556277"/>
                  <a:gd name="connsiteY7" fmla="*/ 428340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428340 h 606087"/>
                  <a:gd name="connsiteX6" fmla="*/ 278159 w 556277"/>
                  <a:gd name="connsiteY6" fmla="*/ 430167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428340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0418 w 556277"/>
                  <a:gd name="connsiteY0" fmla="*/ 23611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0418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0418 w 556277"/>
                  <a:gd name="connsiteY0" fmla="*/ 236110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0418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0418 w 556277"/>
                  <a:gd name="connsiteY0" fmla="*/ 236110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0418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2353 w 556277"/>
                  <a:gd name="connsiteY0" fmla="*/ 255462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2353 w 556277"/>
                  <a:gd name="connsiteY12" fmla="*/ 255462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68483 w 556277"/>
                  <a:gd name="connsiteY0" fmla="*/ 236110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68483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68483 w 556277"/>
                  <a:gd name="connsiteY0" fmla="*/ 236110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68483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6224 w 556277"/>
                  <a:gd name="connsiteY0" fmla="*/ 230305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6224 w 556277"/>
                  <a:gd name="connsiteY12" fmla="*/ 230305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6224 w 556277"/>
                  <a:gd name="connsiteY0" fmla="*/ 230305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91145 w 556277"/>
                  <a:gd name="connsiteY7" fmla="*/ 285138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6224 w 556277"/>
                  <a:gd name="connsiteY12" fmla="*/ 230305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6224 w 556277"/>
                  <a:gd name="connsiteY0" fmla="*/ 230305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96951 w 556277"/>
                  <a:gd name="connsiteY7" fmla="*/ 292879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6224 w 556277"/>
                  <a:gd name="connsiteY12" fmla="*/ 230305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  <a:cxn ang="0">
                    <a:pos x="connsiteX169" y="connsiteY169"/>
                  </a:cxn>
                  <a:cxn ang="0">
                    <a:pos x="connsiteX170" y="connsiteY170"/>
                  </a:cxn>
                  <a:cxn ang="0">
                    <a:pos x="connsiteX171" y="connsiteY171"/>
                  </a:cxn>
                  <a:cxn ang="0">
                    <a:pos x="connsiteX172" y="connsiteY172"/>
                  </a:cxn>
                  <a:cxn ang="0">
                    <a:pos x="connsiteX173" y="connsiteY173"/>
                  </a:cxn>
                  <a:cxn ang="0">
                    <a:pos x="connsiteX174" y="connsiteY174"/>
                  </a:cxn>
                  <a:cxn ang="0">
                    <a:pos x="connsiteX175" y="connsiteY175"/>
                  </a:cxn>
                  <a:cxn ang="0">
                    <a:pos x="connsiteX176" y="connsiteY176"/>
                  </a:cxn>
                  <a:cxn ang="0">
                    <a:pos x="connsiteX177" y="connsiteY177"/>
                  </a:cxn>
                  <a:cxn ang="0">
                    <a:pos x="connsiteX178" y="connsiteY178"/>
                  </a:cxn>
                  <a:cxn ang="0">
                    <a:pos x="connsiteX179" y="connsiteY179"/>
                  </a:cxn>
                  <a:cxn ang="0">
                    <a:pos x="connsiteX180" y="connsiteY180"/>
                  </a:cxn>
                  <a:cxn ang="0">
                    <a:pos x="connsiteX181" y="connsiteY181"/>
                  </a:cxn>
                  <a:cxn ang="0">
                    <a:pos x="connsiteX182" y="connsiteY182"/>
                  </a:cxn>
                  <a:cxn ang="0">
                    <a:pos x="connsiteX183" y="connsiteY183"/>
                  </a:cxn>
                  <a:cxn ang="0">
                    <a:pos x="connsiteX184" y="connsiteY184"/>
                  </a:cxn>
                  <a:cxn ang="0">
                    <a:pos x="connsiteX185" y="connsiteY185"/>
                  </a:cxn>
                  <a:cxn ang="0">
                    <a:pos x="connsiteX186" y="connsiteY186"/>
                  </a:cxn>
                  <a:cxn ang="0">
                    <a:pos x="connsiteX187" y="connsiteY187"/>
                  </a:cxn>
                  <a:cxn ang="0">
                    <a:pos x="connsiteX188" y="connsiteY188"/>
                  </a:cxn>
                  <a:cxn ang="0">
                    <a:pos x="connsiteX189" y="connsiteY189"/>
                  </a:cxn>
                  <a:cxn ang="0">
                    <a:pos x="connsiteX190" y="connsiteY190"/>
                  </a:cxn>
                  <a:cxn ang="0">
                    <a:pos x="connsiteX191" y="connsiteY191"/>
                  </a:cxn>
                  <a:cxn ang="0">
                    <a:pos x="connsiteX192" y="connsiteY192"/>
                  </a:cxn>
                  <a:cxn ang="0">
                    <a:pos x="connsiteX193" y="connsiteY193"/>
                  </a:cxn>
                  <a:cxn ang="0">
                    <a:pos x="connsiteX194" y="connsiteY194"/>
                  </a:cxn>
                  <a:cxn ang="0">
                    <a:pos x="connsiteX195" y="connsiteY195"/>
                  </a:cxn>
                  <a:cxn ang="0">
                    <a:pos x="connsiteX196" y="connsiteY196"/>
                  </a:cxn>
                  <a:cxn ang="0">
                    <a:pos x="connsiteX197" y="connsiteY197"/>
                  </a:cxn>
                  <a:cxn ang="0">
                    <a:pos x="connsiteX198" y="connsiteY198"/>
                  </a:cxn>
                  <a:cxn ang="0">
                    <a:pos x="connsiteX199" y="connsiteY199"/>
                  </a:cxn>
                  <a:cxn ang="0">
                    <a:pos x="connsiteX200" y="connsiteY200"/>
                  </a:cxn>
                  <a:cxn ang="0">
                    <a:pos x="connsiteX201" y="connsiteY201"/>
                  </a:cxn>
                  <a:cxn ang="0">
                    <a:pos x="connsiteX202" y="connsiteY202"/>
                  </a:cxn>
                  <a:cxn ang="0">
                    <a:pos x="connsiteX203" y="connsiteY203"/>
                  </a:cxn>
                  <a:cxn ang="0">
                    <a:pos x="connsiteX204" y="connsiteY204"/>
                  </a:cxn>
                  <a:cxn ang="0">
                    <a:pos x="connsiteX205" y="connsiteY205"/>
                  </a:cxn>
                  <a:cxn ang="0">
                    <a:pos x="connsiteX206" y="connsiteY206"/>
                  </a:cxn>
                  <a:cxn ang="0">
                    <a:pos x="connsiteX207" y="connsiteY207"/>
                  </a:cxn>
                  <a:cxn ang="0">
                    <a:pos x="connsiteX208" y="connsiteY208"/>
                  </a:cxn>
                  <a:cxn ang="0">
                    <a:pos x="connsiteX209" y="connsiteY209"/>
                  </a:cxn>
                  <a:cxn ang="0">
                    <a:pos x="connsiteX210" y="connsiteY210"/>
                  </a:cxn>
                  <a:cxn ang="0">
                    <a:pos x="connsiteX211" y="connsiteY211"/>
                  </a:cxn>
                  <a:cxn ang="0">
                    <a:pos x="connsiteX212" y="connsiteY212"/>
                  </a:cxn>
                  <a:cxn ang="0">
                    <a:pos x="connsiteX213" y="connsiteY213"/>
                  </a:cxn>
                  <a:cxn ang="0">
                    <a:pos x="connsiteX214" y="connsiteY214"/>
                  </a:cxn>
                  <a:cxn ang="0">
                    <a:pos x="connsiteX215" y="connsiteY215"/>
                  </a:cxn>
                </a:cxnLst>
                <a:rect l="l" t="t" r="r" b="b"/>
                <a:pathLst>
                  <a:path w="556277" h="606087">
                    <a:moveTo>
                      <a:pt x="276224" y="230305"/>
                    </a:moveTo>
                    <a:lnTo>
                      <a:pt x="279087" y="224644"/>
                    </a:lnTo>
                    <a:cubicBezTo>
                      <a:pt x="279184" y="224932"/>
                      <a:pt x="316594" y="206774"/>
                      <a:pt x="394620" y="227257"/>
                    </a:cubicBezTo>
                    <a:lnTo>
                      <a:pt x="402904" y="229373"/>
                    </a:lnTo>
                    <a:cubicBezTo>
                      <a:pt x="403257" y="232258"/>
                      <a:pt x="397805" y="240948"/>
                      <a:pt x="398158" y="243833"/>
                    </a:cubicBezTo>
                    <a:cubicBezTo>
                      <a:pt x="398254" y="245179"/>
                      <a:pt x="418606" y="241623"/>
                      <a:pt x="282590" y="292879"/>
                    </a:cubicBezTo>
                    <a:lnTo>
                      <a:pt x="282029" y="290836"/>
                    </a:lnTo>
                    <a:lnTo>
                      <a:pt x="296951" y="292879"/>
                    </a:lnTo>
                    <a:lnTo>
                      <a:pt x="152257" y="238028"/>
                    </a:lnTo>
                    <a:lnTo>
                      <a:pt x="153317" y="229373"/>
                    </a:lnTo>
                    <a:lnTo>
                      <a:pt x="161601" y="227257"/>
                    </a:lnTo>
                    <a:cubicBezTo>
                      <a:pt x="239723" y="206774"/>
                      <a:pt x="269296" y="228803"/>
                      <a:pt x="269489" y="228515"/>
                    </a:cubicBezTo>
                    <a:cubicBezTo>
                      <a:pt x="269799" y="247173"/>
                      <a:pt x="275914" y="211647"/>
                      <a:pt x="276224" y="230305"/>
                    </a:cubicBezTo>
                    <a:close/>
                    <a:moveTo>
                      <a:pt x="230104" y="104060"/>
                    </a:moveTo>
                    <a:lnTo>
                      <a:pt x="122343" y="160995"/>
                    </a:lnTo>
                    <a:cubicBezTo>
                      <a:pt x="122632" y="161475"/>
                      <a:pt x="122632" y="162149"/>
                      <a:pt x="122824" y="162630"/>
                    </a:cubicBezTo>
                    <a:cubicBezTo>
                      <a:pt x="123210" y="163880"/>
                      <a:pt x="123787" y="165130"/>
                      <a:pt x="124173" y="166380"/>
                    </a:cubicBezTo>
                    <a:cubicBezTo>
                      <a:pt x="124365" y="167631"/>
                      <a:pt x="124654" y="168881"/>
                      <a:pt x="124847" y="170035"/>
                    </a:cubicBezTo>
                    <a:cubicBezTo>
                      <a:pt x="125232" y="171478"/>
                      <a:pt x="125521" y="172728"/>
                      <a:pt x="125810" y="173979"/>
                    </a:cubicBezTo>
                    <a:cubicBezTo>
                      <a:pt x="126002" y="175710"/>
                      <a:pt x="126195" y="177537"/>
                      <a:pt x="126291" y="179268"/>
                    </a:cubicBezTo>
                    <a:cubicBezTo>
                      <a:pt x="126291" y="180807"/>
                      <a:pt x="126387" y="182153"/>
                      <a:pt x="126291" y="183596"/>
                    </a:cubicBezTo>
                    <a:cubicBezTo>
                      <a:pt x="126291" y="185327"/>
                      <a:pt x="126291" y="187154"/>
                      <a:pt x="126195" y="188885"/>
                    </a:cubicBezTo>
                    <a:cubicBezTo>
                      <a:pt x="126002" y="189847"/>
                      <a:pt x="125906" y="190905"/>
                      <a:pt x="125617" y="191867"/>
                    </a:cubicBezTo>
                    <a:cubicBezTo>
                      <a:pt x="125521" y="193502"/>
                      <a:pt x="125136" y="195233"/>
                      <a:pt x="124847" y="196868"/>
                    </a:cubicBezTo>
                    <a:cubicBezTo>
                      <a:pt x="124654" y="197830"/>
                      <a:pt x="124365" y="198695"/>
                      <a:pt x="124173" y="199753"/>
                    </a:cubicBezTo>
                    <a:cubicBezTo>
                      <a:pt x="123595" y="201484"/>
                      <a:pt x="123113" y="203119"/>
                      <a:pt x="122535" y="204947"/>
                    </a:cubicBezTo>
                    <a:cubicBezTo>
                      <a:pt x="122150" y="205716"/>
                      <a:pt x="121861" y="206581"/>
                      <a:pt x="121476" y="207351"/>
                    </a:cubicBezTo>
                    <a:cubicBezTo>
                      <a:pt x="120513" y="209851"/>
                      <a:pt x="119357" y="212256"/>
                      <a:pt x="117913" y="214660"/>
                    </a:cubicBezTo>
                    <a:cubicBezTo>
                      <a:pt x="116565" y="216872"/>
                      <a:pt x="115024" y="219180"/>
                      <a:pt x="113387" y="221296"/>
                    </a:cubicBezTo>
                    <a:cubicBezTo>
                      <a:pt x="112905" y="222065"/>
                      <a:pt x="112135" y="222835"/>
                      <a:pt x="111653" y="223604"/>
                    </a:cubicBezTo>
                    <a:lnTo>
                      <a:pt x="108187" y="227355"/>
                    </a:lnTo>
                    <a:cubicBezTo>
                      <a:pt x="107416" y="228124"/>
                      <a:pt x="106549" y="228894"/>
                      <a:pt x="105683" y="229663"/>
                    </a:cubicBezTo>
                    <a:cubicBezTo>
                      <a:pt x="104623" y="230625"/>
                      <a:pt x="103564" y="231683"/>
                      <a:pt x="102408" y="232548"/>
                    </a:cubicBezTo>
                    <a:cubicBezTo>
                      <a:pt x="101349" y="233318"/>
                      <a:pt x="100386" y="233991"/>
                      <a:pt x="99519" y="234664"/>
                    </a:cubicBezTo>
                    <a:cubicBezTo>
                      <a:pt x="98364" y="235434"/>
                      <a:pt x="97112" y="236395"/>
                      <a:pt x="95956" y="237069"/>
                    </a:cubicBezTo>
                    <a:cubicBezTo>
                      <a:pt x="94801" y="237742"/>
                      <a:pt x="93838" y="238223"/>
                      <a:pt x="92778" y="238704"/>
                    </a:cubicBezTo>
                    <a:cubicBezTo>
                      <a:pt x="91526" y="239473"/>
                      <a:pt x="90274" y="240146"/>
                      <a:pt x="89023" y="240627"/>
                    </a:cubicBezTo>
                    <a:cubicBezTo>
                      <a:pt x="87867" y="241108"/>
                      <a:pt x="86711" y="241685"/>
                      <a:pt x="85556" y="242070"/>
                    </a:cubicBezTo>
                    <a:cubicBezTo>
                      <a:pt x="84304" y="242550"/>
                      <a:pt x="82956" y="243031"/>
                      <a:pt x="81607" y="243416"/>
                    </a:cubicBezTo>
                    <a:cubicBezTo>
                      <a:pt x="80548" y="243801"/>
                      <a:pt x="79296" y="244089"/>
                      <a:pt x="78140" y="244282"/>
                    </a:cubicBezTo>
                    <a:cubicBezTo>
                      <a:pt x="76696" y="244666"/>
                      <a:pt x="75348" y="244955"/>
                      <a:pt x="73903" y="245147"/>
                    </a:cubicBezTo>
                    <a:cubicBezTo>
                      <a:pt x="72844" y="245436"/>
                      <a:pt x="71496" y="245532"/>
                      <a:pt x="70436" y="245724"/>
                    </a:cubicBezTo>
                    <a:cubicBezTo>
                      <a:pt x="69859" y="245820"/>
                      <a:pt x="69377" y="245917"/>
                      <a:pt x="68992" y="245917"/>
                    </a:cubicBezTo>
                    <a:lnTo>
                      <a:pt x="68992" y="360075"/>
                    </a:lnTo>
                    <a:cubicBezTo>
                      <a:pt x="69859" y="360075"/>
                      <a:pt x="70822" y="360363"/>
                      <a:pt x="71785" y="360459"/>
                    </a:cubicBezTo>
                    <a:cubicBezTo>
                      <a:pt x="72651" y="360556"/>
                      <a:pt x="73711" y="360748"/>
                      <a:pt x="74674" y="360844"/>
                    </a:cubicBezTo>
                    <a:cubicBezTo>
                      <a:pt x="76696" y="361229"/>
                      <a:pt x="78718" y="361710"/>
                      <a:pt x="80644" y="362383"/>
                    </a:cubicBezTo>
                    <a:cubicBezTo>
                      <a:pt x="81415" y="362479"/>
                      <a:pt x="82185" y="362768"/>
                      <a:pt x="82956" y="362960"/>
                    </a:cubicBezTo>
                    <a:cubicBezTo>
                      <a:pt x="85556" y="363826"/>
                      <a:pt x="88252" y="364883"/>
                      <a:pt x="90756" y="366038"/>
                    </a:cubicBezTo>
                    <a:cubicBezTo>
                      <a:pt x="91237" y="366230"/>
                      <a:pt x="91623" y="366518"/>
                      <a:pt x="92104" y="366807"/>
                    </a:cubicBezTo>
                    <a:cubicBezTo>
                      <a:pt x="94126" y="367865"/>
                      <a:pt x="96149" y="369019"/>
                      <a:pt x="98075" y="370269"/>
                    </a:cubicBezTo>
                    <a:cubicBezTo>
                      <a:pt x="98845" y="370846"/>
                      <a:pt x="99712" y="371423"/>
                      <a:pt x="100482" y="372000"/>
                    </a:cubicBezTo>
                    <a:cubicBezTo>
                      <a:pt x="102023" y="373058"/>
                      <a:pt x="103371" y="374212"/>
                      <a:pt x="104912" y="375463"/>
                    </a:cubicBezTo>
                    <a:cubicBezTo>
                      <a:pt x="105683" y="376232"/>
                      <a:pt x="106453" y="376905"/>
                      <a:pt x="107224" y="377675"/>
                    </a:cubicBezTo>
                    <a:cubicBezTo>
                      <a:pt x="108572" y="379021"/>
                      <a:pt x="109824" y="380367"/>
                      <a:pt x="111268" y="381906"/>
                    </a:cubicBezTo>
                    <a:cubicBezTo>
                      <a:pt x="111750" y="382676"/>
                      <a:pt x="112424" y="383349"/>
                      <a:pt x="113002" y="384118"/>
                    </a:cubicBezTo>
                    <a:cubicBezTo>
                      <a:pt x="114735" y="386330"/>
                      <a:pt x="116468" y="388735"/>
                      <a:pt x="117913" y="391427"/>
                    </a:cubicBezTo>
                    <a:cubicBezTo>
                      <a:pt x="119357" y="393832"/>
                      <a:pt x="120513" y="396236"/>
                      <a:pt x="121476" y="398737"/>
                    </a:cubicBezTo>
                    <a:cubicBezTo>
                      <a:pt x="121861" y="399506"/>
                      <a:pt x="122150" y="400275"/>
                      <a:pt x="122343" y="400949"/>
                    </a:cubicBezTo>
                    <a:cubicBezTo>
                      <a:pt x="123017" y="402776"/>
                      <a:pt x="123595" y="404507"/>
                      <a:pt x="124173" y="406334"/>
                    </a:cubicBezTo>
                    <a:lnTo>
                      <a:pt x="124750" y="408931"/>
                    </a:lnTo>
                    <a:cubicBezTo>
                      <a:pt x="125136" y="410758"/>
                      <a:pt x="125521" y="412489"/>
                      <a:pt x="125810" y="414413"/>
                    </a:cubicBezTo>
                    <a:cubicBezTo>
                      <a:pt x="125906" y="415182"/>
                      <a:pt x="126002" y="416048"/>
                      <a:pt x="126002" y="416817"/>
                    </a:cubicBezTo>
                    <a:cubicBezTo>
                      <a:pt x="126291" y="419222"/>
                      <a:pt x="126387" y="421434"/>
                      <a:pt x="126387" y="423838"/>
                    </a:cubicBezTo>
                    <a:lnTo>
                      <a:pt x="126387" y="424607"/>
                    </a:lnTo>
                    <a:cubicBezTo>
                      <a:pt x="126291" y="427300"/>
                      <a:pt x="126002" y="429801"/>
                      <a:pt x="125617" y="432397"/>
                    </a:cubicBezTo>
                    <a:cubicBezTo>
                      <a:pt x="125521" y="433167"/>
                      <a:pt x="125424" y="433936"/>
                      <a:pt x="125136" y="434706"/>
                    </a:cubicBezTo>
                    <a:cubicBezTo>
                      <a:pt x="124847" y="436437"/>
                      <a:pt x="124365" y="438360"/>
                      <a:pt x="123884" y="440091"/>
                    </a:cubicBezTo>
                    <a:cubicBezTo>
                      <a:pt x="123595" y="441053"/>
                      <a:pt x="123402" y="441919"/>
                      <a:pt x="123113" y="442784"/>
                    </a:cubicBezTo>
                    <a:cubicBezTo>
                      <a:pt x="122824" y="443457"/>
                      <a:pt x="122632" y="444131"/>
                      <a:pt x="122343" y="444900"/>
                    </a:cubicBezTo>
                    <a:lnTo>
                      <a:pt x="230104" y="501835"/>
                    </a:lnTo>
                    <a:cubicBezTo>
                      <a:pt x="230682" y="501162"/>
                      <a:pt x="231452" y="500488"/>
                      <a:pt x="232127" y="499719"/>
                    </a:cubicBezTo>
                    <a:cubicBezTo>
                      <a:pt x="232608" y="499238"/>
                      <a:pt x="233090" y="498565"/>
                      <a:pt x="233764" y="498084"/>
                    </a:cubicBezTo>
                    <a:cubicBezTo>
                      <a:pt x="235112" y="496545"/>
                      <a:pt x="236749" y="495199"/>
                      <a:pt x="238386" y="493949"/>
                    </a:cubicBezTo>
                    <a:cubicBezTo>
                      <a:pt x="238771" y="493564"/>
                      <a:pt x="239060" y="493275"/>
                      <a:pt x="239542" y="492891"/>
                    </a:cubicBezTo>
                    <a:cubicBezTo>
                      <a:pt x="241564" y="491352"/>
                      <a:pt x="243683" y="489909"/>
                      <a:pt x="245898" y="488659"/>
                    </a:cubicBezTo>
                    <a:cubicBezTo>
                      <a:pt x="246379" y="488371"/>
                      <a:pt x="246764" y="488082"/>
                      <a:pt x="247150" y="487890"/>
                    </a:cubicBezTo>
                    <a:cubicBezTo>
                      <a:pt x="249076" y="486832"/>
                      <a:pt x="250809" y="485966"/>
                      <a:pt x="252735" y="485101"/>
                    </a:cubicBezTo>
                    <a:cubicBezTo>
                      <a:pt x="253505" y="484812"/>
                      <a:pt x="254372" y="484427"/>
                      <a:pt x="255143" y="484235"/>
                    </a:cubicBezTo>
                    <a:cubicBezTo>
                      <a:pt x="256780" y="483562"/>
                      <a:pt x="258417" y="482985"/>
                      <a:pt x="260054" y="482408"/>
                    </a:cubicBezTo>
                    <a:cubicBezTo>
                      <a:pt x="260921" y="482215"/>
                      <a:pt x="261787" y="481927"/>
                      <a:pt x="262654" y="481831"/>
                    </a:cubicBezTo>
                    <a:cubicBezTo>
                      <a:pt x="264291" y="481254"/>
                      <a:pt x="266121" y="480965"/>
                      <a:pt x="267854" y="480677"/>
                    </a:cubicBezTo>
                    <a:cubicBezTo>
                      <a:pt x="268625" y="480580"/>
                      <a:pt x="269492" y="480388"/>
                      <a:pt x="270262" y="480292"/>
                    </a:cubicBezTo>
                    <a:cubicBezTo>
                      <a:pt x="272958" y="479907"/>
                      <a:pt x="275462" y="479811"/>
                      <a:pt x="278159" y="479811"/>
                    </a:cubicBezTo>
                    <a:cubicBezTo>
                      <a:pt x="280759" y="479811"/>
                      <a:pt x="283263" y="479907"/>
                      <a:pt x="285959" y="480292"/>
                    </a:cubicBezTo>
                    <a:cubicBezTo>
                      <a:pt x="286729" y="480388"/>
                      <a:pt x="287596" y="480580"/>
                      <a:pt x="288367" y="480677"/>
                    </a:cubicBezTo>
                    <a:cubicBezTo>
                      <a:pt x="290100" y="480965"/>
                      <a:pt x="291930" y="481254"/>
                      <a:pt x="293567" y="481831"/>
                    </a:cubicBezTo>
                    <a:cubicBezTo>
                      <a:pt x="294434" y="481927"/>
                      <a:pt x="295300" y="482215"/>
                      <a:pt x="296167" y="482600"/>
                    </a:cubicBezTo>
                    <a:cubicBezTo>
                      <a:pt x="297804" y="482985"/>
                      <a:pt x="299441" y="483562"/>
                      <a:pt x="301175" y="484235"/>
                    </a:cubicBezTo>
                    <a:cubicBezTo>
                      <a:pt x="301849" y="484427"/>
                      <a:pt x="302812" y="484812"/>
                      <a:pt x="303486" y="485197"/>
                    </a:cubicBezTo>
                    <a:cubicBezTo>
                      <a:pt x="305412" y="485966"/>
                      <a:pt x="307242" y="486832"/>
                      <a:pt x="308975" y="487890"/>
                    </a:cubicBezTo>
                    <a:cubicBezTo>
                      <a:pt x="309360" y="488082"/>
                      <a:pt x="309842" y="488371"/>
                      <a:pt x="310323" y="488659"/>
                    </a:cubicBezTo>
                    <a:cubicBezTo>
                      <a:pt x="312538" y="489909"/>
                      <a:pt x="314657" y="491352"/>
                      <a:pt x="316679" y="492891"/>
                    </a:cubicBezTo>
                    <a:cubicBezTo>
                      <a:pt x="317161" y="493275"/>
                      <a:pt x="317546" y="493660"/>
                      <a:pt x="317931" y="494045"/>
                    </a:cubicBezTo>
                    <a:cubicBezTo>
                      <a:pt x="319568" y="495295"/>
                      <a:pt x="321109" y="496545"/>
                      <a:pt x="322457" y="498084"/>
                    </a:cubicBezTo>
                    <a:lnTo>
                      <a:pt x="324094" y="499719"/>
                    </a:lnTo>
                    <a:cubicBezTo>
                      <a:pt x="324769" y="500488"/>
                      <a:pt x="325539" y="501162"/>
                      <a:pt x="326117" y="501835"/>
                    </a:cubicBezTo>
                    <a:lnTo>
                      <a:pt x="433878" y="444900"/>
                    </a:lnTo>
                    <a:cubicBezTo>
                      <a:pt x="433589" y="444419"/>
                      <a:pt x="433493" y="443938"/>
                      <a:pt x="433397" y="443457"/>
                    </a:cubicBezTo>
                    <a:cubicBezTo>
                      <a:pt x="433011" y="442111"/>
                      <a:pt x="432530" y="440765"/>
                      <a:pt x="432145" y="439514"/>
                    </a:cubicBezTo>
                    <a:cubicBezTo>
                      <a:pt x="431856" y="438360"/>
                      <a:pt x="431567" y="437110"/>
                      <a:pt x="431182" y="435860"/>
                    </a:cubicBezTo>
                    <a:cubicBezTo>
                      <a:pt x="430989" y="434609"/>
                      <a:pt x="430700" y="433359"/>
                      <a:pt x="430508" y="432013"/>
                    </a:cubicBezTo>
                    <a:cubicBezTo>
                      <a:pt x="430219" y="430282"/>
                      <a:pt x="430122" y="428358"/>
                      <a:pt x="429930" y="426627"/>
                    </a:cubicBezTo>
                    <a:cubicBezTo>
                      <a:pt x="429930" y="425281"/>
                      <a:pt x="429834" y="423838"/>
                      <a:pt x="429930" y="422492"/>
                    </a:cubicBezTo>
                    <a:cubicBezTo>
                      <a:pt x="429930" y="420568"/>
                      <a:pt x="429930" y="418837"/>
                      <a:pt x="430122" y="417010"/>
                    </a:cubicBezTo>
                    <a:cubicBezTo>
                      <a:pt x="430219" y="416048"/>
                      <a:pt x="430315" y="414990"/>
                      <a:pt x="430604" y="414028"/>
                    </a:cubicBezTo>
                    <a:cubicBezTo>
                      <a:pt x="430700" y="412393"/>
                      <a:pt x="431085" y="410758"/>
                      <a:pt x="431374" y="409220"/>
                    </a:cubicBezTo>
                    <a:cubicBezTo>
                      <a:pt x="431567" y="408162"/>
                      <a:pt x="431856" y="407200"/>
                      <a:pt x="432145" y="406142"/>
                    </a:cubicBezTo>
                    <a:cubicBezTo>
                      <a:pt x="432626" y="404507"/>
                      <a:pt x="433108" y="402776"/>
                      <a:pt x="433782" y="401141"/>
                    </a:cubicBezTo>
                    <a:cubicBezTo>
                      <a:pt x="434167" y="400372"/>
                      <a:pt x="434360" y="399506"/>
                      <a:pt x="434745" y="398737"/>
                    </a:cubicBezTo>
                    <a:cubicBezTo>
                      <a:pt x="435804" y="396236"/>
                      <a:pt x="436960" y="393832"/>
                      <a:pt x="438308" y="391427"/>
                    </a:cubicBezTo>
                    <a:cubicBezTo>
                      <a:pt x="439656" y="388831"/>
                      <a:pt x="441486" y="386330"/>
                      <a:pt x="443219" y="384118"/>
                    </a:cubicBezTo>
                    <a:cubicBezTo>
                      <a:pt x="443701" y="383445"/>
                      <a:pt x="444375" y="382772"/>
                      <a:pt x="444857" y="382195"/>
                    </a:cubicBezTo>
                    <a:cubicBezTo>
                      <a:pt x="446301" y="380560"/>
                      <a:pt x="447649" y="379021"/>
                      <a:pt x="449190" y="377482"/>
                    </a:cubicBezTo>
                    <a:cubicBezTo>
                      <a:pt x="449768" y="376905"/>
                      <a:pt x="450442" y="376424"/>
                      <a:pt x="451212" y="375751"/>
                    </a:cubicBezTo>
                    <a:cubicBezTo>
                      <a:pt x="452850" y="374405"/>
                      <a:pt x="454487" y="372962"/>
                      <a:pt x="456220" y="371712"/>
                    </a:cubicBezTo>
                    <a:cubicBezTo>
                      <a:pt x="456798" y="371327"/>
                      <a:pt x="457376" y="370846"/>
                      <a:pt x="457857" y="370462"/>
                    </a:cubicBezTo>
                    <a:cubicBezTo>
                      <a:pt x="462865" y="367192"/>
                      <a:pt x="467969" y="364595"/>
                      <a:pt x="473554" y="362864"/>
                    </a:cubicBezTo>
                    <a:cubicBezTo>
                      <a:pt x="474036" y="362768"/>
                      <a:pt x="474614" y="362575"/>
                      <a:pt x="475095" y="362479"/>
                    </a:cubicBezTo>
                    <a:cubicBezTo>
                      <a:pt x="477406" y="361902"/>
                      <a:pt x="479525" y="361229"/>
                      <a:pt x="481836" y="360844"/>
                    </a:cubicBezTo>
                    <a:lnTo>
                      <a:pt x="484436" y="360459"/>
                    </a:lnTo>
                    <a:cubicBezTo>
                      <a:pt x="485303" y="360363"/>
                      <a:pt x="486362" y="360075"/>
                      <a:pt x="487229" y="360075"/>
                    </a:cubicBezTo>
                    <a:lnTo>
                      <a:pt x="487229" y="245917"/>
                    </a:lnTo>
                    <a:cubicBezTo>
                      <a:pt x="486844" y="245917"/>
                      <a:pt x="486362" y="245820"/>
                      <a:pt x="485881" y="245724"/>
                    </a:cubicBezTo>
                    <a:cubicBezTo>
                      <a:pt x="484725" y="245532"/>
                      <a:pt x="483473" y="245436"/>
                      <a:pt x="482318" y="245147"/>
                    </a:cubicBezTo>
                    <a:cubicBezTo>
                      <a:pt x="480873" y="244955"/>
                      <a:pt x="479525" y="244666"/>
                      <a:pt x="478081" y="244282"/>
                    </a:cubicBezTo>
                    <a:cubicBezTo>
                      <a:pt x="477021" y="244089"/>
                      <a:pt x="475769" y="243801"/>
                      <a:pt x="474614" y="243416"/>
                    </a:cubicBezTo>
                    <a:cubicBezTo>
                      <a:pt x="473362" y="243031"/>
                      <a:pt x="471917" y="242550"/>
                      <a:pt x="470665" y="242070"/>
                    </a:cubicBezTo>
                    <a:cubicBezTo>
                      <a:pt x="469510" y="241685"/>
                      <a:pt x="468354" y="241108"/>
                      <a:pt x="467295" y="240627"/>
                    </a:cubicBezTo>
                    <a:cubicBezTo>
                      <a:pt x="465947" y="240146"/>
                      <a:pt x="464695" y="239473"/>
                      <a:pt x="463443" y="238896"/>
                    </a:cubicBezTo>
                    <a:cubicBezTo>
                      <a:pt x="462480" y="238223"/>
                      <a:pt x="461420" y="237742"/>
                      <a:pt x="460265" y="237069"/>
                    </a:cubicBezTo>
                    <a:cubicBezTo>
                      <a:pt x="459205" y="236395"/>
                      <a:pt x="457857" y="235434"/>
                      <a:pt x="456798" y="234664"/>
                    </a:cubicBezTo>
                    <a:cubicBezTo>
                      <a:pt x="455835" y="234087"/>
                      <a:pt x="454872" y="233318"/>
                      <a:pt x="453813" y="232548"/>
                    </a:cubicBezTo>
                    <a:cubicBezTo>
                      <a:pt x="452753" y="231683"/>
                      <a:pt x="451598" y="230625"/>
                      <a:pt x="450538" y="229663"/>
                    </a:cubicBezTo>
                    <a:cubicBezTo>
                      <a:pt x="449672" y="228894"/>
                      <a:pt x="448805" y="228124"/>
                      <a:pt x="448034" y="227355"/>
                    </a:cubicBezTo>
                    <a:cubicBezTo>
                      <a:pt x="446879" y="226105"/>
                      <a:pt x="445723" y="224854"/>
                      <a:pt x="444664" y="223604"/>
                    </a:cubicBezTo>
                    <a:cubicBezTo>
                      <a:pt x="444086" y="222835"/>
                      <a:pt x="443316" y="222065"/>
                      <a:pt x="442834" y="221296"/>
                    </a:cubicBezTo>
                    <a:cubicBezTo>
                      <a:pt x="441197" y="219180"/>
                      <a:pt x="439656" y="217064"/>
                      <a:pt x="438308" y="214660"/>
                    </a:cubicBezTo>
                    <a:cubicBezTo>
                      <a:pt x="436960" y="212256"/>
                      <a:pt x="435804" y="209851"/>
                      <a:pt x="434745" y="207351"/>
                    </a:cubicBezTo>
                    <a:cubicBezTo>
                      <a:pt x="434360" y="206581"/>
                      <a:pt x="434167" y="205812"/>
                      <a:pt x="433878" y="205043"/>
                    </a:cubicBezTo>
                    <a:cubicBezTo>
                      <a:pt x="433204" y="203312"/>
                      <a:pt x="432626" y="201484"/>
                      <a:pt x="432145" y="199753"/>
                    </a:cubicBezTo>
                    <a:cubicBezTo>
                      <a:pt x="431856" y="198695"/>
                      <a:pt x="431567" y="197830"/>
                      <a:pt x="431471" y="196964"/>
                    </a:cubicBezTo>
                    <a:cubicBezTo>
                      <a:pt x="431085" y="195233"/>
                      <a:pt x="430700" y="193406"/>
                      <a:pt x="430508" y="191675"/>
                    </a:cubicBezTo>
                    <a:cubicBezTo>
                      <a:pt x="430315" y="190809"/>
                      <a:pt x="430219" y="190040"/>
                      <a:pt x="430219" y="189174"/>
                    </a:cubicBezTo>
                    <a:cubicBezTo>
                      <a:pt x="429930" y="186770"/>
                      <a:pt x="429834" y="184462"/>
                      <a:pt x="429834" y="182057"/>
                    </a:cubicBezTo>
                    <a:lnTo>
                      <a:pt x="429834" y="181288"/>
                    </a:lnTo>
                    <a:cubicBezTo>
                      <a:pt x="429930" y="178691"/>
                      <a:pt x="430219" y="176094"/>
                      <a:pt x="430604" y="173594"/>
                    </a:cubicBezTo>
                    <a:cubicBezTo>
                      <a:pt x="430700" y="172728"/>
                      <a:pt x="430989" y="171958"/>
                      <a:pt x="431085" y="171093"/>
                    </a:cubicBezTo>
                    <a:cubicBezTo>
                      <a:pt x="431471" y="169266"/>
                      <a:pt x="431856" y="167534"/>
                      <a:pt x="432337" y="165899"/>
                    </a:cubicBezTo>
                    <a:cubicBezTo>
                      <a:pt x="432626" y="164842"/>
                      <a:pt x="432915" y="163976"/>
                      <a:pt x="433204" y="163110"/>
                    </a:cubicBezTo>
                    <a:cubicBezTo>
                      <a:pt x="433493" y="162341"/>
                      <a:pt x="433589" y="161764"/>
                      <a:pt x="433878" y="160995"/>
                    </a:cubicBezTo>
                    <a:lnTo>
                      <a:pt x="326213" y="104060"/>
                    </a:lnTo>
                    <a:cubicBezTo>
                      <a:pt x="325539" y="104829"/>
                      <a:pt x="324865" y="105406"/>
                      <a:pt x="324287" y="106079"/>
                    </a:cubicBezTo>
                    <a:cubicBezTo>
                      <a:pt x="323613" y="106656"/>
                      <a:pt x="323131" y="107426"/>
                      <a:pt x="322457" y="108099"/>
                    </a:cubicBezTo>
                    <a:cubicBezTo>
                      <a:pt x="321109" y="109349"/>
                      <a:pt x="319568" y="110600"/>
                      <a:pt x="318220" y="111850"/>
                    </a:cubicBezTo>
                    <a:cubicBezTo>
                      <a:pt x="317739" y="112235"/>
                      <a:pt x="317161" y="112715"/>
                      <a:pt x="316679" y="113100"/>
                    </a:cubicBezTo>
                    <a:cubicBezTo>
                      <a:pt x="314657" y="114639"/>
                      <a:pt x="312538" y="115985"/>
                      <a:pt x="310323" y="117428"/>
                    </a:cubicBezTo>
                    <a:lnTo>
                      <a:pt x="308879" y="118197"/>
                    </a:lnTo>
                    <a:cubicBezTo>
                      <a:pt x="307049" y="119159"/>
                      <a:pt x="305316" y="120025"/>
                      <a:pt x="303582" y="120794"/>
                    </a:cubicBezTo>
                    <a:cubicBezTo>
                      <a:pt x="302812" y="121179"/>
                      <a:pt x="301849" y="121467"/>
                      <a:pt x="300982" y="121852"/>
                    </a:cubicBezTo>
                    <a:cubicBezTo>
                      <a:pt x="299441" y="122429"/>
                      <a:pt x="297804" y="123006"/>
                      <a:pt x="296360" y="123487"/>
                    </a:cubicBezTo>
                    <a:cubicBezTo>
                      <a:pt x="295397" y="123679"/>
                      <a:pt x="294434" y="123968"/>
                      <a:pt x="293567" y="124256"/>
                    </a:cubicBezTo>
                    <a:cubicBezTo>
                      <a:pt x="291930" y="124641"/>
                      <a:pt x="290100" y="125026"/>
                      <a:pt x="288367" y="125218"/>
                    </a:cubicBezTo>
                    <a:lnTo>
                      <a:pt x="285959" y="125795"/>
                    </a:lnTo>
                    <a:cubicBezTo>
                      <a:pt x="283263" y="125987"/>
                      <a:pt x="280759" y="126276"/>
                      <a:pt x="278159" y="126276"/>
                    </a:cubicBezTo>
                    <a:cubicBezTo>
                      <a:pt x="275462" y="126276"/>
                      <a:pt x="272958" y="125987"/>
                      <a:pt x="270262" y="125795"/>
                    </a:cubicBezTo>
                    <a:lnTo>
                      <a:pt x="267854" y="125218"/>
                    </a:lnTo>
                    <a:cubicBezTo>
                      <a:pt x="266121" y="125026"/>
                      <a:pt x="264388" y="124641"/>
                      <a:pt x="262654" y="124256"/>
                    </a:cubicBezTo>
                    <a:cubicBezTo>
                      <a:pt x="261787" y="123968"/>
                      <a:pt x="260824" y="123679"/>
                      <a:pt x="259958" y="123487"/>
                    </a:cubicBezTo>
                    <a:cubicBezTo>
                      <a:pt x="258417" y="123006"/>
                      <a:pt x="256780" y="122429"/>
                      <a:pt x="255239" y="121852"/>
                    </a:cubicBezTo>
                    <a:cubicBezTo>
                      <a:pt x="254372" y="121467"/>
                      <a:pt x="253505" y="121179"/>
                      <a:pt x="252735" y="120794"/>
                    </a:cubicBezTo>
                    <a:cubicBezTo>
                      <a:pt x="250905" y="120025"/>
                      <a:pt x="249172" y="119159"/>
                      <a:pt x="247535" y="118197"/>
                    </a:cubicBezTo>
                    <a:cubicBezTo>
                      <a:pt x="246861" y="117909"/>
                      <a:pt x="246379" y="117620"/>
                      <a:pt x="245898" y="117332"/>
                    </a:cubicBezTo>
                    <a:cubicBezTo>
                      <a:pt x="243779" y="115985"/>
                      <a:pt x="241564" y="114639"/>
                      <a:pt x="239542" y="113100"/>
                    </a:cubicBezTo>
                    <a:cubicBezTo>
                      <a:pt x="239060" y="112619"/>
                      <a:pt x="238579" y="112235"/>
                      <a:pt x="238001" y="111754"/>
                    </a:cubicBezTo>
                    <a:cubicBezTo>
                      <a:pt x="236556" y="110600"/>
                      <a:pt x="235112" y="109349"/>
                      <a:pt x="233860" y="108099"/>
                    </a:cubicBezTo>
                    <a:cubicBezTo>
                      <a:pt x="233282" y="107426"/>
                      <a:pt x="232608" y="106656"/>
                      <a:pt x="231934" y="106079"/>
                    </a:cubicBezTo>
                    <a:cubicBezTo>
                      <a:pt x="231356" y="105406"/>
                      <a:pt x="230586" y="104829"/>
                      <a:pt x="230104" y="104060"/>
                    </a:cubicBezTo>
                    <a:close/>
                    <a:moveTo>
                      <a:pt x="278159" y="0"/>
                    </a:moveTo>
                    <a:cubicBezTo>
                      <a:pt x="313020" y="0"/>
                      <a:pt x="341332" y="28275"/>
                      <a:pt x="341332" y="63090"/>
                    </a:cubicBezTo>
                    <a:cubicBezTo>
                      <a:pt x="341332" y="69533"/>
                      <a:pt x="340177" y="75881"/>
                      <a:pt x="338347" y="81940"/>
                    </a:cubicBezTo>
                    <a:lnTo>
                      <a:pt x="447264" y="139548"/>
                    </a:lnTo>
                    <a:cubicBezTo>
                      <a:pt x="451309" y="135316"/>
                      <a:pt x="456028" y="131565"/>
                      <a:pt x="461324" y="128392"/>
                    </a:cubicBezTo>
                    <a:cubicBezTo>
                      <a:pt x="491563" y="111080"/>
                      <a:pt x="530180" y="121371"/>
                      <a:pt x="547803" y="151473"/>
                    </a:cubicBezTo>
                    <a:cubicBezTo>
                      <a:pt x="556277" y="166188"/>
                      <a:pt x="558396" y="183211"/>
                      <a:pt x="553966" y="199465"/>
                    </a:cubicBezTo>
                    <a:cubicBezTo>
                      <a:pt x="549729" y="215814"/>
                      <a:pt x="539232" y="229278"/>
                      <a:pt x="524498" y="237646"/>
                    </a:cubicBezTo>
                    <a:cubicBezTo>
                      <a:pt x="520742" y="239858"/>
                      <a:pt x="516697" y="241493"/>
                      <a:pt x="512556" y="242935"/>
                    </a:cubicBezTo>
                    <a:lnTo>
                      <a:pt x="512556" y="362960"/>
                    </a:lnTo>
                    <a:cubicBezTo>
                      <a:pt x="516794" y="364403"/>
                      <a:pt x="520838" y="366134"/>
                      <a:pt x="524690" y="368442"/>
                    </a:cubicBezTo>
                    <a:cubicBezTo>
                      <a:pt x="539232" y="376617"/>
                      <a:pt x="549729" y="390273"/>
                      <a:pt x="553966" y="406527"/>
                    </a:cubicBezTo>
                    <a:cubicBezTo>
                      <a:pt x="555507" y="412105"/>
                      <a:pt x="556277" y="417683"/>
                      <a:pt x="556277" y="423261"/>
                    </a:cubicBezTo>
                    <a:cubicBezTo>
                      <a:pt x="556277" y="434032"/>
                      <a:pt x="553388" y="444804"/>
                      <a:pt x="547803" y="454517"/>
                    </a:cubicBezTo>
                    <a:cubicBezTo>
                      <a:pt x="536054" y="474714"/>
                      <a:pt x="514675" y="485966"/>
                      <a:pt x="492911" y="485966"/>
                    </a:cubicBezTo>
                    <a:cubicBezTo>
                      <a:pt x="482125" y="485966"/>
                      <a:pt x="471339" y="483273"/>
                      <a:pt x="461324" y="477503"/>
                    </a:cubicBezTo>
                    <a:cubicBezTo>
                      <a:pt x="456028" y="474522"/>
                      <a:pt x="451405" y="470675"/>
                      <a:pt x="447360" y="466443"/>
                    </a:cubicBezTo>
                    <a:lnTo>
                      <a:pt x="338251" y="524051"/>
                    </a:lnTo>
                    <a:cubicBezTo>
                      <a:pt x="340177" y="530110"/>
                      <a:pt x="341332" y="536457"/>
                      <a:pt x="341332" y="542901"/>
                    </a:cubicBezTo>
                    <a:cubicBezTo>
                      <a:pt x="341332" y="577620"/>
                      <a:pt x="313020" y="606087"/>
                      <a:pt x="278159" y="606087"/>
                    </a:cubicBezTo>
                    <a:cubicBezTo>
                      <a:pt x="243201" y="606087"/>
                      <a:pt x="214889" y="577620"/>
                      <a:pt x="214889" y="542901"/>
                    </a:cubicBezTo>
                    <a:cubicBezTo>
                      <a:pt x="214889" y="536457"/>
                      <a:pt x="216044" y="530110"/>
                      <a:pt x="217970" y="524051"/>
                    </a:cubicBezTo>
                    <a:lnTo>
                      <a:pt x="108861" y="466443"/>
                    </a:lnTo>
                    <a:cubicBezTo>
                      <a:pt x="104816" y="470675"/>
                      <a:pt x="100193" y="474522"/>
                      <a:pt x="94897" y="477503"/>
                    </a:cubicBezTo>
                    <a:cubicBezTo>
                      <a:pt x="84978" y="483273"/>
                      <a:pt x="74096" y="485966"/>
                      <a:pt x="63310" y="485966"/>
                    </a:cubicBezTo>
                    <a:cubicBezTo>
                      <a:pt x="41546" y="485966"/>
                      <a:pt x="20167" y="474714"/>
                      <a:pt x="8418" y="454517"/>
                    </a:cubicBezTo>
                    <a:cubicBezTo>
                      <a:pt x="-56" y="439899"/>
                      <a:pt x="-2175" y="422876"/>
                      <a:pt x="2255" y="406527"/>
                    </a:cubicBezTo>
                    <a:cubicBezTo>
                      <a:pt x="6588" y="390273"/>
                      <a:pt x="17085" y="376617"/>
                      <a:pt x="31723" y="368250"/>
                    </a:cubicBezTo>
                    <a:cubicBezTo>
                      <a:pt x="35479" y="366134"/>
                      <a:pt x="39524" y="364403"/>
                      <a:pt x="43761" y="362960"/>
                    </a:cubicBezTo>
                    <a:lnTo>
                      <a:pt x="43761" y="242935"/>
                    </a:lnTo>
                    <a:cubicBezTo>
                      <a:pt x="39427" y="241493"/>
                      <a:pt x="35383" y="239858"/>
                      <a:pt x="31627" y="237646"/>
                    </a:cubicBezTo>
                    <a:cubicBezTo>
                      <a:pt x="17085" y="229278"/>
                      <a:pt x="6588" y="215814"/>
                      <a:pt x="2255" y="199465"/>
                    </a:cubicBezTo>
                    <a:cubicBezTo>
                      <a:pt x="-2175" y="183211"/>
                      <a:pt x="-56" y="166188"/>
                      <a:pt x="8418" y="151473"/>
                    </a:cubicBezTo>
                    <a:cubicBezTo>
                      <a:pt x="26041" y="121371"/>
                      <a:pt x="64755" y="111080"/>
                      <a:pt x="94897" y="128392"/>
                    </a:cubicBezTo>
                    <a:cubicBezTo>
                      <a:pt x="100193" y="131565"/>
                      <a:pt x="104816" y="135316"/>
                      <a:pt x="108861" y="139548"/>
                    </a:cubicBezTo>
                    <a:lnTo>
                      <a:pt x="217970" y="81940"/>
                    </a:lnTo>
                    <a:cubicBezTo>
                      <a:pt x="216044" y="75881"/>
                      <a:pt x="214889" y="69533"/>
                      <a:pt x="214889" y="63090"/>
                    </a:cubicBezTo>
                    <a:cubicBezTo>
                      <a:pt x="214889" y="28275"/>
                      <a:pt x="243201" y="0"/>
                      <a:pt x="278159" y="0"/>
                    </a:cubicBezTo>
                    <a:close/>
                  </a:path>
                </a:pathLst>
              </a:custGeom>
              <a:solidFill>
                <a:srgbClr val="36AB9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8" name="椭圆 127">
                <a:extLst>
                  <a:ext uri="{FF2B5EF4-FFF2-40B4-BE49-F238E27FC236}">
                    <a16:creationId xmlns:a16="http://schemas.microsoft.com/office/drawing/2014/main" id="{22D76921-6405-3EDE-1F2C-049EAF2BF3CC}"/>
                  </a:ext>
                </a:extLst>
              </p:cNvPr>
              <p:cNvSpPr/>
              <p:nvPr/>
            </p:nvSpPr>
            <p:spPr>
              <a:xfrm>
                <a:off x="-853081" y="2880834"/>
                <a:ext cx="764608" cy="240078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129" name="组合 128">
                <a:extLst>
                  <a:ext uri="{FF2B5EF4-FFF2-40B4-BE49-F238E27FC236}">
                    <a16:creationId xmlns:a16="http://schemas.microsoft.com/office/drawing/2014/main" id="{ABB56475-4A61-F035-2B14-5C215E4E4DD0}"/>
                  </a:ext>
                </a:extLst>
              </p:cNvPr>
              <p:cNvGrpSpPr/>
              <p:nvPr/>
            </p:nvGrpSpPr>
            <p:grpSpPr>
              <a:xfrm>
                <a:off x="-817573" y="3006063"/>
                <a:ext cx="693591" cy="254633"/>
                <a:chOff x="-1250413" y="4133558"/>
                <a:chExt cx="1118956" cy="585932"/>
              </a:xfrm>
              <a:grpFill/>
            </p:grpSpPr>
            <p:cxnSp>
              <p:nvCxnSpPr>
                <p:cNvPr id="130" name="直接连接符 129">
                  <a:extLst>
                    <a:ext uri="{FF2B5EF4-FFF2-40B4-BE49-F238E27FC236}">
                      <a16:creationId xmlns:a16="http://schemas.microsoft.com/office/drawing/2014/main" id="{B809E533-6CB7-31AB-7EA8-97DBA2DC5D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207022" y="4445794"/>
                  <a:ext cx="1032361" cy="0"/>
                </a:xfrm>
                <a:prstGeom prst="line">
                  <a:avLst/>
                </a:prstGeom>
                <a:grpFill/>
                <a:ln w="6350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31" name="任意多边形: 形状 130">
                  <a:extLst>
                    <a:ext uri="{FF2B5EF4-FFF2-40B4-BE49-F238E27FC236}">
                      <a16:creationId xmlns:a16="http://schemas.microsoft.com/office/drawing/2014/main" id="{DE169F2F-91EB-C394-02BD-7A75AE908F1C}"/>
                    </a:ext>
                  </a:extLst>
                </p:cNvPr>
                <p:cNvSpPr/>
                <p:nvPr/>
              </p:nvSpPr>
              <p:spPr>
                <a:xfrm>
                  <a:off x="-181477" y="4133558"/>
                  <a:ext cx="50020" cy="580795"/>
                </a:xfrm>
                <a:custGeom>
                  <a:avLst/>
                  <a:gdLst>
                    <a:gd name="connsiteX0" fmla="*/ 6816 w 50020"/>
                    <a:gd name="connsiteY0" fmla="*/ 304878 h 580795"/>
                    <a:gd name="connsiteX1" fmla="*/ 1679 w 50020"/>
                    <a:gd name="connsiteY1" fmla="*/ 48024 h 580795"/>
                    <a:gd name="connsiteX2" fmla="*/ 32502 w 50020"/>
                    <a:gd name="connsiteY2" fmla="*/ 6927 h 580795"/>
                    <a:gd name="connsiteX3" fmla="*/ 42776 w 50020"/>
                    <a:gd name="connsiteY3" fmla="*/ 135354 h 580795"/>
                    <a:gd name="connsiteX4" fmla="*/ 47913 w 50020"/>
                    <a:gd name="connsiteY4" fmla="*/ 351112 h 580795"/>
                    <a:gd name="connsiteX5" fmla="*/ 47913 w 50020"/>
                    <a:gd name="connsiteY5" fmla="*/ 541184 h 580795"/>
                    <a:gd name="connsiteX6" fmla="*/ 22228 w 50020"/>
                    <a:gd name="connsiteY6" fmla="*/ 577143 h 580795"/>
                    <a:gd name="connsiteX7" fmla="*/ 11953 w 50020"/>
                    <a:gd name="connsiteY7" fmla="*/ 484676 h 580795"/>
                    <a:gd name="connsiteX8" fmla="*/ 11953 w 50020"/>
                    <a:gd name="connsiteY8" fmla="*/ 361386 h 580795"/>
                    <a:gd name="connsiteX9" fmla="*/ 11953 w 50020"/>
                    <a:gd name="connsiteY9" fmla="*/ 361386 h 58079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0020" h="580795">
                      <a:moveTo>
                        <a:pt x="6816" y="304878"/>
                      </a:moveTo>
                      <a:cubicBezTo>
                        <a:pt x="2107" y="201280"/>
                        <a:pt x="-2602" y="97682"/>
                        <a:pt x="1679" y="48024"/>
                      </a:cubicBezTo>
                      <a:cubicBezTo>
                        <a:pt x="5960" y="-1634"/>
                        <a:pt x="25653" y="-7628"/>
                        <a:pt x="32502" y="6927"/>
                      </a:cubicBezTo>
                      <a:cubicBezTo>
                        <a:pt x="39352" y="21482"/>
                        <a:pt x="40208" y="77990"/>
                        <a:pt x="42776" y="135354"/>
                      </a:cubicBezTo>
                      <a:cubicBezTo>
                        <a:pt x="45344" y="192718"/>
                        <a:pt x="47057" y="283474"/>
                        <a:pt x="47913" y="351112"/>
                      </a:cubicBezTo>
                      <a:cubicBezTo>
                        <a:pt x="48769" y="418750"/>
                        <a:pt x="52194" y="503512"/>
                        <a:pt x="47913" y="541184"/>
                      </a:cubicBezTo>
                      <a:cubicBezTo>
                        <a:pt x="43632" y="578856"/>
                        <a:pt x="28221" y="586561"/>
                        <a:pt x="22228" y="577143"/>
                      </a:cubicBezTo>
                      <a:cubicBezTo>
                        <a:pt x="16235" y="567725"/>
                        <a:pt x="13665" y="520635"/>
                        <a:pt x="11953" y="484676"/>
                      </a:cubicBezTo>
                      <a:cubicBezTo>
                        <a:pt x="10241" y="448717"/>
                        <a:pt x="11953" y="361386"/>
                        <a:pt x="11953" y="361386"/>
                      </a:cubicBezTo>
                      <a:lnTo>
                        <a:pt x="11953" y="361386"/>
                      </a:lnTo>
                    </a:path>
                  </a:pathLst>
                </a:custGeom>
                <a:grpFill/>
                <a:ln w="3175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32" name="任意多边形: 形状 131">
                  <a:extLst>
                    <a:ext uri="{FF2B5EF4-FFF2-40B4-BE49-F238E27FC236}">
                      <a16:creationId xmlns:a16="http://schemas.microsoft.com/office/drawing/2014/main" id="{15A2099B-69E1-528A-385E-D6EB7630C388}"/>
                    </a:ext>
                  </a:extLst>
                </p:cNvPr>
                <p:cNvSpPr/>
                <p:nvPr/>
              </p:nvSpPr>
              <p:spPr>
                <a:xfrm flipH="1">
                  <a:off x="-1250413" y="4138695"/>
                  <a:ext cx="50020" cy="580795"/>
                </a:xfrm>
                <a:custGeom>
                  <a:avLst/>
                  <a:gdLst>
                    <a:gd name="connsiteX0" fmla="*/ 6816 w 50020"/>
                    <a:gd name="connsiteY0" fmla="*/ 304878 h 580795"/>
                    <a:gd name="connsiteX1" fmla="*/ 1679 w 50020"/>
                    <a:gd name="connsiteY1" fmla="*/ 48024 h 580795"/>
                    <a:gd name="connsiteX2" fmla="*/ 32502 w 50020"/>
                    <a:gd name="connsiteY2" fmla="*/ 6927 h 580795"/>
                    <a:gd name="connsiteX3" fmla="*/ 42776 w 50020"/>
                    <a:gd name="connsiteY3" fmla="*/ 135354 h 580795"/>
                    <a:gd name="connsiteX4" fmla="*/ 47913 w 50020"/>
                    <a:gd name="connsiteY4" fmla="*/ 351112 h 580795"/>
                    <a:gd name="connsiteX5" fmla="*/ 47913 w 50020"/>
                    <a:gd name="connsiteY5" fmla="*/ 541184 h 580795"/>
                    <a:gd name="connsiteX6" fmla="*/ 22228 w 50020"/>
                    <a:gd name="connsiteY6" fmla="*/ 577143 h 580795"/>
                    <a:gd name="connsiteX7" fmla="*/ 11953 w 50020"/>
                    <a:gd name="connsiteY7" fmla="*/ 484676 h 580795"/>
                    <a:gd name="connsiteX8" fmla="*/ 11953 w 50020"/>
                    <a:gd name="connsiteY8" fmla="*/ 361386 h 580795"/>
                    <a:gd name="connsiteX9" fmla="*/ 11953 w 50020"/>
                    <a:gd name="connsiteY9" fmla="*/ 361386 h 58079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0020" h="580795">
                      <a:moveTo>
                        <a:pt x="6816" y="304878"/>
                      </a:moveTo>
                      <a:cubicBezTo>
                        <a:pt x="2107" y="201280"/>
                        <a:pt x="-2602" y="97682"/>
                        <a:pt x="1679" y="48024"/>
                      </a:cubicBezTo>
                      <a:cubicBezTo>
                        <a:pt x="5960" y="-1634"/>
                        <a:pt x="25653" y="-7628"/>
                        <a:pt x="32502" y="6927"/>
                      </a:cubicBezTo>
                      <a:cubicBezTo>
                        <a:pt x="39352" y="21482"/>
                        <a:pt x="40208" y="77990"/>
                        <a:pt x="42776" y="135354"/>
                      </a:cubicBezTo>
                      <a:cubicBezTo>
                        <a:pt x="45344" y="192718"/>
                        <a:pt x="47057" y="283474"/>
                        <a:pt x="47913" y="351112"/>
                      </a:cubicBezTo>
                      <a:cubicBezTo>
                        <a:pt x="48769" y="418750"/>
                        <a:pt x="52194" y="503512"/>
                        <a:pt x="47913" y="541184"/>
                      </a:cubicBezTo>
                      <a:cubicBezTo>
                        <a:pt x="43632" y="578856"/>
                        <a:pt x="28221" y="586561"/>
                        <a:pt x="22228" y="577143"/>
                      </a:cubicBezTo>
                      <a:cubicBezTo>
                        <a:pt x="16235" y="567725"/>
                        <a:pt x="13665" y="520635"/>
                        <a:pt x="11953" y="484676"/>
                      </a:cubicBezTo>
                      <a:cubicBezTo>
                        <a:pt x="10241" y="448717"/>
                        <a:pt x="11953" y="361386"/>
                        <a:pt x="11953" y="361386"/>
                      </a:cubicBezTo>
                      <a:lnTo>
                        <a:pt x="11953" y="361386"/>
                      </a:lnTo>
                    </a:path>
                  </a:pathLst>
                </a:custGeom>
                <a:grpFill/>
                <a:ln w="3175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grpSp>
          <p:nvGrpSpPr>
            <p:cNvPr id="133" name="组合 132">
              <a:extLst>
                <a:ext uri="{FF2B5EF4-FFF2-40B4-BE49-F238E27FC236}">
                  <a16:creationId xmlns:a16="http://schemas.microsoft.com/office/drawing/2014/main" id="{4D2C7FBD-52C8-DAF4-9EEC-D5B51D944149}"/>
                </a:ext>
              </a:extLst>
            </p:cNvPr>
            <p:cNvGrpSpPr/>
            <p:nvPr/>
          </p:nvGrpSpPr>
          <p:grpSpPr>
            <a:xfrm>
              <a:off x="1605887" y="1667228"/>
              <a:ext cx="107121" cy="116713"/>
              <a:chOff x="-1207022" y="2342961"/>
              <a:chExt cx="1476700" cy="1608927"/>
            </a:xfrm>
            <a:solidFill>
              <a:srgbClr val="FFBE7A"/>
            </a:solidFill>
          </p:grpSpPr>
          <p:sp>
            <p:nvSpPr>
              <p:cNvPr id="134" name="shield_348433">
                <a:extLst>
                  <a:ext uri="{FF2B5EF4-FFF2-40B4-BE49-F238E27FC236}">
                    <a16:creationId xmlns:a16="http://schemas.microsoft.com/office/drawing/2014/main" id="{692FA91D-CFB8-40B5-8EBF-0AF3C2899A58}"/>
                  </a:ext>
                </a:extLst>
              </p:cNvPr>
              <p:cNvSpPr/>
              <p:nvPr/>
            </p:nvSpPr>
            <p:spPr>
              <a:xfrm>
                <a:off x="-1207022" y="2342961"/>
                <a:ext cx="1476700" cy="1608927"/>
              </a:xfrm>
              <a:custGeom>
                <a:avLst/>
                <a:gdLst>
                  <a:gd name="connsiteX0" fmla="*/ 373273 h 605239"/>
                  <a:gd name="connsiteY0" fmla="*/ 373273 h 605239"/>
                  <a:gd name="connsiteX1" fmla="*/ 373273 h 605239"/>
                  <a:gd name="connsiteY1" fmla="*/ 373273 h 605239"/>
                  <a:gd name="connsiteX2" fmla="*/ 373273 h 605239"/>
                  <a:gd name="connsiteY2" fmla="*/ 373273 h 605239"/>
                  <a:gd name="connsiteX3" fmla="*/ 373273 h 605239"/>
                  <a:gd name="connsiteY3" fmla="*/ 373273 h 605239"/>
                  <a:gd name="connsiteX4" fmla="*/ 373273 h 605239"/>
                  <a:gd name="connsiteY4" fmla="*/ 373273 h 605239"/>
                  <a:gd name="connsiteX5" fmla="*/ 373273 h 605239"/>
                  <a:gd name="connsiteY5" fmla="*/ 373273 h 605239"/>
                  <a:gd name="connsiteX6" fmla="*/ 373273 h 605239"/>
                  <a:gd name="connsiteY6" fmla="*/ 373273 h 605239"/>
                  <a:gd name="connsiteX7" fmla="*/ 373273 h 605239"/>
                  <a:gd name="connsiteY7" fmla="*/ 373273 h 605239"/>
                  <a:gd name="connsiteX8" fmla="*/ 373273 h 605239"/>
                  <a:gd name="connsiteY8" fmla="*/ 373273 h 605239"/>
                  <a:gd name="connsiteX9" fmla="*/ 373273 h 605239"/>
                  <a:gd name="connsiteY9" fmla="*/ 373273 h 605239"/>
                  <a:gd name="connsiteX10" fmla="*/ 373273 h 605239"/>
                  <a:gd name="connsiteY10" fmla="*/ 373273 h 605239"/>
                  <a:gd name="connsiteX11" fmla="*/ 373273 h 605239"/>
                  <a:gd name="connsiteY11" fmla="*/ 373273 h 605239"/>
                  <a:gd name="connsiteX12" fmla="*/ 373273 h 605239"/>
                  <a:gd name="connsiteY12" fmla="*/ 373273 h 605239"/>
                  <a:gd name="connsiteX13" fmla="*/ 373273 h 605239"/>
                  <a:gd name="connsiteY13" fmla="*/ 373273 h 605239"/>
                  <a:gd name="connsiteX14" fmla="*/ 373273 h 605239"/>
                  <a:gd name="connsiteY14" fmla="*/ 373273 h 605239"/>
                  <a:gd name="connsiteX15" fmla="*/ 373273 h 605239"/>
                  <a:gd name="connsiteY15" fmla="*/ 373273 h 605239"/>
                  <a:gd name="connsiteX16" fmla="*/ 373273 h 605239"/>
                  <a:gd name="connsiteY16" fmla="*/ 373273 h 605239"/>
                  <a:gd name="connsiteX17" fmla="*/ 373273 h 605239"/>
                  <a:gd name="connsiteY17" fmla="*/ 373273 h 605239"/>
                  <a:gd name="connsiteX18" fmla="*/ 373273 h 605239"/>
                  <a:gd name="connsiteY18" fmla="*/ 373273 h 605239"/>
                  <a:gd name="connsiteX19" fmla="*/ 373273 h 605239"/>
                  <a:gd name="connsiteY19" fmla="*/ 373273 h 605239"/>
                  <a:gd name="connsiteX20" fmla="*/ 373273 h 605239"/>
                  <a:gd name="connsiteY20" fmla="*/ 373273 h 605239"/>
                  <a:gd name="connsiteX21" fmla="*/ 373273 h 605239"/>
                  <a:gd name="connsiteY21" fmla="*/ 373273 h 605239"/>
                  <a:gd name="connsiteX22" fmla="*/ 373273 h 605239"/>
                  <a:gd name="connsiteY22" fmla="*/ 373273 h 605239"/>
                  <a:gd name="connsiteX23" fmla="*/ 373273 h 605239"/>
                  <a:gd name="connsiteY23" fmla="*/ 373273 h 605239"/>
                  <a:gd name="connsiteX24" fmla="*/ 373273 h 605239"/>
                  <a:gd name="connsiteY24" fmla="*/ 373273 h 605239"/>
                  <a:gd name="connsiteX25" fmla="*/ 373273 h 605239"/>
                  <a:gd name="connsiteY25" fmla="*/ 373273 h 605239"/>
                  <a:gd name="connsiteX26" fmla="*/ 373273 h 605239"/>
                  <a:gd name="connsiteY26" fmla="*/ 373273 h 605239"/>
                  <a:gd name="connsiteX27" fmla="*/ 373273 h 605239"/>
                  <a:gd name="connsiteY27" fmla="*/ 373273 h 605239"/>
                  <a:gd name="connsiteX28" fmla="*/ 373273 h 605239"/>
                  <a:gd name="connsiteY28" fmla="*/ 373273 h 605239"/>
                  <a:gd name="connsiteX29" fmla="*/ 373273 h 605239"/>
                  <a:gd name="connsiteY29" fmla="*/ 373273 h 605239"/>
                  <a:gd name="connsiteX30" fmla="*/ 373273 h 605239"/>
                  <a:gd name="connsiteY30" fmla="*/ 373273 h 605239"/>
                  <a:gd name="connsiteX31" fmla="*/ 373273 h 605239"/>
                  <a:gd name="connsiteY31" fmla="*/ 373273 h 605239"/>
                  <a:gd name="connsiteX32" fmla="*/ 373273 h 605239"/>
                  <a:gd name="connsiteY32" fmla="*/ 373273 h 605239"/>
                  <a:gd name="connsiteX33" fmla="*/ 373273 h 605239"/>
                  <a:gd name="connsiteY33" fmla="*/ 373273 h 605239"/>
                  <a:gd name="connsiteX34" fmla="*/ 373273 h 605239"/>
                  <a:gd name="connsiteY34" fmla="*/ 373273 h 605239"/>
                  <a:gd name="connsiteX35" fmla="*/ 373273 h 605239"/>
                  <a:gd name="connsiteY35" fmla="*/ 373273 h 605239"/>
                  <a:gd name="connsiteX36" fmla="*/ 373273 h 605239"/>
                  <a:gd name="connsiteY36" fmla="*/ 373273 h 605239"/>
                  <a:gd name="connsiteX37" fmla="*/ 373273 h 605239"/>
                  <a:gd name="connsiteY37" fmla="*/ 373273 h 605239"/>
                  <a:gd name="connsiteX38" fmla="*/ 373273 h 605239"/>
                  <a:gd name="connsiteY38" fmla="*/ 373273 h 605239"/>
                  <a:gd name="connsiteX39" fmla="*/ 373273 h 605239"/>
                  <a:gd name="connsiteY39" fmla="*/ 373273 h 605239"/>
                  <a:gd name="connsiteX40" fmla="*/ 373273 h 605239"/>
                  <a:gd name="connsiteY40" fmla="*/ 373273 h 605239"/>
                  <a:gd name="connsiteX41" fmla="*/ 373273 h 605239"/>
                  <a:gd name="connsiteY41" fmla="*/ 373273 h 605239"/>
                  <a:gd name="connsiteX42" fmla="*/ 373273 h 605239"/>
                  <a:gd name="connsiteY42" fmla="*/ 373273 h 605239"/>
                  <a:gd name="connsiteX43" fmla="*/ 373273 h 605239"/>
                  <a:gd name="connsiteY43" fmla="*/ 373273 h 605239"/>
                  <a:gd name="connsiteX44" fmla="*/ 373273 h 605239"/>
                  <a:gd name="connsiteY44" fmla="*/ 373273 h 605239"/>
                  <a:gd name="connsiteX45" fmla="*/ 373273 h 605239"/>
                  <a:gd name="connsiteY45" fmla="*/ 373273 h 605239"/>
                  <a:gd name="connsiteX46" fmla="*/ 373273 h 605239"/>
                  <a:gd name="connsiteY46" fmla="*/ 373273 h 605239"/>
                  <a:gd name="connsiteX47" fmla="*/ 373273 h 605239"/>
                  <a:gd name="connsiteY47" fmla="*/ 373273 h 605239"/>
                  <a:gd name="connsiteX48" fmla="*/ 373273 h 605239"/>
                  <a:gd name="connsiteY48" fmla="*/ 373273 h 605239"/>
                  <a:gd name="connsiteX49" fmla="*/ 373273 h 605239"/>
                  <a:gd name="connsiteY49" fmla="*/ 373273 h 605239"/>
                  <a:gd name="connsiteX50" fmla="*/ 373273 h 605239"/>
                  <a:gd name="connsiteY50" fmla="*/ 373273 h 605239"/>
                  <a:gd name="connsiteX51" fmla="*/ 373273 h 605239"/>
                  <a:gd name="connsiteY51" fmla="*/ 373273 h 605239"/>
                  <a:gd name="connsiteX52" fmla="*/ 373273 h 605239"/>
                  <a:gd name="connsiteY52" fmla="*/ 373273 h 605239"/>
                  <a:gd name="connsiteX53" fmla="*/ 373273 h 605239"/>
                  <a:gd name="connsiteY53" fmla="*/ 373273 h 605239"/>
                  <a:gd name="connsiteX54" fmla="*/ 373273 h 605239"/>
                  <a:gd name="connsiteY54" fmla="*/ 373273 h 605239"/>
                  <a:gd name="connsiteX55" fmla="*/ 373273 h 605239"/>
                  <a:gd name="connsiteY55" fmla="*/ 373273 h 605239"/>
                  <a:gd name="connsiteX56" fmla="*/ 373273 h 605239"/>
                  <a:gd name="connsiteY56" fmla="*/ 373273 h 605239"/>
                  <a:gd name="connsiteX57" fmla="*/ 373273 h 605239"/>
                  <a:gd name="connsiteY57" fmla="*/ 373273 h 605239"/>
                  <a:gd name="connsiteX58" fmla="*/ 373273 h 605239"/>
                  <a:gd name="connsiteY58" fmla="*/ 373273 h 605239"/>
                  <a:gd name="connsiteX59" fmla="*/ 373273 h 605239"/>
                  <a:gd name="connsiteY59" fmla="*/ 373273 h 605239"/>
                  <a:gd name="connsiteX60" fmla="*/ 373273 h 605239"/>
                  <a:gd name="connsiteY60" fmla="*/ 373273 h 605239"/>
                  <a:gd name="connsiteX61" fmla="*/ 373273 h 605239"/>
                  <a:gd name="connsiteY61" fmla="*/ 373273 h 605239"/>
                  <a:gd name="connsiteX62" fmla="*/ 373273 h 605239"/>
                  <a:gd name="connsiteY62" fmla="*/ 373273 h 605239"/>
                  <a:gd name="connsiteX63" fmla="*/ 373273 h 605239"/>
                  <a:gd name="connsiteY63" fmla="*/ 373273 h 605239"/>
                  <a:gd name="connsiteX64" fmla="*/ 373273 h 605239"/>
                  <a:gd name="connsiteY64" fmla="*/ 373273 h 605239"/>
                  <a:gd name="connsiteX65" fmla="*/ 373273 h 605239"/>
                  <a:gd name="connsiteY65" fmla="*/ 373273 h 605239"/>
                  <a:gd name="connsiteX66" fmla="*/ 373273 h 605239"/>
                  <a:gd name="connsiteY66" fmla="*/ 373273 h 605239"/>
                  <a:gd name="connsiteX67" fmla="*/ 373273 h 605239"/>
                  <a:gd name="connsiteY67" fmla="*/ 373273 h 605239"/>
                  <a:gd name="connsiteX68" fmla="*/ 373273 h 605239"/>
                  <a:gd name="connsiteY68" fmla="*/ 373273 h 605239"/>
                  <a:gd name="connsiteX69" fmla="*/ 373273 h 605239"/>
                  <a:gd name="connsiteY69" fmla="*/ 373273 h 605239"/>
                  <a:gd name="connsiteX70" fmla="*/ 373273 h 605239"/>
                  <a:gd name="connsiteY70" fmla="*/ 373273 h 605239"/>
                  <a:gd name="connsiteX71" fmla="*/ 373273 h 605239"/>
                  <a:gd name="connsiteY71" fmla="*/ 373273 h 605239"/>
                  <a:gd name="connsiteX72" fmla="*/ 373273 h 605239"/>
                  <a:gd name="connsiteY72" fmla="*/ 373273 h 605239"/>
                  <a:gd name="connsiteX73" fmla="*/ 373273 h 605239"/>
                  <a:gd name="connsiteY73" fmla="*/ 373273 h 605239"/>
                  <a:gd name="connsiteX74" fmla="*/ 373273 h 605239"/>
                  <a:gd name="connsiteY74" fmla="*/ 373273 h 605239"/>
                  <a:gd name="connsiteX75" fmla="*/ 373273 h 605239"/>
                  <a:gd name="connsiteY75" fmla="*/ 373273 h 605239"/>
                  <a:gd name="connsiteX76" fmla="*/ 373273 h 605239"/>
                  <a:gd name="connsiteY76" fmla="*/ 373273 h 605239"/>
                  <a:gd name="connsiteX77" fmla="*/ 373273 h 605239"/>
                  <a:gd name="connsiteY77" fmla="*/ 373273 h 605239"/>
                  <a:gd name="connsiteX78" fmla="*/ 373273 h 605239"/>
                  <a:gd name="connsiteY78" fmla="*/ 373273 h 605239"/>
                  <a:gd name="connsiteX79" fmla="*/ 373273 h 605239"/>
                  <a:gd name="connsiteY79" fmla="*/ 373273 h 605239"/>
                  <a:gd name="connsiteX80" fmla="*/ 373273 h 605239"/>
                  <a:gd name="connsiteY80" fmla="*/ 373273 h 605239"/>
                  <a:gd name="connsiteX81" fmla="*/ 373273 h 605239"/>
                  <a:gd name="connsiteY81" fmla="*/ 373273 h 605239"/>
                  <a:gd name="connsiteX82" fmla="*/ 373273 h 605239"/>
                  <a:gd name="connsiteY82" fmla="*/ 373273 h 605239"/>
                  <a:gd name="connsiteX83" fmla="*/ 373273 h 605239"/>
                  <a:gd name="connsiteY83" fmla="*/ 373273 h 605239"/>
                  <a:gd name="connsiteX84" fmla="*/ 373273 h 605239"/>
                  <a:gd name="connsiteY84" fmla="*/ 373273 h 605239"/>
                  <a:gd name="connsiteX85" fmla="*/ 373273 h 605239"/>
                  <a:gd name="connsiteY85" fmla="*/ 373273 h 605239"/>
                  <a:gd name="connsiteX86" fmla="*/ 373273 h 605239"/>
                  <a:gd name="connsiteY86" fmla="*/ 373273 h 605239"/>
                  <a:gd name="connsiteX87" fmla="*/ 373273 h 605239"/>
                  <a:gd name="connsiteY87" fmla="*/ 373273 h 605239"/>
                  <a:gd name="connsiteX88" fmla="*/ 373273 h 605239"/>
                  <a:gd name="connsiteY88" fmla="*/ 373273 h 605239"/>
                  <a:gd name="connsiteX89" fmla="*/ 373273 h 605239"/>
                  <a:gd name="connsiteY89" fmla="*/ 373273 h 605239"/>
                  <a:gd name="connsiteX90" fmla="*/ 373273 h 605239"/>
                  <a:gd name="connsiteY90" fmla="*/ 373273 h 605239"/>
                  <a:gd name="connsiteX91" fmla="*/ 373273 h 605239"/>
                  <a:gd name="connsiteY91" fmla="*/ 373273 h 605239"/>
                  <a:gd name="connsiteX92" fmla="*/ 373273 h 605239"/>
                  <a:gd name="connsiteY92" fmla="*/ 373273 h 605239"/>
                  <a:gd name="connsiteX93" fmla="*/ 373273 h 605239"/>
                  <a:gd name="connsiteY93" fmla="*/ 373273 h 605239"/>
                  <a:gd name="connsiteX94" fmla="*/ 373273 h 605239"/>
                  <a:gd name="connsiteY94" fmla="*/ 373273 h 605239"/>
                  <a:gd name="connsiteX95" fmla="*/ 373273 h 605239"/>
                  <a:gd name="connsiteY95" fmla="*/ 373273 h 605239"/>
                  <a:gd name="connsiteX96" fmla="*/ 373273 h 605239"/>
                  <a:gd name="connsiteY96" fmla="*/ 373273 h 605239"/>
                  <a:gd name="connsiteX97" fmla="*/ 373273 h 605239"/>
                  <a:gd name="connsiteY97" fmla="*/ 373273 h 605239"/>
                  <a:gd name="connsiteX98" fmla="*/ 373273 h 605239"/>
                  <a:gd name="connsiteY98" fmla="*/ 373273 h 605239"/>
                  <a:gd name="connsiteX99" fmla="*/ 373273 h 605239"/>
                  <a:gd name="connsiteY99" fmla="*/ 373273 h 605239"/>
                  <a:gd name="connsiteX100" fmla="*/ 373273 h 605239"/>
                  <a:gd name="connsiteY100" fmla="*/ 373273 h 605239"/>
                  <a:gd name="connsiteX101" fmla="*/ 373273 h 605239"/>
                  <a:gd name="connsiteY101" fmla="*/ 373273 h 605239"/>
                  <a:gd name="connsiteX102" fmla="*/ 373273 h 605239"/>
                  <a:gd name="connsiteY102" fmla="*/ 373273 h 605239"/>
                  <a:gd name="connsiteX103" fmla="*/ 373273 h 605239"/>
                  <a:gd name="connsiteY103" fmla="*/ 373273 h 605239"/>
                  <a:gd name="connsiteX104" fmla="*/ 373273 h 605239"/>
                  <a:gd name="connsiteY104" fmla="*/ 373273 h 605239"/>
                  <a:gd name="connsiteX105" fmla="*/ 373273 h 605239"/>
                  <a:gd name="connsiteY105" fmla="*/ 373273 h 605239"/>
                  <a:gd name="connsiteX106" fmla="*/ 373273 h 605239"/>
                  <a:gd name="connsiteY106" fmla="*/ 373273 h 605239"/>
                  <a:gd name="connsiteX107" fmla="*/ 373273 h 605239"/>
                  <a:gd name="connsiteY107" fmla="*/ 373273 h 605239"/>
                  <a:gd name="connsiteX108" fmla="*/ 373273 h 605239"/>
                  <a:gd name="connsiteY108" fmla="*/ 373273 h 605239"/>
                  <a:gd name="connsiteX109" fmla="*/ 373273 h 605239"/>
                  <a:gd name="connsiteY109" fmla="*/ 373273 h 605239"/>
                  <a:gd name="connsiteX110" fmla="*/ 373273 h 605239"/>
                  <a:gd name="connsiteY110" fmla="*/ 373273 h 605239"/>
                  <a:gd name="connsiteX111" fmla="*/ 373273 h 605239"/>
                  <a:gd name="connsiteY111" fmla="*/ 373273 h 605239"/>
                  <a:gd name="connsiteX112" fmla="*/ 373273 h 605239"/>
                  <a:gd name="connsiteY112" fmla="*/ 373273 h 605239"/>
                  <a:gd name="connsiteX113" fmla="*/ 373273 h 605239"/>
                  <a:gd name="connsiteY113" fmla="*/ 373273 h 605239"/>
                  <a:gd name="connsiteX114" fmla="*/ 373273 h 605239"/>
                  <a:gd name="connsiteY114" fmla="*/ 373273 h 605239"/>
                  <a:gd name="connsiteX115" fmla="*/ 373273 h 605239"/>
                  <a:gd name="connsiteY115" fmla="*/ 373273 h 605239"/>
                  <a:gd name="connsiteX116" fmla="*/ 373273 h 605239"/>
                  <a:gd name="connsiteY116" fmla="*/ 373273 h 605239"/>
                  <a:gd name="connsiteX117" fmla="*/ 373273 h 605239"/>
                  <a:gd name="connsiteY117" fmla="*/ 373273 h 605239"/>
                  <a:gd name="connsiteX118" fmla="*/ 373273 h 605239"/>
                  <a:gd name="connsiteY118" fmla="*/ 373273 h 605239"/>
                  <a:gd name="connsiteX119" fmla="*/ 373273 h 605239"/>
                  <a:gd name="connsiteY119" fmla="*/ 373273 h 605239"/>
                  <a:gd name="connsiteX120" fmla="*/ 373273 h 605239"/>
                  <a:gd name="connsiteY120" fmla="*/ 373273 h 605239"/>
                  <a:gd name="connsiteX121" fmla="*/ 373273 h 605239"/>
                  <a:gd name="connsiteY121" fmla="*/ 373273 h 605239"/>
                  <a:gd name="connsiteX122" fmla="*/ 373273 h 605239"/>
                  <a:gd name="connsiteY122" fmla="*/ 373273 h 605239"/>
                  <a:gd name="connsiteX123" fmla="*/ 373273 h 605239"/>
                  <a:gd name="connsiteY123" fmla="*/ 373273 h 605239"/>
                  <a:gd name="connsiteX124" fmla="*/ 373273 h 605239"/>
                  <a:gd name="connsiteY124" fmla="*/ 373273 h 605239"/>
                  <a:gd name="connsiteX125" fmla="*/ 373273 h 605239"/>
                  <a:gd name="connsiteY125" fmla="*/ 373273 h 605239"/>
                  <a:gd name="connsiteX126" fmla="*/ 373273 h 605239"/>
                  <a:gd name="connsiteY126" fmla="*/ 373273 h 605239"/>
                  <a:gd name="connsiteX127" fmla="*/ 373273 h 605239"/>
                  <a:gd name="connsiteY127" fmla="*/ 373273 h 605239"/>
                  <a:gd name="connsiteX128" fmla="*/ 373273 h 605239"/>
                  <a:gd name="connsiteY128" fmla="*/ 373273 h 605239"/>
                  <a:gd name="connsiteX129" fmla="*/ 373273 h 605239"/>
                  <a:gd name="connsiteY129" fmla="*/ 373273 h 605239"/>
                  <a:gd name="connsiteX130" fmla="*/ 373273 h 605239"/>
                  <a:gd name="connsiteY130" fmla="*/ 373273 h 605239"/>
                  <a:gd name="connsiteX131" fmla="*/ 373273 h 605239"/>
                  <a:gd name="connsiteY131" fmla="*/ 373273 h 605239"/>
                  <a:gd name="connsiteX132" fmla="*/ 373273 h 605239"/>
                  <a:gd name="connsiteY132" fmla="*/ 373273 h 605239"/>
                  <a:gd name="connsiteX133" fmla="*/ 373273 h 605239"/>
                  <a:gd name="connsiteY133" fmla="*/ 373273 h 605239"/>
                  <a:gd name="connsiteX134" fmla="*/ 373273 h 605239"/>
                  <a:gd name="connsiteY134" fmla="*/ 373273 h 605239"/>
                  <a:gd name="connsiteX135" fmla="*/ 373273 h 605239"/>
                  <a:gd name="connsiteY135" fmla="*/ 373273 h 605239"/>
                  <a:gd name="connsiteX136" fmla="*/ 373273 h 605239"/>
                  <a:gd name="connsiteY136" fmla="*/ 373273 h 605239"/>
                  <a:gd name="connsiteX137" fmla="*/ 373273 h 605239"/>
                  <a:gd name="connsiteY137" fmla="*/ 373273 h 605239"/>
                  <a:gd name="connsiteX138" fmla="*/ 373273 h 605239"/>
                  <a:gd name="connsiteY138" fmla="*/ 373273 h 605239"/>
                  <a:gd name="connsiteX139" fmla="*/ 373273 h 605239"/>
                  <a:gd name="connsiteY139" fmla="*/ 373273 h 605239"/>
                  <a:gd name="connsiteX140" fmla="*/ 373273 h 605239"/>
                  <a:gd name="connsiteY140" fmla="*/ 373273 h 605239"/>
                  <a:gd name="connsiteX141" fmla="*/ 373273 h 605239"/>
                  <a:gd name="connsiteY141" fmla="*/ 373273 h 605239"/>
                  <a:gd name="connsiteX142" fmla="*/ 373273 h 605239"/>
                  <a:gd name="connsiteY142" fmla="*/ 373273 h 605239"/>
                  <a:gd name="connsiteX143" fmla="*/ 373273 h 605239"/>
                  <a:gd name="connsiteY143" fmla="*/ 373273 h 605239"/>
                  <a:gd name="connsiteX144" fmla="*/ 373273 h 605239"/>
                  <a:gd name="connsiteY144" fmla="*/ 373273 h 605239"/>
                  <a:gd name="connsiteX145" fmla="*/ 373273 h 605239"/>
                  <a:gd name="connsiteY145" fmla="*/ 373273 h 605239"/>
                  <a:gd name="connsiteX146" fmla="*/ 373273 h 605239"/>
                  <a:gd name="connsiteY146" fmla="*/ 373273 h 605239"/>
                  <a:gd name="connsiteX147" fmla="*/ 373273 h 605239"/>
                  <a:gd name="connsiteY147" fmla="*/ 373273 h 605239"/>
                  <a:gd name="connsiteX148" fmla="*/ 373273 h 605239"/>
                  <a:gd name="connsiteY148" fmla="*/ 373273 h 605239"/>
                  <a:gd name="connsiteX149" fmla="*/ 373273 h 605239"/>
                  <a:gd name="connsiteY149" fmla="*/ 373273 h 605239"/>
                  <a:gd name="connsiteX150" fmla="*/ 373273 h 605239"/>
                  <a:gd name="connsiteY150" fmla="*/ 373273 h 605239"/>
                  <a:gd name="connsiteX151" fmla="*/ 373273 h 605239"/>
                  <a:gd name="connsiteY151" fmla="*/ 373273 h 605239"/>
                  <a:gd name="connsiteX152" fmla="*/ 373273 h 605239"/>
                  <a:gd name="connsiteY152" fmla="*/ 373273 h 605239"/>
                  <a:gd name="connsiteX153" fmla="*/ 373273 h 605239"/>
                  <a:gd name="connsiteY153" fmla="*/ 373273 h 605239"/>
                  <a:gd name="connsiteX154" fmla="*/ 373273 h 605239"/>
                  <a:gd name="connsiteY154" fmla="*/ 373273 h 605239"/>
                  <a:gd name="connsiteX155" fmla="*/ 373273 h 605239"/>
                  <a:gd name="connsiteY155" fmla="*/ 373273 h 605239"/>
                  <a:gd name="connsiteX156" fmla="*/ 373273 h 605239"/>
                  <a:gd name="connsiteY156" fmla="*/ 373273 h 605239"/>
                  <a:gd name="connsiteX157" fmla="*/ 373273 h 605239"/>
                  <a:gd name="connsiteY157" fmla="*/ 373273 h 605239"/>
                  <a:gd name="connsiteX158" fmla="*/ 373273 h 605239"/>
                  <a:gd name="connsiteY158" fmla="*/ 373273 h 605239"/>
                  <a:gd name="connsiteX159" fmla="*/ 373273 h 605239"/>
                  <a:gd name="connsiteY159" fmla="*/ 373273 h 605239"/>
                  <a:gd name="connsiteX160" fmla="*/ 373273 h 605239"/>
                  <a:gd name="connsiteY160" fmla="*/ 373273 h 605239"/>
                  <a:gd name="connsiteX161" fmla="*/ 373273 h 605239"/>
                  <a:gd name="connsiteY161" fmla="*/ 373273 h 605239"/>
                  <a:gd name="connsiteX162" fmla="*/ 373273 h 605239"/>
                  <a:gd name="connsiteY162" fmla="*/ 373273 h 605239"/>
                  <a:gd name="connsiteX163" fmla="*/ 373273 h 605239"/>
                  <a:gd name="connsiteY163" fmla="*/ 373273 h 605239"/>
                  <a:gd name="connsiteX164" fmla="*/ 373273 h 605239"/>
                  <a:gd name="connsiteY164" fmla="*/ 373273 h 605239"/>
                  <a:gd name="connsiteX165" fmla="*/ 373273 h 605239"/>
                  <a:gd name="connsiteY165" fmla="*/ 373273 h 605239"/>
                  <a:gd name="connsiteX166" fmla="*/ 373273 h 605239"/>
                  <a:gd name="connsiteY166" fmla="*/ 373273 h 605239"/>
                  <a:gd name="connsiteX167" fmla="*/ 373273 h 605239"/>
                  <a:gd name="connsiteY167" fmla="*/ 373273 h 605239"/>
                  <a:gd name="connsiteX168" fmla="*/ 373273 h 605239"/>
                  <a:gd name="connsiteY168" fmla="*/ 373273 h 605239"/>
                  <a:gd name="connsiteX169" fmla="*/ 373273 h 605239"/>
                  <a:gd name="connsiteY169" fmla="*/ 373273 h 605239"/>
                  <a:gd name="connsiteX170" fmla="*/ 373273 h 605239"/>
                  <a:gd name="connsiteY170" fmla="*/ 373273 h 605239"/>
                  <a:gd name="connsiteX171" fmla="*/ 373273 h 605239"/>
                  <a:gd name="connsiteY171" fmla="*/ 373273 h 605239"/>
                  <a:gd name="connsiteX172" fmla="*/ 373273 h 605239"/>
                  <a:gd name="connsiteY172" fmla="*/ 373273 h 605239"/>
                  <a:gd name="connsiteX173" fmla="*/ 373273 h 605239"/>
                  <a:gd name="connsiteY173" fmla="*/ 373273 h 605239"/>
                  <a:gd name="connsiteX174" fmla="*/ 373273 h 605239"/>
                  <a:gd name="connsiteY174" fmla="*/ 373273 h 605239"/>
                  <a:gd name="connsiteX175" fmla="*/ 373273 h 605239"/>
                  <a:gd name="connsiteY175" fmla="*/ 373273 h 605239"/>
                  <a:gd name="connsiteX176" fmla="*/ 373273 h 605239"/>
                  <a:gd name="connsiteY176" fmla="*/ 373273 h 605239"/>
                  <a:gd name="connsiteX177" fmla="*/ 373273 h 605239"/>
                  <a:gd name="connsiteY177" fmla="*/ 373273 h 605239"/>
                  <a:gd name="connsiteX178" fmla="*/ 373273 h 605239"/>
                  <a:gd name="connsiteY178" fmla="*/ 373273 h 605239"/>
                  <a:gd name="connsiteX179" fmla="*/ 373273 h 605239"/>
                  <a:gd name="connsiteY179" fmla="*/ 373273 h 605239"/>
                  <a:gd name="connsiteX180" fmla="*/ 373273 h 605239"/>
                  <a:gd name="connsiteY180" fmla="*/ 373273 h 605239"/>
                  <a:gd name="connsiteX181" fmla="*/ 373273 h 605239"/>
                  <a:gd name="connsiteY181" fmla="*/ 373273 h 605239"/>
                  <a:gd name="connsiteX182" fmla="*/ 373273 h 605239"/>
                  <a:gd name="connsiteY182" fmla="*/ 373273 h 605239"/>
                  <a:gd name="connsiteX183" fmla="*/ 373273 h 605239"/>
                  <a:gd name="connsiteY183" fmla="*/ 373273 h 605239"/>
                  <a:gd name="connsiteX184" fmla="*/ 373273 h 605239"/>
                  <a:gd name="connsiteY184" fmla="*/ 373273 h 605239"/>
                  <a:gd name="connsiteX185" fmla="*/ 373273 h 605239"/>
                  <a:gd name="connsiteY185" fmla="*/ 373273 h 605239"/>
                  <a:gd name="connsiteX186" fmla="*/ 373273 h 605239"/>
                  <a:gd name="connsiteY186" fmla="*/ 373273 h 605239"/>
                  <a:gd name="connsiteX187" fmla="*/ 373273 h 605239"/>
                  <a:gd name="connsiteY187" fmla="*/ 373273 h 605239"/>
                  <a:gd name="connsiteX188" fmla="*/ 373273 h 605239"/>
                  <a:gd name="connsiteY188" fmla="*/ 373273 h 605239"/>
                  <a:gd name="connsiteX189" fmla="*/ 373273 h 605239"/>
                  <a:gd name="connsiteY189" fmla="*/ 373273 h 605239"/>
                  <a:gd name="connsiteX190" fmla="*/ 373273 h 605239"/>
                  <a:gd name="connsiteY190" fmla="*/ 373273 h 605239"/>
                  <a:gd name="connsiteX191" fmla="*/ 373273 h 605239"/>
                  <a:gd name="connsiteY191" fmla="*/ 373273 h 605239"/>
                  <a:gd name="connsiteX192" fmla="*/ 373273 h 605239"/>
                  <a:gd name="connsiteY192" fmla="*/ 373273 h 605239"/>
                  <a:gd name="connsiteX193" fmla="*/ 373273 h 605239"/>
                  <a:gd name="connsiteY193" fmla="*/ 373273 h 605239"/>
                  <a:gd name="connsiteX194" fmla="*/ 373273 h 605239"/>
                  <a:gd name="connsiteY194" fmla="*/ 373273 h 605239"/>
                  <a:gd name="connsiteX195" fmla="*/ 373273 h 605239"/>
                  <a:gd name="connsiteY195" fmla="*/ 373273 h 605239"/>
                  <a:gd name="connsiteX196" fmla="*/ 373273 h 605239"/>
                  <a:gd name="connsiteY196" fmla="*/ 373273 h 605239"/>
                  <a:gd name="connsiteX197" fmla="*/ 373273 h 605239"/>
                  <a:gd name="connsiteY197" fmla="*/ 373273 h 605239"/>
                  <a:gd name="connsiteX198" fmla="*/ 373273 h 605239"/>
                  <a:gd name="connsiteY198" fmla="*/ 373273 h 605239"/>
                  <a:gd name="connsiteX199" fmla="*/ 373273 h 605239"/>
                  <a:gd name="connsiteY199" fmla="*/ 373273 h 605239"/>
                  <a:gd name="connsiteX200" fmla="*/ 373273 h 605239"/>
                  <a:gd name="connsiteY200" fmla="*/ 373273 h 605239"/>
                  <a:gd name="connsiteX201" fmla="*/ 373273 h 605239"/>
                  <a:gd name="connsiteY201" fmla="*/ 373273 h 605239"/>
                  <a:gd name="connsiteX202" fmla="*/ 373273 h 605239"/>
                  <a:gd name="connsiteY202" fmla="*/ 373273 h 605239"/>
                  <a:gd name="connsiteX203" fmla="*/ 373273 h 605239"/>
                  <a:gd name="connsiteY203" fmla="*/ 373273 h 605239"/>
                  <a:gd name="connsiteX204" fmla="*/ 373273 h 605239"/>
                  <a:gd name="connsiteY204" fmla="*/ 373273 h 605239"/>
                  <a:gd name="connsiteX205" fmla="*/ 373273 h 605239"/>
                  <a:gd name="connsiteY205" fmla="*/ 373273 h 605239"/>
                  <a:gd name="connsiteX206" fmla="*/ 373273 h 605239"/>
                  <a:gd name="connsiteY206" fmla="*/ 373273 h 605239"/>
                  <a:gd name="connsiteX207" fmla="*/ 373273 h 605239"/>
                  <a:gd name="connsiteY207" fmla="*/ 373273 h 605239"/>
                  <a:gd name="connsiteX208" fmla="*/ 373273 h 605239"/>
                  <a:gd name="connsiteY208" fmla="*/ 373273 h 605239"/>
                  <a:gd name="connsiteX209" fmla="*/ 373273 h 605239"/>
                  <a:gd name="connsiteY209" fmla="*/ 373273 h 605239"/>
                  <a:gd name="connsiteX210" fmla="*/ 373273 h 605239"/>
                  <a:gd name="connsiteY210" fmla="*/ 373273 h 605239"/>
                  <a:gd name="connsiteX211" fmla="*/ 373273 h 605239"/>
                  <a:gd name="connsiteY211" fmla="*/ 373273 h 605239"/>
                  <a:gd name="connsiteX212" fmla="*/ 373273 h 605239"/>
                  <a:gd name="connsiteY212" fmla="*/ 373273 h 605239"/>
                  <a:gd name="connsiteX213" fmla="*/ 373273 h 605239"/>
                  <a:gd name="connsiteY213" fmla="*/ 373273 h 605239"/>
                  <a:gd name="connsiteX214" fmla="*/ 373273 h 605239"/>
                  <a:gd name="connsiteY214" fmla="*/ 373273 h 605239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428340 h 606087"/>
                  <a:gd name="connsiteX6" fmla="*/ 278159 w 556277"/>
                  <a:gd name="connsiteY6" fmla="*/ 430167 h 606087"/>
                  <a:gd name="connsiteX7" fmla="*/ 273728 w 556277"/>
                  <a:gd name="connsiteY7" fmla="*/ 428340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428340 h 606087"/>
                  <a:gd name="connsiteX6" fmla="*/ 278159 w 556277"/>
                  <a:gd name="connsiteY6" fmla="*/ 430167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428340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8159 w 556277"/>
                  <a:gd name="connsiteY0" fmla="*/ 17225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8159 w 556277"/>
                  <a:gd name="connsiteY12" fmla="*/ 17225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0418 w 556277"/>
                  <a:gd name="connsiteY0" fmla="*/ 236110 h 606087"/>
                  <a:gd name="connsiteX1" fmla="*/ 286828 w 556277"/>
                  <a:gd name="connsiteY1" fmla="*/ 180136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0418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0418 w 556277"/>
                  <a:gd name="connsiteY0" fmla="*/ 236110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180136 h 606087"/>
                  <a:gd name="connsiteX12" fmla="*/ 270418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0418 w 556277"/>
                  <a:gd name="connsiteY0" fmla="*/ 236110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0418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2353 w 556277"/>
                  <a:gd name="connsiteY0" fmla="*/ 255462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2353 w 556277"/>
                  <a:gd name="connsiteY12" fmla="*/ 255462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68483 w 556277"/>
                  <a:gd name="connsiteY0" fmla="*/ 236110 h 606087"/>
                  <a:gd name="connsiteX1" fmla="*/ 286828 w 556277"/>
                  <a:gd name="connsiteY1" fmla="*/ 245931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68483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68483 w 556277"/>
                  <a:gd name="connsiteY0" fmla="*/ 236110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68483 w 556277"/>
                  <a:gd name="connsiteY12" fmla="*/ 236110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6224 w 556277"/>
                  <a:gd name="connsiteY0" fmla="*/ 230305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85339 w 556277"/>
                  <a:gd name="connsiteY7" fmla="*/ 290944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6224 w 556277"/>
                  <a:gd name="connsiteY12" fmla="*/ 230305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6224 w 556277"/>
                  <a:gd name="connsiteY0" fmla="*/ 230305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91145 w 556277"/>
                  <a:gd name="connsiteY7" fmla="*/ 285138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6224 w 556277"/>
                  <a:gd name="connsiteY12" fmla="*/ 230305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  <a:gd name="connsiteX0" fmla="*/ 276224 w 556277"/>
                  <a:gd name="connsiteY0" fmla="*/ 230305 h 606087"/>
                  <a:gd name="connsiteX1" fmla="*/ 279087 w 556277"/>
                  <a:gd name="connsiteY1" fmla="*/ 224644 h 606087"/>
                  <a:gd name="connsiteX2" fmla="*/ 394620 w 556277"/>
                  <a:gd name="connsiteY2" fmla="*/ 227257 h 606087"/>
                  <a:gd name="connsiteX3" fmla="*/ 402904 w 556277"/>
                  <a:gd name="connsiteY3" fmla="*/ 229373 h 606087"/>
                  <a:gd name="connsiteX4" fmla="*/ 398158 w 556277"/>
                  <a:gd name="connsiteY4" fmla="*/ 243833 h 606087"/>
                  <a:gd name="connsiteX5" fmla="*/ 282590 w 556277"/>
                  <a:gd name="connsiteY5" fmla="*/ 292879 h 606087"/>
                  <a:gd name="connsiteX6" fmla="*/ 282029 w 556277"/>
                  <a:gd name="connsiteY6" fmla="*/ 290836 h 606087"/>
                  <a:gd name="connsiteX7" fmla="*/ 296951 w 556277"/>
                  <a:gd name="connsiteY7" fmla="*/ 292879 h 606087"/>
                  <a:gd name="connsiteX8" fmla="*/ 152257 w 556277"/>
                  <a:gd name="connsiteY8" fmla="*/ 238028 h 606087"/>
                  <a:gd name="connsiteX9" fmla="*/ 153317 w 556277"/>
                  <a:gd name="connsiteY9" fmla="*/ 229373 h 606087"/>
                  <a:gd name="connsiteX10" fmla="*/ 161601 w 556277"/>
                  <a:gd name="connsiteY10" fmla="*/ 227257 h 606087"/>
                  <a:gd name="connsiteX11" fmla="*/ 269489 w 556277"/>
                  <a:gd name="connsiteY11" fmla="*/ 228515 h 606087"/>
                  <a:gd name="connsiteX12" fmla="*/ 276224 w 556277"/>
                  <a:gd name="connsiteY12" fmla="*/ 230305 h 606087"/>
                  <a:gd name="connsiteX13" fmla="*/ 230104 w 556277"/>
                  <a:gd name="connsiteY13" fmla="*/ 104060 h 606087"/>
                  <a:gd name="connsiteX14" fmla="*/ 122343 w 556277"/>
                  <a:gd name="connsiteY14" fmla="*/ 160995 h 606087"/>
                  <a:gd name="connsiteX15" fmla="*/ 122824 w 556277"/>
                  <a:gd name="connsiteY15" fmla="*/ 162630 h 606087"/>
                  <a:gd name="connsiteX16" fmla="*/ 124173 w 556277"/>
                  <a:gd name="connsiteY16" fmla="*/ 166380 h 606087"/>
                  <a:gd name="connsiteX17" fmla="*/ 124847 w 556277"/>
                  <a:gd name="connsiteY17" fmla="*/ 170035 h 606087"/>
                  <a:gd name="connsiteX18" fmla="*/ 125810 w 556277"/>
                  <a:gd name="connsiteY18" fmla="*/ 173979 h 606087"/>
                  <a:gd name="connsiteX19" fmla="*/ 126291 w 556277"/>
                  <a:gd name="connsiteY19" fmla="*/ 179268 h 606087"/>
                  <a:gd name="connsiteX20" fmla="*/ 126291 w 556277"/>
                  <a:gd name="connsiteY20" fmla="*/ 183596 h 606087"/>
                  <a:gd name="connsiteX21" fmla="*/ 126195 w 556277"/>
                  <a:gd name="connsiteY21" fmla="*/ 188885 h 606087"/>
                  <a:gd name="connsiteX22" fmla="*/ 125617 w 556277"/>
                  <a:gd name="connsiteY22" fmla="*/ 191867 h 606087"/>
                  <a:gd name="connsiteX23" fmla="*/ 124847 w 556277"/>
                  <a:gd name="connsiteY23" fmla="*/ 196868 h 606087"/>
                  <a:gd name="connsiteX24" fmla="*/ 124173 w 556277"/>
                  <a:gd name="connsiteY24" fmla="*/ 199753 h 606087"/>
                  <a:gd name="connsiteX25" fmla="*/ 122535 w 556277"/>
                  <a:gd name="connsiteY25" fmla="*/ 204947 h 606087"/>
                  <a:gd name="connsiteX26" fmla="*/ 121476 w 556277"/>
                  <a:gd name="connsiteY26" fmla="*/ 207351 h 606087"/>
                  <a:gd name="connsiteX27" fmla="*/ 117913 w 556277"/>
                  <a:gd name="connsiteY27" fmla="*/ 214660 h 606087"/>
                  <a:gd name="connsiteX28" fmla="*/ 113387 w 556277"/>
                  <a:gd name="connsiteY28" fmla="*/ 221296 h 606087"/>
                  <a:gd name="connsiteX29" fmla="*/ 111653 w 556277"/>
                  <a:gd name="connsiteY29" fmla="*/ 223604 h 606087"/>
                  <a:gd name="connsiteX30" fmla="*/ 108187 w 556277"/>
                  <a:gd name="connsiteY30" fmla="*/ 227355 h 606087"/>
                  <a:gd name="connsiteX31" fmla="*/ 105683 w 556277"/>
                  <a:gd name="connsiteY31" fmla="*/ 229663 h 606087"/>
                  <a:gd name="connsiteX32" fmla="*/ 102408 w 556277"/>
                  <a:gd name="connsiteY32" fmla="*/ 232548 h 606087"/>
                  <a:gd name="connsiteX33" fmla="*/ 99519 w 556277"/>
                  <a:gd name="connsiteY33" fmla="*/ 234664 h 606087"/>
                  <a:gd name="connsiteX34" fmla="*/ 95956 w 556277"/>
                  <a:gd name="connsiteY34" fmla="*/ 237069 h 606087"/>
                  <a:gd name="connsiteX35" fmla="*/ 92778 w 556277"/>
                  <a:gd name="connsiteY35" fmla="*/ 238704 h 606087"/>
                  <a:gd name="connsiteX36" fmla="*/ 89023 w 556277"/>
                  <a:gd name="connsiteY36" fmla="*/ 240627 h 606087"/>
                  <a:gd name="connsiteX37" fmla="*/ 85556 w 556277"/>
                  <a:gd name="connsiteY37" fmla="*/ 242070 h 606087"/>
                  <a:gd name="connsiteX38" fmla="*/ 81607 w 556277"/>
                  <a:gd name="connsiteY38" fmla="*/ 243416 h 606087"/>
                  <a:gd name="connsiteX39" fmla="*/ 78140 w 556277"/>
                  <a:gd name="connsiteY39" fmla="*/ 244282 h 606087"/>
                  <a:gd name="connsiteX40" fmla="*/ 73903 w 556277"/>
                  <a:gd name="connsiteY40" fmla="*/ 245147 h 606087"/>
                  <a:gd name="connsiteX41" fmla="*/ 70436 w 556277"/>
                  <a:gd name="connsiteY41" fmla="*/ 245724 h 606087"/>
                  <a:gd name="connsiteX42" fmla="*/ 68992 w 556277"/>
                  <a:gd name="connsiteY42" fmla="*/ 245917 h 606087"/>
                  <a:gd name="connsiteX43" fmla="*/ 68992 w 556277"/>
                  <a:gd name="connsiteY43" fmla="*/ 360075 h 606087"/>
                  <a:gd name="connsiteX44" fmla="*/ 71785 w 556277"/>
                  <a:gd name="connsiteY44" fmla="*/ 360459 h 606087"/>
                  <a:gd name="connsiteX45" fmla="*/ 74674 w 556277"/>
                  <a:gd name="connsiteY45" fmla="*/ 360844 h 606087"/>
                  <a:gd name="connsiteX46" fmla="*/ 80644 w 556277"/>
                  <a:gd name="connsiteY46" fmla="*/ 362383 h 606087"/>
                  <a:gd name="connsiteX47" fmla="*/ 82956 w 556277"/>
                  <a:gd name="connsiteY47" fmla="*/ 362960 h 606087"/>
                  <a:gd name="connsiteX48" fmla="*/ 90756 w 556277"/>
                  <a:gd name="connsiteY48" fmla="*/ 366038 h 606087"/>
                  <a:gd name="connsiteX49" fmla="*/ 92104 w 556277"/>
                  <a:gd name="connsiteY49" fmla="*/ 366807 h 606087"/>
                  <a:gd name="connsiteX50" fmla="*/ 98075 w 556277"/>
                  <a:gd name="connsiteY50" fmla="*/ 370269 h 606087"/>
                  <a:gd name="connsiteX51" fmla="*/ 100482 w 556277"/>
                  <a:gd name="connsiteY51" fmla="*/ 372000 h 606087"/>
                  <a:gd name="connsiteX52" fmla="*/ 104912 w 556277"/>
                  <a:gd name="connsiteY52" fmla="*/ 375463 h 606087"/>
                  <a:gd name="connsiteX53" fmla="*/ 107224 w 556277"/>
                  <a:gd name="connsiteY53" fmla="*/ 377675 h 606087"/>
                  <a:gd name="connsiteX54" fmla="*/ 111268 w 556277"/>
                  <a:gd name="connsiteY54" fmla="*/ 381906 h 606087"/>
                  <a:gd name="connsiteX55" fmla="*/ 113002 w 556277"/>
                  <a:gd name="connsiteY55" fmla="*/ 384118 h 606087"/>
                  <a:gd name="connsiteX56" fmla="*/ 117913 w 556277"/>
                  <a:gd name="connsiteY56" fmla="*/ 391427 h 606087"/>
                  <a:gd name="connsiteX57" fmla="*/ 121476 w 556277"/>
                  <a:gd name="connsiteY57" fmla="*/ 398737 h 606087"/>
                  <a:gd name="connsiteX58" fmla="*/ 122343 w 556277"/>
                  <a:gd name="connsiteY58" fmla="*/ 400949 h 606087"/>
                  <a:gd name="connsiteX59" fmla="*/ 124173 w 556277"/>
                  <a:gd name="connsiteY59" fmla="*/ 406334 h 606087"/>
                  <a:gd name="connsiteX60" fmla="*/ 124750 w 556277"/>
                  <a:gd name="connsiteY60" fmla="*/ 408931 h 606087"/>
                  <a:gd name="connsiteX61" fmla="*/ 125810 w 556277"/>
                  <a:gd name="connsiteY61" fmla="*/ 414413 h 606087"/>
                  <a:gd name="connsiteX62" fmla="*/ 126002 w 556277"/>
                  <a:gd name="connsiteY62" fmla="*/ 416817 h 606087"/>
                  <a:gd name="connsiteX63" fmla="*/ 126387 w 556277"/>
                  <a:gd name="connsiteY63" fmla="*/ 423838 h 606087"/>
                  <a:gd name="connsiteX64" fmla="*/ 126387 w 556277"/>
                  <a:gd name="connsiteY64" fmla="*/ 424607 h 606087"/>
                  <a:gd name="connsiteX65" fmla="*/ 125617 w 556277"/>
                  <a:gd name="connsiteY65" fmla="*/ 432397 h 606087"/>
                  <a:gd name="connsiteX66" fmla="*/ 125136 w 556277"/>
                  <a:gd name="connsiteY66" fmla="*/ 434706 h 606087"/>
                  <a:gd name="connsiteX67" fmla="*/ 123884 w 556277"/>
                  <a:gd name="connsiteY67" fmla="*/ 440091 h 606087"/>
                  <a:gd name="connsiteX68" fmla="*/ 123113 w 556277"/>
                  <a:gd name="connsiteY68" fmla="*/ 442784 h 606087"/>
                  <a:gd name="connsiteX69" fmla="*/ 122343 w 556277"/>
                  <a:gd name="connsiteY69" fmla="*/ 444900 h 606087"/>
                  <a:gd name="connsiteX70" fmla="*/ 230104 w 556277"/>
                  <a:gd name="connsiteY70" fmla="*/ 501835 h 606087"/>
                  <a:gd name="connsiteX71" fmla="*/ 232127 w 556277"/>
                  <a:gd name="connsiteY71" fmla="*/ 499719 h 606087"/>
                  <a:gd name="connsiteX72" fmla="*/ 233764 w 556277"/>
                  <a:gd name="connsiteY72" fmla="*/ 498084 h 606087"/>
                  <a:gd name="connsiteX73" fmla="*/ 238386 w 556277"/>
                  <a:gd name="connsiteY73" fmla="*/ 493949 h 606087"/>
                  <a:gd name="connsiteX74" fmla="*/ 239542 w 556277"/>
                  <a:gd name="connsiteY74" fmla="*/ 492891 h 606087"/>
                  <a:gd name="connsiteX75" fmla="*/ 245898 w 556277"/>
                  <a:gd name="connsiteY75" fmla="*/ 488659 h 606087"/>
                  <a:gd name="connsiteX76" fmla="*/ 247150 w 556277"/>
                  <a:gd name="connsiteY76" fmla="*/ 487890 h 606087"/>
                  <a:gd name="connsiteX77" fmla="*/ 252735 w 556277"/>
                  <a:gd name="connsiteY77" fmla="*/ 485101 h 606087"/>
                  <a:gd name="connsiteX78" fmla="*/ 255143 w 556277"/>
                  <a:gd name="connsiteY78" fmla="*/ 484235 h 606087"/>
                  <a:gd name="connsiteX79" fmla="*/ 260054 w 556277"/>
                  <a:gd name="connsiteY79" fmla="*/ 482408 h 606087"/>
                  <a:gd name="connsiteX80" fmla="*/ 262654 w 556277"/>
                  <a:gd name="connsiteY80" fmla="*/ 481831 h 606087"/>
                  <a:gd name="connsiteX81" fmla="*/ 267854 w 556277"/>
                  <a:gd name="connsiteY81" fmla="*/ 480677 h 606087"/>
                  <a:gd name="connsiteX82" fmla="*/ 270262 w 556277"/>
                  <a:gd name="connsiteY82" fmla="*/ 480292 h 606087"/>
                  <a:gd name="connsiteX83" fmla="*/ 278159 w 556277"/>
                  <a:gd name="connsiteY83" fmla="*/ 479811 h 606087"/>
                  <a:gd name="connsiteX84" fmla="*/ 285959 w 556277"/>
                  <a:gd name="connsiteY84" fmla="*/ 480292 h 606087"/>
                  <a:gd name="connsiteX85" fmla="*/ 288367 w 556277"/>
                  <a:gd name="connsiteY85" fmla="*/ 480677 h 606087"/>
                  <a:gd name="connsiteX86" fmla="*/ 293567 w 556277"/>
                  <a:gd name="connsiteY86" fmla="*/ 481831 h 606087"/>
                  <a:gd name="connsiteX87" fmla="*/ 296167 w 556277"/>
                  <a:gd name="connsiteY87" fmla="*/ 482600 h 606087"/>
                  <a:gd name="connsiteX88" fmla="*/ 301175 w 556277"/>
                  <a:gd name="connsiteY88" fmla="*/ 484235 h 606087"/>
                  <a:gd name="connsiteX89" fmla="*/ 303486 w 556277"/>
                  <a:gd name="connsiteY89" fmla="*/ 485197 h 606087"/>
                  <a:gd name="connsiteX90" fmla="*/ 308975 w 556277"/>
                  <a:gd name="connsiteY90" fmla="*/ 487890 h 606087"/>
                  <a:gd name="connsiteX91" fmla="*/ 310323 w 556277"/>
                  <a:gd name="connsiteY91" fmla="*/ 488659 h 606087"/>
                  <a:gd name="connsiteX92" fmla="*/ 316679 w 556277"/>
                  <a:gd name="connsiteY92" fmla="*/ 492891 h 606087"/>
                  <a:gd name="connsiteX93" fmla="*/ 317931 w 556277"/>
                  <a:gd name="connsiteY93" fmla="*/ 494045 h 606087"/>
                  <a:gd name="connsiteX94" fmla="*/ 322457 w 556277"/>
                  <a:gd name="connsiteY94" fmla="*/ 498084 h 606087"/>
                  <a:gd name="connsiteX95" fmla="*/ 324094 w 556277"/>
                  <a:gd name="connsiteY95" fmla="*/ 499719 h 606087"/>
                  <a:gd name="connsiteX96" fmla="*/ 326117 w 556277"/>
                  <a:gd name="connsiteY96" fmla="*/ 501835 h 606087"/>
                  <a:gd name="connsiteX97" fmla="*/ 433878 w 556277"/>
                  <a:gd name="connsiteY97" fmla="*/ 444900 h 606087"/>
                  <a:gd name="connsiteX98" fmla="*/ 433397 w 556277"/>
                  <a:gd name="connsiteY98" fmla="*/ 443457 h 606087"/>
                  <a:gd name="connsiteX99" fmla="*/ 432145 w 556277"/>
                  <a:gd name="connsiteY99" fmla="*/ 439514 h 606087"/>
                  <a:gd name="connsiteX100" fmla="*/ 431182 w 556277"/>
                  <a:gd name="connsiteY100" fmla="*/ 435860 h 606087"/>
                  <a:gd name="connsiteX101" fmla="*/ 430508 w 556277"/>
                  <a:gd name="connsiteY101" fmla="*/ 432013 h 606087"/>
                  <a:gd name="connsiteX102" fmla="*/ 429930 w 556277"/>
                  <a:gd name="connsiteY102" fmla="*/ 426627 h 606087"/>
                  <a:gd name="connsiteX103" fmla="*/ 429930 w 556277"/>
                  <a:gd name="connsiteY103" fmla="*/ 422492 h 606087"/>
                  <a:gd name="connsiteX104" fmla="*/ 430122 w 556277"/>
                  <a:gd name="connsiteY104" fmla="*/ 417010 h 606087"/>
                  <a:gd name="connsiteX105" fmla="*/ 430604 w 556277"/>
                  <a:gd name="connsiteY105" fmla="*/ 414028 h 606087"/>
                  <a:gd name="connsiteX106" fmla="*/ 431374 w 556277"/>
                  <a:gd name="connsiteY106" fmla="*/ 409220 h 606087"/>
                  <a:gd name="connsiteX107" fmla="*/ 432145 w 556277"/>
                  <a:gd name="connsiteY107" fmla="*/ 406142 h 606087"/>
                  <a:gd name="connsiteX108" fmla="*/ 433782 w 556277"/>
                  <a:gd name="connsiteY108" fmla="*/ 401141 h 606087"/>
                  <a:gd name="connsiteX109" fmla="*/ 434745 w 556277"/>
                  <a:gd name="connsiteY109" fmla="*/ 398737 h 606087"/>
                  <a:gd name="connsiteX110" fmla="*/ 438308 w 556277"/>
                  <a:gd name="connsiteY110" fmla="*/ 391427 h 606087"/>
                  <a:gd name="connsiteX111" fmla="*/ 443219 w 556277"/>
                  <a:gd name="connsiteY111" fmla="*/ 384118 h 606087"/>
                  <a:gd name="connsiteX112" fmla="*/ 444857 w 556277"/>
                  <a:gd name="connsiteY112" fmla="*/ 382195 h 606087"/>
                  <a:gd name="connsiteX113" fmla="*/ 449190 w 556277"/>
                  <a:gd name="connsiteY113" fmla="*/ 377482 h 606087"/>
                  <a:gd name="connsiteX114" fmla="*/ 451212 w 556277"/>
                  <a:gd name="connsiteY114" fmla="*/ 375751 h 606087"/>
                  <a:gd name="connsiteX115" fmla="*/ 456220 w 556277"/>
                  <a:gd name="connsiteY115" fmla="*/ 371712 h 606087"/>
                  <a:gd name="connsiteX116" fmla="*/ 457857 w 556277"/>
                  <a:gd name="connsiteY116" fmla="*/ 370462 h 606087"/>
                  <a:gd name="connsiteX117" fmla="*/ 473554 w 556277"/>
                  <a:gd name="connsiteY117" fmla="*/ 362864 h 606087"/>
                  <a:gd name="connsiteX118" fmla="*/ 475095 w 556277"/>
                  <a:gd name="connsiteY118" fmla="*/ 362479 h 606087"/>
                  <a:gd name="connsiteX119" fmla="*/ 481836 w 556277"/>
                  <a:gd name="connsiteY119" fmla="*/ 360844 h 606087"/>
                  <a:gd name="connsiteX120" fmla="*/ 484436 w 556277"/>
                  <a:gd name="connsiteY120" fmla="*/ 360459 h 606087"/>
                  <a:gd name="connsiteX121" fmla="*/ 487229 w 556277"/>
                  <a:gd name="connsiteY121" fmla="*/ 360075 h 606087"/>
                  <a:gd name="connsiteX122" fmla="*/ 487229 w 556277"/>
                  <a:gd name="connsiteY122" fmla="*/ 245917 h 606087"/>
                  <a:gd name="connsiteX123" fmla="*/ 485881 w 556277"/>
                  <a:gd name="connsiteY123" fmla="*/ 245724 h 606087"/>
                  <a:gd name="connsiteX124" fmla="*/ 482318 w 556277"/>
                  <a:gd name="connsiteY124" fmla="*/ 245147 h 606087"/>
                  <a:gd name="connsiteX125" fmla="*/ 478081 w 556277"/>
                  <a:gd name="connsiteY125" fmla="*/ 244282 h 606087"/>
                  <a:gd name="connsiteX126" fmla="*/ 474614 w 556277"/>
                  <a:gd name="connsiteY126" fmla="*/ 243416 h 606087"/>
                  <a:gd name="connsiteX127" fmla="*/ 470665 w 556277"/>
                  <a:gd name="connsiteY127" fmla="*/ 242070 h 606087"/>
                  <a:gd name="connsiteX128" fmla="*/ 467295 w 556277"/>
                  <a:gd name="connsiteY128" fmla="*/ 240627 h 606087"/>
                  <a:gd name="connsiteX129" fmla="*/ 463443 w 556277"/>
                  <a:gd name="connsiteY129" fmla="*/ 238896 h 606087"/>
                  <a:gd name="connsiteX130" fmla="*/ 460265 w 556277"/>
                  <a:gd name="connsiteY130" fmla="*/ 237069 h 606087"/>
                  <a:gd name="connsiteX131" fmla="*/ 456798 w 556277"/>
                  <a:gd name="connsiteY131" fmla="*/ 234664 h 606087"/>
                  <a:gd name="connsiteX132" fmla="*/ 453813 w 556277"/>
                  <a:gd name="connsiteY132" fmla="*/ 232548 h 606087"/>
                  <a:gd name="connsiteX133" fmla="*/ 450538 w 556277"/>
                  <a:gd name="connsiteY133" fmla="*/ 229663 h 606087"/>
                  <a:gd name="connsiteX134" fmla="*/ 448034 w 556277"/>
                  <a:gd name="connsiteY134" fmla="*/ 227355 h 606087"/>
                  <a:gd name="connsiteX135" fmla="*/ 444664 w 556277"/>
                  <a:gd name="connsiteY135" fmla="*/ 223604 h 606087"/>
                  <a:gd name="connsiteX136" fmla="*/ 442834 w 556277"/>
                  <a:gd name="connsiteY136" fmla="*/ 221296 h 606087"/>
                  <a:gd name="connsiteX137" fmla="*/ 438308 w 556277"/>
                  <a:gd name="connsiteY137" fmla="*/ 214660 h 606087"/>
                  <a:gd name="connsiteX138" fmla="*/ 434745 w 556277"/>
                  <a:gd name="connsiteY138" fmla="*/ 207351 h 606087"/>
                  <a:gd name="connsiteX139" fmla="*/ 433878 w 556277"/>
                  <a:gd name="connsiteY139" fmla="*/ 205043 h 606087"/>
                  <a:gd name="connsiteX140" fmla="*/ 432145 w 556277"/>
                  <a:gd name="connsiteY140" fmla="*/ 199753 h 606087"/>
                  <a:gd name="connsiteX141" fmla="*/ 431471 w 556277"/>
                  <a:gd name="connsiteY141" fmla="*/ 196964 h 606087"/>
                  <a:gd name="connsiteX142" fmla="*/ 430508 w 556277"/>
                  <a:gd name="connsiteY142" fmla="*/ 191675 h 606087"/>
                  <a:gd name="connsiteX143" fmla="*/ 430219 w 556277"/>
                  <a:gd name="connsiteY143" fmla="*/ 189174 h 606087"/>
                  <a:gd name="connsiteX144" fmla="*/ 429834 w 556277"/>
                  <a:gd name="connsiteY144" fmla="*/ 182057 h 606087"/>
                  <a:gd name="connsiteX145" fmla="*/ 429834 w 556277"/>
                  <a:gd name="connsiteY145" fmla="*/ 181288 h 606087"/>
                  <a:gd name="connsiteX146" fmla="*/ 430604 w 556277"/>
                  <a:gd name="connsiteY146" fmla="*/ 173594 h 606087"/>
                  <a:gd name="connsiteX147" fmla="*/ 431085 w 556277"/>
                  <a:gd name="connsiteY147" fmla="*/ 171093 h 606087"/>
                  <a:gd name="connsiteX148" fmla="*/ 432337 w 556277"/>
                  <a:gd name="connsiteY148" fmla="*/ 165899 h 606087"/>
                  <a:gd name="connsiteX149" fmla="*/ 433204 w 556277"/>
                  <a:gd name="connsiteY149" fmla="*/ 163110 h 606087"/>
                  <a:gd name="connsiteX150" fmla="*/ 433878 w 556277"/>
                  <a:gd name="connsiteY150" fmla="*/ 160995 h 606087"/>
                  <a:gd name="connsiteX151" fmla="*/ 326213 w 556277"/>
                  <a:gd name="connsiteY151" fmla="*/ 104060 h 606087"/>
                  <a:gd name="connsiteX152" fmla="*/ 324287 w 556277"/>
                  <a:gd name="connsiteY152" fmla="*/ 106079 h 606087"/>
                  <a:gd name="connsiteX153" fmla="*/ 322457 w 556277"/>
                  <a:gd name="connsiteY153" fmla="*/ 108099 h 606087"/>
                  <a:gd name="connsiteX154" fmla="*/ 318220 w 556277"/>
                  <a:gd name="connsiteY154" fmla="*/ 111850 h 606087"/>
                  <a:gd name="connsiteX155" fmla="*/ 316679 w 556277"/>
                  <a:gd name="connsiteY155" fmla="*/ 113100 h 606087"/>
                  <a:gd name="connsiteX156" fmla="*/ 310323 w 556277"/>
                  <a:gd name="connsiteY156" fmla="*/ 117428 h 606087"/>
                  <a:gd name="connsiteX157" fmla="*/ 308879 w 556277"/>
                  <a:gd name="connsiteY157" fmla="*/ 118197 h 606087"/>
                  <a:gd name="connsiteX158" fmla="*/ 303582 w 556277"/>
                  <a:gd name="connsiteY158" fmla="*/ 120794 h 606087"/>
                  <a:gd name="connsiteX159" fmla="*/ 300982 w 556277"/>
                  <a:gd name="connsiteY159" fmla="*/ 121852 h 606087"/>
                  <a:gd name="connsiteX160" fmla="*/ 296360 w 556277"/>
                  <a:gd name="connsiteY160" fmla="*/ 123487 h 606087"/>
                  <a:gd name="connsiteX161" fmla="*/ 293567 w 556277"/>
                  <a:gd name="connsiteY161" fmla="*/ 124256 h 606087"/>
                  <a:gd name="connsiteX162" fmla="*/ 288367 w 556277"/>
                  <a:gd name="connsiteY162" fmla="*/ 125218 h 606087"/>
                  <a:gd name="connsiteX163" fmla="*/ 285959 w 556277"/>
                  <a:gd name="connsiteY163" fmla="*/ 125795 h 606087"/>
                  <a:gd name="connsiteX164" fmla="*/ 278159 w 556277"/>
                  <a:gd name="connsiteY164" fmla="*/ 126276 h 606087"/>
                  <a:gd name="connsiteX165" fmla="*/ 270262 w 556277"/>
                  <a:gd name="connsiteY165" fmla="*/ 125795 h 606087"/>
                  <a:gd name="connsiteX166" fmla="*/ 267854 w 556277"/>
                  <a:gd name="connsiteY166" fmla="*/ 125218 h 606087"/>
                  <a:gd name="connsiteX167" fmla="*/ 262654 w 556277"/>
                  <a:gd name="connsiteY167" fmla="*/ 124256 h 606087"/>
                  <a:gd name="connsiteX168" fmla="*/ 259958 w 556277"/>
                  <a:gd name="connsiteY168" fmla="*/ 123487 h 606087"/>
                  <a:gd name="connsiteX169" fmla="*/ 255239 w 556277"/>
                  <a:gd name="connsiteY169" fmla="*/ 121852 h 606087"/>
                  <a:gd name="connsiteX170" fmla="*/ 252735 w 556277"/>
                  <a:gd name="connsiteY170" fmla="*/ 120794 h 606087"/>
                  <a:gd name="connsiteX171" fmla="*/ 247535 w 556277"/>
                  <a:gd name="connsiteY171" fmla="*/ 118197 h 606087"/>
                  <a:gd name="connsiteX172" fmla="*/ 245898 w 556277"/>
                  <a:gd name="connsiteY172" fmla="*/ 117332 h 606087"/>
                  <a:gd name="connsiteX173" fmla="*/ 239542 w 556277"/>
                  <a:gd name="connsiteY173" fmla="*/ 113100 h 606087"/>
                  <a:gd name="connsiteX174" fmla="*/ 238001 w 556277"/>
                  <a:gd name="connsiteY174" fmla="*/ 111754 h 606087"/>
                  <a:gd name="connsiteX175" fmla="*/ 233860 w 556277"/>
                  <a:gd name="connsiteY175" fmla="*/ 108099 h 606087"/>
                  <a:gd name="connsiteX176" fmla="*/ 231934 w 556277"/>
                  <a:gd name="connsiteY176" fmla="*/ 106079 h 606087"/>
                  <a:gd name="connsiteX177" fmla="*/ 230104 w 556277"/>
                  <a:gd name="connsiteY177" fmla="*/ 104060 h 606087"/>
                  <a:gd name="connsiteX178" fmla="*/ 278159 w 556277"/>
                  <a:gd name="connsiteY178" fmla="*/ 0 h 606087"/>
                  <a:gd name="connsiteX179" fmla="*/ 341332 w 556277"/>
                  <a:gd name="connsiteY179" fmla="*/ 63090 h 606087"/>
                  <a:gd name="connsiteX180" fmla="*/ 338347 w 556277"/>
                  <a:gd name="connsiteY180" fmla="*/ 81940 h 606087"/>
                  <a:gd name="connsiteX181" fmla="*/ 447264 w 556277"/>
                  <a:gd name="connsiteY181" fmla="*/ 139548 h 606087"/>
                  <a:gd name="connsiteX182" fmla="*/ 461324 w 556277"/>
                  <a:gd name="connsiteY182" fmla="*/ 128392 h 606087"/>
                  <a:gd name="connsiteX183" fmla="*/ 547803 w 556277"/>
                  <a:gd name="connsiteY183" fmla="*/ 151473 h 606087"/>
                  <a:gd name="connsiteX184" fmla="*/ 553966 w 556277"/>
                  <a:gd name="connsiteY184" fmla="*/ 199465 h 606087"/>
                  <a:gd name="connsiteX185" fmla="*/ 524498 w 556277"/>
                  <a:gd name="connsiteY185" fmla="*/ 237646 h 606087"/>
                  <a:gd name="connsiteX186" fmla="*/ 512556 w 556277"/>
                  <a:gd name="connsiteY186" fmla="*/ 242935 h 606087"/>
                  <a:gd name="connsiteX187" fmla="*/ 512556 w 556277"/>
                  <a:gd name="connsiteY187" fmla="*/ 362960 h 606087"/>
                  <a:gd name="connsiteX188" fmla="*/ 524690 w 556277"/>
                  <a:gd name="connsiteY188" fmla="*/ 368442 h 606087"/>
                  <a:gd name="connsiteX189" fmla="*/ 553966 w 556277"/>
                  <a:gd name="connsiteY189" fmla="*/ 406527 h 606087"/>
                  <a:gd name="connsiteX190" fmla="*/ 556277 w 556277"/>
                  <a:gd name="connsiteY190" fmla="*/ 423261 h 606087"/>
                  <a:gd name="connsiteX191" fmla="*/ 547803 w 556277"/>
                  <a:gd name="connsiteY191" fmla="*/ 454517 h 606087"/>
                  <a:gd name="connsiteX192" fmla="*/ 492911 w 556277"/>
                  <a:gd name="connsiteY192" fmla="*/ 485966 h 606087"/>
                  <a:gd name="connsiteX193" fmla="*/ 461324 w 556277"/>
                  <a:gd name="connsiteY193" fmla="*/ 477503 h 606087"/>
                  <a:gd name="connsiteX194" fmla="*/ 447360 w 556277"/>
                  <a:gd name="connsiteY194" fmla="*/ 466443 h 606087"/>
                  <a:gd name="connsiteX195" fmla="*/ 338251 w 556277"/>
                  <a:gd name="connsiteY195" fmla="*/ 524051 h 606087"/>
                  <a:gd name="connsiteX196" fmla="*/ 341332 w 556277"/>
                  <a:gd name="connsiteY196" fmla="*/ 542901 h 606087"/>
                  <a:gd name="connsiteX197" fmla="*/ 278159 w 556277"/>
                  <a:gd name="connsiteY197" fmla="*/ 606087 h 606087"/>
                  <a:gd name="connsiteX198" fmla="*/ 214889 w 556277"/>
                  <a:gd name="connsiteY198" fmla="*/ 542901 h 606087"/>
                  <a:gd name="connsiteX199" fmla="*/ 217970 w 556277"/>
                  <a:gd name="connsiteY199" fmla="*/ 524051 h 606087"/>
                  <a:gd name="connsiteX200" fmla="*/ 108861 w 556277"/>
                  <a:gd name="connsiteY200" fmla="*/ 466443 h 606087"/>
                  <a:gd name="connsiteX201" fmla="*/ 94897 w 556277"/>
                  <a:gd name="connsiteY201" fmla="*/ 477503 h 606087"/>
                  <a:gd name="connsiteX202" fmla="*/ 63310 w 556277"/>
                  <a:gd name="connsiteY202" fmla="*/ 485966 h 606087"/>
                  <a:gd name="connsiteX203" fmla="*/ 8418 w 556277"/>
                  <a:gd name="connsiteY203" fmla="*/ 454517 h 606087"/>
                  <a:gd name="connsiteX204" fmla="*/ 2255 w 556277"/>
                  <a:gd name="connsiteY204" fmla="*/ 406527 h 606087"/>
                  <a:gd name="connsiteX205" fmla="*/ 31723 w 556277"/>
                  <a:gd name="connsiteY205" fmla="*/ 368250 h 606087"/>
                  <a:gd name="connsiteX206" fmla="*/ 43761 w 556277"/>
                  <a:gd name="connsiteY206" fmla="*/ 362960 h 606087"/>
                  <a:gd name="connsiteX207" fmla="*/ 43761 w 556277"/>
                  <a:gd name="connsiteY207" fmla="*/ 242935 h 606087"/>
                  <a:gd name="connsiteX208" fmla="*/ 31627 w 556277"/>
                  <a:gd name="connsiteY208" fmla="*/ 237646 h 606087"/>
                  <a:gd name="connsiteX209" fmla="*/ 2255 w 556277"/>
                  <a:gd name="connsiteY209" fmla="*/ 199465 h 606087"/>
                  <a:gd name="connsiteX210" fmla="*/ 8418 w 556277"/>
                  <a:gd name="connsiteY210" fmla="*/ 151473 h 606087"/>
                  <a:gd name="connsiteX211" fmla="*/ 94897 w 556277"/>
                  <a:gd name="connsiteY211" fmla="*/ 128392 h 606087"/>
                  <a:gd name="connsiteX212" fmla="*/ 108861 w 556277"/>
                  <a:gd name="connsiteY212" fmla="*/ 139548 h 606087"/>
                  <a:gd name="connsiteX213" fmla="*/ 217970 w 556277"/>
                  <a:gd name="connsiteY213" fmla="*/ 81940 h 606087"/>
                  <a:gd name="connsiteX214" fmla="*/ 214889 w 556277"/>
                  <a:gd name="connsiteY214" fmla="*/ 63090 h 606087"/>
                  <a:gd name="connsiteX215" fmla="*/ 278159 w 556277"/>
                  <a:gd name="connsiteY215" fmla="*/ 0 h 6060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  <a:cxn ang="0">
                    <a:pos x="connsiteX169" y="connsiteY169"/>
                  </a:cxn>
                  <a:cxn ang="0">
                    <a:pos x="connsiteX170" y="connsiteY170"/>
                  </a:cxn>
                  <a:cxn ang="0">
                    <a:pos x="connsiteX171" y="connsiteY171"/>
                  </a:cxn>
                  <a:cxn ang="0">
                    <a:pos x="connsiteX172" y="connsiteY172"/>
                  </a:cxn>
                  <a:cxn ang="0">
                    <a:pos x="connsiteX173" y="connsiteY173"/>
                  </a:cxn>
                  <a:cxn ang="0">
                    <a:pos x="connsiteX174" y="connsiteY174"/>
                  </a:cxn>
                  <a:cxn ang="0">
                    <a:pos x="connsiteX175" y="connsiteY175"/>
                  </a:cxn>
                  <a:cxn ang="0">
                    <a:pos x="connsiteX176" y="connsiteY176"/>
                  </a:cxn>
                  <a:cxn ang="0">
                    <a:pos x="connsiteX177" y="connsiteY177"/>
                  </a:cxn>
                  <a:cxn ang="0">
                    <a:pos x="connsiteX178" y="connsiteY178"/>
                  </a:cxn>
                  <a:cxn ang="0">
                    <a:pos x="connsiteX179" y="connsiteY179"/>
                  </a:cxn>
                  <a:cxn ang="0">
                    <a:pos x="connsiteX180" y="connsiteY180"/>
                  </a:cxn>
                  <a:cxn ang="0">
                    <a:pos x="connsiteX181" y="connsiteY181"/>
                  </a:cxn>
                  <a:cxn ang="0">
                    <a:pos x="connsiteX182" y="connsiteY182"/>
                  </a:cxn>
                  <a:cxn ang="0">
                    <a:pos x="connsiteX183" y="connsiteY183"/>
                  </a:cxn>
                  <a:cxn ang="0">
                    <a:pos x="connsiteX184" y="connsiteY184"/>
                  </a:cxn>
                  <a:cxn ang="0">
                    <a:pos x="connsiteX185" y="connsiteY185"/>
                  </a:cxn>
                  <a:cxn ang="0">
                    <a:pos x="connsiteX186" y="connsiteY186"/>
                  </a:cxn>
                  <a:cxn ang="0">
                    <a:pos x="connsiteX187" y="connsiteY187"/>
                  </a:cxn>
                  <a:cxn ang="0">
                    <a:pos x="connsiteX188" y="connsiteY188"/>
                  </a:cxn>
                  <a:cxn ang="0">
                    <a:pos x="connsiteX189" y="connsiteY189"/>
                  </a:cxn>
                  <a:cxn ang="0">
                    <a:pos x="connsiteX190" y="connsiteY190"/>
                  </a:cxn>
                  <a:cxn ang="0">
                    <a:pos x="connsiteX191" y="connsiteY191"/>
                  </a:cxn>
                  <a:cxn ang="0">
                    <a:pos x="connsiteX192" y="connsiteY192"/>
                  </a:cxn>
                  <a:cxn ang="0">
                    <a:pos x="connsiteX193" y="connsiteY193"/>
                  </a:cxn>
                  <a:cxn ang="0">
                    <a:pos x="connsiteX194" y="connsiteY194"/>
                  </a:cxn>
                  <a:cxn ang="0">
                    <a:pos x="connsiteX195" y="connsiteY195"/>
                  </a:cxn>
                  <a:cxn ang="0">
                    <a:pos x="connsiteX196" y="connsiteY196"/>
                  </a:cxn>
                  <a:cxn ang="0">
                    <a:pos x="connsiteX197" y="connsiteY197"/>
                  </a:cxn>
                  <a:cxn ang="0">
                    <a:pos x="connsiteX198" y="connsiteY198"/>
                  </a:cxn>
                  <a:cxn ang="0">
                    <a:pos x="connsiteX199" y="connsiteY199"/>
                  </a:cxn>
                  <a:cxn ang="0">
                    <a:pos x="connsiteX200" y="connsiteY200"/>
                  </a:cxn>
                  <a:cxn ang="0">
                    <a:pos x="connsiteX201" y="connsiteY201"/>
                  </a:cxn>
                  <a:cxn ang="0">
                    <a:pos x="connsiteX202" y="connsiteY202"/>
                  </a:cxn>
                  <a:cxn ang="0">
                    <a:pos x="connsiteX203" y="connsiteY203"/>
                  </a:cxn>
                  <a:cxn ang="0">
                    <a:pos x="connsiteX204" y="connsiteY204"/>
                  </a:cxn>
                  <a:cxn ang="0">
                    <a:pos x="connsiteX205" y="connsiteY205"/>
                  </a:cxn>
                  <a:cxn ang="0">
                    <a:pos x="connsiteX206" y="connsiteY206"/>
                  </a:cxn>
                  <a:cxn ang="0">
                    <a:pos x="connsiteX207" y="connsiteY207"/>
                  </a:cxn>
                  <a:cxn ang="0">
                    <a:pos x="connsiteX208" y="connsiteY208"/>
                  </a:cxn>
                  <a:cxn ang="0">
                    <a:pos x="connsiteX209" y="connsiteY209"/>
                  </a:cxn>
                  <a:cxn ang="0">
                    <a:pos x="connsiteX210" y="connsiteY210"/>
                  </a:cxn>
                  <a:cxn ang="0">
                    <a:pos x="connsiteX211" y="connsiteY211"/>
                  </a:cxn>
                  <a:cxn ang="0">
                    <a:pos x="connsiteX212" y="connsiteY212"/>
                  </a:cxn>
                  <a:cxn ang="0">
                    <a:pos x="connsiteX213" y="connsiteY213"/>
                  </a:cxn>
                  <a:cxn ang="0">
                    <a:pos x="connsiteX214" y="connsiteY214"/>
                  </a:cxn>
                  <a:cxn ang="0">
                    <a:pos x="connsiteX215" y="connsiteY215"/>
                  </a:cxn>
                </a:cxnLst>
                <a:rect l="l" t="t" r="r" b="b"/>
                <a:pathLst>
                  <a:path w="556277" h="606087">
                    <a:moveTo>
                      <a:pt x="276224" y="230305"/>
                    </a:moveTo>
                    <a:lnTo>
                      <a:pt x="279087" y="224644"/>
                    </a:lnTo>
                    <a:cubicBezTo>
                      <a:pt x="279184" y="224932"/>
                      <a:pt x="316594" y="206774"/>
                      <a:pt x="394620" y="227257"/>
                    </a:cubicBezTo>
                    <a:lnTo>
                      <a:pt x="402904" y="229373"/>
                    </a:lnTo>
                    <a:cubicBezTo>
                      <a:pt x="403257" y="232258"/>
                      <a:pt x="397805" y="240948"/>
                      <a:pt x="398158" y="243833"/>
                    </a:cubicBezTo>
                    <a:cubicBezTo>
                      <a:pt x="398254" y="245179"/>
                      <a:pt x="418606" y="241623"/>
                      <a:pt x="282590" y="292879"/>
                    </a:cubicBezTo>
                    <a:lnTo>
                      <a:pt x="282029" y="290836"/>
                    </a:lnTo>
                    <a:lnTo>
                      <a:pt x="296951" y="292879"/>
                    </a:lnTo>
                    <a:lnTo>
                      <a:pt x="152257" y="238028"/>
                    </a:lnTo>
                    <a:lnTo>
                      <a:pt x="153317" y="229373"/>
                    </a:lnTo>
                    <a:lnTo>
                      <a:pt x="161601" y="227257"/>
                    </a:lnTo>
                    <a:cubicBezTo>
                      <a:pt x="239723" y="206774"/>
                      <a:pt x="269296" y="228803"/>
                      <a:pt x="269489" y="228515"/>
                    </a:cubicBezTo>
                    <a:cubicBezTo>
                      <a:pt x="269799" y="247173"/>
                      <a:pt x="275914" y="211647"/>
                      <a:pt x="276224" y="230305"/>
                    </a:cubicBezTo>
                    <a:close/>
                    <a:moveTo>
                      <a:pt x="230104" y="104060"/>
                    </a:moveTo>
                    <a:lnTo>
                      <a:pt x="122343" y="160995"/>
                    </a:lnTo>
                    <a:cubicBezTo>
                      <a:pt x="122632" y="161475"/>
                      <a:pt x="122632" y="162149"/>
                      <a:pt x="122824" y="162630"/>
                    </a:cubicBezTo>
                    <a:cubicBezTo>
                      <a:pt x="123210" y="163880"/>
                      <a:pt x="123787" y="165130"/>
                      <a:pt x="124173" y="166380"/>
                    </a:cubicBezTo>
                    <a:cubicBezTo>
                      <a:pt x="124365" y="167631"/>
                      <a:pt x="124654" y="168881"/>
                      <a:pt x="124847" y="170035"/>
                    </a:cubicBezTo>
                    <a:cubicBezTo>
                      <a:pt x="125232" y="171478"/>
                      <a:pt x="125521" y="172728"/>
                      <a:pt x="125810" y="173979"/>
                    </a:cubicBezTo>
                    <a:cubicBezTo>
                      <a:pt x="126002" y="175710"/>
                      <a:pt x="126195" y="177537"/>
                      <a:pt x="126291" y="179268"/>
                    </a:cubicBezTo>
                    <a:cubicBezTo>
                      <a:pt x="126291" y="180807"/>
                      <a:pt x="126387" y="182153"/>
                      <a:pt x="126291" y="183596"/>
                    </a:cubicBezTo>
                    <a:cubicBezTo>
                      <a:pt x="126291" y="185327"/>
                      <a:pt x="126291" y="187154"/>
                      <a:pt x="126195" y="188885"/>
                    </a:cubicBezTo>
                    <a:cubicBezTo>
                      <a:pt x="126002" y="189847"/>
                      <a:pt x="125906" y="190905"/>
                      <a:pt x="125617" y="191867"/>
                    </a:cubicBezTo>
                    <a:cubicBezTo>
                      <a:pt x="125521" y="193502"/>
                      <a:pt x="125136" y="195233"/>
                      <a:pt x="124847" y="196868"/>
                    </a:cubicBezTo>
                    <a:cubicBezTo>
                      <a:pt x="124654" y="197830"/>
                      <a:pt x="124365" y="198695"/>
                      <a:pt x="124173" y="199753"/>
                    </a:cubicBezTo>
                    <a:cubicBezTo>
                      <a:pt x="123595" y="201484"/>
                      <a:pt x="123113" y="203119"/>
                      <a:pt x="122535" y="204947"/>
                    </a:cubicBezTo>
                    <a:cubicBezTo>
                      <a:pt x="122150" y="205716"/>
                      <a:pt x="121861" y="206581"/>
                      <a:pt x="121476" y="207351"/>
                    </a:cubicBezTo>
                    <a:cubicBezTo>
                      <a:pt x="120513" y="209851"/>
                      <a:pt x="119357" y="212256"/>
                      <a:pt x="117913" y="214660"/>
                    </a:cubicBezTo>
                    <a:cubicBezTo>
                      <a:pt x="116565" y="216872"/>
                      <a:pt x="115024" y="219180"/>
                      <a:pt x="113387" y="221296"/>
                    </a:cubicBezTo>
                    <a:cubicBezTo>
                      <a:pt x="112905" y="222065"/>
                      <a:pt x="112135" y="222835"/>
                      <a:pt x="111653" y="223604"/>
                    </a:cubicBezTo>
                    <a:lnTo>
                      <a:pt x="108187" y="227355"/>
                    </a:lnTo>
                    <a:cubicBezTo>
                      <a:pt x="107416" y="228124"/>
                      <a:pt x="106549" y="228894"/>
                      <a:pt x="105683" y="229663"/>
                    </a:cubicBezTo>
                    <a:cubicBezTo>
                      <a:pt x="104623" y="230625"/>
                      <a:pt x="103564" y="231683"/>
                      <a:pt x="102408" y="232548"/>
                    </a:cubicBezTo>
                    <a:cubicBezTo>
                      <a:pt x="101349" y="233318"/>
                      <a:pt x="100386" y="233991"/>
                      <a:pt x="99519" y="234664"/>
                    </a:cubicBezTo>
                    <a:cubicBezTo>
                      <a:pt x="98364" y="235434"/>
                      <a:pt x="97112" y="236395"/>
                      <a:pt x="95956" y="237069"/>
                    </a:cubicBezTo>
                    <a:cubicBezTo>
                      <a:pt x="94801" y="237742"/>
                      <a:pt x="93838" y="238223"/>
                      <a:pt x="92778" y="238704"/>
                    </a:cubicBezTo>
                    <a:cubicBezTo>
                      <a:pt x="91526" y="239473"/>
                      <a:pt x="90274" y="240146"/>
                      <a:pt x="89023" y="240627"/>
                    </a:cubicBezTo>
                    <a:cubicBezTo>
                      <a:pt x="87867" y="241108"/>
                      <a:pt x="86711" y="241685"/>
                      <a:pt x="85556" y="242070"/>
                    </a:cubicBezTo>
                    <a:cubicBezTo>
                      <a:pt x="84304" y="242550"/>
                      <a:pt x="82956" y="243031"/>
                      <a:pt x="81607" y="243416"/>
                    </a:cubicBezTo>
                    <a:cubicBezTo>
                      <a:pt x="80548" y="243801"/>
                      <a:pt x="79296" y="244089"/>
                      <a:pt x="78140" y="244282"/>
                    </a:cubicBezTo>
                    <a:cubicBezTo>
                      <a:pt x="76696" y="244666"/>
                      <a:pt x="75348" y="244955"/>
                      <a:pt x="73903" y="245147"/>
                    </a:cubicBezTo>
                    <a:cubicBezTo>
                      <a:pt x="72844" y="245436"/>
                      <a:pt x="71496" y="245532"/>
                      <a:pt x="70436" y="245724"/>
                    </a:cubicBezTo>
                    <a:cubicBezTo>
                      <a:pt x="69859" y="245820"/>
                      <a:pt x="69377" y="245917"/>
                      <a:pt x="68992" y="245917"/>
                    </a:cubicBezTo>
                    <a:lnTo>
                      <a:pt x="68992" y="360075"/>
                    </a:lnTo>
                    <a:cubicBezTo>
                      <a:pt x="69859" y="360075"/>
                      <a:pt x="70822" y="360363"/>
                      <a:pt x="71785" y="360459"/>
                    </a:cubicBezTo>
                    <a:cubicBezTo>
                      <a:pt x="72651" y="360556"/>
                      <a:pt x="73711" y="360748"/>
                      <a:pt x="74674" y="360844"/>
                    </a:cubicBezTo>
                    <a:cubicBezTo>
                      <a:pt x="76696" y="361229"/>
                      <a:pt x="78718" y="361710"/>
                      <a:pt x="80644" y="362383"/>
                    </a:cubicBezTo>
                    <a:cubicBezTo>
                      <a:pt x="81415" y="362479"/>
                      <a:pt x="82185" y="362768"/>
                      <a:pt x="82956" y="362960"/>
                    </a:cubicBezTo>
                    <a:cubicBezTo>
                      <a:pt x="85556" y="363826"/>
                      <a:pt x="88252" y="364883"/>
                      <a:pt x="90756" y="366038"/>
                    </a:cubicBezTo>
                    <a:cubicBezTo>
                      <a:pt x="91237" y="366230"/>
                      <a:pt x="91623" y="366518"/>
                      <a:pt x="92104" y="366807"/>
                    </a:cubicBezTo>
                    <a:cubicBezTo>
                      <a:pt x="94126" y="367865"/>
                      <a:pt x="96149" y="369019"/>
                      <a:pt x="98075" y="370269"/>
                    </a:cubicBezTo>
                    <a:cubicBezTo>
                      <a:pt x="98845" y="370846"/>
                      <a:pt x="99712" y="371423"/>
                      <a:pt x="100482" y="372000"/>
                    </a:cubicBezTo>
                    <a:cubicBezTo>
                      <a:pt x="102023" y="373058"/>
                      <a:pt x="103371" y="374212"/>
                      <a:pt x="104912" y="375463"/>
                    </a:cubicBezTo>
                    <a:cubicBezTo>
                      <a:pt x="105683" y="376232"/>
                      <a:pt x="106453" y="376905"/>
                      <a:pt x="107224" y="377675"/>
                    </a:cubicBezTo>
                    <a:cubicBezTo>
                      <a:pt x="108572" y="379021"/>
                      <a:pt x="109824" y="380367"/>
                      <a:pt x="111268" y="381906"/>
                    </a:cubicBezTo>
                    <a:cubicBezTo>
                      <a:pt x="111750" y="382676"/>
                      <a:pt x="112424" y="383349"/>
                      <a:pt x="113002" y="384118"/>
                    </a:cubicBezTo>
                    <a:cubicBezTo>
                      <a:pt x="114735" y="386330"/>
                      <a:pt x="116468" y="388735"/>
                      <a:pt x="117913" y="391427"/>
                    </a:cubicBezTo>
                    <a:cubicBezTo>
                      <a:pt x="119357" y="393832"/>
                      <a:pt x="120513" y="396236"/>
                      <a:pt x="121476" y="398737"/>
                    </a:cubicBezTo>
                    <a:cubicBezTo>
                      <a:pt x="121861" y="399506"/>
                      <a:pt x="122150" y="400275"/>
                      <a:pt x="122343" y="400949"/>
                    </a:cubicBezTo>
                    <a:cubicBezTo>
                      <a:pt x="123017" y="402776"/>
                      <a:pt x="123595" y="404507"/>
                      <a:pt x="124173" y="406334"/>
                    </a:cubicBezTo>
                    <a:lnTo>
                      <a:pt x="124750" y="408931"/>
                    </a:lnTo>
                    <a:cubicBezTo>
                      <a:pt x="125136" y="410758"/>
                      <a:pt x="125521" y="412489"/>
                      <a:pt x="125810" y="414413"/>
                    </a:cubicBezTo>
                    <a:cubicBezTo>
                      <a:pt x="125906" y="415182"/>
                      <a:pt x="126002" y="416048"/>
                      <a:pt x="126002" y="416817"/>
                    </a:cubicBezTo>
                    <a:cubicBezTo>
                      <a:pt x="126291" y="419222"/>
                      <a:pt x="126387" y="421434"/>
                      <a:pt x="126387" y="423838"/>
                    </a:cubicBezTo>
                    <a:lnTo>
                      <a:pt x="126387" y="424607"/>
                    </a:lnTo>
                    <a:cubicBezTo>
                      <a:pt x="126291" y="427300"/>
                      <a:pt x="126002" y="429801"/>
                      <a:pt x="125617" y="432397"/>
                    </a:cubicBezTo>
                    <a:cubicBezTo>
                      <a:pt x="125521" y="433167"/>
                      <a:pt x="125424" y="433936"/>
                      <a:pt x="125136" y="434706"/>
                    </a:cubicBezTo>
                    <a:cubicBezTo>
                      <a:pt x="124847" y="436437"/>
                      <a:pt x="124365" y="438360"/>
                      <a:pt x="123884" y="440091"/>
                    </a:cubicBezTo>
                    <a:cubicBezTo>
                      <a:pt x="123595" y="441053"/>
                      <a:pt x="123402" y="441919"/>
                      <a:pt x="123113" y="442784"/>
                    </a:cubicBezTo>
                    <a:cubicBezTo>
                      <a:pt x="122824" y="443457"/>
                      <a:pt x="122632" y="444131"/>
                      <a:pt x="122343" y="444900"/>
                    </a:cubicBezTo>
                    <a:lnTo>
                      <a:pt x="230104" y="501835"/>
                    </a:lnTo>
                    <a:cubicBezTo>
                      <a:pt x="230682" y="501162"/>
                      <a:pt x="231452" y="500488"/>
                      <a:pt x="232127" y="499719"/>
                    </a:cubicBezTo>
                    <a:cubicBezTo>
                      <a:pt x="232608" y="499238"/>
                      <a:pt x="233090" y="498565"/>
                      <a:pt x="233764" y="498084"/>
                    </a:cubicBezTo>
                    <a:cubicBezTo>
                      <a:pt x="235112" y="496545"/>
                      <a:pt x="236749" y="495199"/>
                      <a:pt x="238386" y="493949"/>
                    </a:cubicBezTo>
                    <a:cubicBezTo>
                      <a:pt x="238771" y="493564"/>
                      <a:pt x="239060" y="493275"/>
                      <a:pt x="239542" y="492891"/>
                    </a:cubicBezTo>
                    <a:cubicBezTo>
                      <a:pt x="241564" y="491352"/>
                      <a:pt x="243683" y="489909"/>
                      <a:pt x="245898" y="488659"/>
                    </a:cubicBezTo>
                    <a:cubicBezTo>
                      <a:pt x="246379" y="488371"/>
                      <a:pt x="246764" y="488082"/>
                      <a:pt x="247150" y="487890"/>
                    </a:cubicBezTo>
                    <a:cubicBezTo>
                      <a:pt x="249076" y="486832"/>
                      <a:pt x="250809" y="485966"/>
                      <a:pt x="252735" y="485101"/>
                    </a:cubicBezTo>
                    <a:cubicBezTo>
                      <a:pt x="253505" y="484812"/>
                      <a:pt x="254372" y="484427"/>
                      <a:pt x="255143" y="484235"/>
                    </a:cubicBezTo>
                    <a:cubicBezTo>
                      <a:pt x="256780" y="483562"/>
                      <a:pt x="258417" y="482985"/>
                      <a:pt x="260054" y="482408"/>
                    </a:cubicBezTo>
                    <a:cubicBezTo>
                      <a:pt x="260921" y="482215"/>
                      <a:pt x="261787" y="481927"/>
                      <a:pt x="262654" y="481831"/>
                    </a:cubicBezTo>
                    <a:cubicBezTo>
                      <a:pt x="264291" y="481254"/>
                      <a:pt x="266121" y="480965"/>
                      <a:pt x="267854" y="480677"/>
                    </a:cubicBezTo>
                    <a:cubicBezTo>
                      <a:pt x="268625" y="480580"/>
                      <a:pt x="269492" y="480388"/>
                      <a:pt x="270262" y="480292"/>
                    </a:cubicBezTo>
                    <a:cubicBezTo>
                      <a:pt x="272958" y="479907"/>
                      <a:pt x="275462" y="479811"/>
                      <a:pt x="278159" y="479811"/>
                    </a:cubicBezTo>
                    <a:cubicBezTo>
                      <a:pt x="280759" y="479811"/>
                      <a:pt x="283263" y="479907"/>
                      <a:pt x="285959" y="480292"/>
                    </a:cubicBezTo>
                    <a:cubicBezTo>
                      <a:pt x="286729" y="480388"/>
                      <a:pt x="287596" y="480580"/>
                      <a:pt x="288367" y="480677"/>
                    </a:cubicBezTo>
                    <a:cubicBezTo>
                      <a:pt x="290100" y="480965"/>
                      <a:pt x="291930" y="481254"/>
                      <a:pt x="293567" y="481831"/>
                    </a:cubicBezTo>
                    <a:cubicBezTo>
                      <a:pt x="294434" y="481927"/>
                      <a:pt x="295300" y="482215"/>
                      <a:pt x="296167" y="482600"/>
                    </a:cubicBezTo>
                    <a:cubicBezTo>
                      <a:pt x="297804" y="482985"/>
                      <a:pt x="299441" y="483562"/>
                      <a:pt x="301175" y="484235"/>
                    </a:cubicBezTo>
                    <a:cubicBezTo>
                      <a:pt x="301849" y="484427"/>
                      <a:pt x="302812" y="484812"/>
                      <a:pt x="303486" y="485197"/>
                    </a:cubicBezTo>
                    <a:cubicBezTo>
                      <a:pt x="305412" y="485966"/>
                      <a:pt x="307242" y="486832"/>
                      <a:pt x="308975" y="487890"/>
                    </a:cubicBezTo>
                    <a:cubicBezTo>
                      <a:pt x="309360" y="488082"/>
                      <a:pt x="309842" y="488371"/>
                      <a:pt x="310323" y="488659"/>
                    </a:cubicBezTo>
                    <a:cubicBezTo>
                      <a:pt x="312538" y="489909"/>
                      <a:pt x="314657" y="491352"/>
                      <a:pt x="316679" y="492891"/>
                    </a:cubicBezTo>
                    <a:cubicBezTo>
                      <a:pt x="317161" y="493275"/>
                      <a:pt x="317546" y="493660"/>
                      <a:pt x="317931" y="494045"/>
                    </a:cubicBezTo>
                    <a:cubicBezTo>
                      <a:pt x="319568" y="495295"/>
                      <a:pt x="321109" y="496545"/>
                      <a:pt x="322457" y="498084"/>
                    </a:cubicBezTo>
                    <a:lnTo>
                      <a:pt x="324094" y="499719"/>
                    </a:lnTo>
                    <a:cubicBezTo>
                      <a:pt x="324769" y="500488"/>
                      <a:pt x="325539" y="501162"/>
                      <a:pt x="326117" y="501835"/>
                    </a:cubicBezTo>
                    <a:lnTo>
                      <a:pt x="433878" y="444900"/>
                    </a:lnTo>
                    <a:cubicBezTo>
                      <a:pt x="433589" y="444419"/>
                      <a:pt x="433493" y="443938"/>
                      <a:pt x="433397" y="443457"/>
                    </a:cubicBezTo>
                    <a:cubicBezTo>
                      <a:pt x="433011" y="442111"/>
                      <a:pt x="432530" y="440765"/>
                      <a:pt x="432145" y="439514"/>
                    </a:cubicBezTo>
                    <a:cubicBezTo>
                      <a:pt x="431856" y="438360"/>
                      <a:pt x="431567" y="437110"/>
                      <a:pt x="431182" y="435860"/>
                    </a:cubicBezTo>
                    <a:cubicBezTo>
                      <a:pt x="430989" y="434609"/>
                      <a:pt x="430700" y="433359"/>
                      <a:pt x="430508" y="432013"/>
                    </a:cubicBezTo>
                    <a:cubicBezTo>
                      <a:pt x="430219" y="430282"/>
                      <a:pt x="430122" y="428358"/>
                      <a:pt x="429930" y="426627"/>
                    </a:cubicBezTo>
                    <a:cubicBezTo>
                      <a:pt x="429930" y="425281"/>
                      <a:pt x="429834" y="423838"/>
                      <a:pt x="429930" y="422492"/>
                    </a:cubicBezTo>
                    <a:cubicBezTo>
                      <a:pt x="429930" y="420568"/>
                      <a:pt x="429930" y="418837"/>
                      <a:pt x="430122" y="417010"/>
                    </a:cubicBezTo>
                    <a:cubicBezTo>
                      <a:pt x="430219" y="416048"/>
                      <a:pt x="430315" y="414990"/>
                      <a:pt x="430604" y="414028"/>
                    </a:cubicBezTo>
                    <a:cubicBezTo>
                      <a:pt x="430700" y="412393"/>
                      <a:pt x="431085" y="410758"/>
                      <a:pt x="431374" y="409220"/>
                    </a:cubicBezTo>
                    <a:cubicBezTo>
                      <a:pt x="431567" y="408162"/>
                      <a:pt x="431856" y="407200"/>
                      <a:pt x="432145" y="406142"/>
                    </a:cubicBezTo>
                    <a:cubicBezTo>
                      <a:pt x="432626" y="404507"/>
                      <a:pt x="433108" y="402776"/>
                      <a:pt x="433782" y="401141"/>
                    </a:cubicBezTo>
                    <a:cubicBezTo>
                      <a:pt x="434167" y="400372"/>
                      <a:pt x="434360" y="399506"/>
                      <a:pt x="434745" y="398737"/>
                    </a:cubicBezTo>
                    <a:cubicBezTo>
                      <a:pt x="435804" y="396236"/>
                      <a:pt x="436960" y="393832"/>
                      <a:pt x="438308" y="391427"/>
                    </a:cubicBezTo>
                    <a:cubicBezTo>
                      <a:pt x="439656" y="388831"/>
                      <a:pt x="441486" y="386330"/>
                      <a:pt x="443219" y="384118"/>
                    </a:cubicBezTo>
                    <a:cubicBezTo>
                      <a:pt x="443701" y="383445"/>
                      <a:pt x="444375" y="382772"/>
                      <a:pt x="444857" y="382195"/>
                    </a:cubicBezTo>
                    <a:cubicBezTo>
                      <a:pt x="446301" y="380560"/>
                      <a:pt x="447649" y="379021"/>
                      <a:pt x="449190" y="377482"/>
                    </a:cubicBezTo>
                    <a:cubicBezTo>
                      <a:pt x="449768" y="376905"/>
                      <a:pt x="450442" y="376424"/>
                      <a:pt x="451212" y="375751"/>
                    </a:cubicBezTo>
                    <a:cubicBezTo>
                      <a:pt x="452850" y="374405"/>
                      <a:pt x="454487" y="372962"/>
                      <a:pt x="456220" y="371712"/>
                    </a:cubicBezTo>
                    <a:cubicBezTo>
                      <a:pt x="456798" y="371327"/>
                      <a:pt x="457376" y="370846"/>
                      <a:pt x="457857" y="370462"/>
                    </a:cubicBezTo>
                    <a:cubicBezTo>
                      <a:pt x="462865" y="367192"/>
                      <a:pt x="467969" y="364595"/>
                      <a:pt x="473554" y="362864"/>
                    </a:cubicBezTo>
                    <a:cubicBezTo>
                      <a:pt x="474036" y="362768"/>
                      <a:pt x="474614" y="362575"/>
                      <a:pt x="475095" y="362479"/>
                    </a:cubicBezTo>
                    <a:cubicBezTo>
                      <a:pt x="477406" y="361902"/>
                      <a:pt x="479525" y="361229"/>
                      <a:pt x="481836" y="360844"/>
                    </a:cubicBezTo>
                    <a:lnTo>
                      <a:pt x="484436" y="360459"/>
                    </a:lnTo>
                    <a:cubicBezTo>
                      <a:pt x="485303" y="360363"/>
                      <a:pt x="486362" y="360075"/>
                      <a:pt x="487229" y="360075"/>
                    </a:cubicBezTo>
                    <a:lnTo>
                      <a:pt x="487229" y="245917"/>
                    </a:lnTo>
                    <a:cubicBezTo>
                      <a:pt x="486844" y="245917"/>
                      <a:pt x="486362" y="245820"/>
                      <a:pt x="485881" y="245724"/>
                    </a:cubicBezTo>
                    <a:cubicBezTo>
                      <a:pt x="484725" y="245532"/>
                      <a:pt x="483473" y="245436"/>
                      <a:pt x="482318" y="245147"/>
                    </a:cubicBezTo>
                    <a:cubicBezTo>
                      <a:pt x="480873" y="244955"/>
                      <a:pt x="479525" y="244666"/>
                      <a:pt x="478081" y="244282"/>
                    </a:cubicBezTo>
                    <a:cubicBezTo>
                      <a:pt x="477021" y="244089"/>
                      <a:pt x="475769" y="243801"/>
                      <a:pt x="474614" y="243416"/>
                    </a:cubicBezTo>
                    <a:cubicBezTo>
                      <a:pt x="473362" y="243031"/>
                      <a:pt x="471917" y="242550"/>
                      <a:pt x="470665" y="242070"/>
                    </a:cubicBezTo>
                    <a:cubicBezTo>
                      <a:pt x="469510" y="241685"/>
                      <a:pt x="468354" y="241108"/>
                      <a:pt x="467295" y="240627"/>
                    </a:cubicBezTo>
                    <a:cubicBezTo>
                      <a:pt x="465947" y="240146"/>
                      <a:pt x="464695" y="239473"/>
                      <a:pt x="463443" y="238896"/>
                    </a:cubicBezTo>
                    <a:cubicBezTo>
                      <a:pt x="462480" y="238223"/>
                      <a:pt x="461420" y="237742"/>
                      <a:pt x="460265" y="237069"/>
                    </a:cubicBezTo>
                    <a:cubicBezTo>
                      <a:pt x="459205" y="236395"/>
                      <a:pt x="457857" y="235434"/>
                      <a:pt x="456798" y="234664"/>
                    </a:cubicBezTo>
                    <a:cubicBezTo>
                      <a:pt x="455835" y="234087"/>
                      <a:pt x="454872" y="233318"/>
                      <a:pt x="453813" y="232548"/>
                    </a:cubicBezTo>
                    <a:cubicBezTo>
                      <a:pt x="452753" y="231683"/>
                      <a:pt x="451598" y="230625"/>
                      <a:pt x="450538" y="229663"/>
                    </a:cubicBezTo>
                    <a:cubicBezTo>
                      <a:pt x="449672" y="228894"/>
                      <a:pt x="448805" y="228124"/>
                      <a:pt x="448034" y="227355"/>
                    </a:cubicBezTo>
                    <a:cubicBezTo>
                      <a:pt x="446879" y="226105"/>
                      <a:pt x="445723" y="224854"/>
                      <a:pt x="444664" y="223604"/>
                    </a:cubicBezTo>
                    <a:cubicBezTo>
                      <a:pt x="444086" y="222835"/>
                      <a:pt x="443316" y="222065"/>
                      <a:pt x="442834" y="221296"/>
                    </a:cubicBezTo>
                    <a:cubicBezTo>
                      <a:pt x="441197" y="219180"/>
                      <a:pt x="439656" y="217064"/>
                      <a:pt x="438308" y="214660"/>
                    </a:cubicBezTo>
                    <a:cubicBezTo>
                      <a:pt x="436960" y="212256"/>
                      <a:pt x="435804" y="209851"/>
                      <a:pt x="434745" y="207351"/>
                    </a:cubicBezTo>
                    <a:cubicBezTo>
                      <a:pt x="434360" y="206581"/>
                      <a:pt x="434167" y="205812"/>
                      <a:pt x="433878" y="205043"/>
                    </a:cubicBezTo>
                    <a:cubicBezTo>
                      <a:pt x="433204" y="203312"/>
                      <a:pt x="432626" y="201484"/>
                      <a:pt x="432145" y="199753"/>
                    </a:cubicBezTo>
                    <a:cubicBezTo>
                      <a:pt x="431856" y="198695"/>
                      <a:pt x="431567" y="197830"/>
                      <a:pt x="431471" y="196964"/>
                    </a:cubicBezTo>
                    <a:cubicBezTo>
                      <a:pt x="431085" y="195233"/>
                      <a:pt x="430700" y="193406"/>
                      <a:pt x="430508" y="191675"/>
                    </a:cubicBezTo>
                    <a:cubicBezTo>
                      <a:pt x="430315" y="190809"/>
                      <a:pt x="430219" y="190040"/>
                      <a:pt x="430219" y="189174"/>
                    </a:cubicBezTo>
                    <a:cubicBezTo>
                      <a:pt x="429930" y="186770"/>
                      <a:pt x="429834" y="184462"/>
                      <a:pt x="429834" y="182057"/>
                    </a:cubicBezTo>
                    <a:lnTo>
                      <a:pt x="429834" y="181288"/>
                    </a:lnTo>
                    <a:cubicBezTo>
                      <a:pt x="429930" y="178691"/>
                      <a:pt x="430219" y="176094"/>
                      <a:pt x="430604" y="173594"/>
                    </a:cubicBezTo>
                    <a:cubicBezTo>
                      <a:pt x="430700" y="172728"/>
                      <a:pt x="430989" y="171958"/>
                      <a:pt x="431085" y="171093"/>
                    </a:cubicBezTo>
                    <a:cubicBezTo>
                      <a:pt x="431471" y="169266"/>
                      <a:pt x="431856" y="167534"/>
                      <a:pt x="432337" y="165899"/>
                    </a:cubicBezTo>
                    <a:cubicBezTo>
                      <a:pt x="432626" y="164842"/>
                      <a:pt x="432915" y="163976"/>
                      <a:pt x="433204" y="163110"/>
                    </a:cubicBezTo>
                    <a:cubicBezTo>
                      <a:pt x="433493" y="162341"/>
                      <a:pt x="433589" y="161764"/>
                      <a:pt x="433878" y="160995"/>
                    </a:cubicBezTo>
                    <a:lnTo>
                      <a:pt x="326213" y="104060"/>
                    </a:lnTo>
                    <a:cubicBezTo>
                      <a:pt x="325539" y="104829"/>
                      <a:pt x="324865" y="105406"/>
                      <a:pt x="324287" y="106079"/>
                    </a:cubicBezTo>
                    <a:cubicBezTo>
                      <a:pt x="323613" y="106656"/>
                      <a:pt x="323131" y="107426"/>
                      <a:pt x="322457" y="108099"/>
                    </a:cubicBezTo>
                    <a:cubicBezTo>
                      <a:pt x="321109" y="109349"/>
                      <a:pt x="319568" y="110600"/>
                      <a:pt x="318220" y="111850"/>
                    </a:cubicBezTo>
                    <a:cubicBezTo>
                      <a:pt x="317739" y="112235"/>
                      <a:pt x="317161" y="112715"/>
                      <a:pt x="316679" y="113100"/>
                    </a:cubicBezTo>
                    <a:cubicBezTo>
                      <a:pt x="314657" y="114639"/>
                      <a:pt x="312538" y="115985"/>
                      <a:pt x="310323" y="117428"/>
                    </a:cubicBezTo>
                    <a:lnTo>
                      <a:pt x="308879" y="118197"/>
                    </a:lnTo>
                    <a:cubicBezTo>
                      <a:pt x="307049" y="119159"/>
                      <a:pt x="305316" y="120025"/>
                      <a:pt x="303582" y="120794"/>
                    </a:cubicBezTo>
                    <a:cubicBezTo>
                      <a:pt x="302812" y="121179"/>
                      <a:pt x="301849" y="121467"/>
                      <a:pt x="300982" y="121852"/>
                    </a:cubicBezTo>
                    <a:cubicBezTo>
                      <a:pt x="299441" y="122429"/>
                      <a:pt x="297804" y="123006"/>
                      <a:pt x="296360" y="123487"/>
                    </a:cubicBezTo>
                    <a:cubicBezTo>
                      <a:pt x="295397" y="123679"/>
                      <a:pt x="294434" y="123968"/>
                      <a:pt x="293567" y="124256"/>
                    </a:cubicBezTo>
                    <a:cubicBezTo>
                      <a:pt x="291930" y="124641"/>
                      <a:pt x="290100" y="125026"/>
                      <a:pt x="288367" y="125218"/>
                    </a:cubicBezTo>
                    <a:lnTo>
                      <a:pt x="285959" y="125795"/>
                    </a:lnTo>
                    <a:cubicBezTo>
                      <a:pt x="283263" y="125987"/>
                      <a:pt x="280759" y="126276"/>
                      <a:pt x="278159" y="126276"/>
                    </a:cubicBezTo>
                    <a:cubicBezTo>
                      <a:pt x="275462" y="126276"/>
                      <a:pt x="272958" y="125987"/>
                      <a:pt x="270262" y="125795"/>
                    </a:cubicBezTo>
                    <a:lnTo>
                      <a:pt x="267854" y="125218"/>
                    </a:lnTo>
                    <a:cubicBezTo>
                      <a:pt x="266121" y="125026"/>
                      <a:pt x="264388" y="124641"/>
                      <a:pt x="262654" y="124256"/>
                    </a:cubicBezTo>
                    <a:cubicBezTo>
                      <a:pt x="261787" y="123968"/>
                      <a:pt x="260824" y="123679"/>
                      <a:pt x="259958" y="123487"/>
                    </a:cubicBezTo>
                    <a:cubicBezTo>
                      <a:pt x="258417" y="123006"/>
                      <a:pt x="256780" y="122429"/>
                      <a:pt x="255239" y="121852"/>
                    </a:cubicBezTo>
                    <a:cubicBezTo>
                      <a:pt x="254372" y="121467"/>
                      <a:pt x="253505" y="121179"/>
                      <a:pt x="252735" y="120794"/>
                    </a:cubicBezTo>
                    <a:cubicBezTo>
                      <a:pt x="250905" y="120025"/>
                      <a:pt x="249172" y="119159"/>
                      <a:pt x="247535" y="118197"/>
                    </a:cubicBezTo>
                    <a:cubicBezTo>
                      <a:pt x="246861" y="117909"/>
                      <a:pt x="246379" y="117620"/>
                      <a:pt x="245898" y="117332"/>
                    </a:cubicBezTo>
                    <a:cubicBezTo>
                      <a:pt x="243779" y="115985"/>
                      <a:pt x="241564" y="114639"/>
                      <a:pt x="239542" y="113100"/>
                    </a:cubicBezTo>
                    <a:cubicBezTo>
                      <a:pt x="239060" y="112619"/>
                      <a:pt x="238579" y="112235"/>
                      <a:pt x="238001" y="111754"/>
                    </a:cubicBezTo>
                    <a:cubicBezTo>
                      <a:pt x="236556" y="110600"/>
                      <a:pt x="235112" y="109349"/>
                      <a:pt x="233860" y="108099"/>
                    </a:cubicBezTo>
                    <a:cubicBezTo>
                      <a:pt x="233282" y="107426"/>
                      <a:pt x="232608" y="106656"/>
                      <a:pt x="231934" y="106079"/>
                    </a:cubicBezTo>
                    <a:cubicBezTo>
                      <a:pt x="231356" y="105406"/>
                      <a:pt x="230586" y="104829"/>
                      <a:pt x="230104" y="104060"/>
                    </a:cubicBezTo>
                    <a:close/>
                    <a:moveTo>
                      <a:pt x="278159" y="0"/>
                    </a:moveTo>
                    <a:cubicBezTo>
                      <a:pt x="313020" y="0"/>
                      <a:pt x="341332" y="28275"/>
                      <a:pt x="341332" y="63090"/>
                    </a:cubicBezTo>
                    <a:cubicBezTo>
                      <a:pt x="341332" y="69533"/>
                      <a:pt x="340177" y="75881"/>
                      <a:pt x="338347" y="81940"/>
                    </a:cubicBezTo>
                    <a:lnTo>
                      <a:pt x="447264" y="139548"/>
                    </a:lnTo>
                    <a:cubicBezTo>
                      <a:pt x="451309" y="135316"/>
                      <a:pt x="456028" y="131565"/>
                      <a:pt x="461324" y="128392"/>
                    </a:cubicBezTo>
                    <a:cubicBezTo>
                      <a:pt x="491563" y="111080"/>
                      <a:pt x="530180" y="121371"/>
                      <a:pt x="547803" y="151473"/>
                    </a:cubicBezTo>
                    <a:cubicBezTo>
                      <a:pt x="556277" y="166188"/>
                      <a:pt x="558396" y="183211"/>
                      <a:pt x="553966" y="199465"/>
                    </a:cubicBezTo>
                    <a:cubicBezTo>
                      <a:pt x="549729" y="215814"/>
                      <a:pt x="539232" y="229278"/>
                      <a:pt x="524498" y="237646"/>
                    </a:cubicBezTo>
                    <a:cubicBezTo>
                      <a:pt x="520742" y="239858"/>
                      <a:pt x="516697" y="241493"/>
                      <a:pt x="512556" y="242935"/>
                    </a:cubicBezTo>
                    <a:lnTo>
                      <a:pt x="512556" y="362960"/>
                    </a:lnTo>
                    <a:cubicBezTo>
                      <a:pt x="516794" y="364403"/>
                      <a:pt x="520838" y="366134"/>
                      <a:pt x="524690" y="368442"/>
                    </a:cubicBezTo>
                    <a:cubicBezTo>
                      <a:pt x="539232" y="376617"/>
                      <a:pt x="549729" y="390273"/>
                      <a:pt x="553966" y="406527"/>
                    </a:cubicBezTo>
                    <a:cubicBezTo>
                      <a:pt x="555507" y="412105"/>
                      <a:pt x="556277" y="417683"/>
                      <a:pt x="556277" y="423261"/>
                    </a:cubicBezTo>
                    <a:cubicBezTo>
                      <a:pt x="556277" y="434032"/>
                      <a:pt x="553388" y="444804"/>
                      <a:pt x="547803" y="454517"/>
                    </a:cubicBezTo>
                    <a:cubicBezTo>
                      <a:pt x="536054" y="474714"/>
                      <a:pt x="514675" y="485966"/>
                      <a:pt x="492911" y="485966"/>
                    </a:cubicBezTo>
                    <a:cubicBezTo>
                      <a:pt x="482125" y="485966"/>
                      <a:pt x="471339" y="483273"/>
                      <a:pt x="461324" y="477503"/>
                    </a:cubicBezTo>
                    <a:cubicBezTo>
                      <a:pt x="456028" y="474522"/>
                      <a:pt x="451405" y="470675"/>
                      <a:pt x="447360" y="466443"/>
                    </a:cubicBezTo>
                    <a:lnTo>
                      <a:pt x="338251" y="524051"/>
                    </a:lnTo>
                    <a:cubicBezTo>
                      <a:pt x="340177" y="530110"/>
                      <a:pt x="341332" y="536457"/>
                      <a:pt x="341332" y="542901"/>
                    </a:cubicBezTo>
                    <a:cubicBezTo>
                      <a:pt x="341332" y="577620"/>
                      <a:pt x="313020" y="606087"/>
                      <a:pt x="278159" y="606087"/>
                    </a:cubicBezTo>
                    <a:cubicBezTo>
                      <a:pt x="243201" y="606087"/>
                      <a:pt x="214889" y="577620"/>
                      <a:pt x="214889" y="542901"/>
                    </a:cubicBezTo>
                    <a:cubicBezTo>
                      <a:pt x="214889" y="536457"/>
                      <a:pt x="216044" y="530110"/>
                      <a:pt x="217970" y="524051"/>
                    </a:cubicBezTo>
                    <a:lnTo>
                      <a:pt x="108861" y="466443"/>
                    </a:lnTo>
                    <a:cubicBezTo>
                      <a:pt x="104816" y="470675"/>
                      <a:pt x="100193" y="474522"/>
                      <a:pt x="94897" y="477503"/>
                    </a:cubicBezTo>
                    <a:cubicBezTo>
                      <a:pt x="84978" y="483273"/>
                      <a:pt x="74096" y="485966"/>
                      <a:pt x="63310" y="485966"/>
                    </a:cubicBezTo>
                    <a:cubicBezTo>
                      <a:pt x="41546" y="485966"/>
                      <a:pt x="20167" y="474714"/>
                      <a:pt x="8418" y="454517"/>
                    </a:cubicBezTo>
                    <a:cubicBezTo>
                      <a:pt x="-56" y="439899"/>
                      <a:pt x="-2175" y="422876"/>
                      <a:pt x="2255" y="406527"/>
                    </a:cubicBezTo>
                    <a:cubicBezTo>
                      <a:pt x="6588" y="390273"/>
                      <a:pt x="17085" y="376617"/>
                      <a:pt x="31723" y="368250"/>
                    </a:cubicBezTo>
                    <a:cubicBezTo>
                      <a:pt x="35479" y="366134"/>
                      <a:pt x="39524" y="364403"/>
                      <a:pt x="43761" y="362960"/>
                    </a:cubicBezTo>
                    <a:lnTo>
                      <a:pt x="43761" y="242935"/>
                    </a:lnTo>
                    <a:cubicBezTo>
                      <a:pt x="39427" y="241493"/>
                      <a:pt x="35383" y="239858"/>
                      <a:pt x="31627" y="237646"/>
                    </a:cubicBezTo>
                    <a:cubicBezTo>
                      <a:pt x="17085" y="229278"/>
                      <a:pt x="6588" y="215814"/>
                      <a:pt x="2255" y="199465"/>
                    </a:cubicBezTo>
                    <a:cubicBezTo>
                      <a:pt x="-2175" y="183211"/>
                      <a:pt x="-56" y="166188"/>
                      <a:pt x="8418" y="151473"/>
                    </a:cubicBezTo>
                    <a:cubicBezTo>
                      <a:pt x="26041" y="121371"/>
                      <a:pt x="64755" y="111080"/>
                      <a:pt x="94897" y="128392"/>
                    </a:cubicBezTo>
                    <a:cubicBezTo>
                      <a:pt x="100193" y="131565"/>
                      <a:pt x="104816" y="135316"/>
                      <a:pt x="108861" y="139548"/>
                    </a:cubicBezTo>
                    <a:lnTo>
                      <a:pt x="217970" y="81940"/>
                    </a:lnTo>
                    <a:cubicBezTo>
                      <a:pt x="216044" y="75881"/>
                      <a:pt x="214889" y="69533"/>
                      <a:pt x="214889" y="63090"/>
                    </a:cubicBezTo>
                    <a:cubicBezTo>
                      <a:pt x="214889" y="28275"/>
                      <a:pt x="243201" y="0"/>
                      <a:pt x="278159" y="0"/>
                    </a:cubicBezTo>
                    <a:close/>
                  </a:path>
                </a:pathLst>
              </a:cu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35" name="椭圆 134">
                <a:extLst>
                  <a:ext uri="{FF2B5EF4-FFF2-40B4-BE49-F238E27FC236}">
                    <a16:creationId xmlns:a16="http://schemas.microsoft.com/office/drawing/2014/main" id="{9145748B-CD1C-9E7B-BCCE-A854C7A27D88}"/>
                  </a:ext>
                </a:extLst>
              </p:cNvPr>
              <p:cNvSpPr/>
              <p:nvPr/>
            </p:nvSpPr>
            <p:spPr>
              <a:xfrm>
                <a:off x="-853081" y="2880834"/>
                <a:ext cx="764608" cy="240078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136" name="组合 135">
                <a:extLst>
                  <a:ext uri="{FF2B5EF4-FFF2-40B4-BE49-F238E27FC236}">
                    <a16:creationId xmlns:a16="http://schemas.microsoft.com/office/drawing/2014/main" id="{6030FE7B-4BA0-CE26-031D-A71E6397A3C8}"/>
                  </a:ext>
                </a:extLst>
              </p:cNvPr>
              <p:cNvGrpSpPr/>
              <p:nvPr/>
            </p:nvGrpSpPr>
            <p:grpSpPr>
              <a:xfrm>
                <a:off x="-817573" y="3006063"/>
                <a:ext cx="693591" cy="254633"/>
                <a:chOff x="-1250413" y="4133558"/>
                <a:chExt cx="1118956" cy="585932"/>
              </a:xfrm>
              <a:grpFill/>
            </p:grpSpPr>
            <p:cxnSp>
              <p:nvCxnSpPr>
                <p:cNvPr id="137" name="直接连接符 136">
                  <a:extLst>
                    <a:ext uri="{FF2B5EF4-FFF2-40B4-BE49-F238E27FC236}">
                      <a16:creationId xmlns:a16="http://schemas.microsoft.com/office/drawing/2014/main" id="{A7CA606E-F0C9-EE50-15BA-44682DB9EA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207022" y="4445794"/>
                  <a:ext cx="1032361" cy="0"/>
                </a:xfrm>
                <a:prstGeom prst="line">
                  <a:avLst/>
                </a:prstGeom>
                <a:grpFill/>
                <a:ln w="6350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</p:cxnSp>
            <p:sp>
              <p:nvSpPr>
                <p:cNvPr id="138" name="任意多边形: 形状 137">
                  <a:extLst>
                    <a:ext uri="{FF2B5EF4-FFF2-40B4-BE49-F238E27FC236}">
                      <a16:creationId xmlns:a16="http://schemas.microsoft.com/office/drawing/2014/main" id="{295FAB67-DBAE-BF2A-55C7-5A7AEBEA2E70}"/>
                    </a:ext>
                  </a:extLst>
                </p:cNvPr>
                <p:cNvSpPr/>
                <p:nvPr/>
              </p:nvSpPr>
              <p:spPr>
                <a:xfrm>
                  <a:off x="-181477" y="4133558"/>
                  <a:ext cx="50020" cy="580795"/>
                </a:xfrm>
                <a:custGeom>
                  <a:avLst/>
                  <a:gdLst>
                    <a:gd name="connsiteX0" fmla="*/ 6816 w 50020"/>
                    <a:gd name="connsiteY0" fmla="*/ 304878 h 580795"/>
                    <a:gd name="connsiteX1" fmla="*/ 1679 w 50020"/>
                    <a:gd name="connsiteY1" fmla="*/ 48024 h 580795"/>
                    <a:gd name="connsiteX2" fmla="*/ 32502 w 50020"/>
                    <a:gd name="connsiteY2" fmla="*/ 6927 h 580795"/>
                    <a:gd name="connsiteX3" fmla="*/ 42776 w 50020"/>
                    <a:gd name="connsiteY3" fmla="*/ 135354 h 580795"/>
                    <a:gd name="connsiteX4" fmla="*/ 47913 w 50020"/>
                    <a:gd name="connsiteY4" fmla="*/ 351112 h 580795"/>
                    <a:gd name="connsiteX5" fmla="*/ 47913 w 50020"/>
                    <a:gd name="connsiteY5" fmla="*/ 541184 h 580795"/>
                    <a:gd name="connsiteX6" fmla="*/ 22228 w 50020"/>
                    <a:gd name="connsiteY6" fmla="*/ 577143 h 580795"/>
                    <a:gd name="connsiteX7" fmla="*/ 11953 w 50020"/>
                    <a:gd name="connsiteY7" fmla="*/ 484676 h 580795"/>
                    <a:gd name="connsiteX8" fmla="*/ 11953 w 50020"/>
                    <a:gd name="connsiteY8" fmla="*/ 361386 h 580795"/>
                    <a:gd name="connsiteX9" fmla="*/ 11953 w 50020"/>
                    <a:gd name="connsiteY9" fmla="*/ 361386 h 58079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0020" h="580795">
                      <a:moveTo>
                        <a:pt x="6816" y="304878"/>
                      </a:moveTo>
                      <a:cubicBezTo>
                        <a:pt x="2107" y="201280"/>
                        <a:pt x="-2602" y="97682"/>
                        <a:pt x="1679" y="48024"/>
                      </a:cubicBezTo>
                      <a:cubicBezTo>
                        <a:pt x="5960" y="-1634"/>
                        <a:pt x="25653" y="-7628"/>
                        <a:pt x="32502" y="6927"/>
                      </a:cubicBezTo>
                      <a:cubicBezTo>
                        <a:pt x="39352" y="21482"/>
                        <a:pt x="40208" y="77990"/>
                        <a:pt x="42776" y="135354"/>
                      </a:cubicBezTo>
                      <a:cubicBezTo>
                        <a:pt x="45344" y="192718"/>
                        <a:pt x="47057" y="283474"/>
                        <a:pt x="47913" y="351112"/>
                      </a:cubicBezTo>
                      <a:cubicBezTo>
                        <a:pt x="48769" y="418750"/>
                        <a:pt x="52194" y="503512"/>
                        <a:pt x="47913" y="541184"/>
                      </a:cubicBezTo>
                      <a:cubicBezTo>
                        <a:pt x="43632" y="578856"/>
                        <a:pt x="28221" y="586561"/>
                        <a:pt x="22228" y="577143"/>
                      </a:cubicBezTo>
                      <a:cubicBezTo>
                        <a:pt x="16235" y="567725"/>
                        <a:pt x="13665" y="520635"/>
                        <a:pt x="11953" y="484676"/>
                      </a:cubicBezTo>
                      <a:cubicBezTo>
                        <a:pt x="10241" y="448717"/>
                        <a:pt x="11953" y="361386"/>
                        <a:pt x="11953" y="361386"/>
                      </a:cubicBezTo>
                      <a:lnTo>
                        <a:pt x="11953" y="361386"/>
                      </a:lnTo>
                    </a:path>
                  </a:pathLst>
                </a:custGeom>
                <a:grpFill/>
                <a:ln w="3175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39" name="任意多边形: 形状 138">
                  <a:extLst>
                    <a:ext uri="{FF2B5EF4-FFF2-40B4-BE49-F238E27FC236}">
                      <a16:creationId xmlns:a16="http://schemas.microsoft.com/office/drawing/2014/main" id="{85CBAA1D-01A9-796D-E464-FEE64A40B4FD}"/>
                    </a:ext>
                  </a:extLst>
                </p:cNvPr>
                <p:cNvSpPr/>
                <p:nvPr/>
              </p:nvSpPr>
              <p:spPr>
                <a:xfrm flipH="1">
                  <a:off x="-1250413" y="4138695"/>
                  <a:ext cx="50020" cy="580795"/>
                </a:xfrm>
                <a:custGeom>
                  <a:avLst/>
                  <a:gdLst>
                    <a:gd name="connsiteX0" fmla="*/ 6816 w 50020"/>
                    <a:gd name="connsiteY0" fmla="*/ 304878 h 580795"/>
                    <a:gd name="connsiteX1" fmla="*/ 1679 w 50020"/>
                    <a:gd name="connsiteY1" fmla="*/ 48024 h 580795"/>
                    <a:gd name="connsiteX2" fmla="*/ 32502 w 50020"/>
                    <a:gd name="connsiteY2" fmla="*/ 6927 h 580795"/>
                    <a:gd name="connsiteX3" fmla="*/ 42776 w 50020"/>
                    <a:gd name="connsiteY3" fmla="*/ 135354 h 580795"/>
                    <a:gd name="connsiteX4" fmla="*/ 47913 w 50020"/>
                    <a:gd name="connsiteY4" fmla="*/ 351112 h 580795"/>
                    <a:gd name="connsiteX5" fmla="*/ 47913 w 50020"/>
                    <a:gd name="connsiteY5" fmla="*/ 541184 h 580795"/>
                    <a:gd name="connsiteX6" fmla="*/ 22228 w 50020"/>
                    <a:gd name="connsiteY6" fmla="*/ 577143 h 580795"/>
                    <a:gd name="connsiteX7" fmla="*/ 11953 w 50020"/>
                    <a:gd name="connsiteY7" fmla="*/ 484676 h 580795"/>
                    <a:gd name="connsiteX8" fmla="*/ 11953 w 50020"/>
                    <a:gd name="connsiteY8" fmla="*/ 361386 h 580795"/>
                    <a:gd name="connsiteX9" fmla="*/ 11953 w 50020"/>
                    <a:gd name="connsiteY9" fmla="*/ 361386 h 58079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0020" h="580795">
                      <a:moveTo>
                        <a:pt x="6816" y="304878"/>
                      </a:moveTo>
                      <a:cubicBezTo>
                        <a:pt x="2107" y="201280"/>
                        <a:pt x="-2602" y="97682"/>
                        <a:pt x="1679" y="48024"/>
                      </a:cubicBezTo>
                      <a:cubicBezTo>
                        <a:pt x="5960" y="-1634"/>
                        <a:pt x="25653" y="-7628"/>
                        <a:pt x="32502" y="6927"/>
                      </a:cubicBezTo>
                      <a:cubicBezTo>
                        <a:pt x="39352" y="21482"/>
                        <a:pt x="40208" y="77990"/>
                        <a:pt x="42776" y="135354"/>
                      </a:cubicBezTo>
                      <a:cubicBezTo>
                        <a:pt x="45344" y="192718"/>
                        <a:pt x="47057" y="283474"/>
                        <a:pt x="47913" y="351112"/>
                      </a:cubicBezTo>
                      <a:cubicBezTo>
                        <a:pt x="48769" y="418750"/>
                        <a:pt x="52194" y="503512"/>
                        <a:pt x="47913" y="541184"/>
                      </a:cubicBezTo>
                      <a:cubicBezTo>
                        <a:pt x="43632" y="578856"/>
                        <a:pt x="28221" y="586561"/>
                        <a:pt x="22228" y="577143"/>
                      </a:cubicBezTo>
                      <a:cubicBezTo>
                        <a:pt x="16235" y="567725"/>
                        <a:pt x="13665" y="520635"/>
                        <a:pt x="11953" y="484676"/>
                      </a:cubicBezTo>
                      <a:cubicBezTo>
                        <a:pt x="10241" y="448717"/>
                        <a:pt x="11953" y="361386"/>
                        <a:pt x="11953" y="361386"/>
                      </a:cubicBezTo>
                      <a:lnTo>
                        <a:pt x="11953" y="361386"/>
                      </a:lnTo>
                    </a:path>
                  </a:pathLst>
                </a:custGeom>
                <a:grpFill/>
                <a:ln w="3175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cxnSp>
          <p:nvCxnSpPr>
            <p:cNvPr id="140" name="直接箭头连接符 139">
              <a:extLst>
                <a:ext uri="{FF2B5EF4-FFF2-40B4-BE49-F238E27FC236}">
                  <a16:creationId xmlns:a16="http://schemas.microsoft.com/office/drawing/2014/main" id="{8870CB99-E1C2-E0EF-3E04-607ED57532DC}"/>
                </a:ext>
              </a:extLst>
            </p:cNvPr>
            <p:cNvCxnSpPr>
              <a:cxnSpLocks/>
            </p:cNvCxnSpPr>
            <p:nvPr/>
          </p:nvCxnSpPr>
          <p:spPr>
            <a:xfrm>
              <a:off x="1854198" y="1730305"/>
              <a:ext cx="384356" cy="0"/>
            </a:xfrm>
            <a:prstGeom prst="straightConnector1">
              <a:avLst/>
            </a:prstGeom>
            <a:ln w="38100">
              <a:solidFill>
                <a:schemeClr val="tx1">
                  <a:lumMod val="85000"/>
                  <a:lumOff val="1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1" name="组合 140">
              <a:extLst>
                <a:ext uri="{FF2B5EF4-FFF2-40B4-BE49-F238E27FC236}">
                  <a16:creationId xmlns:a16="http://schemas.microsoft.com/office/drawing/2014/main" id="{59F292AE-FA81-C3E1-D107-B17322EA8398}"/>
                </a:ext>
              </a:extLst>
            </p:cNvPr>
            <p:cNvGrpSpPr/>
            <p:nvPr/>
          </p:nvGrpSpPr>
          <p:grpSpPr>
            <a:xfrm>
              <a:off x="2379799" y="1587780"/>
              <a:ext cx="350110" cy="348754"/>
              <a:chOff x="1682825" y="2871964"/>
              <a:chExt cx="2052293" cy="2044342"/>
            </a:xfrm>
          </p:grpSpPr>
          <p:sp>
            <p:nvSpPr>
              <p:cNvPr id="142" name="流程图: 准备 141">
                <a:extLst>
                  <a:ext uri="{FF2B5EF4-FFF2-40B4-BE49-F238E27FC236}">
                    <a16:creationId xmlns:a16="http://schemas.microsoft.com/office/drawing/2014/main" id="{175D9E32-EDF2-E826-4F21-EB1A0D120F54}"/>
                  </a:ext>
                </a:extLst>
              </p:cNvPr>
              <p:cNvSpPr/>
              <p:nvPr/>
            </p:nvSpPr>
            <p:spPr>
              <a:xfrm>
                <a:off x="1682825" y="3644245"/>
                <a:ext cx="598499" cy="508003"/>
              </a:xfrm>
              <a:prstGeom prst="flowChartPreparation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3" name="流程图: 准备 142">
                <a:extLst>
                  <a:ext uri="{FF2B5EF4-FFF2-40B4-BE49-F238E27FC236}">
                    <a16:creationId xmlns:a16="http://schemas.microsoft.com/office/drawing/2014/main" id="{2AE2EA9F-152F-D213-2BD9-742C70BA3FB4}"/>
                  </a:ext>
                </a:extLst>
              </p:cNvPr>
              <p:cNvSpPr/>
              <p:nvPr/>
            </p:nvSpPr>
            <p:spPr>
              <a:xfrm>
                <a:off x="1682825" y="4147111"/>
                <a:ext cx="598499" cy="508003"/>
              </a:xfrm>
              <a:prstGeom prst="flowChartPreparation">
                <a:avLst/>
              </a:prstGeom>
              <a:solidFill>
                <a:srgbClr val="36AB9C"/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4" name="流程图: 准备 143">
                <a:extLst>
                  <a:ext uri="{FF2B5EF4-FFF2-40B4-BE49-F238E27FC236}">
                    <a16:creationId xmlns:a16="http://schemas.microsoft.com/office/drawing/2014/main" id="{860C5D2F-141D-CAF0-0400-C1873024BFD5}"/>
                  </a:ext>
                </a:extLst>
              </p:cNvPr>
              <p:cNvSpPr/>
              <p:nvPr/>
            </p:nvSpPr>
            <p:spPr>
              <a:xfrm>
                <a:off x="2170848" y="3893109"/>
                <a:ext cx="598499" cy="508003"/>
              </a:xfrm>
              <a:prstGeom prst="flowChartPreparation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5" name="流程图: 准备 144">
                <a:extLst>
                  <a:ext uri="{FF2B5EF4-FFF2-40B4-BE49-F238E27FC236}">
                    <a16:creationId xmlns:a16="http://schemas.microsoft.com/office/drawing/2014/main" id="{F1CC9483-F356-8741-165C-4E377C9E6A82}"/>
                  </a:ext>
                </a:extLst>
              </p:cNvPr>
              <p:cNvSpPr/>
              <p:nvPr/>
            </p:nvSpPr>
            <p:spPr>
              <a:xfrm>
                <a:off x="2170848" y="3385105"/>
                <a:ext cx="598499" cy="508003"/>
              </a:xfrm>
              <a:prstGeom prst="flowChartPreparation">
                <a:avLst/>
              </a:prstGeom>
              <a:solidFill>
                <a:srgbClr val="36AB9C"/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6" name="流程图: 准备 145">
                <a:extLst>
                  <a:ext uri="{FF2B5EF4-FFF2-40B4-BE49-F238E27FC236}">
                    <a16:creationId xmlns:a16="http://schemas.microsoft.com/office/drawing/2014/main" id="{592FC54B-19E8-81CD-F873-8EF2221885B8}"/>
                  </a:ext>
                </a:extLst>
              </p:cNvPr>
              <p:cNvSpPr/>
              <p:nvPr/>
            </p:nvSpPr>
            <p:spPr>
              <a:xfrm>
                <a:off x="2165711" y="4408303"/>
                <a:ext cx="598499" cy="508003"/>
              </a:xfrm>
              <a:prstGeom prst="flowChartPreparation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7" name="流程图: 准备 146">
                <a:extLst>
                  <a:ext uri="{FF2B5EF4-FFF2-40B4-BE49-F238E27FC236}">
                    <a16:creationId xmlns:a16="http://schemas.microsoft.com/office/drawing/2014/main" id="{B1582502-B438-0851-3100-9F04E06562AC}"/>
                  </a:ext>
                </a:extLst>
              </p:cNvPr>
              <p:cNvSpPr/>
              <p:nvPr/>
            </p:nvSpPr>
            <p:spPr>
              <a:xfrm>
                <a:off x="2653733" y="3633969"/>
                <a:ext cx="598499" cy="508003"/>
              </a:xfrm>
              <a:prstGeom prst="flowChartPreparation">
                <a:avLst/>
              </a:prstGeom>
              <a:solidFill>
                <a:srgbClr val="36AB9C"/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8" name="流程图: 准备 147">
                <a:extLst>
                  <a:ext uri="{FF2B5EF4-FFF2-40B4-BE49-F238E27FC236}">
                    <a16:creationId xmlns:a16="http://schemas.microsoft.com/office/drawing/2014/main" id="{3CBD1116-1040-1E22-E225-7DFF24B62F3B}"/>
                  </a:ext>
                </a:extLst>
              </p:cNvPr>
              <p:cNvSpPr/>
              <p:nvPr/>
            </p:nvSpPr>
            <p:spPr>
              <a:xfrm>
                <a:off x="2653733" y="4149163"/>
                <a:ext cx="598499" cy="508003"/>
              </a:xfrm>
              <a:prstGeom prst="flowChartPreparation">
                <a:avLst/>
              </a:prstGeom>
              <a:solidFill>
                <a:srgbClr val="36AB9C"/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9" name="流程图: 准备 148">
                <a:extLst>
                  <a:ext uri="{FF2B5EF4-FFF2-40B4-BE49-F238E27FC236}">
                    <a16:creationId xmlns:a16="http://schemas.microsoft.com/office/drawing/2014/main" id="{B7D07A05-A101-B139-E2CA-1886EEBA28CF}"/>
                  </a:ext>
                </a:extLst>
              </p:cNvPr>
              <p:cNvSpPr/>
              <p:nvPr/>
            </p:nvSpPr>
            <p:spPr>
              <a:xfrm>
                <a:off x="2648596" y="3111811"/>
                <a:ext cx="598499" cy="508003"/>
              </a:xfrm>
              <a:prstGeom prst="flowChartPreparation">
                <a:avLst/>
              </a:prstGeom>
              <a:solidFill>
                <a:srgbClr val="36AB9C"/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0" name="流程图: 准备 149">
                <a:extLst>
                  <a:ext uri="{FF2B5EF4-FFF2-40B4-BE49-F238E27FC236}">
                    <a16:creationId xmlns:a16="http://schemas.microsoft.com/office/drawing/2014/main" id="{33C942D4-CDF6-C191-320D-DEE7C0051C57}"/>
                  </a:ext>
                </a:extLst>
              </p:cNvPr>
              <p:cNvSpPr/>
              <p:nvPr/>
            </p:nvSpPr>
            <p:spPr>
              <a:xfrm>
                <a:off x="1682825" y="3131104"/>
                <a:ext cx="598499" cy="508003"/>
              </a:xfrm>
              <a:prstGeom prst="flowChartPreparation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1" name="流程图: 准备 150">
                <a:extLst>
                  <a:ext uri="{FF2B5EF4-FFF2-40B4-BE49-F238E27FC236}">
                    <a16:creationId xmlns:a16="http://schemas.microsoft.com/office/drawing/2014/main" id="{01E4488D-E7E1-53FF-BF9F-0A4E2A74EBFE}"/>
                  </a:ext>
                </a:extLst>
              </p:cNvPr>
              <p:cNvSpPr/>
              <p:nvPr/>
            </p:nvSpPr>
            <p:spPr>
              <a:xfrm>
                <a:off x="2165710" y="2871964"/>
                <a:ext cx="598499" cy="508003"/>
              </a:xfrm>
              <a:prstGeom prst="flowChartPreparation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2" name="流程图: 准备 151">
                <a:extLst>
                  <a:ext uri="{FF2B5EF4-FFF2-40B4-BE49-F238E27FC236}">
                    <a16:creationId xmlns:a16="http://schemas.microsoft.com/office/drawing/2014/main" id="{9AEA42B6-CEBF-20DC-AB77-986C76084649}"/>
                  </a:ext>
                </a:extLst>
              </p:cNvPr>
              <p:cNvSpPr/>
              <p:nvPr/>
            </p:nvSpPr>
            <p:spPr>
              <a:xfrm>
                <a:off x="3131482" y="3372890"/>
                <a:ext cx="598499" cy="508003"/>
              </a:xfrm>
              <a:prstGeom prst="flowChartPreparation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3" name="流程图: 准备 152">
                <a:extLst>
                  <a:ext uri="{FF2B5EF4-FFF2-40B4-BE49-F238E27FC236}">
                    <a16:creationId xmlns:a16="http://schemas.microsoft.com/office/drawing/2014/main" id="{341FB440-10DA-D5BF-64A8-8905ABC7ED69}"/>
                  </a:ext>
                </a:extLst>
              </p:cNvPr>
              <p:cNvSpPr/>
              <p:nvPr/>
            </p:nvSpPr>
            <p:spPr>
              <a:xfrm>
                <a:off x="3136619" y="3886030"/>
                <a:ext cx="598499" cy="508003"/>
              </a:xfrm>
              <a:prstGeom prst="flowChartPreparation">
                <a:avLst/>
              </a:prstGeom>
              <a:solidFill>
                <a:schemeClr val="bg2">
                  <a:lumMod val="7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4" name="椭圆 153">
                <a:extLst>
                  <a:ext uri="{FF2B5EF4-FFF2-40B4-BE49-F238E27FC236}">
                    <a16:creationId xmlns:a16="http://schemas.microsoft.com/office/drawing/2014/main" id="{371A9DC2-5106-E490-DDFA-E7A267F9C204}"/>
                  </a:ext>
                </a:extLst>
              </p:cNvPr>
              <p:cNvSpPr/>
              <p:nvPr/>
            </p:nvSpPr>
            <p:spPr>
              <a:xfrm>
                <a:off x="3272500" y="3472665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5" name="椭圆 154">
                <a:extLst>
                  <a:ext uri="{FF2B5EF4-FFF2-40B4-BE49-F238E27FC236}">
                    <a16:creationId xmlns:a16="http://schemas.microsoft.com/office/drawing/2014/main" id="{8A765F0D-CA15-0488-AC62-358800408576}"/>
                  </a:ext>
                </a:extLst>
              </p:cNvPr>
              <p:cNvSpPr/>
              <p:nvPr/>
            </p:nvSpPr>
            <p:spPr>
              <a:xfrm>
                <a:off x="3413518" y="3602583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6" name="椭圆 155">
                <a:extLst>
                  <a:ext uri="{FF2B5EF4-FFF2-40B4-BE49-F238E27FC236}">
                    <a16:creationId xmlns:a16="http://schemas.microsoft.com/office/drawing/2014/main" id="{D7DA2921-D684-9DBE-94B3-00F9411983C4}"/>
                  </a:ext>
                </a:extLst>
              </p:cNvPr>
              <p:cNvSpPr/>
              <p:nvPr/>
            </p:nvSpPr>
            <p:spPr>
              <a:xfrm rot="3157468">
                <a:off x="3353764" y="3959633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7" name="椭圆 156">
                <a:extLst>
                  <a:ext uri="{FF2B5EF4-FFF2-40B4-BE49-F238E27FC236}">
                    <a16:creationId xmlns:a16="http://schemas.microsoft.com/office/drawing/2014/main" id="{9477CAED-B3C5-0D43-55D2-06736F52351E}"/>
                  </a:ext>
                </a:extLst>
              </p:cNvPr>
              <p:cNvSpPr/>
              <p:nvPr/>
            </p:nvSpPr>
            <p:spPr>
              <a:xfrm rot="3157468">
                <a:off x="3413518" y="4149163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8" name="椭圆 157">
                <a:extLst>
                  <a:ext uri="{FF2B5EF4-FFF2-40B4-BE49-F238E27FC236}">
                    <a16:creationId xmlns:a16="http://schemas.microsoft.com/office/drawing/2014/main" id="{CE27FA44-89BB-344B-5FF0-CD169CBF7410}"/>
                  </a:ext>
                </a:extLst>
              </p:cNvPr>
              <p:cNvSpPr/>
              <p:nvPr/>
            </p:nvSpPr>
            <p:spPr>
              <a:xfrm rot="2337341">
                <a:off x="2819814" y="4289805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9" name="椭圆 158">
                <a:extLst>
                  <a:ext uri="{FF2B5EF4-FFF2-40B4-BE49-F238E27FC236}">
                    <a16:creationId xmlns:a16="http://schemas.microsoft.com/office/drawing/2014/main" id="{F9B70ACF-4708-CB14-B789-0F31C7E1E302}"/>
                  </a:ext>
                </a:extLst>
              </p:cNvPr>
              <p:cNvSpPr/>
              <p:nvPr/>
            </p:nvSpPr>
            <p:spPr>
              <a:xfrm rot="2337341">
                <a:off x="2976011" y="4415299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0" name="椭圆 159">
                <a:extLst>
                  <a:ext uri="{FF2B5EF4-FFF2-40B4-BE49-F238E27FC236}">
                    <a16:creationId xmlns:a16="http://schemas.microsoft.com/office/drawing/2014/main" id="{1ED4FFED-D228-231D-9D3D-F6270E103013}"/>
                  </a:ext>
                </a:extLst>
              </p:cNvPr>
              <p:cNvSpPr/>
              <p:nvPr/>
            </p:nvSpPr>
            <p:spPr>
              <a:xfrm rot="4717307">
                <a:off x="2819814" y="3802236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1" name="椭圆 160">
                <a:extLst>
                  <a:ext uri="{FF2B5EF4-FFF2-40B4-BE49-F238E27FC236}">
                    <a16:creationId xmlns:a16="http://schemas.microsoft.com/office/drawing/2014/main" id="{2C107889-9094-C099-C53C-98851D2317E5}"/>
                  </a:ext>
                </a:extLst>
              </p:cNvPr>
              <p:cNvSpPr/>
              <p:nvPr/>
            </p:nvSpPr>
            <p:spPr>
              <a:xfrm rot="4717307">
                <a:off x="2993292" y="3747400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2" name="椭圆 161">
                <a:extLst>
                  <a:ext uri="{FF2B5EF4-FFF2-40B4-BE49-F238E27FC236}">
                    <a16:creationId xmlns:a16="http://schemas.microsoft.com/office/drawing/2014/main" id="{9CE72D7B-B685-4C9A-7CE9-E9C63119436B}"/>
                  </a:ext>
                </a:extLst>
              </p:cNvPr>
              <p:cNvSpPr/>
              <p:nvPr/>
            </p:nvSpPr>
            <p:spPr>
              <a:xfrm rot="2337341">
                <a:off x="2314071" y="4521386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3" name="椭圆 162">
                <a:extLst>
                  <a:ext uri="{FF2B5EF4-FFF2-40B4-BE49-F238E27FC236}">
                    <a16:creationId xmlns:a16="http://schemas.microsoft.com/office/drawing/2014/main" id="{0860C3A0-B74B-FA24-D58A-420BB09D9669}"/>
                  </a:ext>
                </a:extLst>
              </p:cNvPr>
              <p:cNvSpPr/>
              <p:nvPr/>
            </p:nvSpPr>
            <p:spPr>
              <a:xfrm rot="2337341">
                <a:off x="2470268" y="4646880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4" name="椭圆 163">
                <a:extLst>
                  <a:ext uri="{FF2B5EF4-FFF2-40B4-BE49-F238E27FC236}">
                    <a16:creationId xmlns:a16="http://schemas.microsoft.com/office/drawing/2014/main" id="{0BDD65CE-DDE7-B5B8-6085-D2AB2DC5A65A}"/>
                  </a:ext>
                </a:extLst>
              </p:cNvPr>
              <p:cNvSpPr/>
              <p:nvPr/>
            </p:nvSpPr>
            <p:spPr>
              <a:xfrm rot="2337341">
                <a:off x="2361200" y="4042960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5" name="椭圆 164">
                <a:extLst>
                  <a:ext uri="{FF2B5EF4-FFF2-40B4-BE49-F238E27FC236}">
                    <a16:creationId xmlns:a16="http://schemas.microsoft.com/office/drawing/2014/main" id="{58B30469-9136-7368-BCFD-2D184C6F00DE}"/>
                  </a:ext>
                </a:extLst>
              </p:cNvPr>
              <p:cNvSpPr/>
              <p:nvPr/>
            </p:nvSpPr>
            <p:spPr>
              <a:xfrm rot="2337341">
                <a:off x="2470268" y="4138870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6" name="椭圆 165">
                <a:extLst>
                  <a:ext uri="{FF2B5EF4-FFF2-40B4-BE49-F238E27FC236}">
                    <a16:creationId xmlns:a16="http://schemas.microsoft.com/office/drawing/2014/main" id="{EECC3FAF-861B-28BD-31A8-0B3415AFB807}"/>
                  </a:ext>
                </a:extLst>
              </p:cNvPr>
              <p:cNvSpPr/>
              <p:nvPr/>
            </p:nvSpPr>
            <p:spPr>
              <a:xfrm rot="2337341">
                <a:off x="2361201" y="3579415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7" name="椭圆 166">
                <a:extLst>
                  <a:ext uri="{FF2B5EF4-FFF2-40B4-BE49-F238E27FC236}">
                    <a16:creationId xmlns:a16="http://schemas.microsoft.com/office/drawing/2014/main" id="{F2504AB4-DAAA-46B2-1B17-E444381D9B29}"/>
                  </a:ext>
                </a:extLst>
              </p:cNvPr>
              <p:cNvSpPr/>
              <p:nvPr/>
            </p:nvSpPr>
            <p:spPr>
              <a:xfrm rot="2337341">
                <a:off x="2537112" y="3579415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8" name="椭圆 167">
                <a:extLst>
                  <a:ext uri="{FF2B5EF4-FFF2-40B4-BE49-F238E27FC236}">
                    <a16:creationId xmlns:a16="http://schemas.microsoft.com/office/drawing/2014/main" id="{331664C9-EE36-A6D5-9B18-9EF11616B470}"/>
                  </a:ext>
                </a:extLst>
              </p:cNvPr>
              <p:cNvSpPr/>
              <p:nvPr/>
            </p:nvSpPr>
            <p:spPr>
              <a:xfrm>
                <a:off x="2808858" y="3215884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9" name="椭圆 168">
                <a:extLst>
                  <a:ext uri="{FF2B5EF4-FFF2-40B4-BE49-F238E27FC236}">
                    <a16:creationId xmlns:a16="http://schemas.microsoft.com/office/drawing/2014/main" id="{462F780D-8373-0E96-F4A7-B5CA15E4BC81}"/>
                  </a:ext>
                </a:extLst>
              </p:cNvPr>
              <p:cNvSpPr/>
              <p:nvPr/>
            </p:nvSpPr>
            <p:spPr>
              <a:xfrm>
                <a:off x="2949876" y="3345802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0" name="椭圆 169">
                <a:extLst>
                  <a:ext uri="{FF2B5EF4-FFF2-40B4-BE49-F238E27FC236}">
                    <a16:creationId xmlns:a16="http://schemas.microsoft.com/office/drawing/2014/main" id="{E37477EC-3728-C868-F52A-A1A6B1D05886}"/>
                  </a:ext>
                </a:extLst>
              </p:cNvPr>
              <p:cNvSpPr/>
              <p:nvPr/>
            </p:nvSpPr>
            <p:spPr>
              <a:xfrm>
                <a:off x="2295226" y="3022403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1" name="椭圆 170">
                <a:extLst>
                  <a:ext uri="{FF2B5EF4-FFF2-40B4-BE49-F238E27FC236}">
                    <a16:creationId xmlns:a16="http://schemas.microsoft.com/office/drawing/2014/main" id="{20D4B735-C97F-90E2-1548-9575D90BDBFB}"/>
                  </a:ext>
                </a:extLst>
              </p:cNvPr>
              <p:cNvSpPr/>
              <p:nvPr/>
            </p:nvSpPr>
            <p:spPr>
              <a:xfrm>
                <a:off x="2491338" y="3051769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2" name="椭圆 171">
                <a:extLst>
                  <a:ext uri="{FF2B5EF4-FFF2-40B4-BE49-F238E27FC236}">
                    <a16:creationId xmlns:a16="http://schemas.microsoft.com/office/drawing/2014/main" id="{5B667173-D903-992F-03A0-A72BEB2BA7D5}"/>
                  </a:ext>
                </a:extLst>
              </p:cNvPr>
              <p:cNvSpPr/>
              <p:nvPr/>
            </p:nvSpPr>
            <p:spPr>
              <a:xfrm>
                <a:off x="1808511" y="3298694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3" name="椭圆 172">
                <a:extLst>
                  <a:ext uri="{FF2B5EF4-FFF2-40B4-BE49-F238E27FC236}">
                    <a16:creationId xmlns:a16="http://schemas.microsoft.com/office/drawing/2014/main" id="{DB1D1D3C-50A8-1CF1-0A3E-80B34306C1D6}"/>
                  </a:ext>
                </a:extLst>
              </p:cNvPr>
              <p:cNvSpPr/>
              <p:nvPr/>
            </p:nvSpPr>
            <p:spPr>
              <a:xfrm>
                <a:off x="2004623" y="3328060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4" name="椭圆 173">
                <a:extLst>
                  <a:ext uri="{FF2B5EF4-FFF2-40B4-BE49-F238E27FC236}">
                    <a16:creationId xmlns:a16="http://schemas.microsoft.com/office/drawing/2014/main" id="{929DBE1F-2740-DDF7-2D77-A001231B370E}"/>
                  </a:ext>
                </a:extLst>
              </p:cNvPr>
              <p:cNvSpPr/>
              <p:nvPr/>
            </p:nvSpPr>
            <p:spPr>
              <a:xfrm>
                <a:off x="1808511" y="3818131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5" name="椭圆 174">
                <a:extLst>
                  <a:ext uri="{FF2B5EF4-FFF2-40B4-BE49-F238E27FC236}">
                    <a16:creationId xmlns:a16="http://schemas.microsoft.com/office/drawing/2014/main" id="{3E9643A3-5087-B4FD-661B-FEB54320E2CC}"/>
                  </a:ext>
                </a:extLst>
              </p:cNvPr>
              <p:cNvSpPr/>
              <p:nvPr/>
            </p:nvSpPr>
            <p:spPr>
              <a:xfrm>
                <a:off x="1999829" y="3750974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6" name="椭圆 175">
                <a:extLst>
                  <a:ext uri="{FF2B5EF4-FFF2-40B4-BE49-F238E27FC236}">
                    <a16:creationId xmlns:a16="http://schemas.microsoft.com/office/drawing/2014/main" id="{11583261-6856-2FC7-BE77-7431956E94B3}"/>
                  </a:ext>
                </a:extLst>
              </p:cNvPr>
              <p:cNvSpPr/>
              <p:nvPr/>
            </p:nvSpPr>
            <p:spPr>
              <a:xfrm>
                <a:off x="1808511" y="4326134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08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7" name="椭圆 176">
                <a:extLst>
                  <a:ext uri="{FF2B5EF4-FFF2-40B4-BE49-F238E27FC236}">
                    <a16:creationId xmlns:a16="http://schemas.microsoft.com/office/drawing/2014/main" id="{53E35473-6A2A-7157-591D-781CF988F926}"/>
                  </a:ext>
                </a:extLst>
              </p:cNvPr>
              <p:cNvSpPr/>
              <p:nvPr/>
            </p:nvSpPr>
            <p:spPr>
              <a:xfrm>
                <a:off x="2004623" y="4355500"/>
                <a:ext cx="153931" cy="148391"/>
              </a:xfrm>
              <a:prstGeom prst="ellipse">
                <a:avLst/>
              </a:prstGeom>
              <a:solidFill>
                <a:srgbClr val="999999"/>
              </a:solidFill>
              <a:ln w="6350">
                <a:solidFill>
                  <a:schemeClr val="bg1">
                    <a:lumMod val="50000"/>
                  </a:schemeClr>
                </a:solidFill>
              </a:ln>
              <a:effectLst>
                <a:innerShdw blurRad="63500" dist="50800" dir="13500000">
                  <a:prstClr val="black">
                    <a:alpha val="50000"/>
                  </a:prstClr>
                </a:innerShdw>
                <a:softEdge rad="6350"/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cxnSp>
          <p:nvCxnSpPr>
            <p:cNvPr id="178" name="直接箭头连接符 177">
              <a:extLst>
                <a:ext uri="{FF2B5EF4-FFF2-40B4-BE49-F238E27FC236}">
                  <a16:creationId xmlns:a16="http://schemas.microsoft.com/office/drawing/2014/main" id="{9CA78C5F-C5F5-52AB-1C8F-6EBBE1EBFAAC}"/>
                </a:ext>
              </a:extLst>
            </p:cNvPr>
            <p:cNvCxnSpPr>
              <a:cxnSpLocks/>
            </p:cNvCxnSpPr>
            <p:nvPr/>
          </p:nvCxnSpPr>
          <p:spPr>
            <a:xfrm>
              <a:off x="2871439" y="1730305"/>
              <a:ext cx="384356" cy="0"/>
            </a:xfrm>
            <a:prstGeom prst="straightConnector1">
              <a:avLst/>
            </a:prstGeom>
            <a:ln w="38100">
              <a:solidFill>
                <a:schemeClr val="tx1">
                  <a:lumMod val="85000"/>
                  <a:lumOff val="1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0" name="组合 179">
              <a:extLst>
                <a:ext uri="{FF2B5EF4-FFF2-40B4-BE49-F238E27FC236}">
                  <a16:creationId xmlns:a16="http://schemas.microsoft.com/office/drawing/2014/main" id="{FD270691-D7A8-B2CD-40B4-1CE1FA7965D1}"/>
                </a:ext>
              </a:extLst>
            </p:cNvPr>
            <p:cNvGrpSpPr/>
            <p:nvPr/>
          </p:nvGrpSpPr>
          <p:grpSpPr>
            <a:xfrm rot="20469737">
              <a:off x="1057587" y="1493365"/>
              <a:ext cx="561961" cy="549007"/>
              <a:chOff x="3875949" y="2389953"/>
              <a:chExt cx="3053775" cy="2983381"/>
            </a:xfrm>
          </p:grpSpPr>
          <p:sp>
            <p:nvSpPr>
              <p:cNvPr id="181" name="任意多边形: 形状 180">
                <a:extLst>
                  <a:ext uri="{FF2B5EF4-FFF2-40B4-BE49-F238E27FC236}">
                    <a16:creationId xmlns:a16="http://schemas.microsoft.com/office/drawing/2014/main" id="{F10624CF-149E-301A-7660-74B75FA638A3}"/>
                  </a:ext>
                </a:extLst>
              </p:cNvPr>
              <p:cNvSpPr/>
              <p:nvPr/>
            </p:nvSpPr>
            <p:spPr>
              <a:xfrm rot="240970">
                <a:off x="4890399" y="4906378"/>
                <a:ext cx="399998" cy="466169"/>
              </a:xfrm>
              <a:custGeom>
                <a:avLst/>
                <a:gdLst>
                  <a:gd name="connsiteX0" fmla="*/ 0 w 898497"/>
                  <a:gd name="connsiteY0" fmla="*/ 143123 h 850789"/>
                  <a:gd name="connsiteX1" fmla="*/ 55659 w 898497"/>
                  <a:gd name="connsiteY1" fmla="*/ 174928 h 850789"/>
                  <a:gd name="connsiteX2" fmla="*/ 15903 w 898497"/>
                  <a:gd name="connsiteY2" fmla="*/ 850789 h 850789"/>
                  <a:gd name="connsiteX3" fmla="*/ 898497 w 898497"/>
                  <a:gd name="connsiteY3" fmla="*/ 811033 h 850789"/>
                  <a:gd name="connsiteX4" fmla="*/ 620202 w 898497"/>
                  <a:gd name="connsiteY4" fmla="*/ 0 h 850789"/>
                  <a:gd name="connsiteX5" fmla="*/ 0 w 898497"/>
                  <a:gd name="connsiteY5" fmla="*/ 143123 h 85078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898497" h="850789">
                    <a:moveTo>
                      <a:pt x="0" y="143123"/>
                    </a:moveTo>
                    <a:lnTo>
                      <a:pt x="55659" y="174928"/>
                    </a:lnTo>
                    <a:lnTo>
                      <a:pt x="15903" y="850789"/>
                    </a:lnTo>
                    <a:lnTo>
                      <a:pt x="898497" y="811033"/>
                    </a:lnTo>
                    <a:lnTo>
                      <a:pt x="620202" y="0"/>
                    </a:lnTo>
                    <a:lnTo>
                      <a:pt x="0" y="143123"/>
                    </a:lnTo>
                    <a:close/>
                  </a:path>
                </a:pathLst>
              </a:custGeom>
              <a:solidFill>
                <a:srgbClr val="F2F2F2"/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2" name="弦形 181">
                <a:extLst>
                  <a:ext uri="{FF2B5EF4-FFF2-40B4-BE49-F238E27FC236}">
                    <a16:creationId xmlns:a16="http://schemas.microsoft.com/office/drawing/2014/main" id="{863EF8ED-CCFA-144A-0511-41D3E994DA3F}"/>
                  </a:ext>
                </a:extLst>
              </p:cNvPr>
              <p:cNvSpPr/>
              <p:nvPr/>
            </p:nvSpPr>
            <p:spPr>
              <a:xfrm rot="17621915">
                <a:off x="3872279" y="2749207"/>
                <a:ext cx="2293598" cy="2286257"/>
              </a:xfrm>
              <a:prstGeom prst="chord">
                <a:avLst>
                  <a:gd name="adj1" fmla="val 2892838"/>
                  <a:gd name="adj2" fmla="val 15826118"/>
                </a:avLst>
              </a:prstGeom>
              <a:solidFill>
                <a:srgbClr val="F2F2F2"/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 sd="2650216993">
                      <a:custGeom>
                        <a:avLst/>
                        <a:gdLst>
                          <a:gd name="connsiteX0" fmla="*/ 324478 w 2525819"/>
                          <a:gd name="connsiteY0" fmla="*/ 750107 h 4535284"/>
                          <a:gd name="connsiteX1" fmla="*/ 2113751 w 2525819"/>
                          <a:gd name="connsiteY1" fmla="*/ 591875 h 4535284"/>
                          <a:gd name="connsiteX2" fmla="*/ 324478 w 2525819"/>
                          <a:gd name="connsiteY2" fmla="*/ 750107 h 4535284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</a:cxnLst>
                        <a:rect l="l" t="t" r="r" b="b"/>
                        <a:pathLst>
                          <a:path w="2525819" h="4535284" fill="none" extrusionOk="0">
                            <a:moveTo>
                              <a:pt x="324478" y="750107"/>
                            </a:moveTo>
                            <a:cubicBezTo>
                              <a:pt x="720087" y="-294886"/>
                              <a:pt x="1676393" y="-158421"/>
                              <a:pt x="2113751" y="591875"/>
                            </a:cubicBezTo>
                            <a:cubicBezTo>
                              <a:pt x="1315736" y="794749"/>
                              <a:pt x="541424" y="700273"/>
                              <a:pt x="324478" y="750107"/>
                            </a:cubicBezTo>
                            <a:close/>
                          </a:path>
                          <a:path w="2525819" h="4535284" stroke="0" extrusionOk="0">
                            <a:moveTo>
                              <a:pt x="324478" y="750107"/>
                            </a:moveTo>
                            <a:cubicBezTo>
                              <a:pt x="724241" y="-181551"/>
                              <a:pt x="1616893" y="-235058"/>
                              <a:pt x="2113751" y="591875"/>
                            </a:cubicBezTo>
                            <a:cubicBezTo>
                              <a:pt x="1602322" y="711009"/>
                              <a:pt x="1027670" y="801337"/>
                              <a:pt x="324478" y="750107"/>
                            </a:cubicBezTo>
                            <a:close/>
                          </a:path>
                        </a:pathLst>
                      </a:custGeom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3" name="弦形 182">
                <a:extLst>
                  <a:ext uri="{FF2B5EF4-FFF2-40B4-BE49-F238E27FC236}">
                    <a16:creationId xmlns:a16="http://schemas.microsoft.com/office/drawing/2014/main" id="{6E917429-94DD-B065-F136-6C0C87105041}"/>
                  </a:ext>
                </a:extLst>
              </p:cNvPr>
              <p:cNvSpPr/>
              <p:nvPr/>
            </p:nvSpPr>
            <p:spPr>
              <a:xfrm rot="6827173">
                <a:off x="3858157" y="2725121"/>
                <a:ext cx="2302939" cy="2221084"/>
              </a:xfrm>
              <a:prstGeom prst="chord">
                <a:avLst>
                  <a:gd name="adj1" fmla="val 4868995"/>
                  <a:gd name="adj2" fmla="val 13867367"/>
                </a:avLst>
              </a:prstGeom>
              <a:solidFill>
                <a:schemeClr val="bg1">
                  <a:lumMod val="95000"/>
                </a:schemeClr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 sd="2650216993">
                      <a:custGeom>
                        <a:avLst/>
                        <a:gdLst>
                          <a:gd name="connsiteX0" fmla="*/ 308525 w 2525819"/>
                          <a:gd name="connsiteY0" fmla="*/ 792420 h 4592601"/>
                          <a:gd name="connsiteX1" fmla="*/ 2119574 w 2525819"/>
                          <a:gd name="connsiteY1" fmla="*/ 609066 h 4592601"/>
                          <a:gd name="connsiteX2" fmla="*/ 308525 w 2525819"/>
                          <a:gd name="connsiteY2" fmla="*/ 792420 h 4592601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</a:cxnLst>
                        <a:rect l="l" t="t" r="r" b="b"/>
                        <a:pathLst>
                          <a:path w="2525819" h="4592601" fill="none" extrusionOk="0">
                            <a:moveTo>
                              <a:pt x="308525" y="792420"/>
                            </a:moveTo>
                            <a:cubicBezTo>
                              <a:pt x="765498" y="-202417"/>
                              <a:pt x="1678190" y="-170587"/>
                              <a:pt x="2119574" y="609066"/>
                            </a:cubicBezTo>
                            <a:cubicBezTo>
                              <a:pt x="1423039" y="810329"/>
                              <a:pt x="863455" y="847825"/>
                              <a:pt x="308525" y="792420"/>
                            </a:cubicBezTo>
                            <a:close/>
                          </a:path>
                          <a:path w="2525819" h="4592601" stroke="0" extrusionOk="0">
                            <a:moveTo>
                              <a:pt x="308525" y="792420"/>
                            </a:moveTo>
                            <a:cubicBezTo>
                              <a:pt x="690064" y="-183675"/>
                              <a:pt x="1678443" y="-188982"/>
                              <a:pt x="2119574" y="609066"/>
                            </a:cubicBezTo>
                            <a:cubicBezTo>
                              <a:pt x="1306149" y="563447"/>
                              <a:pt x="1158438" y="848397"/>
                              <a:pt x="308525" y="792420"/>
                            </a:cubicBezTo>
                            <a:close/>
                          </a:path>
                        </a:pathLst>
                      </a:custGeom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4" name="弦形 183">
                <a:extLst>
                  <a:ext uri="{FF2B5EF4-FFF2-40B4-BE49-F238E27FC236}">
                    <a16:creationId xmlns:a16="http://schemas.microsoft.com/office/drawing/2014/main" id="{CF3AC710-C168-349B-E3F8-06E84A4CD680}"/>
                  </a:ext>
                </a:extLst>
              </p:cNvPr>
              <p:cNvSpPr/>
              <p:nvPr/>
            </p:nvSpPr>
            <p:spPr>
              <a:xfrm rot="16840533">
                <a:off x="3892557" y="2747204"/>
                <a:ext cx="2236682" cy="2169574"/>
              </a:xfrm>
              <a:prstGeom prst="chord">
                <a:avLst>
                  <a:gd name="adj1" fmla="val 4033808"/>
                  <a:gd name="adj2" fmla="val 16461139"/>
                </a:avLst>
              </a:prstGeom>
              <a:solidFill>
                <a:srgbClr val="FFBE7A"/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 sd="2650216993">
                      <a:custGeom>
                        <a:avLst/>
                        <a:gdLst>
                          <a:gd name="connsiteX0" fmla="*/ 1851774 w 2169465"/>
                          <a:gd name="connsiteY0" fmla="*/ 1851829 h 2169576"/>
                          <a:gd name="connsiteX1" fmla="*/ 381713 w 2169465"/>
                          <a:gd name="connsiteY1" fmla="*/ 1910910 h 2169576"/>
                          <a:gd name="connsiteX2" fmla="*/ 204871 w 2169465"/>
                          <a:gd name="connsiteY2" fmla="*/ 450335 h 2169576"/>
                          <a:gd name="connsiteX3" fmla="*/ 1646546 w 2169465"/>
                          <a:gd name="connsiteY3" fmla="*/ 156834 h 2169576"/>
                          <a:gd name="connsiteX4" fmla="*/ 1851774 w 2169465"/>
                          <a:gd name="connsiteY4" fmla="*/ 1851829 h 2169576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  <a:cxn ang="0">
                            <a:pos x="connsiteX3" y="connsiteY3"/>
                          </a:cxn>
                          <a:cxn ang="0">
                            <a:pos x="connsiteX4" y="connsiteY4"/>
                          </a:cxn>
                        </a:cxnLst>
                        <a:rect l="l" t="t" r="r" b="b"/>
                        <a:pathLst>
                          <a:path w="2169465" h="2169576" fill="none" extrusionOk="0">
                            <a:moveTo>
                              <a:pt x="1851774" y="1851829"/>
                            </a:moveTo>
                            <a:cubicBezTo>
                              <a:pt x="1519766" y="2256621"/>
                              <a:pt x="821881" y="2294169"/>
                              <a:pt x="381713" y="1910910"/>
                            </a:cubicBezTo>
                            <a:cubicBezTo>
                              <a:pt x="-36844" y="1654291"/>
                              <a:pt x="-157315" y="1013576"/>
                              <a:pt x="204871" y="450335"/>
                            </a:cubicBezTo>
                            <a:cubicBezTo>
                              <a:pt x="593698" y="-85626"/>
                              <a:pt x="1078315" y="-116182"/>
                              <a:pt x="1646546" y="156834"/>
                            </a:cubicBezTo>
                            <a:cubicBezTo>
                              <a:pt x="1525782" y="422991"/>
                              <a:pt x="1735636" y="1420577"/>
                              <a:pt x="1851774" y="1851829"/>
                            </a:cubicBezTo>
                            <a:close/>
                          </a:path>
                          <a:path w="2169465" h="2169576" stroke="0" extrusionOk="0">
                            <a:moveTo>
                              <a:pt x="1851774" y="1851829"/>
                            </a:moveTo>
                            <a:cubicBezTo>
                              <a:pt x="1400362" y="2253832"/>
                              <a:pt x="881938" y="2345843"/>
                              <a:pt x="381713" y="1910910"/>
                            </a:cubicBezTo>
                            <a:cubicBezTo>
                              <a:pt x="-37275" y="1568162"/>
                              <a:pt x="-123725" y="970918"/>
                              <a:pt x="204871" y="450335"/>
                            </a:cubicBezTo>
                            <a:cubicBezTo>
                              <a:pt x="511047" y="-45185"/>
                              <a:pt x="1207425" y="-82197"/>
                              <a:pt x="1646546" y="156834"/>
                            </a:cubicBezTo>
                            <a:cubicBezTo>
                              <a:pt x="1847962" y="977195"/>
                              <a:pt x="1744835" y="1328901"/>
                              <a:pt x="1851774" y="1851829"/>
                            </a:cubicBezTo>
                            <a:close/>
                          </a:path>
                        </a:pathLst>
                      </a:custGeom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5" name="任意多边形: 形状 184">
                <a:extLst>
                  <a:ext uri="{FF2B5EF4-FFF2-40B4-BE49-F238E27FC236}">
                    <a16:creationId xmlns:a16="http://schemas.microsoft.com/office/drawing/2014/main" id="{6BCCA8EC-7395-AF59-4941-0DA12B35D0E3}"/>
                  </a:ext>
                </a:extLst>
              </p:cNvPr>
              <p:cNvSpPr/>
              <p:nvPr/>
            </p:nvSpPr>
            <p:spPr>
              <a:xfrm rot="240970">
                <a:off x="4964305" y="4821306"/>
                <a:ext cx="269163" cy="552028"/>
              </a:xfrm>
              <a:custGeom>
                <a:avLst/>
                <a:gdLst>
                  <a:gd name="connsiteX0" fmla="*/ 7952 w 628153"/>
                  <a:gd name="connsiteY0" fmla="*/ 71561 h 954156"/>
                  <a:gd name="connsiteX1" fmla="*/ 0 w 628153"/>
                  <a:gd name="connsiteY1" fmla="*/ 954156 h 954156"/>
                  <a:gd name="connsiteX2" fmla="*/ 628153 w 628153"/>
                  <a:gd name="connsiteY2" fmla="*/ 914400 h 954156"/>
                  <a:gd name="connsiteX3" fmla="*/ 357809 w 628153"/>
                  <a:gd name="connsiteY3" fmla="*/ 0 h 954156"/>
                  <a:gd name="connsiteX4" fmla="*/ 7952 w 628153"/>
                  <a:gd name="connsiteY4" fmla="*/ 71561 h 95415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28153" h="954156">
                    <a:moveTo>
                      <a:pt x="7952" y="71561"/>
                    </a:moveTo>
                    <a:cubicBezTo>
                      <a:pt x="5301" y="365759"/>
                      <a:pt x="2651" y="659958"/>
                      <a:pt x="0" y="954156"/>
                    </a:cubicBezTo>
                    <a:lnTo>
                      <a:pt x="628153" y="914400"/>
                    </a:lnTo>
                    <a:lnTo>
                      <a:pt x="357809" y="0"/>
                    </a:lnTo>
                    <a:lnTo>
                      <a:pt x="7952" y="71561"/>
                    </a:lnTo>
                    <a:close/>
                  </a:path>
                </a:pathLst>
              </a:custGeom>
              <a:solidFill>
                <a:srgbClr val="FA7F6F"/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6" name="弦形 185">
                <a:extLst>
                  <a:ext uri="{FF2B5EF4-FFF2-40B4-BE49-F238E27FC236}">
                    <a16:creationId xmlns:a16="http://schemas.microsoft.com/office/drawing/2014/main" id="{30FA33F8-12A4-2345-060C-E9A5622B9D2A}"/>
                  </a:ext>
                </a:extLst>
              </p:cNvPr>
              <p:cNvSpPr/>
              <p:nvPr/>
            </p:nvSpPr>
            <p:spPr>
              <a:xfrm rot="16840533">
                <a:off x="3938840" y="2781340"/>
                <a:ext cx="2143573" cy="2093174"/>
              </a:xfrm>
              <a:prstGeom prst="chord">
                <a:avLst>
                  <a:gd name="adj1" fmla="val 3985950"/>
                  <a:gd name="adj2" fmla="val 16534130"/>
                </a:avLst>
              </a:prstGeom>
              <a:solidFill>
                <a:srgbClr val="FA7F6F"/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 sd="2650216993">
                      <a:custGeom>
                        <a:avLst/>
                        <a:gdLst>
                          <a:gd name="connsiteX0" fmla="*/ 1803791 w 2093069"/>
                          <a:gd name="connsiteY0" fmla="*/ 1768980 h 2093176"/>
                          <a:gd name="connsiteX1" fmla="*/ 375297 w 2093069"/>
                          <a:gd name="connsiteY1" fmla="*/ 1849545 h 2093176"/>
                          <a:gd name="connsiteX2" fmla="*/ 201341 w 2093069"/>
                          <a:gd name="connsiteY2" fmla="*/ 429400 h 2093176"/>
                          <a:gd name="connsiteX3" fmla="*/ 1607040 w 2093069"/>
                          <a:gd name="connsiteY3" fmla="*/ 162762 h 2093176"/>
                          <a:gd name="connsiteX4" fmla="*/ 1803791 w 2093069"/>
                          <a:gd name="connsiteY4" fmla="*/ 1768980 h 2093176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  <a:cxn ang="0">
                            <a:pos x="connsiteX3" y="connsiteY3"/>
                          </a:cxn>
                          <a:cxn ang="0">
                            <a:pos x="connsiteX4" y="connsiteY4"/>
                          </a:cxn>
                        </a:cxnLst>
                        <a:rect l="l" t="t" r="r" b="b"/>
                        <a:pathLst>
                          <a:path w="2093069" h="2093176" fill="none" extrusionOk="0">
                            <a:moveTo>
                              <a:pt x="1803791" y="1768980"/>
                            </a:moveTo>
                            <a:cubicBezTo>
                              <a:pt x="1508583" y="2174280"/>
                              <a:pt x="846175" y="2286900"/>
                              <a:pt x="375297" y="1849545"/>
                            </a:cubicBezTo>
                            <a:cubicBezTo>
                              <a:pt x="-36181" y="1601747"/>
                              <a:pt x="-137214" y="919197"/>
                              <a:pt x="201341" y="429400"/>
                            </a:cubicBezTo>
                            <a:cubicBezTo>
                              <a:pt x="543005" y="-37876"/>
                              <a:pt x="1073332" y="-116634"/>
                              <a:pt x="1607040" y="162762"/>
                            </a:cubicBezTo>
                            <a:cubicBezTo>
                              <a:pt x="1509268" y="538806"/>
                              <a:pt x="1780134" y="1396963"/>
                              <a:pt x="1803791" y="1768980"/>
                            </a:cubicBezTo>
                            <a:close/>
                          </a:path>
                          <a:path w="2093069" h="2093176" stroke="0" extrusionOk="0">
                            <a:moveTo>
                              <a:pt x="1803791" y="1768980"/>
                            </a:moveTo>
                            <a:cubicBezTo>
                              <a:pt x="1382641" y="2169714"/>
                              <a:pt x="840673" y="2244848"/>
                              <a:pt x="375297" y="1849545"/>
                            </a:cubicBezTo>
                            <a:cubicBezTo>
                              <a:pt x="-9805" y="1573687"/>
                              <a:pt x="-122928" y="901273"/>
                              <a:pt x="201341" y="429400"/>
                            </a:cubicBezTo>
                            <a:cubicBezTo>
                              <a:pt x="511582" y="-38446"/>
                              <a:pt x="1203710" y="-57230"/>
                              <a:pt x="1607040" y="162762"/>
                            </a:cubicBezTo>
                            <a:cubicBezTo>
                              <a:pt x="1623981" y="744355"/>
                              <a:pt x="1869520" y="1418646"/>
                              <a:pt x="1803791" y="1768980"/>
                            </a:cubicBezTo>
                            <a:close/>
                          </a:path>
                        </a:pathLst>
                      </a:custGeom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7" name="弦形 186">
                <a:extLst>
                  <a:ext uri="{FF2B5EF4-FFF2-40B4-BE49-F238E27FC236}">
                    <a16:creationId xmlns:a16="http://schemas.microsoft.com/office/drawing/2014/main" id="{5140ADFF-C4D1-43AA-CAAC-2086513EA23F}"/>
                  </a:ext>
                </a:extLst>
              </p:cNvPr>
              <p:cNvSpPr/>
              <p:nvPr/>
            </p:nvSpPr>
            <p:spPr>
              <a:xfrm rot="6827173">
                <a:off x="3884507" y="2802835"/>
                <a:ext cx="2249184" cy="2207324"/>
              </a:xfrm>
              <a:prstGeom prst="chord">
                <a:avLst>
                  <a:gd name="adj1" fmla="val 5041728"/>
                  <a:gd name="adj2" fmla="val 13813942"/>
                </a:avLst>
              </a:prstGeom>
              <a:solidFill>
                <a:schemeClr val="bg1"/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 sd="2650216993">
                      <a:custGeom>
                        <a:avLst/>
                        <a:gdLst>
                          <a:gd name="connsiteX0" fmla="*/ 324478 w 2525819"/>
                          <a:gd name="connsiteY0" fmla="*/ 750107 h 4535284"/>
                          <a:gd name="connsiteX1" fmla="*/ 2113751 w 2525819"/>
                          <a:gd name="connsiteY1" fmla="*/ 591875 h 4535284"/>
                          <a:gd name="connsiteX2" fmla="*/ 324478 w 2525819"/>
                          <a:gd name="connsiteY2" fmla="*/ 750107 h 4535284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</a:cxnLst>
                        <a:rect l="l" t="t" r="r" b="b"/>
                        <a:pathLst>
                          <a:path w="2525819" h="4535284" fill="none" extrusionOk="0">
                            <a:moveTo>
                              <a:pt x="324478" y="750107"/>
                            </a:moveTo>
                            <a:cubicBezTo>
                              <a:pt x="720087" y="-294886"/>
                              <a:pt x="1676393" y="-158421"/>
                              <a:pt x="2113751" y="591875"/>
                            </a:cubicBezTo>
                            <a:cubicBezTo>
                              <a:pt x="1315736" y="794749"/>
                              <a:pt x="541424" y="700273"/>
                              <a:pt x="324478" y="750107"/>
                            </a:cubicBezTo>
                            <a:close/>
                          </a:path>
                          <a:path w="2525819" h="4535284" stroke="0" extrusionOk="0">
                            <a:moveTo>
                              <a:pt x="324478" y="750107"/>
                            </a:moveTo>
                            <a:cubicBezTo>
                              <a:pt x="724241" y="-181551"/>
                              <a:pt x="1616893" y="-235058"/>
                              <a:pt x="2113751" y="591875"/>
                            </a:cubicBezTo>
                            <a:cubicBezTo>
                              <a:pt x="1602322" y="711009"/>
                              <a:pt x="1027670" y="801337"/>
                              <a:pt x="324478" y="750107"/>
                            </a:cubicBezTo>
                            <a:close/>
                          </a:path>
                        </a:pathLst>
                      </a:custGeom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8" name="任意多边形: 形状 187">
                <a:extLst>
                  <a:ext uri="{FF2B5EF4-FFF2-40B4-BE49-F238E27FC236}">
                    <a16:creationId xmlns:a16="http://schemas.microsoft.com/office/drawing/2014/main" id="{ED383A85-A7CC-5C56-6036-1AE75DD6BF4C}"/>
                  </a:ext>
                </a:extLst>
              </p:cNvPr>
              <p:cNvSpPr/>
              <p:nvPr/>
            </p:nvSpPr>
            <p:spPr>
              <a:xfrm rot="19895928">
                <a:off x="3908837" y="3177922"/>
                <a:ext cx="778532" cy="232219"/>
              </a:xfrm>
              <a:custGeom>
                <a:avLst/>
                <a:gdLst>
                  <a:gd name="connsiteX0" fmla="*/ 14197 w 878978"/>
                  <a:gd name="connsiteY0" fmla="*/ 482458 h 491439"/>
                  <a:gd name="connsiteX1" fmla="*/ 49638 w 878978"/>
                  <a:gd name="connsiteY1" fmla="*/ 447016 h 491439"/>
                  <a:gd name="connsiteX2" fmla="*/ 70904 w 878978"/>
                  <a:gd name="connsiteY2" fmla="*/ 432839 h 491439"/>
                  <a:gd name="connsiteX3" fmla="*/ 85080 w 878978"/>
                  <a:gd name="connsiteY3" fmla="*/ 411574 h 491439"/>
                  <a:gd name="connsiteX4" fmla="*/ 148876 w 878978"/>
                  <a:gd name="connsiteY4" fmla="*/ 369044 h 491439"/>
                  <a:gd name="connsiteX5" fmla="*/ 191406 w 878978"/>
                  <a:gd name="connsiteY5" fmla="*/ 333602 h 491439"/>
                  <a:gd name="connsiteX6" fmla="*/ 233936 w 878978"/>
                  <a:gd name="connsiteY6" fmla="*/ 305248 h 491439"/>
                  <a:gd name="connsiteX7" fmla="*/ 255201 w 878978"/>
                  <a:gd name="connsiteY7" fmla="*/ 291072 h 491439"/>
                  <a:gd name="connsiteX8" fmla="*/ 311908 w 878978"/>
                  <a:gd name="connsiteY8" fmla="*/ 269806 h 491439"/>
                  <a:gd name="connsiteX9" fmla="*/ 333173 w 878978"/>
                  <a:gd name="connsiteY9" fmla="*/ 255630 h 491439"/>
                  <a:gd name="connsiteX10" fmla="*/ 354438 w 878978"/>
                  <a:gd name="connsiteY10" fmla="*/ 248541 h 491439"/>
                  <a:gd name="connsiteX11" fmla="*/ 382792 w 878978"/>
                  <a:gd name="connsiteY11" fmla="*/ 234365 h 491439"/>
                  <a:gd name="connsiteX12" fmla="*/ 404057 w 878978"/>
                  <a:gd name="connsiteY12" fmla="*/ 227276 h 491439"/>
                  <a:gd name="connsiteX13" fmla="*/ 460764 w 878978"/>
                  <a:gd name="connsiteY13" fmla="*/ 206011 h 491439"/>
                  <a:gd name="connsiteX14" fmla="*/ 489117 w 878978"/>
                  <a:gd name="connsiteY14" fmla="*/ 191834 h 491439"/>
                  <a:gd name="connsiteX15" fmla="*/ 510383 w 878978"/>
                  <a:gd name="connsiteY15" fmla="*/ 177658 h 491439"/>
                  <a:gd name="connsiteX16" fmla="*/ 545824 w 878978"/>
                  <a:gd name="connsiteY16" fmla="*/ 170569 h 491439"/>
                  <a:gd name="connsiteX17" fmla="*/ 567090 w 878978"/>
                  <a:gd name="connsiteY17" fmla="*/ 163481 h 491439"/>
                  <a:gd name="connsiteX18" fmla="*/ 652150 w 878978"/>
                  <a:gd name="connsiteY18" fmla="*/ 149304 h 491439"/>
                  <a:gd name="connsiteX19" fmla="*/ 701769 w 878978"/>
                  <a:gd name="connsiteY19" fmla="*/ 142216 h 491439"/>
                  <a:gd name="connsiteX20" fmla="*/ 730122 w 878978"/>
                  <a:gd name="connsiteY20" fmla="*/ 135127 h 491439"/>
                  <a:gd name="connsiteX21" fmla="*/ 793917 w 878978"/>
                  <a:gd name="connsiteY21" fmla="*/ 120951 h 491439"/>
                  <a:gd name="connsiteX22" fmla="*/ 822271 w 878978"/>
                  <a:gd name="connsiteY22" fmla="*/ 106774 h 491439"/>
                  <a:gd name="connsiteX23" fmla="*/ 843536 w 878978"/>
                  <a:gd name="connsiteY23" fmla="*/ 99686 h 491439"/>
                  <a:gd name="connsiteX24" fmla="*/ 878978 w 878978"/>
                  <a:gd name="connsiteY24" fmla="*/ 50067 h 491439"/>
                  <a:gd name="connsiteX25" fmla="*/ 871890 w 878978"/>
                  <a:gd name="connsiteY25" fmla="*/ 7537 h 491439"/>
                  <a:gd name="connsiteX26" fmla="*/ 850624 w 878978"/>
                  <a:gd name="connsiteY26" fmla="*/ 448 h 491439"/>
                  <a:gd name="connsiteX27" fmla="*/ 765564 w 878978"/>
                  <a:gd name="connsiteY27" fmla="*/ 28802 h 491439"/>
                  <a:gd name="connsiteX28" fmla="*/ 637973 w 878978"/>
                  <a:gd name="connsiteY28" fmla="*/ 42979 h 491439"/>
                  <a:gd name="connsiteX29" fmla="*/ 574178 w 878978"/>
                  <a:gd name="connsiteY29" fmla="*/ 57155 h 491439"/>
                  <a:gd name="connsiteX30" fmla="*/ 531648 w 878978"/>
                  <a:gd name="connsiteY30" fmla="*/ 71332 h 491439"/>
                  <a:gd name="connsiteX31" fmla="*/ 474941 w 878978"/>
                  <a:gd name="connsiteY31" fmla="*/ 99686 h 491439"/>
                  <a:gd name="connsiteX32" fmla="*/ 439499 w 878978"/>
                  <a:gd name="connsiteY32" fmla="*/ 113862 h 491439"/>
                  <a:gd name="connsiteX33" fmla="*/ 418234 w 878978"/>
                  <a:gd name="connsiteY33" fmla="*/ 120951 h 491439"/>
                  <a:gd name="connsiteX34" fmla="*/ 382792 w 878978"/>
                  <a:gd name="connsiteY34" fmla="*/ 142216 h 491439"/>
                  <a:gd name="connsiteX35" fmla="*/ 347350 w 878978"/>
                  <a:gd name="connsiteY35" fmla="*/ 156392 h 491439"/>
                  <a:gd name="connsiteX36" fmla="*/ 318997 w 878978"/>
                  <a:gd name="connsiteY36" fmla="*/ 177658 h 491439"/>
                  <a:gd name="connsiteX37" fmla="*/ 290643 w 878978"/>
                  <a:gd name="connsiteY37" fmla="*/ 184746 h 491439"/>
                  <a:gd name="connsiteX38" fmla="*/ 248113 w 878978"/>
                  <a:gd name="connsiteY38" fmla="*/ 198923 h 491439"/>
                  <a:gd name="connsiteX39" fmla="*/ 226848 w 878978"/>
                  <a:gd name="connsiteY39" fmla="*/ 206011 h 491439"/>
                  <a:gd name="connsiteX40" fmla="*/ 198494 w 878978"/>
                  <a:gd name="connsiteY40" fmla="*/ 220188 h 491439"/>
                  <a:gd name="connsiteX41" fmla="*/ 127611 w 878978"/>
                  <a:gd name="connsiteY41" fmla="*/ 262718 h 491439"/>
                  <a:gd name="connsiteX42" fmla="*/ 63815 w 878978"/>
                  <a:gd name="connsiteY42" fmla="*/ 291072 h 491439"/>
                  <a:gd name="connsiteX43" fmla="*/ 49638 w 878978"/>
                  <a:gd name="connsiteY43" fmla="*/ 312337 h 491439"/>
                  <a:gd name="connsiteX44" fmla="*/ 28373 w 878978"/>
                  <a:gd name="connsiteY44" fmla="*/ 326513 h 491439"/>
                  <a:gd name="connsiteX45" fmla="*/ 21285 w 878978"/>
                  <a:gd name="connsiteY45" fmla="*/ 354867 h 491439"/>
                  <a:gd name="connsiteX46" fmla="*/ 20 w 878978"/>
                  <a:gd name="connsiteY46" fmla="*/ 489546 h 491439"/>
                  <a:gd name="connsiteX47" fmla="*/ 14197 w 878978"/>
                  <a:gd name="connsiteY47" fmla="*/ 482458 h 4914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</a:cxnLst>
                <a:rect l="l" t="t" r="r" b="b"/>
                <a:pathLst>
                  <a:path w="878978" h="491439">
                    <a:moveTo>
                      <a:pt x="14197" y="482458"/>
                    </a:moveTo>
                    <a:cubicBezTo>
                      <a:pt x="22467" y="475370"/>
                      <a:pt x="37065" y="458018"/>
                      <a:pt x="49638" y="447016"/>
                    </a:cubicBezTo>
                    <a:cubicBezTo>
                      <a:pt x="56050" y="441406"/>
                      <a:pt x="64880" y="438863"/>
                      <a:pt x="70904" y="432839"/>
                    </a:cubicBezTo>
                    <a:cubicBezTo>
                      <a:pt x="76928" y="426815"/>
                      <a:pt x="79056" y="417598"/>
                      <a:pt x="85080" y="411574"/>
                    </a:cubicBezTo>
                    <a:cubicBezTo>
                      <a:pt x="111297" y="385356"/>
                      <a:pt x="119195" y="383883"/>
                      <a:pt x="148876" y="369044"/>
                    </a:cubicBezTo>
                    <a:cubicBezTo>
                      <a:pt x="172136" y="334153"/>
                      <a:pt x="151435" y="357585"/>
                      <a:pt x="191406" y="333602"/>
                    </a:cubicBezTo>
                    <a:cubicBezTo>
                      <a:pt x="206016" y="324836"/>
                      <a:pt x="219759" y="314699"/>
                      <a:pt x="233936" y="305248"/>
                    </a:cubicBezTo>
                    <a:cubicBezTo>
                      <a:pt x="241024" y="300523"/>
                      <a:pt x="247119" y="293766"/>
                      <a:pt x="255201" y="291072"/>
                    </a:cubicBezTo>
                    <a:cubicBezTo>
                      <a:pt x="273604" y="284937"/>
                      <a:pt x="294959" y="278281"/>
                      <a:pt x="311908" y="269806"/>
                    </a:cubicBezTo>
                    <a:cubicBezTo>
                      <a:pt x="319528" y="265996"/>
                      <a:pt x="325553" y="259440"/>
                      <a:pt x="333173" y="255630"/>
                    </a:cubicBezTo>
                    <a:cubicBezTo>
                      <a:pt x="339856" y="252288"/>
                      <a:pt x="347570" y="251484"/>
                      <a:pt x="354438" y="248541"/>
                    </a:cubicBezTo>
                    <a:cubicBezTo>
                      <a:pt x="364150" y="244379"/>
                      <a:pt x="373080" y="238527"/>
                      <a:pt x="382792" y="234365"/>
                    </a:cubicBezTo>
                    <a:cubicBezTo>
                      <a:pt x="389660" y="231422"/>
                      <a:pt x="397374" y="230618"/>
                      <a:pt x="404057" y="227276"/>
                    </a:cubicBezTo>
                    <a:cubicBezTo>
                      <a:pt x="452727" y="202940"/>
                      <a:pt x="392389" y="219685"/>
                      <a:pt x="460764" y="206011"/>
                    </a:cubicBezTo>
                    <a:cubicBezTo>
                      <a:pt x="470215" y="201285"/>
                      <a:pt x="479943" y="197076"/>
                      <a:pt x="489117" y="191834"/>
                    </a:cubicBezTo>
                    <a:cubicBezTo>
                      <a:pt x="496514" y="187607"/>
                      <a:pt x="502406" y="180649"/>
                      <a:pt x="510383" y="177658"/>
                    </a:cubicBezTo>
                    <a:cubicBezTo>
                      <a:pt x="521664" y="173428"/>
                      <a:pt x="534136" y="173491"/>
                      <a:pt x="545824" y="170569"/>
                    </a:cubicBezTo>
                    <a:cubicBezTo>
                      <a:pt x="553073" y="168757"/>
                      <a:pt x="559763" y="164946"/>
                      <a:pt x="567090" y="163481"/>
                    </a:cubicBezTo>
                    <a:cubicBezTo>
                      <a:pt x="595276" y="157844"/>
                      <a:pt x="623694" y="153369"/>
                      <a:pt x="652150" y="149304"/>
                    </a:cubicBezTo>
                    <a:cubicBezTo>
                      <a:pt x="668690" y="146941"/>
                      <a:pt x="685331" y="145205"/>
                      <a:pt x="701769" y="142216"/>
                    </a:cubicBezTo>
                    <a:cubicBezTo>
                      <a:pt x="711354" y="140473"/>
                      <a:pt x="720612" y="137240"/>
                      <a:pt x="730122" y="135127"/>
                    </a:cubicBezTo>
                    <a:cubicBezTo>
                      <a:pt x="811157" y="117119"/>
                      <a:pt x="724734" y="138246"/>
                      <a:pt x="793917" y="120951"/>
                    </a:cubicBezTo>
                    <a:cubicBezTo>
                      <a:pt x="803368" y="116225"/>
                      <a:pt x="812558" y="110936"/>
                      <a:pt x="822271" y="106774"/>
                    </a:cubicBezTo>
                    <a:cubicBezTo>
                      <a:pt x="829139" y="103831"/>
                      <a:pt x="837319" y="103831"/>
                      <a:pt x="843536" y="99686"/>
                    </a:cubicBezTo>
                    <a:cubicBezTo>
                      <a:pt x="865087" y="85318"/>
                      <a:pt x="867891" y="72239"/>
                      <a:pt x="878978" y="50067"/>
                    </a:cubicBezTo>
                    <a:cubicBezTo>
                      <a:pt x="876615" y="35890"/>
                      <a:pt x="879021" y="20016"/>
                      <a:pt x="871890" y="7537"/>
                    </a:cubicBezTo>
                    <a:cubicBezTo>
                      <a:pt x="868183" y="1049"/>
                      <a:pt x="857951" y="-1017"/>
                      <a:pt x="850624" y="448"/>
                    </a:cubicBezTo>
                    <a:cubicBezTo>
                      <a:pt x="821317" y="6309"/>
                      <a:pt x="794871" y="22941"/>
                      <a:pt x="765564" y="28802"/>
                    </a:cubicBezTo>
                    <a:cubicBezTo>
                      <a:pt x="699913" y="41931"/>
                      <a:pt x="742134" y="34966"/>
                      <a:pt x="637973" y="42979"/>
                    </a:cubicBezTo>
                    <a:cubicBezTo>
                      <a:pt x="617740" y="47025"/>
                      <a:pt x="594197" y="51149"/>
                      <a:pt x="574178" y="57155"/>
                    </a:cubicBezTo>
                    <a:cubicBezTo>
                      <a:pt x="559865" y="61449"/>
                      <a:pt x="545014" y="64649"/>
                      <a:pt x="531648" y="71332"/>
                    </a:cubicBezTo>
                    <a:cubicBezTo>
                      <a:pt x="512746" y="80783"/>
                      <a:pt x="494563" y="91838"/>
                      <a:pt x="474941" y="99686"/>
                    </a:cubicBezTo>
                    <a:cubicBezTo>
                      <a:pt x="463127" y="104411"/>
                      <a:pt x="451413" y="109394"/>
                      <a:pt x="439499" y="113862"/>
                    </a:cubicBezTo>
                    <a:cubicBezTo>
                      <a:pt x="432503" y="116486"/>
                      <a:pt x="424917" y="117609"/>
                      <a:pt x="418234" y="120951"/>
                    </a:cubicBezTo>
                    <a:cubicBezTo>
                      <a:pt x="405911" y="127113"/>
                      <a:pt x="395115" y="136055"/>
                      <a:pt x="382792" y="142216"/>
                    </a:cubicBezTo>
                    <a:cubicBezTo>
                      <a:pt x="371411" y="147906"/>
                      <a:pt x="358473" y="150213"/>
                      <a:pt x="347350" y="156392"/>
                    </a:cubicBezTo>
                    <a:cubicBezTo>
                      <a:pt x="337023" y="162129"/>
                      <a:pt x="329564" y="172375"/>
                      <a:pt x="318997" y="177658"/>
                    </a:cubicBezTo>
                    <a:cubicBezTo>
                      <a:pt x="310283" y="182015"/>
                      <a:pt x="299974" y="181947"/>
                      <a:pt x="290643" y="184746"/>
                    </a:cubicBezTo>
                    <a:cubicBezTo>
                      <a:pt x="276330" y="189040"/>
                      <a:pt x="262290" y="194197"/>
                      <a:pt x="248113" y="198923"/>
                    </a:cubicBezTo>
                    <a:cubicBezTo>
                      <a:pt x="241025" y="201286"/>
                      <a:pt x="233531" y="202670"/>
                      <a:pt x="226848" y="206011"/>
                    </a:cubicBezTo>
                    <a:cubicBezTo>
                      <a:pt x="217397" y="210737"/>
                      <a:pt x="207669" y="214945"/>
                      <a:pt x="198494" y="220188"/>
                    </a:cubicBezTo>
                    <a:cubicBezTo>
                      <a:pt x="174570" y="233859"/>
                      <a:pt x="153195" y="252484"/>
                      <a:pt x="127611" y="262718"/>
                    </a:cubicBezTo>
                    <a:cubicBezTo>
                      <a:pt x="82358" y="280820"/>
                      <a:pt x="103550" y="271205"/>
                      <a:pt x="63815" y="291072"/>
                    </a:cubicBezTo>
                    <a:cubicBezTo>
                      <a:pt x="59089" y="298160"/>
                      <a:pt x="55662" y="306313"/>
                      <a:pt x="49638" y="312337"/>
                    </a:cubicBezTo>
                    <a:cubicBezTo>
                      <a:pt x="43614" y="318361"/>
                      <a:pt x="33098" y="319425"/>
                      <a:pt x="28373" y="326513"/>
                    </a:cubicBezTo>
                    <a:cubicBezTo>
                      <a:pt x="22969" y="334619"/>
                      <a:pt x="23326" y="345341"/>
                      <a:pt x="21285" y="354867"/>
                    </a:cubicBezTo>
                    <a:cubicBezTo>
                      <a:pt x="7345" y="419919"/>
                      <a:pt x="5832" y="425610"/>
                      <a:pt x="20" y="489546"/>
                    </a:cubicBezTo>
                    <a:cubicBezTo>
                      <a:pt x="-408" y="494252"/>
                      <a:pt x="5927" y="489546"/>
                      <a:pt x="14197" y="482458"/>
                    </a:cubicBez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9" name="弦形 188">
                <a:extLst>
                  <a:ext uri="{FF2B5EF4-FFF2-40B4-BE49-F238E27FC236}">
                    <a16:creationId xmlns:a16="http://schemas.microsoft.com/office/drawing/2014/main" id="{652D3C9A-B779-DB6C-7F39-D4B712F7E477}"/>
                  </a:ext>
                </a:extLst>
              </p:cNvPr>
              <p:cNvSpPr/>
              <p:nvPr/>
            </p:nvSpPr>
            <p:spPr>
              <a:xfrm rot="16230941">
                <a:off x="4001558" y="2807961"/>
                <a:ext cx="2035573" cy="1970251"/>
              </a:xfrm>
              <a:prstGeom prst="chord">
                <a:avLst>
                  <a:gd name="adj1" fmla="val 4630590"/>
                  <a:gd name="adj2" fmla="val 17068392"/>
                </a:avLst>
              </a:prstGeom>
              <a:solidFill>
                <a:schemeClr val="bg1"/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 sd="2650216993">
                      <a:custGeom>
                        <a:avLst/>
                        <a:gdLst>
                          <a:gd name="connsiteX0" fmla="*/ 1559077 w 2035574"/>
                          <a:gd name="connsiteY0" fmla="*/ 1819381 h 1970252"/>
                          <a:gd name="connsiteX1" fmla="*/ 237534 w 2035574"/>
                          <a:gd name="connsiteY1" fmla="*/ 1617680 h 1970252"/>
                          <a:gd name="connsiteX2" fmla="*/ 308825 w 2035574"/>
                          <a:gd name="connsiteY2" fmla="*/ 278311 h 1970252"/>
                          <a:gd name="connsiteX3" fmla="*/ 1643676 w 2035574"/>
                          <a:gd name="connsiteY3" fmla="*/ 208290 h 1970252"/>
                          <a:gd name="connsiteX4" fmla="*/ 1559077 w 2035574"/>
                          <a:gd name="connsiteY4" fmla="*/ 1819381 h 1970252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  <a:cxn ang="0">
                            <a:pos x="connsiteX3" y="connsiteY3"/>
                          </a:cxn>
                          <a:cxn ang="0">
                            <a:pos x="connsiteX4" y="connsiteY4"/>
                          </a:cxn>
                        </a:cxnLst>
                        <a:rect l="l" t="t" r="r" b="b"/>
                        <a:pathLst>
                          <a:path w="2035574" h="1970252" fill="none" extrusionOk="0">
                            <a:moveTo>
                              <a:pt x="1559077" y="1819381"/>
                            </a:moveTo>
                            <a:cubicBezTo>
                              <a:pt x="1172742" y="2084463"/>
                              <a:pt x="612428" y="2079584"/>
                              <a:pt x="237534" y="1617680"/>
                            </a:cubicBezTo>
                            <a:cubicBezTo>
                              <a:pt x="-98182" y="1282943"/>
                              <a:pt x="-79329" y="656410"/>
                              <a:pt x="308825" y="278311"/>
                            </a:cubicBezTo>
                            <a:cubicBezTo>
                              <a:pt x="710775" y="-114000"/>
                              <a:pt x="1164939" y="-75835"/>
                              <a:pt x="1643676" y="208290"/>
                            </a:cubicBezTo>
                            <a:cubicBezTo>
                              <a:pt x="1502622" y="427177"/>
                              <a:pt x="1597850" y="1030499"/>
                              <a:pt x="1559077" y="1819381"/>
                            </a:cubicBezTo>
                            <a:close/>
                          </a:path>
                          <a:path w="2035574" h="1970252" stroke="0" extrusionOk="0">
                            <a:moveTo>
                              <a:pt x="1559077" y="1819381"/>
                            </a:moveTo>
                            <a:cubicBezTo>
                              <a:pt x="1077467" y="2083365"/>
                              <a:pt x="608568" y="2038779"/>
                              <a:pt x="237534" y="1617680"/>
                            </a:cubicBezTo>
                            <a:cubicBezTo>
                              <a:pt x="-99076" y="1233836"/>
                              <a:pt x="-72184" y="684421"/>
                              <a:pt x="308825" y="278311"/>
                            </a:cubicBezTo>
                            <a:cubicBezTo>
                              <a:pt x="641724" y="-111953"/>
                              <a:pt x="1289774" y="-37608"/>
                              <a:pt x="1643676" y="208290"/>
                            </a:cubicBezTo>
                            <a:cubicBezTo>
                              <a:pt x="1471668" y="923832"/>
                              <a:pt x="1490613" y="1204762"/>
                              <a:pt x="1559077" y="1819381"/>
                            </a:cubicBezTo>
                            <a:close/>
                          </a:path>
                        </a:pathLst>
                      </a:custGeom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0" name="任意多边形: 形状 189">
                <a:extLst>
                  <a:ext uri="{FF2B5EF4-FFF2-40B4-BE49-F238E27FC236}">
                    <a16:creationId xmlns:a16="http://schemas.microsoft.com/office/drawing/2014/main" id="{6C03076B-B9AA-54F8-BD6D-BAFEDFE5051E}"/>
                  </a:ext>
                </a:extLst>
              </p:cNvPr>
              <p:cNvSpPr/>
              <p:nvPr/>
            </p:nvSpPr>
            <p:spPr>
              <a:xfrm rot="20789710" flipH="1">
                <a:off x="3983876" y="3319148"/>
                <a:ext cx="693463" cy="339142"/>
              </a:xfrm>
              <a:custGeom>
                <a:avLst/>
                <a:gdLst>
                  <a:gd name="connsiteX0" fmla="*/ 1007663 w 1036016"/>
                  <a:gd name="connsiteY0" fmla="*/ 333153 h 894628"/>
                  <a:gd name="connsiteX1" fmla="*/ 936779 w 1036016"/>
                  <a:gd name="connsiteY1" fmla="*/ 290623 h 894628"/>
                  <a:gd name="connsiteX2" fmla="*/ 887160 w 1036016"/>
                  <a:gd name="connsiteY2" fmla="*/ 276446 h 894628"/>
                  <a:gd name="connsiteX3" fmla="*/ 844630 w 1036016"/>
                  <a:gd name="connsiteY3" fmla="*/ 262270 h 894628"/>
                  <a:gd name="connsiteX4" fmla="*/ 802100 w 1036016"/>
                  <a:gd name="connsiteY4" fmla="*/ 248093 h 894628"/>
                  <a:gd name="connsiteX5" fmla="*/ 773746 w 1036016"/>
                  <a:gd name="connsiteY5" fmla="*/ 241004 h 894628"/>
                  <a:gd name="connsiteX6" fmla="*/ 752481 w 1036016"/>
                  <a:gd name="connsiteY6" fmla="*/ 226828 h 894628"/>
                  <a:gd name="connsiteX7" fmla="*/ 688686 w 1036016"/>
                  <a:gd name="connsiteY7" fmla="*/ 205563 h 894628"/>
                  <a:gd name="connsiteX8" fmla="*/ 667421 w 1036016"/>
                  <a:gd name="connsiteY8" fmla="*/ 191386 h 894628"/>
                  <a:gd name="connsiteX9" fmla="*/ 589449 w 1036016"/>
                  <a:gd name="connsiteY9" fmla="*/ 155944 h 894628"/>
                  <a:gd name="connsiteX10" fmla="*/ 525653 w 1036016"/>
                  <a:gd name="connsiteY10" fmla="*/ 120502 h 894628"/>
                  <a:gd name="connsiteX11" fmla="*/ 468946 w 1036016"/>
                  <a:gd name="connsiteY11" fmla="*/ 85060 h 894628"/>
                  <a:gd name="connsiteX12" fmla="*/ 440593 w 1036016"/>
                  <a:gd name="connsiteY12" fmla="*/ 63795 h 894628"/>
                  <a:gd name="connsiteX13" fmla="*/ 419328 w 1036016"/>
                  <a:gd name="connsiteY13" fmla="*/ 56707 h 894628"/>
                  <a:gd name="connsiteX14" fmla="*/ 362621 w 1036016"/>
                  <a:gd name="connsiteY14" fmla="*/ 35442 h 894628"/>
                  <a:gd name="connsiteX15" fmla="*/ 341356 w 1036016"/>
                  <a:gd name="connsiteY15" fmla="*/ 28353 h 894628"/>
                  <a:gd name="connsiteX16" fmla="*/ 298825 w 1036016"/>
                  <a:gd name="connsiteY16" fmla="*/ 0 h 894628"/>
                  <a:gd name="connsiteX17" fmla="*/ 8202 w 1036016"/>
                  <a:gd name="connsiteY17" fmla="*/ 7088 h 894628"/>
                  <a:gd name="connsiteX18" fmla="*/ 1114 w 1036016"/>
                  <a:gd name="connsiteY18" fmla="*/ 28353 h 894628"/>
                  <a:gd name="connsiteX19" fmla="*/ 22379 w 1036016"/>
                  <a:gd name="connsiteY19" fmla="*/ 42530 h 894628"/>
                  <a:gd name="connsiteX20" fmla="*/ 50732 w 1036016"/>
                  <a:gd name="connsiteY20" fmla="*/ 49618 h 894628"/>
                  <a:gd name="connsiteX21" fmla="*/ 100351 w 1036016"/>
                  <a:gd name="connsiteY21" fmla="*/ 63795 h 894628"/>
                  <a:gd name="connsiteX22" fmla="*/ 128705 w 1036016"/>
                  <a:gd name="connsiteY22" fmla="*/ 77972 h 894628"/>
                  <a:gd name="connsiteX23" fmla="*/ 178323 w 1036016"/>
                  <a:gd name="connsiteY23" fmla="*/ 120502 h 894628"/>
                  <a:gd name="connsiteX24" fmla="*/ 220853 w 1036016"/>
                  <a:gd name="connsiteY24" fmla="*/ 155944 h 894628"/>
                  <a:gd name="connsiteX25" fmla="*/ 284649 w 1036016"/>
                  <a:gd name="connsiteY25" fmla="*/ 191386 h 894628"/>
                  <a:gd name="connsiteX26" fmla="*/ 327179 w 1036016"/>
                  <a:gd name="connsiteY26" fmla="*/ 219739 h 894628"/>
                  <a:gd name="connsiteX27" fmla="*/ 376798 w 1036016"/>
                  <a:gd name="connsiteY27" fmla="*/ 269358 h 894628"/>
                  <a:gd name="connsiteX28" fmla="*/ 412239 w 1036016"/>
                  <a:gd name="connsiteY28" fmla="*/ 297711 h 894628"/>
                  <a:gd name="connsiteX29" fmla="*/ 426416 w 1036016"/>
                  <a:gd name="connsiteY29" fmla="*/ 326065 h 894628"/>
                  <a:gd name="connsiteX30" fmla="*/ 468946 w 1036016"/>
                  <a:gd name="connsiteY30" fmla="*/ 375684 h 894628"/>
                  <a:gd name="connsiteX31" fmla="*/ 476035 w 1036016"/>
                  <a:gd name="connsiteY31" fmla="*/ 396949 h 894628"/>
                  <a:gd name="connsiteX32" fmla="*/ 497300 w 1036016"/>
                  <a:gd name="connsiteY32" fmla="*/ 439479 h 894628"/>
                  <a:gd name="connsiteX33" fmla="*/ 532742 w 1036016"/>
                  <a:gd name="connsiteY33" fmla="*/ 517451 h 894628"/>
                  <a:gd name="connsiteX34" fmla="*/ 539830 w 1036016"/>
                  <a:gd name="connsiteY34" fmla="*/ 545804 h 894628"/>
                  <a:gd name="connsiteX35" fmla="*/ 575272 w 1036016"/>
                  <a:gd name="connsiteY35" fmla="*/ 602511 h 894628"/>
                  <a:gd name="connsiteX36" fmla="*/ 589449 w 1036016"/>
                  <a:gd name="connsiteY36" fmla="*/ 652130 h 894628"/>
                  <a:gd name="connsiteX37" fmla="*/ 603625 w 1036016"/>
                  <a:gd name="connsiteY37" fmla="*/ 673395 h 894628"/>
                  <a:gd name="connsiteX38" fmla="*/ 617802 w 1036016"/>
                  <a:gd name="connsiteY38" fmla="*/ 730102 h 894628"/>
                  <a:gd name="connsiteX39" fmla="*/ 624891 w 1036016"/>
                  <a:gd name="connsiteY39" fmla="*/ 772632 h 894628"/>
                  <a:gd name="connsiteX40" fmla="*/ 631979 w 1036016"/>
                  <a:gd name="connsiteY40" fmla="*/ 822251 h 894628"/>
                  <a:gd name="connsiteX41" fmla="*/ 639067 w 1036016"/>
                  <a:gd name="connsiteY41" fmla="*/ 843516 h 894628"/>
                  <a:gd name="connsiteX42" fmla="*/ 646156 w 1036016"/>
                  <a:gd name="connsiteY42" fmla="*/ 893135 h 894628"/>
                  <a:gd name="connsiteX43" fmla="*/ 653244 w 1036016"/>
                  <a:gd name="connsiteY43" fmla="*/ 864781 h 894628"/>
                  <a:gd name="connsiteX44" fmla="*/ 674509 w 1036016"/>
                  <a:gd name="connsiteY44" fmla="*/ 822251 h 894628"/>
                  <a:gd name="connsiteX45" fmla="*/ 695774 w 1036016"/>
                  <a:gd name="connsiteY45" fmla="*/ 800986 h 894628"/>
                  <a:gd name="connsiteX46" fmla="*/ 717039 w 1036016"/>
                  <a:gd name="connsiteY46" fmla="*/ 772632 h 894628"/>
                  <a:gd name="connsiteX47" fmla="*/ 731216 w 1036016"/>
                  <a:gd name="connsiteY47" fmla="*/ 751367 h 894628"/>
                  <a:gd name="connsiteX48" fmla="*/ 787923 w 1036016"/>
                  <a:gd name="connsiteY48" fmla="*/ 701749 h 894628"/>
                  <a:gd name="connsiteX49" fmla="*/ 858807 w 1036016"/>
                  <a:gd name="connsiteY49" fmla="*/ 645042 h 894628"/>
                  <a:gd name="connsiteX50" fmla="*/ 887160 w 1036016"/>
                  <a:gd name="connsiteY50" fmla="*/ 616688 h 894628"/>
                  <a:gd name="connsiteX51" fmla="*/ 901337 w 1036016"/>
                  <a:gd name="connsiteY51" fmla="*/ 595423 h 894628"/>
                  <a:gd name="connsiteX52" fmla="*/ 929691 w 1036016"/>
                  <a:gd name="connsiteY52" fmla="*/ 559981 h 894628"/>
                  <a:gd name="connsiteX53" fmla="*/ 943867 w 1036016"/>
                  <a:gd name="connsiteY53" fmla="*/ 538716 h 894628"/>
                  <a:gd name="connsiteX54" fmla="*/ 965132 w 1036016"/>
                  <a:gd name="connsiteY54" fmla="*/ 524539 h 894628"/>
                  <a:gd name="connsiteX55" fmla="*/ 1014751 w 1036016"/>
                  <a:gd name="connsiteY55" fmla="*/ 474921 h 894628"/>
                  <a:gd name="connsiteX56" fmla="*/ 1036016 w 1036016"/>
                  <a:gd name="connsiteY56" fmla="*/ 453656 h 894628"/>
                  <a:gd name="connsiteX57" fmla="*/ 1028928 w 1036016"/>
                  <a:gd name="connsiteY57" fmla="*/ 411125 h 894628"/>
                  <a:gd name="connsiteX58" fmla="*/ 1007663 w 1036016"/>
                  <a:gd name="connsiteY58" fmla="*/ 333153 h 8946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</a:cxnLst>
                <a:rect l="l" t="t" r="r" b="b"/>
                <a:pathLst>
                  <a:path w="1036016" h="894628">
                    <a:moveTo>
                      <a:pt x="1007663" y="333153"/>
                    </a:moveTo>
                    <a:cubicBezTo>
                      <a:pt x="992305" y="313069"/>
                      <a:pt x="963273" y="298193"/>
                      <a:pt x="936779" y="290623"/>
                    </a:cubicBezTo>
                    <a:cubicBezTo>
                      <a:pt x="920239" y="285897"/>
                      <a:pt x="903601" y="281505"/>
                      <a:pt x="887160" y="276446"/>
                    </a:cubicBezTo>
                    <a:cubicBezTo>
                      <a:pt x="872877" y="272051"/>
                      <a:pt x="858807" y="266995"/>
                      <a:pt x="844630" y="262270"/>
                    </a:cubicBezTo>
                    <a:cubicBezTo>
                      <a:pt x="830453" y="257544"/>
                      <a:pt x="816597" y="251718"/>
                      <a:pt x="802100" y="248093"/>
                    </a:cubicBezTo>
                    <a:lnTo>
                      <a:pt x="773746" y="241004"/>
                    </a:lnTo>
                    <a:cubicBezTo>
                      <a:pt x="766658" y="236279"/>
                      <a:pt x="760311" y="230184"/>
                      <a:pt x="752481" y="226828"/>
                    </a:cubicBezTo>
                    <a:cubicBezTo>
                      <a:pt x="657738" y="186224"/>
                      <a:pt x="803763" y="263100"/>
                      <a:pt x="688686" y="205563"/>
                    </a:cubicBezTo>
                    <a:cubicBezTo>
                      <a:pt x="681066" y="201753"/>
                      <a:pt x="675041" y="195196"/>
                      <a:pt x="667421" y="191386"/>
                    </a:cubicBezTo>
                    <a:cubicBezTo>
                      <a:pt x="610378" y="162864"/>
                      <a:pt x="651936" y="193436"/>
                      <a:pt x="589449" y="155944"/>
                    </a:cubicBezTo>
                    <a:cubicBezTo>
                      <a:pt x="522016" y="115485"/>
                      <a:pt x="603189" y="151517"/>
                      <a:pt x="525653" y="120502"/>
                    </a:cubicBezTo>
                    <a:cubicBezTo>
                      <a:pt x="483051" y="77900"/>
                      <a:pt x="529358" y="118622"/>
                      <a:pt x="468946" y="85060"/>
                    </a:cubicBezTo>
                    <a:cubicBezTo>
                      <a:pt x="458619" y="79323"/>
                      <a:pt x="450850" y="69656"/>
                      <a:pt x="440593" y="63795"/>
                    </a:cubicBezTo>
                    <a:cubicBezTo>
                      <a:pt x="434106" y="60088"/>
                      <a:pt x="426196" y="59650"/>
                      <a:pt x="419328" y="56707"/>
                    </a:cubicBezTo>
                    <a:cubicBezTo>
                      <a:pt x="353249" y="28388"/>
                      <a:pt x="427972" y="54114"/>
                      <a:pt x="362621" y="35442"/>
                    </a:cubicBezTo>
                    <a:cubicBezTo>
                      <a:pt x="355437" y="33389"/>
                      <a:pt x="347888" y="31982"/>
                      <a:pt x="341356" y="28353"/>
                    </a:cubicBezTo>
                    <a:cubicBezTo>
                      <a:pt x="326462" y="20078"/>
                      <a:pt x="298825" y="0"/>
                      <a:pt x="298825" y="0"/>
                    </a:cubicBezTo>
                    <a:cubicBezTo>
                      <a:pt x="201951" y="2363"/>
                      <a:pt x="104669" y="-2099"/>
                      <a:pt x="8202" y="7088"/>
                    </a:cubicBezTo>
                    <a:cubicBezTo>
                      <a:pt x="764" y="7796"/>
                      <a:pt x="-1661" y="21416"/>
                      <a:pt x="1114" y="28353"/>
                    </a:cubicBezTo>
                    <a:cubicBezTo>
                      <a:pt x="4278" y="36263"/>
                      <a:pt x="14549" y="39174"/>
                      <a:pt x="22379" y="42530"/>
                    </a:cubicBezTo>
                    <a:cubicBezTo>
                      <a:pt x="31333" y="46368"/>
                      <a:pt x="41365" y="46942"/>
                      <a:pt x="50732" y="49618"/>
                    </a:cubicBezTo>
                    <a:cubicBezTo>
                      <a:pt x="121915" y="69956"/>
                      <a:pt x="11719" y="41638"/>
                      <a:pt x="100351" y="63795"/>
                    </a:cubicBezTo>
                    <a:cubicBezTo>
                      <a:pt x="109802" y="68521"/>
                      <a:pt x="120753" y="71014"/>
                      <a:pt x="128705" y="77972"/>
                    </a:cubicBezTo>
                    <a:cubicBezTo>
                      <a:pt x="184586" y="126868"/>
                      <a:pt x="131415" y="104867"/>
                      <a:pt x="178323" y="120502"/>
                    </a:cubicBezTo>
                    <a:cubicBezTo>
                      <a:pt x="254319" y="171167"/>
                      <a:pt x="138977" y="92263"/>
                      <a:pt x="220853" y="155944"/>
                    </a:cubicBezTo>
                    <a:cubicBezTo>
                      <a:pt x="257414" y="184381"/>
                      <a:pt x="252564" y="180691"/>
                      <a:pt x="284649" y="191386"/>
                    </a:cubicBezTo>
                    <a:cubicBezTo>
                      <a:pt x="298826" y="200837"/>
                      <a:pt x="314172" y="208733"/>
                      <a:pt x="327179" y="219739"/>
                    </a:cubicBezTo>
                    <a:cubicBezTo>
                      <a:pt x="345035" y="234848"/>
                      <a:pt x="358533" y="254746"/>
                      <a:pt x="376798" y="269358"/>
                    </a:cubicBezTo>
                    <a:lnTo>
                      <a:pt x="412239" y="297711"/>
                    </a:lnTo>
                    <a:cubicBezTo>
                      <a:pt x="416965" y="307162"/>
                      <a:pt x="420076" y="317612"/>
                      <a:pt x="426416" y="326065"/>
                    </a:cubicBezTo>
                    <a:cubicBezTo>
                      <a:pt x="452585" y="360957"/>
                      <a:pt x="452589" y="342968"/>
                      <a:pt x="468946" y="375684"/>
                    </a:cubicBezTo>
                    <a:cubicBezTo>
                      <a:pt x="472287" y="382367"/>
                      <a:pt x="473000" y="390121"/>
                      <a:pt x="476035" y="396949"/>
                    </a:cubicBezTo>
                    <a:cubicBezTo>
                      <a:pt x="482472" y="411433"/>
                      <a:pt x="491204" y="424848"/>
                      <a:pt x="497300" y="439479"/>
                    </a:cubicBezTo>
                    <a:cubicBezTo>
                      <a:pt x="530998" y="520352"/>
                      <a:pt x="489808" y="445894"/>
                      <a:pt x="532742" y="517451"/>
                    </a:cubicBezTo>
                    <a:cubicBezTo>
                      <a:pt x="535105" y="526902"/>
                      <a:pt x="536409" y="536682"/>
                      <a:pt x="539830" y="545804"/>
                    </a:cubicBezTo>
                    <a:cubicBezTo>
                      <a:pt x="549560" y="571751"/>
                      <a:pt x="558545" y="580209"/>
                      <a:pt x="575272" y="602511"/>
                    </a:cubicBezTo>
                    <a:cubicBezTo>
                      <a:pt x="577545" y="611603"/>
                      <a:pt x="584362" y="641956"/>
                      <a:pt x="589449" y="652130"/>
                    </a:cubicBezTo>
                    <a:cubicBezTo>
                      <a:pt x="593259" y="659750"/>
                      <a:pt x="598900" y="666307"/>
                      <a:pt x="603625" y="673395"/>
                    </a:cubicBezTo>
                    <a:cubicBezTo>
                      <a:pt x="608351" y="692297"/>
                      <a:pt x="614599" y="710883"/>
                      <a:pt x="617802" y="730102"/>
                    </a:cubicBezTo>
                    <a:cubicBezTo>
                      <a:pt x="620165" y="744279"/>
                      <a:pt x="622706" y="758427"/>
                      <a:pt x="624891" y="772632"/>
                    </a:cubicBezTo>
                    <a:cubicBezTo>
                      <a:pt x="627432" y="789145"/>
                      <a:pt x="628703" y="805868"/>
                      <a:pt x="631979" y="822251"/>
                    </a:cubicBezTo>
                    <a:cubicBezTo>
                      <a:pt x="633444" y="829578"/>
                      <a:pt x="636704" y="836428"/>
                      <a:pt x="639067" y="843516"/>
                    </a:cubicBezTo>
                    <a:cubicBezTo>
                      <a:pt x="641430" y="860056"/>
                      <a:pt x="636888" y="879234"/>
                      <a:pt x="646156" y="893135"/>
                    </a:cubicBezTo>
                    <a:cubicBezTo>
                      <a:pt x="651560" y="901241"/>
                      <a:pt x="650568" y="874148"/>
                      <a:pt x="653244" y="864781"/>
                    </a:cubicBezTo>
                    <a:cubicBezTo>
                      <a:pt x="658804" y="845321"/>
                      <a:pt x="661001" y="838460"/>
                      <a:pt x="674509" y="822251"/>
                    </a:cubicBezTo>
                    <a:cubicBezTo>
                      <a:pt x="680927" y="814550"/>
                      <a:pt x="689250" y="808597"/>
                      <a:pt x="695774" y="800986"/>
                    </a:cubicBezTo>
                    <a:cubicBezTo>
                      <a:pt x="703462" y="792016"/>
                      <a:pt x="710172" y="782246"/>
                      <a:pt x="717039" y="772632"/>
                    </a:cubicBezTo>
                    <a:cubicBezTo>
                      <a:pt x="721991" y="765700"/>
                      <a:pt x="725762" y="757912"/>
                      <a:pt x="731216" y="751367"/>
                    </a:cubicBezTo>
                    <a:cubicBezTo>
                      <a:pt x="752424" y="725917"/>
                      <a:pt x="760884" y="726534"/>
                      <a:pt x="787923" y="701749"/>
                    </a:cubicBezTo>
                    <a:cubicBezTo>
                      <a:pt x="850669" y="644232"/>
                      <a:pt x="812846" y="660362"/>
                      <a:pt x="858807" y="645042"/>
                    </a:cubicBezTo>
                    <a:cubicBezTo>
                      <a:pt x="874271" y="598647"/>
                      <a:pt x="852793" y="644182"/>
                      <a:pt x="887160" y="616688"/>
                    </a:cubicBezTo>
                    <a:cubicBezTo>
                      <a:pt x="893812" y="611366"/>
                      <a:pt x="896225" y="602238"/>
                      <a:pt x="901337" y="595423"/>
                    </a:cubicBezTo>
                    <a:cubicBezTo>
                      <a:pt x="910415" y="583320"/>
                      <a:pt x="920613" y="572085"/>
                      <a:pt x="929691" y="559981"/>
                    </a:cubicBezTo>
                    <a:cubicBezTo>
                      <a:pt x="934802" y="553166"/>
                      <a:pt x="937843" y="544740"/>
                      <a:pt x="943867" y="538716"/>
                    </a:cubicBezTo>
                    <a:cubicBezTo>
                      <a:pt x="949891" y="532692"/>
                      <a:pt x="958800" y="530238"/>
                      <a:pt x="965132" y="524539"/>
                    </a:cubicBezTo>
                    <a:cubicBezTo>
                      <a:pt x="982518" y="508892"/>
                      <a:pt x="998211" y="491460"/>
                      <a:pt x="1014751" y="474921"/>
                    </a:cubicBezTo>
                    <a:lnTo>
                      <a:pt x="1036016" y="453656"/>
                    </a:lnTo>
                    <a:cubicBezTo>
                      <a:pt x="1033653" y="439479"/>
                      <a:pt x="1031939" y="425178"/>
                      <a:pt x="1028928" y="411125"/>
                    </a:cubicBezTo>
                    <a:cubicBezTo>
                      <a:pt x="1014178" y="342291"/>
                      <a:pt x="1023021" y="353237"/>
                      <a:pt x="1007663" y="333153"/>
                    </a:cubicBezTo>
                    <a:close/>
                  </a:path>
                </a:pathLst>
              </a:custGeom>
              <a:solidFill>
                <a:schemeClr val="bg1"/>
              </a:solidFill>
              <a:ln w="3175">
                <a:solidFill>
                  <a:srgbClr val="E7DAD2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1" name="任意多边形: 形状 190">
                <a:extLst>
                  <a:ext uri="{FF2B5EF4-FFF2-40B4-BE49-F238E27FC236}">
                    <a16:creationId xmlns:a16="http://schemas.microsoft.com/office/drawing/2014/main" id="{6144A9DA-B4C0-F847-A56B-D2FED6BBDC52}"/>
                  </a:ext>
                </a:extLst>
              </p:cNvPr>
              <p:cNvSpPr/>
              <p:nvPr/>
            </p:nvSpPr>
            <p:spPr>
              <a:xfrm rot="1048711">
                <a:off x="5378390" y="3318507"/>
                <a:ext cx="605349" cy="461929"/>
              </a:xfrm>
              <a:custGeom>
                <a:avLst/>
                <a:gdLst>
                  <a:gd name="connsiteX0" fmla="*/ 1007663 w 1036016"/>
                  <a:gd name="connsiteY0" fmla="*/ 333153 h 894628"/>
                  <a:gd name="connsiteX1" fmla="*/ 936779 w 1036016"/>
                  <a:gd name="connsiteY1" fmla="*/ 290623 h 894628"/>
                  <a:gd name="connsiteX2" fmla="*/ 887160 w 1036016"/>
                  <a:gd name="connsiteY2" fmla="*/ 276446 h 894628"/>
                  <a:gd name="connsiteX3" fmla="*/ 844630 w 1036016"/>
                  <a:gd name="connsiteY3" fmla="*/ 262270 h 894628"/>
                  <a:gd name="connsiteX4" fmla="*/ 802100 w 1036016"/>
                  <a:gd name="connsiteY4" fmla="*/ 248093 h 894628"/>
                  <a:gd name="connsiteX5" fmla="*/ 773746 w 1036016"/>
                  <a:gd name="connsiteY5" fmla="*/ 241004 h 894628"/>
                  <a:gd name="connsiteX6" fmla="*/ 752481 w 1036016"/>
                  <a:gd name="connsiteY6" fmla="*/ 226828 h 894628"/>
                  <a:gd name="connsiteX7" fmla="*/ 688686 w 1036016"/>
                  <a:gd name="connsiteY7" fmla="*/ 205563 h 894628"/>
                  <a:gd name="connsiteX8" fmla="*/ 667421 w 1036016"/>
                  <a:gd name="connsiteY8" fmla="*/ 191386 h 894628"/>
                  <a:gd name="connsiteX9" fmla="*/ 589449 w 1036016"/>
                  <a:gd name="connsiteY9" fmla="*/ 155944 h 894628"/>
                  <a:gd name="connsiteX10" fmla="*/ 525653 w 1036016"/>
                  <a:gd name="connsiteY10" fmla="*/ 120502 h 894628"/>
                  <a:gd name="connsiteX11" fmla="*/ 468946 w 1036016"/>
                  <a:gd name="connsiteY11" fmla="*/ 85060 h 894628"/>
                  <a:gd name="connsiteX12" fmla="*/ 440593 w 1036016"/>
                  <a:gd name="connsiteY12" fmla="*/ 63795 h 894628"/>
                  <a:gd name="connsiteX13" fmla="*/ 419328 w 1036016"/>
                  <a:gd name="connsiteY13" fmla="*/ 56707 h 894628"/>
                  <a:gd name="connsiteX14" fmla="*/ 362621 w 1036016"/>
                  <a:gd name="connsiteY14" fmla="*/ 35442 h 894628"/>
                  <a:gd name="connsiteX15" fmla="*/ 341356 w 1036016"/>
                  <a:gd name="connsiteY15" fmla="*/ 28353 h 894628"/>
                  <a:gd name="connsiteX16" fmla="*/ 298825 w 1036016"/>
                  <a:gd name="connsiteY16" fmla="*/ 0 h 894628"/>
                  <a:gd name="connsiteX17" fmla="*/ 8202 w 1036016"/>
                  <a:gd name="connsiteY17" fmla="*/ 7088 h 894628"/>
                  <a:gd name="connsiteX18" fmla="*/ 1114 w 1036016"/>
                  <a:gd name="connsiteY18" fmla="*/ 28353 h 894628"/>
                  <a:gd name="connsiteX19" fmla="*/ 22379 w 1036016"/>
                  <a:gd name="connsiteY19" fmla="*/ 42530 h 894628"/>
                  <a:gd name="connsiteX20" fmla="*/ 50732 w 1036016"/>
                  <a:gd name="connsiteY20" fmla="*/ 49618 h 894628"/>
                  <a:gd name="connsiteX21" fmla="*/ 100351 w 1036016"/>
                  <a:gd name="connsiteY21" fmla="*/ 63795 h 894628"/>
                  <a:gd name="connsiteX22" fmla="*/ 128705 w 1036016"/>
                  <a:gd name="connsiteY22" fmla="*/ 77972 h 894628"/>
                  <a:gd name="connsiteX23" fmla="*/ 178323 w 1036016"/>
                  <a:gd name="connsiteY23" fmla="*/ 120502 h 894628"/>
                  <a:gd name="connsiteX24" fmla="*/ 220853 w 1036016"/>
                  <a:gd name="connsiteY24" fmla="*/ 155944 h 894628"/>
                  <a:gd name="connsiteX25" fmla="*/ 284649 w 1036016"/>
                  <a:gd name="connsiteY25" fmla="*/ 191386 h 894628"/>
                  <a:gd name="connsiteX26" fmla="*/ 327179 w 1036016"/>
                  <a:gd name="connsiteY26" fmla="*/ 219739 h 894628"/>
                  <a:gd name="connsiteX27" fmla="*/ 376798 w 1036016"/>
                  <a:gd name="connsiteY27" fmla="*/ 269358 h 894628"/>
                  <a:gd name="connsiteX28" fmla="*/ 412239 w 1036016"/>
                  <a:gd name="connsiteY28" fmla="*/ 297711 h 894628"/>
                  <a:gd name="connsiteX29" fmla="*/ 426416 w 1036016"/>
                  <a:gd name="connsiteY29" fmla="*/ 326065 h 894628"/>
                  <a:gd name="connsiteX30" fmla="*/ 468946 w 1036016"/>
                  <a:gd name="connsiteY30" fmla="*/ 375684 h 894628"/>
                  <a:gd name="connsiteX31" fmla="*/ 476035 w 1036016"/>
                  <a:gd name="connsiteY31" fmla="*/ 396949 h 894628"/>
                  <a:gd name="connsiteX32" fmla="*/ 497300 w 1036016"/>
                  <a:gd name="connsiteY32" fmla="*/ 439479 h 894628"/>
                  <a:gd name="connsiteX33" fmla="*/ 532742 w 1036016"/>
                  <a:gd name="connsiteY33" fmla="*/ 517451 h 894628"/>
                  <a:gd name="connsiteX34" fmla="*/ 539830 w 1036016"/>
                  <a:gd name="connsiteY34" fmla="*/ 545804 h 894628"/>
                  <a:gd name="connsiteX35" fmla="*/ 575272 w 1036016"/>
                  <a:gd name="connsiteY35" fmla="*/ 602511 h 894628"/>
                  <a:gd name="connsiteX36" fmla="*/ 589449 w 1036016"/>
                  <a:gd name="connsiteY36" fmla="*/ 652130 h 894628"/>
                  <a:gd name="connsiteX37" fmla="*/ 603625 w 1036016"/>
                  <a:gd name="connsiteY37" fmla="*/ 673395 h 894628"/>
                  <a:gd name="connsiteX38" fmla="*/ 617802 w 1036016"/>
                  <a:gd name="connsiteY38" fmla="*/ 730102 h 894628"/>
                  <a:gd name="connsiteX39" fmla="*/ 624891 w 1036016"/>
                  <a:gd name="connsiteY39" fmla="*/ 772632 h 894628"/>
                  <a:gd name="connsiteX40" fmla="*/ 631979 w 1036016"/>
                  <a:gd name="connsiteY40" fmla="*/ 822251 h 894628"/>
                  <a:gd name="connsiteX41" fmla="*/ 639067 w 1036016"/>
                  <a:gd name="connsiteY41" fmla="*/ 843516 h 894628"/>
                  <a:gd name="connsiteX42" fmla="*/ 646156 w 1036016"/>
                  <a:gd name="connsiteY42" fmla="*/ 893135 h 894628"/>
                  <a:gd name="connsiteX43" fmla="*/ 653244 w 1036016"/>
                  <a:gd name="connsiteY43" fmla="*/ 864781 h 894628"/>
                  <a:gd name="connsiteX44" fmla="*/ 674509 w 1036016"/>
                  <a:gd name="connsiteY44" fmla="*/ 822251 h 894628"/>
                  <a:gd name="connsiteX45" fmla="*/ 695774 w 1036016"/>
                  <a:gd name="connsiteY45" fmla="*/ 800986 h 894628"/>
                  <a:gd name="connsiteX46" fmla="*/ 717039 w 1036016"/>
                  <a:gd name="connsiteY46" fmla="*/ 772632 h 894628"/>
                  <a:gd name="connsiteX47" fmla="*/ 731216 w 1036016"/>
                  <a:gd name="connsiteY47" fmla="*/ 751367 h 894628"/>
                  <a:gd name="connsiteX48" fmla="*/ 787923 w 1036016"/>
                  <a:gd name="connsiteY48" fmla="*/ 701749 h 894628"/>
                  <a:gd name="connsiteX49" fmla="*/ 858807 w 1036016"/>
                  <a:gd name="connsiteY49" fmla="*/ 645042 h 894628"/>
                  <a:gd name="connsiteX50" fmla="*/ 887160 w 1036016"/>
                  <a:gd name="connsiteY50" fmla="*/ 616688 h 894628"/>
                  <a:gd name="connsiteX51" fmla="*/ 901337 w 1036016"/>
                  <a:gd name="connsiteY51" fmla="*/ 595423 h 894628"/>
                  <a:gd name="connsiteX52" fmla="*/ 929691 w 1036016"/>
                  <a:gd name="connsiteY52" fmla="*/ 559981 h 894628"/>
                  <a:gd name="connsiteX53" fmla="*/ 943867 w 1036016"/>
                  <a:gd name="connsiteY53" fmla="*/ 538716 h 894628"/>
                  <a:gd name="connsiteX54" fmla="*/ 965132 w 1036016"/>
                  <a:gd name="connsiteY54" fmla="*/ 524539 h 894628"/>
                  <a:gd name="connsiteX55" fmla="*/ 1014751 w 1036016"/>
                  <a:gd name="connsiteY55" fmla="*/ 474921 h 894628"/>
                  <a:gd name="connsiteX56" fmla="*/ 1036016 w 1036016"/>
                  <a:gd name="connsiteY56" fmla="*/ 453656 h 894628"/>
                  <a:gd name="connsiteX57" fmla="*/ 1028928 w 1036016"/>
                  <a:gd name="connsiteY57" fmla="*/ 411125 h 894628"/>
                  <a:gd name="connsiteX58" fmla="*/ 1007663 w 1036016"/>
                  <a:gd name="connsiteY58" fmla="*/ 333153 h 89462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</a:cxnLst>
                <a:rect l="l" t="t" r="r" b="b"/>
                <a:pathLst>
                  <a:path w="1036016" h="894628">
                    <a:moveTo>
                      <a:pt x="1007663" y="333153"/>
                    </a:moveTo>
                    <a:cubicBezTo>
                      <a:pt x="992305" y="313069"/>
                      <a:pt x="963273" y="298193"/>
                      <a:pt x="936779" y="290623"/>
                    </a:cubicBezTo>
                    <a:cubicBezTo>
                      <a:pt x="920239" y="285897"/>
                      <a:pt x="903601" y="281505"/>
                      <a:pt x="887160" y="276446"/>
                    </a:cubicBezTo>
                    <a:cubicBezTo>
                      <a:pt x="872877" y="272051"/>
                      <a:pt x="858807" y="266995"/>
                      <a:pt x="844630" y="262270"/>
                    </a:cubicBezTo>
                    <a:cubicBezTo>
                      <a:pt x="830453" y="257544"/>
                      <a:pt x="816597" y="251718"/>
                      <a:pt x="802100" y="248093"/>
                    </a:cubicBezTo>
                    <a:lnTo>
                      <a:pt x="773746" y="241004"/>
                    </a:lnTo>
                    <a:cubicBezTo>
                      <a:pt x="766658" y="236279"/>
                      <a:pt x="760311" y="230184"/>
                      <a:pt x="752481" y="226828"/>
                    </a:cubicBezTo>
                    <a:cubicBezTo>
                      <a:pt x="657738" y="186224"/>
                      <a:pt x="803763" y="263100"/>
                      <a:pt x="688686" y="205563"/>
                    </a:cubicBezTo>
                    <a:cubicBezTo>
                      <a:pt x="681066" y="201753"/>
                      <a:pt x="675041" y="195196"/>
                      <a:pt x="667421" y="191386"/>
                    </a:cubicBezTo>
                    <a:cubicBezTo>
                      <a:pt x="610378" y="162864"/>
                      <a:pt x="651936" y="193436"/>
                      <a:pt x="589449" y="155944"/>
                    </a:cubicBezTo>
                    <a:cubicBezTo>
                      <a:pt x="522016" y="115485"/>
                      <a:pt x="603189" y="151517"/>
                      <a:pt x="525653" y="120502"/>
                    </a:cubicBezTo>
                    <a:cubicBezTo>
                      <a:pt x="483051" y="77900"/>
                      <a:pt x="529358" y="118622"/>
                      <a:pt x="468946" y="85060"/>
                    </a:cubicBezTo>
                    <a:cubicBezTo>
                      <a:pt x="458619" y="79323"/>
                      <a:pt x="450850" y="69656"/>
                      <a:pt x="440593" y="63795"/>
                    </a:cubicBezTo>
                    <a:cubicBezTo>
                      <a:pt x="434106" y="60088"/>
                      <a:pt x="426196" y="59650"/>
                      <a:pt x="419328" y="56707"/>
                    </a:cubicBezTo>
                    <a:cubicBezTo>
                      <a:pt x="353249" y="28388"/>
                      <a:pt x="427972" y="54114"/>
                      <a:pt x="362621" y="35442"/>
                    </a:cubicBezTo>
                    <a:cubicBezTo>
                      <a:pt x="355437" y="33389"/>
                      <a:pt x="347888" y="31982"/>
                      <a:pt x="341356" y="28353"/>
                    </a:cubicBezTo>
                    <a:cubicBezTo>
                      <a:pt x="326462" y="20078"/>
                      <a:pt x="298825" y="0"/>
                      <a:pt x="298825" y="0"/>
                    </a:cubicBezTo>
                    <a:cubicBezTo>
                      <a:pt x="201951" y="2363"/>
                      <a:pt x="104669" y="-2099"/>
                      <a:pt x="8202" y="7088"/>
                    </a:cubicBezTo>
                    <a:cubicBezTo>
                      <a:pt x="764" y="7796"/>
                      <a:pt x="-1661" y="21416"/>
                      <a:pt x="1114" y="28353"/>
                    </a:cubicBezTo>
                    <a:cubicBezTo>
                      <a:pt x="4278" y="36263"/>
                      <a:pt x="14549" y="39174"/>
                      <a:pt x="22379" y="42530"/>
                    </a:cubicBezTo>
                    <a:cubicBezTo>
                      <a:pt x="31333" y="46368"/>
                      <a:pt x="41365" y="46942"/>
                      <a:pt x="50732" y="49618"/>
                    </a:cubicBezTo>
                    <a:cubicBezTo>
                      <a:pt x="121915" y="69956"/>
                      <a:pt x="11719" y="41638"/>
                      <a:pt x="100351" y="63795"/>
                    </a:cubicBezTo>
                    <a:cubicBezTo>
                      <a:pt x="109802" y="68521"/>
                      <a:pt x="120753" y="71014"/>
                      <a:pt x="128705" y="77972"/>
                    </a:cubicBezTo>
                    <a:cubicBezTo>
                      <a:pt x="184586" y="126868"/>
                      <a:pt x="131415" y="104867"/>
                      <a:pt x="178323" y="120502"/>
                    </a:cubicBezTo>
                    <a:cubicBezTo>
                      <a:pt x="254319" y="171167"/>
                      <a:pt x="138977" y="92263"/>
                      <a:pt x="220853" y="155944"/>
                    </a:cubicBezTo>
                    <a:cubicBezTo>
                      <a:pt x="257414" y="184381"/>
                      <a:pt x="252564" y="180691"/>
                      <a:pt x="284649" y="191386"/>
                    </a:cubicBezTo>
                    <a:cubicBezTo>
                      <a:pt x="298826" y="200837"/>
                      <a:pt x="314172" y="208733"/>
                      <a:pt x="327179" y="219739"/>
                    </a:cubicBezTo>
                    <a:cubicBezTo>
                      <a:pt x="345035" y="234848"/>
                      <a:pt x="358533" y="254746"/>
                      <a:pt x="376798" y="269358"/>
                    </a:cubicBezTo>
                    <a:lnTo>
                      <a:pt x="412239" y="297711"/>
                    </a:lnTo>
                    <a:cubicBezTo>
                      <a:pt x="416965" y="307162"/>
                      <a:pt x="420076" y="317612"/>
                      <a:pt x="426416" y="326065"/>
                    </a:cubicBezTo>
                    <a:cubicBezTo>
                      <a:pt x="452585" y="360957"/>
                      <a:pt x="452589" y="342968"/>
                      <a:pt x="468946" y="375684"/>
                    </a:cubicBezTo>
                    <a:cubicBezTo>
                      <a:pt x="472287" y="382367"/>
                      <a:pt x="473000" y="390121"/>
                      <a:pt x="476035" y="396949"/>
                    </a:cubicBezTo>
                    <a:cubicBezTo>
                      <a:pt x="482472" y="411433"/>
                      <a:pt x="491204" y="424848"/>
                      <a:pt x="497300" y="439479"/>
                    </a:cubicBezTo>
                    <a:cubicBezTo>
                      <a:pt x="530998" y="520352"/>
                      <a:pt x="489808" y="445894"/>
                      <a:pt x="532742" y="517451"/>
                    </a:cubicBezTo>
                    <a:cubicBezTo>
                      <a:pt x="535105" y="526902"/>
                      <a:pt x="536409" y="536682"/>
                      <a:pt x="539830" y="545804"/>
                    </a:cubicBezTo>
                    <a:cubicBezTo>
                      <a:pt x="549560" y="571751"/>
                      <a:pt x="558545" y="580209"/>
                      <a:pt x="575272" y="602511"/>
                    </a:cubicBezTo>
                    <a:cubicBezTo>
                      <a:pt x="577545" y="611603"/>
                      <a:pt x="584362" y="641956"/>
                      <a:pt x="589449" y="652130"/>
                    </a:cubicBezTo>
                    <a:cubicBezTo>
                      <a:pt x="593259" y="659750"/>
                      <a:pt x="598900" y="666307"/>
                      <a:pt x="603625" y="673395"/>
                    </a:cubicBezTo>
                    <a:cubicBezTo>
                      <a:pt x="608351" y="692297"/>
                      <a:pt x="614599" y="710883"/>
                      <a:pt x="617802" y="730102"/>
                    </a:cubicBezTo>
                    <a:cubicBezTo>
                      <a:pt x="620165" y="744279"/>
                      <a:pt x="622706" y="758427"/>
                      <a:pt x="624891" y="772632"/>
                    </a:cubicBezTo>
                    <a:cubicBezTo>
                      <a:pt x="627432" y="789145"/>
                      <a:pt x="628703" y="805868"/>
                      <a:pt x="631979" y="822251"/>
                    </a:cubicBezTo>
                    <a:cubicBezTo>
                      <a:pt x="633444" y="829578"/>
                      <a:pt x="636704" y="836428"/>
                      <a:pt x="639067" y="843516"/>
                    </a:cubicBezTo>
                    <a:cubicBezTo>
                      <a:pt x="641430" y="860056"/>
                      <a:pt x="636888" y="879234"/>
                      <a:pt x="646156" y="893135"/>
                    </a:cubicBezTo>
                    <a:cubicBezTo>
                      <a:pt x="651560" y="901241"/>
                      <a:pt x="650568" y="874148"/>
                      <a:pt x="653244" y="864781"/>
                    </a:cubicBezTo>
                    <a:cubicBezTo>
                      <a:pt x="658804" y="845321"/>
                      <a:pt x="661001" y="838460"/>
                      <a:pt x="674509" y="822251"/>
                    </a:cubicBezTo>
                    <a:cubicBezTo>
                      <a:pt x="680927" y="814550"/>
                      <a:pt x="689250" y="808597"/>
                      <a:pt x="695774" y="800986"/>
                    </a:cubicBezTo>
                    <a:cubicBezTo>
                      <a:pt x="703462" y="792016"/>
                      <a:pt x="710172" y="782246"/>
                      <a:pt x="717039" y="772632"/>
                    </a:cubicBezTo>
                    <a:cubicBezTo>
                      <a:pt x="721991" y="765700"/>
                      <a:pt x="725762" y="757912"/>
                      <a:pt x="731216" y="751367"/>
                    </a:cubicBezTo>
                    <a:cubicBezTo>
                      <a:pt x="752424" y="725917"/>
                      <a:pt x="760884" y="726534"/>
                      <a:pt x="787923" y="701749"/>
                    </a:cubicBezTo>
                    <a:cubicBezTo>
                      <a:pt x="850669" y="644232"/>
                      <a:pt x="812846" y="660362"/>
                      <a:pt x="858807" y="645042"/>
                    </a:cubicBezTo>
                    <a:cubicBezTo>
                      <a:pt x="874271" y="598647"/>
                      <a:pt x="852793" y="644182"/>
                      <a:pt x="887160" y="616688"/>
                    </a:cubicBezTo>
                    <a:cubicBezTo>
                      <a:pt x="893812" y="611366"/>
                      <a:pt x="896225" y="602238"/>
                      <a:pt x="901337" y="595423"/>
                    </a:cubicBezTo>
                    <a:cubicBezTo>
                      <a:pt x="910415" y="583320"/>
                      <a:pt x="920613" y="572085"/>
                      <a:pt x="929691" y="559981"/>
                    </a:cubicBezTo>
                    <a:cubicBezTo>
                      <a:pt x="934802" y="553166"/>
                      <a:pt x="937843" y="544740"/>
                      <a:pt x="943867" y="538716"/>
                    </a:cubicBezTo>
                    <a:cubicBezTo>
                      <a:pt x="949891" y="532692"/>
                      <a:pt x="958800" y="530238"/>
                      <a:pt x="965132" y="524539"/>
                    </a:cubicBezTo>
                    <a:cubicBezTo>
                      <a:pt x="982518" y="508892"/>
                      <a:pt x="998211" y="491460"/>
                      <a:pt x="1014751" y="474921"/>
                    </a:cubicBezTo>
                    <a:lnTo>
                      <a:pt x="1036016" y="453656"/>
                    </a:lnTo>
                    <a:cubicBezTo>
                      <a:pt x="1033653" y="439479"/>
                      <a:pt x="1031939" y="425178"/>
                      <a:pt x="1028928" y="411125"/>
                    </a:cubicBezTo>
                    <a:cubicBezTo>
                      <a:pt x="1014178" y="342291"/>
                      <a:pt x="1023021" y="353237"/>
                      <a:pt x="1007663" y="333153"/>
                    </a:cubicBezTo>
                    <a:close/>
                  </a:path>
                </a:pathLst>
              </a:custGeom>
              <a:solidFill>
                <a:schemeClr val="bg1"/>
              </a:solidFill>
              <a:ln w="3175">
                <a:solidFill>
                  <a:srgbClr val="E7DAD2"/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2" name="椭圆 191">
                <a:extLst>
                  <a:ext uri="{FF2B5EF4-FFF2-40B4-BE49-F238E27FC236}">
                    <a16:creationId xmlns:a16="http://schemas.microsoft.com/office/drawing/2014/main" id="{77CB8F00-E046-3DD1-9032-1DA3B1660704}"/>
                  </a:ext>
                </a:extLst>
              </p:cNvPr>
              <p:cNvSpPr/>
              <p:nvPr/>
            </p:nvSpPr>
            <p:spPr>
              <a:xfrm rot="21572790">
                <a:off x="4254645" y="3079880"/>
                <a:ext cx="1520679" cy="1113879"/>
              </a:xfrm>
              <a:prstGeom prst="ellipse">
                <a:avLst/>
              </a:prstGeom>
              <a:solidFill>
                <a:schemeClr val="bg2"/>
              </a:solidFill>
              <a:ln w="3175">
                <a:solidFill>
                  <a:schemeClr val="bg1">
                    <a:lumMod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3" name="任意多边形: 形状 192">
                <a:extLst>
                  <a:ext uri="{FF2B5EF4-FFF2-40B4-BE49-F238E27FC236}">
                    <a16:creationId xmlns:a16="http://schemas.microsoft.com/office/drawing/2014/main" id="{5A0270A8-D8B0-C5C0-D2B8-E80A9B22B6FE}"/>
                  </a:ext>
                </a:extLst>
              </p:cNvPr>
              <p:cNvSpPr/>
              <p:nvPr/>
            </p:nvSpPr>
            <p:spPr>
              <a:xfrm rot="1934030" flipH="1">
                <a:off x="5350500" y="3179080"/>
                <a:ext cx="778531" cy="222988"/>
              </a:xfrm>
              <a:custGeom>
                <a:avLst/>
                <a:gdLst>
                  <a:gd name="connsiteX0" fmla="*/ 14197 w 878978"/>
                  <a:gd name="connsiteY0" fmla="*/ 482458 h 491439"/>
                  <a:gd name="connsiteX1" fmla="*/ 49638 w 878978"/>
                  <a:gd name="connsiteY1" fmla="*/ 447016 h 491439"/>
                  <a:gd name="connsiteX2" fmla="*/ 70904 w 878978"/>
                  <a:gd name="connsiteY2" fmla="*/ 432839 h 491439"/>
                  <a:gd name="connsiteX3" fmla="*/ 85080 w 878978"/>
                  <a:gd name="connsiteY3" fmla="*/ 411574 h 491439"/>
                  <a:gd name="connsiteX4" fmla="*/ 148876 w 878978"/>
                  <a:gd name="connsiteY4" fmla="*/ 369044 h 491439"/>
                  <a:gd name="connsiteX5" fmla="*/ 191406 w 878978"/>
                  <a:gd name="connsiteY5" fmla="*/ 333602 h 491439"/>
                  <a:gd name="connsiteX6" fmla="*/ 233936 w 878978"/>
                  <a:gd name="connsiteY6" fmla="*/ 305248 h 491439"/>
                  <a:gd name="connsiteX7" fmla="*/ 255201 w 878978"/>
                  <a:gd name="connsiteY7" fmla="*/ 291072 h 491439"/>
                  <a:gd name="connsiteX8" fmla="*/ 311908 w 878978"/>
                  <a:gd name="connsiteY8" fmla="*/ 269806 h 491439"/>
                  <a:gd name="connsiteX9" fmla="*/ 333173 w 878978"/>
                  <a:gd name="connsiteY9" fmla="*/ 255630 h 491439"/>
                  <a:gd name="connsiteX10" fmla="*/ 354438 w 878978"/>
                  <a:gd name="connsiteY10" fmla="*/ 248541 h 491439"/>
                  <a:gd name="connsiteX11" fmla="*/ 382792 w 878978"/>
                  <a:gd name="connsiteY11" fmla="*/ 234365 h 491439"/>
                  <a:gd name="connsiteX12" fmla="*/ 404057 w 878978"/>
                  <a:gd name="connsiteY12" fmla="*/ 227276 h 491439"/>
                  <a:gd name="connsiteX13" fmla="*/ 460764 w 878978"/>
                  <a:gd name="connsiteY13" fmla="*/ 206011 h 491439"/>
                  <a:gd name="connsiteX14" fmla="*/ 489117 w 878978"/>
                  <a:gd name="connsiteY14" fmla="*/ 191834 h 491439"/>
                  <a:gd name="connsiteX15" fmla="*/ 510383 w 878978"/>
                  <a:gd name="connsiteY15" fmla="*/ 177658 h 491439"/>
                  <a:gd name="connsiteX16" fmla="*/ 545824 w 878978"/>
                  <a:gd name="connsiteY16" fmla="*/ 170569 h 491439"/>
                  <a:gd name="connsiteX17" fmla="*/ 567090 w 878978"/>
                  <a:gd name="connsiteY17" fmla="*/ 163481 h 491439"/>
                  <a:gd name="connsiteX18" fmla="*/ 652150 w 878978"/>
                  <a:gd name="connsiteY18" fmla="*/ 149304 h 491439"/>
                  <a:gd name="connsiteX19" fmla="*/ 701769 w 878978"/>
                  <a:gd name="connsiteY19" fmla="*/ 142216 h 491439"/>
                  <a:gd name="connsiteX20" fmla="*/ 730122 w 878978"/>
                  <a:gd name="connsiteY20" fmla="*/ 135127 h 491439"/>
                  <a:gd name="connsiteX21" fmla="*/ 793917 w 878978"/>
                  <a:gd name="connsiteY21" fmla="*/ 120951 h 491439"/>
                  <a:gd name="connsiteX22" fmla="*/ 822271 w 878978"/>
                  <a:gd name="connsiteY22" fmla="*/ 106774 h 491439"/>
                  <a:gd name="connsiteX23" fmla="*/ 843536 w 878978"/>
                  <a:gd name="connsiteY23" fmla="*/ 99686 h 491439"/>
                  <a:gd name="connsiteX24" fmla="*/ 878978 w 878978"/>
                  <a:gd name="connsiteY24" fmla="*/ 50067 h 491439"/>
                  <a:gd name="connsiteX25" fmla="*/ 871890 w 878978"/>
                  <a:gd name="connsiteY25" fmla="*/ 7537 h 491439"/>
                  <a:gd name="connsiteX26" fmla="*/ 850624 w 878978"/>
                  <a:gd name="connsiteY26" fmla="*/ 448 h 491439"/>
                  <a:gd name="connsiteX27" fmla="*/ 765564 w 878978"/>
                  <a:gd name="connsiteY27" fmla="*/ 28802 h 491439"/>
                  <a:gd name="connsiteX28" fmla="*/ 637973 w 878978"/>
                  <a:gd name="connsiteY28" fmla="*/ 42979 h 491439"/>
                  <a:gd name="connsiteX29" fmla="*/ 574178 w 878978"/>
                  <a:gd name="connsiteY29" fmla="*/ 57155 h 491439"/>
                  <a:gd name="connsiteX30" fmla="*/ 531648 w 878978"/>
                  <a:gd name="connsiteY30" fmla="*/ 71332 h 491439"/>
                  <a:gd name="connsiteX31" fmla="*/ 474941 w 878978"/>
                  <a:gd name="connsiteY31" fmla="*/ 99686 h 491439"/>
                  <a:gd name="connsiteX32" fmla="*/ 439499 w 878978"/>
                  <a:gd name="connsiteY32" fmla="*/ 113862 h 491439"/>
                  <a:gd name="connsiteX33" fmla="*/ 418234 w 878978"/>
                  <a:gd name="connsiteY33" fmla="*/ 120951 h 491439"/>
                  <a:gd name="connsiteX34" fmla="*/ 382792 w 878978"/>
                  <a:gd name="connsiteY34" fmla="*/ 142216 h 491439"/>
                  <a:gd name="connsiteX35" fmla="*/ 347350 w 878978"/>
                  <a:gd name="connsiteY35" fmla="*/ 156392 h 491439"/>
                  <a:gd name="connsiteX36" fmla="*/ 318997 w 878978"/>
                  <a:gd name="connsiteY36" fmla="*/ 177658 h 491439"/>
                  <a:gd name="connsiteX37" fmla="*/ 290643 w 878978"/>
                  <a:gd name="connsiteY37" fmla="*/ 184746 h 491439"/>
                  <a:gd name="connsiteX38" fmla="*/ 248113 w 878978"/>
                  <a:gd name="connsiteY38" fmla="*/ 198923 h 491439"/>
                  <a:gd name="connsiteX39" fmla="*/ 226848 w 878978"/>
                  <a:gd name="connsiteY39" fmla="*/ 206011 h 491439"/>
                  <a:gd name="connsiteX40" fmla="*/ 198494 w 878978"/>
                  <a:gd name="connsiteY40" fmla="*/ 220188 h 491439"/>
                  <a:gd name="connsiteX41" fmla="*/ 127611 w 878978"/>
                  <a:gd name="connsiteY41" fmla="*/ 262718 h 491439"/>
                  <a:gd name="connsiteX42" fmla="*/ 63815 w 878978"/>
                  <a:gd name="connsiteY42" fmla="*/ 291072 h 491439"/>
                  <a:gd name="connsiteX43" fmla="*/ 49638 w 878978"/>
                  <a:gd name="connsiteY43" fmla="*/ 312337 h 491439"/>
                  <a:gd name="connsiteX44" fmla="*/ 28373 w 878978"/>
                  <a:gd name="connsiteY44" fmla="*/ 326513 h 491439"/>
                  <a:gd name="connsiteX45" fmla="*/ 21285 w 878978"/>
                  <a:gd name="connsiteY45" fmla="*/ 354867 h 491439"/>
                  <a:gd name="connsiteX46" fmla="*/ 20 w 878978"/>
                  <a:gd name="connsiteY46" fmla="*/ 489546 h 491439"/>
                  <a:gd name="connsiteX47" fmla="*/ 14197 w 878978"/>
                  <a:gd name="connsiteY47" fmla="*/ 482458 h 4914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</a:cxnLst>
                <a:rect l="l" t="t" r="r" b="b"/>
                <a:pathLst>
                  <a:path w="878978" h="491439">
                    <a:moveTo>
                      <a:pt x="14197" y="482458"/>
                    </a:moveTo>
                    <a:cubicBezTo>
                      <a:pt x="22467" y="475370"/>
                      <a:pt x="37065" y="458018"/>
                      <a:pt x="49638" y="447016"/>
                    </a:cubicBezTo>
                    <a:cubicBezTo>
                      <a:pt x="56050" y="441406"/>
                      <a:pt x="64880" y="438863"/>
                      <a:pt x="70904" y="432839"/>
                    </a:cubicBezTo>
                    <a:cubicBezTo>
                      <a:pt x="76928" y="426815"/>
                      <a:pt x="79056" y="417598"/>
                      <a:pt x="85080" y="411574"/>
                    </a:cubicBezTo>
                    <a:cubicBezTo>
                      <a:pt x="111297" y="385356"/>
                      <a:pt x="119195" y="383883"/>
                      <a:pt x="148876" y="369044"/>
                    </a:cubicBezTo>
                    <a:cubicBezTo>
                      <a:pt x="172136" y="334153"/>
                      <a:pt x="151435" y="357585"/>
                      <a:pt x="191406" y="333602"/>
                    </a:cubicBezTo>
                    <a:cubicBezTo>
                      <a:pt x="206016" y="324836"/>
                      <a:pt x="219759" y="314699"/>
                      <a:pt x="233936" y="305248"/>
                    </a:cubicBezTo>
                    <a:cubicBezTo>
                      <a:pt x="241024" y="300523"/>
                      <a:pt x="247119" y="293766"/>
                      <a:pt x="255201" y="291072"/>
                    </a:cubicBezTo>
                    <a:cubicBezTo>
                      <a:pt x="273604" y="284937"/>
                      <a:pt x="294959" y="278281"/>
                      <a:pt x="311908" y="269806"/>
                    </a:cubicBezTo>
                    <a:cubicBezTo>
                      <a:pt x="319528" y="265996"/>
                      <a:pt x="325553" y="259440"/>
                      <a:pt x="333173" y="255630"/>
                    </a:cubicBezTo>
                    <a:cubicBezTo>
                      <a:pt x="339856" y="252288"/>
                      <a:pt x="347570" y="251484"/>
                      <a:pt x="354438" y="248541"/>
                    </a:cubicBezTo>
                    <a:cubicBezTo>
                      <a:pt x="364150" y="244379"/>
                      <a:pt x="373080" y="238527"/>
                      <a:pt x="382792" y="234365"/>
                    </a:cubicBezTo>
                    <a:cubicBezTo>
                      <a:pt x="389660" y="231422"/>
                      <a:pt x="397374" y="230618"/>
                      <a:pt x="404057" y="227276"/>
                    </a:cubicBezTo>
                    <a:cubicBezTo>
                      <a:pt x="452727" y="202940"/>
                      <a:pt x="392389" y="219685"/>
                      <a:pt x="460764" y="206011"/>
                    </a:cubicBezTo>
                    <a:cubicBezTo>
                      <a:pt x="470215" y="201285"/>
                      <a:pt x="479943" y="197076"/>
                      <a:pt x="489117" y="191834"/>
                    </a:cubicBezTo>
                    <a:cubicBezTo>
                      <a:pt x="496514" y="187607"/>
                      <a:pt x="502406" y="180649"/>
                      <a:pt x="510383" y="177658"/>
                    </a:cubicBezTo>
                    <a:cubicBezTo>
                      <a:pt x="521664" y="173428"/>
                      <a:pt x="534136" y="173491"/>
                      <a:pt x="545824" y="170569"/>
                    </a:cubicBezTo>
                    <a:cubicBezTo>
                      <a:pt x="553073" y="168757"/>
                      <a:pt x="559763" y="164946"/>
                      <a:pt x="567090" y="163481"/>
                    </a:cubicBezTo>
                    <a:cubicBezTo>
                      <a:pt x="595276" y="157844"/>
                      <a:pt x="623694" y="153369"/>
                      <a:pt x="652150" y="149304"/>
                    </a:cubicBezTo>
                    <a:cubicBezTo>
                      <a:pt x="668690" y="146941"/>
                      <a:pt x="685331" y="145205"/>
                      <a:pt x="701769" y="142216"/>
                    </a:cubicBezTo>
                    <a:cubicBezTo>
                      <a:pt x="711354" y="140473"/>
                      <a:pt x="720612" y="137240"/>
                      <a:pt x="730122" y="135127"/>
                    </a:cubicBezTo>
                    <a:cubicBezTo>
                      <a:pt x="811157" y="117119"/>
                      <a:pt x="724734" y="138246"/>
                      <a:pt x="793917" y="120951"/>
                    </a:cubicBezTo>
                    <a:cubicBezTo>
                      <a:pt x="803368" y="116225"/>
                      <a:pt x="812558" y="110936"/>
                      <a:pt x="822271" y="106774"/>
                    </a:cubicBezTo>
                    <a:cubicBezTo>
                      <a:pt x="829139" y="103831"/>
                      <a:pt x="837319" y="103831"/>
                      <a:pt x="843536" y="99686"/>
                    </a:cubicBezTo>
                    <a:cubicBezTo>
                      <a:pt x="865087" y="85318"/>
                      <a:pt x="867891" y="72239"/>
                      <a:pt x="878978" y="50067"/>
                    </a:cubicBezTo>
                    <a:cubicBezTo>
                      <a:pt x="876615" y="35890"/>
                      <a:pt x="879021" y="20016"/>
                      <a:pt x="871890" y="7537"/>
                    </a:cubicBezTo>
                    <a:cubicBezTo>
                      <a:pt x="868183" y="1049"/>
                      <a:pt x="857951" y="-1017"/>
                      <a:pt x="850624" y="448"/>
                    </a:cubicBezTo>
                    <a:cubicBezTo>
                      <a:pt x="821317" y="6309"/>
                      <a:pt x="794871" y="22941"/>
                      <a:pt x="765564" y="28802"/>
                    </a:cubicBezTo>
                    <a:cubicBezTo>
                      <a:pt x="699913" y="41931"/>
                      <a:pt x="742134" y="34966"/>
                      <a:pt x="637973" y="42979"/>
                    </a:cubicBezTo>
                    <a:cubicBezTo>
                      <a:pt x="617740" y="47025"/>
                      <a:pt x="594197" y="51149"/>
                      <a:pt x="574178" y="57155"/>
                    </a:cubicBezTo>
                    <a:cubicBezTo>
                      <a:pt x="559865" y="61449"/>
                      <a:pt x="545014" y="64649"/>
                      <a:pt x="531648" y="71332"/>
                    </a:cubicBezTo>
                    <a:cubicBezTo>
                      <a:pt x="512746" y="80783"/>
                      <a:pt x="494563" y="91838"/>
                      <a:pt x="474941" y="99686"/>
                    </a:cubicBezTo>
                    <a:cubicBezTo>
                      <a:pt x="463127" y="104411"/>
                      <a:pt x="451413" y="109394"/>
                      <a:pt x="439499" y="113862"/>
                    </a:cubicBezTo>
                    <a:cubicBezTo>
                      <a:pt x="432503" y="116486"/>
                      <a:pt x="424917" y="117609"/>
                      <a:pt x="418234" y="120951"/>
                    </a:cubicBezTo>
                    <a:cubicBezTo>
                      <a:pt x="405911" y="127113"/>
                      <a:pt x="395115" y="136055"/>
                      <a:pt x="382792" y="142216"/>
                    </a:cubicBezTo>
                    <a:cubicBezTo>
                      <a:pt x="371411" y="147906"/>
                      <a:pt x="358473" y="150213"/>
                      <a:pt x="347350" y="156392"/>
                    </a:cubicBezTo>
                    <a:cubicBezTo>
                      <a:pt x="337023" y="162129"/>
                      <a:pt x="329564" y="172375"/>
                      <a:pt x="318997" y="177658"/>
                    </a:cubicBezTo>
                    <a:cubicBezTo>
                      <a:pt x="310283" y="182015"/>
                      <a:pt x="299974" y="181947"/>
                      <a:pt x="290643" y="184746"/>
                    </a:cubicBezTo>
                    <a:cubicBezTo>
                      <a:pt x="276330" y="189040"/>
                      <a:pt x="262290" y="194197"/>
                      <a:pt x="248113" y="198923"/>
                    </a:cubicBezTo>
                    <a:cubicBezTo>
                      <a:pt x="241025" y="201286"/>
                      <a:pt x="233531" y="202670"/>
                      <a:pt x="226848" y="206011"/>
                    </a:cubicBezTo>
                    <a:cubicBezTo>
                      <a:pt x="217397" y="210737"/>
                      <a:pt x="207669" y="214945"/>
                      <a:pt x="198494" y="220188"/>
                    </a:cubicBezTo>
                    <a:cubicBezTo>
                      <a:pt x="174570" y="233859"/>
                      <a:pt x="153195" y="252484"/>
                      <a:pt x="127611" y="262718"/>
                    </a:cubicBezTo>
                    <a:cubicBezTo>
                      <a:pt x="82358" y="280820"/>
                      <a:pt x="103550" y="271205"/>
                      <a:pt x="63815" y="291072"/>
                    </a:cubicBezTo>
                    <a:cubicBezTo>
                      <a:pt x="59089" y="298160"/>
                      <a:pt x="55662" y="306313"/>
                      <a:pt x="49638" y="312337"/>
                    </a:cubicBezTo>
                    <a:cubicBezTo>
                      <a:pt x="43614" y="318361"/>
                      <a:pt x="33098" y="319425"/>
                      <a:pt x="28373" y="326513"/>
                    </a:cubicBezTo>
                    <a:cubicBezTo>
                      <a:pt x="22969" y="334619"/>
                      <a:pt x="23326" y="345341"/>
                      <a:pt x="21285" y="354867"/>
                    </a:cubicBezTo>
                    <a:cubicBezTo>
                      <a:pt x="7345" y="419919"/>
                      <a:pt x="5832" y="425610"/>
                      <a:pt x="20" y="489546"/>
                    </a:cubicBezTo>
                    <a:cubicBezTo>
                      <a:pt x="-408" y="494252"/>
                      <a:pt x="5927" y="489546"/>
                      <a:pt x="14197" y="482458"/>
                    </a:cubicBez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3175">
                <a:solidFill>
                  <a:schemeClr val="tx1">
                    <a:lumMod val="50000"/>
                    <a:lumOff val="50000"/>
                  </a:schemeClr>
                </a:solidFill>
                <a:extLst>
                  <a:ext uri="{C807C97D-BFC1-408E-A445-0C87EB9F89A2}">
                    <ask:lineSketchStyleProps xmlns:ask="http://schemas.microsoft.com/office/drawing/2018/sketchyshapes"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194" name="组合 193">
                <a:extLst>
                  <a:ext uri="{FF2B5EF4-FFF2-40B4-BE49-F238E27FC236}">
                    <a16:creationId xmlns:a16="http://schemas.microsoft.com/office/drawing/2014/main" id="{57F051C6-91AF-3419-E128-35F137657344}"/>
                  </a:ext>
                </a:extLst>
              </p:cNvPr>
              <p:cNvGrpSpPr/>
              <p:nvPr/>
            </p:nvGrpSpPr>
            <p:grpSpPr>
              <a:xfrm rot="884748">
                <a:off x="4915894" y="2389953"/>
                <a:ext cx="2013830" cy="2656388"/>
                <a:chOff x="5225455" y="1418200"/>
                <a:chExt cx="2171522" cy="3077726"/>
              </a:xfrm>
            </p:grpSpPr>
            <p:sp>
              <p:nvSpPr>
                <p:cNvPr id="195" name="iconfont-11894-5689852">
                  <a:extLst>
                    <a:ext uri="{FF2B5EF4-FFF2-40B4-BE49-F238E27FC236}">
                      <a16:creationId xmlns:a16="http://schemas.microsoft.com/office/drawing/2014/main" id="{63750C06-2152-367F-1AFC-A55E0A1CD5CD}"/>
                    </a:ext>
                  </a:extLst>
                </p:cNvPr>
                <p:cNvSpPr/>
                <p:nvPr/>
              </p:nvSpPr>
              <p:spPr>
                <a:xfrm rot="9888042">
                  <a:off x="6042642" y="1418200"/>
                  <a:ext cx="1354335" cy="1506043"/>
                </a:xfrm>
                <a:custGeom>
                  <a:avLst/>
                  <a:gdLst>
                    <a:gd name="T0" fmla="*/ 9971 w 10092"/>
                    <a:gd name="T1" fmla="*/ 29 h 11250"/>
                    <a:gd name="T2" fmla="*/ 7770 w 10092"/>
                    <a:gd name="T3" fmla="*/ 2526 h 11250"/>
                    <a:gd name="T4" fmla="*/ 7357 w 10092"/>
                    <a:gd name="T5" fmla="*/ 2584 h 11250"/>
                    <a:gd name="T6" fmla="*/ 6799 w 10092"/>
                    <a:gd name="T7" fmla="*/ 3217 h 11250"/>
                    <a:gd name="T8" fmla="*/ 6141 w 10092"/>
                    <a:gd name="T9" fmla="*/ 3426 h 11250"/>
                    <a:gd name="T10" fmla="*/ 1895 w 10092"/>
                    <a:gd name="T11" fmla="*/ 8242 h 11250"/>
                    <a:gd name="T12" fmla="*/ 1508 w 10092"/>
                    <a:gd name="T13" fmla="*/ 7901 h 11250"/>
                    <a:gd name="T14" fmla="*/ 1235 w 10092"/>
                    <a:gd name="T15" fmla="*/ 7918 h 11250"/>
                    <a:gd name="T16" fmla="*/ 1252 w 10092"/>
                    <a:gd name="T17" fmla="*/ 8191 h 11250"/>
                    <a:gd name="T18" fmla="*/ 1881 w 10092"/>
                    <a:gd name="T19" fmla="*/ 8746 h 11250"/>
                    <a:gd name="T20" fmla="*/ 622 w 10092"/>
                    <a:gd name="T21" fmla="*/ 10174 h 11250"/>
                    <a:gd name="T22" fmla="*/ 344 w 10092"/>
                    <a:gd name="T23" fmla="*/ 9928 h 11250"/>
                    <a:gd name="T24" fmla="*/ 70 w 10092"/>
                    <a:gd name="T25" fmla="*/ 9945 h 11250"/>
                    <a:gd name="T26" fmla="*/ 88 w 10092"/>
                    <a:gd name="T27" fmla="*/ 10219 h 11250"/>
                    <a:gd name="T28" fmla="*/ 1176 w 10092"/>
                    <a:gd name="T29" fmla="*/ 11179 h 11250"/>
                    <a:gd name="T30" fmla="*/ 1450 w 10092"/>
                    <a:gd name="T31" fmla="*/ 11162 h 11250"/>
                    <a:gd name="T32" fmla="*/ 1432 w 10092"/>
                    <a:gd name="T33" fmla="*/ 10888 h 11250"/>
                    <a:gd name="T34" fmla="*/ 1154 w 10092"/>
                    <a:gd name="T35" fmla="*/ 10643 h 11250"/>
                    <a:gd name="T36" fmla="*/ 2413 w 10092"/>
                    <a:gd name="T37" fmla="*/ 9215 h 11250"/>
                    <a:gd name="T38" fmla="*/ 3042 w 10092"/>
                    <a:gd name="T39" fmla="*/ 9770 h 11250"/>
                    <a:gd name="T40" fmla="*/ 3315 w 10092"/>
                    <a:gd name="T41" fmla="*/ 9753 h 11250"/>
                    <a:gd name="T42" fmla="*/ 3298 w 10092"/>
                    <a:gd name="T43" fmla="*/ 9480 h 11250"/>
                    <a:gd name="T44" fmla="*/ 2911 w 10092"/>
                    <a:gd name="T45" fmla="*/ 9138 h 11250"/>
                    <a:gd name="T46" fmla="*/ 7157 w 10092"/>
                    <a:gd name="T47" fmla="*/ 4323 h 11250"/>
                    <a:gd name="T48" fmla="*/ 7283 w 10092"/>
                    <a:gd name="T49" fmla="*/ 3644 h 11250"/>
                    <a:gd name="T50" fmla="*/ 7841 w 10092"/>
                    <a:gd name="T51" fmla="*/ 3011 h 11250"/>
                    <a:gd name="T52" fmla="*/ 7863 w 10092"/>
                    <a:gd name="T53" fmla="*/ 2615 h 11250"/>
                    <a:gd name="T54" fmla="*/ 10068 w 10092"/>
                    <a:gd name="T55" fmla="*/ 115 h 11250"/>
                    <a:gd name="T56" fmla="*/ 10062 w 10092"/>
                    <a:gd name="T57" fmla="*/ 23 h 11250"/>
                    <a:gd name="T58" fmla="*/ 9971 w 10092"/>
                    <a:gd name="T59" fmla="*/ 29 h 11250"/>
                    <a:gd name="T60" fmla="*/ 6964 w 10092"/>
                    <a:gd name="T61" fmla="*/ 4152 h 11250"/>
                    <a:gd name="T62" fmla="*/ 4820 w 10092"/>
                    <a:gd name="T63" fmla="*/ 6584 h 11250"/>
                    <a:gd name="T64" fmla="*/ 4684 w 10092"/>
                    <a:gd name="T65" fmla="*/ 6464 h 11250"/>
                    <a:gd name="T66" fmla="*/ 6743 w 10092"/>
                    <a:gd name="T67" fmla="*/ 4129 h 11250"/>
                    <a:gd name="T68" fmla="*/ 6735 w 10092"/>
                    <a:gd name="T69" fmla="*/ 3992 h 11250"/>
                    <a:gd name="T70" fmla="*/ 6598 w 10092"/>
                    <a:gd name="T71" fmla="*/ 4001 h 11250"/>
                    <a:gd name="T72" fmla="*/ 4539 w 10092"/>
                    <a:gd name="T73" fmla="*/ 6337 h 11250"/>
                    <a:gd name="T74" fmla="*/ 4190 w 10092"/>
                    <a:gd name="T75" fmla="*/ 6029 h 11250"/>
                    <a:gd name="T76" fmla="*/ 6335 w 10092"/>
                    <a:gd name="T77" fmla="*/ 3597 h 11250"/>
                    <a:gd name="T78" fmla="*/ 6927 w 10092"/>
                    <a:gd name="T79" fmla="*/ 3560 h 11250"/>
                    <a:gd name="T80" fmla="*/ 6964 w 10092"/>
                    <a:gd name="T81" fmla="*/ 4152 h 112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</a:cxnLst>
                  <a:rect l="0" t="0" r="r" b="b"/>
                  <a:pathLst>
                    <a:path w="10092" h="11250">
                      <a:moveTo>
                        <a:pt x="9971" y="29"/>
                      </a:moveTo>
                      <a:lnTo>
                        <a:pt x="7770" y="2526"/>
                      </a:lnTo>
                      <a:cubicBezTo>
                        <a:pt x="7639" y="2443"/>
                        <a:pt x="7463" y="2464"/>
                        <a:pt x="7357" y="2584"/>
                      </a:cubicBezTo>
                      <a:lnTo>
                        <a:pt x="6799" y="3217"/>
                      </a:lnTo>
                      <a:cubicBezTo>
                        <a:pt x="6565" y="3164"/>
                        <a:pt x="6311" y="3234"/>
                        <a:pt x="6141" y="3426"/>
                      </a:cubicBezTo>
                      <a:lnTo>
                        <a:pt x="1895" y="8242"/>
                      </a:lnTo>
                      <a:lnTo>
                        <a:pt x="1508" y="7901"/>
                      </a:lnTo>
                      <a:cubicBezTo>
                        <a:pt x="1428" y="7830"/>
                        <a:pt x="1306" y="7837"/>
                        <a:pt x="1235" y="7918"/>
                      </a:cubicBezTo>
                      <a:cubicBezTo>
                        <a:pt x="1164" y="7998"/>
                        <a:pt x="1172" y="8120"/>
                        <a:pt x="1252" y="8191"/>
                      </a:cubicBezTo>
                      <a:lnTo>
                        <a:pt x="1881" y="8746"/>
                      </a:lnTo>
                      <a:lnTo>
                        <a:pt x="622" y="10174"/>
                      </a:lnTo>
                      <a:lnTo>
                        <a:pt x="344" y="9928"/>
                      </a:lnTo>
                      <a:cubicBezTo>
                        <a:pt x="263" y="9858"/>
                        <a:pt x="141" y="9865"/>
                        <a:pt x="70" y="9945"/>
                      </a:cubicBezTo>
                      <a:cubicBezTo>
                        <a:pt x="0" y="10026"/>
                        <a:pt x="7" y="10148"/>
                        <a:pt x="88" y="10219"/>
                      </a:cubicBezTo>
                      <a:lnTo>
                        <a:pt x="1176" y="11179"/>
                      </a:lnTo>
                      <a:cubicBezTo>
                        <a:pt x="1257" y="11250"/>
                        <a:pt x="1379" y="11242"/>
                        <a:pt x="1450" y="11162"/>
                      </a:cubicBezTo>
                      <a:cubicBezTo>
                        <a:pt x="1520" y="11082"/>
                        <a:pt x="1513" y="10959"/>
                        <a:pt x="1432" y="10888"/>
                      </a:cubicBezTo>
                      <a:lnTo>
                        <a:pt x="1154" y="10643"/>
                      </a:lnTo>
                      <a:lnTo>
                        <a:pt x="2413" y="9215"/>
                      </a:lnTo>
                      <a:lnTo>
                        <a:pt x="3042" y="9770"/>
                      </a:lnTo>
                      <a:cubicBezTo>
                        <a:pt x="3122" y="9841"/>
                        <a:pt x="3245" y="9833"/>
                        <a:pt x="3315" y="9753"/>
                      </a:cubicBezTo>
                      <a:cubicBezTo>
                        <a:pt x="3386" y="9672"/>
                        <a:pt x="3378" y="9550"/>
                        <a:pt x="3298" y="9480"/>
                      </a:cubicBezTo>
                      <a:lnTo>
                        <a:pt x="2911" y="9138"/>
                      </a:lnTo>
                      <a:lnTo>
                        <a:pt x="7157" y="4323"/>
                      </a:lnTo>
                      <a:cubicBezTo>
                        <a:pt x="7327" y="4130"/>
                        <a:pt x="7365" y="3869"/>
                        <a:pt x="7283" y="3644"/>
                      </a:cubicBezTo>
                      <a:lnTo>
                        <a:pt x="7841" y="3011"/>
                      </a:lnTo>
                      <a:cubicBezTo>
                        <a:pt x="7941" y="2898"/>
                        <a:pt x="7946" y="2734"/>
                        <a:pt x="7863" y="2615"/>
                      </a:cubicBezTo>
                      <a:lnTo>
                        <a:pt x="10068" y="115"/>
                      </a:lnTo>
                      <a:cubicBezTo>
                        <a:pt x="10092" y="88"/>
                        <a:pt x="10089" y="47"/>
                        <a:pt x="10062" y="23"/>
                      </a:cubicBezTo>
                      <a:cubicBezTo>
                        <a:pt x="10036" y="0"/>
                        <a:pt x="9995" y="2"/>
                        <a:pt x="9971" y="29"/>
                      </a:cubicBezTo>
                      <a:close/>
                      <a:moveTo>
                        <a:pt x="6964" y="4152"/>
                      </a:moveTo>
                      <a:lnTo>
                        <a:pt x="4820" y="6584"/>
                      </a:lnTo>
                      <a:lnTo>
                        <a:pt x="4684" y="6464"/>
                      </a:lnTo>
                      <a:lnTo>
                        <a:pt x="6743" y="4129"/>
                      </a:lnTo>
                      <a:cubicBezTo>
                        <a:pt x="6778" y="4089"/>
                        <a:pt x="6775" y="4028"/>
                        <a:pt x="6735" y="3992"/>
                      </a:cubicBezTo>
                      <a:cubicBezTo>
                        <a:pt x="6695" y="3957"/>
                        <a:pt x="6633" y="3961"/>
                        <a:pt x="6598" y="4001"/>
                      </a:cubicBezTo>
                      <a:lnTo>
                        <a:pt x="4539" y="6337"/>
                      </a:lnTo>
                      <a:lnTo>
                        <a:pt x="4190" y="6029"/>
                      </a:lnTo>
                      <a:lnTo>
                        <a:pt x="6335" y="3597"/>
                      </a:lnTo>
                      <a:cubicBezTo>
                        <a:pt x="6488" y="3424"/>
                        <a:pt x="6753" y="3407"/>
                        <a:pt x="6927" y="3560"/>
                      </a:cubicBezTo>
                      <a:cubicBezTo>
                        <a:pt x="7101" y="3713"/>
                        <a:pt x="7117" y="3978"/>
                        <a:pt x="6964" y="4152"/>
                      </a:cubicBezTo>
                      <a:close/>
                    </a:path>
                  </a:pathLst>
                </a:custGeom>
                <a:solidFill>
                  <a:srgbClr val="36AB9C"/>
                </a:solidFill>
                <a:ln w="3175">
                  <a:noFill/>
                  <a:extLst>
                    <a:ext uri="{C807C97D-BFC1-408E-A445-0C87EB9F89A2}">
                      <ask:lineSketchStyleProps xmlns:ask="http://schemas.microsoft.com/office/drawing/2018/sketchyshapes">
                        <ask:type>
                          <ask:lineSketchNone/>
                        </ask:type>
                      </ask:lineSketchStyleProps>
                    </a:ext>
                  </a:extLst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dirty="0"/>
                </a:p>
              </p:txBody>
            </p:sp>
            <p:cxnSp>
              <p:nvCxnSpPr>
                <p:cNvPr id="196" name="直接连接符 195">
                  <a:extLst>
                    <a:ext uri="{FF2B5EF4-FFF2-40B4-BE49-F238E27FC236}">
                      <a16:creationId xmlns:a16="http://schemas.microsoft.com/office/drawing/2014/main" id="{8C209395-5792-A19F-33E6-9A3AD113CED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20688042" flipV="1">
                  <a:off x="5225455" y="3208812"/>
                  <a:ext cx="1215261" cy="1287114"/>
                </a:xfrm>
                <a:prstGeom prst="line">
                  <a:avLst/>
                </a:prstGeom>
                <a:ln w="3175">
                  <a:solidFill>
                    <a:srgbClr val="36AB9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573EE5FC-168F-427A-675D-E4FC502DD472}"/>
                </a:ext>
              </a:extLst>
            </p:cNvPr>
            <p:cNvSpPr txBox="1"/>
            <p:nvPr/>
          </p:nvSpPr>
          <p:spPr>
            <a:xfrm>
              <a:off x="3331253" y="2004285"/>
              <a:ext cx="923479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 algn="ctr">
                <a:defRPr sz="1200">
                  <a:cs typeface="+mn-ea"/>
                </a:defRPr>
              </a:lvl1pPr>
            </a:lstStyle>
            <a:p>
              <a:r>
                <a:rPr lang="en-US" altLang="zh-CN" sz="1200" dirty="0">
                  <a:latin typeface="+mn-lt"/>
                  <a:cs typeface="+mn-ea"/>
                  <a:sym typeface="+mn-lt"/>
                </a:rPr>
                <a:t>T7E1 digestion</a:t>
              </a:r>
              <a:endParaRPr lang="zh-CN" altLang="en-US" sz="1200" dirty="0">
                <a:latin typeface="+mn-lt"/>
                <a:cs typeface="+mn-ea"/>
                <a:sym typeface="+mn-lt"/>
              </a:endParaRPr>
            </a:p>
          </p:txBody>
        </p:sp>
        <p:grpSp>
          <p:nvGrpSpPr>
            <p:cNvPr id="113" name="组合 112">
              <a:extLst>
                <a:ext uri="{FF2B5EF4-FFF2-40B4-BE49-F238E27FC236}">
                  <a16:creationId xmlns:a16="http://schemas.microsoft.com/office/drawing/2014/main" id="{B8E03243-A00E-AC2C-85E2-2AC650789D46}"/>
                </a:ext>
              </a:extLst>
            </p:cNvPr>
            <p:cNvGrpSpPr/>
            <p:nvPr/>
          </p:nvGrpSpPr>
          <p:grpSpPr>
            <a:xfrm>
              <a:off x="3534329" y="1515958"/>
              <a:ext cx="487427" cy="468865"/>
              <a:chOff x="60443" y="1527437"/>
              <a:chExt cx="1123996" cy="1123996"/>
            </a:xfrm>
          </p:grpSpPr>
          <p:sp>
            <p:nvSpPr>
              <p:cNvPr id="114" name="矩形 113">
                <a:extLst>
                  <a:ext uri="{FF2B5EF4-FFF2-40B4-BE49-F238E27FC236}">
                    <a16:creationId xmlns:a16="http://schemas.microsoft.com/office/drawing/2014/main" id="{161A8201-BD98-1F06-1567-F224CEFCA6A2}"/>
                  </a:ext>
                </a:extLst>
              </p:cNvPr>
              <p:cNvSpPr/>
              <p:nvPr/>
            </p:nvSpPr>
            <p:spPr>
              <a:xfrm>
                <a:off x="60443" y="1527437"/>
                <a:ext cx="1123996" cy="1123996"/>
              </a:xfrm>
              <a:prstGeom prst="rect">
                <a:avLst/>
              </a:prstGeom>
              <a:noFill/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7" name="矩形 196">
                <a:extLst>
                  <a:ext uri="{FF2B5EF4-FFF2-40B4-BE49-F238E27FC236}">
                    <a16:creationId xmlns:a16="http://schemas.microsoft.com/office/drawing/2014/main" id="{402A4ECA-EBE3-883E-92A5-A472A5310901}"/>
                  </a:ext>
                </a:extLst>
              </p:cNvPr>
              <p:cNvSpPr/>
              <p:nvPr/>
            </p:nvSpPr>
            <p:spPr>
              <a:xfrm>
                <a:off x="250311" y="1745669"/>
                <a:ext cx="277235" cy="144697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8" name="矩形 197">
                <a:extLst>
                  <a:ext uri="{FF2B5EF4-FFF2-40B4-BE49-F238E27FC236}">
                    <a16:creationId xmlns:a16="http://schemas.microsoft.com/office/drawing/2014/main" id="{D62EAA4C-60EF-5C48-C00C-815C2F7D0BB3}"/>
                  </a:ext>
                </a:extLst>
              </p:cNvPr>
              <p:cNvSpPr/>
              <p:nvPr/>
            </p:nvSpPr>
            <p:spPr>
              <a:xfrm flipV="1">
                <a:off x="674876" y="1770057"/>
                <a:ext cx="272983" cy="71742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9" name="矩形 198">
                <a:extLst>
                  <a:ext uri="{FF2B5EF4-FFF2-40B4-BE49-F238E27FC236}">
                    <a16:creationId xmlns:a16="http://schemas.microsoft.com/office/drawing/2014/main" id="{0A02D0F0-3A45-7022-820E-335C691B4B21}"/>
                  </a:ext>
                </a:extLst>
              </p:cNvPr>
              <p:cNvSpPr/>
              <p:nvPr/>
            </p:nvSpPr>
            <p:spPr>
              <a:xfrm flipV="1">
                <a:off x="674497" y="2039161"/>
                <a:ext cx="272983" cy="45719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0" name="矩形 199">
                <a:extLst>
                  <a:ext uri="{FF2B5EF4-FFF2-40B4-BE49-F238E27FC236}">
                    <a16:creationId xmlns:a16="http://schemas.microsoft.com/office/drawing/2014/main" id="{6977A936-04CE-CB2A-D33C-B62364E992FE}"/>
                  </a:ext>
                </a:extLst>
              </p:cNvPr>
              <p:cNvSpPr/>
              <p:nvPr/>
            </p:nvSpPr>
            <p:spPr>
              <a:xfrm flipV="1">
                <a:off x="674497" y="2227989"/>
                <a:ext cx="272983" cy="45719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201" name="文本框 200">
              <a:extLst>
                <a:ext uri="{FF2B5EF4-FFF2-40B4-BE49-F238E27FC236}">
                  <a16:creationId xmlns:a16="http://schemas.microsoft.com/office/drawing/2014/main" id="{D6F700F7-DCAE-C7C8-B3D5-235583E7F76E}"/>
                </a:ext>
              </a:extLst>
            </p:cNvPr>
            <p:cNvSpPr txBox="1"/>
            <p:nvPr/>
          </p:nvSpPr>
          <p:spPr>
            <a:xfrm>
              <a:off x="4085647" y="2008161"/>
              <a:ext cx="1064255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 algn="ctr">
                <a:defRPr sz="1200">
                  <a:cs typeface="+mn-ea"/>
                </a:defRPr>
              </a:lvl1pPr>
            </a:lstStyle>
            <a:p>
              <a:r>
                <a:rPr lang="en-US" altLang="zh-CN" dirty="0"/>
                <a:t>Deep sequencing</a:t>
              </a:r>
              <a:endParaRPr lang="zh-CN" altLang="en-US" dirty="0"/>
            </a:p>
          </p:txBody>
        </p:sp>
        <p:grpSp>
          <p:nvGrpSpPr>
            <p:cNvPr id="221" name="组合 220">
              <a:extLst>
                <a:ext uri="{FF2B5EF4-FFF2-40B4-BE49-F238E27FC236}">
                  <a16:creationId xmlns:a16="http://schemas.microsoft.com/office/drawing/2014/main" id="{E08E7B65-D0B1-8B8F-3C47-4B110EC49B98}"/>
                </a:ext>
              </a:extLst>
            </p:cNvPr>
            <p:cNvGrpSpPr/>
            <p:nvPr/>
          </p:nvGrpSpPr>
          <p:grpSpPr>
            <a:xfrm>
              <a:off x="4407910" y="1606456"/>
              <a:ext cx="395057" cy="313050"/>
              <a:chOff x="1432490" y="4592218"/>
              <a:chExt cx="1684783" cy="928009"/>
            </a:xfrm>
          </p:grpSpPr>
          <p:grpSp>
            <p:nvGrpSpPr>
              <p:cNvPr id="222" name="组合 221">
                <a:extLst>
                  <a:ext uri="{FF2B5EF4-FFF2-40B4-BE49-F238E27FC236}">
                    <a16:creationId xmlns:a16="http://schemas.microsoft.com/office/drawing/2014/main" id="{C1FD2DD7-C1B3-6248-43B5-CD47EB0E45A6}"/>
                  </a:ext>
                </a:extLst>
              </p:cNvPr>
              <p:cNvGrpSpPr/>
              <p:nvPr/>
            </p:nvGrpSpPr>
            <p:grpSpPr>
              <a:xfrm rot="21266569">
                <a:off x="1432490" y="4592218"/>
                <a:ext cx="1684783" cy="218143"/>
                <a:chOff x="1432490" y="4592218"/>
                <a:chExt cx="1684783" cy="218143"/>
              </a:xfrm>
            </p:grpSpPr>
            <p:cxnSp>
              <p:nvCxnSpPr>
                <p:cNvPr id="239" name="直接连接符 238">
                  <a:extLst>
                    <a:ext uri="{FF2B5EF4-FFF2-40B4-BE49-F238E27FC236}">
                      <a16:creationId xmlns:a16="http://schemas.microsoft.com/office/drawing/2014/main" id="{029CD99D-A81F-2771-D885-39920DAB9E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32490" y="4592218"/>
                  <a:ext cx="194260" cy="106325"/>
                </a:xfrm>
                <a:prstGeom prst="line">
                  <a:avLst/>
                </a:prstGeom>
                <a:ln w="12700">
                  <a:solidFill>
                    <a:srgbClr val="FA7F6F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40" name="任意多边形: 形状 239">
                  <a:extLst>
                    <a:ext uri="{FF2B5EF4-FFF2-40B4-BE49-F238E27FC236}">
                      <a16:creationId xmlns:a16="http://schemas.microsoft.com/office/drawing/2014/main" id="{02AEE8DC-4272-EC55-9251-2BFB0F362F39}"/>
                    </a:ext>
                  </a:extLst>
                </p:cNvPr>
                <p:cNvSpPr/>
                <p:nvPr/>
              </p:nvSpPr>
              <p:spPr>
                <a:xfrm>
                  <a:off x="1617518" y="4693227"/>
                  <a:ext cx="1278082" cy="117134"/>
                </a:xfrm>
                <a:custGeom>
                  <a:avLst/>
                  <a:gdLst>
                    <a:gd name="connsiteX0" fmla="*/ 0 w 1278082"/>
                    <a:gd name="connsiteY0" fmla="*/ 0 h 117134"/>
                    <a:gd name="connsiteX1" fmla="*/ 193964 w 1278082"/>
                    <a:gd name="connsiteY1" fmla="*/ 83128 h 117134"/>
                    <a:gd name="connsiteX2" fmla="*/ 381000 w 1278082"/>
                    <a:gd name="connsiteY2" fmla="*/ 114300 h 117134"/>
                    <a:gd name="connsiteX3" fmla="*/ 786246 w 1278082"/>
                    <a:gd name="connsiteY3" fmla="*/ 17318 h 117134"/>
                    <a:gd name="connsiteX4" fmla="*/ 1163782 w 1278082"/>
                    <a:gd name="connsiteY4" fmla="*/ 86591 h 117134"/>
                    <a:gd name="connsiteX5" fmla="*/ 1278082 w 1278082"/>
                    <a:gd name="connsiteY5" fmla="*/ 103909 h 1171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278082" h="117134">
                      <a:moveTo>
                        <a:pt x="0" y="0"/>
                      </a:moveTo>
                      <a:cubicBezTo>
                        <a:pt x="65232" y="32039"/>
                        <a:pt x="130464" y="64078"/>
                        <a:pt x="193964" y="83128"/>
                      </a:cubicBezTo>
                      <a:cubicBezTo>
                        <a:pt x="257464" y="102178"/>
                        <a:pt x="282286" y="125268"/>
                        <a:pt x="381000" y="114300"/>
                      </a:cubicBezTo>
                      <a:cubicBezTo>
                        <a:pt x="479714" y="103332"/>
                        <a:pt x="655782" y="21936"/>
                        <a:pt x="786246" y="17318"/>
                      </a:cubicBezTo>
                      <a:cubicBezTo>
                        <a:pt x="916710" y="12700"/>
                        <a:pt x="1081809" y="72159"/>
                        <a:pt x="1163782" y="86591"/>
                      </a:cubicBezTo>
                      <a:cubicBezTo>
                        <a:pt x="1245755" y="101023"/>
                        <a:pt x="1261918" y="102466"/>
                        <a:pt x="1278082" y="103909"/>
                      </a:cubicBezTo>
                    </a:path>
                  </a:pathLst>
                </a:custGeom>
                <a:noFill/>
                <a:ln w="12700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241" name="直接连接符 240">
                  <a:extLst>
                    <a:ext uri="{FF2B5EF4-FFF2-40B4-BE49-F238E27FC236}">
                      <a16:creationId xmlns:a16="http://schemas.microsoft.com/office/drawing/2014/main" id="{AEB8C566-5C78-85D9-B58F-16F538D8BF2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95600" y="4798761"/>
                  <a:ext cx="221673" cy="11600"/>
                </a:xfrm>
                <a:prstGeom prst="line">
                  <a:avLst/>
                </a:prstGeom>
                <a:ln w="12700">
                  <a:solidFill>
                    <a:srgbClr val="FA7F6F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3" name="组合 222">
                <a:extLst>
                  <a:ext uri="{FF2B5EF4-FFF2-40B4-BE49-F238E27FC236}">
                    <a16:creationId xmlns:a16="http://schemas.microsoft.com/office/drawing/2014/main" id="{9988DE6A-D299-9B09-01AA-16CA423C54B7}"/>
                  </a:ext>
                </a:extLst>
              </p:cNvPr>
              <p:cNvGrpSpPr/>
              <p:nvPr/>
            </p:nvGrpSpPr>
            <p:grpSpPr>
              <a:xfrm rot="21266569">
                <a:off x="1432490" y="4751545"/>
                <a:ext cx="1684783" cy="218143"/>
                <a:chOff x="1432490" y="4592218"/>
                <a:chExt cx="1684783" cy="218143"/>
              </a:xfrm>
            </p:grpSpPr>
            <p:cxnSp>
              <p:nvCxnSpPr>
                <p:cNvPr id="236" name="直接连接符 235">
                  <a:extLst>
                    <a:ext uri="{FF2B5EF4-FFF2-40B4-BE49-F238E27FC236}">
                      <a16:creationId xmlns:a16="http://schemas.microsoft.com/office/drawing/2014/main" id="{5EF0E925-FA68-5472-1EBB-D8D7E63FD8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32490" y="4592218"/>
                  <a:ext cx="194260" cy="106325"/>
                </a:xfrm>
                <a:prstGeom prst="line">
                  <a:avLst/>
                </a:prstGeom>
                <a:ln w="12700">
                  <a:solidFill>
                    <a:srgbClr val="FA7F6F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37" name="任意多边形: 形状 236">
                  <a:extLst>
                    <a:ext uri="{FF2B5EF4-FFF2-40B4-BE49-F238E27FC236}">
                      <a16:creationId xmlns:a16="http://schemas.microsoft.com/office/drawing/2014/main" id="{3BEC8CF9-FC0B-F8D0-31A8-D6AE4418D35E}"/>
                    </a:ext>
                  </a:extLst>
                </p:cNvPr>
                <p:cNvSpPr/>
                <p:nvPr/>
              </p:nvSpPr>
              <p:spPr>
                <a:xfrm>
                  <a:off x="1617518" y="4693227"/>
                  <a:ext cx="1278082" cy="117134"/>
                </a:xfrm>
                <a:custGeom>
                  <a:avLst/>
                  <a:gdLst>
                    <a:gd name="connsiteX0" fmla="*/ 0 w 1278082"/>
                    <a:gd name="connsiteY0" fmla="*/ 0 h 117134"/>
                    <a:gd name="connsiteX1" fmla="*/ 193964 w 1278082"/>
                    <a:gd name="connsiteY1" fmla="*/ 83128 h 117134"/>
                    <a:gd name="connsiteX2" fmla="*/ 381000 w 1278082"/>
                    <a:gd name="connsiteY2" fmla="*/ 114300 h 117134"/>
                    <a:gd name="connsiteX3" fmla="*/ 786246 w 1278082"/>
                    <a:gd name="connsiteY3" fmla="*/ 17318 h 117134"/>
                    <a:gd name="connsiteX4" fmla="*/ 1163782 w 1278082"/>
                    <a:gd name="connsiteY4" fmla="*/ 86591 h 117134"/>
                    <a:gd name="connsiteX5" fmla="*/ 1278082 w 1278082"/>
                    <a:gd name="connsiteY5" fmla="*/ 103909 h 1171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278082" h="117134">
                      <a:moveTo>
                        <a:pt x="0" y="0"/>
                      </a:moveTo>
                      <a:cubicBezTo>
                        <a:pt x="65232" y="32039"/>
                        <a:pt x="130464" y="64078"/>
                        <a:pt x="193964" y="83128"/>
                      </a:cubicBezTo>
                      <a:cubicBezTo>
                        <a:pt x="257464" y="102178"/>
                        <a:pt x="282286" y="125268"/>
                        <a:pt x="381000" y="114300"/>
                      </a:cubicBezTo>
                      <a:cubicBezTo>
                        <a:pt x="479714" y="103332"/>
                        <a:pt x="655782" y="21936"/>
                        <a:pt x="786246" y="17318"/>
                      </a:cubicBezTo>
                      <a:cubicBezTo>
                        <a:pt x="916710" y="12700"/>
                        <a:pt x="1081809" y="72159"/>
                        <a:pt x="1163782" y="86591"/>
                      </a:cubicBezTo>
                      <a:cubicBezTo>
                        <a:pt x="1245755" y="101023"/>
                        <a:pt x="1261918" y="102466"/>
                        <a:pt x="1278082" y="103909"/>
                      </a:cubicBezTo>
                    </a:path>
                  </a:pathLst>
                </a:custGeom>
                <a:noFill/>
                <a:ln w="12700">
                  <a:solidFill>
                    <a:srgbClr val="8ECFC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238" name="直接连接符 237">
                  <a:extLst>
                    <a:ext uri="{FF2B5EF4-FFF2-40B4-BE49-F238E27FC236}">
                      <a16:creationId xmlns:a16="http://schemas.microsoft.com/office/drawing/2014/main" id="{C0948EE2-696A-3699-DBF2-4C060C5F9B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95600" y="4798761"/>
                  <a:ext cx="221673" cy="11600"/>
                </a:xfrm>
                <a:prstGeom prst="line">
                  <a:avLst/>
                </a:prstGeom>
                <a:ln w="12700">
                  <a:solidFill>
                    <a:srgbClr val="FA7F6F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4" name="组合 223">
                <a:extLst>
                  <a:ext uri="{FF2B5EF4-FFF2-40B4-BE49-F238E27FC236}">
                    <a16:creationId xmlns:a16="http://schemas.microsoft.com/office/drawing/2014/main" id="{6CA8CED1-8806-73FF-01C1-3ADBBFC6BC63}"/>
                  </a:ext>
                </a:extLst>
              </p:cNvPr>
              <p:cNvGrpSpPr/>
              <p:nvPr/>
            </p:nvGrpSpPr>
            <p:grpSpPr>
              <a:xfrm rot="21266569">
                <a:off x="1432490" y="4939732"/>
                <a:ext cx="1684783" cy="218143"/>
                <a:chOff x="1432490" y="4592218"/>
                <a:chExt cx="1684783" cy="218143"/>
              </a:xfrm>
            </p:grpSpPr>
            <p:cxnSp>
              <p:nvCxnSpPr>
                <p:cNvPr id="233" name="直接连接符 232">
                  <a:extLst>
                    <a:ext uri="{FF2B5EF4-FFF2-40B4-BE49-F238E27FC236}">
                      <a16:creationId xmlns:a16="http://schemas.microsoft.com/office/drawing/2014/main" id="{7178DEC0-AAA0-8415-64D6-E2373DCD37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32490" y="4592218"/>
                  <a:ext cx="194260" cy="106325"/>
                </a:xfrm>
                <a:prstGeom prst="line">
                  <a:avLst/>
                </a:prstGeom>
                <a:ln w="12700">
                  <a:solidFill>
                    <a:srgbClr val="36AB9C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任意多边形: 形状 233">
                  <a:extLst>
                    <a:ext uri="{FF2B5EF4-FFF2-40B4-BE49-F238E27FC236}">
                      <a16:creationId xmlns:a16="http://schemas.microsoft.com/office/drawing/2014/main" id="{3594E7EB-0FD6-F367-13DC-D81ADC256B74}"/>
                    </a:ext>
                  </a:extLst>
                </p:cNvPr>
                <p:cNvSpPr/>
                <p:nvPr/>
              </p:nvSpPr>
              <p:spPr>
                <a:xfrm>
                  <a:off x="1617518" y="4693227"/>
                  <a:ext cx="1278082" cy="117134"/>
                </a:xfrm>
                <a:custGeom>
                  <a:avLst/>
                  <a:gdLst>
                    <a:gd name="connsiteX0" fmla="*/ 0 w 1278082"/>
                    <a:gd name="connsiteY0" fmla="*/ 0 h 117134"/>
                    <a:gd name="connsiteX1" fmla="*/ 193964 w 1278082"/>
                    <a:gd name="connsiteY1" fmla="*/ 83128 h 117134"/>
                    <a:gd name="connsiteX2" fmla="*/ 381000 w 1278082"/>
                    <a:gd name="connsiteY2" fmla="*/ 114300 h 117134"/>
                    <a:gd name="connsiteX3" fmla="*/ 786246 w 1278082"/>
                    <a:gd name="connsiteY3" fmla="*/ 17318 h 117134"/>
                    <a:gd name="connsiteX4" fmla="*/ 1163782 w 1278082"/>
                    <a:gd name="connsiteY4" fmla="*/ 86591 h 117134"/>
                    <a:gd name="connsiteX5" fmla="*/ 1278082 w 1278082"/>
                    <a:gd name="connsiteY5" fmla="*/ 103909 h 1171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278082" h="117134">
                      <a:moveTo>
                        <a:pt x="0" y="0"/>
                      </a:moveTo>
                      <a:cubicBezTo>
                        <a:pt x="65232" y="32039"/>
                        <a:pt x="130464" y="64078"/>
                        <a:pt x="193964" y="83128"/>
                      </a:cubicBezTo>
                      <a:cubicBezTo>
                        <a:pt x="257464" y="102178"/>
                        <a:pt x="282286" y="125268"/>
                        <a:pt x="381000" y="114300"/>
                      </a:cubicBezTo>
                      <a:cubicBezTo>
                        <a:pt x="479714" y="103332"/>
                        <a:pt x="655782" y="21936"/>
                        <a:pt x="786246" y="17318"/>
                      </a:cubicBezTo>
                      <a:cubicBezTo>
                        <a:pt x="916710" y="12700"/>
                        <a:pt x="1081809" y="72159"/>
                        <a:pt x="1163782" y="86591"/>
                      </a:cubicBezTo>
                      <a:cubicBezTo>
                        <a:pt x="1245755" y="101023"/>
                        <a:pt x="1261918" y="102466"/>
                        <a:pt x="1278082" y="103909"/>
                      </a:cubicBezTo>
                    </a:path>
                  </a:pathLst>
                </a:custGeom>
                <a:noFill/>
                <a:ln w="12700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235" name="直接连接符 234">
                  <a:extLst>
                    <a:ext uri="{FF2B5EF4-FFF2-40B4-BE49-F238E27FC236}">
                      <a16:creationId xmlns:a16="http://schemas.microsoft.com/office/drawing/2014/main" id="{5A333C16-D283-D74F-EF19-778FE3C4DDD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95600" y="4798761"/>
                  <a:ext cx="221673" cy="11600"/>
                </a:xfrm>
                <a:prstGeom prst="line">
                  <a:avLst/>
                </a:prstGeom>
                <a:ln w="12700">
                  <a:solidFill>
                    <a:srgbClr val="36AB9C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5" name="组合 224">
                <a:extLst>
                  <a:ext uri="{FF2B5EF4-FFF2-40B4-BE49-F238E27FC236}">
                    <a16:creationId xmlns:a16="http://schemas.microsoft.com/office/drawing/2014/main" id="{81C8804A-96CC-7794-81F7-58F7A2F2C438}"/>
                  </a:ext>
                </a:extLst>
              </p:cNvPr>
              <p:cNvGrpSpPr/>
              <p:nvPr/>
            </p:nvGrpSpPr>
            <p:grpSpPr>
              <a:xfrm rot="21266569">
                <a:off x="1432490" y="5121003"/>
                <a:ext cx="1684783" cy="218143"/>
                <a:chOff x="1432490" y="4592218"/>
                <a:chExt cx="1684783" cy="218143"/>
              </a:xfrm>
            </p:grpSpPr>
            <p:cxnSp>
              <p:nvCxnSpPr>
                <p:cNvPr id="230" name="直接连接符 229">
                  <a:extLst>
                    <a:ext uri="{FF2B5EF4-FFF2-40B4-BE49-F238E27FC236}">
                      <a16:creationId xmlns:a16="http://schemas.microsoft.com/office/drawing/2014/main" id="{4213E053-A15E-7861-98D8-5173D92EA01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32490" y="4592218"/>
                  <a:ext cx="194260" cy="106325"/>
                </a:xfrm>
                <a:prstGeom prst="line">
                  <a:avLst/>
                </a:prstGeom>
                <a:ln w="12700">
                  <a:solidFill>
                    <a:srgbClr val="36AB9C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31" name="任意多边形: 形状 230">
                  <a:extLst>
                    <a:ext uri="{FF2B5EF4-FFF2-40B4-BE49-F238E27FC236}">
                      <a16:creationId xmlns:a16="http://schemas.microsoft.com/office/drawing/2014/main" id="{226EA1DF-73EA-FB5C-3DC0-12A643E1F308}"/>
                    </a:ext>
                  </a:extLst>
                </p:cNvPr>
                <p:cNvSpPr/>
                <p:nvPr/>
              </p:nvSpPr>
              <p:spPr>
                <a:xfrm>
                  <a:off x="1617518" y="4693227"/>
                  <a:ext cx="1278082" cy="117134"/>
                </a:xfrm>
                <a:custGeom>
                  <a:avLst/>
                  <a:gdLst>
                    <a:gd name="connsiteX0" fmla="*/ 0 w 1278082"/>
                    <a:gd name="connsiteY0" fmla="*/ 0 h 117134"/>
                    <a:gd name="connsiteX1" fmla="*/ 193964 w 1278082"/>
                    <a:gd name="connsiteY1" fmla="*/ 83128 h 117134"/>
                    <a:gd name="connsiteX2" fmla="*/ 381000 w 1278082"/>
                    <a:gd name="connsiteY2" fmla="*/ 114300 h 117134"/>
                    <a:gd name="connsiteX3" fmla="*/ 786246 w 1278082"/>
                    <a:gd name="connsiteY3" fmla="*/ 17318 h 117134"/>
                    <a:gd name="connsiteX4" fmla="*/ 1163782 w 1278082"/>
                    <a:gd name="connsiteY4" fmla="*/ 86591 h 117134"/>
                    <a:gd name="connsiteX5" fmla="*/ 1278082 w 1278082"/>
                    <a:gd name="connsiteY5" fmla="*/ 103909 h 1171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278082" h="117134">
                      <a:moveTo>
                        <a:pt x="0" y="0"/>
                      </a:moveTo>
                      <a:cubicBezTo>
                        <a:pt x="65232" y="32039"/>
                        <a:pt x="130464" y="64078"/>
                        <a:pt x="193964" y="83128"/>
                      </a:cubicBezTo>
                      <a:cubicBezTo>
                        <a:pt x="257464" y="102178"/>
                        <a:pt x="282286" y="125268"/>
                        <a:pt x="381000" y="114300"/>
                      </a:cubicBezTo>
                      <a:cubicBezTo>
                        <a:pt x="479714" y="103332"/>
                        <a:pt x="655782" y="21936"/>
                        <a:pt x="786246" y="17318"/>
                      </a:cubicBezTo>
                      <a:cubicBezTo>
                        <a:pt x="916710" y="12700"/>
                        <a:pt x="1081809" y="72159"/>
                        <a:pt x="1163782" y="86591"/>
                      </a:cubicBezTo>
                      <a:cubicBezTo>
                        <a:pt x="1245755" y="101023"/>
                        <a:pt x="1261918" y="102466"/>
                        <a:pt x="1278082" y="103909"/>
                      </a:cubicBezTo>
                    </a:path>
                  </a:pathLst>
                </a:custGeom>
                <a:noFill/>
                <a:ln w="12700">
                  <a:solidFill>
                    <a:srgbClr val="8ECFC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232" name="直接连接符 231">
                  <a:extLst>
                    <a:ext uri="{FF2B5EF4-FFF2-40B4-BE49-F238E27FC236}">
                      <a16:creationId xmlns:a16="http://schemas.microsoft.com/office/drawing/2014/main" id="{B3E68D7C-8879-97FC-0E07-82C31EC13D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95600" y="4798761"/>
                  <a:ext cx="221673" cy="11600"/>
                </a:xfrm>
                <a:prstGeom prst="line">
                  <a:avLst/>
                </a:prstGeom>
                <a:ln w="12700">
                  <a:solidFill>
                    <a:srgbClr val="36AB9C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6" name="组合 225">
                <a:extLst>
                  <a:ext uri="{FF2B5EF4-FFF2-40B4-BE49-F238E27FC236}">
                    <a16:creationId xmlns:a16="http://schemas.microsoft.com/office/drawing/2014/main" id="{EB730AB8-08F1-713E-5229-90732CD5B999}"/>
                  </a:ext>
                </a:extLst>
              </p:cNvPr>
              <p:cNvGrpSpPr/>
              <p:nvPr/>
            </p:nvGrpSpPr>
            <p:grpSpPr>
              <a:xfrm rot="21266569">
                <a:off x="1432490" y="5302084"/>
                <a:ext cx="1684783" cy="218143"/>
                <a:chOff x="1432490" y="4592218"/>
                <a:chExt cx="1684783" cy="218143"/>
              </a:xfrm>
            </p:grpSpPr>
            <p:cxnSp>
              <p:nvCxnSpPr>
                <p:cNvPr id="227" name="直接连接符 226">
                  <a:extLst>
                    <a:ext uri="{FF2B5EF4-FFF2-40B4-BE49-F238E27FC236}">
                      <a16:creationId xmlns:a16="http://schemas.microsoft.com/office/drawing/2014/main" id="{9FB38F81-631F-6666-23E5-086CBE5963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32490" y="4592218"/>
                  <a:ext cx="194260" cy="106325"/>
                </a:xfrm>
                <a:prstGeom prst="line">
                  <a:avLst/>
                </a:prstGeom>
                <a:ln w="12700">
                  <a:solidFill>
                    <a:srgbClr val="FFBE7A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28" name="任意多边形: 形状 227">
                  <a:extLst>
                    <a:ext uri="{FF2B5EF4-FFF2-40B4-BE49-F238E27FC236}">
                      <a16:creationId xmlns:a16="http://schemas.microsoft.com/office/drawing/2014/main" id="{100BFE5A-7AF7-298F-1884-764CC55C5D04}"/>
                    </a:ext>
                  </a:extLst>
                </p:cNvPr>
                <p:cNvSpPr/>
                <p:nvPr/>
              </p:nvSpPr>
              <p:spPr>
                <a:xfrm>
                  <a:off x="1617518" y="4693227"/>
                  <a:ext cx="1278082" cy="117134"/>
                </a:xfrm>
                <a:custGeom>
                  <a:avLst/>
                  <a:gdLst>
                    <a:gd name="connsiteX0" fmla="*/ 0 w 1278082"/>
                    <a:gd name="connsiteY0" fmla="*/ 0 h 117134"/>
                    <a:gd name="connsiteX1" fmla="*/ 193964 w 1278082"/>
                    <a:gd name="connsiteY1" fmla="*/ 83128 h 117134"/>
                    <a:gd name="connsiteX2" fmla="*/ 381000 w 1278082"/>
                    <a:gd name="connsiteY2" fmla="*/ 114300 h 117134"/>
                    <a:gd name="connsiteX3" fmla="*/ 786246 w 1278082"/>
                    <a:gd name="connsiteY3" fmla="*/ 17318 h 117134"/>
                    <a:gd name="connsiteX4" fmla="*/ 1163782 w 1278082"/>
                    <a:gd name="connsiteY4" fmla="*/ 86591 h 117134"/>
                    <a:gd name="connsiteX5" fmla="*/ 1278082 w 1278082"/>
                    <a:gd name="connsiteY5" fmla="*/ 103909 h 1171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278082" h="117134">
                      <a:moveTo>
                        <a:pt x="0" y="0"/>
                      </a:moveTo>
                      <a:cubicBezTo>
                        <a:pt x="65232" y="32039"/>
                        <a:pt x="130464" y="64078"/>
                        <a:pt x="193964" y="83128"/>
                      </a:cubicBezTo>
                      <a:cubicBezTo>
                        <a:pt x="257464" y="102178"/>
                        <a:pt x="282286" y="125268"/>
                        <a:pt x="381000" y="114300"/>
                      </a:cubicBezTo>
                      <a:cubicBezTo>
                        <a:pt x="479714" y="103332"/>
                        <a:pt x="655782" y="21936"/>
                        <a:pt x="786246" y="17318"/>
                      </a:cubicBezTo>
                      <a:cubicBezTo>
                        <a:pt x="916710" y="12700"/>
                        <a:pt x="1081809" y="72159"/>
                        <a:pt x="1163782" y="86591"/>
                      </a:cubicBezTo>
                      <a:cubicBezTo>
                        <a:pt x="1245755" y="101023"/>
                        <a:pt x="1261918" y="102466"/>
                        <a:pt x="1278082" y="103909"/>
                      </a:cubicBezTo>
                    </a:path>
                  </a:pathLst>
                </a:custGeom>
                <a:noFill/>
                <a:ln w="12700">
                  <a:solidFill>
                    <a:srgbClr val="99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229" name="直接连接符 228">
                  <a:extLst>
                    <a:ext uri="{FF2B5EF4-FFF2-40B4-BE49-F238E27FC236}">
                      <a16:creationId xmlns:a16="http://schemas.microsoft.com/office/drawing/2014/main" id="{3C489BAE-3317-6840-07A1-5AE4A2683E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95600" y="4798761"/>
                  <a:ext cx="221673" cy="11600"/>
                </a:xfrm>
                <a:prstGeom prst="line">
                  <a:avLst/>
                </a:prstGeom>
                <a:ln w="12700">
                  <a:solidFill>
                    <a:srgbClr val="FFBE7A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B0970C47-5DEB-FC8D-5C81-9F67F3A6EBBD}"/>
              </a:ext>
            </a:extLst>
          </p:cNvPr>
          <p:cNvSpPr txBox="1"/>
          <p:nvPr/>
        </p:nvSpPr>
        <p:spPr>
          <a:xfrm>
            <a:off x="356716" y="3412449"/>
            <a:ext cx="6087627" cy="483638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Gene editing efficiency of single AAV-mediated Nme</a:t>
            </a:r>
            <a:r>
              <a:rPr lang="en-US" altLang="zh-CN" sz="1200" b="1" kern="1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9 targeting </a:t>
            </a:r>
            <a:r>
              <a:rPr lang="en-US" altLang="zh-CN" sz="12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Vegfr2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post 15 days. 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A) Workflow for AAV subretinal injection in mice. 1</a:t>
            </a:r>
            <a:r>
              <a:rPr lang="en-US" altLang="zh-CN" sz="1200" dirty="0">
                <a:effectLst/>
                <a:latin typeface="等线" panose="02010600030101010101" pitchFamily="2" charset="-122"/>
                <a:cs typeface="Arial" panose="020B0604020202020204" pitchFamily="34" charset="0"/>
              </a:rPr>
              <a:t> x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10</a:t>
            </a:r>
            <a:r>
              <a:rPr lang="en-US" altLang="zh-CN" sz="12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10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VG AAV8 (9 </a:t>
            </a:r>
            <a:r>
              <a:rPr lang="en-US" altLang="zh-CN" sz="1200" dirty="0">
                <a:effectLst/>
                <a:latin typeface="等线" panose="02010600030101010101" pitchFamily="2" charset="-122"/>
                <a:cs typeface="Arial" panose="020B0604020202020204" pitchFamily="34" charset="0"/>
              </a:rPr>
              <a:t>x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10</a:t>
            </a:r>
            <a:r>
              <a:rPr lang="en-US" altLang="zh-CN" sz="12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9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VG Nme</a:t>
            </a:r>
            <a:r>
              <a:rPr lang="en-US" altLang="zh-CN" sz="12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2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Cas9 with 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Vegfr2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-g3+ 1</a:t>
            </a:r>
            <a:r>
              <a:rPr lang="en-US" altLang="zh-CN" sz="1200" dirty="0">
                <a:effectLst/>
                <a:latin typeface="等线" panose="02010600030101010101" pitchFamily="2" charset="-122"/>
                <a:cs typeface="Arial" panose="020B0604020202020204" pitchFamily="34" charset="0"/>
              </a:rPr>
              <a:t> x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10</a:t>
            </a:r>
            <a:r>
              <a:rPr lang="en-US" altLang="zh-CN" sz="12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9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VG GFP) was injected into 6-week-old mouse retina. Mouse RPE cells’ genomic DNA was isolated and extracted 15 days post-injection, then the editing efficiency was qualified by T7E1 assay and deep sequencing. (B) T7E1 assay showed the cleavage efficiency of AAV8-Nme</a:t>
            </a:r>
            <a:r>
              <a:rPr lang="en-US" altLang="zh-CN" sz="12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2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Cas9 with 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Vegfr2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-g3 in the RPE cell genome of treated mice. +, represented an individual sample.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C) Indel frequencies at the 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Vegfr2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-g3 site were measured through targeted deep sequencing. The negative control was the same in Fig2. Samples with reads over 10,000 were calculated. Error bars indicate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.e.m.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(n=3). Unpaired Student’s t-tests, **P&lt;0.01. (D) The indel profile induced by Nme</a:t>
            </a:r>
            <a:r>
              <a:rPr lang="en-US" altLang="zh-CN" sz="12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2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Cas9 with </a:t>
            </a:r>
            <a:r>
              <a:rPr lang="en-US" altLang="zh-CN" sz="1200" i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Vegfr2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-g3 in the genomes of mouse RPE cells. The frequencies of the top 8 were analyzed. +, insertion; –, deletion.</a:t>
            </a:r>
            <a:endParaRPr lang="zh-CN" altLang="en-US" sz="1200" dirty="0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35734401-DCEE-8D34-C5E7-7F03A14EF48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9564" y="1802413"/>
            <a:ext cx="1944624" cy="1481328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AB5647F7-DE89-A97C-C3DA-17BC8F5E904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915" y="1865739"/>
            <a:ext cx="1923011" cy="1100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729702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B26F312-FC23-B9F9-7137-FFC102E9186B}"/>
              </a:ext>
            </a:extLst>
          </p:cNvPr>
          <p:cNvSpPr txBox="1"/>
          <p:nvPr/>
        </p:nvSpPr>
        <p:spPr>
          <a:xfrm>
            <a:off x="269857" y="93447"/>
            <a:ext cx="645548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US" altLang="zh-CN" b="1" dirty="0"/>
              <a:t>Supplementary Table S3 Predicted off-target sites and corresponding primers</a:t>
            </a: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27354876-AC87-5B0A-966F-72ECA121BD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2546408"/>
              </p:ext>
            </p:extLst>
          </p:nvPr>
        </p:nvGraphicFramePr>
        <p:xfrm>
          <a:off x="192527" y="678222"/>
          <a:ext cx="6455484" cy="7697858"/>
        </p:xfrm>
        <a:graphic>
          <a:graphicData uri="http://schemas.openxmlformats.org/drawingml/2006/table">
            <a:tbl>
              <a:tblPr/>
              <a:tblGrid>
                <a:gridCol w="717276">
                  <a:extLst>
                    <a:ext uri="{9D8B030D-6E8A-4147-A177-3AD203B41FA5}">
                      <a16:colId xmlns:a16="http://schemas.microsoft.com/office/drawing/2014/main" val="1777953324"/>
                    </a:ext>
                  </a:extLst>
                </a:gridCol>
                <a:gridCol w="1158483">
                  <a:extLst>
                    <a:ext uri="{9D8B030D-6E8A-4147-A177-3AD203B41FA5}">
                      <a16:colId xmlns:a16="http://schemas.microsoft.com/office/drawing/2014/main" val="273180083"/>
                    </a:ext>
                  </a:extLst>
                </a:gridCol>
                <a:gridCol w="631371">
                  <a:extLst>
                    <a:ext uri="{9D8B030D-6E8A-4147-A177-3AD203B41FA5}">
                      <a16:colId xmlns:a16="http://schemas.microsoft.com/office/drawing/2014/main" val="2062451589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208526749"/>
                    </a:ext>
                  </a:extLst>
                </a:gridCol>
                <a:gridCol w="446314">
                  <a:extLst>
                    <a:ext uri="{9D8B030D-6E8A-4147-A177-3AD203B41FA5}">
                      <a16:colId xmlns:a16="http://schemas.microsoft.com/office/drawing/2014/main" val="1983976433"/>
                    </a:ext>
                  </a:extLst>
                </a:gridCol>
                <a:gridCol w="555172">
                  <a:extLst>
                    <a:ext uri="{9D8B030D-6E8A-4147-A177-3AD203B41FA5}">
                      <a16:colId xmlns:a16="http://schemas.microsoft.com/office/drawing/2014/main" val="3707189836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170381236"/>
                    </a:ext>
                  </a:extLst>
                </a:gridCol>
                <a:gridCol w="1012371">
                  <a:extLst>
                    <a:ext uri="{9D8B030D-6E8A-4147-A177-3AD203B41FA5}">
                      <a16:colId xmlns:a16="http://schemas.microsoft.com/office/drawing/2014/main" val="3689587151"/>
                    </a:ext>
                  </a:extLst>
                </a:gridCol>
                <a:gridCol w="943897">
                  <a:extLst>
                    <a:ext uri="{9D8B030D-6E8A-4147-A177-3AD203B41FA5}">
                      <a16:colId xmlns:a16="http://schemas.microsoft.com/office/drawing/2014/main" val="2634731671"/>
                    </a:ext>
                  </a:extLst>
                </a:gridCol>
              </a:tblGrid>
              <a:tr h="12537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Off-target site 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NA sequence 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omosome 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osition 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irection 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Mismatches 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Bulge Size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Forward primer 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Reverse primer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7282733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1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TGCTTGAGTTTCATAgCaAcACCCT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58466765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GGGTTGTTGTACAATGGAGAAG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ATGCTCGACACAACCCTTT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3484446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2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TGCTTGAGcTTCAttCCAGAGCAAG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4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9311759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GGAGCCAGGAAGAGTAAAGA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ATAACTCTGCATACCACGTCA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8703459"/>
                  </a:ext>
                </a:extLst>
              </a:tr>
              <a:tr h="12537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3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GCCTTGAGTTTCtACCCtGACTTCC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6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0062583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ACGGTTCGGAGCAAACACAA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CAATACAGCTAGCCTTGAAG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1582890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4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TtCTTGAcTTTCcACCCATGACTGGA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7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43315747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CTTATATAGCCCTGGCTCTGA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GAACAGTCCTCCTTGA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5604801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5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TGCTaGtGTTTCAAtCCAGACCCCT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7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45002099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TTAGGGCCCCTGGGAATAAAC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GGCAGGAAGATGTGATTGTCAG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3308457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6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TGCTTGAGgTTCAgCtTCAGACGTGA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3498050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ACCAAGACCTCATTCAACACTTG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TATCCCACTCACTCCATCC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6907347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7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TGCTTGAAGTTcCAACtCAGcCAGCC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4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70517817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GCTCATGTTGAGAATGGGAG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CATCAGTCACACCCAAGAAG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1902552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8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gGCTTGAGcTTCAACTCCAGtCAAAT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6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8145186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ATTCGGGGGTATGTCCTTG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TCACTGTGGCTGAATAAAGCA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6751157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9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TGCTTGAGTTcCAgCCCtGACTTCC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8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598392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TTTTAAGAGAGCAGCCGGAG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ACTGGGGAAAAGCTTGTTGT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4954867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Hif1</a:t>
                      </a:r>
                      <a:r>
                        <a:rPr lang="el-GR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α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3-OT10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TGCTTGAGGTTTCAAaCCAtAtCATT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X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2284589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CATCTGAAGCTCATGGATG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GGTCCTGAGTTCCAAGATTC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476658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1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CCTAGGTGGtgAcCTTCCAGGTG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6318800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CACTTTTCCTGCAGGTTTGTG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CATCTTACAGTGAGCACACC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045221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2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CCTGGTGaAaATCTTCCAGGAG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23023448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TGAGCAGTGGAAATCAGTCA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AAAATAGTCCCCTGTTCGTG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5443196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3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CCTGGTGGcCATGCTTCCctGGACT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7927188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TTAGTGAGGCAAGACACTGGG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GTGCCTCATTTCCTGTAGAG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4907610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4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CCATGcTGGtCAgCTTCCAGGAAAC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5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112248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TGTGGATATAGTGCCAGTGG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GAAGTGGGCTTTCCTAAGCA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9592833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5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gCCTGGTctACATCGTTCCAGGAC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8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5483456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CTCTGAAGCACAAGAAAACGA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TCACAGCTCATAGGTGACTCAG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9056856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6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CCTGGGTGGACATCTTCCcaGGC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9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799200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GCCTGTCCTCTTTAAGATCG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TGGAGCCATATGGGGAAAT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2463874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7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CCTaGTGGAaAaCTTCCAAGGACAT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9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0706619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GCTCTAACAGAGGCAAAGTTG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TCATTGCTTCGCATTGTGTGT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3144341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8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gCCTGGTctACATCATTCCAGGAC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5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35278206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GGGGCCCAGAATCTCCATTT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AGGCACACATGTGATAGGTAC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267331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9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CCaGGTGGACtTCTGTCaAGGTGTC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6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7157174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GAAGAAAACTCATCACGGCA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GCTACAGATGAATTTAAGAACG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4639845"/>
                  </a:ext>
                </a:extLst>
              </a:tr>
              <a:tr h="12537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a-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4-OT10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CCTGGTGGACATCTTCtAatTCT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X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89380440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GGAAGCTTACCTTATGCAGGA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CAGAACCTCTTGCCCATTG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0986645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1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TGCAGATGtaCCcAGGTCAGGCATC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20032584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ATTCTGGGCCTTGCTGGTAA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CCTCAGTAGAATTGAAGGCG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8409973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2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TGAGATGCTCaAAGGCagAGGCCT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3584620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AGTCAGCCTTAAAGACTCGG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ACCCATCCCACCAATAGTTC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861197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3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TGAGcTGACTCCAAGGTCAcaCA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4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02785184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CCTAAGGGTCAGTGATAACT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CATCTTCCGTTTTCCCGTA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6883965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4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gGAGcTAGCTCCAAGaTCAGGGAG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7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8066496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ACTCTCCCTGTTTACA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GATAACACTGATTGTGCCC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3583633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5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TcAGATGCCCTtCAAGGTCAGGGCCT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7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9956276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AGGACATCCAAACTGC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TCCATAACCAGCTTGACAGG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2483991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6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gTGCAGATGCTCaAAGGTCAGGACGA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X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6148604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CCACTTATGGTGGATCAGG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AGGGGTAAGTACTCCAGGGT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4300268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7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TGAGATcCTCCAgGGTCTtGGCAGC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69027452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CCAAAGTTTATGGTGCCTCC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CATCTCAACACATGGGGAC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307724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8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TaAGAaGCTTCCAAGGaCAGGGAA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5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68753109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TCTGCTTTTGCTCTTCGGTG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GCAATGCAACAGAGCACTTAC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155704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9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ATGAGATGGCTCaAcGGTtAGGAATT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6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2364710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GTGTGAAGGTGTTAGATCTTGGA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TCATCCGTAACAAGATCTCTACTG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7422502"/>
                  </a:ext>
                </a:extLst>
              </a:tr>
              <a:tr h="1880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egfr2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-g3-OT10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GtTGAGATGAgTCCAAGGTtAGGGCTGCC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chr17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8080961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+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TGGGTTGAATTCCAGACCGTT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GCTGCTCAGAATGAAGTCGAT</a:t>
                      </a:r>
                    </a:p>
                  </a:txBody>
                  <a:tcPr marL="4478" marR="4478" marT="447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70447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367421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6D13F39E-F41E-6902-B85B-B39061F96C9B}"/>
              </a:ext>
            </a:extLst>
          </p:cNvPr>
          <p:cNvGrpSpPr/>
          <p:nvPr/>
        </p:nvGrpSpPr>
        <p:grpSpPr>
          <a:xfrm>
            <a:off x="456899" y="457769"/>
            <a:ext cx="5164273" cy="2356188"/>
            <a:chOff x="376321" y="342674"/>
            <a:chExt cx="5164273" cy="2356188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C6221077-A054-3BE4-933A-76F1A07251CE}"/>
                </a:ext>
              </a:extLst>
            </p:cNvPr>
            <p:cNvSpPr txBox="1"/>
            <p:nvPr/>
          </p:nvSpPr>
          <p:spPr>
            <a:xfrm>
              <a:off x="376321" y="34267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cs typeface="+mn-ea"/>
                  <a:sym typeface="+mn-lt"/>
                </a:rPr>
                <a:t>A</a:t>
              </a:r>
              <a:endParaRPr lang="zh-CN" altLang="en-US" sz="1600" b="1" dirty="0">
                <a:cs typeface="+mn-ea"/>
                <a:sym typeface="+mn-lt"/>
              </a:endParaRPr>
            </a:p>
          </p:txBody>
        </p: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7A188503-A7BE-9616-22ED-6B88873DB96F}"/>
                </a:ext>
              </a:extLst>
            </p:cNvPr>
            <p:cNvGrpSpPr/>
            <p:nvPr/>
          </p:nvGrpSpPr>
          <p:grpSpPr>
            <a:xfrm>
              <a:off x="893224" y="496841"/>
              <a:ext cx="3826321" cy="1014744"/>
              <a:chOff x="1038367" y="1324155"/>
              <a:chExt cx="3826321" cy="1014744"/>
            </a:xfrm>
          </p:grpSpPr>
          <p:sp>
            <p:nvSpPr>
              <p:cNvPr id="5" name="矩形 4">
                <a:extLst>
                  <a:ext uri="{FF2B5EF4-FFF2-40B4-BE49-F238E27FC236}">
                    <a16:creationId xmlns:a16="http://schemas.microsoft.com/office/drawing/2014/main" id="{723A8167-57E3-E34E-42DB-332BE61731C4}"/>
                  </a:ext>
                </a:extLst>
              </p:cNvPr>
              <p:cNvSpPr/>
              <p:nvPr/>
            </p:nvSpPr>
            <p:spPr>
              <a:xfrm>
                <a:off x="1038367" y="2056214"/>
                <a:ext cx="1795416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Laser induced CNV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40C64B23-58BA-F415-1489-47D73EE4029D}"/>
                  </a:ext>
                </a:extLst>
              </p:cNvPr>
              <p:cNvSpPr txBox="1"/>
              <p:nvPr/>
            </p:nvSpPr>
            <p:spPr>
              <a:xfrm>
                <a:off x="1507882" y="132415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d0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cxnSp>
            <p:nvCxnSpPr>
              <p:cNvPr id="7" name="直接箭头连接符 6">
                <a:extLst>
                  <a:ext uri="{FF2B5EF4-FFF2-40B4-BE49-F238E27FC236}">
                    <a16:creationId xmlns:a16="http://schemas.microsoft.com/office/drawing/2014/main" id="{540F0072-0C20-DB04-2D97-0DE669F0F1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46727" y="1881851"/>
                <a:ext cx="362074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18A55E98-7675-D0FF-2990-E7B74A7BF1D7}"/>
                  </a:ext>
                </a:extLst>
              </p:cNvPr>
              <p:cNvSpPr txBox="1"/>
              <p:nvPr/>
            </p:nvSpPr>
            <p:spPr>
              <a:xfrm>
                <a:off x="3122570" y="1326297"/>
                <a:ext cx="78579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d3 ~ d22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4E49D5C0-334A-2259-D35D-583C2D818CDF}"/>
                  </a:ext>
                </a:extLst>
              </p:cNvPr>
              <p:cNvSpPr txBox="1"/>
              <p:nvPr/>
            </p:nvSpPr>
            <p:spPr>
              <a:xfrm>
                <a:off x="2701968" y="2061900"/>
                <a:ext cx="216272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RPE flat-mount analysis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id="{C7AB2514-3CC5-9201-9BE2-C0BA1D2520E1}"/>
                  </a:ext>
                </a:extLst>
              </p:cNvPr>
              <p:cNvGrpSpPr/>
              <p:nvPr/>
            </p:nvGrpSpPr>
            <p:grpSpPr>
              <a:xfrm>
                <a:off x="1292850" y="1538675"/>
                <a:ext cx="784647" cy="499273"/>
                <a:chOff x="967517" y="1775931"/>
                <a:chExt cx="920293" cy="585585"/>
              </a:xfrm>
            </p:grpSpPr>
            <p:pic>
              <p:nvPicPr>
                <p:cNvPr id="17" name="图片 16">
                  <a:extLst>
                    <a:ext uri="{FF2B5EF4-FFF2-40B4-BE49-F238E27FC236}">
                      <a16:creationId xmlns:a16="http://schemas.microsoft.com/office/drawing/2014/main" id="{EDABA18F-6B82-2306-C88E-045ED8F8DA8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967517" y="2002290"/>
                  <a:ext cx="851052" cy="359226"/>
                </a:xfrm>
                <a:prstGeom prst="rect">
                  <a:avLst/>
                </a:prstGeom>
              </p:spPr>
            </p:pic>
            <p:sp>
              <p:nvSpPr>
                <p:cNvPr id="18" name="闪电形 17">
                  <a:extLst>
                    <a:ext uri="{FF2B5EF4-FFF2-40B4-BE49-F238E27FC236}">
                      <a16:creationId xmlns:a16="http://schemas.microsoft.com/office/drawing/2014/main" id="{E150284F-083A-33DE-F0BF-E42C08D06CA0}"/>
                    </a:ext>
                  </a:extLst>
                </p:cNvPr>
                <p:cNvSpPr/>
                <p:nvPr/>
              </p:nvSpPr>
              <p:spPr>
                <a:xfrm rot="441954" flipH="1">
                  <a:off x="1740171" y="1775931"/>
                  <a:ext cx="147639" cy="308334"/>
                </a:xfrm>
                <a:prstGeom prst="lightningBolt">
                  <a:avLst/>
                </a:prstGeom>
                <a:solidFill>
                  <a:srgbClr val="FFBE7A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566" dirty="0">
                    <a:cs typeface="+mn-ea"/>
                    <a:sym typeface="+mn-lt"/>
                  </a:endParaRPr>
                </a:p>
              </p:txBody>
            </p:sp>
          </p:grpSp>
          <p:grpSp>
            <p:nvGrpSpPr>
              <p:cNvPr id="19" name="组合 18">
                <a:extLst>
                  <a:ext uri="{FF2B5EF4-FFF2-40B4-BE49-F238E27FC236}">
                    <a16:creationId xmlns:a16="http://schemas.microsoft.com/office/drawing/2014/main" id="{08496634-4ED4-42EB-87EC-0800F56D5E4C}"/>
                  </a:ext>
                </a:extLst>
              </p:cNvPr>
              <p:cNvGrpSpPr/>
              <p:nvPr/>
            </p:nvGrpSpPr>
            <p:grpSpPr>
              <a:xfrm>
                <a:off x="3307964" y="1657183"/>
                <a:ext cx="358897" cy="363817"/>
                <a:chOff x="3488299" y="546752"/>
                <a:chExt cx="2994960" cy="3036014"/>
              </a:xfrm>
            </p:grpSpPr>
            <p:sp>
              <p:nvSpPr>
                <p:cNvPr id="20" name="任意多边形: 形状 19">
                  <a:extLst>
                    <a:ext uri="{FF2B5EF4-FFF2-40B4-BE49-F238E27FC236}">
                      <a16:creationId xmlns:a16="http://schemas.microsoft.com/office/drawing/2014/main" id="{5EA0520F-F4C5-E080-D4A2-532E2983C23C}"/>
                    </a:ext>
                  </a:extLst>
                </p:cNvPr>
                <p:cNvSpPr/>
                <p:nvPr/>
              </p:nvSpPr>
              <p:spPr>
                <a:xfrm>
                  <a:off x="3488299" y="546752"/>
                  <a:ext cx="2994960" cy="3036014"/>
                </a:xfrm>
                <a:custGeom>
                  <a:avLst/>
                  <a:gdLst>
                    <a:gd name="connsiteX0" fmla="*/ 1258585 w 2994958"/>
                    <a:gd name="connsiteY0" fmla="*/ 1135295 h 3036014"/>
                    <a:gd name="connsiteX1" fmla="*/ 1248311 w 2994958"/>
                    <a:gd name="connsiteY1" fmla="*/ 1109609 h 3036014"/>
                    <a:gd name="connsiteX2" fmla="*/ 1222625 w 2994958"/>
                    <a:gd name="connsiteY2" fmla="*/ 1073650 h 3036014"/>
                    <a:gd name="connsiteX3" fmla="*/ 1212351 w 2994958"/>
                    <a:gd name="connsiteY3" fmla="*/ 1058239 h 3036014"/>
                    <a:gd name="connsiteX4" fmla="*/ 1196940 w 2994958"/>
                    <a:gd name="connsiteY4" fmla="*/ 1047964 h 3036014"/>
                    <a:gd name="connsiteX5" fmla="*/ 1191803 w 2994958"/>
                    <a:gd name="connsiteY5" fmla="*/ 1027416 h 3036014"/>
                    <a:gd name="connsiteX6" fmla="*/ 1176391 w 2994958"/>
                    <a:gd name="connsiteY6" fmla="*/ 1001731 h 3036014"/>
                    <a:gd name="connsiteX7" fmla="*/ 1155843 w 2994958"/>
                    <a:gd name="connsiteY7" fmla="*/ 955497 h 3036014"/>
                    <a:gd name="connsiteX8" fmla="*/ 1140432 w 2994958"/>
                    <a:gd name="connsiteY8" fmla="*/ 909263 h 3036014"/>
                    <a:gd name="connsiteX9" fmla="*/ 1130158 w 2994958"/>
                    <a:gd name="connsiteY9" fmla="*/ 878441 h 3036014"/>
                    <a:gd name="connsiteX10" fmla="*/ 1114746 w 2994958"/>
                    <a:gd name="connsiteY10" fmla="*/ 857893 h 3036014"/>
                    <a:gd name="connsiteX11" fmla="*/ 1094198 w 2994958"/>
                    <a:gd name="connsiteY11" fmla="*/ 811659 h 3036014"/>
                    <a:gd name="connsiteX12" fmla="*/ 1068513 w 2994958"/>
                    <a:gd name="connsiteY12" fmla="*/ 770562 h 3036014"/>
                    <a:gd name="connsiteX13" fmla="*/ 1053102 w 2994958"/>
                    <a:gd name="connsiteY13" fmla="*/ 729466 h 3036014"/>
                    <a:gd name="connsiteX14" fmla="*/ 1042827 w 2994958"/>
                    <a:gd name="connsiteY14" fmla="*/ 719191 h 3036014"/>
                    <a:gd name="connsiteX15" fmla="*/ 1032553 w 2994958"/>
                    <a:gd name="connsiteY15" fmla="*/ 703780 h 3036014"/>
                    <a:gd name="connsiteX16" fmla="*/ 1022279 w 2994958"/>
                    <a:gd name="connsiteY16" fmla="*/ 683232 h 3036014"/>
                    <a:gd name="connsiteX17" fmla="*/ 1012005 w 2994958"/>
                    <a:gd name="connsiteY17" fmla="*/ 667821 h 3036014"/>
                    <a:gd name="connsiteX18" fmla="*/ 1001731 w 2994958"/>
                    <a:gd name="connsiteY18" fmla="*/ 647272 h 3036014"/>
                    <a:gd name="connsiteX19" fmla="*/ 991457 w 2994958"/>
                    <a:gd name="connsiteY19" fmla="*/ 631861 h 3036014"/>
                    <a:gd name="connsiteX20" fmla="*/ 950360 w 2994958"/>
                    <a:gd name="connsiteY20" fmla="*/ 554805 h 3036014"/>
                    <a:gd name="connsiteX21" fmla="*/ 940086 w 2994958"/>
                    <a:gd name="connsiteY21" fmla="*/ 529120 h 3036014"/>
                    <a:gd name="connsiteX22" fmla="*/ 919537 w 2994958"/>
                    <a:gd name="connsiteY22" fmla="*/ 508571 h 3036014"/>
                    <a:gd name="connsiteX23" fmla="*/ 904126 w 2994958"/>
                    <a:gd name="connsiteY23" fmla="*/ 477749 h 3036014"/>
                    <a:gd name="connsiteX24" fmla="*/ 893852 w 2994958"/>
                    <a:gd name="connsiteY24" fmla="*/ 441789 h 3036014"/>
                    <a:gd name="connsiteX25" fmla="*/ 883578 w 2994958"/>
                    <a:gd name="connsiteY25" fmla="*/ 426378 h 3036014"/>
                    <a:gd name="connsiteX26" fmla="*/ 868167 w 2994958"/>
                    <a:gd name="connsiteY26" fmla="*/ 400693 h 3036014"/>
                    <a:gd name="connsiteX27" fmla="*/ 852755 w 2994958"/>
                    <a:gd name="connsiteY27" fmla="*/ 369870 h 3036014"/>
                    <a:gd name="connsiteX28" fmla="*/ 837344 w 2994958"/>
                    <a:gd name="connsiteY28" fmla="*/ 339048 h 3036014"/>
                    <a:gd name="connsiteX29" fmla="*/ 821933 w 2994958"/>
                    <a:gd name="connsiteY29" fmla="*/ 313362 h 3036014"/>
                    <a:gd name="connsiteX30" fmla="*/ 816796 w 2994958"/>
                    <a:gd name="connsiteY30" fmla="*/ 297951 h 3036014"/>
                    <a:gd name="connsiteX31" fmla="*/ 801385 w 2994958"/>
                    <a:gd name="connsiteY31" fmla="*/ 272266 h 3036014"/>
                    <a:gd name="connsiteX32" fmla="*/ 796248 w 2994958"/>
                    <a:gd name="connsiteY32" fmla="*/ 241443 h 3036014"/>
                    <a:gd name="connsiteX33" fmla="*/ 791111 w 2994958"/>
                    <a:gd name="connsiteY33" fmla="*/ 226032 h 3036014"/>
                    <a:gd name="connsiteX34" fmla="*/ 811659 w 2994958"/>
                    <a:gd name="connsiteY34" fmla="*/ 154113 h 3036014"/>
                    <a:gd name="connsiteX35" fmla="*/ 827070 w 2994958"/>
                    <a:gd name="connsiteY35" fmla="*/ 138702 h 3036014"/>
                    <a:gd name="connsiteX36" fmla="*/ 842481 w 2994958"/>
                    <a:gd name="connsiteY36" fmla="*/ 133564 h 3036014"/>
                    <a:gd name="connsiteX37" fmla="*/ 863030 w 2994958"/>
                    <a:gd name="connsiteY37" fmla="*/ 123290 h 3036014"/>
                    <a:gd name="connsiteX38" fmla="*/ 888715 w 2994958"/>
                    <a:gd name="connsiteY38" fmla="*/ 107879 h 3036014"/>
                    <a:gd name="connsiteX39" fmla="*/ 909263 w 2994958"/>
                    <a:gd name="connsiteY39" fmla="*/ 102742 h 3036014"/>
                    <a:gd name="connsiteX40" fmla="*/ 940086 w 2994958"/>
                    <a:gd name="connsiteY40" fmla="*/ 92468 h 3036014"/>
                    <a:gd name="connsiteX41" fmla="*/ 965771 w 2994958"/>
                    <a:gd name="connsiteY41" fmla="*/ 87331 h 3036014"/>
                    <a:gd name="connsiteX42" fmla="*/ 1012005 w 2994958"/>
                    <a:gd name="connsiteY42" fmla="*/ 71920 h 3036014"/>
                    <a:gd name="connsiteX43" fmla="*/ 1032553 w 2994958"/>
                    <a:gd name="connsiteY43" fmla="*/ 61645 h 3036014"/>
                    <a:gd name="connsiteX44" fmla="*/ 1063376 w 2994958"/>
                    <a:gd name="connsiteY44" fmla="*/ 56508 h 3036014"/>
                    <a:gd name="connsiteX45" fmla="*/ 1089061 w 2994958"/>
                    <a:gd name="connsiteY45" fmla="*/ 51371 h 3036014"/>
                    <a:gd name="connsiteX46" fmla="*/ 1160980 w 2994958"/>
                    <a:gd name="connsiteY46" fmla="*/ 41097 h 3036014"/>
                    <a:gd name="connsiteX47" fmla="*/ 1186666 w 2994958"/>
                    <a:gd name="connsiteY47" fmla="*/ 30823 h 3036014"/>
                    <a:gd name="connsiteX48" fmla="*/ 1217488 w 2994958"/>
                    <a:gd name="connsiteY48" fmla="*/ 25686 h 3036014"/>
                    <a:gd name="connsiteX49" fmla="*/ 1238036 w 2994958"/>
                    <a:gd name="connsiteY49" fmla="*/ 20549 h 3036014"/>
                    <a:gd name="connsiteX50" fmla="*/ 1253448 w 2994958"/>
                    <a:gd name="connsiteY50" fmla="*/ 15412 h 3036014"/>
                    <a:gd name="connsiteX51" fmla="*/ 1392149 w 2994958"/>
                    <a:gd name="connsiteY51" fmla="*/ 0 h 3036014"/>
                    <a:gd name="connsiteX52" fmla="*/ 1643866 w 2994958"/>
                    <a:gd name="connsiteY52" fmla="*/ 5138 h 3036014"/>
                    <a:gd name="connsiteX53" fmla="*/ 1679825 w 2994958"/>
                    <a:gd name="connsiteY53" fmla="*/ 10275 h 3036014"/>
                    <a:gd name="connsiteX54" fmla="*/ 1731196 w 2994958"/>
                    <a:gd name="connsiteY54" fmla="*/ 15412 h 3036014"/>
                    <a:gd name="connsiteX55" fmla="*/ 1756881 w 2994958"/>
                    <a:gd name="connsiteY55" fmla="*/ 25686 h 3036014"/>
                    <a:gd name="connsiteX56" fmla="*/ 1782567 w 2994958"/>
                    <a:gd name="connsiteY56" fmla="*/ 30823 h 3036014"/>
                    <a:gd name="connsiteX57" fmla="*/ 1797978 w 2994958"/>
                    <a:gd name="connsiteY57" fmla="*/ 35960 h 3036014"/>
                    <a:gd name="connsiteX58" fmla="*/ 1828800 w 2994958"/>
                    <a:gd name="connsiteY58" fmla="*/ 41097 h 3036014"/>
                    <a:gd name="connsiteX59" fmla="*/ 1880171 w 2994958"/>
                    <a:gd name="connsiteY59" fmla="*/ 56508 h 3036014"/>
                    <a:gd name="connsiteX60" fmla="*/ 1967502 w 2994958"/>
                    <a:gd name="connsiteY60" fmla="*/ 66782 h 3036014"/>
                    <a:gd name="connsiteX61" fmla="*/ 2034284 w 2994958"/>
                    <a:gd name="connsiteY61" fmla="*/ 82194 h 3036014"/>
                    <a:gd name="connsiteX62" fmla="*/ 2085654 w 2994958"/>
                    <a:gd name="connsiteY62" fmla="*/ 97605 h 3036014"/>
                    <a:gd name="connsiteX63" fmla="*/ 2111340 w 2994958"/>
                    <a:gd name="connsiteY63" fmla="*/ 107879 h 3036014"/>
                    <a:gd name="connsiteX64" fmla="*/ 2126751 w 2994958"/>
                    <a:gd name="connsiteY64" fmla="*/ 118153 h 3036014"/>
                    <a:gd name="connsiteX65" fmla="*/ 2147299 w 2994958"/>
                    <a:gd name="connsiteY65" fmla="*/ 128427 h 3036014"/>
                    <a:gd name="connsiteX66" fmla="*/ 2162711 w 2994958"/>
                    <a:gd name="connsiteY66" fmla="*/ 143839 h 3036014"/>
                    <a:gd name="connsiteX67" fmla="*/ 2208944 w 2994958"/>
                    <a:gd name="connsiteY67" fmla="*/ 169524 h 3036014"/>
                    <a:gd name="connsiteX68" fmla="*/ 2224355 w 2994958"/>
                    <a:gd name="connsiteY68" fmla="*/ 184935 h 3036014"/>
                    <a:gd name="connsiteX69" fmla="*/ 2239767 w 2994958"/>
                    <a:gd name="connsiteY69" fmla="*/ 195209 h 3036014"/>
                    <a:gd name="connsiteX70" fmla="*/ 2260315 w 2994958"/>
                    <a:gd name="connsiteY70" fmla="*/ 210621 h 3036014"/>
                    <a:gd name="connsiteX71" fmla="*/ 2286000 w 2994958"/>
                    <a:gd name="connsiteY71" fmla="*/ 226032 h 3036014"/>
                    <a:gd name="connsiteX72" fmla="*/ 2301412 w 2994958"/>
                    <a:gd name="connsiteY72" fmla="*/ 236306 h 3036014"/>
                    <a:gd name="connsiteX73" fmla="*/ 2321960 w 2994958"/>
                    <a:gd name="connsiteY73" fmla="*/ 246580 h 3036014"/>
                    <a:gd name="connsiteX74" fmla="*/ 2347645 w 2994958"/>
                    <a:gd name="connsiteY74" fmla="*/ 267129 h 3036014"/>
                    <a:gd name="connsiteX75" fmla="*/ 2357920 w 2994958"/>
                    <a:gd name="connsiteY75" fmla="*/ 277403 h 3036014"/>
                    <a:gd name="connsiteX76" fmla="*/ 2383605 w 2994958"/>
                    <a:gd name="connsiteY76" fmla="*/ 292814 h 3036014"/>
                    <a:gd name="connsiteX77" fmla="*/ 2409290 w 2994958"/>
                    <a:gd name="connsiteY77" fmla="*/ 313362 h 3036014"/>
                    <a:gd name="connsiteX78" fmla="*/ 2440113 w 2994958"/>
                    <a:gd name="connsiteY78" fmla="*/ 333911 h 3036014"/>
                    <a:gd name="connsiteX79" fmla="*/ 2460661 w 2994958"/>
                    <a:gd name="connsiteY79" fmla="*/ 354459 h 3036014"/>
                    <a:gd name="connsiteX80" fmla="*/ 2481209 w 2994958"/>
                    <a:gd name="connsiteY80" fmla="*/ 369870 h 3036014"/>
                    <a:gd name="connsiteX81" fmla="*/ 2512032 w 2994958"/>
                    <a:gd name="connsiteY81" fmla="*/ 395555 h 3036014"/>
                    <a:gd name="connsiteX82" fmla="*/ 2527443 w 2994958"/>
                    <a:gd name="connsiteY82" fmla="*/ 405830 h 3036014"/>
                    <a:gd name="connsiteX83" fmla="*/ 2542854 w 2994958"/>
                    <a:gd name="connsiteY83" fmla="*/ 421241 h 3036014"/>
                    <a:gd name="connsiteX84" fmla="*/ 2568540 w 2994958"/>
                    <a:gd name="connsiteY84" fmla="*/ 441789 h 3036014"/>
                    <a:gd name="connsiteX85" fmla="*/ 2589088 w 2994958"/>
                    <a:gd name="connsiteY85" fmla="*/ 462338 h 3036014"/>
                    <a:gd name="connsiteX86" fmla="*/ 2609636 w 2994958"/>
                    <a:gd name="connsiteY86" fmla="*/ 477749 h 3036014"/>
                    <a:gd name="connsiteX87" fmla="*/ 2619911 w 2994958"/>
                    <a:gd name="connsiteY87" fmla="*/ 488023 h 3036014"/>
                    <a:gd name="connsiteX88" fmla="*/ 2635322 w 2994958"/>
                    <a:gd name="connsiteY88" fmla="*/ 498297 h 3036014"/>
                    <a:gd name="connsiteX89" fmla="*/ 2661007 w 2994958"/>
                    <a:gd name="connsiteY89" fmla="*/ 518845 h 3036014"/>
                    <a:gd name="connsiteX90" fmla="*/ 2686693 w 2994958"/>
                    <a:gd name="connsiteY90" fmla="*/ 549668 h 3036014"/>
                    <a:gd name="connsiteX91" fmla="*/ 2712378 w 2994958"/>
                    <a:gd name="connsiteY91" fmla="*/ 580490 h 3036014"/>
                    <a:gd name="connsiteX92" fmla="*/ 2717515 w 2994958"/>
                    <a:gd name="connsiteY92" fmla="*/ 595902 h 3036014"/>
                    <a:gd name="connsiteX93" fmla="*/ 2686693 w 2994958"/>
                    <a:gd name="connsiteY93" fmla="*/ 631861 h 3036014"/>
                    <a:gd name="connsiteX94" fmla="*/ 2671281 w 2994958"/>
                    <a:gd name="connsiteY94" fmla="*/ 642135 h 3036014"/>
                    <a:gd name="connsiteX95" fmla="*/ 2655870 w 2994958"/>
                    <a:gd name="connsiteY95" fmla="*/ 657546 h 3036014"/>
                    <a:gd name="connsiteX96" fmla="*/ 2614773 w 2994958"/>
                    <a:gd name="connsiteY96" fmla="*/ 683232 h 3036014"/>
                    <a:gd name="connsiteX97" fmla="*/ 2573677 w 2994958"/>
                    <a:gd name="connsiteY97" fmla="*/ 714054 h 3036014"/>
                    <a:gd name="connsiteX98" fmla="*/ 2553129 w 2994958"/>
                    <a:gd name="connsiteY98" fmla="*/ 729466 h 3036014"/>
                    <a:gd name="connsiteX99" fmla="*/ 2527443 w 2994958"/>
                    <a:gd name="connsiteY99" fmla="*/ 739740 h 3036014"/>
                    <a:gd name="connsiteX100" fmla="*/ 2501758 w 2994958"/>
                    <a:gd name="connsiteY100" fmla="*/ 755151 h 3036014"/>
                    <a:gd name="connsiteX101" fmla="*/ 2486346 w 2994958"/>
                    <a:gd name="connsiteY101" fmla="*/ 760288 h 3036014"/>
                    <a:gd name="connsiteX102" fmla="*/ 2434976 w 2994958"/>
                    <a:gd name="connsiteY102" fmla="*/ 791111 h 3036014"/>
                    <a:gd name="connsiteX103" fmla="*/ 2414427 w 2994958"/>
                    <a:gd name="connsiteY103" fmla="*/ 801385 h 3036014"/>
                    <a:gd name="connsiteX104" fmla="*/ 2393879 w 2994958"/>
                    <a:gd name="connsiteY104" fmla="*/ 816796 h 3036014"/>
                    <a:gd name="connsiteX105" fmla="*/ 2373331 w 2994958"/>
                    <a:gd name="connsiteY105" fmla="*/ 827070 h 3036014"/>
                    <a:gd name="connsiteX106" fmla="*/ 2342508 w 2994958"/>
                    <a:gd name="connsiteY106" fmla="*/ 847618 h 3036014"/>
                    <a:gd name="connsiteX107" fmla="*/ 2321960 w 2994958"/>
                    <a:gd name="connsiteY107" fmla="*/ 868167 h 3036014"/>
                    <a:gd name="connsiteX108" fmla="*/ 2265452 w 2994958"/>
                    <a:gd name="connsiteY108" fmla="*/ 909263 h 3036014"/>
                    <a:gd name="connsiteX109" fmla="*/ 2239767 w 2994958"/>
                    <a:gd name="connsiteY109" fmla="*/ 940086 h 3036014"/>
                    <a:gd name="connsiteX110" fmla="*/ 2198670 w 2994958"/>
                    <a:gd name="connsiteY110" fmla="*/ 970908 h 3036014"/>
                    <a:gd name="connsiteX111" fmla="*/ 2162711 w 2994958"/>
                    <a:gd name="connsiteY111" fmla="*/ 1006868 h 3036014"/>
                    <a:gd name="connsiteX112" fmla="*/ 2147299 w 2994958"/>
                    <a:gd name="connsiteY112" fmla="*/ 1012005 h 3036014"/>
                    <a:gd name="connsiteX113" fmla="*/ 2131888 w 2994958"/>
                    <a:gd name="connsiteY113" fmla="*/ 1027416 h 3036014"/>
                    <a:gd name="connsiteX114" fmla="*/ 2111340 w 2994958"/>
                    <a:gd name="connsiteY114" fmla="*/ 1037690 h 3036014"/>
                    <a:gd name="connsiteX115" fmla="*/ 2085654 w 2994958"/>
                    <a:gd name="connsiteY115" fmla="*/ 1058239 h 3036014"/>
                    <a:gd name="connsiteX116" fmla="*/ 2070243 w 2994958"/>
                    <a:gd name="connsiteY116" fmla="*/ 1068513 h 3036014"/>
                    <a:gd name="connsiteX117" fmla="*/ 2059969 w 2994958"/>
                    <a:gd name="connsiteY117" fmla="*/ 1083924 h 3036014"/>
                    <a:gd name="connsiteX118" fmla="*/ 2044558 w 2994958"/>
                    <a:gd name="connsiteY118" fmla="*/ 1089061 h 3036014"/>
                    <a:gd name="connsiteX119" fmla="*/ 2024009 w 2994958"/>
                    <a:gd name="connsiteY119" fmla="*/ 1104472 h 3036014"/>
                    <a:gd name="connsiteX120" fmla="*/ 2008598 w 2994958"/>
                    <a:gd name="connsiteY120" fmla="*/ 1119884 h 3036014"/>
                    <a:gd name="connsiteX121" fmla="*/ 1993187 w 2994958"/>
                    <a:gd name="connsiteY121" fmla="*/ 1125021 h 3036014"/>
                    <a:gd name="connsiteX122" fmla="*/ 1977776 w 2994958"/>
                    <a:gd name="connsiteY122" fmla="*/ 1145569 h 3036014"/>
                    <a:gd name="connsiteX123" fmla="*/ 1957227 w 2994958"/>
                    <a:gd name="connsiteY123" fmla="*/ 1155843 h 3036014"/>
                    <a:gd name="connsiteX124" fmla="*/ 1931542 w 2994958"/>
                    <a:gd name="connsiteY124" fmla="*/ 1181529 h 3036014"/>
                    <a:gd name="connsiteX125" fmla="*/ 1890445 w 2994958"/>
                    <a:gd name="connsiteY125" fmla="*/ 1222625 h 3036014"/>
                    <a:gd name="connsiteX126" fmla="*/ 1844212 w 2994958"/>
                    <a:gd name="connsiteY126" fmla="*/ 1253448 h 3036014"/>
                    <a:gd name="connsiteX127" fmla="*/ 1833937 w 2994958"/>
                    <a:gd name="connsiteY127" fmla="*/ 1268859 h 3036014"/>
                    <a:gd name="connsiteX128" fmla="*/ 1844212 w 2994958"/>
                    <a:gd name="connsiteY128" fmla="*/ 1279133 h 3036014"/>
                    <a:gd name="connsiteX129" fmla="*/ 1905857 w 2994958"/>
                    <a:gd name="connsiteY129" fmla="*/ 1273996 h 3036014"/>
                    <a:gd name="connsiteX130" fmla="*/ 1972639 w 2994958"/>
                    <a:gd name="connsiteY130" fmla="*/ 1253448 h 3036014"/>
                    <a:gd name="connsiteX131" fmla="*/ 2003461 w 2994958"/>
                    <a:gd name="connsiteY131" fmla="*/ 1243173 h 3036014"/>
                    <a:gd name="connsiteX132" fmla="*/ 2044558 w 2994958"/>
                    <a:gd name="connsiteY132" fmla="*/ 1238036 h 3036014"/>
                    <a:gd name="connsiteX133" fmla="*/ 2085654 w 2994958"/>
                    <a:gd name="connsiteY133" fmla="*/ 1227762 h 3036014"/>
                    <a:gd name="connsiteX134" fmla="*/ 2116477 w 2994958"/>
                    <a:gd name="connsiteY134" fmla="*/ 1217488 h 3036014"/>
                    <a:gd name="connsiteX135" fmla="*/ 2131888 w 2994958"/>
                    <a:gd name="connsiteY135" fmla="*/ 1212351 h 3036014"/>
                    <a:gd name="connsiteX136" fmla="*/ 2147299 w 2994958"/>
                    <a:gd name="connsiteY136" fmla="*/ 1207214 h 3036014"/>
                    <a:gd name="connsiteX137" fmla="*/ 2172985 w 2994958"/>
                    <a:gd name="connsiteY137" fmla="*/ 1196940 h 3036014"/>
                    <a:gd name="connsiteX138" fmla="*/ 2214081 w 2994958"/>
                    <a:gd name="connsiteY138" fmla="*/ 1186666 h 3036014"/>
                    <a:gd name="connsiteX139" fmla="*/ 2234630 w 2994958"/>
                    <a:gd name="connsiteY139" fmla="*/ 1181529 h 3036014"/>
                    <a:gd name="connsiteX140" fmla="*/ 2255178 w 2994958"/>
                    <a:gd name="connsiteY140" fmla="*/ 1171254 h 3036014"/>
                    <a:gd name="connsiteX141" fmla="*/ 2280863 w 2994958"/>
                    <a:gd name="connsiteY141" fmla="*/ 1155843 h 3036014"/>
                    <a:gd name="connsiteX142" fmla="*/ 2332234 w 2994958"/>
                    <a:gd name="connsiteY142" fmla="*/ 1140432 h 3036014"/>
                    <a:gd name="connsiteX143" fmla="*/ 2404153 w 2994958"/>
                    <a:gd name="connsiteY143" fmla="*/ 1109609 h 3036014"/>
                    <a:gd name="connsiteX144" fmla="*/ 2424702 w 2994958"/>
                    <a:gd name="connsiteY144" fmla="*/ 1099335 h 3036014"/>
                    <a:gd name="connsiteX145" fmla="*/ 2440113 w 2994958"/>
                    <a:gd name="connsiteY145" fmla="*/ 1089061 h 3036014"/>
                    <a:gd name="connsiteX146" fmla="*/ 2506895 w 2994958"/>
                    <a:gd name="connsiteY146" fmla="*/ 1068513 h 3036014"/>
                    <a:gd name="connsiteX147" fmla="*/ 2558266 w 2994958"/>
                    <a:gd name="connsiteY147" fmla="*/ 1047964 h 3036014"/>
                    <a:gd name="connsiteX148" fmla="*/ 2573677 w 2994958"/>
                    <a:gd name="connsiteY148" fmla="*/ 1037690 h 3036014"/>
                    <a:gd name="connsiteX149" fmla="*/ 2599362 w 2994958"/>
                    <a:gd name="connsiteY149" fmla="*/ 1027416 h 3036014"/>
                    <a:gd name="connsiteX150" fmla="*/ 2640459 w 2994958"/>
                    <a:gd name="connsiteY150" fmla="*/ 1006868 h 3036014"/>
                    <a:gd name="connsiteX151" fmla="*/ 2661007 w 2994958"/>
                    <a:gd name="connsiteY151" fmla="*/ 991457 h 3036014"/>
                    <a:gd name="connsiteX152" fmla="*/ 2681555 w 2994958"/>
                    <a:gd name="connsiteY152" fmla="*/ 986320 h 3036014"/>
                    <a:gd name="connsiteX153" fmla="*/ 2722652 w 2994958"/>
                    <a:gd name="connsiteY153" fmla="*/ 960634 h 3036014"/>
                    <a:gd name="connsiteX154" fmla="*/ 2743200 w 2994958"/>
                    <a:gd name="connsiteY154" fmla="*/ 955497 h 3036014"/>
                    <a:gd name="connsiteX155" fmla="*/ 2768886 w 2994958"/>
                    <a:gd name="connsiteY155" fmla="*/ 945223 h 3036014"/>
                    <a:gd name="connsiteX156" fmla="*/ 2784297 w 2994958"/>
                    <a:gd name="connsiteY156" fmla="*/ 934949 h 3036014"/>
                    <a:gd name="connsiteX157" fmla="*/ 2809982 w 2994958"/>
                    <a:gd name="connsiteY157" fmla="*/ 924675 h 3036014"/>
                    <a:gd name="connsiteX158" fmla="*/ 2866490 w 2994958"/>
                    <a:gd name="connsiteY158" fmla="*/ 909263 h 3036014"/>
                    <a:gd name="connsiteX159" fmla="*/ 2902450 w 2994958"/>
                    <a:gd name="connsiteY159" fmla="*/ 914400 h 3036014"/>
                    <a:gd name="connsiteX160" fmla="*/ 2917861 w 2994958"/>
                    <a:gd name="connsiteY160" fmla="*/ 924675 h 3036014"/>
                    <a:gd name="connsiteX161" fmla="*/ 2938409 w 2994958"/>
                    <a:gd name="connsiteY161" fmla="*/ 960634 h 3036014"/>
                    <a:gd name="connsiteX162" fmla="*/ 2948684 w 2994958"/>
                    <a:gd name="connsiteY162" fmla="*/ 1012005 h 3036014"/>
                    <a:gd name="connsiteX163" fmla="*/ 2958958 w 2994958"/>
                    <a:gd name="connsiteY163" fmla="*/ 1047964 h 3036014"/>
                    <a:gd name="connsiteX164" fmla="*/ 2969232 w 2994958"/>
                    <a:gd name="connsiteY164" fmla="*/ 1166117 h 3036014"/>
                    <a:gd name="connsiteX165" fmla="*/ 2974369 w 2994958"/>
                    <a:gd name="connsiteY165" fmla="*/ 1202077 h 3036014"/>
                    <a:gd name="connsiteX166" fmla="*/ 2989780 w 2994958"/>
                    <a:gd name="connsiteY166" fmla="*/ 1253448 h 3036014"/>
                    <a:gd name="connsiteX167" fmla="*/ 2989780 w 2994958"/>
                    <a:gd name="connsiteY167" fmla="*/ 1720922 h 3036014"/>
                    <a:gd name="connsiteX168" fmla="*/ 2974369 w 2994958"/>
                    <a:gd name="connsiteY168" fmla="*/ 1792841 h 3036014"/>
                    <a:gd name="connsiteX169" fmla="*/ 2969232 w 2994958"/>
                    <a:gd name="connsiteY169" fmla="*/ 1818526 h 3036014"/>
                    <a:gd name="connsiteX170" fmla="*/ 2964095 w 2994958"/>
                    <a:gd name="connsiteY170" fmla="*/ 1833938 h 3036014"/>
                    <a:gd name="connsiteX171" fmla="*/ 2958958 w 2994958"/>
                    <a:gd name="connsiteY171" fmla="*/ 1864760 h 3036014"/>
                    <a:gd name="connsiteX172" fmla="*/ 2953821 w 2994958"/>
                    <a:gd name="connsiteY172" fmla="*/ 1880171 h 3036014"/>
                    <a:gd name="connsiteX173" fmla="*/ 2948684 w 2994958"/>
                    <a:gd name="connsiteY173" fmla="*/ 1900720 h 3036014"/>
                    <a:gd name="connsiteX174" fmla="*/ 2943546 w 2994958"/>
                    <a:gd name="connsiteY174" fmla="*/ 1916131 h 3036014"/>
                    <a:gd name="connsiteX175" fmla="*/ 2933272 w 2994958"/>
                    <a:gd name="connsiteY175" fmla="*/ 1957227 h 3036014"/>
                    <a:gd name="connsiteX176" fmla="*/ 2928135 w 2994958"/>
                    <a:gd name="connsiteY176" fmla="*/ 1972639 h 3036014"/>
                    <a:gd name="connsiteX177" fmla="*/ 2912724 w 2994958"/>
                    <a:gd name="connsiteY177" fmla="*/ 2018872 h 3036014"/>
                    <a:gd name="connsiteX178" fmla="*/ 2902450 w 2994958"/>
                    <a:gd name="connsiteY178" fmla="*/ 2075380 h 3036014"/>
                    <a:gd name="connsiteX179" fmla="*/ 2897313 w 2994958"/>
                    <a:gd name="connsiteY179" fmla="*/ 2090791 h 3036014"/>
                    <a:gd name="connsiteX180" fmla="*/ 2892176 w 2994958"/>
                    <a:gd name="connsiteY180" fmla="*/ 2116477 h 3036014"/>
                    <a:gd name="connsiteX181" fmla="*/ 2876764 w 2994958"/>
                    <a:gd name="connsiteY181" fmla="*/ 2157573 h 3036014"/>
                    <a:gd name="connsiteX182" fmla="*/ 2861353 w 2994958"/>
                    <a:gd name="connsiteY182" fmla="*/ 2214081 h 3036014"/>
                    <a:gd name="connsiteX183" fmla="*/ 2840805 w 2994958"/>
                    <a:gd name="connsiteY183" fmla="*/ 2255178 h 3036014"/>
                    <a:gd name="connsiteX184" fmla="*/ 2835668 w 2994958"/>
                    <a:gd name="connsiteY184" fmla="*/ 2275726 h 3036014"/>
                    <a:gd name="connsiteX185" fmla="*/ 2804845 w 2994958"/>
                    <a:gd name="connsiteY185" fmla="*/ 2332234 h 3036014"/>
                    <a:gd name="connsiteX186" fmla="*/ 2779160 w 2994958"/>
                    <a:gd name="connsiteY186" fmla="*/ 2373331 h 3036014"/>
                    <a:gd name="connsiteX187" fmla="*/ 2774023 w 2994958"/>
                    <a:gd name="connsiteY187" fmla="*/ 2388742 h 3036014"/>
                    <a:gd name="connsiteX188" fmla="*/ 2748337 w 2994958"/>
                    <a:gd name="connsiteY188" fmla="*/ 2414427 h 3036014"/>
                    <a:gd name="connsiteX189" fmla="*/ 2717515 w 2994958"/>
                    <a:gd name="connsiteY189" fmla="*/ 2460661 h 3036014"/>
                    <a:gd name="connsiteX190" fmla="*/ 2712378 w 2994958"/>
                    <a:gd name="connsiteY190" fmla="*/ 2476072 h 3036014"/>
                    <a:gd name="connsiteX191" fmla="*/ 2691830 w 2994958"/>
                    <a:gd name="connsiteY191" fmla="*/ 2496621 h 3036014"/>
                    <a:gd name="connsiteX192" fmla="*/ 2655870 w 2994958"/>
                    <a:gd name="connsiteY192" fmla="*/ 2542854 h 3036014"/>
                    <a:gd name="connsiteX193" fmla="*/ 2650733 w 2994958"/>
                    <a:gd name="connsiteY193" fmla="*/ 2558266 h 3036014"/>
                    <a:gd name="connsiteX194" fmla="*/ 2594225 w 2994958"/>
                    <a:gd name="connsiteY194" fmla="*/ 2609636 h 3036014"/>
                    <a:gd name="connsiteX195" fmla="*/ 2573677 w 2994958"/>
                    <a:gd name="connsiteY195" fmla="*/ 2630185 h 3036014"/>
                    <a:gd name="connsiteX196" fmla="*/ 2558266 w 2994958"/>
                    <a:gd name="connsiteY196" fmla="*/ 2640459 h 3036014"/>
                    <a:gd name="connsiteX197" fmla="*/ 2527443 w 2994958"/>
                    <a:gd name="connsiteY197" fmla="*/ 2661007 h 3036014"/>
                    <a:gd name="connsiteX198" fmla="*/ 2460661 w 2994958"/>
                    <a:gd name="connsiteY198" fmla="*/ 2707241 h 3036014"/>
                    <a:gd name="connsiteX199" fmla="*/ 2450387 w 2994958"/>
                    <a:gd name="connsiteY199" fmla="*/ 2722652 h 3036014"/>
                    <a:gd name="connsiteX200" fmla="*/ 2409290 w 2994958"/>
                    <a:gd name="connsiteY200" fmla="*/ 2738063 h 3036014"/>
                    <a:gd name="connsiteX201" fmla="*/ 2388742 w 2994958"/>
                    <a:gd name="connsiteY201" fmla="*/ 2732926 h 3036014"/>
                    <a:gd name="connsiteX202" fmla="*/ 2342508 w 2994958"/>
                    <a:gd name="connsiteY202" fmla="*/ 2717515 h 3036014"/>
                    <a:gd name="connsiteX203" fmla="*/ 2311686 w 2994958"/>
                    <a:gd name="connsiteY203" fmla="*/ 2691830 h 3036014"/>
                    <a:gd name="connsiteX204" fmla="*/ 2275726 w 2994958"/>
                    <a:gd name="connsiteY204" fmla="*/ 2655870 h 3036014"/>
                    <a:gd name="connsiteX205" fmla="*/ 2260315 w 2994958"/>
                    <a:gd name="connsiteY205" fmla="*/ 2640459 h 3036014"/>
                    <a:gd name="connsiteX206" fmla="*/ 2244904 w 2994958"/>
                    <a:gd name="connsiteY206" fmla="*/ 2609636 h 3036014"/>
                    <a:gd name="connsiteX207" fmla="*/ 2224355 w 2994958"/>
                    <a:gd name="connsiteY207" fmla="*/ 2594225 h 3036014"/>
                    <a:gd name="connsiteX208" fmla="*/ 2203807 w 2994958"/>
                    <a:gd name="connsiteY208" fmla="*/ 2558266 h 3036014"/>
                    <a:gd name="connsiteX209" fmla="*/ 2172985 w 2994958"/>
                    <a:gd name="connsiteY209" fmla="*/ 2517169 h 3036014"/>
                    <a:gd name="connsiteX210" fmla="*/ 2152436 w 2994958"/>
                    <a:gd name="connsiteY210" fmla="*/ 2476072 h 3036014"/>
                    <a:gd name="connsiteX211" fmla="*/ 2131888 w 2994958"/>
                    <a:gd name="connsiteY211" fmla="*/ 2445250 h 3036014"/>
                    <a:gd name="connsiteX212" fmla="*/ 2111340 w 2994958"/>
                    <a:gd name="connsiteY212" fmla="*/ 2404153 h 3036014"/>
                    <a:gd name="connsiteX213" fmla="*/ 2095929 w 2994958"/>
                    <a:gd name="connsiteY213" fmla="*/ 2373331 h 3036014"/>
                    <a:gd name="connsiteX214" fmla="*/ 2044558 w 2994958"/>
                    <a:gd name="connsiteY214" fmla="*/ 2291138 h 3036014"/>
                    <a:gd name="connsiteX215" fmla="*/ 2034284 w 2994958"/>
                    <a:gd name="connsiteY215" fmla="*/ 2270589 h 3036014"/>
                    <a:gd name="connsiteX216" fmla="*/ 2013735 w 2994958"/>
                    <a:gd name="connsiteY216" fmla="*/ 2244904 h 3036014"/>
                    <a:gd name="connsiteX217" fmla="*/ 2003461 w 2994958"/>
                    <a:gd name="connsiteY217" fmla="*/ 2224355 h 3036014"/>
                    <a:gd name="connsiteX218" fmla="*/ 1982913 w 2994958"/>
                    <a:gd name="connsiteY218" fmla="*/ 2198670 h 3036014"/>
                    <a:gd name="connsiteX219" fmla="*/ 1962364 w 2994958"/>
                    <a:gd name="connsiteY219" fmla="*/ 2172985 h 3036014"/>
                    <a:gd name="connsiteX220" fmla="*/ 1941816 w 2994958"/>
                    <a:gd name="connsiteY220" fmla="*/ 2137025 h 3036014"/>
                    <a:gd name="connsiteX221" fmla="*/ 1931542 w 2994958"/>
                    <a:gd name="connsiteY221" fmla="*/ 2121614 h 3036014"/>
                    <a:gd name="connsiteX222" fmla="*/ 1916131 w 2994958"/>
                    <a:gd name="connsiteY222" fmla="*/ 2106203 h 3036014"/>
                    <a:gd name="connsiteX223" fmla="*/ 1905857 w 2994958"/>
                    <a:gd name="connsiteY223" fmla="*/ 2090791 h 3036014"/>
                    <a:gd name="connsiteX224" fmla="*/ 1869897 w 2994958"/>
                    <a:gd name="connsiteY224" fmla="*/ 2049695 h 3036014"/>
                    <a:gd name="connsiteX225" fmla="*/ 1839075 w 2994958"/>
                    <a:gd name="connsiteY225" fmla="*/ 2008598 h 3036014"/>
                    <a:gd name="connsiteX226" fmla="*/ 1823663 w 2994958"/>
                    <a:gd name="connsiteY226" fmla="*/ 1988050 h 3036014"/>
                    <a:gd name="connsiteX227" fmla="*/ 1833937 w 2994958"/>
                    <a:gd name="connsiteY227" fmla="*/ 2059969 h 3036014"/>
                    <a:gd name="connsiteX228" fmla="*/ 1849349 w 2994958"/>
                    <a:gd name="connsiteY228" fmla="*/ 2095929 h 3036014"/>
                    <a:gd name="connsiteX229" fmla="*/ 1859623 w 2994958"/>
                    <a:gd name="connsiteY229" fmla="*/ 2157573 h 3036014"/>
                    <a:gd name="connsiteX230" fmla="*/ 1864760 w 2994958"/>
                    <a:gd name="connsiteY230" fmla="*/ 2172985 h 3036014"/>
                    <a:gd name="connsiteX231" fmla="*/ 1880171 w 2994958"/>
                    <a:gd name="connsiteY231" fmla="*/ 2214081 h 3036014"/>
                    <a:gd name="connsiteX232" fmla="*/ 1885308 w 2994958"/>
                    <a:gd name="connsiteY232" fmla="*/ 2239767 h 3036014"/>
                    <a:gd name="connsiteX233" fmla="*/ 1900720 w 2994958"/>
                    <a:gd name="connsiteY233" fmla="*/ 2275726 h 3036014"/>
                    <a:gd name="connsiteX234" fmla="*/ 1905857 w 2994958"/>
                    <a:gd name="connsiteY234" fmla="*/ 2296275 h 3036014"/>
                    <a:gd name="connsiteX235" fmla="*/ 1910994 w 2994958"/>
                    <a:gd name="connsiteY235" fmla="*/ 2321960 h 3036014"/>
                    <a:gd name="connsiteX236" fmla="*/ 1926405 w 2994958"/>
                    <a:gd name="connsiteY236" fmla="*/ 2352782 h 3036014"/>
                    <a:gd name="connsiteX237" fmla="*/ 1936679 w 2994958"/>
                    <a:gd name="connsiteY237" fmla="*/ 2383605 h 3036014"/>
                    <a:gd name="connsiteX238" fmla="*/ 1967502 w 2994958"/>
                    <a:gd name="connsiteY238" fmla="*/ 2429839 h 3036014"/>
                    <a:gd name="connsiteX239" fmla="*/ 1977776 w 2994958"/>
                    <a:gd name="connsiteY239" fmla="*/ 2460661 h 3036014"/>
                    <a:gd name="connsiteX240" fmla="*/ 1998324 w 2994958"/>
                    <a:gd name="connsiteY240" fmla="*/ 2506895 h 3036014"/>
                    <a:gd name="connsiteX241" fmla="*/ 2008598 w 2994958"/>
                    <a:gd name="connsiteY241" fmla="*/ 2527443 h 3036014"/>
                    <a:gd name="connsiteX242" fmla="*/ 2034284 w 2994958"/>
                    <a:gd name="connsiteY242" fmla="*/ 2583951 h 3036014"/>
                    <a:gd name="connsiteX243" fmla="*/ 2039421 w 2994958"/>
                    <a:gd name="connsiteY243" fmla="*/ 2614773 h 3036014"/>
                    <a:gd name="connsiteX244" fmla="*/ 2049695 w 2994958"/>
                    <a:gd name="connsiteY244" fmla="*/ 2650733 h 3036014"/>
                    <a:gd name="connsiteX245" fmla="*/ 2054832 w 2994958"/>
                    <a:gd name="connsiteY245" fmla="*/ 2671281 h 3036014"/>
                    <a:gd name="connsiteX246" fmla="*/ 2070243 w 2994958"/>
                    <a:gd name="connsiteY246" fmla="*/ 2722652 h 3036014"/>
                    <a:gd name="connsiteX247" fmla="*/ 2075380 w 2994958"/>
                    <a:gd name="connsiteY247" fmla="*/ 2758612 h 3036014"/>
                    <a:gd name="connsiteX248" fmla="*/ 2085654 w 2994958"/>
                    <a:gd name="connsiteY248" fmla="*/ 2809982 h 3036014"/>
                    <a:gd name="connsiteX249" fmla="*/ 2090791 w 2994958"/>
                    <a:gd name="connsiteY249" fmla="*/ 2835668 h 3036014"/>
                    <a:gd name="connsiteX250" fmla="*/ 2059969 w 2994958"/>
                    <a:gd name="connsiteY250" fmla="*/ 2964095 h 3036014"/>
                    <a:gd name="connsiteX251" fmla="*/ 2044558 w 2994958"/>
                    <a:gd name="connsiteY251" fmla="*/ 2969232 h 3036014"/>
                    <a:gd name="connsiteX252" fmla="*/ 2024009 w 2994958"/>
                    <a:gd name="connsiteY252" fmla="*/ 2979506 h 3036014"/>
                    <a:gd name="connsiteX253" fmla="*/ 2008598 w 2994958"/>
                    <a:gd name="connsiteY253" fmla="*/ 2984643 h 3036014"/>
                    <a:gd name="connsiteX254" fmla="*/ 1972639 w 2994958"/>
                    <a:gd name="connsiteY254" fmla="*/ 3000054 h 3036014"/>
                    <a:gd name="connsiteX255" fmla="*/ 1936679 w 2994958"/>
                    <a:gd name="connsiteY255" fmla="*/ 3005191 h 3036014"/>
                    <a:gd name="connsiteX256" fmla="*/ 1880171 w 2994958"/>
                    <a:gd name="connsiteY256" fmla="*/ 3015466 h 3036014"/>
                    <a:gd name="connsiteX257" fmla="*/ 1787704 w 2994958"/>
                    <a:gd name="connsiteY257" fmla="*/ 3025740 h 3036014"/>
                    <a:gd name="connsiteX258" fmla="*/ 1715785 w 2994958"/>
                    <a:gd name="connsiteY258" fmla="*/ 3030877 h 3036014"/>
                    <a:gd name="connsiteX259" fmla="*/ 1469205 w 2994958"/>
                    <a:gd name="connsiteY259" fmla="*/ 3036014 h 3036014"/>
                    <a:gd name="connsiteX260" fmla="*/ 1284270 w 2994958"/>
                    <a:gd name="connsiteY260" fmla="*/ 3025740 h 3036014"/>
                    <a:gd name="connsiteX261" fmla="*/ 1186666 w 2994958"/>
                    <a:gd name="connsiteY261" fmla="*/ 3000054 h 3036014"/>
                    <a:gd name="connsiteX262" fmla="*/ 1160980 w 2994958"/>
                    <a:gd name="connsiteY262" fmla="*/ 2994917 h 3036014"/>
                    <a:gd name="connsiteX263" fmla="*/ 1089061 w 2994958"/>
                    <a:gd name="connsiteY263" fmla="*/ 2974369 h 3036014"/>
                    <a:gd name="connsiteX264" fmla="*/ 1042827 w 2994958"/>
                    <a:gd name="connsiteY264" fmla="*/ 2958958 h 3036014"/>
                    <a:gd name="connsiteX265" fmla="*/ 1027416 w 2994958"/>
                    <a:gd name="connsiteY265" fmla="*/ 2953821 h 3036014"/>
                    <a:gd name="connsiteX266" fmla="*/ 996594 w 2994958"/>
                    <a:gd name="connsiteY266" fmla="*/ 2948684 h 3036014"/>
                    <a:gd name="connsiteX267" fmla="*/ 970908 w 2994958"/>
                    <a:gd name="connsiteY267" fmla="*/ 2938409 h 3036014"/>
                    <a:gd name="connsiteX268" fmla="*/ 940086 w 2994958"/>
                    <a:gd name="connsiteY268" fmla="*/ 2928135 h 3036014"/>
                    <a:gd name="connsiteX269" fmla="*/ 904126 w 2994958"/>
                    <a:gd name="connsiteY269" fmla="*/ 2912724 h 3036014"/>
                    <a:gd name="connsiteX270" fmla="*/ 883578 w 2994958"/>
                    <a:gd name="connsiteY270" fmla="*/ 2902450 h 3036014"/>
                    <a:gd name="connsiteX271" fmla="*/ 863030 w 2994958"/>
                    <a:gd name="connsiteY271" fmla="*/ 2897313 h 3036014"/>
                    <a:gd name="connsiteX272" fmla="*/ 832207 w 2994958"/>
                    <a:gd name="connsiteY272" fmla="*/ 2876764 h 3036014"/>
                    <a:gd name="connsiteX273" fmla="*/ 765425 w 2994958"/>
                    <a:gd name="connsiteY273" fmla="*/ 2845942 h 3036014"/>
                    <a:gd name="connsiteX274" fmla="*/ 739740 w 2994958"/>
                    <a:gd name="connsiteY274" fmla="*/ 2830531 h 3036014"/>
                    <a:gd name="connsiteX275" fmla="*/ 719191 w 2994958"/>
                    <a:gd name="connsiteY275" fmla="*/ 2815120 h 3036014"/>
                    <a:gd name="connsiteX276" fmla="*/ 693506 w 2994958"/>
                    <a:gd name="connsiteY276" fmla="*/ 2809982 h 3036014"/>
                    <a:gd name="connsiteX277" fmla="*/ 683232 w 2994958"/>
                    <a:gd name="connsiteY277" fmla="*/ 2794571 h 3036014"/>
                    <a:gd name="connsiteX278" fmla="*/ 626724 w 2994958"/>
                    <a:gd name="connsiteY278" fmla="*/ 2768886 h 3036014"/>
                    <a:gd name="connsiteX279" fmla="*/ 606176 w 2994958"/>
                    <a:gd name="connsiteY279" fmla="*/ 2753475 h 3036014"/>
                    <a:gd name="connsiteX280" fmla="*/ 570216 w 2994958"/>
                    <a:gd name="connsiteY280" fmla="*/ 2722652 h 3036014"/>
                    <a:gd name="connsiteX281" fmla="*/ 523982 w 2994958"/>
                    <a:gd name="connsiteY281" fmla="*/ 2691830 h 3036014"/>
                    <a:gd name="connsiteX282" fmla="*/ 498297 w 2994958"/>
                    <a:gd name="connsiteY282" fmla="*/ 2661007 h 3036014"/>
                    <a:gd name="connsiteX283" fmla="*/ 482886 w 2994958"/>
                    <a:gd name="connsiteY283" fmla="*/ 2650733 h 3036014"/>
                    <a:gd name="connsiteX284" fmla="*/ 446926 w 2994958"/>
                    <a:gd name="connsiteY284" fmla="*/ 2614773 h 3036014"/>
                    <a:gd name="connsiteX285" fmla="*/ 421241 w 2994958"/>
                    <a:gd name="connsiteY285" fmla="*/ 2594225 h 3036014"/>
                    <a:gd name="connsiteX286" fmla="*/ 410967 w 2994958"/>
                    <a:gd name="connsiteY286" fmla="*/ 2578814 h 3036014"/>
                    <a:gd name="connsiteX287" fmla="*/ 395555 w 2994958"/>
                    <a:gd name="connsiteY287" fmla="*/ 2568540 h 3036014"/>
                    <a:gd name="connsiteX288" fmla="*/ 354459 w 2994958"/>
                    <a:gd name="connsiteY288" fmla="*/ 2532580 h 3036014"/>
                    <a:gd name="connsiteX289" fmla="*/ 339048 w 2994958"/>
                    <a:gd name="connsiteY289" fmla="*/ 2501758 h 3036014"/>
                    <a:gd name="connsiteX290" fmla="*/ 344185 w 2994958"/>
                    <a:gd name="connsiteY290" fmla="*/ 2465798 h 3036014"/>
                    <a:gd name="connsiteX291" fmla="*/ 380144 w 2994958"/>
                    <a:gd name="connsiteY291" fmla="*/ 2429839 h 3036014"/>
                    <a:gd name="connsiteX292" fmla="*/ 405830 w 2994958"/>
                    <a:gd name="connsiteY292" fmla="*/ 2414427 h 3036014"/>
                    <a:gd name="connsiteX293" fmla="*/ 452063 w 2994958"/>
                    <a:gd name="connsiteY293" fmla="*/ 2378468 h 3036014"/>
                    <a:gd name="connsiteX294" fmla="*/ 462337 w 2994958"/>
                    <a:gd name="connsiteY294" fmla="*/ 2363057 h 3036014"/>
                    <a:gd name="connsiteX295" fmla="*/ 513708 w 2994958"/>
                    <a:gd name="connsiteY295" fmla="*/ 2332234 h 3036014"/>
                    <a:gd name="connsiteX296" fmla="*/ 539394 w 2994958"/>
                    <a:gd name="connsiteY296" fmla="*/ 2311686 h 3036014"/>
                    <a:gd name="connsiteX297" fmla="*/ 559942 w 2994958"/>
                    <a:gd name="connsiteY297" fmla="*/ 2301412 h 3036014"/>
                    <a:gd name="connsiteX298" fmla="*/ 606176 w 2994958"/>
                    <a:gd name="connsiteY298" fmla="*/ 2270589 h 3036014"/>
                    <a:gd name="connsiteX299" fmla="*/ 621587 w 2994958"/>
                    <a:gd name="connsiteY299" fmla="*/ 2265452 h 3036014"/>
                    <a:gd name="connsiteX300" fmla="*/ 642135 w 2994958"/>
                    <a:gd name="connsiteY300" fmla="*/ 2255178 h 3036014"/>
                    <a:gd name="connsiteX301" fmla="*/ 667821 w 2994958"/>
                    <a:gd name="connsiteY301" fmla="*/ 2234630 h 3036014"/>
                    <a:gd name="connsiteX302" fmla="*/ 719191 w 2994958"/>
                    <a:gd name="connsiteY302" fmla="*/ 2193533 h 3036014"/>
                    <a:gd name="connsiteX303" fmla="*/ 750014 w 2994958"/>
                    <a:gd name="connsiteY303" fmla="*/ 2172985 h 3036014"/>
                    <a:gd name="connsiteX304" fmla="*/ 770562 w 2994958"/>
                    <a:gd name="connsiteY304" fmla="*/ 2152436 h 3036014"/>
                    <a:gd name="connsiteX305" fmla="*/ 816796 w 2994958"/>
                    <a:gd name="connsiteY305" fmla="*/ 2116477 h 3036014"/>
                    <a:gd name="connsiteX306" fmla="*/ 842481 w 2994958"/>
                    <a:gd name="connsiteY306" fmla="*/ 2095929 h 3036014"/>
                    <a:gd name="connsiteX307" fmla="*/ 863030 w 2994958"/>
                    <a:gd name="connsiteY307" fmla="*/ 2080517 h 3036014"/>
                    <a:gd name="connsiteX308" fmla="*/ 904126 w 2994958"/>
                    <a:gd name="connsiteY308" fmla="*/ 2039421 h 3036014"/>
                    <a:gd name="connsiteX309" fmla="*/ 919537 w 2994958"/>
                    <a:gd name="connsiteY309" fmla="*/ 2029146 h 3036014"/>
                    <a:gd name="connsiteX310" fmla="*/ 940086 w 2994958"/>
                    <a:gd name="connsiteY310" fmla="*/ 2003461 h 3036014"/>
                    <a:gd name="connsiteX311" fmla="*/ 965771 w 2994958"/>
                    <a:gd name="connsiteY311" fmla="*/ 1977776 h 3036014"/>
                    <a:gd name="connsiteX312" fmla="*/ 1001731 w 2994958"/>
                    <a:gd name="connsiteY312" fmla="*/ 1931542 h 3036014"/>
                    <a:gd name="connsiteX313" fmla="*/ 1006868 w 2994958"/>
                    <a:gd name="connsiteY313" fmla="*/ 1916131 h 3036014"/>
                    <a:gd name="connsiteX314" fmla="*/ 1022279 w 2994958"/>
                    <a:gd name="connsiteY314" fmla="*/ 1905857 h 3036014"/>
                    <a:gd name="connsiteX315" fmla="*/ 1032553 w 2994958"/>
                    <a:gd name="connsiteY315" fmla="*/ 1895582 h 3036014"/>
                    <a:gd name="connsiteX316" fmla="*/ 1017142 w 2994958"/>
                    <a:gd name="connsiteY316" fmla="*/ 1885308 h 3036014"/>
                    <a:gd name="connsiteX317" fmla="*/ 965771 w 2994958"/>
                    <a:gd name="connsiteY317" fmla="*/ 1905857 h 3036014"/>
                    <a:gd name="connsiteX318" fmla="*/ 950360 w 2994958"/>
                    <a:gd name="connsiteY318" fmla="*/ 1910994 h 3036014"/>
                    <a:gd name="connsiteX319" fmla="*/ 929812 w 2994958"/>
                    <a:gd name="connsiteY319" fmla="*/ 1926405 h 3036014"/>
                    <a:gd name="connsiteX320" fmla="*/ 863030 w 2994958"/>
                    <a:gd name="connsiteY320" fmla="*/ 1962364 h 3036014"/>
                    <a:gd name="connsiteX321" fmla="*/ 852755 w 2994958"/>
                    <a:gd name="connsiteY321" fmla="*/ 1972639 h 3036014"/>
                    <a:gd name="connsiteX322" fmla="*/ 811659 w 2994958"/>
                    <a:gd name="connsiteY322" fmla="*/ 1993187 h 3036014"/>
                    <a:gd name="connsiteX323" fmla="*/ 775699 w 2994958"/>
                    <a:gd name="connsiteY323" fmla="*/ 2018872 h 3036014"/>
                    <a:gd name="connsiteX324" fmla="*/ 760288 w 2994958"/>
                    <a:gd name="connsiteY324" fmla="*/ 2029146 h 3036014"/>
                    <a:gd name="connsiteX325" fmla="*/ 703780 w 2994958"/>
                    <a:gd name="connsiteY325" fmla="*/ 2049695 h 3036014"/>
                    <a:gd name="connsiteX326" fmla="*/ 683232 w 2994958"/>
                    <a:gd name="connsiteY326" fmla="*/ 2065106 h 3036014"/>
                    <a:gd name="connsiteX327" fmla="*/ 657546 w 2994958"/>
                    <a:gd name="connsiteY327" fmla="*/ 2075380 h 3036014"/>
                    <a:gd name="connsiteX328" fmla="*/ 631861 w 2994958"/>
                    <a:gd name="connsiteY328" fmla="*/ 2090791 h 3036014"/>
                    <a:gd name="connsiteX329" fmla="*/ 601039 w 2994958"/>
                    <a:gd name="connsiteY329" fmla="*/ 2106203 h 3036014"/>
                    <a:gd name="connsiteX330" fmla="*/ 580490 w 2994958"/>
                    <a:gd name="connsiteY330" fmla="*/ 2121614 h 3036014"/>
                    <a:gd name="connsiteX331" fmla="*/ 559942 w 2994958"/>
                    <a:gd name="connsiteY331" fmla="*/ 2131888 h 3036014"/>
                    <a:gd name="connsiteX332" fmla="*/ 539394 w 2994958"/>
                    <a:gd name="connsiteY332" fmla="*/ 2147299 h 3036014"/>
                    <a:gd name="connsiteX333" fmla="*/ 498297 w 2994958"/>
                    <a:gd name="connsiteY333" fmla="*/ 2167848 h 3036014"/>
                    <a:gd name="connsiteX334" fmla="*/ 482886 w 2994958"/>
                    <a:gd name="connsiteY334" fmla="*/ 2178122 h 3036014"/>
                    <a:gd name="connsiteX335" fmla="*/ 436652 w 2994958"/>
                    <a:gd name="connsiteY335" fmla="*/ 2198670 h 3036014"/>
                    <a:gd name="connsiteX336" fmla="*/ 405830 w 2994958"/>
                    <a:gd name="connsiteY336" fmla="*/ 2214081 h 3036014"/>
                    <a:gd name="connsiteX337" fmla="*/ 375007 w 2994958"/>
                    <a:gd name="connsiteY337" fmla="*/ 2224355 h 3036014"/>
                    <a:gd name="connsiteX338" fmla="*/ 349322 w 2994958"/>
                    <a:gd name="connsiteY338" fmla="*/ 2239767 h 3036014"/>
                    <a:gd name="connsiteX339" fmla="*/ 308225 w 2994958"/>
                    <a:gd name="connsiteY339" fmla="*/ 2255178 h 3036014"/>
                    <a:gd name="connsiteX340" fmla="*/ 261991 w 2994958"/>
                    <a:gd name="connsiteY340" fmla="*/ 2275726 h 3036014"/>
                    <a:gd name="connsiteX341" fmla="*/ 246580 w 2994958"/>
                    <a:gd name="connsiteY341" fmla="*/ 2286000 h 3036014"/>
                    <a:gd name="connsiteX342" fmla="*/ 231169 w 2994958"/>
                    <a:gd name="connsiteY342" fmla="*/ 2291138 h 3036014"/>
                    <a:gd name="connsiteX343" fmla="*/ 205484 w 2994958"/>
                    <a:gd name="connsiteY343" fmla="*/ 2311686 h 3036014"/>
                    <a:gd name="connsiteX344" fmla="*/ 190072 w 2994958"/>
                    <a:gd name="connsiteY344" fmla="*/ 2321960 h 3036014"/>
                    <a:gd name="connsiteX345" fmla="*/ 169524 w 2994958"/>
                    <a:gd name="connsiteY345" fmla="*/ 2286000 h 3036014"/>
                    <a:gd name="connsiteX346" fmla="*/ 164387 w 2994958"/>
                    <a:gd name="connsiteY346" fmla="*/ 2239767 h 3036014"/>
                    <a:gd name="connsiteX347" fmla="*/ 159250 w 2994958"/>
                    <a:gd name="connsiteY347" fmla="*/ 2219218 h 3036014"/>
                    <a:gd name="connsiteX348" fmla="*/ 154113 w 2994958"/>
                    <a:gd name="connsiteY348" fmla="*/ 2188396 h 3036014"/>
                    <a:gd name="connsiteX349" fmla="*/ 138702 w 2994958"/>
                    <a:gd name="connsiteY349" fmla="*/ 2147299 h 3036014"/>
                    <a:gd name="connsiteX350" fmla="*/ 123290 w 2994958"/>
                    <a:gd name="connsiteY350" fmla="*/ 2101066 h 3036014"/>
                    <a:gd name="connsiteX351" fmla="*/ 102742 w 2994958"/>
                    <a:gd name="connsiteY351" fmla="*/ 2070243 h 3036014"/>
                    <a:gd name="connsiteX352" fmla="*/ 92468 w 2994958"/>
                    <a:gd name="connsiteY352" fmla="*/ 2018872 h 3036014"/>
                    <a:gd name="connsiteX353" fmla="*/ 87331 w 2994958"/>
                    <a:gd name="connsiteY353" fmla="*/ 1998324 h 3036014"/>
                    <a:gd name="connsiteX354" fmla="*/ 77057 w 2994958"/>
                    <a:gd name="connsiteY354" fmla="*/ 1982913 h 3036014"/>
                    <a:gd name="connsiteX355" fmla="*/ 71920 w 2994958"/>
                    <a:gd name="connsiteY355" fmla="*/ 1967502 h 3036014"/>
                    <a:gd name="connsiteX356" fmla="*/ 66782 w 2994958"/>
                    <a:gd name="connsiteY356" fmla="*/ 1910994 h 3036014"/>
                    <a:gd name="connsiteX357" fmla="*/ 56508 w 2994958"/>
                    <a:gd name="connsiteY357" fmla="*/ 1880171 h 3036014"/>
                    <a:gd name="connsiteX358" fmla="*/ 35960 w 2994958"/>
                    <a:gd name="connsiteY358" fmla="*/ 1823663 h 3036014"/>
                    <a:gd name="connsiteX359" fmla="*/ 30823 w 2994958"/>
                    <a:gd name="connsiteY359" fmla="*/ 1808252 h 3036014"/>
                    <a:gd name="connsiteX360" fmla="*/ 10275 w 2994958"/>
                    <a:gd name="connsiteY360" fmla="*/ 1731196 h 3036014"/>
                    <a:gd name="connsiteX361" fmla="*/ 0 w 2994958"/>
                    <a:gd name="connsiteY361" fmla="*/ 1582221 h 3036014"/>
                    <a:gd name="connsiteX362" fmla="*/ 5137 w 2994958"/>
                    <a:gd name="connsiteY362" fmla="*/ 1294544 h 3036014"/>
                    <a:gd name="connsiteX363" fmla="*/ 20549 w 2994958"/>
                    <a:gd name="connsiteY363" fmla="*/ 1202077 h 3036014"/>
                    <a:gd name="connsiteX364" fmla="*/ 30823 w 2994958"/>
                    <a:gd name="connsiteY364" fmla="*/ 1155843 h 3036014"/>
                    <a:gd name="connsiteX365" fmla="*/ 35960 w 2994958"/>
                    <a:gd name="connsiteY365" fmla="*/ 1140432 h 3036014"/>
                    <a:gd name="connsiteX366" fmla="*/ 41097 w 2994958"/>
                    <a:gd name="connsiteY366" fmla="*/ 1109609 h 3036014"/>
                    <a:gd name="connsiteX367" fmla="*/ 56508 w 2994958"/>
                    <a:gd name="connsiteY367" fmla="*/ 1083924 h 3036014"/>
                    <a:gd name="connsiteX368" fmla="*/ 66782 w 2994958"/>
                    <a:gd name="connsiteY368" fmla="*/ 1058239 h 3036014"/>
                    <a:gd name="connsiteX369" fmla="*/ 77057 w 2994958"/>
                    <a:gd name="connsiteY369" fmla="*/ 1027416 h 3036014"/>
                    <a:gd name="connsiteX370" fmla="*/ 87331 w 2994958"/>
                    <a:gd name="connsiteY370" fmla="*/ 1001731 h 3036014"/>
                    <a:gd name="connsiteX371" fmla="*/ 97605 w 2994958"/>
                    <a:gd name="connsiteY371" fmla="*/ 960634 h 3036014"/>
                    <a:gd name="connsiteX372" fmla="*/ 107879 w 2994958"/>
                    <a:gd name="connsiteY372" fmla="*/ 934949 h 3036014"/>
                    <a:gd name="connsiteX373" fmla="*/ 113016 w 2994958"/>
                    <a:gd name="connsiteY373" fmla="*/ 914400 h 3036014"/>
                    <a:gd name="connsiteX374" fmla="*/ 133564 w 2994958"/>
                    <a:gd name="connsiteY374" fmla="*/ 873304 h 3036014"/>
                    <a:gd name="connsiteX375" fmla="*/ 154113 w 2994958"/>
                    <a:gd name="connsiteY375" fmla="*/ 821933 h 3036014"/>
                    <a:gd name="connsiteX376" fmla="*/ 164387 w 2994958"/>
                    <a:gd name="connsiteY376" fmla="*/ 796248 h 3036014"/>
                    <a:gd name="connsiteX377" fmla="*/ 184935 w 2994958"/>
                    <a:gd name="connsiteY377" fmla="*/ 755151 h 3036014"/>
                    <a:gd name="connsiteX378" fmla="*/ 195209 w 2994958"/>
                    <a:gd name="connsiteY378" fmla="*/ 708917 h 3036014"/>
                    <a:gd name="connsiteX379" fmla="*/ 205484 w 2994958"/>
                    <a:gd name="connsiteY379" fmla="*/ 698643 h 3036014"/>
                    <a:gd name="connsiteX380" fmla="*/ 215758 w 2994958"/>
                    <a:gd name="connsiteY380" fmla="*/ 667821 h 3036014"/>
                    <a:gd name="connsiteX381" fmla="*/ 246580 w 2994958"/>
                    <a:gd name="connsiteY381" fmla="*/ 636998 h 3036014"/>
                    <a:gd name="connsiteX382" fmla="*/ 256854 w 2994958"/>
                    <a:gd name="connsiteY382" fmla="*/ 621587 h 3036014"/>
                    <a:gd name="connsiteX383" fmla="*/ 277403 w 2994958"/>
                    <a:gd name="connsiteY383" fmla="*/ 595902 h 3036014"/>
                    <a:gd name="connsiteX384" fmla="*/ 282540 w 2994958"/>
                    <a:gd name="connsiteY384" fmla="*/ 580490 h 3036014"/>
                    <a:gd name="connsiteX385" fmla="*/ 313362 w 2994958"/>
                    <a:gd name="connsiteY385" fmla="*/ 549668 h 3036014"/>
                    <a:gd name="connsiteX386" fmla="*/ 333911 w 2994958"/>
                    <a:gd name="connsiteY386" fmla="*/ 529120 h 3036014"/>
                    <a:gd name="connsiteX387" fmla="*/ 344185 w 2994958"/>
                    <a:gd name="connsiteY387" fmla="*/ 513708 h 3036014"/>
                    <a:gd name="connsiteX388" fmla="*/ 380144 w 2994958"/>
                    <a:gd name="connsiteY388" fmla="*/ 477749 h 3036014"/>
                    <a:gd name="connsiteX389" fmla="*/ 405830 w 2994958"/>
                    <a:gd name="connsiteY389" fmla="*/ 452063 h 3036014"/>
                    <a:gd name="connsiteX390" fmla="*/ 457200 w 2994958"/>
                    <a:gd name="connsiteY390" fmla="*/ 410967 h 3036014"/>
                    <a:gd name="connsiteX391" fmla="*/ 467475 w 2994958"/>
                    <a:gd name="connsiteY391" fmla="*/ 395555 h 3036014"/>
                    <a:gd name="connsiteX392" fmla="*/ 498297 w 2994958"/>
                    <a:gd name="connsiteY392" fmla="*/ 400693 h 3036014"/>
                    <a:gd name="connsiteX393" fmla="*/ 544531 w 2994958"/>
                    <a:gd name="connsiteY393" fmla="*/ 426378 h 3036014"/>
                    <a:gd name="connsiteX394" fmla="*/ 585627 w 2994958"/>
                    <a:gd name="connsiteY394" fmla="*/ 446926 h 3036014"/>
                    <a:gd name="connsiteX395" fmla="*/ 616450 w 2994958"/>
                    <a:gd name="connsiteY395" fmla="*/ 472612 h 3036014"/>
                    <a:gd name="connsiteX396" fmla="*/ 642135 w 2994958"/>
                    <a:gd name="connsiteY396" fmla="*/ 493160 h 3036014"/>
                    <a:gd name="connsiteX397" fmla="*/ 662684 w 2994958"/>
                    <a:gd name="connsiteY397" fmla="*/ 518845 h 3036014"/>
                    <a:gd name="connsiteX398" fmla="*/ 672958 w 2994958"/>
                    <a:gd name="connsiteY398" fmla="*/ 529120 h 3036014"/>
                    <a:gd name="connsiteX399" fmla="*/ 683232 w 2994958"/>
                    <a:gd name="connsiteY399" fmla="*/ 544531 h 3036014"/>
                    <a:gd name="connsiteX400" fmla="*/ 703780 w 2994958"/>
                    <a:gd name="connsiteY400" fmla="*/ 565079 h 3036014"/>
                    <a:gd name="connsiteX401" fmla="*/ 724329 w 2994958"/>
                    <a:gd name="connsiteY401" fmla="*/ 595902 h 3036014"/>
                    <a:gd name="connsiteX402" fmla="*/ 739740 w 2994958"/>
                    <a:gd name="connsiteY402" fmla="*/ 611313 h 3036014"/>
                    <a:gd name="connsiteX403" fmla="*/ 765425 w 2994958"/>
                    <a:gd name="connsiteY403" fmla="*/ 647272 h 3036014"/>
                    <a:gd name="connsiteX404" fmla="*/ 780836 w 2994958"/>
                    <a:gd name="connsiteY404" fmla="*/ 672958 h 3036014"/>
                    <a:gd name="connsiteX405" fmla="*/ 811659 w 2994958"/>
                    <a:gd name="connsiteY405" fmla="*/ 703780 h 3036014"/>
                    <a:gd name="connsiteX406" fmla="*/ 827070 w 2994958"/>
                    <a:gd name="connsiteY406" fmla="*/ 719191 h 3036014"/>
                    <a:gd name="connsiteX407" fmla="*/ 868167 w 2994958"/>
                    <a:gd name="connsiteY407" fmla="*/ 765425 h 3036014"/>
                    <a:gd name="connsiteX408" fmla="*/ 888715 w 2994958"/>
                    <a:gd name="connsiteY408" fmla="*/ 791111 h 3036014"/>
                    <a:gd name="connsiteX409" fmla="*/ 904126 w 2994958"/>
                    <a:gd name="connsiteY409" fmla="*/ 806522 h 3036014"/>
                    <a:gd name="connsiteX410" fmla="*/ 914400 w 2994958"/>
                    <a:gd name="connsiteY410" fmla="*/ 821933 h 3036014"/>
                    <a:gd name="connsiteX411" fmla="*/ 945223 w 2994958"/>
                    <a:gd name="connsiteY411" fmla="*/ 852755 h 3036014"/>
                    <a:gd name="connsiteX412" fmla="*/ 970908 w 2994958"/>
                    <a:gd name="connsiteY412" fmla="*/ 883578 h 3036014"/>
                    <a:gd name="connsiteX413" fmla="*/ 986320 w 2994958"/>
                    <a:gd name="connsiteY413" fmla="*/ 904126 h 3036014"/>
                    <a:gd name="connsiteX414" fmla="*/ 1001731 w 2994958"/>
                    <a:gd name="connsiteY414" fmla="*/ 919538 h 3036014"/>
                    <a:gd name="connsiteX415" fmla="*/ 1012005 w 2994958"/>
                    <a:gd name="connsiteY415" fmla="*/ 934949 h 3036014"/>
                    <a:gd name="connsiteX416" fmla="*/ 1027416 w 2994958"/>
                    <a:gd name="connsiteY416" fmla="*/ 945223 h 3036014"/>
                    <a:gd name="connsiteX417" fmla="*/ 1047964 w 2994958"/>
                    <a:gd name="connsiteY417" fmla="*/ 970908 h 3036014"/>
                    <a:gd name="connsiteX418" fmla="*/ 1099335 w 2994958"/>
                    <a:gd name="connsiteY418" fmla="*/ 1017142 h 3036014"/>
                    <a:gd name="connsiteX419" fmla="*/ 1125021 w 2994958"/>
                    <a:gd name="connsiteY419" fmla="*/ 1032553 h 3036014"/>
                    <a:gd name="connsiteX420" fmla="*/ 1150706 w 2994958"/>
                    <a:gd name="connsiteY420" fmla="*/ 1058239 h 3036014"/>
                    <a:gd name="connsiteX421" fmla="*/ 1166117 w 2994958"/>
                    <a:gd name="connsiteY421" fmla="*/ 1073650 h 3036014"/>
                    <a:gd name="connsiteX422" fmla="*/ 1217488 w 2994958"/>
                    <a:gd name="connsiteY422" fmla="*/ 1109609 h 3036014"/>
                    <a:gd name="connsiteX423" fmla="*/ 1243173 w 2994958"/>
                    <a:gd name="connsiteY423" fmla="*/ 1135295 h 3036014"/>
                    <a:gd name="connsiteX424" fmla="*/ 1258585 w 2994958"/>
                    <a:gd name="connsiteY424" fmla="*/ 1135295 h 303601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  <a:cxn ang="0">
                      <a:pos x="connsiteX131" y="connsiteY131"/>
                    </a:cxn>
                    <a:cxn ang="0">
                      <a:pos x="connsiteX132" y="connsiteY132"/>
                    </a:cxn>
                    <a:cxn ang="0">
                      <a:pos x="connsiteX133" y="connsiteY133"/>
                    </a:cxn>
                    <a:cxn ang="0">
                      <a:pos x="connsiteX134" y="connsiteY134"/>
                    </a:cxn>
                    <a:cxn ang="0">
                      <a:pos x="connsiteX135" y="connsiteY135"/>
                    </a:cxn>
                    <a:cxn ang="0">
                      <a:pos x="connsiteX136" y="connsiteY136"/>
                    </a:cxn>
                    <a:cxn ang="0">
                      <a:pos x="connsiteX137" y="connsiteY137"/>
                    </a:cxn>
                    <a:cxn ang="0">
                      <a:pos x="connsiteX138" y="connsiteY138"/>
                    </a:cxn>
                    <a:cxn ang="0">
                      <a:pos x="connsiteX139" y="connsiteY139"/>
                    </a:cxn>
                    <a:cxn ang="0">
                      <a:pos x="connsiteX140" y="connsiteY140"/>
                    </a:cxn>
                    <a:cxn ang="0">
                      <a:pos x="connsiteX141" y="connsiteY141"/>
                    </a:cxn>
                    <a:cxn ang="0">
                      <a:pos x="connsiteX142" y="connsiteY142"/>
                    </a:cxn>
                    <a:cxn ang="0">
                      <a:pos x="connsiteX143" y="connsiteY143"/>
                    </a:cxn>
                    <a:cxn ang="0">
                      <a:pos x="connsiteX144" y="connsiteY144"/>
                    </a:cxn>
                    <a:cxn ang="0">
                      <a:pos x="connsiteX145" y="connsiteY145"/>
                    </a:cxn>
                    <a:cxn ang="0">
                      <a:pos x="connsiteX146" y="connsiteY146"/>
                    </a:cxn>
                    <a:cxn ang="0">
                      <a:pos x="connsiteX147" y="connsiteY147"/>
                    </a:cxn>
                    <a:cxn ang="0">
                      <a:pos x="connsiteX148" y="connsiteY148"/>
                    </a:cxn>
                    <a:cxn ang="0">
                      <a:pos x="connsiteX149" y="connsiteY149"/>
                    </a:cxn>
                    <a:cxn ang="0">
                      <a:pos x="connsiteX150" y="connsiteY150"/>
                    </a:cxn>
                    <a:cxn ang="0">
                      <a:pos x="connsiteX151" y="connsiteY151"/>
                    </a:cxn>
                    <a:cxn ang="0">
                      <a:pos x="connsiteX152" y="connsiteY152"/>
                    </a:cxn>
                    <a:cxn ang="0">
                      <a:pos x="connsiteX153" y="connsiteY153"/>
                    </a:cxn>
                    <a:cxn ang="0">
                      <a:pos x="connsiteX154" y="connsiteY154"/>
                    </a:cxn>
                    <a:cxn ang="0">
                      <a:pos x="connsiteX155" y="connsiteY155"/>
                    </a:cxn>
                    <a:cxn ang="0">
                      <a:pos x="connsiteX156" y="connsiteY156"/>
                    </a:cxn>
                    <a:cxn ang="0">
                      <a:pos x="connsiteX157" y="connsiteY157"/>
                    </a:cxn>
                    <a:cxn ang="0">
                      <a:pos x="connsiteX158" y="connsiteY158"/>
                    </a:cxn>
                    <a:cxn ang="0">
                      <a:pos x="connsiteX159" y="connsiteY159"/>
                    </a:cxn>
                    <a:cxn ang="0">
                      <a:pos x="connsiteX160" y="connsiteY160"/>
                    </a:cxn>
                    <a:cxn ang="0">
                      <a:pos x="connsiteX161" y="connsiteY161"/>
                    </a:cxn>
                    <a:cxn ang="0">
                      <a:pos x="connsiteX162" y="connsiteY162"/>
                    </a:cxn>
                    <a:cxn ang="0">
                      <a:pos x="connsiteX163" y="connsiteY163"/>
                    </a:cxn>
                    <a:cxn ang="0">
                      <a:pos x="connsiteX164" y="connsiteY164"/>
                    </a:cxn>
                    <a:cxn ang="0">
                      <a:pos x="connsiteX165" y="connsiteY165"/>
                    </a:cxn>
                    <a:cxn ang="0">
                      <a:pos x="connsiteX166" y="connsiteY166"/>
                    </a:cxn>
                    <a:cxn ang="0">
                      <a:pos x="connsiteX167" y="connsiteY167"/>
                    </a:cxn>
                    <a:cxn ang="0">
                      <a:pos x="connsiteX168" y="connsiteY168"/>
                    </a:cxn>
                    <a:cxn ang="0">
                      <a:pos x="connsiteX169" y="connsiteY169"/>
                    </a:cxn>
                    <a:cxn ang="0">
                      <a:pos x="connsiteX170" y="connsiteY170"/>
                    </a:cxn>
                    <a:cxn ang="0">
                      <a:pos x="connsiteX171" y="connsiteY171"/>
                    </a:cxn>
                    <a:cxn ang="0">
                      <a:pos x="connsiteX172" y="connsiteY172"/>
                    </a:cxn>
                    <a:cxn ang="0">
                      <a:pos x="connsiteX173" y="connsiteY173"/>
                    </a:cxn>
                    <a:cxn ang="0">
                      <a:pos x="connsiteX174" y="connsiteY174"/>
                    </a:cxn>
                    <a:cxn ang="0">
                      <a:pos x="connsiteX175" y="connsiteY175"/>
                    </a:cxn>
                    <a:cxn ang="0">
                      <a:pos x="connsiteX176" y="connsiteY176"/>
                    </a:cxn>
                    <a:cxn ang="0">
                      <a:pos x="connsiteX177" y="connsiteY177"/>
                    </a:cxn>
                    <a:cxn ang="0">
                      <a:pos x="connsiteX178" y="connsiteY178"/>
                    </a:cxn>
                    <a:cxn ang="0">
                      <a:pos x="connsiteX179" y="connsiteY179"/>
                    </a:cxn>
                    <a:cxn ang="0">
                      <a:pos x="connsiteX180" y="connsiteY180"/>
                    </a:cxn>
                    <a:cxn ang="0">
                      <a:pos x="connsiteX181" y="connsiteY181"/>
                    </a:cxn>
                    <a:cxn ang="0">
                      <a:pos x="connsiteX182" y="connsiteY182"/>
                    </a:cxn>
                    <a:cxn ang="0">
                      <a:pos x="connsiteX183" y="connsiteY183"/>
                    </a:cxn>
                    <a:cxn ang="0">
                      <a:pos x="connsiteX184" y="connsiteY184"/>
                    </a:cxn>
                    <a:cxn ang="0">
                      <a:pos x="connsiteX185" y="connsiteY185"/>
                    </a:cxn>
                    <a:cxn ang="0">
                      <a:pos x="connsiteX186" y="connsiteY186"/>
                    </a:cxn>
                    <a:cxn ang="0">
                      <a:pos x="connsiteX187" y="connsiteY187"/>
                    </a:cxn>
                    <a:cxn ang="0">
                      <a:pos x="connsiteX188" y="connsiteY188"/>
                    </a:cxn>
                    <a:cxn ang="0">
                      <a:pos x="connsiteX189" y="connsiteY189"/>
                    </a:cxn>
                    <a:cxn ang="0">
                      <a:pos x="connsiteX190" y="connsiteY190"/>
                    </a:cxn>
                    <a:cxn ang="0">
                      <a:pos x="connsiteX191" y="connsiteY191"/>
                    </a:cxn>
                    <a:cxn ang="0">
                      <a:pos x="connsiteX192" y="connsiteY192"/>
                    </a:cxn>
                    <a:cxn ang="0">
                      <a:pos x="connsiteX193" y="connsiteY193"/>
                    </a:cxn>
                    <a:cxn ang="0">
                      <a:pos x="connsiteX194" y="connsiteY194"/>
                    </a:cxn>
                    <a:cxn ang="0">
                      <a:pos x="connsiteX195" y="connsiteY195"/>
                    </a:cxn>
                    <a:cxn ang="0">
                      <a:pos x="connsiteX196" y="connsiteY196"/>
                    </a:cxn>
                    <a:cxn ang="0">
                      <a:pos x="connsiteX197" y="connsiteY197"/>
                    </a:cxn>
                    <a:cxn ang="0">
                      <a:pos x="connsiteX198" y="connsiteY198"/>
                    </a:cxn>
                    <a:cxn ang="0">
                      <a:pos x="connsiteX199" y="connsiteY199"/>
                    </a:cxn>
                    <a:cxn ang="0">
                      <a:pos x="connsiteX200" y="connsiteY200"/>
                    </a:cxn>
                    <a:cxn ang="0">
                      <a:pos x="connsiteX201" y="connsiteY201"/>
                    </a:cxn>
                    <a:cxn ang="0">
                      <a:pos x="connsiteX202" y="connsiteY202"/>
                    </a:cxn>
                    <a:cxn ang="0">
                      <a:pos x="connsiteX203" y="connsiteY203"/>
                    </a:cxn>
                    <a:cxn ang="0">
                      <a:pos x="connsiteX204" y="connsiteY204"/>
                    </a:cxn>
                    <a:cxn ang="0">
                      <a:pos x="connsiteX205" y="connsiteY205"/>
                    </a:cxn>
                    <a:cxn ang="0">
                      <a:pos x="connsiteX206" y="connsiteY206"/>
                    </a:cxn>
                    <a:cxn ang="0">
                      <a:pos x="connsiteX207" y="connsiteY207"/>
                    </a:cxn>
                    <a:cxn ang="0">
                      <a:pos x="connsiteX208" y="connsiteY208"/>
                    </a:cxn>
                    <a:cxn ang="0">
                      <a:pos x="connsiteX209" y="connsiteY209"/>
                    </a:cxn>
                    <a:cxn ang="0">
                      <a:pos x="connsiteX210" y="connsiteY210"/>
                    </a:cxn>
                    <a:cxn ang="0">
                      <a:pos x="connsiteX211" y="connsiteY211"/>
                    </a:cxn>
                    <a:cxn ang="0">
                      <a:pos x="connsiteX212" y="connsiteY212"/>
                    </a:cxn>
                    <a:cxn ang="0">
                      <a:pos x="connsiteX213" y="connsiteY213"/>
                    </a:cxn>
                    <a:cxn ang="0">
                      <a:pos x="connsiteX214" y="connsiteY214"/>
                    </a:cxn>
                    <a:cxn ang="0">
                      <a:pos x="connsiteX215" y="connsiteY215"/>
                    </a:cxn>
                    <a:cxn ang="0">
                      <a:pos x="connsiteX216" y="connsiteY216"/>
                    </a:cxn>
                    <a:cxn ang="0">
                      <a:pos x="connsiteX217" y="connsiteY217"/>
                    </a:cxn>
                    <a:cxn ang="0">
                      <a:pos x="connsiteX218" y="connsiteY218"/>
                    </a:cxn>
                    <a:cxn ang="0">
                      <a:pos x="connsiteX219" y="connsiteY219"/>
                    </a:cxn>
                    <a:cxn ang="0">
                      <a:pos x="connsiteX220" y="connsiteY220"/>
                    </a:cxn>
                    <a:cxn ang="0">
                      <a:pos x="connsiteX221" y="connsiteY221"/>
                    </a:cxn>
                    <a:cxn ang="0">
                      <a:pos x="connsiteX222" y="connsiteY222"/>
                    </a:cxn>
                    <a:cxn ang="0">
                      <a:pos x="connsiteX223" y="connsiteY223"/>
                    </a:cxn>
                    <a:cxn ang="0">
                      <a:pos x="connsiteX224" y="connsiteY224"/>
                    </a:cxn>
                    <a:cxn ang="0">
                      <a:pos x="connsiteX225" y="connsiteY225"/>
                    </a:cxn>
                    <a:cxn ang="0">
                      <a:pos x="connsiteX226" y="connsiteY226"/>
                    </a:cxn>
                    <a:cxn ang="0">
                      <a:pos x="connsiteX227" y="connsiteY227"/>
                    </a:cxn>
                    <a:cxn ang="0">
                      <a:pos x="connsiteX228" y="connsiteY228"/>
                    </a:cxn>
                    <a:cxn ang="0">
                      <a:pos x="connsiteX229" y="connsiteY229"/>
                    </a:cxn>
                    <a:cxn ang="0">
                      <a:pos x="connsiteX230" y="connsiteY230"/>
                    </a:cxn>
                    <a:cxn ang="0">
                      <a:pos x="connsiteX231" y="connsiteY231"/>
                    </a:cxn>
                    <a:cxn ang="0">
                      <a:pos x="connsiteX232" y="connsiteY232"/>
                    </a:cxn>
                    <a:cxn ang="0">
                      <a:pos x="connsiteX233" y="connsiteY233"/>
                    </a:cxn>
                    <a:cxn ang="0">
                      <a:pos x="connsiteX234" y="connsiteY234"/>
                    </a:cxn>
                    <a:cxn ang="0">
                      <a:pos x="connsiteX235" y="connsiteY235"/>
                    </a:cxn>
                    <a:cxn ang="0">
                      <a:pos x="connsiteX236" y="connsiteY236"/>
                    </a:cxn>
                    <a:cxn ang="0">
                      <a:pos x="connsiteX237" y="connsiteY237"/>
                    </a:cxn>
                    <a:cxn ang="0">
                      <a:pos x="connsiteX238" y="connsiteY238"/>
                    </a:cxn>
                    <a:cxn ang="0">
                      <a:pos x="connsiteX239" y="connsiteY239"/>
                    </a:cxn>
                    <a:cxn ang="0">
                      <a:pos x="connsiteX240" y="connsiteY240"/>
                    </a:cxn>
                    <a:cxn ang="0">
                      <a:pos x="connsiteX241" y="connsiteY241"/>
                    </a:cxn>
                    <a:cxn ang="0">
                      <a:pos x="connsiteX242" y="connsiteY242"/>
                    </a:cxn>
                    <a:cxn ang="0">
                      <a:pos x="connsiteX243" y="connsiteY243"/>
                    </a:cxn>
                    <a:cxn ang="0">
                      <a:pos x="connsiteX244" y="connsiteY244"/>
                    </a:cxn>
                    <a:cxn ang="0">
                      <a:pos x="connsiteX245" y="connsiteY245"/>
                    </a:cxn>
                    <a:cxn ang="0">
                      <a:pos x="connsiteX246" y="connsiteY246"/>
                    </a:cxn>
                    <a:cxn ang="0">
                      <a:pos x="connsiteX247" y="connsiteY247"/>
                    </a:cxn>
                    <a:cxn ang="0">
                      <a:pos x="connsiteX248" y="connsiteY248"/>
                    </a:cxn>
                    <a:cxn ang="0">
                      <a:pos x="connsiteX249" y="connsiteY249"/>
                    </a:cxn>
                    <a:cxn ang="0">
                      <a:pos x="connsiteX250" y="connsiteY250"/>
                    </a:cxn>
                    <a:cxn ang="0">
                      <a:pos x="connsiteX251" y="connsiteY251"/>
                    </a:cxn>
                    <a:cxn ang="0">
                      <a:pos x="connsiteX252" y="connsiteY252"/>
                    </a:cxn>
                    <a:cxn ang="0">
                      <a:pos x="connsiteX253" y="connsiteY253"/>
                    </a:cxn>
                    <a:cxn ang="0">
                      <a:pos x="connsiteX254" y="connsiteY254"/>
                    </a:cxn>
                    <a:cxn ang="0">
                      <a:pos x="connsiteX255" y="connsiteY255"/>
                    </a:cxn>
                    <a:cxn ang="0">
                      <a:pos x="connsiteX256" y="connsiteY256"/>
                    </a:cxn>
                    <a:cxn ang="0">
                      <a:pos x="connsiteX257" y="connsiteY257"/>
                    </a:cxn>
                    <a:cxn ang="0">
                      <a:pos x="connsiteX258" y="connsiteY258"/>
                    </a:cxn>
                    <a:cxn ang="0">
                      <a:pos x="connsiteX259" y="connsiteY259"/>
                    </a:cxn>
                    <a:cxn ang="0">
                      <a:pos x="connsiteX260" y="connsiteY260"/>
                    </a:cxn>
                    <a:cxn ang="0">
                      <a:pos x="connsiteX261" y="connsiteY261"/>
                    </a:cxn>
                    <a:cxn ang="0">
                      <a:pos x="connsiteX262" y="connsiteY262"/>
                    </a:cxn>
                    <a:cxn ang="0">
                      <a:pos x="connsiteX263" y="connsiteY263"/>
                    </a:cxn>
                    <a:cxn ang="0">
                      <a:pos x="connsiteX264" y="connsiteY264"/>
                    </a:cxn>
                    <a:cxn ang="0">
                      <a:pos x="connsiteX265" y="connsiteY265"/>
                    </a:cxn>
                    <a:cxn ang="0">
                      <a:pos x="connsiteX266" y="connsiteY266"/>
                    </a:cxn>
                    <a:cxn ang="0">
                      <a:pos x="connsiteX267" y="connsiteY267"/>
                    </a:cxn>
                    <a:cxn ang="0">
                      <a:pos x="connsiteX268" y="connsiteY268"/>
                    </a:cxn>
                    <a:cxn ang="0">
                      <a:pos x="connsiteX269" y="connsiteY269"/>
                    </a:cxn>
                    <a:cxn ang="0">
                      <a:pos x="connsiteX270" y="connsiteY270"/>
                    </a:cxn>
                    <a:cxn ang="0">
                      <a:pos x="connsiteX271" y="connsiteY271"/>
                    </a:cxn>
                    <a:cxn ang="0">
                      <a:pos x="connsiteX272" y="connsiteY272"/>
                    </a:cxn>
                    <a:cxn ang="0">
                      <a:pos x="connsiteX273" y="connsiteY273"/>
                    </a:cxn>
                    <a:cxn ang="0">
                      <a:pos x="connsiteX274" y="connsiteY274"/>
                    </a:cxn>
                    <a:cxn ang="0">
                      <a:pos x="connsiteX275" y="connsiteY275"/>
                    </a:cxn>
                    <a:cxn ang="0">
                      <a:pos x="connsiteX276" y="connsiteY276"/>
                    </a:cxn>
                    <a:cxn ang="0">
                      <a:pos x="connsiteX277" y="connsiteY277"/>
                    </a:cxn>
                    <a:cxn ang="0">
                      <a:pos x="connsiteX278" y="connsiteY278"/>
                    </a:cxn>
                    <a:cxn ang="0">
                      <a:pos x="connsiteX279" y="connsiteY279"/>
                    </a:cxn>
                    <a:cxn ang="0">
                      <a:pos x="connsiteX280" y="connsiteY280"/>
                    </a:cxn>
                    <a:cxn ang="0">
                      <a:pos x="connsiteX281" y="connsiteY281"/>
                    </a:cxn>
                    <a:cxn ang="0">
                      <a:pos x="connsiteX282" y="connsiteY282"/>
                    </a:cxn>
                    <a:cxn ang="0">
                      <a:pos x="connsiteX283" y="connsiteY283"/>
                    </a:cxn>
                    <a:cxn ang="0">
                      <a:pos x="connsiteX284" y="connsiteY284"/>
                    </a:cxn>
                    <a:cxn ang="0">
                      <a:pos x="connsiteX285" y="connsiteY285"/>
                    </a:cxn>
                    <a:cxn ang="0">
                      <a:pos x="connsiteX286" y="connsiteY286"/>
                    </a:cxn>
                    <a:cxn ang="0">
                      <a:pos x="connsiteX287" y="connsiteY287"/>
                    </a:cxn>
                    <a:cxn ang="0">
                      <a:pos x="connsiteX288" y="connsiteY288"/>
                    </a:cxn>
                    <a:cxn ang="0">
                      <a:pos x="connsiteX289" y="connsiteY289"/>
                    </a:cxn>
                    <a:cxn ang="0">
                      <a:pos x="connsiteX290" y="connsiteY290"/>
                    </a:cxn>
                    <a:cxn ang="0">
                      <a:pos x="connsiteX291" y="connsiteY291"/>
                    </a:cxn>
                    <a:cxn ang="0">
                      <a:pos x="connsiteX292" y="connsiteY292"/>
                    </a:cxn>
                    <a:cxn ang="0">
                      <a:pos x="connsiteX293" y="connsiteY293"/>
                    </a:cxn>
                    <a:cxn ang="0">
                      <a:pos x="connsiteX294" y="connsiteY294"/>
                    </a:cxn>
                    <a:cxn ang="0">
                      <a:pos x="connsiteX295" y="connsiteY295"/>
                    </a:cxn>
                    <a:cxn ang="0">
                      <a:pos x="connsiteX296" y="connsiteY296"/>
                    </a:cxn>
                    <a:cxn ang="0">
                      <a:pos x="connsiteX297" y="connsiteY297"/>
                    </a:cxn>
                    <a:cxn ang="0">
                      <a:pos x="connsiteX298" y="connsiteY298"/>
                    </a:cxn>
                    <a:cxn ang="0">
                      <a:pos x="connsiteX299" y="connsiteY299"/>
                    </a:cxn>
                    <a:cxn ang="0">
                      <a:pos x="connsiteX300" y="connsiteY300"/>
                    </a:cxn>
                    <a:cxn ang="0">
                      <a:pos x="connsiteX301" y="connsiteY301"/>
                    </a:cxn>
                    <a:cxn ang="0">
                      <a:pos x="connsiteX302" y="connsiteY302"/>
                    </a:cxn>
                    <a:cxn ang="0">
                      <a:pos x="connsiteX303" y="connsiteY303"/>
                    </a:cxn>
                    <a:cxn ang="0">
                      <a:pos x="connsiteX304" y="connsiteY304"/>
                    </a:cxn>
                    <a:cxn ang="0">
                      <a:pos x="connsiteX305" y="connsiteY305"/>
                    </a:cxn>
                    <a:cxn ang="0">
                      <a:pos x="connsiteX306" y="connsiteY306"/>
                    </a:cxn>
                    <a:cxn ang="0">
                      <a:pos x="connsiteX307" y="connsiteY307"/>
                    </a:cxn>
                    <a:cxn ang="0">
                      <a:pos x="connsiteX308" y="connsiteY308"/>
                    </a:cxn>
                    <a:cxn ang="0">
                      <a:pos x="connsiteX309" y="connsiteY309"/>
                    </a:cxn>
                    <a:cxn ang="0">
                      <a:pos x="connsiteX310" y="connsiteY310"/>
                    </a:cxn>
                    <a:cxn ang="0">
                      <a:pos x="connsiteX311" y="connsiteY311"/>
                    </a:cxn>
                    <a:cxn ang="0">
                      <a:pos x="connsiteX312" y="connsiteY312"/>
                    </a:cxn>
                    <a:cxn ang="0">
                      <a:pos x="connsiteX313" y="connsiteY313"/>
                    </a:cxn>
                    <a:cxn ang="0">
                      <a:pos x="connsiteX314" y="connsiteY314"/>
                    </a:cxn>
                    <a:cxn ang="0">
                      <a:pos x="connsiteX315" y="connsiteY315"/>
                    </a:cxn>
                    <a:cxn ang="0">
                      <a:pos x="connsiteX316" y="connsiteY316"/>
                    </a:cxn>
                    <a:cxn ang="0">
                      <a:pos x="connsiteX317" y="connsiteY317"/>
                    </a:cxn>
                    <a:cxn ang="0">
                      <a:pos x="connsiteX318" y="connsiteY318"/>
                    </a:cxn>
                    <a:cxn ang="0">
                      <a:pos x="connsiteX319" y="connsiteY319"/>
                    </a:cxn>
                    <a:cxn ang="0">
                      <a:pos x="connsiteX320" y="connsiteY320"/>
                    </a:cxn>
                    <a:cxn ang="0">
                      <a:pos x="connsiteX321" y="connsiteY321"/>
                    </a:cxn>
                    <a:cxn ang="0">
                      <a:pos x="connsiteX322" y="connsiteY322"/>
                    </a:cxn>
                    <a:cxn ang="0">
                      <a:pos x="connsiteX323" y="connsiteY323"/>
                    </a:cxn>
                    <a:cxn ang="0">
                      <a:pos x="connsiteX324" y="connsiteY324"/>
                    </a:cxn>
                    <a:cxn ang="0">
                      <a:pos x="connsiteX325" y="connsiteY325"/>
                    </a:cxn>
                    <a:cxn ang="0">
                      <a:pos x="connsiteX326" y="connsiteY326"/>
                    </a:cxn>
                    <a:cxn ang="0">
                      <a:pos x="connsiteX327" y="connsiteY327"/>
                    </a:cxn>
                    <a:cxn ang="0">
                      <a:pos x="connsiteX328" y="connsiteY328"/>
                    </a:cxn>
                    <a:cxn ang="0">
                      <a:pos x="connsiteX329" y="connsiteY329"/>
                    </a:cxn>
                    <a:cxn ang="0">
                      <a:pos x="connsiteX330" y="connsiteY330"/>
                    </a:cxn>
                    <a:cxn ang="0">
                      <a:pos x="connsiteX331" y="connsiteY331"/>
                    </a:cxn>
                    <a:cxn ang="0">
                      <a:pos x="connsiteX332" y="connsiteY332"/>
                    </a:cxn>
                    <a:cxn ang="0">
                      <a:pos x="connsiteX333" y="connsiteY333"/>
                    </a:cxn>
                    <a:cxn ang="0">
                      <a:pos x="connsiteX334" y="connsiteY334"/>
                    </a:cxn>
                    <a:cxn ang="0">
                      <a:pos x="connsiteX335" y="connsiteY335"/>
                    </a:cxn>
                    <a:cxn ang="0">
                      <a:pos x="connsiteX336" y="connsiteY336"/>
                    </a:cxn>
                    <a:cxn ang="0">
                      <a:pos x="connsiteX337" y="connsiteY337"/>
                    </a:cxn>
                    <a:cxn ang="0">
                      <a:pos x="connsiteX338" y="connsiteY338"/>
                    </a:cxn>
                    <a:cxn ang="0">
                      <a:pos x="connsiteX339" y="connsiteY339"/>
                    </a:cxn>
                    <a:cxn ang="0">
                      <a:pos x="connsiteX340" y="connsiteY340"/>
                    </a:cxn>
                    <a:cxn ang="0">
                      <a:pos x="connsiteX341" y="connsiteY341"/>
                    </a:cxn>
                    <a:cxn ang="0">
                      <a:pos x="connsiteX342" y="connsiteY342"/>
                    </a:cxn>
                    <a:cxn ang="0">
                      <a:pos x="connsiteX343" y="connsiteY343"/>
                    </a:cxn>
                    <a:cxn ang="0">
                      <a:pos x="connsiteX344" y="connsiteY344"/>
                    </a:cxn>
                    <a:cxn ang="0">
                      <a:pos x="connsiteX345" y="connsiteY345"/>
                    </a:cxn>
                    <a:cxn ang="0">
                      <a:pos x="connsiteX346" y="connsiteY346"/>
                    </a:cxn>
                    <a:cxn ang="0">
                      <a:pos x="connsiteX347" y="connsiteY347"/>
                    </a:cxn>
                    <a:cxn ang="0">
                      <a:pos x="connsiteX348" y="connsiteY348"/>
                    </a:cxn>
                    <a:cxn ang="0">
                      <a:pos x="connsiteX349" y="connsiteY349"/>
                    </a:cxn>
                    <a:cxn ang="0">
                      <a:pos x="connsiteX350" y="connsiteY350"/>
                    </a:cxn>
                    <a:cxn ang="0">
                      <a:pos x="connsiteX351" y="connsiteY351"/>
                    </a:cxn>
                    <a:cxn ang="0">
                      <a:pos x="connsiteX352" y="connsiteY352"/>
                    </a:cxn>
                    <a:cxn ang="0">
                      <a:pos x="connsiteX353" y="connsiteY353"/>
                    </a:cxn>
                    <a:cxn ang="0">
                      <a:pos x="connsiteX354" y="connsiteY354"/>
                    </a:cxn>
                    <a:cxn ang="0">
                      <a:pos x="connsiteX355" y="connsiteY355"/>
                    </a:cxn>
                    <a:cxn ang="0">
                      <a:pos x="connsiteX356" y="connsiteY356"/>
                    </a:cxn>
                    <a:cxn ang="0">
                      <a:pos x="connsiteX357" y="connsiteY357"/>
                    </a:cxn>
                    <a:cxn ang="0">
                      <a:pos x="connsiteX358" y="connsiteY358"/>
                    </a:cxn>
                    <a:cxn ang="0">
                      <a:pos x="connsiteX359" y="connsiteY359"/>
                    </a:cxn>
                    <a:cxn ang="0">
                      <a:pos x="connsiteX360" y="connsiteY360"/>
                    </a:cxn>
                    <a:cxn ang="0">
                      <a:pos x="connsiteX361" y="connsiteY361"/>
                    </a:cxn>
                    <a:cxn ang="0">
                      <a:pos x="connsiteX362" y="connsiteY362"/>
                    </a:cxn>
                    <a:cxn ang="0">
                      <a:pos x="connsiteX363" y="connsiteY363"/>
                    </a:cxn>
                    <a:cxn ang="0">
                      <a:pos x="connsiteX364" y="connsiteY364"/>
                    </a:cxn>
                    <a:cxn ang="0">
                      <a:pos x="connsiteX365" y="connsiteY365"/>
                    </a:cxn>
                    <a:cxn ang="0">
                      <a:pos x="connsiteX366" y="connsiteY366"/>
                    </a:cxn>
                    <a:cxn ang="0">
                      <a:pos x="connsiteX367" y="connsiteY367"/>
                    </a:cxn>
                    <a:cxn ang="0">
                      <a:pos x="connsiteX368" y="connsiteY368"/>
                    </a:cxn>
                    <a:cxn ang="0">
                      <a:pos x="connsiteX369" y="connsiteY369"/>
                    </a:cxn>
                    <a:cxn ang="0">
                      <a:pos x="connsiteX370" y="connsiteY370"/>
                    </a:cxn>
                    <a:cxn ang="0">
                      <a:pos x="connsiteX371" y="connsiteY371"/>
                    </a:cxn>
                    <a:cxn ang="0">
                      <a:pos x="connsiteX372" y="connsiteY372"/>
                    </a:cxn>
                    <a:cxn ang="0">
                      <a:pos x="connsiteX373" y="connsiteY373"/>
                    </a:cxn>
                    <a:cxn ang="0">
                      <a:pos x="connsiteX374" y="connsiteY374"/>
                    </a:cxn>
                    <a:cxn ang="0">
                      <a:pos x="connsiteX375" y="connsiteY375"/>
                    </a:cxn>
                    <a:cxn ang="0">
                      <a:pos x="connsiteX376" y="connsiteY376"/>
                    </a:cxn>
                    <a:cxn ang="0">
                      <a:pos x="connsiteX377" y="connsiteY377"/>
                    </a:cxn>
                    <a:cxn ang="0">
                      <a:pos x="connsiteX378" y="connsiteY378"/>
                    </a:cxn>
                    <a:cxn ang="0">
                      <a:pos x="connsiteX379" y="connsiteY379"/>
                    </a:cxn>
                    <a:cxn ang="0">
                      <a:pos x="connsiteX380" y="connsiteY380"/>
                    </a:cxn>
                    <a:cxn ang="0">
                      <a:pos x="connsiteX381" y="connsiteY381"/>
                    </a:cxn>
                    <a:cxn ang="0">
                      <a:pos x="connsiteX382" y="connsiteY382"/>
                    </a:cxn>
                    <a:cxn ang="0">
                      <a:pos x="connsiteX383" y="connsiteY383"/>
                    </a:cxn>
                    <a:cxn ang="0">
                      <a:pos x="connsiteX384" y="connsiteY384"/>
                    </a:cxn>
                    <a:cxn ang="0">
                      <a:pos x="connsiteX385" y="connsiteY385"/>
                    </a:cxn>
                    <a:cxn ang="0">
                      <a:pos x="connsiteX386" y="connsiteY386"/>
                    </a:cxn>
                    <a:cxn ang="0">
                      <a:pos x="connsiteX387" y="connsiteY387"/>
                    </a:cxn>
                    <a:cxn ang="0">
                      <a:pos x="connsiteX388" y="connsiteY388"/>
                    </a:cxn>
                    <a:cxn ang="0">
                      <a:pos x="connsiteX389" y="connsiteY389"/>
                    </a:cxn>
                    <a:cxn ang="0">
                      <a:pos x="connsiteX390" y="connsiteY390"/>
                    </a:cxn>
                    <a:cxn ang="0">
                      <a:pos x="connsiteX391" y="connsiteY391"/>
                    </a:cxn>
                    <a:cxn ang="0">
                      <a:pos x="connsiteX392" y="connsiteY392"/>
                    </a:cxn>
                    <a:cxn ang="0">
                      <a:pos x="connsiteX393" y="connsiteY393"/>
                    </a:cxn>
                    <a:cxn ang="0">
                      <a:pos x="connsiteX394" y="connsiteY394"/>
                    </a:cxn>
                    <a:cxn ang="0">
                      <a:pos x="connsiteX395" y="connsiteY395"/>
                    </a:cxn>
                    <a:cxn ang="0">
                      <a:pos x="connsiteX396" y="connsiteY396"/>
                    </a:cxn>
                    <a:cxn ang="0">
                      <a:pos x="connsiteX397" y="connsiteY397"/>
                    </a:cxn>
                    <a:cxn ang="0">
                      <a:pos x="connsiteX398" y="connsiteY398"/>
                    </a:cxn>
                    <a:cxn ang="0">
                      <a:pos x="connsiteX399" y="connsiteY399"/>
                    </a:cxn>
                    <a:cxn ang="0">
                      <a:pos x="connsiteX400" y="connsiteY400"/>
                    </a:cxn>
                    <a:cxn ang="0">
                      <a:pos x="connsiteX401" y="connsiteY401"/>
                    </a:cxn>
                    <a:cxn ang="0">
                      <a:pos x="connsiteX402" y="connsiteY402"/>
                    </a:cxn>
                    <a:cxn ang="0">
                      <a:pos x="connsiteX403" y="connsiteY403"/>
                    </a:cxn>
                    <a:cxn ang="0">
                      <a:pos x="connsiteX404" y="connsiteY404"/>
                    </a:cxn>
                    <a:cxn ang="0">
                      <a:pos x="connsiteX405" y="connsiteY405"/>
                    </a:cxn>
                    <a:cxn ang="0">
                      <a:pos x="connsiteX406" y="connsiteY406"/>
                    </a:cxn>
                    <a:cxn ang="0">
                      <a:pos x="connsiteX407" y="connsiteY407"/>
                    </a:cxn>
                    <a:cxn ang="0">
                      <a:pos x="connsiteX408" y="connsiteY408"/>
                    </a:cxn>
                    <a:cxn ang="0">
                      <a:pos x="connsiteX409" y="connsiteY409"/>
                    </a:cxn>
                    <a:cxn ang="0">
                      <a:pos x="connsiteX410" y="connsiteY410"/>
                    </a:cxn>
                    <a:cxn ang="0">
                      <a:pos x="connsiteX411" y="connsiteY411"/>
                    </a:cxn>
                    <a:cxn ang="0">
                      <a:pos x="connsiteX412" y="connsiteY412"/>
                    </a:cxn>
                    <a:cxn ang="0">
                      <a:pos x="connsiteX413" y="connsiteY413"/>
                    </a:cxn>
                    <a:cxn ang="0">
                      <a:pos x="connsiteX414" y="connsiteY414"/>
                    </a:cxn>
                    <a:cxn ang="0">
                      <a:pos x="connsiteX415" y="connsiteY415"/>
                    </a:cxn>
                    <a:cxn ang="0">
                      <a:pos x="connsiteX416" y="connsiteY416"/>
                    </a:cxn>
                    <a:cxn ang="0">
                      <a:pos x="connsiteX417" y="connsiteY417"/>
                    </a:cxn>
                    <a:cxn ang="0">
                      <a:pos x="connsiteX418" y="connsiteY418"/>
                    </a:cxn>
                    <a:cxn ang="0">
                      <a:pos x="connsiteX419" y="connsiteY419"/>
                    </a:cxn>
                    <a:cxn ang="0">
                      <a:pos x="connsiteX420" y="connsiteY420"/>
                    </a:cxn>
                    <a:cxn ang="0">
                      <a:pos x="connsiteX421" y="connsiteY421"/>
                    </a:cxn>
                    <a:cxn ang="0">
                      <a:pos x="connsiteX422" y="connsiteY422"/>
                    </a:cxn>
                    <a:cxn ang="0">
                      <a:pos x="connsiteX423" y="connsiteY423"/>
                    </a:cxn>
                    <a:cxn ang="0">
                      <a:pos x="connsiteX424" y="connsiteY424"/>
                    </a:cxn>
                  </a:cxnLst>
                  <a:rect l="l" t="t" r="r" b="b"/>
                  <a:pathLst>
                    <a:path w="2994958" h="3036014">
                      <a:moveTo>
                        <a:pt x="1258585" y="1135295"/>
                      </a:moveTo>
                      <a:cubicBezTo>
                        <a:pt x="1259441" y="1131014"/>
                        <a:pt x="1252435" y="1117857"/>
                        <a:pt x="1248311" y="1109609"/>
                      </a:cubicBezTo>
                      <a:cubicBezTo>
                        <a:pt x="1244279" y="1101544"/>
                        <a:pt x="1226498" y="1079072"/>
                        <a:pt x="1222625" y="1073650"/>
                      </a:cubicBezTo>
                      <a:cubicBezTo>
                        <a:pt x="1219036" y="1068626"/>
                        <a:pt x="1216717" y="1062605"/>
                        <a:pt x="1212351" y="1058239"/>
                      </a:cubicBezTo>
                      <a:cubicBezTo>
                        <a:pt x="1207985" y="1053873"/>
                        <a:pt x="1202077" y="1051389"/>
                        <a:pt x="1196940" y="1047964"/>
                      </a:cubicBezTo>
                      <a:cubicBezTo>
                        <a:pt x="1195228" y="1041115"/>
                        <a:pt x="1194671" y="1033868"/>
                        <a:pt x="1191803" y="1027416"/>
                      </a:cubicBezTo>
                      <a:cubicBezTo>
                        <a:pt x="1187748" y="1018292"/>
                        <a:pt x="1181240" y="1010459"/>
                        <a:pt x="1176391" y="1001731"/>
                      </a:cubicBezTo>
                      <a:cubicBezTo>
                        <a:pt x="1167893" y="986435"/>
                        <a:pt x="1161857" y="972036"/>
                        <a:pt x="1155843" y="955497"/>
                      </a:cubicBezTo>
                      <a:cubicBezTo>
                        <a:pt x="1155831" y="955464"/>
                        <a:pt x="1143006" y="916985"/>
                        <a:pt x="1140432" y="909263"/>
                      </a:cubicBezTo>
                      <a:cubicBezTo>
                        <a:pt x="1137007" y="898989"/>
                        <a:pt x="1136656" y="887105"/>
                        <a:pt x="1130158" y="878441"/>
                      </a:cubicBezTo>
                      <a:cubicBezTo>
                        <a:pt x="1125021" y="871592"/>
                        <a:pt x="1118904" y="865377"/>
                        <a:pt x="1114746" y="857893"/>
                      </a:cubicBezTo>
                      <a:cubicBezTo>
                        <a:pt x="1090381" y="814037"/>
                        <a:pt x="1117936" y="849639"/>
                        <a:pt x="1094198" y="811659"/>
                      </a:cubicBezTo>
                      <a:cubicBezTo>
                        <a:pt x="1074083" y="779475"/>
                        <a:pt x="1082713" y="803696"/>
                        <a:pt x="1068513" y="770562"/>
                      </a:cubicBezTo>
                      <a:cubicBezTo>
                        <a:pt x="1060533" y="751942"/>
                        <a:pt x="1065263" y="750747"/>
                        <a:pt x="1053102" y="729466"/>
                      </a:cubicBezTo>
                      <a:cubicBezTo>
                        <a:pt x="1050699" y="725261"/>
                        <a:pt x="1045853" y="722973"/>
                        <a:pt x="1042827" y="719191"/>
                      </a:cubicBezTo>
                      <a:cubicBezTo>
                        <a:pt x="1038970" y="714370"/>
                        <a:pt x="1035616" y="709140"/>
                        <a:pt x="1032553" y="703780"/>
                      </a:cubicBezTo>
                      <a:cubicBezTo>
                        <a:pt x="1028754" y="697131"/>
                        <a:pt x="1026078" y="689881"/>
                        <a:pt x="1022279" y="683232"/>
                      </a:cubicBezTo>
                      <a:cubicBezTo>
                        <a:pt x="1019216" y="677872"/>
                        <a:pt x="1015068" y="673181"/>
                        <a:pt x="1012005" y="667821"/>
                      </a:cubicBezTo>
                      <a:cubicBezTo>
                        <a:pt x="1008206" y="661172"/>
                        <a:pt x="1005530" y="653921"/>
                        <a:pt x="1001731" y="647272"/>
                      </a:cubicBezTo>
                      <a:cubicBezTo>
                        <a:pt x="998668" y="641912"/>
                        <a:pt x="994068" y="637456"/>
                        <a:pt x="991457" y="631861"/>
                      </a:cubicBezTo>
                      <a:cubicBezTo>
                        <a:pt x="956569" y="557102"/>
                        <a:pt x="983603" y="588048"/>
                        <a:pt x="950360" y="554805"/>
                      </a:cubicBezTo>
                      <a:cubicBezTo>
                        <a:pt x="946935" y="546243"/>
                        <a:pt x="945201" y="536792"/>
                        <a:pt x="940086" y="529120"/>
                      </a:cubicBezTo>
                      <a:cubicBezTo>
                        <a:pt x="934713" y="521060"/>
                        <a:pt x="919537" y="508571"/>
                        <a:pt x="919537" y="508571"/>
                      </a:cubicBezTo>
                      <a:cubicBezTo>
                        <a:pt x="914400" y="498297"/>
                        <a:pt x="908392" y="488414"/>
                        <a:pt x="904126" y="477749"/>
                      </a:cubicBezTo>
                      <a:cubicBezTo>
                        <a:pt x="897542" y="461288"/>
                        <a:pt x="901324" y="456734"/>
                        <a:pt x="893852" y="441789"/>
                      </a:cubicBezTo>
                      <a:cubicBezTo>
                        <a:pt x="891091" y="436267"/>
                        <a:pt x="886850" y="431613"/>
                        <a:pt x="883578" y="426378"/>
                      </a:cubicBezTo>
                      <a:cubicBezTo>
                        <a:pt x="878286" y="417911"/>
                        <a:pt x="873304" y="409255"/>
                        <a:pt x="868167" y="400693"/>
                      </a:cubicBezTo>
                      <a:cubicBezTo>
                        <a:pt x="856292" y="353189"/>
                        <a:pt x="871839" y="400404"/>
                        <a:pt x="852755" y="369870"/>
                      </a:cubicBezTo>
                      <a:cubicBezTo>
                        <a:pt x="846667" y="360129"/>
                        <a:pt x="842844" y="349132"/>
                        <a:pt x="837344" y="339048"/>
                      </a:cubicBezTo>
                      <a:cubicBezTo>
                        <a:pt x="832563" y="330282"/>
                        <a:pt x="826398" y="322293"/>
                        <a:pt x="821933" y="313362"/>
                      </a:cubicBezTo>
                      <a:cubicBezTo>
                        <a:pt x="819511" y="308519"/>
                        <a:pt x="819218" y="302794"/>
                        <a:pt x="816796" y="297951"/>
                      </a:cubicBezTo>
                      <a:cubicBezTo>
                        <a:pt x="812331" y="289021"/>
                        <a:pt x="806522" y="280828"/>
                        <a:pt x="801385" y="272266"/>
                      </a:cubicBezTo>
                      <a:cubicBezTo>
                        <a:pt x="799673" y="261992"/>
                        <a:pt x="798508" y="251611"/>
                        <a:pt x="796248" y="241443"/>
                      </a:cubicBezTo>
                      <a:cubicBezTo>
                        <a:pt x="795073" y="236157"/>
                        <a:pt x="791111" y="231447"/>
                        <a:pt x="791111" y="226032"/>
                      </a:cubicBezTo>
                      <a:cubicBezTo>
                        <a:pt x="791111" y="190302"/>
                        <a:pt x="792288" y="179941"/>
                        <a:pt x="811659" y="154113"/>
                      </a:cubicBezTo>
                      <a:cubicBezTo>
                        <a:pt x="816018" y="148301"/>
                        <a:pt x="821025" y="142732"/>
                        <a:pt x="827070" y="138702"/>
                      </a:cubicBezTo>
                      <a:cubicBezTo>
                        <a:pt x="831575" y="135698"/>
                        <a:pt x="837504" y="135697"/>
                        <a:pt x="842481" y="133564"/>
                      </a:cubicBezTo>
                      <a:cubicBezTo>
                        <a:pt x="849520" y="130547"/>
                        <a:pt x="856336" y="127009"/>
                        <a:pt x="863030" y="123290"/>
                      </a:cubicBezTo>
                      <a:cubicBezTo>
                        <a:pt x="871758" y="118441"/>
                        <a:pt x="879591" y="111934"/>
                        <a:pt x="888715" y="107879"/>
                      </a:cubicBezTo>
                      <a:cubicBezTo>
                        <a:pt x="895167" y="105012"/>
                        <a:pt x="902501" y="104771"/>
                        <a:pt x="909263" y="102742"/>
                      </a:cubicBezTo>
                      <a:cubicBezTo>
                        <a:pt x="919636" y="99630"/>
                        <a:pt x="929466" y="94592"/>
                        <a:pt x="940086" y="92468"/>
                      </a:cubicBezTo>
                      <a:cubicBezTo>
                        <a:pt x="948648" y="90756"/>
                        <a:pt x="957376" y="89730"/>
                        <a:pt x="965771" y="87331"/>
                      </a:cubicBezTo>
                      <a:cubicBezTo>
                        <a:pt x="981391" y="82868"/>
                        <a:pt x="997475" y="79186"/>
                        <a:pt x="1012005" y="71920"/>
                      </a:cubicBezTo>
                      <a:cubicBezTo>
                        <a:pt x="1018854" y="68495"/>
                        <a:pt x="1025218" y="63846"/>
                        <a:pt x="1032553" y="61645"/>
                      </a:cubicBezTo>
                      <a:cubicBezTo>
                        <a:pt x="1042530" y="58652"/>
                        <a:pt x="1053128" y="58371"/>
                        <a:pt x="1063376" y="56508"/>
                      </a:cubicBezTo>
                      <a:cubicBezTo>
                        <a:pt x="1071966" y="54946"/>
                        <a:pt x="1080418" y="52606"/>
                        <a:pt x="1089061" y="51371"/>
                      </a:cubicBezTo>
                      <a:cubicBezTo>
                        <a:pt x="1108856" y="48543"/>
                        <a:pt x="1139863" y="47432"/>
                        <a:pt x="1160980" y="41097"/>
                      </a:cubicBezTo>
                      <a:cubicBezTo>
                        <a:pt x="1169813" y="38447"/>
                        <a:pt x="1177769" y="33249"/>
                        <a:pt x="1186666" y="30823"/>
                      </a:cubicBezTo>
                      <a:cubicBezTo>
                        <a:pt x="1196715" y="28082"/>
                        <a:pt x="1207275" y="27729"/>
                        <a:pt x="1217488" y="25686"/>
                      </a:cubicBezTo>
                      <a:cubicBezTo>
                        <a:pt x="1224411" y="24301"/>
                        <a:pt x="1231248" y="22489"/>
                        <a:pt x="1238036" y="20549"/>
                      </a:cubicBezTo>
                      <a:cubicBezTo>
                        <a:pt x="1243243" y="19061"/>
                        <a:pt x="1248115" y="16353"/>
                        <a:pt x="1253448" y="15412"/>
                      </a:cubicBezTo>
                      <a:cubicBezTo>
                        <a:pt x="1315718" y="4423"/>
                        <a:pt x="1330495" y="4743"/>
                        <a:pt x="1392149" y="0"/>
                      </a:cubicBezTo>
                      <a:lnTo>
                        <a:pt x="1643866" y="5138"/>
                      </a:lnTo>
                      <a:cubicBezTo>
                        <a:pt x="1655966" y="5570"/>
                        <a:pt x="1667800" y="8860"/>
                        <a:pt x="1679825" y="10275"/>
                      </a:cubicBezTo>
                      <a:cubicBezTo>
                        <a:pt x="1696916" y="12286"/>
                        <a:pt x="1714072" y="13700"/>
                        <a:pt x="1731196" y="15412"/>
                      </a:cubicBezTo>
                      <a:cubicBezTo>
                        <a:pt x="1739758" y="18837"/>
                        <a:pt x="1748049" y="23036"/>
                        <a:pt x="1756881" y="25686"/>
                      </a:cubicBezTo>
                      <a:cubicBezTo>
                        <a:pt x="1765244" y="28195"/>
                        <a:pt x="1774096" y="28705"/>
                        <a:pt x="1782567" y="30823"/>
                      </a:cubicBezTo>
                      <a:cubicBezTo>
                        <a:pt x="1787820" y="32136"/>
                        <a:pt x="1792692" y="34785"/>
                        <a:pt x="1797978" y="35960"/>
                      </a:cubicBezTo>
                      <a:cubicBezTo>
                        <a:pt x="1808146" y="38219"/>
                        <a:pt x="1818587" y="39054"/>
                        <a:pt x="1828800" y="41097"/>
                      </a:cubicBezTo>
                      <a:cubicBezTo>
                        <a:pt x="1858894" y="47116"/>
                        <a:pt x="1844125" y="46677"/>
                        <a:pt x="1880171" y="56508"/>
                      </a:cubicBezTo>
                      <a:cubicBezTo>
                        <a:pt x="1908448" y="64220"/>
                        <a:pt x="1938786" y="64389"/>
                        <a:pt x="1967502" y="66782"/>
                      </a:cubicBezTo>
                      <a:cubicBezTo>
                        <a:pt x="2005201" y="85634"/>
                        <a:pt x="1973792" y="72888"/>
                        <a:pt x="2034284" y="82194"/>
                      </a:cubicBezTo>
                      <a:cubicBezTo>
                        <a:pt x="2046583" y="84086"/>
                        <a:pt x="2076903" y="94105"/>
                        <a:pt x="2085654" y="97605"/>
                      </a:cubicBezTo>
                      <a:cubicBezTo>
                        <a:pt x="2094216" y="101030"/>
                        <a:pt x="2103092" y="103755"/>
                        <a:pt x="2111340" y="107879"/>
                      </a:cubicBezTo>
                      <a:cubicBezTo>
                        <a:pt x="2116862" y="110640"/>
                        <a:pt x="2121391" y="115090"/>
                        <a:pt x="2126751" y="118153"/>
                      </a:cubicBezTo>
                      <a:cubicBezTo>
                        <a:pt x="2133400" y="121952"/>
                        <a:pt x="2141068" y="123976"/>
                        <a:pt x="2147299" y="128427"/>
                      </a:cubicBezTo>
                      <a:cubicBezTo>
                        <a:pt x="2153211" y="132650"/>
                        <a:pt x="2157130" y="139188"/>
                        <a:pt x="2162711" y="143839"/>
                      </a:cubicBezTo>
                      <a:cubicBezTo>
                        <a:pt x="2182245" y="160117"/>
                        <a:pt x="2182711" y="152036"/>
                        <a:pt x="2208944" y="169524"/>
                      </a:cubicBezTo>
                      <a:cubicBezTo>
                        <a:pt x="2214989" y="173554"/>
                        <a:pt x="2218774" y="180284"/>
                        <a:pt x="2224355" y="184935"/>
                      </a:cubicBezTo>
                      <a:cubicBezTo>
                        <a:pt x="2229098" y="188888"/>
                        <a:pt x="2234743" y="191620"/>
                        <a:pt x="2239767" y="195209"/>
                      </a:cubicBezTo>
                      <a:cubicBezTo>
                        <a:pt x="2246734" y="200186"/>
                        <a:pt x="2253191" y="205872"/>
                        <a:pt x="2260315" y="210621"/>
                      </a:cubicBezTo>
                      <a:cubicBezTo>
                        <a:pt x="2268623" y="216160"/>
                        <a:pt x="2277533" y="220740"/>
                        <a:pt x="2286000" y="226032"/>
                      </a:cubicBezTo>
                      <a:cubicBezTo>
                        <a:pt x="2291236" y="229304"/>
                        <a:pt x="2296051" y="233243"/>
                        <a:pt x="2301412" y="236306"/>
                      </a:cubicBezTo>
                      <a:cubicBezTo>
                        <a:pt x="2308061" y="240105"/>
                        <a:pt x="2315588" y="242332"/>
                        <a:pt x="2321960" y="246580"/>
                      </a:cubicBezTo>
                      <a:cubicBezTo>
                        <a:pt x="2331083" y="252662"/>
                        <a:pt x="2339320" y="259993"/>
                        <a:pt x="2347645" y="267129"/>
                      </a:cubicBezTo>
                      <a:cubicBezTo>
                        <a:pt x="2351322" y="270281"/>
                        <a:pt x="2353979" y="274588"/>
                        <a:pt x="2357920" y="277403"/>
                      </a:cubicBezTo>
                      <a:cubicBezTo>
                        <a:pt x="2366045" y="283206"/>
                        <a:pt x="2375425" y="287088"/>
                        <a:pt x="2383605" y="292814"/>
                      </a:cubicBezTo>
                      <a:cubicBezTo>
                        <a:pt x="2392587" y="299102"/>
                        <a:pt x="2400423" y="306913"/>
                        <a:pt x="2409290" y="313362"/>
                      </a:cubicBezTo>
                      <a:cubicBezTo>
                        <a:pt x="2419276" y="320625"/>
                        <a:pt x="2430471" y="326197"/>
                        <a:pt x="2440113" y="333911"/>
                      </a:cubicBezTo>
                      <a:cubicBezTo>
                        <a:pt x="2447677" y="339962"/>
                        <a:pt x="2453371" y="348080"/>
                        <a:pt x="2460661" y="354459"/>
                      </a:cubicBezTo>
                      <a:cubicBezTo>
                        <a:pt x="2467104" y="360097"/>
                        <a:pt x="2474523" y="364522"/>
                        <a:pt x="2481209" y="369870"/>
                      </a:cubicBezTo>
                      <a:cubicBezTo>
                        <a:pt x="2491652" y="378225"/>
                        <a:pt x="2501475" y="387344"/>
                        <a:pt x="2512032" y="395555"/>
                      </a:cubicBezTo>
                      <a:cubicBezTo>
                        <a:pt x="2516906" y="399346"/>
                        <a:pt x="2522700" y="401877"/>
                        <a:pt x="2527443" y="405830"/>
                      </a:cubicBezTo>
                      <a:cubicBezTo>
                        <a:pt x="2533024" y="410481"/>
                        <a:pt x="2537387" y="416457"/>
                        <a:pt x="2542854" y="421241"/>
                      </a:cubicBezTo>
                      <a:cubicBezTo>
                        <a:pt x="2551106" y="428461"/>
                        <a:pt x="2560345" y="434505"/>
                        <a:pt x="2568540" y="441789"/>
                      </a:cubicBezTo>
                      <a:cubicBezTo>
                        <a:pt x="2575780" y="448224"/>
                        <a:pt x="2581798" y="455959"/>
                        <a:pt x="2589088" y="462338"/>
                      </a:cubicBezTo>
                      <a:cubicBezTo>
                        <a:pt x="2595531" y="467976"/>
                        <a:pt x="2603059" y="472268"/>
                        <a:pt x="2609636" y="477749"/>
                      </a:cubicBezTo>
                      <a:cubicBezTo>
                        <a:pt x="2613357" y="480850"/>
                        <a:pt x="2616129" y="484997"/>
                        <a:pt x="2619911" y="488023"/>
                      </a:cubicBezTo>
                      <a:cubicBezTo>
                        <a:pt x="2624732" y="491880"/>
                        <a:pt x="2630383" y="494593"/>
                        <a:pt x="2635322" y="498297"/>
                      </a:cubicBezTo>
                      <a:cubicBezTo>
                        <a:pt x="2644093" y="504876"/>
                        <a:pt x="2652445" y="511996"/>
                        <a:pt x="2661007" y="518845"/>
                      </a:cubicBezTo>
                      <a:cubicBezTo>
                        <a:pt x="2672427" y="553108"/>
                        <a:pt x="2656158" y="514045"/>
                        <a:pt x="2686693" y="549668"/>
                      </a:cubicBezTo>
                      <a:cubicBezTo>
                        <a:pt x="2721456" y="590223"/>
                        <a:pt x="2673078" y="554290"/>
                        <a:pt x="2712378" y="580490"/>
                      </a:cubicBezTo>
                      <a:cubicBezTo>
                        <a:pt x="2714090" y="585627"/>
                        <a:pt x="2718405" y="590560"/>
                        <a:pt x="2717515" y="595902"/>
                      </a:cubicBezTo>
                      <a:cubicBezTo>
                        <a:pt x="2716000" y="604991"/>
                        <a:pt x="2689434" y="629512"/>
                        <a:pt x="2686693" y="631861"/>
                      </a:cubicBezTo>
                      <a:cubicBezTo>
                        <a:pt x="2682005" y="635879"/>
                        <a:pt x="2676024" y="638182"/>
                        <a:pt x="2671281" y="642135"/>
                      </a:cubicBezTo>
                      <a:cubicBezTo>
                        <a:pt x="2665700" y="646786"/>
                        <a:pt x="2661451" y="652895"/>
                        <a:pt x="2655870" y="657546"/>
                      </a:cubicBezTo>
                      <a:cubicBezTo>
                        <a:pt x="2649086" y="663200"/>
                        <a:pt x="2618367" y="681076"/>
                        <a:pt x="2614773" y="683232"/>
                      </a:cubicBezTo>
                      <a:cubicBezTo>
                        <a:pt x="2595956" y="711457"/>
                        <a:pt x="2614060" y="689823"/>
                        <a:pt x="2573677" y="714054"/>
                      </a:cubicBezTo>
                      <a:cubicBezTo>
                        <a:pt x="2566335" y="718459"/>
                        <a:pt x="2560613" y="725308"/>
                        <a:pt x="2553129" y="729466"/>
                      </a:cubicBezTo>
                      <a:cubicBezTo>
                        <a:pt x="2545068" y="733944"/>
                        <a:pt x="2535691" y="735616"/>
                        <a:pt x="2527443" y="739740"/>
                      </a:cubicBezTo>
                      <a:cubicBezTo>
                        <a:pt x="2518513" y="744205"/>
                        <a:pt x="2510688" y="750686"/>
                        <a:pt x="2501758" y="755151"/>
                      </a:cubicBezTo>
                      <a:cubicBezTo>
                        <a:pt x="2496914" y="757573"/>
                        <a:pt x="2491114" y="757721"/>
                        <a:pt x="2486346" y="760288"/>
                      </a:cubicBezTo>
                      <a:cubicBezTo>
                        <a:pt x="2468764" y="769756"/>
                        <a:pt x="2452837" y="782181"/>
                        <a:pt x="2434976" y="791111"/>
                      </a:cubicBezTo>
                      <a:cubicBezTo>
                        <a:pt x="2428126" y="794536"/>
                        <a:pt x="2420921" y="797326"/>
                        <a:pt x="2414427" y="801385"/>
                      </a:cubicBezTo>
                      <a:cubicBezTo>
                        <a:pt x="2407167" y="805923"/>
                        <a:pt x="2401139" y="812258"/>
                        <a:pt x="2393879" y="816796"/>
                      </a:cubicBezTo>
                      <a:cubicBezTo>
                        <a:pt x="2387385" y="820855"/>
                        <a:pt x="2379562" y="822619"/>
                        <a:pt x="2373331" y="827070"/>
                      </a:cubicBezTo>
                      <a:cubicBezTo>
                        <a:pt x="2339662" y="851120"/>
                        <a:pt x="2375568" y="836599"/>
                        <a:pt x="2342508" y="847618"/>
                      </a:cubicBezTo>
                      <a:cubicBezTo>
                        <a:pt x="2335659" y="854468"/>
                        <a:pt x="2329401" y="861966"/>
                        <a:pt x="2321960" y="868167"/>
                      </a:cubicBezTo>
                      <a:cubicBezTo>
                        <a:pt x="2298947" y="887344"/>
                        <a:pt x="2286810" y="895025"/>
                        <a:pt x="2265452" y="909263"/>
                      </a:cubicBezTo>
                      <a:cubicBezTo>
                        <a:pt x="2255630" y="923997"/>
                        <a:pt x="2254270" y="928220"/>
                        <a:pt x="2239767" y="940086"/>
                      </a:cubicBezTo>
                      <a:cubicBezTo>
                        <a:pt x="2226514" y="950929"/>
                        <a:pt x="2198670" y="970908"/>
                        <a:pt x="2198670" y="970908"/>
                      </a:cubicBezTo>
                      <a:cubicBezTo>
                        <a:pt x="2185750" y="990289"/>
                        <a:pt x="2187116" y="991615"/>
                        <a:pt x="2162711" y="1006868"/>
                      </a:cubicBezTo>
                      <a:cubicBezTo>
                        <a:pt x="2158119" y="1009738"/>
                        <a:pt x="2152436" y="1010293"/>
                        <a:pt x="2147299" y="1012005"/>
                      </a:cubicBezTo>
                      <a:cubicBezTo>
                        <a:pt x="2142162" y="1017142"/>
                        <a:pt x="2137800" y="1023193"/>
                        <a:pt x="2131888" y="1027416"/>
                      </a:cubicBezTo>
                      <a:cubicBezTo>
                        <a:pt x="2125657" y="1031867"/>
                        <a:pt x="2117223" y="1032787"/>
                        <a:pt x="2111340" y="1037690"/>
                      </a:cubicBezTo>
                      <a:cubicBezTo>
                        <a:pt x="2080359" y="1063509"/>
                        <a:pt x="2122450" y="1045974"/>
                        <a:pt x="2085654" y="1058239"/>
                      </a:cubicBezTo>
                      <a:cubicBezTo>
                        <a:pt x="2080517" y="1061664"/>
                        <a:pt x="2074609" y="1064147"/>
                        <a:pt x="2070243" y="1068513"/>
                      </a:cubicBezTo>
                      <a:cubicBezTo>
                        <a:pt x="2065877" y="1072879"/>
                        <a:pt x="2064790" y="1080067"/>
                        <a:pt x="2059969" y="1083924"/>
                      </a:cubicBezTo>
                      <a:cubicBezTo>
                        <a:pt x="2055741" y="1087307"/>
                        <a:pt x="2049695" y="1087349"/>
                        <a:pt x="2044558" y="1089061"/>
                      </a:cubicBezTo>
                      <a:cubicBezTo>
                        <a:pt x="2037708" y="1094198"/>
                        <a:pt x="2030510" y="1098900"/>
                        <a:pt x="2024009" y="1104472"/>
                      </a:cubicBezTo>
                      <a:cubicBezTo>
                        <a:pt x="2018493" y="1109200"/>
                        <a:pt x="2014643" y="1115854"/>
                        <a:pt x="2008598" y="1119884"/>
                      </a:cubicBezTo>
                      <a:cubicBezTo>
                        <a:pt x="2004093" y="1122888"/>
                        <a:pt x="1998324" y="1123309"/>
                        <a:pt x="1993187" y="1125021"/>
                      </a:cubicBezTo>
                      <a:cubicBezTo>
                        <a:pt x="1988050" y="1131870"/>
                        <a:pt x="1984277" y="1139997"/>
                        <a:pt x="1977776" y="1145569"/>
                      </a:cubicBezTo>
                      <a:cubicBezTo>
                        <a:pt x="1971961" y="1150553"/>
                        <a:pt x="1962642" y="1150428"/>
                        <a:pt x="1957227" y="1155843"/>
                      </a:cubicBezTo>
                      <a:cubicBezTo>
                        <a:pt x="1925484" y="1187584"/>
                        <a:pt x="1967686" y="1169479"/>
                        <a:pt x="1931542" y="1181529"/>
                      </a:cubicBezTo>
                      <a:cubicBezTo>
                        <a:pt x="1917843" y="1195228"/>
                        <a:pt x="1907773" y="1213961"/>
                        <a:pt x="1890445" y="1222625"/>
                      </a:cubicBezTo>
                      <a:cubicBezTo>
                        <a:pt x="1873798" y="1230948"/>
                        <a:pt x="1856190" y="1238475"/>
                        <a:pt x="1844212" y="1253448"/>
                      </a:cubicBezTo>
                      <a:cubicBezTo>
                        <a:pt x="1840355" y="1258269"/>
                        <a:pt x="1837362" y="1263722"/>
                        <a:pt x="1833937" y="1268859"/>
                      </a:cubicBezTo>
                      <a:cubicBezTo>
                        <a:pt x="1837362" y="1272284"/>
                        <a:pt x="1840059" y="1276641"/>
                        <a:pt x="1844212" y="1279133"/>
                      </a:cubicBezTo>
                      <a:cubicBezTo>
                        <a:pt x="1863961" y="1290982"/>
                        <a:pt x="1886150" y="1279908"/>
                        <a:pt x="1905857" y="1273996"/>
                      </a:cubicBezTo>
                      <a:cubicBezTo>
                        <a:pt x="1972053" y="1254137"/>
                        <a:pt x="1912767" y="1273406"/>
                        <a:pt x="1972639" y="1253448"/>
                      </a:cubicBezTo>
                      <a:cubicBezTo>
                        <a:pt x="1982913" y="1250023"/>
                        <a:pt x="1992715" y="1244516"/>
                        <a:pt x="2003461" y="1243173"/>
                      </a:cubicBezTo>
                      <a:lnTo>
                        <a:pt x="2044558" y="1238036"/>
                      </a:lnTo>
                      <a:cubicBezTo>
                        <a:pt x="2091315" y="1222450"/>
                        <a:pt x="2017471" y="1246357"/>
                        <a:pt x="2085654" y="1227762"/>
                      </a:cubicBezTo>
                      <a:cubicBezTo>
                        <a:pt x="2096102" y="1224912"/>
                        <a:pt x="2106203" y="1220913"/>
                        <a:pt x="2116477" y="1217488"/>
                      </a:cubicBezTo>
                      <a:lnTo>
                        <a:pt x="2131888" y="1212351"/>
                      </a:lnTo>
                      <a:cubicBezTo>
                        <a:pt x="2137025" y="1210639"/>
                        <a:pt x="2142271" y="1209225"/>
                        <a:pt x="2147299" y="1207214"/>
                      </a:cubicBezTo>
                      <a:cubicBezTo>
                        <a:pt x="2155861" y="1203789"/>
                        <a:pt x="2164171" y="1199652"/>
                        <a:pt x="2172985" y="1196940"/>
                      </a:cubicBezTo>
                      <a:cubicBezTo>
                        <a:pt x="2186481" y="1192787"/>
                        <a:pt x="2200382" y="1190091"/>
                        <a:pt x="2214081" y="1186666"/>
                      </a:cubicBezTo>
                      <a:lnTo>
                        <a:pt x="2234630" y="1181529"/>
                      </a:lnTo>
                      <a:cubicBezTo>
                        <a:pt x="2241479" y="1178104"/>
                        <a:pt x="2248484" y="1174973"/>
                        <a:pt x="2255178" y="1171254"/>
                      </a:cubicBezTo>
                      <a:cubicBezTo>
                        <a:pt x="2263906" y="1166405"/>
                        <a:pt x="2271739" y="1159898"/>
                        <a:pt x="2280863" y="1155843"/>
                      </a:cubicBezTo>
                      <a:cubicBezTo>
                        <a:pt x="2347237" y="1126344"/>
                        <a:pt x="2240540" y="1186278"/>
                        <a:pt x="2332234" y="1140432"/>
                      </a:cubicBezTo>
                      <a:cubicBezTo>
                        <a:pt x="2425773" y="1093664"/>
                        <a:pt x="2328569" y="1139844"/>
                        <a:pt x="2404153" y="1109609"/>
                      </a:cubicBezTo>
                      <a:cubicBezTo>
                        <a:pt x="2411263" y="1106765"/>
                        <a:pt x="2418053" y="1103134"/>
                        <a:pt x="2424702" y="1099335"/>
                      </a:cubicBezTo>
                      <a:cubicBezTo>
                        <a:pt x="2430062" y="1096272"/>
                        <a:pt x="2434471" y="1091568"/>
                        <a:pt x="2440113" y="1089061"/>
                      </a:cubicBezTo>
                      <a:cubicBezTo>
                        <a:pt x="2452909" y="1083374"/>
                        <a:pt x="2494886" y="1071944"/>
                        <a:pt x="2506895" y="1068513"/>
                      </a:cubicBezTo>
                      <a:cubicBezTo>
                        <a:pt x="2571619" y="1029679"/>
                        <a:pt x="2495197" y="1071616"/>
                        <a:pt x="2558266" y="1047964"/>
                      </a:cubicBezTo>
                      <a:cubicBezTo>
                        <a:pt x="2564047" y="1045796"/>
                        <a:pt x="2568155" y="1040451"/>
                        <a:pt x="2573677" y="1037690"/>
                      </a:cubicBezTo>
                      <a:cubicBezTo>
                        <a:pt x="2581925" y="1033566"/>
                        <a:pt x="2590990" y="1031280"/>
                        <a:pt x="2599362" y="1027416"/>
                      </a:cubicBezTo>
                      <a:cubicBezTo>
                        <a:pt x="2613268" y="1020998"/>
                        <a:pt x="2628206" y="1016058"/>
                        <a:pt x="2640459" y="1006868"/>
                      </a:cubicBezTo>
                      <a:cubicBezTo>
                        <a:pt x="2647308" y="1001731"/>
                        <a:pt x="2653349" y="995286"/>
                        <a:pt x="2661007" y="991457"/>
                      </a:cubicBezTo>
                      <a:cubicBezTo>
                        <a:pt x="2667322" y="988300"/>
                        <a:pt x="2674706" y="988032"/>
                        <a:pt x="2681555" y="986320"/>
                      </a:cubicBezTo>
                      <a:cubicBezTo>
                        <a:pt x="2691866" y="979446"/>
                        <a:pt x="2713356" y="964766"/>
                        <a:pt x="2722652" y="960634"/>
                      </a:cubicBezTo>
                      <a:cubicBezTo>
                        <a:pt x="2729104" y="957767"/>
                        <a:pt x="2736502" y="957730"/>
                        <a:pt x="2743200" y="955497"/>
                      </a:cubicBezTo>
                      <a:cubicBezTo>
                        <a:pt x="2751948" y="952581"/>
                        <a:pt x="2760638" y="949347"/>
                        <a:pt x="2768886" y="945223"/>
                      </a:cubicBezTo>
                      <a:cubicBezTo>
                        <a:pt x="2774408" y="942462"/>
                        <a:pt x="2778775" y="937710"/>
                        <a:pt x="2784297" y="934949"/>
                      </a:cubicBezTo>
                      <a:cubicBezTo>
                        <a:pt x="2792545" y="930825"/>
                        <a:pt x="2801316" y="927826"/>
                        <a:pt x="2809982" y="924675"/>
                      </a:cubicBezTo>
                      <a:cubicBezTo>
                        <a:pt x="2841849" y="913087"/>
                        <a:pt x="2836021" y="915357"/>
                        <a:pt x="2866490" y="909263"/>
                      </a:cubicBezTo>
                      <a:cubicBezTo>
                        <a:pt x="2878477" y="910975"/>
                        <a:pt x="2890852" y="910921"/>
                        <a:pt x="2902450" y="914400"/>
                      </a:cubicBezTo>
                      <a:cubicBezTo>
                        <a:pt x="2908364" y="916174"/>
                        <a:pt x="2913495" y="920309"/>
                        <a:pt x="2917861" y="924675"/>
                      </a:cubicBezTo>
                      <a:cubicBezTo>
                        <a:pt x="2925122" y="931936"/>
                        <a:pt x="2934380" y="952575"/>
                        <a:pt x="2938409" y="960634"/>
                      </a:cubicBezTo>
                      <a:cubicBezTo>
                        <a:pt x="2941834" y="977758"/>
                        <a:pt x="2943162" y="995438"/>
                        <a:pt x="2948684" y="1012005"/>
                      </a:cubicBezTo>
                      <a:cubicBezTo>
                        <a:pt x="2956054" y="1034114"/>
                        <a:pt x="2952508" y="1022163"/>
                        <a:pt x="2958958" y="1047964"/>
                      </a:cubicBezTo>
                      <a:cubicBezTo>
                        <a:pt x="2963187" y="1107175"/>
                        <a:pt x="2962739" y="1114174"/>
                        <a:pt x="2969232" y="1166117"/>
                      </a:cubicBezTo>
                      <a:cubicBezTo>
                        <a:pt x="2970734" y="1178132"/>
                        <a:pt x="2972203" y="1190164"/>
                        <a:pt x="2974369" y="1202077"/>
                      </a:cubicBezTo>
                      <a:cubicBezTo>
                        <a:pt x="2977474" y="1219156"/>
                        <a:pt x="2984419" y="1237366"/>
                        <a:pt x="2989780" y="1253448"/>
                      </a:cubicBezTo>
                      <a:cubicBezTo>
                        <a:pt x="2994511" y="1480545"/>
                        <a:pt x="2998566" y="1501261"/>
                        <a:pt x="2989780" y="1720922"/>
                      </a:cubicBezTo>
                      <a:cubicBezTo>
                        <a:pt x="2988480" y="1753427"/>
                        <a:pt x="2982204" y="1761502"/>
                        <a:pt x="2974369" y="1792841"/>
                      </a:cubicBezTo>
                      <a:cubicBezTo>
                        <a:pt x="2972251" y="1801312"/>
                        <a:pt x="2971350" y="1810055"/>
                        <a:pt x="2969232" y="1818526"/>
                      </a:cubicBezTo>
                      <a:cubicBezTo>
                        <a:pt x="2967919" y="1823780"/>
                        <a:pt x="2965270" y="1828652"/>
                        <a:pt x="2964095" y="1833938"/>
                      </a:cubicBezTo>
                      <a:cubicBezTo>
                        <a:pt x="2961836" y="1844106"/>
                        <a:pt x="2961217" y="1854592"/>
                        <a:pt x="2958958" y="1864760"/>
                      </a:cubicBezTo>
                      <a:cubicBezTo>
                        <a:pt x="2957783" y="1870046"/>
                        <a:pt x="2955309" y="1874964"/>
                        <a:pt x="2953821" y="1880171"/>
                      </a:cubicBezTo>
                      <a:cubicBezTo>
                        <a:pt x="2951881" y="1886960"/>
                        <a:pt x="2950624" y="1893931"/>
                        <a:pt x="2948684" y="1900720"/>
                      </a:cubicBezTo>
                      <a:cubicBezTo>
                        <a:pt x="2947196" y="1905927"/>
                        <a:pt x="2944971" y="1910907"/>
                        <a:pt x="2943546" y="1916131"/>
                      </a:cubicBezTo>
                      <a:cubicBezTo>
                        <a:pt x="2939830" y="1929754"/>
                        <a:pt x="2937737" y="1943831"/>
                        <a:pt x="2933272" y="1957227"/>
                      </a:cubicBezTo>
                      <a:cubicBezTo>
                        <a:pt x="2931560" y="1962364"/>
                        <a:pt x="2929448" y="1967385"/>
                        <a:pt x="2928135" y="1972639"/>
                      </a:cubicBezTo>
                      <a:cubicBezTo>
                        <a:pt x="2918177" y="2012471"/>
                        <a:pt x="2929814" y="1984693"/>
                        <a:pt x="2912724" y="2018872"/>
                      </a:cubicBezTo>
                      <a:cubicBezTo>
                        <a:pt x="2897494" y="2079796"/>
                        <a:pt x="2920859" y="1983336"/>
                        <a:pt x="2902450" y="2075380"/>
                      </a:cubicBezTo>
                      <a:cubicBezTo>
                        <a:pt x="2901388" y="2080690"/>
                        <a:pt x="2898626" y="2085538"/>
                        <a:pt x="2897313" y="2090791"/>
                      </a:cubicBezTo>
                      <a:cubicBezTo>
                        <a:pt x="2895195" y="2099262"/>
                        <a:pt x="2894685" y="2108114"/>
                        <a:pt x="2892176" y="2116477"/>
                      </a:cubicBezTo>
                      <a:cubicBezTo>
                        <a:pt x="2885116" y="2140010"/>
                        <a:pt x="2881750" y="2137630"/>
                        <a:pt x="2876764" y="2157573"/>
                      </a:cubicBezTo>
                      <a:cubicBezTo>
                        <a:pt x="2871126" y="2180124"/>
                        <a:pt x="2872376" y="2192035"/>
                        <a:pt x="2861353" y="2214081"/>
                      </a:cubicBezTo>
                      <a:cubicBezTo>
                        <a:pt x="2854504" y="2227780"/>
                        <a:pt x="2844520" y="2240319"/>
                        <a:pt x="2840805" y="2255178"/>
                      </a:cubicBezTo>
                      <a:cubicBezTo>
                        <a:pt x="2839093" y="2262027"/>
                        <a:pt x="2838290" y="2269171"/>
                        <a:pt x="2835668" y="2275726"/>
                      </a:cubicBezTo>
                      <a:cubicBezTo>
                        <a:pt x="2825313" y="2301613"/>
                        <a:pt x="2817891" y="2308752"/>
                        <a:pt x="2804845" y="2332234"/>
                      </a:cubicBezTo>
                      <a:cubicBezTo>
                        <a:pt x="2784694" y="2368504"/>
                        <a:pt x="2805928" y="2337639"/>
                        <a:pt x="2779160" y="2373331"/>
                      </a:cubicBezTo>
                      <a:cubicBezTo>
                        <a:pt x="2777448" y="2378468"/>
                        <a:pt x="2777272" y="2384410"/>
                        <a:pt x="2774023" y="2388742"/>
                      </a:cubicBezTo>
                      <a:cubicBezTo>
                        <a:pt x="2766758" y="2398428"/>
                        <a:pt x="2748337" y="2414427"/>
                        <a:pt x="2748337" y="2414427"/>
                      </a:cubicBezTo>
                      <a:cubicBezTo>
                        <a:pt x="2725096" y="2472532"/>
                        <a:pt x="2754426" y="2408986"/>
                        <a:pt x="2717515" y="2460661"/>
                      </a:cubicBezTo>
                      <a:cubicBezTo>
                        <a:pt x="2714368" y="2465067"/>
                        <a:pt x="2715525" y="2471666"/>
                        <a:pt x="2712378" y="2476072"/>
                      </a:cubicBezTo>
                      <a:cubicBezTo>
                        <a:pt x="2706748" y="2483954"/>
                        <a:pt x="2697777" y="2488975"/>
                        <a:pt x="2691830" y="2496621"/>
                      </a:cubicBezTo>
                      <a:cubicBezTo>
                        <a:pt x="2644246" y="2557800"/>
                        <a:pt x="2709854" y="2488870"/>
                        <a:pt x="2655870" y="2542854"/>
                      </a:cubicBezTo>
                      <a:cubicBezTo>
                        <a:pt x="2654158" y="2547991"/>
                        <a:pt x="2654058" y="2553991"/>
                        <a:pt x="2650733" y="2558266"/>
                      </a:cubicBezTo>
                      <a:cubicBezTo>
                        <a:pt x="2628937" y="2586290"/>
                        <a:pt x="2618595" y="2587974"/>
                        <a:pt x="2594225" y="2609636"/>
                      </a:cubicBezTo>
                      <a:cubicBezTo>
                        <a:pt x="2586985" y="2616071"/>
                        <a:pt x="2581032" y="2623881"/>
                        <a:pt x="2573677" y="2630185"/>
                      </a:cubicBezTo>
                      <a:cubicBezTo>
                        <a:pt x="2568989" y="2634203"/>
                        <a:pt x="2563009" y="2636507"/>
                        <a:pt x="2558266" y="2640459"/>
                      </a:cubicBezTo>
                      <a:cubicBezTo>
                        <a:pt x="2532612" y="2661836"/>
                        <a:pt x="2554526" y="2651979"/>
                        <a:pt x="2527443" y="2661007"/>
                      </a:cubicBezTo>
                      <a:cubicBezTo>
                        <a:pt x="2478358" y="2697821"/>
                        <a:pt x="2501030" y="2683020"/>
                        <a:pt x="2460661" y="2707241"/>
                      </a:cubicBezTo>
                      <a:cubicBezTo>
                        <a:pt x="2457236" y="2712378"/>
                        <a:pt x="2455411" y="2719063"/>
                        <a:pt x="2450387" y="2722652"/>
                      </a:cubicBezTo>
                      <a:cubicBezTo>
                        <a:pt x="2445011" y="2726492"/>
                        <a:pt x="2418571" y="2734970"/>
                        <a:pt x="2409290" y="2738063"/>
                      </a:cubicBezTo>
                      <a:cubicBezTo>
                        <a:pt x="2402441" y="2736351"/>
                        <a:pt x="2395490" y="2735002"/>
                        <a:pt x="2388742" y="2732926"/>
                      </a:cubicBezTo>
                      <a:cubicBezTo>
                        <a:pt x="2373215" y="2728149"/>
                        <a:pt x="2342508" y="2717515"/>
                        <a:pt x="2342508" y="2717515"/>
                      </a:cubicBezTo>
                      <a:cubicBezTo>
                        <a:pt x="2318177" y="2681019"/>
                        <a:pt x="2349922" y="2723114"/>
                        <a:pt x="2311686" y="2691830"/>
                      </a:cubicBezTo>
                      <a:cubicBezTo>
                        <a:pt x="2298566" y="2681096"/>
                        <a:pt x="2287713" y="2667857"/>
                        <a:pt x="2275726" y="2655870"/>
                      </a:cubicBezTo>
                      <a:lnTo>
                        <a:pt x="2260315" y="2640459"/>
                      </a:lnTo>
                      <a:cubicBezTo>
                        <a:pt x="2256137" y="2627926"/>
                        <a:pt x="2254861" y="2619593"/>
                        <a:pt x="2244904" y="2609636"/>
                      </a:cubicBezTo>
                      <a:cubicBezTo>
                        <a:pt x="2238850" y="2603582"/>
                        <a:pt x="2231205" y="2599362"/>
                        <a:pt x="2224355" y="2594225"/>
                      </a:cubicBezTo>
                      <a:cubicBezTo>
                        <a:pt x="2214922" y="2575359"/>
                        <a:pt x="2215425" y="2574241"/>
                        <a:pt x="2203807" y="2558266"/>
                      </a:cubicBezTo>
                      <a:cubicBezTo>
                        <a:pt x="2193735" y="2544417"/>
                        <a:pt x="2180643" y="2532485"/>
                        <a:pt x="2172985" y="2517169"/>
                      </a:cubicBezTo>
                      <a:cubicBezTo>
                        <a:pt x="2166135" y="2503470"/>
                        <a:pt x="2160932" y="2488816"/>
                        <a:pt x="2152436" y="2476072"/>
                      </a:cubicBezTo>
                      <a:cubicBezTo>
                        <a:pt x="2145587" y="2465798"/>
                        <a:pt x="2137410" y="2456294"/>
                        <a:pt x="2131888" y="2445250"/>
                      </a:cubicBezTo>
                      <a:lnTo>
                        <a:pt x="2111340" y="2404153"/>
                      </a:lnTo>
                      <a:cubicBezTo>
                        <a:pt x="2106203" y="2393879"/>
                        <a:pt x="2102301" y="2382888"/>
                        <a:pt x="2095929" y="2373331"/>
                      </a:cubicBezTo>
                      <a:cubicBezTo>
                        <a:pt x="2079629" y="2348882"/>
                        <a:pt x="2056949" y="2315920"/>
                        <a:pt x="2044558" y="2291138"/>
                      </a:cubicBezTo>
                      <a:cubicBezTo>
                        <a:pt x="2041133" y="2284288"/>
                        <a:pt x="2038532" y="2276961"/>
                        <a:pt x="2034284" y="2270589"/>
                      </a:cubicBezTo>
                      <a:cubicBezTo>
                        <a:pt x="2028202" y="2261466"/>
                        <a:pt x="2019817" y="2254027"/>
                        <a:pt x="2013735" y="2244904"/>
                      </a:cubicBezTo>
                      <a:cubicBezTo>
                        <a:pt x="2009487" y="2238532"/>
                        <a:pt x="2007709" y="2230727"/>
                        <a:pt x="2003461" y="2224355"/>
                      </a:cubicBezTo>
                      <a:cubicBezTo>
                        <a:pt x="1997379" y="2215232"/>
                        <a:pt x="1989492" y="2207441"/>
                        <a:pt x="1982913" y="2198670"/>
                      </a:cubicBezTo>
                      <a:cubicBezTo>
                        <a:pt x="1963474" y="2172751"/>
                        <a:pt x="1982087" y="2192706"/>
                        <a:pt x="1962364" y="2172985"/>
                      </a:cubicBezTo>
                      <a:cubicBezTo>
                        <a:pt x="1954028" y="2147975"/>
                        <a:pt x="1961254" y="2164238"/>
                        <a:pt x="1941816" y="2137025"/>
                      </a:cubicBezTo>
                      <a:cubicBezTo>
                        <a:pt x="1938227" y="2132001"/>
                        <a:pt x="1935494" y="2126357"/>
                        <a:pt x="1931542" y="2121614"/>
                      </a:cubicBezTo>
                      <a:cubicBezTo>
                        <a:pt x="1926891" y="2116033"/>
                        <a:pt x="1920782" y="2111784"/>
                        <a:pt x="1916131" y="2106203"/>
                      </a:cubicBezTo>
                      <a:cubicBezTo>
                        <a:pt x="1912178" y="2101460"/>
                        <a:pt x="1909923" y="2095438"/>
                        <a:pt x="1905857" y="2090791"/>
                      </a:cubicBezTo>
                      <a:cubicBezTo>
                        <a:pt x="1839373" y="2014809"/>
                        <a:pt x="1905464" y="2098601"/>
                        <a:pt x="1869897" y="2049695"/>
                      </a:cubicBezTo>
                      <a:cubicBezTo>
                        <a:pt x="1859825" y="2035846"/>
                        <a:pt x="1849349" y="2022297"/>
                        <a:pt x="1839075" y="2008598"/>
                      </a:cubicBezTo>
                      <a:lnTo>
                        <a:pt x="1823663" y="1988050"/>
                      </a:lnTo>
                      <a:cubicBezTo>
                        <a:pt x="1826859" y="2016811"/>
                        <a:pt x="1827395" y="2033804"/>
                        <a:pt x="1833937" y="2059969"/>
                      </a:cubicBezTo>
                      <a:cubicBezTo>
                        <a:pt x="1837715" y="2075081"/>
                        <a:pt x="1842002" y="2081234"/>
                        <a:pt x="1849349" y="2095929"/>
                      </a:cubicBezTo>
                      <a:cubicBezTo>
                        <a:pt x="1852774" y="2116477"/>
                        <a:pt x="1853036" y="2137810"/>
                        <a:pt x="1859623" y="2157573"/>
                      </a:cubicBezTo>
                      <a:cubicBezTo>
                        <a:pt x="1861335" y="2162710"/>
                        <a:pt x="1862859" y="2167915"/>
                        <a:pt x="1864760" y="2172985"/>
                      </a:cubicBezTo>
                      <a:cubicBezTo>
                        <a:pt x="1868295" y="2182412"/>
                        <a:pt x="1877256" y="2202421"/>
                        <a:pt x="1880171" y="2214081"/>
                      </a:cubicBezTo>
                      <a:cubicBezTo>
                        <a:pt x="1882289" y="2222552"/>
                        <a:pt x="1882547" y="2231484"/>
                        <a:pt x="1885308" y="2239767"/>
                      </a:cubicBezTo>
                      <a:cubicBezTo>
                        <a:pt x="1912707" y="2321966"/>
                        <a:pt x="1882763" y="2212880"/>
                        <a:pt x="1900720" y="2275726"/>
                      </a:cubicBezTo>
                      <a:cubicBezTo>
                        <a:pt x="1902660" y="2282515"/>
                        <a:pt x="1904325" y="2289383"/>
                        <a:pt x="1905857" y="2296275"/>
                      </a:cubicBezTo>
                      <a:cubicBezTo>
                        <a:pt x="1907751" y="2304798"/>
                        <a:pt x="1908010" y="2313754"/>
                        <a:pt x="1910994" y="2321960"/>
                      </a:cubicBezTo>
                      <a:cubicBezTo>
                        <a:pt x="1914919" y="2332755"/>
                        <a:pt x="1921987" y="2342179"/>
                        <a:pt x="1926405" y="2352782"/>
                      </a:cubicBezTo>
                      <a:cubicBezTo>
                        <a:pt x="1930570" y="2362779"/>
                        <a:pt x="1931583" y="2374049"/>
                        <a:pt x="1936679" y="2383605"/>
                      </a:cubicBezTo>
                      <a:cubicBezTo>
                        <a:pt x="1945395" y="2399948"/>
                        <a:pt x="1967502" y="2429839"/>
                        <a:pt x="1967502" y="2429839"/>
                      </a:cubicBezTo>
                      <a:cubicBezTo>
                        <a:pt x="1970927" y="2440113"/>
                        <a:pt x="1972933" y="2450975"/>
                        <a:pt x="1977776" y="2460661"/>
                      </a:cubicBezTo>
                      <a:cubicBezTo>
                        <a:pt x="2003067" y="2511244"/>
                        <a:pt x="1972088" y="2447863"/>
                        <a:pt x="1998324" y="2506895"/>
                      </a:cubicBezTo>
                      <a:cubicBezTo>
                        <a:pt x="2001434" y="2513893"/>
                        <a:pt x="2005488" y="2520445"/>
                        <a:pt x="2008598" y="2527443"/>
                      </a:cubicBezTo>
                      <a:cubicBezTo>
                        <a:pt x="2037670" y="2592857"/>
                        <a:pt x="1996645" y="2508679"/>
                        <a:pt x="2034284" y="2583951"/>
                      </a:cubicBezTo>
                      <a:cubicBezTo>
                        <a:pt x="2035996" y="2594225"/>
                        <a:pt x="2037378" y="2604560"/>
                        <a:pt x="2039421" y="2614773"/>
                      </a:cubicBezTo>
                      <a:cubicBezTo>
                        <a:pt x="2044775" y="2641542"/>
                        <a:pt x="2043166" y="2627882"/>
                        <a:pt x="2049695" y="2650733"/>
                      </a:cubicBezTo>
                      <a:cubicBezTo>
                        <a:pt x="2051635" y="2657521"/>
                        <a:pt x="2052803" y="2664519"/>
                        <a:pt x="2054832" y="2671281"/>
                      </a:cubicBezTo>
                      <a:cubicBezTo>
                        <a:pt x="2061017" y="2691898"/>
                        <a:pt x="2066600" y="2702617"/>
                        <a:pt x="2070243" y="2722652"/>
                      </a:cubicBezTo>
                      <a:cubicBezTo>
                        <a:pt x="2072409" y="2734565"/>
                        <a:pt x="2073276" y="2746688"/>
                        <a:pt x="2075380" y="2758612"/>
                      </a:cubicBezTo>
                      <a:cubicBezTo>
                        <a:pt x="2078415" y="2775809"/>
                        <a:pt x="2082229" y="2792859"/>
                        <a:pt x="2085654" y="2809982"/>
                      </a:cubicBezTo>
                      <a:lnTo>
                        <a:pt x="2090791" y="2835668"/>
                      </a:lnTo>
                      <a:cubicBezTo>
                        <a:pt x="2086968" y="2862429"/>
                        <a:pt x="2094157" y="2935604"/>
                        <a:pt x="2059969" y="2964095"/>
                      </a:cubicBezTo>
                      <a:cubicBezTo>
                        <a:pt x="2055809" y="2967562"/>
                        <a:pt x="2049535" y="2967099"/>
                        <a:pt x="2044558" y="2969232"/>
                      </a:cubicBezTo>
                      <a:cubicBezTo>
                        <a:pt x="2037519" y="2972249"/>
                        <a:pt x="2031048" y="2976489"/>
                        <a:pt x="2024009" y="2979506"/>
                      </a:cubicBezTo>
                      <a:cubicBezTo>
                        <a:pt x="2019032" y="2981639"/>
                        <a:pt x="2013575" y="2982510"/>
                        <a:pt x="2008598" y="2984643"/>
                      </a:cubicBezTo>
                      <a:cubicBezTo>
                        <a:pt x="1993979" y="2990908"/>
                        <a:pt x="1987698" y="2997042"/>
                        <a:pt x="1972639" y="3000054"/>
                      </a:cubicBezTo>
                      <a:cubicBezTo>
                        <a:pt x="1960766" y="3002429"/>
                        <a:pt x="1948592" y="3003025"/>
                        <a:pt x="1936679" y="3005191"/>
                      </a:cubicBezTo>
                      <a:cubicBezTo>
                        <a:pt x="1863879" y="3018428"/>
                        <a:pt x="1992588" y="3000477"/>
                        <a:pt x="1880171" y="3015466"/>
                      </a:cubicBezTo>
                      <a:cubicBezTo>
                        <a:pt x="1849102" y="3019609"/>
                        <a:pt x="1819026" y="3023130"/>
                        <a:pt x="1787704" y="3025740"/>
                      </a:cubicBezTo>
                      <a:cubicBezTo>
                        <a:pt x="1763753" y="3027736"/>
                        <a:pt x="1739807" y="3030102"/>
                        <a:pt x="1715785" y="3030877"/>
                      </a:cubicBezTo>
                      <a:cubicBezTo>
                        <a:pt x="1633617" y="3033528"/>
                        <a:pt x="1551398" y="3034302"/>
                        <a:pt x="1469205" y="3036014"/>
                      </a:cubicBezTo>
                      <a:cubicBezTo>
                        <a:pt x="1447925" y="3035047"/>
                        <a:pt x="1320037" y="3030211"/>
                        <a:pt x="1284270" y="3025740"/>
                      </a:cubicBezTo>
                      <a:cubicBezTo>
                        <a:pt x="1164223" y="3010734"/>
                        <a:pt x="1298533" y="3022427"/>
                        <a:pt x="1186666" y="3000054"/>
                      </a:cubicBezTo>
                      <a:cubicBezTo>
                        <a:pt x="1178104" y="2998342"/>
                        <a:pt x="1169376" y="2997316"/>
                        <a:pt x="1160980" y="2994917"/>
                      </a:cubicBezTo>
                      <a:cubicBezTo>
                        <a:pt x="1076172" y="2970687"/>
                        <a:pt x="1146956" y="2985948"/>
                        <a:pt x="1089061" y="2974369"/>
                      </a:cubicBezTo>
                      <a:cubicBezTo>
                        <a:pt x="1062248" y="2956494"/>
                        <a:pt x="1084354" y="2968186"/>
                        <a:pt x="1042827" y="2958958"/>
                      </a:cubicBezTo>
                      <a:cubicBezTo>
                        <a:pt x="1037541" y="2957783"/>
                        <a:pt x="1032702" y="2954996"/>
                        <a:pt x="1027416" y="2953821"/>
                      </a:cubicBezTo>
                      <a:cubicBezTo>
                        <a:pt x="1017248" y="2951562"/>
                        <a:pt x="1006868" y="2950396"/>
                        <a:pt x="996594" y="2948684"/>
                      </a:cubicBezTo>
                      <a:cubicBezTo>
                        <a:pt x="988032" y="2945259"/>
                        <a:pt x="979574" y="2941561"/>
                        <a:pt x="970908" y="2938409"/>
                      </a:cubicBezTo>
                      <a:cubicBezTo>
                        <a:pt x="960730" y="2934708"/>
                        <a:pt x="949097" y="2934142"/>
                        <a:pt x="940086" y="2928135"/>
                      </a:cubicBezTo>
                      <a:cubicBezTo>
                        <a:pt x="918800" y="2913945"/>
                        <a:pt x="930665" y="2919358"/>
                        <a:pt x="904126" y="2912724"/>
                      </a:cubicBezTo>
                      <a:cubicBezTo>
                        <a:pt x="897277" y="2909299"/>
                        <a:pt x="890748" y="2905139"/>
                        <a:pt x="883578" y="2902450"/>
                      </a:cubicBezTo>
                      <a:cubicBezTo>
                        <a:pt x="876967" y="2899971"/>
                        <a:pt x="869345" y="2900470"/>
                        <a:pt x="863030" y="2897313"/>
                      </a:cubicBezTo>
                      <a:cubicBezTo>
                        <a:pt x="851985" y="2891791"/>
                        <a:pt x="843672" y="2881350"/>
                        <a:pt x="832207" y="2876764"/>
                      </a:cubicBezTo>
                      <a:cubicBezTo>
                        <a:pt x="807158" y="2866744"/>
                        <a:pt x="790094" y="2860744"/>
                        <a:pt x="765425" y="2845942"/>
                      </a:cubicBezTo>
                      <a:cubicBezTo>
                        <a:pt x="756863" y="2840805"/>
                        <a:pt x="748048" y="2836069"/>
                        <a:pt x="739740" y="2830531"/>
                      </a:cubicBezTo>
                      <a:cubicBezTo>
                        <a:pt x="732616" y="2825782"/>
                        <a:pt x="727015" y="2818597"/>
                        <a:pt x="719191" y="2815120"/>
                      </a:cubicBezTo>
                      <a:cubicBezTo>
                        <a:pt x="711212" y="2811574"/>
                        <a:pt x="702068" y="2811695"/>
                        <a:pt x="693506" y="2809982"/>
                      </a:cubicBezTo>
                      <a:cubicBezTo>
                        <a:pt x="690081" y="2804845"/>
                        <a:pt x="688290" y="2798111"/>
                        <a:pt x="683232" y="2794571"/>
                      </a:cubicBezTo>
                      <a:cubicBezTo>
                        <a:pt x="662351" y="2779954"/>
                        <a:pt x="647805" y="2775913"/>
                        <a:pt x="626724" y="2768886"/>
                      </a:cubicBezTo>
                      <a:cubicBezTo>
                        <a:pt x="619875" y="2763749"/>
                        <a:pt x="612676" y="2759047"/>
                        <a:pt x="606176" y="2753475"/>
                      </a:cubicBezTo>
                      <a:cubicBezTo>
                        <a:pt x="573938" y="2725842"/>
                        <a:pt x="609270" y="2749689"/>
                        <a:pt x="570216" y="2722652"/>
                      </a:cubicBezTo>
                      <a:cubicBezTo>
                        <a:pt x="554987" y="2712109"/>
                        <a:pt x="523982" y="2691830"/>
                        <a:pt x="523982" y="2691830"/>
                      </a:cubicBezTo>
                      <a:cubicBezTo>
                        <a:pt x="513880" y="2676676"/>
                        <a:pt x="513130" y="2673368"/>
                        <a:pt x="498297" y="2661007"/>
                      </a:cubicBezTo>
                      <a:cubicBezTo>
                        <a:pt x="493554" y="2657055"/>
                        <a:pt x="487475" y="2654863"/>
                        <a:pt x="482886" y="2650733"/>
                      </a:cubicBezTo>
                      <a:cubicBezTo>
                        <a:pt x="470286" y="2639393"/>
                        <a:pt x="460163" y="2625363"/>
                        <a:pt x="446926" y="2614773"/>
                      </a:cubicBezTo>
                      <a:cubicBezTo>
                        <a:pt x="438364" y="2607924"/>
                        <a:pt x="428994" y="2601978"/>
                        <a:pt x="421241" y="2594225"/>
                      </a:cubicBezTo>
                      <a:cubicBezTo>
                        <a:pt x="416875" y="2589859"/>
                        <a:pt x="415333" y="2583180"/>
                        <a:pt x="410967" y="2578814"/>
                      </a:cubicBezTo>
                      <a:cubicBezTo>
                        <a:pt x="406601" y="2574448"/>
                        <a:pt x="400202" y="2572606"/>
                        <a:pt x="395555" y="2568540"/>
                      </a:cubicBezTo>
                      <a:cubicBezTo>
                        <a:pt x="347469" y="2526465"/>
                        <a:pt x="389141" y="2555701"/>
                        <a:pt x="354459" y="2532580"/>
                      </a:cubicBezTo>
                      <a:cubicBezTo>
                        <a:pt x="349264" y="2524788"/>
                        <a:pt x="339048" y="2512392"/>
                        <a:pt x="339048" y="2501758"/>
                      </a:cubicBezTo>
                      <a:cubicBezTo>
                        <a:pt x="339048" y="2489650"/>
                        <a:pt x="338178" y="2476311"/>
                        <a:pt x="344185" y="2465798"/>
                      </a:cubicBezTo>
                      <a:cubicBezTo>
                        <a:pt x="352595" y="2451080"/>
                        <a:pt x="368158" y="2441825"/>
                        <a:pt x="380144" y="2429839"/>
                      </a:cubicBezTo>
                      <a:cubicBezTo>
                        <a:pt x="394249" y="2415734"/>
                        <a:pt x="385821" y="2421096"/>
                        <a:pt x="405830" y="2414427"/>
                      </a:cubicBezTo>
                      <a:cubicBezTo>
                        <a:pt x="421241" y="2402441"/>
                        <a:pt x="441233" y="2394713"/>
                        <a:pt x="452063" y="2378468"/>
                      </a:cubicBezTo>
                      <a:cubicBezTo>
                        <a:pt x="455488" y="2373331"/>
                        <a:pt x="457691" y="2367123"/>
                        <a:pt x="462337" y="2363057"/>
                      </a:cubicBezTo>
                      <a:cubicBezTo>
                        <a:pt x="503089" y="2327399"/>
                        <a:pt x="479909" y="2354766"/>
                        <a:pt x="513708" y="2332234"/>
                      </a:cubicBezTo>
                      <a:cubicBezTo>
                        <a:pt x="522831" y="2326152"/>
                        <a:pt x="530271" y="2317768"/>
                        <a:pt x="539394" y="2311686"/>
                      </a:cubicBezTo>
                      <a:cubicBezTo>
                        <a:pt x="545766" y="2307438"/>
                        <a:pt x="553448" y="2305471"/>
                        <a:pt x="559942" y="2301412"/>
                      </a:cubicBezTo>
                      <a:cubicBezTo>
                        <a:pt x="594363" y="2279898"/>
                        <a:pt x="566285" y="2290534"/>
                        <a:pt x="606176" y="2270589"/>
                      </a:cubicBezTo>
                      <a:cubicBezTo>
                        <a:pt x="611019" y="2268167"/>
                        <a:pt x="616610" y="2267585"/>
                        <a:pt x="621587" y="2265452"/>
                      </a:cubicBezTo>
                      <a:cubicBezTo>
                        <a:pt x="628626" y="2262435"/>
                        <a:pt x="635286" y="2258603"/>
                        <a:pt x="642135" y="2255178"/>
                      </a:cubicBezTo>
                      <a:cubicBezTo>
                        <a:pt x="666191" y="2219094"/>
                        <a:pt x="637098" y="2255900"/>
                        <a:pt x="667821" y="2234630"/>
                      </a:cubicBezTo>
                      <a:cubicBezTo>
                        <a:pt x="685851" y="2222148"/>
                        <a:pt x="700945" y="2205697"/>
                        <a:pt x="719191" y="2193533"/>
                      </a:cubicBezTo>
                      <a:cubicBezTo>
                        <a:pt x="729465" y="2186684"/>
                        <a:pt x="741283" y="2181717"/>
                        <a:pt x="750014" y="2172985"/>
                      </a:cubicBezTo>
                      <a:cubicBezTo>
                        <a:pt x="756863" y="2166135"/>
                        <a:pt x="763167" y="2158693"/>
                        <a:pt x="770562" y="2152436"/>
                      </a:cubicBezTo>
                      <a:cubicBezTo>
                        <a:pt x="785466" y="2139825"/>
                        <a:pt x="801444" y="2128539"/>
                        <a:pt x="816796" y="2116477"/>
                      </a:cubicBezTo>
                      <a:cubicBezTo>
                        <a:pt x="825417" y="2109703"/>
                        <a:pt x="833826" y="2102660"/>
                        <a:pt x="842481" y="2095929"/>
                      </a:cubicBezTo>
                      <a:cubicBezTo>
                        <a:pt x="849240" y="2090672"/>
                        <a:pt x="856976" y="2086571"/>
                        <a:pt x="863030" y="2080517"/>
                      </a:cubicBezTo>
                      <a:cubicBezTo>
                        <a:pt x="876729" y="2066818"/>
                        <a:pt x="888007" y="2050168"/>
                        <a:pt x="904126" y="2039421"/>
                      </a:cubicBezTo>
                      <a:cubicBezTo>
                        <a:pt x="909263" y="2035996"/>
                        <a:pt x="915171" y="2033512"/>
                        <a:pt x="919537" y="2029146"/>
                      </a:cubicBezTo>
                      <a:cubicBezTo>
                        <a:pt x="927290" y="2021393"/>
                        <a:pt x="932751" y="2011611"/>
                        <a:pt x="940086" y="2003461"/>
                      </a:cubicBezTo>
                      <a:cubicBezTo>
                        <a:pt x="948186" y="1994461"/>
                        <a:pt x="958104" y="1987147"/>
                        <a:pt x="965771" y="1977776"/>
                      </a:cubicBezTo>
                      <a:cubicBezTo>
                        <a:pt x="1021072" y="1910186"/>
                        <a:pt x="959514" y="1973759"/>
                        <a:pt x="1001731" y="1931542"/>
                      </a:cubicBezTo>
                      <a:cubicBezTo>
                        <a:pt x="1003443" y="1926405"/>
                        <a:pt x="1003485" y="1920359"/>
                        <a:pt x="1006868" y="1916131"/>
                      </a:cubicBezTo>
                      <a:cubicBezTo>
                        <a:pt x="1010725" y="1911310"/>
                        <a:pt x="1017458" y="1909714"/>
                        <a:pt x="1022279" y="1905857"/>
                      </a:cubicBezTo>
                      <a:cubicBezTo>
                        <a:pt x="1026061" y="1902831"/>
                        <a:pt x="1029128" y="1899007"/>
                        <a:pt x="1032553" y="1895582"/>
                      </a:cubicBezTo>
                      <a:cubicBezTo>
                        <a:pt x="1027416" y="1892157"/>
                        <a:pt x="1023316" y="1885308"/>
                        <a:pt x="1017142" y="1885308"/>
                      </a:cubicBezTo>
                      <a:cubicBezTo>
                        <a:pt x="1001550" y="1885308"/>
                        <a:pt x="980099" y="1899716"/>
                        <a:pt x="965771" y="1905857"/>
                      </a:cubicBezTo>
                      <a:cubicBezTo>
                        <a:pt x="960794" y="1907990"/>
                        <a:pt x="955497" y="1909282"/>
                        <a:pt x="950360" y="1910994"/>
                      </a:cubicBezTo>
                      <a:cubicBezTo>
                        <a:pt x="943511" y="1916131"/>
                        <a:pt x="937246" y="1922157"/>
                        <a:pt x="929812" y="1926405"/>
                      </a:cubicBezTo>
                      <a:cubicBezTo>
                        <a:pt x="890545" y="1948842"/>
                        <a:pt x="937150" y="1888244"/>
                        <a:pt x="863030" y="1962364"/>
                      </a:cubicBezTo>
                      <a:cubicBezTo>
                        <a:pt x="859605" y="1965789"/>
                        <a:pt x="856908" y="1970147"/>
                        <a:pt x="852755" y="1972639"/>
                      </a:cubicBezTo>
                      <a:cubicBezTo>
                        <a:pt x="839622" y="1980519"/>
                        <a:pt x="824402" y="1984691"/>
                        <a:pt x="811659" y="1993187"/>
                      </a:cubicBezTo>
                      <a:cubicBezTo>
                        <a:pt x="775340" y="2017399"/>
                        <a:pt x="820302" y="1987013"/>
                        <a:pt x="775699" y="2018872"/>
                      </a:cubicBezTo>
                      <a:cubicBezTo>
                        <a:pt x="770675" y="2022460"/>
                        <a:pt x="765930" y="2026638"/>
                        <a:pt x="760288" y="2029146"/>
                      </a:cubicBezTo>
                      <a:cubicBezTo>
                        <a:pt x="739924" y="2038197"/>
                        <a:pt x="723168" y="2038924"/>
                        <a:pt x="703780" y="2049695"/>
                      </a:cubicBezTo>
                      <a:cubicBezTo>
                        <a:pt x="696296" y="2053853"/>
                        <a:pt x="690716" y="2060948"/>
                        <a:pt x="683232" y="2065106"/>
                      </a:cubicBezTo>
                      <a:cubicBezTo>
                        <a:pt x="675171" y="2069584"/>
                        <a:pt x="665794" y="2071256"/>
                        <a:pt x="657546" y="2075380"/>
                      </a:cubicBezTo>
                      <a:cubicBezTo>
                        <a:pt x="648616" y="2079845"/>
                        <a:pt x="640626" y="2086010"/>
                        <a:pt x="631861" y="2090791"/>
                      </a:cubicBezTo>
                      <a:cubicBezTo>
                        <a:pt x="621777" y="2096292"/>
                        <a:pt x="610889" y="2100293"/>
                        <a:pt x="601039" y="2106203"/>
                      </a:cubicBezTo>
                      <a:cubicBezTo>
                        <a:pt x="593697" y="2110608"/>
                        <a:pt x="587751" y="2117076"/>
                        <a:pt x="580490" y="2121614"/>
                      </a:cubicBezTo>
                      <a:cubicBezTo>
                        <a:pt x="573996" y="2125673"/>
                        <a:pt x="566436" y="2127829"/>
                        <a:pt x="559942" y="2131888"/>
                      </a:cubicBezTo>
                      <a:cubicBezTo>
                        <a:pt x="552682" y="2136426"/>
                        <a:pt x="546789" y="2142985"/>
                        <a:pt x="539394" y="2147299"/>
                      </a:cubicBezTo>
                      <a:cubicBezTo>
                        <a:pt x="526164" y="2155016"/>
                        <a:pt x="511041" y="2159352"/>
                        <a:pt x="498297" y="2167848"/>
                      </a:cubicBezTo>
                      <a:cubicBezTo>
                        <a:pt x="493160" y="2171273"/>
                        <a:pt x="488246" y="2175059"/>
                        <a:pt x="482886" y="2178122"/>
                      </a:cubicBezTo>
                      <a:cubicBezTo>
                        <a:pt x="458980" y="2191782"/>
                        <a:pt x="463559" y="2186440"/>
                        <a:pt x="436652" y="2198670"/>
                      </a:cubicBezTo>
                      <a:cubicBezTo>
                        <a:pt x="426195" y="2203423"/>
                        <a:pt x="416433" y="2209663"/>
                        <a:pt x="405830" y="2214081"/>
                      </a:cubicBezTo>
                      <a:cubicBezTo>
                        <a:pt x="395833" y="2218246"/>
                        <a:pt x="384866" y="2219873"/>
                        <a:pt x="375007" y="2224355"/>
                      </a:cubicBezTo>
                      <a:cubicBezTo>
                        <a:pt x="365917" y="2228487"/>
                        <a:pt x="358388" y="2235583"/>
                        <a:pt x="349322" y="2239767"/>
                      </a:cubicBezTo>
                      <a:cubicBezTo>
                        <a:pt x="336038" y="2245898"/>
                        <a:pt x="321509" y="2249047"/>
                        <a:pt x="308225" y="2255178"/>
                      </a:cubicBezTo>
                      <a:cubicBezTo>
                        <a:pt x="255710" y="2279415"/>
                        <a:pt x="306917" y="2264495"/>
                        <a:pt x="261991" y="2275726"/>
                      </a:cubicBezTo>
                      <a:cubicBezTo>
                        <a:pt x="256854" y="2279151"/>
                        <a:pt x="252102" y="2283239"/>
                        <a:pt x="246580" y="2286000"/>
                      </a:cubicBezTo>
                      <a:cubicBezTo>
                        <a:pt x="241737" y="2288422"/>
                        <a:pt x="235761" y="2288268"/>
                        <a:pt x="231169" y="2291138"/>
                      </a:cubicBezTo>
                      <a:cubicBezTo>
                        <a:pt x="221871" y="2296949"/>
                        <a:pt x="214256" y="2305108"/>
                        <a:pt x="205484" y="2311686"/>
                      </a:cubicBezTo>
                      <a:cubicBezTo>
                        <a:pt x="200545" y="2315390"/>
                        <a:pt x="195209" y="2318535"/>
                        <a:pt x="190072" y="2321960"/>
                      </a:cubicBezTo>
                      <a:cubicBezTo>
                        <a:pt x="184204" y="2313158"/>
                        <a:pt x="171825" y="2295970"/>
                        <a:pt x="169524" y="2286000"/>
                      </a:cubicBezTo>
                      <a:cubicBezTo>
                        <a:pt x="166037" y="2270891"/>
                        <a:pt x="166745" y="2255093"/>
                        <a:pt x="164387" y="2239767"/>
                      </a:cubicBezTo>
                      <a:cubicBezTo>
                        <a:pt x="163313" y="2232789"/>
                        <a:pt x="160635" y="2226141"/>
                        <a:pt x="159250" y="2219218"/>
                      </a:cubicBezTo>
                      <a:cubicBezTo>
                        <a:pt x="157207" y="2209005"/>
                        <a:pt x="156372" y="2198564"/>
                        <a:pt x="154113" y="2188396"/>
                      </a:cubicBezTo>
                      <a:cubicBezTo>
                        <a:pt x="151262" y="2175567"/>
                        <a:pt x="142128" y="2158717"/>
                        <a:pt x="138702" y="2147299"/>
                      </a:cubicBezTo>
                      <a:cubicBezTo>
                        <a:pt x="130437" y="2119750"/>
                        <a:pt x="138894" y="2124473"/>
                        <a:pt x="123290" y="2101066"/>
                      </a:cubicBezTo>
                      <a:cubicBezTo>
                        <a:pt x="91913" y="2053999"/>
                        <a:pt x="139987" y="2144732"/>
                        <a:pt x="102742" y="2070243"/>
                      </a:cubicBezTo>
                      <a:cubicBezTo>
                        <a:pt x="93976" y="2008880"/>
                        <a:pt x="102714" y="2054735"/>
                        <a:pt x="92468" y="2018872"/>
                      </a:cubicBezTo>
                      <a:cubicBezTo>
                        <a:pt x="90528" y="2012084"/>
                        <a:pt x="90112" y="2004813"/>
                        <a:pt x="87331" y="1998324"/>
                      </a:cubicBezTo>
                      <a:cubicBezTo>
                        <a:pt x="84899" y="1992649"/>
                        <a:pt x="79818" y="1988435"/>
                        <a:pt x="77057" y="1982913"/>
                      </a:cubicBezTo>
                      <a:cubicBezTo>
                        <a:pt x="74635" y="1978070"/>
                        <a:pt x="73632" y="1972639"/>
                        <a:pt x="71920" y="1967502"/>
                      </a:cubicBezTo>
                      <a:cubicBezTo>
                        <a:pt x="70207" y="1948666"/>
                        <a:pt x="70069" y="1929620"/>
                        <a:pt x="66782" y="1910994"/>
                      </a:cubicBezTo>
                      <a:cubicBezTo>
                        <a:pt x="64900" y="1900329"/>
                        <a:pt x="60209" y="1890349"/>
                        <a:pt x="56508" y="1880171"/>
                      </a:cubicBezTo>
                      <a:cubicBezTo>
                        <a:pt x="27912" y="1801531"/>
                        <a:pt x="65944" y="1913618"/>
                        <a:pt x="35960" y="1823663"/>
                      </a:cubicBezTo>
                      <a:cubicBezTo>
                        <a:pt x="34248" y="1818526"/>
                        <a:pt x="32136" y="1813505"/>
                        <a:pt x="30823" y="1808252"/>
                      </a:cubicBezTo>
                      <a:cubicBezTo>
                        <a:pt x="14099" y="1741354"/>
                        <a:pt x="22110" y="1766701"/>
                        <a:pt x="10275" y="1731196"/>
                      </a:cubicBezTo>
                      <a:cubicBezTo>
                        <a:pt x="7204" y="1694345"/>
                        <a:pt x="0" y="1613975"/>
                        <a:pt x="0" y="1582221"/>
                      </a:cubicBezTo>
                      <a:cubicBezTo>
                        <a:pt x="0" y="1486313"/>
                        <a:pt x="2358" y="1390411"/>
                        <a:pt x="5137" y="1294544"/>
                      </a:cubicBezTo>
                      <a:cubicBezTo>
                        <a:pt x="7055" y="1228387"/>
                        <a:pt x="3605" y="1244436"/>
                        <a:pt x="20549" y="1202077"/>
                      </a:cubicBezTo>
                      <a:cubicBezTo>
                        <a:pt x="24080" y="1184420"/>
                        <a:pt x="25986" y="1172772"/>
                        <a:pt x="30823" y="1155843"/>
                      </a:cubicBezTo>
                      <a:cubicBezTo>
                        <a:pt x="32311" y="1150636"/>
                        <a:pt x="34248" y="1145569"/>
                        <a:pt x="35960" y="1140432"/>
                      </a:cubicBezTo>
                      <a:cubicBezTo>
                        <a:pt x="37672" y="1130158"/>
                        <a:pt x="37537" y="1119398"/>
                        <a:pt x="41097" y="1109609"/>
                      </a:cubicBezTo>
                      <a:cubicBezTo>
                        <a:pt x="44509" y="1100226"/>
                        <a:pt x="52043" y="1092854"/>
                        <a:pt x="56508" y="1083924"/>
                      </a:cubicBezTo>
                      <a:cubicBezTo>
                        <a:pt x="60632" y="1075676"/>
                        <a:pt x="63631" y="1066905"/>
                        <a:pt x="66782" y="1058239"/>
                      </a:cubicBezTo>
                      <a:cubicBezTo>
                        <a:pt x="70483" y="1048061"/>
                        <a:pt x="73356" y="1037594"/>
                        <a:pt x="77057" y="1027416"/>
                      </a:cubicBezTo>
                      <a:cubicBezTo>
                        <a:pt x="80208" y="1018750"/>
                        <a:pt x="84619" y="1010544"/>
                        <a:pt x="87331" y="1001731"/>
                      </a:cubicBezTo>
                      <a:cubicBezTo>
                        <a:pt x="91484" y="988235"/>
                        <a:pt x="92361" y="973745"/>
                        <a:pt x="97605" y="960634"/>
                      </a:cubicBezTo>
                      <a:cubicBezTo>
                        <a:pt x="101030" y="952072"/>
                        <a:pt x="104963" y="943697"/>
                        <a:pt x="107879" y="934949"/>
                      </a:cubicBezTo>
                      <a:cubicBezTo>
                        <a:pt x="110112" y="928251"/>
                        <a:pt x="110300" y="920917"/>
                        <a:pt x="113016" y="914400"/>
                      </a:cubicBezTo>
                      <a:cubicBezTo>
                        <a:pt x="118907" y="900263"/>
                        <a:pt x="129849" y="888162"/>
                        <a:pt x="133564" y="873304"/>
                      </a:cubicBezTo>
                      <a:cubicBezTo>
                        <a:pt x="142757" y="836538"/>
                        <a:pt x="133481" y="867324"/>
                        <a:pt x="154113" y="821933"/>
                      </a:cubicBezTo>
                      <a:cubicBezTo>
                        <a:pt x="157929" y="813538"/>
                        <a:pt x="160523" y="804620"/>
                        <a:pt x="164387" y="796248"/>
                      </a:cubicBezTo>
                      <a:cubicBezTo>
                        <a:pt x="170805" y="782342"/>
                        <a:pt x="184935" y="755151"/>
                        <a:pt x="184935" y="755151"/>
                      </a:cubicBezTo>
                      <a:cubicBezTo>
                        <a:pt x="185972" y="748929"/>
                        <a:pt x="189373" y="718644"/>
                        <a:pt x="195209" y="708917"/>
                      </a:cubicBezTo>
                      <a:cubicBezTo>
                        <a:pt x="197701" y="704764"/>
                        <a:pt x="202059" y="702068"/>
                        <a:pt x="205484" y="698643"/>
                      </a:cubicBezTo>
                      <a:cubicBezTo>
                        <a:pt x="208909" y="688369"/>
                        <a:pt x="208100" y="675479"/>
                        <a:pt x="215758" y="667821"/>
                      </a:cubicBezTo>
                      <a:cubicBezTo>
                        <a:pt x="226032" y="657547"/>
                        <a:pt x="238520" y="649088"/>
                        <a:pt x="246580" y="636998"/>
                      </a:cubicBezTo>
                      <a:cubicBezTo>
                        <a:pt x="250005" y="631861"/>
                        <a:pt x="252997" y="626408"/>
                        <a:pt x="256854" y="621587"/>
                      </a:cubicBezTo>
                      <a:cubicBezTo>
                        <a:pt x="286134" y="584989"/>
                        <a:pt x="245782" y="643334"/>
                        <a:pt x="277403" y="595902"/>
                      </a:cubicBezTo>
                      <a:cubicBezTo>
                        <a:pt x="279115" y="590765"/>
                        <a:pt x="279215" y="584765"/>
                        <a:pt x="282540" y="580490"/>
                      </a:cubicBezTo>
                      <a:cubicBezTo>
                        <a:pt x="291460" y="569021"/>
                        <a:pt x="303088" y="559942"/>
                        <a:pt x="313362" y="549668"/>
                      </a:cubicBezTo>
                      <a:cubicBezTo>
                        <a:pt x="320212" y="542819"/>
                        <a:pt x="328538" y="537180"/>
                        <a:pt x="333911" y="529120"/>
                      </a:cubicBezTo>
                      <a:cubicBezTo>
                        <a:pt x="337336" y="523983"/>
                        <a:pt x="340055" y="518297"/>
                        <a:pt x="344185" y="513708"/>
                      </a:cubicBezTo>
                      <a:cubicBezTo>
                        <a:pt x="355525" y="501108"/>
                        <a:pt x="370741" y="491853"/>
                        <a:pt x="380144" y="477749"/>
                      </a:cubicBezTo>
                      <a:cubicBezTo>
                        <a:pt x="401314" y="445994"/>
                        <a:pt x="377809" y="476970"/>
                        <a:pt x="405830" y="452063"/>
                      </a:cubicBezTo>
                      <a:cubicBezTo>
                        <a:pt x="452420" y="410650"/>
                        <a:pt x="418200" y="430467"/>
                        <a:pt x="457200" y="410967"/>
                      </a:cubicBezTo>
                      <a:cubicBezTo>
                        <a:pt x="460625" y="405830"/>
                        <a:pt x="461485" y="397052"/>
                        <a:pt x="467475" y="395555"/>
                      </a:cubicBezTo>
                      <a:cubicBezTo>
                        <a:pt x="477580" y="393029"/>
                        <a:pt x="488129" y="398433"/>
                        <a:pt x="498297" y="400693"/>
                      </a:cubicBezTo>
                      <a:cubicBezTo>
                        <a:pt x="519279" y="405356"/>
                        <a:pt x="523212" y="412812"/>
                        <a:pt x="544531" y="426378"/>
                      </a:cubicBezTo>
                      <a:cubicBezTo>
                        <a:pt x="571221" y="443362"/>
                        <a:pt x="562717" y="439289"/>
                        <a:pt x="585627" y="446926"/>
                      </a:cubicBezTo>
                      <a:cubicBezTo>
                        <a:pt x="610661" y="484475"/>
                        <a:pt x="577343" y="440023"/>
                        <a:pt x="616450" y="472612"/>
                      </a:cubicBezTo>
                      <a:cubicBezTo>
                        <a:pt x="647431" y="498430"/>
                        <a:pt x="605340" y="480895"/>
                        <a:pt x="642135" y="493160"/>
                      </a:cubicBezTo>
                      <a:cubicBezTo>
                        <a:pt x="648985" y="501722"/>
                        <a:pt x="655548" y="510520"/>
                        <a:pt x="662684" y="518845"/>
                      </a:cubicBezTo>
                      <a:cubicBezTo>
                        <a:pt x="665836" y="522522"/>
                        <a:pt x="669932" y="525338"/>
                        <a:pt x="672958" y="529120"/>
                      </a:cubicBezTo>
                      <a:cubicBezTo>
                        <a:pt x="676815" y="533941"/>
                        <a:pt x="679214" y="539843"/>
                        <a:pt x="683232" y="544531"/>
                      </a:cubicBezTo>
                      <a:cubicBezTo>
                        <a:pt x="689536" y="551885"/>
                        <a:pt x="697729" y="557515"/>
                        <a:pt x="703780" y="565079"/>
                      </a:cubicBezTo>
                      <a:cubicBezTo>
                        <a:pt x="711494" y="574721"/>
                        <a:pt x="715597" y="587170"/>
                        <a:pt x="724329" y="595902"/>
                      </a:cubicBezTo>
                      <a:cubicBezTo>
                        <a:pt x="729466" y="601039"/>
                        <a:pt x="735012" y="605797"/>
                        <a:pt x="739740" y="611313"/>
                      </a:cubicBezTo>
                      <a:cubicBezTo>
                        <a:pt x="746695" y="619427"/>
                        <a:pt x="759171" y="637265"/>
                        <a:pt x="765425" y="647272"/>
                      </a:cubicBezTo>
                      <a:cubicBezTo>
                        <a:pt x="770717" y="655739"/>
                        <a:pt x="774513" y="665230"/>
                        <a:pt x="780836" y="672958"/>
                      </a:cubicBezTo>
                      <a:cubicBezTo>
                        <a:pt x="790037" y="684203"/>
                        <a:pt x="801385" y="693506"/>
                        <a:pt x="811659" y="703780"/>
                      </a:cubicBezTo>
                      <a:cubicBezTo>
                        <a:pt x="816796" y="708917"/>
                        <a:pt x="823040" y="713146"/>
                        <a:pt x="827070" y="719191"/>
                      </a:cubicBezTo>
                      <a:cubicBezTo>
                        <a:pt x="860358" y="769126"/>
                        <a:pt x="797785" y="677444"/>
                        <a:pt x="868167" y="765425"/>
                      </a:cubicBezTo>
                      <a:cubicBezTo>
                        <a:pt x="875016" y="773987"/>
                        <a:pt x="881495" y="782859"/>
                        <a:pt x="888715" y="791111"/>
                      </a:cubicBezTo>
                      <a:cubicBezTo>
                        <a:pt x="893499" y="796578"/>
                        <a:pt x="899475" y="800941"/>
                        <a:pt x="904126" y="806522"/>
                      </a:cubicBezTo>
                      <a:cubicBezTo>
                        <a:pt x="908078" y="811265"/>
                        <a:pt x="910298" y="817319"/>
                        <a:pt x="914400" y="821933"/>
                      </a:cubicBezTo>
                      <a:cubicBezTo>
                        <a:pt x="924053" y="832793"/>
                        <a:pt x="937164" y="840665"/>
                        <a:pt x="945223" y="852755"/>
                      </a:cubicBezTo>
                      <a:cubicBezTo>
                        <a:pt x="967925" y="886811"/>
                        <a:pt x="941249" y="848977"/>
                        <a:pt x="970908" y="883578"/>
                      </a:cubicBezTo>
                      <a:cubicBezTo>
                        <a:pt x="976480" y="890079"/>
                        <a:pt x="980748" y="897625"/>
                        <a:pt x="986320" y="904126"/>
                      </a:cubicBezTo>
                      <a:cubicBezTo>
                        <a:pt x="991048" y="909642"/>
                        <a:pt x="997080" y="913957"/>
                        <a:pt x="1001731" y="919538"/>
                      </a:cubicBezTo>
                      <a:cubicBezTo>
                        <a:pt x="1005683" y="924281"/>
                        <a:pt x="1007639" y="930583"/>
                        <a:pt x="1012005" y="934949"/>
                      </a:cubicBezTo>
                      <a:cubicBezTo>
                        <a:pt x="1016371" y="939315"/>
                        <a:pt x="1023050" y="940857"/>
                        <a:pt x="1027416" y="945223"/>
                      </a:cubicBezTo>
                      <a:cubicBezTo>
                        <a:pt x="1035169" y="952976"/>
                        <a:pt x="1040589" y="962795"/>
                        <a:pt x="1047964" y="970908"/>
                      </a:cubicBezTo>
                      <a:cubicBezTo>
                        <a:pt x="1065830" y="990560"/>
                        <a:pt x="1078365" y="1003162"/>
                        <a:pt x="1099335" y="1017142"/>
                      </a:cubicBezTo>
                      <a:cubicBezTo>
                        <a:pt x="1107643" y="1022680"/>
                        <a:pt x="1116459" y="1027416"/>
                        <a:pt x="1125021" y="1032553"/>
                      </a:cubicBezTo>
                      <a:cubicBezTo>
                        <a:pt x="1143856" y="1060805"/>
                        <a:pt x="1125022" y="1036835"/>
                        <a:pt x="1150706" y="1058239"/>
                      </a:cubicBezTo>
                      <a:cubicBezTo>
                        <a:pt x="1156287" y="1062890"/>
                        <a:pt x="1160650" y="1068866"/>
                        <a:pt x="1166117" y="1073650"/>
                      </a:cubicBezTo>
                      <a:cubicBezTo>
                        <a:pt x="1190466" y="1094955"/>
                        <a:pt x="1190718" y="1093547"/>
                        <a:pt x="1217488" y="1109609"/>
                      </a:cubicBezTo>
                      <a:cubicBezTo>
                        <a:pt x="1244881" y="1150701"/>
                        <a:pt x="1208931" y="1101055"/>
                        <a:pt x="1243173" y="1135295"/>
                      </a:cubicBezTo>
                      <a:cubicBezTo>
                        <a:pt x="1261434" y="1153555"/>
                        <a:pt x="1257729" y="1139576"/>
                        <a:pt x="1258585" y="1135295"/>
                      </a:cubicBezTo>
                      <a:close/>
                    </a:path>
                  </a:pathLst>
                </a:custGeom>
                <a:solidFill>
                  <a:srgbClr val="999999"/>
                </a:solidFill>
                <a:ln w="6350">
                  <a:solidFill>
                    <a:schemeClr val="bg1">
                      <a:lumMod val="50000"/>
                    </a:schemeClr>
                  </a:solidFill>
                  <a:extLst>
                    <a:ext uri="{C807C97D-BFC1-408E-A445-0C87EB9F89A2}">
                      <ask:lineSketchStyleProps xmlns:ask="http://schemas.microsoft.com/office/drawing/2018/sketchyshapes" sd="1219033472">
                        <a:custGeom>
                          <a:avLst/>
                          <a:gdLst>
                            <a:gd name="connsiteX0" fmla="*/ 1258585 w 2994958"/>
                            <a:gd name="connsiteY0" fmla="*/ 1135295 h 3036014"/>
                            <a:gd name="connsiteX1" fmla="*/ 1248311 w 2994958"/>
                            <a:gd name="connsiteY1" fmla="*/ 1109609 h 3036014"/>
                            <a:gd name="connsiteX2" fmla="*/ 1222625 w 2994958"/>
                            <a:gd name="connsiteY2" fmla="*/ 1073650 h 3036014"/>
                            <a:gd name="connsiteX3" fmla="*/ 1212351 w 2994958"/>
                            <a:gd name="connsiteY3" fmla="*/ 1058239 h 3036014"/>
                            <a:gd name="connsiteX4" fmla="*/ 1196940 w 2994958"/>
                            <a:gd name="connsiteY4" fmla="*/ 1047964 h 3036014"/>
                            <a:gd name="connsiteX5" fmla="*/ 1191803 w 2994958"/>
                            <a:gd name="connsiteY5" fmla="*/ 1027416 h 3036014"/>
                            <a:gd name="connsiteX6" fmla="*/ 1176391 w 2994958"/>
                            <a:gd name="connsiteY6" fmla="*/ 1001731 h 3036014"/>
                            <a:gd name="connsiteX7" fmla="*/ 1155843 w 2994958"/>
                            <a:gd name="connsiteY7" fmla="*/ 955497 h 3036014"/>
                            <a:gd name="connsiteX8" fmla="*/ 1140432 w 2994958"/>
                            <a:gd name="connsiteY8" fmla="*/ 909263 h 3036014"/>
                            <a:gd name="connsiteX9" fmla="*/ 1130158 w 2994958"/>
                            <a:gd name="connsiteY9" fmla="*/ 878441 h 3036014"/>
                            <a:gd name="connsiteX10" fmla="*/ 1114746 w 2994958"/>
                            <a:gd name="connsiteY10" fmla="*/ 857893 h 3036014"/>
                            <a:gd name="connsiteX11" fmla="*/ 1094198 w 2994958"/>
                            <a:gd name="connsiteY11" fmla="*/ 811659 h 3036014"/>
                            <a:gd name="connsiteX12" fmla="*/ 1068513 w 2994958"/>
                            <a:gd name="connsiteY12" fmla="*/ 770562 h 3036014"/>
                            <a:gd name="connsiteX13" fmla="*/ 1053102 w 2994958"/>
                            <a:gd name="connsiteY13" fmla="*/ 729466 h 3036014"/>
                            <a:gd name="connsiteX14" fmla="*/ 1042827 w 2994958"/>
                            <a:gd name="connsiteY14" fmla="*/ 719191 h 3036014"/>
                            <a:gd name="connsiteX15" fmla="*/ 1032553 w 2994958"/>
                            <a:gd name="connsiteY15" fmla="*/ 703780 h 3036014"/>
                            <a:gd name="connsiteX16" fmla="*/ 1022279 w 2994958"/>
                            <a:gd name="connsiteY16" fmla="*/ 683232 h 3036014"/>
                            <a:gd name="connsiteX17" fmla="*/ 1012005 w 2994958"/>
                            <a:gd name="connsiteY17" fmla="*/ 667821 h 3036014"/>
                            <a:gd name="connsiteX18" fmla="*/ 1001731 w 2994958"/>
                            <a:gd name="connsiteY18" fmla="*/ 647272 h 3036014"/>
                            <a:gd name="connsiteX19" fmla="*/ 991457 w 2994958"/>
                            <a:gd name="connsiteY19" fmla="*/ 631861 h 3036014"/>
                            <a:gd name="connsiteX20" fmla="*/ 950360 w 2994958"/>
                            <a:gd name="connsiteY20" fmla="*/ 554805 h 3036014"/>
                            <a:gd name="connsiteX21" fmla="*/ 940086 w 2994958"/>
                            <a:gd name="connsiteY21" fmla="*/ 529120 h 3036014"/>
                            <a:gd name="connsiteX22" fmla="*/ 919537 w 2994958"/>
                            <a:gd name="connsiteY22" fmla="*/ 508571 h 3036014"/>
                            <a:gd name="connsiteX23" fmla="*/ 904126 w 2994958"/>
                            <a:gd name="connsiteY23" fmla="*/ 477749 h 3036014"/>
                            <a:gd name="connsiteX24" fmla="*/ 893852 w 2994958"/>
                            <a:gd name="connsiteY24" fmla="*/ 441789 h 3036014"/>
                            <a:gd name="connsiteX25" fmla="*/ 883578 w 2994958"/>
                            <a:gd name="connsiteY25" fmla="*/ 426378 h 3036014"/>
                            <a:gd name="connsiteX26" fmla="*/ 868167 w 2994958"/>
                            <a:gd name="connsiteY26" fmla="*/ 400693 h 3036014"/>
                            <a:gd name="connsiteX27" fmla="*/ 852755 w 2994958"/>
                            <a:gd name="connsiteY27" fmla="*/ 369870 h 3036014"/>
                            <a:gd name="connsiteX28" fmla="*/ 837344 w 2994958"/>
                            <a:gd name="connsiteY28" fmla="*/ 339048 h 3036014"/>
                            <a:gd name="connsiteX29" fmla="*/ 821933 w 2994958"/>
                            <a:gd name="connsiteY29" fmla="*/ 313362 h 3036014"/>
                            <a:gd name="connsiteX30" fmla="*/ 816796 w 2994958"/>
                            <a:gd name="connsiteY30" fmla="*/ 297951 h 3036014"/>
                            <a:gd name="connsiteX31" fmla="*/ 801385 w 2994958"/>
                            <a:gd name="connsiteY31" fmla="*/ 272266 h 3036014"/>
                            <a:gd name="connsiteX32" fmla="*/ 796248 w 2994958"/>
                            <a:gd name="connsiteY32" fmla="*/ 241443 h 3036014"/>
                            <a:gd name="connsiteX33" fmla="*/ 791111 w 2994958"/>
                            <a:gd name="connsiteY33" fmla="*/ 226032 h 3036014"/>
                            <a:gd name="connsiteX34" fmla="*/ 811659 w 2994958"/>
                            <a:gd name="connsiteY34" fmla="*/ 154113 h 3036014"/>
                            <a:gd name="connsiteX35" fmla="*/ 827070 w 2994958"/>
                            <a:gd name="connsiteY35" fmla="*/ 138702 h 3036014"/>
                            <a:gd name="connsiteX36" fmla="*/ 842481 w 2994958"/>
                            <a:gd name="connsiteY36" fmla="*/ 133564 h 3036014"/>
                            <a:gd name="connsiteX37" fmla="*/ 863030 w 2994958"/>
                            <a:gd name="connsiteY37" fmla="*/ 123290 h 3036014"/>
                            <a:gd name="connsiteX38" fmla="*/ 888715 w 2994958"/>
                            <a:gd name="connsiteY38" fmla="*/ 107879 h 3036014"/>
                            <a:gd name="connsiteX39" fmla="*/ 909263 w 2994958"/>
                            <a:gd name="connsiteY39" fmla="*/ 102742 h 3036014"/>
                            <a:gd name="connsiteX40" fmla="*/ 940086 w 2994958"/>
                            <a:gd name="connsiteY40" fmla="*/ 92468 h 3036014"/>
                            <a:gd name="connsiteX41" fmla="*/ 965771 w 2994958"/>
                            <a:gd name="connsiteY41" fmla="*/ 87331 h 3036014"/>
                            <a:gd name="connsiteX42" fmla="*/ 1012005 w 2994958"/>
                            <a:gd name="connsiteY42" fmla="*/ 71920 h 3036014"/>
                            <a:gd name="connsiteX43" fmla="*/ 1032553 w 2994958"/>
                            <a:gd name="connsiteY43" fmla="*/ 61645 h 3036014"/>
                            <a:gd name="connsiteX44" fmla="*/ 1063376 w 2994958"/>
                            <a:gd name="connsiteY44" fmla="*/ 56508 h 3036014"/>
                            <a:gd name="connsiteX45" fmla="*/ 1089061 w 2994958"/>
                            <a:gd name="connsiteY45" fmla="*/ 51371 h 3036014"/>
                            <a:gd name="connsiteX46" fmla="*/ 1160980 w 2994958"/>
                            <a:gd name="connsiteY46" fmla="*/ 41097 h 3036014"/>
                            <a:gd name="connsiteX47" fmla="*/ 1186666 w 2994958"/>
                            <a:gd name="connsiteY47" fmla="*/ 30823 h 3036014"/>
                            <a:gd name="connsiteX48" fmla="*/ 1217488 w 2994958"/>
                            <a:gd name="connsiteY48" fmla="*/ 25686 h 3036014"/>
                            <a:gd name="connsiteX49" fmla="*/ 1238036 w 2994958"/>
                            <a:gd name="connsiteY49" fmla="*/ 20549 h 3036014"/>
                            <a:gd name="connsiteX50" fmla="*/ 1253448 w 2994958"/>
                            <a:gd name="connsiteY50" fmla="*/ 15412 h 3036014"/>
                            <a:gd name="connsiteX51" fmla="*/ 1392149 w 2994958"/>
                            <a:gd name="connsiteY51" fmla="*/ 0 h 3036014"/>
                            <a:gd name="connsiteX52" fmla="*/ 1643866 w 2994958"/>
                            <a:gd name="connsiteY52" fmla="*/ 5138 h 3036014"/>
                            <a:gd name="connsiteX53" fmla="*/ 1679825 w 2994958"/>
                            <a:gd name="connsiteY53" fmla="*/ 10275 h 3036014"/>
                            <a:gd name="connsiteX54" fmla="*/ 1731196 w 2994958"/>
                            <a:gd name="connsiteY54" fmla="*/ 15412 h 3036014"/>
                            <a:gd name="connsiteX55" fmla="*/ 1756881 w 2994958"/>
                            <a:gd name="connsiteY55" fmla="*/ 25686 h 3036014"/>
                            <a:gd name="connsiteX56" fmla="*/ 1782567 w 2994958"/>
                            <a:gd name="connsiteY56" fmla="*/ 30823 h 3036014"/>
                            <a:gd name="connsiteX57" fmla="*/ 1797978 w 2994958"/>
                            <a:gd name="connsiteY57" fmla="*/ 35960 h 3036014"/>
                            <a:gd name="connsiteX58" fmla="*/ 1828800 w 2994958"/>
                            <a:gd name="connsiteY58" fmla="*/ 41097 h 3036014"/>
                            <a:gd name="connsiteX59" fmla="*/ 1880171 w 2994958"/>
                            <a:gd name="connsiteY59" fmla="*/ 56508 h 3036014"/>
                            <a:gd name="connsiteX60" fmla="*/ 1967502 w 2994958"/>
                            <a:gd name="connsiteY60" fmla="*/ 66782 h 3036014"/>
                            <a:gd name="connsiteX61" fmla="*/ 2034284 w 2994958"/>
                            <a:gd name="connsiteY61" fmla="*/ 82194 h 3036014"/>
                            <a:gd name="connsiteX62" fmla="*/ 2085654 w 2994958"/>
                            <a:gd name="connsiteY62" fmla="*/ 97605 h 3036014"/>
                            <a:gd name="connsiteX63" fmla="*/ 2111340 w 2994958"/>
                            <a:gd name="connsiteY63" fmla="*/ 107879 h 3036014"/>
                            <a:gd name="connsiteX64" fmla="*/ 2126751 w 2994958"/>
                            <a:gd name="connsiteY64" fmla="*/ 118153 h 3036014"/>
                            <a:gd name="connsiteX65" fmla="*/ 2147299 w 2994958"/>
                            <a:gd name="connsiteY65" fmla="*/ 128427 h 3036014"/>
                            <a:gd name="connsiteX66" fmla="*/ 2162711 w 2994958"/>
                            <a:gd name="connsiteY66" fmla="*/ 143839 h 3036014"/>
                            <a:gd name="connsiteX67" fmla="*/ 2208944 w 2994958"/>
                            <a:gd name="connsiteY67" fmla="*/ 169524 h 3036014"/>
                            <a:gd name="connsiteX68" fmla="*/ 2224355 w 2994958"/>
                            <a:gd name="connsiteY68" fmla="*/ 184935 h 3036014"/>
                            <a:gd name="connsiteX69" fmla="*/ 2239767 w 2994958"/>
                            <a:gd name="connsiteY69" fmla="*/ 195209 h 3036014"/>
                            <a:gd name="connsiteX70" fmla="*/ 2260315 w 2994958"/>
                            <a:gd name="connsiteY70" fmla="*/ 210621 h 3036014"/>
                            <a:gd name="connsiteX71" fmla="*/ 2286000 w 2994958"/>
                            <a:gd name="connsiteY71" fmla="*/ 226032 h 3036014"/>
                            <a:gd name="connsiteX72" fmla="*/ 2301412 w 2994958"/>
                            <a:gd name="connsiteY72" fmla="*/ 236306 h 3036014"/>
                            <a:gd name="connsiteX73" fmla="*/ 2321960 w 2994958"/>
                            <a:gd name="connsiteY73" fmla="*/ 246580 h 3036014"/>
                            <a:gd name="connsiteX74" fmla="*/ 2347645 w 2994958"/>
                            <a:gd name="connsiteY74" fmla="*/ 267129 h 3036014"/>
                            <a:gd name="connsiteX75" fmla="*/ 2357920 w 2994958"/>
                            <a:gd name="connsiteY75" fmla="*/ 277403 h 3036014"/>
                            <a:gd name="connsiteX76" fmla="*/ 2383605 w 2994958"/>
                            <a:gd name="connsiteY76" fmla="*/ 292814 h 3036014"/>
                            <a:gd name="connsiteX77" fmla="*/ 2409290 w 2994958"/>
                            <a:gd name="connsiteY77" fmla="*/ 313362 h 3036014"/>
                            <a:gd name="connsiteX78" fmla="*/ 2440113 w 2994958"/>
                            <a:gd name="connsiteY78" fmla="*/ 333911 h 3036014"/>
                            <a:gd name="connsiteX79" fmla="*/ 2460661 w 2994958"/>
                            <a:gd name="connsiteY79" fmla="*/ 354459 h 3036014"/>
                            <a:gd name="connsiteX80" fmla="*/ 2481209 w 2994958"/>
                            <a:gd name="connsiteY80" fmla="*/ 369870 h 3036014"/>
                            <a:gd name="connsiteX81" fmla="*/ 2512032 w 2994958"/>
                            <a:gd name="connsiteY81" fmla="*/ 395555 h 3036014"/>
                            <a:gd name="connsiteX82" fmla="*/ 2527443 w 2994958"/>
                            <a:gd name="connsiteY82" fmla="*/ 405830 h 3036014"/>
                            <a:gd name="connsiteX83" fmla="*/ 2542854 w 2994958"/>
                            <a:gd name="connsiteY83" fmla="*/ 421241 h 3036014"/>
                            <a:gd name="connsiteX84" fmla="*/ 2568540 w 2994958"/>
                            <a:gd name="connsiteY84" fmla="*/ 441789 h 3036014"/>
                            <a:gd name="connsiteX85" fmla="*/ 2589088 w 2994958"/>
                            <a:gd name="connsiteY85" fmla="*/ 462338 h 3036014"/>
                            <a:gd name="connsiteX86" fmla="*/ 2609636 w 2994958"/>
                            <a:gd name="connsiteY86" fmla="*/ 477749 h 3036014"/>
                            <a:gd name="connsiteX87" fmla="*/ 2619911 w 2994958"/>
                            <a:gd name="connsiteY87" fmla="*/ 488023 h 3036014"/>
                            <a:gd name="connsiteX88" fmla="*/ 2635322 w 2994958"/>
                            <a:gd name="connsiteY88" fmla="*/ 498297 h 3036014"/>
                            <a:gd name="connsiteX89" fmla="*/ 2661007 w 2994958"/>
                            <a:gd name="connsiteY89" fmla="*/ 518845 h 3036014"/>
                            <a:gd name="connsiteX90" fmla="*/ 2686693 w 2994958"/>
                            <a:gd name="connsiteY90" fmla="*/ 549668 h 3036014"/>
                            <a:gd name="connsiteX91" fmla="*/ 2712378 w 2994958"/>
                            <a:gd name="connsiteY91" fmla="*/ 580490 h 3036014"/>
                            <a:gd name="connsiteX92" fmla="*/ 2717515 w 2994958"/>
                            <a:gd name="connsiteY92" fmla="*/ 595902 h 3036014"/>
                            <a:gd name="connsiteX93" fmla="*/ 2686693 w 2994958"/>
                            <a:gd name="connsiteY93" fmla="*/ 631861 h 3036014"/>
                            <a:gd name="connsiteX94" fmla="*/ 2671281 w 2994958"/>
                            <a:gd name="connsiteY94" fmla="*/ 642135 h 3036014"/>
                            <a:gd name="connsiteX95" fmla="*/ 2655870 w 2994958"/>
                            <a:gd name="connsiteY95" fmla="*/ 657546 h 3036014"/>
                            <a:gd name="connsiteX96" fmla="*/ 2614773 w 2994958"/>
                            <a:gd name="connsiteY96" fmla="*/ 683232 h 3036014"/>
                            <a:gd name="connsiteX97" fmla="*/ 2573677 w 2994958"/>
                            <a:gd name="connsiteY97" fmla="*/ 714054 h 3036014"/>
                            <a:gd name="connsiteX98" fmla="*/ 2553129 w 2994958"/>
                            <a:gd name="connsiteY98" fmla="*/ 729466 h 3036014"/>
                            <a:gd name="connsiteX99" fmla="*/ 2527443 w 2994958"/>
                            <a:gd name="connsiteY99" fmla="*/ 739740 h 3036014"/>
                            <a:gd name="connsiteX100" fmla="*/ 2501758 w 2994958"/>
                            <a:gd name="connsiteY100" fmla="*/ 755151 h 3036014"/>
                            <a:gd name="connsiteX101" fmla="*/ 2486346 w 2994958"/>
                            <a:gd name="connsiteY101" fmla="*/ 760288 h 3036014"/>
                            <a:gd name="connsiteX102" fmla="*/ 2434976 w 2994958"/>
                            <a:gd name="connsiteY102" fmla="*/ 791111 h 3036014"/>
                            <a:gd name="connsiteX103" fmla="*/ 2414427 w 2994958"/>
                            <a:gd name="connsiteY103" fmla="*/ 801385 h 3036014"/>
                            <a:gd name="connsiteX104" fmla="*/ 2393879 w 2994958"/>
                            <a:gd name="connsiteY104" fmla="*/ 816796 h 3036014"/>
                            <a:gd name="connsiteX105" fmla="*/ 2373331 w 2994958"/>
                            <a:gd name="connsiteY105" fmla="*/ 827070 h 3036014"/>
                            <a:gd name="connsiteX106" fmla="*/ 2342508 w 2994958"/>
                            <a:gd name="connsiteY106" fmla="*/ 847618 h 3036014"/>
                            <a:gd name="connsiteX107" fmla="*/ 2321960 w 2994958"/>
                            <a:gd name="connsiteY107" fmla="*/ 868167 h 3036014"/>
                            <a:gd name="connsiteX108" fmla="*/ 2265452 w 2994958"/>
                            <a:gd name="connsiteY108" fmla="*/ 909263 h 3036014"/>
                            <a:gd name="connsiteX109" fmla="*/ 2239767 w 2994958"/>
                            <a:gd name="connsiteY109" fmla="*/ 940086 h 3036014"/>
                            <a:gd name="connsiteX110" fmla="*/ 2198670 w 2994958"/>
                            <a:gd name="connsiteY110" fmla="*/ 970908 h 3036014"/>
                            <a:gd name="connsiteX111" fmla="*/ 2162711 w 2994958"/>
                            <a:gd name="connsiteY111" fmla="*/ 1006868 h 3036014"/>
                            <a:gd name="connsiteX112" fmla="*/ 2147299 w 2994958"/>
                            <a:gd name="connsiteY112" fmla="*/ 1012005 h 3036014"/>
                            <a:gd name="connsiteX113" fmla="*/ 2131888 w 2994958"/>
                            <a:gd name="connsiteY113" fmla="*/ 1027416 h 3036014"/>
                            <a:gd name="connsiteX114" fmla="*/ 2111340 w 2994958"/>
                            <a:gd name="connsiteY114" fmla="*/ 1037690 h 3036014"/>
                            <a:gd name="connsiteX115" fmla="*/ 2085654 w 2994958"/>
                            <a:gd name="connsiteY115" fmla="*/ 1058239 h 3036014"/>
                            <a:gd name="connsiteX116" fmla="*/ 2070243 w 2994958"/>
                            <a:gd name="connsiteY116" fmla="*/ 1068513 h 3036014"/>
                            <a:gd name="connsiteX117" fmla="*/ 2059969 w 2994958"/>
                            <a:gd name="connsiteY117" fmla="*/ 1083924 h 3036014"/>
                            <a:gd name="connsiteX118" fmla="*/ 2044558 w 2994958"/>
                            <a:gd name="connsiteY118" fmla="*/ 1089061 h 3036014"/>
                            <a:gd name="connsiteX119" fmla="*/ 2024009 w 2994958"/>
                            <a:gd name="connsiteY119" fmla="*/ 1104472 h 3036014"/>
                            <a:gd name="connsiteX120" fmla="*/ 2008598 w 2994958"/>
                            <a:gd name="connsiteY120" fmla="*/ 1119884 h 3036014"/>
                            <a:gd name="connsiteX121" fmla="*/ 1993187 w 2994958"/>
                            <a:gd name="connsiteY121" fmla="*/ 1125021 h 3036014"/>
                            <a:gd name="connsiteX122" fmla="*/ 1977776 w 2994958"/>
                            <a:gd name="connsiteY122" fmla="*/ 1145569 h 3036014"/>
                            <a:gd name="connsiteX123" fmla="*/ 1957227 w 2994958"/>
                            <a:gd name="connsiteY123" fmla="*/ 1155843 h 3036014"/>
                            <a:gd name="connsiteX124" fmla="*/ 1931542 w 2994958"/>
                            <a:gd name="connsiteY124" fmla="*/ 1181529 h 3036014"/>
                            <a:gd name="connsiteX125" fmla="*/ 1890445 w 2994958"/>
                            <a:gd name="connsiteY125" fmla="*/ 1222625 h 3036014"/>
                            <a:gd name="connsiteX126" fmla="*/ 1844212 w 2994958"/>
                            <a:gd name="connsiteY126" fmla="*/ 1253448 h 3036014"/>
                            <a:gd name="connsiteX127" fmla="*/ 1833937 w 2994958"/>
                            <a:gd name="connsiteY127" fmla="*/ 1268859 h 3036014"/>
                            <a:gd name="connsiteX128" fmla="*/ 1844212 w 2994958"/>
                            <a:gd name="connsiteY128" fmla="*/ 1279133 h 3036014"/>
                            <a:gd name="connsiteX129" fmla="*/ 1905857 w 2994958"/>
                            <a:gd name="connsiteY129" fmla="*/ 1273996 h 3036014"/>
                            <a:gd name="connsiteX130" fmla="*/ 1972639 w 2994958"/>
                            <a:gd name="connsiteY130" fmla="*/ 1253448 h 3036014"/>
                            <a:gd name="connsiteX131" fmla="*/ 2003461 w 2994958"/>
                            <a:gd name="connsiteY131" fmla="*/ 1243173 h 3036014"/>
                            <a:gd name="connsiteX132" fmla="*/ 2044558 w 2994958"/>
                            <a:gd name="connsiteY132" fmla="*/ 1238036 h 3036014"/>
                            <a:gd name="connsiteX133" fmla="*/ 2085654 w 2994958"/>
                            <a:gd name="connsiteY133" fmla="*/ 1227762 h 3036014"/>
                            <a:gd name="connsiteX134" fmla="*/ 2116477 w 2994958"/>
                            <a:gd name="connsiteY134" fmla="*/ 1217488 h 3036014"/>
                            <a:gd name="connsiteX135" fmla="*/ 2131888 w 2994958"/>
                            <a:gd name="connsiteY135" fmla="*/ 1212351 h 3036014"/>
                            <a:gd name="connsiteX136" fmla="*/ 2147299 w 2994958"/>
                            <a:gd name="connsiteY136" fmla="*/ 1207214 h 3036014"/>
                            <a:gd name="connsiteX137" fmla="*/ 2172985 w 2994958"/>
                            <a:gd name="connsiteY137" fmla="*/ 1196940 h 3036014"/>
                            <a:gd name="connsiteX138" fmla="*/ 2214081 w 2994958"/>
                            <a:gd name="connsiteY138" fmla="*/ 1186666 h 3036014"/>
                            <a:gd name="connsiteX139" fmla="*/ 2234630 w 2994958"/>
                            <a:gd name="connsiteY139" fmla="*/ 1181529 h 3036014"/>
                            <a:gd name="connsiteX140" fmla="*/ 2255178 w 2994958"/>
                            <a:gd name="connsiteY140" fmla="*/ 1171254 h 3036014"/>
                            <a:gd name="connsiteX141" fmla="*/ 2280863 w 2994958"/>
                            <a:gd name="connsiteY141" fmla="*/ 1155843 h 3036014"/>
                            <a:gd name="connsiteX142" fmla="*/ 2332234 w 2994958"/>
                            <a:gd name="connsiteY142" fmla="*/ 1140432 h 3036014"/>
                            <a:gd name="connsiteX143" fmla="*/ 2404153 w 2994958"/>
                            <a:gd name="connsiteY143" fmla="*/ 1109609 h 3036014"/>
                            <a:gd name="connsiteX144" fmla="*/ 2424702 w 2994958"/>
                            <a:gd name="connsiteY144" fmla="*/ 1099335 h 3036014"/>
                            <a:gd name="connsiteX145" fmla="*/ 2440113 w 2994958"/>
                            <a:gd name="connsiteY145" fmla="*/ 1089061 h 3036014"/>
                            <a:gd name="connsiteX146" fmla="*/ 2506895 w 2994958"/>
                            <a:gd name="connsiteY146" fmla="*/ 1068513 h 3036014"/>
                            <a:gd name="connsiteX147" fmla="*/ 2558266 w 2994958"/>
                            <a:gd name="connsiteY147" fmla="*/ 1047964 h 3036014"/>
                            <a:gd name="connsiteX148" fmla="*/ 2573677 w 2994958"/>
                            <a:gd name="connsiteY148" fmla="*/ 1037690 h 3036014"/>
                            <a:gd name="connsiteX149" fmla="*/ 2599362 w 2994958"/>
                            <a:gd name="connsiteY149" fmla="*/ 1027416 h 3036014"/>
                            <a:gd name="connsiteX150" fmla="*/ 2640459 w 2994958"/>
                            <a:gd name="connsiteY150" fmla="*/ 1006868 h 3036014"/>
                            <a:gd name="connsiteX151" fmla="*/ 2661007 w 2994958"/>
                            <a:gd name="connsiteY151" fmla="*/ 991457 h 3036014"/>
                            <a:gd name="connsiteX152" fmla="*/ 2681555 w 2994958"/>
                            <a:gd name="connsiteY152" fmla="*/ 986320 h 3036014"/>
                            <a:gd name="connsiteX153" fmla="*/ 2722652 w 2994958"/>
                            <a:gd name="connsiteY153" fmla="*/ 960634 h 3036014"/>
                            <a:gd name="connsiteX154" fmla="*/ 2743200 w 2994958"/>
                            <a:gd name="connsiteY154" fmla="*/ 955497 h 3036014"/>
                            <a:gd name="connsiteX155" fmla="*/ 2768886 w 2994958"/>
                            <a:gd name="connsiteY155" fmla="*/ 945223 h 3036014"/>
                            <a:gd name="connsiteX156" fmla="*/ 2784297 w 2994958"/>
                            <a:gd name="connsiteY156" fmla="*/ 934949 h 3036014"/>
                            <a:gd name="connsiteX157" fmla="*/ 2809982 w 2994958"/>
                            <a:gd name="connsiteY157" fmla="*/ 924675 h 3036014"/>
                            <a:gd name="connsiteX158" fmla="*/ 2866490 w 2994958"/>
                            <a:gd name="connsiteY158" fmla="*/ 909263 h 3036014"/>
                            <a:gd name="connsiteX159" fmla="*/ 2902450 w 2994958"/>
                            <a:gd name="connsiteY159" fmla="*/ 914400 h 3036014"/>
                            <a:gd name="connsiteX160" fmla="*/ 2917861 w 2994958"/>
                            <a:gd name="connsiteY160" fmla="*/ 924675 h 3036014"/>
                            <a:gd name="connsiteX161" fmla="*/ 2938409 w 2994958"/>
                            <a:gd name="connsiteY161" fmla="*/ 960634 h 3036014"/>
                            <a:gd name="connsiteX162" fmla="*/ 2948684 w 2994958"/>
                            <a:gd name="connsiteY162" fmla="*/ 1012005 h 3036014"/>
                            <a:gd name="connsiteX163" fmla="*/ 2958958 w 2994958"/>
                            <a:gd name="connsiteY163" fmla="*/ 1047964 h 3036014"/>
                            <a:gd name="connsiteX164" fmla="*/ 2969232 w 2994958"/>
                            <a:gd name="connsiteY164" fmla="*/ 1166117 h 3036014"/>
                            <a:gd name="connsiteX165" fmla="*/ 2974369 w 2994958"/>
                            <a:gd name="connsiteY165" fmla="*/ 1202077 h 3036014"/>
                            <a:gd name="connsiteX166" fmla="*/ 2989780 w 2994958"/>
                            <a:gd name="connsiteY166" fmla="*/ 1253448 h 3036014"/>
                            <a:gd name="connsiteX167" fmla="*/ 2989780 w 2994958"/>
                            <a:gd name="connsiteY167" fmla="*/ 1720922 h 3036014"/>
                            <a:gd name="connsiteX168" fmla="*/ 2974369 w 2994958"/>
                            <a:gd name="connsiteY168" fmla="*/ 1792841 h 3036014"/>
                            <a:gd name="connsiteX169" fmla="*/ 2969232 w 2994958"/>
                            <a:gd name="connsiteY169" fmla="*/ 1818526 h 3036014"/>
                            <a:gd name="connsiteX170" fmla="*/ 2964095 w 2994958"/>
                            <a:gd name="connsiteY170" fmla="*/ 1833938 h 3036014"/>
                            <a:gd name="connsiteX171" fmla="*/ 2958958 w 2994958"/>
                            <a:gd name="connsiteY171" fmla="*/ 1864760 h 3036014"/>
                            <a:gd name="connsiteX172" fmla="*/ 2953821 w 2994958"/>
                            <a:gd name="connsiteY172" fmla="*/ 1880171 h 3036014"/>
                            <a:gd name="connsiteX173" fmla="*/ 2948684 w 2994958"/>
                            <a:gd name="connsiteY173" fmla="*/ 1900720 h 3036014"/>
                            <a:gd name="connsiteX174" fmla="*/ 2943546 w 2994958"/>
                            <a:gd name="connsiteY174" fmla="*/ 1916131 h 3036014"/>
                            <a:gd name="connsiteX175" fmla="*/ 2933272 w 2994958"/>
                            <a:gd name="connsiteY175" fmla="*/ 1957227 h 3036014"/>
                            <a:gd name="connsiteX176" fmla="*/ 2928135 w 2994958"/>
                            <a:gd name="connsiteY176" fmla="*/ 1972639 h 3036014"/>
                            <a:gd name="connsiteX177" fmla="*/ 2912724 w 2994958"/>
                            <a:gd name="connsiteY177" fmla="*/ 2018872 h 3036014"/>
                            <a:gd name="connsiteX178" fmla="*/ 2902450 w 2994958"/>
                            <a:gd name="connsiteY178" fmla="*/ 2075380 h 3036014"/>
                            <a:gd name="connsiteX179" fmla="*/ 2897313 w 2994958"/>
                            <a:gd name="connsiteY179" fmla="*/ 2090791 h 3036014"/>
                            <a:gd name="connsiteX180" fmla="*/ 2892176 w 2994958"/>
                            <a:gd name="connsiteY180" fmla="*/ 2116477 h 3036014"/>
                            <a:gd name="connsiteX181" fmla="*/ 2876764 w 2994958"/>
                            <a:gd name="connsiteY181" fmla="*/ 2157573 h 3036014"/>
                            <a:gd name="connsiteX182" fmla="*/ 2861353 w 2994958"/>
                            <a:gd name="connsiteY182" fmla="*/ 2214081 h 3036014"/>
                            <a:gd name="connsiteX183" fmla="*/ 2840805 w 2994958"/>
                            <a:gd name="connsiteY183" fmla="*/ 2255178 h 3036014"/>
                            <a:gd name="connsiteX184" fmla="*/ 2835668 w 2994958"/>
                            <a:gd name="connsiteY184" fmla="*/ 2275726 h 3036014"/>
                            <a:gd name="connsiteX185" fmla="*/ 2804845 w 2994958"/>
                            <a:gd name="connsiteY185" fmla="*/ 2332234 h 3036014"/>
                            <a:gd name="connsiteX186" fmla="*/ 2779160 w 2994958"/>
                            <a:gd name="connsiteY186" fmla="*/ 2373331 h 3036014"/>
                            <a:gd name="connsiteX187" fmla="*/ 2774023 w 2994958"/>
                            <a:gd name="connsiteY187" fmla="*/ 2388742 h 3036014"/>
                            <a:gd name="connsiteX188" fmla="*/ 2748337 w 2994958"/>
                            <a:gd name="connsiteY188" fmla="*/ 2414427 h 3036014"/>
                            <a:gd name="connsiteX189" fmla="*/ 2717515 w 2994958"/>
                            <a:gd name="connsiteY189" fmla="*/ 2460661 h 3036014"/>
                            <a:gd name="connsiteX190" fmla="*/ 2712378 w 2994958"/>
                            <a:gd name="connsiteY190" fmla="*/ 2476072 h 3036014"/>
                            <a:gd name="connsiteX191" fmla="*/ 2691830 w 2994958"/>
                            <a:gd name="connsiteY191" fmla="*/ 2496621 h 3036014"/>
                            <a:gd name="connsiteX192" fmla="*/ 2655870 w 2994958"/>
                            <a:gd name="connsiteY192" fmla="*/ 2542854 h 3036014"/>
                            <a:gd name="connsiteX193" fmla="*/ 2650733 w 2994958"/>
                            <a:gd name="connsiteY193" fmla="*/ 2558266 h 3036014"/>
                            <a:gd name="connsiteX194" fmla="*/ 2594225 w 2994958"/>
                            <a:gd name="connsiteY194" fmla="*/ 2609636 h 3036014"/>
                            <a:gd name="connsiteX195" fmla="*/ 2573677 w 2994958"/>
                            <a:gd name="connsiteY195" fmla="*/ 2630185 h 3036014"/>
                            <a:gd name="connsiteX196" fmla="*/ 2558266 w 2994958"/>
                            <a:gd name="connsiteY196" fmla="*/ 2640459 h 3036014"/>
                            <a:gd name="connsiteX197" fmla="*/ 2527443 w 2994958"/>
                            <a:gd name="connsiteY197" fmla="*/ 2661007 h 3036014"/>
                            <a:gd name="connsiteX198" fmla="*/ 2460661 w 2994958"/>
                            <a:gd name="connsiteY198" fmla="*/ 2707241 h 3036014"/>
                            <a:gd name="connsiteX199" fmla="*/ 2450387 w 2994958"/>
                            <a:gd name="connsiteY199" fmla="*/ 2722652 h 3036014"/>
                            <a:gd name="connsiteX200" fmla="*/ 2409290 w 2994958"/>
                            <a:gd name="connsiteY200" fmla="*/ 2738063 h 3036014"/>
                            <a:gd name="connsiteX201" fmla="*/ 2388742 w 2994958"/>
                            <a:gd name="connsiteY201" fmla="*/ 2732926 h 3036014"/>
                            <a:gd name="connsiteX202" fmla="*/ 2342508 w 2994958"/>
                            <a:gd name="connsiteY202" fmla="*/ 2717515 h 3036014"/>
                            <a:gd name="connsiteX203" fmla="*/ 2311686 w 2994958"/>
                            <a:gd name="connsiteY203" fmla="*/ 2691830 h 3036014"/>
                            <a:gd name="connsiteX204" fmla="*/ 2275726 w 2994958"/>
                            <a:gd name="connsiteY204" fmla="*/ 2655870 h 3036014"/>
                            <a:gd name="connsiteX205" fmla="*/ 2260315 w 2994958"/>
                            <a:gd name="connsiteY205" fmla="*/ 2640459 h 3036014"/>
                            <a:gd name="connsiteX206" fmla="*/ 2244904 w 2994958"/>
                            <a:gd name="connsiteY206" fmla="*/ 2609636 h 3036014"/>
                            <a:gd name="connsiteX207" fmla="*/ 2224355 w 2994958"/>
                            <a:gd name="connsiteY207" fmla="*/ 2594225 h 3036014"/>
                            <a:gd name="connsiteX208" fmla="*/ 2203807 w 2994958"/>
                            <a:gd name="connsiteY208" fmla="*/ 2558266 h 3036014"/>
                            <a:gd name="connsiteX209" fmla="*/ 2172985 w 2994958"/>
                            <a:gd name="connsiteY209" fmla="*/ 2517169 h 3036014"/>
                            <a:gd name="connsiteX210" fmla="*/ 2152436 w 2994958"/>
                            <a:gd name="connsiteY210" fmla="*/ 2476072 h 3036014"/>
                            <a:gd name="connsiteX211" fmla="*/ 2131888 w 2994958"/>
                            <a:gd name="connsiteY211" fmla="*/ 2445250 h 3036014"/>
                            <a:gd name="connsiteX212" fmla="*/ 2111340 w 2994958"/>
                            <a:gd name="connsiteY212" fmla="*/ 2404153 h 3036014"/>
                            <a:gd name="connsiteX213" fmla="*/ 2095929 w 2994958"/>
                            <a:gd name="connsiteY213" fmla="*/ 2373331 h 3036014"/>
                            <a:gd name="connsiteX214" fmla="*/ 2044558 w 2994958"/>
                            <a:gd name="connsiteY214" fmla="*/ 2291138 h 3036014"/>
                            <a:gd name="connsiteX215" fmla="*/ 2034284 w 2994958"/>
                            <a:gd name="connsiteY215" fmla="*/ 2270589 h 3036014"/>
                            <a:gd name="connsiteX216" fmla="*/ 2013735 w 2994958"/>
                            <a:gd name="connsiteY216" fmla="*/ 2244904 h 3036014"/>
                            <a:gd name="connsiteX217" fmla="*/ 2003461 w 2994958"/>
                            <a:gd name="connsiteY217" fmla="*/ 2224355 h 3036014"/>
                            <a:gd name="connsiteX218" fmla="*/ 1982913 w 2994958"/>
                            <a:gd name="connsiteY218" fmla="*/ 2198670 h 3036014"/>
                            <a:gd name="connsiteX219" fmla="*/ 1962364 w 2994958"/>
                            <a:gd name="connsiteY219" fmla="*/ 2172985 h 3036014"/>
                            <a:gd name="connsiteX220" fmla="*/ 1941816 w 2994958"/>
                            <a:gd name="connsiteY220" fmla="*/ 2137025 h 3036014"/>
                            <a:gd name="connsiteX221" fmla="*/ 1931542 w 2994958"/>
                            <a:gd name="connsiteY221" fmla="*/ 2121614 h 3036014"/>
                            <a:gd name="connsiteX222" fmla="*/ 1916131 w 2994958"/>
                            <a:gd name="connsiteY222" fmla="*/ 2106203 h 3036014"/>
                            <a:gd name="connsiteX223" fmla="*/ 1905857 w 2994958"/>
                            <a:gd name="connsiteY223" fmla="*/ 2090791 h 3036014"/>
                            <a:gd name="connsiteX224" fmla="*/ 1869897 w 2994958"/>
                            <a:gd name="connsiteY224" fmla="*/ 2049695 h 3036014"/>
                            <a:gd name="connsiteX225" fmla="*/ 1839075 w 2994958"/>
                            <a:gd name="connsiteY225" fmla="*/ 2008598 h 3036014"/>
                            <a:gd name="connsiteX226" fmla="*/ 1823663 w 2994958"/>
                            <a:gd name="connsiteY226" fmla="*/ 1988050 h 3036014"/>
                            <a:gd name="connsiteX227" fmla="*/ 1833937 w 2994958"/>
                            <a:gd name="connsiteY227" fmla="*/ 2059969 h 3036014"/>
                            <a:gd name="connsiteX228" fmla="*/ 1849349 w 2994958"/>
                            <a:gd name="connsiteY228" fmla="*/ 2095929 h 3036014"/>
                            <a:gd name="connsiteX229" fmla="*/ 1859623 w 2994958"/>
                            <a:gd name="connsiteY229" fmla="*/ 2157573 h 3036014"/>
                            <a:gd name="connsiteX230" fmla="*/ 1864760 w 2994958"/>
                            <a:gd name="connsiteY230" fmla="*/ 2172985 h 3036014"/>
                            <a:gd name="connsiteX231" fmla="*/ 1880171 w 2994958"/>
                            <a:gd name="connsiteY231" fmla="*/ 2214081 h 3036014"/>
                            <a:gd name="connsiteX232" fmla="*/ 1885308 w 2994958"/>
                            <a:gd name="connsiteY232" fmla="*/ 2239767 h 3036014"/>
                            <a:gd name="connsiteX233" fmla="*/ 1900720 w 2994958"/>
                            <a:gd name="connsiteY233" fmla="*/ 2275726 h 3036014"/>
                            <a:gd name="connsiteX234" fmla="*/ 1905857 w 2994958"/>
                            <a:gd name="connsiteY234" fmla="*/ 2296275 h 3036014"/>
                            <a:gd name="connsiteX235" fmla="*/ 1910994 w 2994958"/>
                            <a:gd name="connsiteY235" fmla="*/ 2321960 h 3036014"/>
                            <a:gd name="connsiteX236" fmla="*/ 1926405 w 2994958"/>
                            <a:gd name="connsiteY236" fmla="*/ 2352782 h 3036014"/>
                            <a:gd name="connsiteX237" fmla="*/ 1936679 w 2994958"/>
                            <a:gd name="connsiteY237" fmla="*/ 2383605 h 3036014"/>
                            <a:gd name="connsiteX238" fmla="*/ 1967502 w 2994958"/>
                            <a:gd name="connsiteY238" fmla="*/ 2429839 h 3036014"/>
                            <a:gd name="connsiteX239" fmla="*/ 1977776 w 2994958"/>
                            <a:gd name="connsiteY239" fmla="*/ 2460661 h 3036014"/>
                            <a:gd name="connsiteX240" fmla="*/ 1998324 w 2994958"/>
                            <a:gd name="connsiteY240" fmla="*/ 2506895 h 3036014"/>
                            <a:gd name="connsiteX241" fmla="*/ 2008598 w 2994958"/>
                            <a:gd name="connsiteY241" fmla="*/ 2527443 h 3036014"/>
                            <a:gd name="connsiteX242" fmla="*/ 2034284 w 2994958"/>
                            <a:gd name="connsiteY242" fmla="*/ 2583951 h 3036014"/>
                            <a:gd name="connsiteX243" fmla="*/ 2039421 w 2994958"/>
                            <a:gd name="connsiteY243" fmla="*/ 2614773 h 3036014"/>
                            <a:gd name="connsiteX244" fmla="*/ 2049695 w 2994958"/>
                            <a:gd name="connsiteY244" fmla="*/ 2650733 h 3036014"/>
                            <a:gd name="connsiteX245" fmla="*/ 2054832 w 2994958"/>
                            <a:gd name="connsiteY245" fmla="*/ 2671281 h 3036014"/>
                            <a:gd name="connsiteX246" fmla="*/ 2070243 w 2994958"/>
                            <a:gd name="connsiteY246" fmla="*/ 2722652 h 3036014"/>
                            <a:gd name="connsiteX247" fmla="*/ 2075380 w 2994958"/>
                            <a:gd name="connsiteY247" fmla="*/ 2758612 h 3036014"/>
                            <a:gd name="connsiteX248" fmla="*/ 2085654 w 2994958"/>
                            <a:gd name="connsiteY248" fmla="*/ 2809982 h 3036014"/>
                            <a:gd name="connsiteX249" fmla="*/ 2090791 w 2994958"/>
                            <a:gd name="connsiteY249" fmla="*/ 2835668 h 3036014"/>
                            <a:gd name="connsiteX250" fmla="*/ 2059969 w 2994958"/>
                            <a:gd name="connsiteY250" fmla="*/ 2964095 h 3036014"/>
                            <a:gd name="connsiteX251" fmla="*/ 2044558 w 2994958"/>
                            <a:gd name="connsiteY251" fmla="*/ 2969232 h 3036014"/>
                            <a:gd name="connsiteX252" fmla="*/ 2024009 w 2994958"/>
                            <a:gd name="connsiteY252" fmla="*/ 2979506 h 3036014"/>
                            <a:gd name="connsiteX253" fmla="*/ 2008598 w 2994958"/>
                            <a:gd name="connsiteY253" fmla="*/ 2984643 h 3036014"/>
                            <a:gd name="connsiteX254" fmla="*/ 1972639 w 2994958"/>
                            <a:gd name="connsiteY254" fmla="*/ 3000054 h 3036014"/>
                            <a:gd name="connsiteX255" fmla="*/ 1936679 w 2994958"/>
                            <a:gd name="connsiteY255" fmla="*/ 3005191 h 3036014"/>
                            <a:gd name="connsiteX256" fmla="*/ 1880171 w 2994958"/>
                            <a:gd name="connsiteY256" fmla="*/ 3015466 h 3036014"/>
                            <a:gd name="connsiteX257" fmla="*/ 1787704 w 2994958"/>
                            <a:gd name="connsiteY257" fmla="*/ 3025740 h 3036014"/>
                            <a:gd name="connsiteX258" fmla="*/ 1715785 w 2994958"/>
                            <a:gd name="connsiteY258" fmla="*/ 3030877 h 3036014"/>
                            <a:gd name="connsiteX259" fmla="*/ 1469205 w 2994958"/>
                            <a:gd name="connsiteY259" fmla="*/ 3036014 h 3036014"/>
                            <a:gd name="connsiteX260" fmla="*/ 1284270 w 2994958"/>
                            <a:gd name="connsiteY260" fmla="*/ 3025740 h 3036014"/>
                            <a:gd name="connsiteX261" fmla="*/ 1186666 w 2994958"/>
                            <a:gd name="connsiteY261" fmla="*/ 3000054 h 3036014"/>
                            <a:gd name="connsiteX262" fmla="*/ 1160980 w 2994958"/>
                            <a:gd name="connsiteY262" fmla="*/ 2994917 h 3036014"/>
                            <a:gd name="connsiteX263" fmla="*/ 1089061 w 2994958"/>
                            <a:gd name="connsiteY263" fmla="*/ 2974369 h 3036014"/>
                            <a:gd name="connsiteX264" fmla="*/ 1042827 w 2994958"/>
                            <a:gd name="connsiteY264" fmla="*/ 2958958 h 3036014"/>
                            <a:gd name="connsiteX265" fmla="*/ 1027416 w 2994958"/>
                            <a:gd name="connsiteY265" fmla="*/ 2953821 h 3036014"/>
                            <a:gd name="connsiteX266" fmla="*/ 996594 w 2994958"/>
                            <a:gd name="connsiteY266" fmla="*/ 2948684 h 3036014"/>
                            <a:gd name="connsiteX267" fmla="*/ 970908 w 2994958"/>
                            <a:gd name="connsiteY267" fmla="*/ 2938409 h 3036014"/>
                            <a:gd name="connsiteX268" fmla="*/ 940086 w 2994958"/>
                            <a:gd name="connsiteY268" fmla="*/ 2928135 h 3036014"/>
                            <a:gd name="connsiteX269" fmla="*/ 904126 w 2994958"/>
                            <a:gd name="connsiteY269" fmla="*/ 2912724 h 3036014"/>
                            <a:gd name="connsiteX270" fmla="*/ 883578 w 2994958"/>
                            <a:gd name="connsiteY270" fmla="*/ 2902450 h 3036014"/>
                            <a:gd name="connsiteX271" fmla="*/ 863030 w 2994958"/>
                            <a:gd name="connsiteY271" fmla="*/ 2897313 h 3036014"/>
                            <a:gd name="connsiteX272" fmla="*/ 832207 w 2994958"/>
                            <a:gd name="connsiteY272" fmla="*/ 2876764 h 3036014"/>
                            <a:gd name="connsiteX273" fmla="*/ 765425 w 2994958"/>
                            <a:gd name="connsiteY273" fmla="*/ 2845942 h 3036014"/>
                            <a:gd name="connsiteX274" fmla="*/ 739740 w 2994958"/>
                            <a:gd name="connsiteY274" fmla="*/ 2830531 h 3036014"/>
                            <a:gd name="connsiteX275" fmla="*/ 719191 w 2994958"/>
                            <a:gd name="connsiteY275" fmla="*/ 2815120 h 3036014"/>
                            <a:gd name="connsiteX276" fmla="*/ 693506 w 2994958"/>
                            <a:gd name="connsiteY276" fmla="*/ 2809982 h 3036014"/>
                            <a:gd name="connsiteX277" fmla="*/ 683232 w 2994958"/>
                            <a:gd name="connsiteY277" fmla="*/ 2794571 h 3036014"/>
                            <a:gd name="connsiteX278" fmla="*/ 626724 w 2994958"/>
                            <a:gd name="connsiteY278" fmla="*/ 2768886 h 3036014"/>
                            <a:gd name="connsiteX279" fmla="*/ 606176 w 2994958"/>
                            <a:gd name="connsiteY279" fmla="*/ 2753475 h 3036014"/>
                            <a:gd name="connsiteX280" fmla="*/ 570216 w 2994958"/>
                            <a:gd name="connsiteY280" fmla="*/ 2722652 h 3036014"/>
                            <a:gd name="connsiteX281" fmla="*/ 523982 w 2994958"/>
                            <a:gd name="connsiteY281" fmla="*/ 2691830 h 3036014"/>
                            <a:gd name="connsiteX282" fmla="*/ 498297 w 2994958"/>
                            <a:gd name="connsiteY282" fmla="*/ 2661007 h 3036014"/>
                            <a:gd name="connsiteX283" fmla="*/ 482886 w 2994958"/>
                            <a:gd name="connsiteY283" fmla="*/ 2650733 h 3036014"/>
                            <a:gd name="connsiteX284" fmla="*/ 446926 w 2994958"/>
                            <a:gd name="connsiteY284" fmla="*/ 2614773 h 3036014"/>
                            <a:gd name="connsiteX285" fmla="*/ 421241 w 2994958"/>
                            <a:gd name="connsiteY285" fmla="*/ 2594225 h 3036014"/>
                            <a:gd name="connsiteX286" fmla="*/ 410967 w 2994958"/>
                            <a:gd name="connsiteY286" fmla="*/ 2578814 h 3036014"/>
                            <a:gd name="connsiteX287" fmla="*/ 395555 w 2994958"/>
                            <a:gd name="connsiteY287" fmla="*/ 2568540 h 3036014"/>
                            <a:gd name="connsiteX288" fmla="*/ 354459 w 2994958"/>
                            <a:gd name="connsiteY288" fmla="*/ 2532580 h 3036014"/>
                            <a:gd name="connsiteX289" fmla="*/ 339048 w 2994958"/>
                            <a:gd name="connsiteY289" fmla="*/ 2501758 h 3036014"/>
                            <a:gd name="connsiteX290" fmla="*/ 344185 w 2994958"/>
                            <a:gd name="connsiteY290" fmla="*/ 2465798 h 3036014"/>
                            <a:gd name="connsiteX291" fmla="*/ 380144 w 2994958"/>
                            <a:gd name="connsiteY291" fmla="*/ 2429839 h 3036014"/>
                            <a:gd name="connsiteX292" fmla="*/ 405830 w 2994958"/>
                            <a:gd name="connsiteY292" fmla="*/ 2414427 h 3036014"/>
                            <a:gd name="connsiteX293" fmla="*/ 452063 w 2994958"/>
                            <a:gd name="connsiteY293" fmla="*/ 2378468 h 3036014"/>
                            <a:gd name="connsiteX294" fmla="*/ 462337 w 2994958"/>
                            <a:gd name="connsiteY294" fmla="*/ 2363057 h 3036014"/>
                            <a:gd name="connsiteX295" fmla="*/ 513708 w 2994958"/>
                            <a:gd name="connsiteY295" fmla="*/ 2332234 h 3036014"/>
                            <a:gd name="connsiteX296" fmla="*/ 539394 w 2994958"/>
                            <a:gd name="connsiteY296" fmla="*/ 2311686 h 3036014"/>
                            <a:gd name="connsiteX297" fmla="*/ 559942 w 2994958"/>
                            <a:gd name="connsiteY297" fmla="*/ 2301412 h 3036014"/>
                            <a:gd name="connsiteX298" fmla="*/ 606176 w 2994958"/>
                            <a:gd name="connsiteY298" fmla="*/ 2270589 h 3036014"/>
                            <a:gd name="connsiteX299" fmla="*/ 621587 w 2994958"/>
                            <a:gd name="connsiteY299" fmla="*/ 2265452 h 3036014"/>
                            <a:gd name="connsiteX300" fmla="*/ 642135 w 2994958"/>
                            <a:gd name="connsiteY300" fmla="*/ 2255178 h 3036014"/>
                            <a:gd name="connsiteX301" fmla="*/ 667821 w 2994958"/>
                            <a:gd name="connsiteY301" fmla="*/ 2234630 h 3036014"/>
                            <a:gd name="connsiteX302" fmla="*/ 719191 w 2994958"/>
                            <a:gd name="connsiteY302" fmla="*/ 2193533 h 3036014"/>
                            <a:gd name="connsiteX303" fmla="*/ 750014 w 2994958"/>
                            <a:gd name="connsiteY303" fmla="*/ 2172985 h 3036014"/>
                            <a:gd name="connsiteX304" fmla="*/ 770562 w 2994958"/>
                            <a:gd name="connsiteY304" fmla="*/ 2152436 h 3036014"/>
                            <a:gd name="connsiteX305" fmla="*/ 816796 w 2994958"/>
                            <a:gd name="connsiteY305" fmla="*/ 2116477 h 3036014"/>
                            <a:gd name="connsiteX306" fmla="*/ 842481 w 2994958"/>
                            <a:gd name="connsiteY306" fmla="*/ 2095929 h 3036014"/>
                            <a:gd name="connsiteX307" fmla="*/ 863030 w 2994958"/>
                            <a:gd name="connsiteY307" fmla="*/ 2080517 h 3036014"/>
                            <a:gd name="connsiteX308" fmla="*/ 904126 w 2994958"/>
                            <a:gd name="connsiteY308" fmla="*/ 2039421 h 3036014"/>
                            <a:gd name="connsiteX309" fmla="*/ 919537 w 2994958"/>
                            <a:gd name="connsiteY309" fmla="*/ 2029146 h 3036014"/>
                            <a:gd name="connsiteX310" fmla="*/ 940086 w 2994958"/>
                            <a:gd name="connsiteY310" fmla="*/ 2003461 h 3036014"/>
                            <a:gd name="connsiteX311" fmla="*/ 965771 w 2994958"/>
                            <a:gd name="connsiteY311" fmla="*/ 1977776 h 3036014"/>
                            <a:gd name="connsiteX312" fmla="*/ 1001731 w 2994958"/>
                            <a:gd name="connsiteY312" fmla="*/ 1931542 h 3036014"/>
                            <a:gd name="connsiteX313" fmla="*/ 1006868 w 2994958"/>
                            <a:gd name="connsiteY313" fmla="*/ 1916131 h 3036014"/>
                            <a:gd name="connsiteX314" fmla="*/ 1022279 w 2994958"/>
                            <a:gd name="connsiteY314" fmla="*/ 1905857 h 3036014"/>
                            <a:gd name="connsiteX315" fmla="*/ 1032553 w 2994958"/>
                            <a:gd name="connsiteY315" fmla="*/ 1895582 h 3036014"/>
                            <a:gd name="connsiteX316" fmla="*/ 1017142 w 2994958"/>
                            <a:gd name="connsiteY316" fmla="*/ 1885308 h 3036014"/>
                            <a:gd name="connsiteX317" fmla="*/ 965771 w 2994958"/>
                            <a:gd name="connsiteY317" fmla="*/ 1905857 h 3036014"/>
                            <a:gd name="connsiteX318" fmla="*/ 950360 w 2994958"/>
                            <a:gd name="connsiteY318" fmla="*/ 1910994 h 3036014"/>
                            <a:gd name="connsiteX319" fmla="*/ 929812 w 2994958"/>
                            <a:gd name="connsiteY319" fmla="*/ 1926405 h 3036014"/>
                            <a:gd name="connsiteX320" fmla="*/ 863030 w 2994958"/>
                            <a:gd name="connsiteY320" fmla="*/ 1962364 h 3036014"/>
                            <a:gd name="connsiteX321" fmla="*/ 852755 w 2994958"/>
                            <a:gd name="connsiteY321" fmla="*/ 1972639 h 3036014"/>
                            <a:gd name="connsiteX322" fmla="*/ 811659 w 2994958"/>
                            <a:gd name="connsiteY322" fmla="*/ 1993187 h 3036014"/>
                            <a:gd name="connsiteX323" fmla="*/ 775699 w 2994958"/>
                            <a:gd name="connsiteY323" fmla="*/ 2018872 h 3036014"/>
                            <a:gd name="connsiteX324" fmla="*/ 760288 w 2994958"/>
                            <a:gd name="connsiteY324" fmla="*/ 2029146 h 3036014"/>
                            <a:gd name="connsiteX325" fmla="*/ 703780 w 2994958"/>
                            <a:gd name="connsiteY325" fmla="*/ 2049695 h 3036014"/>
                            <a:gd name="connsiteX326" fmla="*/ 683232 w 2994958"/>
                            <a:gd name="connsiteY326" fmla="*/ 2065106 h 3036014"/>
                            <a:gd name="connsiteX327" fmla="*/ 657546 w 2994958"/>
                            <a:gd name="connsiteY327" fmla="*/ 2075380 h 3036014"/>
                            <a:gd name="connsiteX328" fmla="*/ 631861 w 2994958"/>
                            <a:gd name="connsiteY328" fmla="*/ 2090791 h 3036014"/>
                            <a:gd name="connsiteX329" fmla="*/ 601039 w 2994958"/>
                            <a:gd name="connsiteY329" fmla="*/ 2106203 h 3036014"/>
                            <a:gd name="connsiteX330" fmla="*/ 580490 w 2994958"/>
                            <a:gd name="connsiteY330" fmla="*/ 2121614 h 3036014"/>
                            <a:gd name="connsiteX331" fmla="*/ 559942 w 2994958"/>
                            <a:gd name="connsiteY331" fmla="*/ 2131888 h 3036014"/>
                            <a:gd name="connsiteX332" fmla="*/ 539394 w 2994958"/>
                            <a:gd name="connsiteY332" fmla="*/ 2147299 h 3036014"/>
                            <a:gd name="connsiteX333" fmla="*/ 498297 w 2994958"/>
                            <a:gd name="connsiteY333" fmla="*/ 2167848 h 3036014"/>
                            <a:gd name="connsiteX334" fmla="*/ 482886 w 2994958"/>
                            <a:gd name="connsiteY334" fmla="*/ 2178122 h 3036014"/>
                            <a:gd name="connsiteX335" fmla="*/ 436652 w 2994958"/>
                            <a:gd name="connsiteY335" fmla="*/ 2198670 h 3036014"/>
                            <a:gd name="connsiteX336" fmla="*/ 405830 w 2994958"/>
                            <a:gd name="connsiteY336" fmla="*/ 2214081 h 3036014"/>
                            <a:gd name="connsiteX337" fmla="*/ 375007 w 2994958"/>
                            <a:gd name="connsiteY337" fmla="*/ 2224355 h 3036014"/>
                            <a:gd name="connsiteX338" fmla="*/ 349322 w 2994958"/>
                            <a:gd name="connsiteY338" fmla="*/ 2239767 h 3036014"/>
                            <a:gd name="connsiteX339" fmla="*/ 308225 w 2994958"/>
                            <a:gd name="connsiteY339" fmla="*/ 2255178 h 3036014"/>
                            <a:gd name="connsiteX340" fmla="*/ 261991 w 2994958"/>
                            <a:gd name="connsiteY340" fmla="*/ 2275726 h 3036014"/>
                            <a:gd name="connsiteX341" fmla="*/ 246580 w 2994958"/>
                            <a:gd name="connsiteY341" fmla="*/ 2286000 h 3036014"/>
                            <a:gd name="connsiteX342" fmla="*/ 231169 w 2994958"/>
                            <a:gd name="connsiteY342" fmla="*/ 2291138 h 3036014"/>
                            <a:gd name="connsiteX343" fmla="*/ 205484 w 2994958"/>
                            <a:gd name="connsiteY343" fmla="*/ 2311686 h 3036014"/>
                            <a:gd name="connsiteX344" fmla="*/ 190072 w 2994958"/>
                            <a:gd name="connsiteY344" fmla="*/ 2321960 h 3036014"/>
                            <a:gd name="connsiteX345" fmla="*/ 169524 w 2994958"/>
                            <a:gd name="connsiteY345" fmla="*/ 2286000 h 3036014"/>
                            <a:gd name="connsiteX346" fmla="*/ 164387 w 2994958"/>
                            <a:gd name="connsiteY346" fmla="*/ 2239767 h 3036014"/>
                            <a:gd name="connsiteX347" fmla="*/ 159250 w 2994958"/>
                            <a:gd name="connsiteY347" fmla="*/ 2219218 h 3036014"/>
                            <a:gd name="connsiteX348" fmla="*/ 154113 w 2994958"/>
                            <a:gd name="connsiteY348" fmla="*/ 2188396 h 3036014"/>
                            <a:gd name="connsiteX349" fmla="*/ 138702 w 2994958"/>
                            <a:gd name="connsiteY349" fmla="*/ 2147299 h 3036014"/>
                            <a:gd name="connsiteX350" fmla="*/ 123290 w 2994958"/>
                            <a:gd name="connsiteY350" fmla="*/ 2101066 h 3036014"/>
                            <a:gd name="connsiteX351" fmla="*/ 102742 w 2994958"/>
                            <a:gd name="connsiteY351" fmla="*/ 2070243 h 3036014"/>
                            <a:gd name="connsiteX352" fmla="*/ 92468 w 2994958"/>
                            <a:gd name="connsiteY352" fmla="*/ 2018872 h 3036014"/>
                            <a:gd name="connsiteX353" fmla="*/ 87331 w 2994958"/>
                            <a:gd name="connsiteY353" fmla="*/ 1998324 h 3036014"/>
                            <a:gd name="connsiteX354" fmla="*/ 77057 w 2994958"/>
                            <a:gd name="connsiteY354" fmla="*/ 1982913 h 3036014"/>
                            <a:gd name="connsiteX355" fmla="*/ 71920 w 2994958"/>
                            <a:gd name="connsiteY355" fmla="*/ 1967502 h 3036014"/>
                            <a:gd name="connsiteX356" fmla="*/ 66782 w 2994958"/>
                            <a:gd name="connsiteY356" fmla="*/ 1910994 h 3036014"/>
                            <a:gd name="connsiteX357" fmla="*/ 56508 w 2994958"/>
                            <a:gd name="connsiteY357" fmla="*/ 1880171 h 3036014"/>
                            <a:gd name="connsiteX358" fmla="*/ 35960 w 2994958"/>
                            <a:gd name="connsiteY358" fmla="*/ 1823663 h 3036014"/>
                            <a:gd name="connsiteX359" fmla="*/ 30823 w 2994958"/>
                            <a:gd name="connsiteY359" fmla="*/ 1808252 h 3036014"/>
                            <a:gd name="connsiteX360" fmla="*/ 10275 w 2994958"/>
                            <a:gd name="connsiteY360" fmla="*/ 1731196 h 3036014"/>
                            <a:gd name="connsiteX361" fmla="*/ 0 w 2994958"/>
                            <a:gd name="connsiteY361" fmla="*/ 1582221 h 3036014"/>
                            <a:gd name="connsiteX362" fmla="*/ 5137 w 2994958"/>
                            <a:gd name="connsiteY362" fmla="*/ 1294544 h 3036014"/>
                            <a:gd name="connsiteX363" fmla="*/ 20549 w 2994958"/>
                            <a:gd name="connsiteY363" fmla="*/ 1202077 h 3036014"/>
                            <a:gd name="connsiteX364" fmla="*/ 30823 w 2994958"/>
                            <a:gd name="connsiteY364" fmla="*/ 1155843 h 3036014"/>
                            <a:gd name="connsiteX365" fmla="*/ 35960 w 2994958"/>
                            <a:gd name="connsiteY365" fmla="*/ 1140432 h 3036014"/>
                            <a:gd name="connsiteX366" fmla="*/ 41097 w 2994958"/>
                            <a:gd name="connsiteY366" fmla="*/ 1109609 h 3036014"/>
                            <a:gd name="connsiteX367" fmla="*/ 56508 w 2994958"/>
                            <a:gd name="connsiteY367" fmla="*/ 1083924 h 3036014"/>
                            <a:gd name="connsiteX368" fmla="*/ 66782 w 2994958"/>
                            <a:gd name="connsiteY368" fmla="*/ 1058239 h 3036014"/>
                            <a:gd name="connsiteX369" fmla="*/ 77057 w 2994958"/>
                            <a:gd name="connsiteY369" fmla="*/ 1027416 h 3036014"/>
                            <a:gd name="connsiteX370" fmla="*/ 87331 w 2994958"/>
                            <a:gd name="connsiteY370" fmla="*/ 1001731 h 3036014"/>
                            <a:gd name="connsiteX371" fmla="*/ 97605 w 2994958"/>
                            <a:gd name="connsiteY371" fmla="*/ 960634 h 3036014"/>
                            <a:gd name="connsiteX372" fmla="*/ 107879 w 2994958"/>
                            <a:gd name="connsiteY372" fmla="*/ 934949 h 3036014"/>
                            <a:gd name="connsiteX373" fmla="*/ 113016 w 2994958"/>
                            <a:gd name="connsiteY373" fmla="*/ 914400 h 3036014"/>
                            <a:gd name="connsiteX374" fmla="*/ 133564 w 2994958"/>
                            <a:gd name="connsiteY374" fmla="*/ 873304 h 3036014"/>
                            <a:gd name="connsiteX375" fmla="*/ 154113 w 2994958"/>
                            <a:gd name="connsiteY375" fmla="*/ 821933 h 3036014"/>
                            <a:gd name="connsiteX376" fmla="*/ 164387 w 2994958"/>
                            <a:gd name="connsiteY376" fmla="*/ 796248 h 3036014"/>
                            <a:gd name="connsiteX377" fmla="*/ 184935 w 2994958"/>
                            <a:gd name="connsiteY377" fmla="*/ 755151 h 3036014"/>
                            <a:gd name="connsiteX378" fmla="*/ 195209 w 2994958"/>
                            <a:gd name="connsiteY378" fmla="*/ 708917 h 3036014"/>
                            <a:gd name="connsiteX379" fmla="*/ 205484 w 2994958"/>
                            <a:gd name="connsiteY379" fmla="*/ 698643 h 3036014"/>
                            <a:gd name="connsiteX380" fmla="*/ 215758 w 2994958"/>
                            <a:gd name="connsiteY380" fmla="*/ 667821 h 3036014"/>
                            <a:gd name="connsiteX381" fmla="*/ 246580 w 2994958"/>
                            <a:gd name="connsiteY381" fmla="*/ 636998 h 3036014"/>
                            <a:gd name="connsiteX382" fmla="*/ 256854 w 2994958"/>
                            <a:gd name="connsiteY382" fmla="*/ 621587 h 3036014"/>
                            <a:gd name="connsiteX383" fmla="*/ 277403 w 2994958"/>
                            <a:gd name="connsiteY383" fmla="*/ 595902 h 3036014"/>
                            <a:gd name="connsiteX384" fmla="*/ 282540 w 2994958"/>
                            <a:gd name="connsiteY384" fmla="*/ 580490 h 3036014"/>
                            <a:gd name="connsiteX385" fmla="*/ 313362 w 2994958"/>
                            <a:gd name="connsiteY385" fmla="*/ 549668 h 3036014"/>
                            <a:gd name="connsiteX386" fmla="*/ 333911 w 2994958"/>
                            <a:gd name="connsiteY386" fmla="*/ 529120 h 3036014"/>
                            <a:gd name="connsiteX387" fmla="*/ 344185 w 2994958"/>
                            <a:gd name="connsiteY387" fmla="*/ 513708 h 3036014"/>
                            <a:gd name="connsiteX388" fmla="*/ 380144 w 2994958"/>
                            <a:gd name="connsiteY388" fmla="*/ 477749 h 3036014"/>
                            <a:gd name="connsiteX389" fmla="*/ 405830 w 2994958"/>
                            <a:gd name="connsiteY389" fmla="*/ 452063 h 3036014"/>
                            <a:gd name="connsiteX390" fmla="*/ 457200 w 2994958"/>
                            <a:gd name="connsiteY390" fmla="*/ 410967 h 3036014"/>
                            <a:gd name="connsiteX391" fmla="*/ 467475 w 2994958"/>
                            <a:gd name="connsiteY391" fmla="*/ 395555 h 3036014"/>
                            <a:gd name="connsiteX392" fmla="*/ 498297 w 2994958"/>
                            <a:gd name="connsiteY392" fmla="*/ 400693 h 3036014"/>
                            <a:gd name="connsiteX393" fmla="*/ 544531 w 2994958"/>
                            <a:gd name="connsiteY393" fmla="*/ 426378 h 3036014"/>
                            <a:gd name="connsiteX394" fmla="*/ 585627 w 2994958"/>
                            <a:gd name="connsiteY394" fmla="*/ 446926 h 3036014"/>
                            <a:gd name="connsiteX395" fmla="*/ 616450 w 2994958"/>
                            <a:gd name="connsiteY395" fmla="*/ 472612 h 3036014"/>
                            <a:gd name="connsiteX396" fmla="*/ 642135 w 2994958"/>
                            <a:gd name="connsiteY396" fmla="*/ 493160 h 3036014"/>
                            <a:gd name="connsiteX397" fmla="*/ 662684 w 2994958"/>
                            <a:gd name="connsiteY397" fmla="*/ 518845 h 3036014"/>
                            <a:gd name="connsiteX398" fmla="*/ 672958 w 2994958"/>
                            <a:gd name="connsiteY398" fmla="*/ 529120 h 3036014"/>
                            <a:gd name="connsiteX399" fmla="*/ 683232 w 2994958"/>
                            <a:gd name="connsiteY399" fmla="*/ 544531 h 3036014"/>
                            <a:gd name="connsiteX400" fmla="*/ 703780 w 2994958"/>
                            <a:gd name="connsiteY400" fmla="*/ 565079 h 3036014"/>
                            <a:gd name="connsiteX401" fmla="*/ 724329 w 2994958"/>
                            <a:gd name="connsiteY401" fmla="*/ 595902 h 3036014"/>
                            <a:gd name="connsiteX402" fmla="*/ 739740 w 2994958"/>
                            <a:gd name="connsiteY402" fmla="*/ 611313 h 3036014"/>
                            <a:gd name="connsiteX403" fmla="*/ 765425 w 2994958"/>
                            <a:gd name="connsiteY403" fmla="*/ 647272 h 3036014"/>
                            <a:gd name="connsiteX404" fmla="*/ 780836 w 2994958"/>
                            <a:gd name="connsiteY404" fmla="*/ 672958 h 3036014"/>
                            <a:gd name="connsiteX405" fmla="*/ 811659 w 2994958"/>
                            <a:gd name="connsiteY405" fmla="*/ 703780 h 3036014"/>
                            <a:gd name="connsiteX406" fmla="*/ 827070 w 2994958"/>
                            <a:gd name="connsiteY406" fmla="*/ 719191 h 3036014"/>
                            <a:gd name="connsiteX407" fmla="*/ 868167 w 2994958"/>
                            <a:gd name="connsiteY407" fmla="*/ 765425 h 3036014"/>
                            <a:gd name="connsiteX408" fmla="*/ 888715 w 2994958"/>
                            <a:gd name="connsiteY408" fmla="*/ 791111 h 3036014"/>
                            <a:gd name="connsiteX409" fmla="*/ 904126 w 2994958"/>
                            <a:gd name="connsiteY409" fmla="*/ 806522 h 3036014"/>
                            <a:gd name="connsiteX410" fmla="*/ 914400 w 2994958"/>
                            <a:gd name="connsiteY410" fmla="*/ 821933 h 3036014"/>
                            <a:gd name="connsiteX411" fmla="*/ 945223 w 2994958"/>
                            <a:gd name="connsiteY411" fmla="*/ 852755 h 3036014"/>
                            <a:gd name="connsiteX412" fmla="*/ 970908 w 2994958"/>
                            <a:gd name="connsiteY412" fmla="*/ 883578 h 3036014"/>
                            <a:gd name="connsiteX413" fmla="*/ 986320 w 2994958"/>
                            <a:gd name="connsiteY413" fmla="*/ 904126 h 3036014"/>
                            <a:gd name="connsiteX414" fmla="*/ 1001731 w 2994958"/>
                            <a:gd name="connsiteY414" fmla="*/ 919538 h 3036014"/>
                            <a:gd name="connsiteX415" fmla="*/ 1012005 w 2994958"/>
                            <a:gd name="connsiteY415" fmla="*/ 934949 h 3036014"/>
                            <a:gd name="connsiteX416" fmla="*/ 1027416 w 2994958"/>
                            <a:gd name="connsiteY416" fmla="*/ 945223 h 3036014"/>
                            <a:gd name="connsiteX417" fmla="*/ 1047964 w 2994958"/>
                            <a:gd name="connsiteY417" fmla="*/ 970908 h 3036014"/>
                            <a:gd name="connsiteX418" fmla="*/ 1099335 w 2994958"/>
                            <a:gd name="connsiteY418" fmla="*/ 1017142 h 3036014"/>
                            <a:gd name="connsiteX419" fmla="*/ 1125021 w 2994958"/>
                            <a:gd name="connsiteY419" fmla="*/ 1032553 h 3036014"/>
                            <a:gd name="connsiteX420" fmla="*/ 1150706 w 2994958"/>
                            <a:gd name="connsiteY420" fmla="*/ 1058239 h 3036014"/>
                            <a:gd name="connsiteX421" fmla="*/ 1166117 w 2994958"/>
                            <a:gd name="connsiteY421" fmla="*/ 1073650 h 3036014"/>
                            <a:gd name="connsiteX422" fmla="*/ 1217488 w 2994958"/>
                            <a:gd name="connsiteY422" fmla="*/ 1109609 h 3036014"/>
                            <a:gd name="connsiteX423" fmla="*/ 1243173 w 2994958"/>
                            <a:gd name="connsiteY423" fmla="*/ 1135295 h 3036014"/>
                            <a:gd name="connsiteX424" fmla="*/ 1258585 w 2994958"/>
                            <a:gd name="connsiteY424" fmla="*/ 1135295 h 3036014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  <a:cxn ang="0">
                              <a:pos x="connsiteX4" y="connsiteY4"/>
                            </a:cxn>
                            <a:cxn ang="0">
                              <a:pos x="connsiteX5" y="connsiteY5"/>
                            </a:cxn>
                            <a:cxn ang="0">
                              <a:pos x="connsiteX6" y="connsiteY6"/>
                            </a:cxn>
                            <a:cxn ang="0">
                              <a:pos x="connsiteX7" y="connsiteY7"/>
                            </a:cxn>
                            <a:cxn ang="0">
                              <a:pos x="connsiteX8" y="connsiteY8"/>
                            </a:cxn>
                            <a:cxn ang="0">
                              <a:pos x="connsiteX9" y="connsiteY9"/>
                            </a:cxn>
                            <a:cxn ang="0">
                              <a:pos x="connsiteX10" y="connsiteY10"/>
                            </a:cxn>
                            <a:cxn ang="0">
                              <a:pos x="connsiteX11" y="connsiteY11"/>
                            </a:cxn>
                            <a:cxn ang="0">
                              <a:pos x="connsiteX12" y="connsiteY12"/>
                            </a:cxn>
                            <a:cxn ang="0">
                              <a:pos x="connsiteX13" y="connsiteY13"/>
                            </a:cxn>
                            <a:cxn ang="0">
                              <a:pos x="connsiteX14" y="connsiteY14"/>
                            </a:cxn>
                            <a:cxn ang="0">
                              <a:pos x="connsiteX15" y="connsiteY15"/>
                            </a:cxn>
                            <a:cxn ang="0">
                              <a:pos x="connsiteX16" y="connsiteY16"/>
                            </a:cxn>
                            <a:cxn ang="0">
                              <a:pos x="connsiteX17" y="connsiteY17"/>
                            </a:cxn>
                            <a:cxn ang="0">
                              <a:pos x="connsiteX18" y="connsiteY18"/>
                            </a:cxn>
                            <a:cxn ang="0">
                              <a:pos x="connsiteX19" y="connsiteY19"/>
                            </a:cxn>
                            <a:cxn ang="0">
                              <a:pos x="connsiteX20" y="connsiteY20"/>
                            </a:cxn>
                            <a:cxn ang="0">
                              <a:pos x="connsiteX21" y="connsiteY21"/>
                            </a:cxn>
                            <a:cxn ang="0">
                              <a:pos x="connsiteX22" y="connsiteY22"/>
                            </a:cxn>
                            <a:cxn ang="0">
                              <a:pos x="connsiteX23" y="connsiteY23"/>
                            </a:cxn>
                            <a:cxn ang="0">
                              <a:pos x="connsiteX24" y="connsiteY24"/>
                            </a:cxn>
                            <a:cxn ang="0">
                              <a:pos x="connsiteX25" y="connsiteY25"/>
                            </a:cxn>
                            <a:cxn ang="0">
                              <a:pos x="connsiteX26" y="connsiteY26"/>
                            </a:cxn>
                            <a:cxn ang="0">
                              <a:pos x="connsiteX27" y="connsiteY27"/>
                            </a:cxn>
                            <a:cxn ang="0">
                              <a:pos x="connsiteX28" y="connsiteY28"/>
                            </a:cxn>
                            <a:cxn ang="0">
                              <a:pos x="connsiteX29" y="connsiteY29"/>
                            </a:cxn>
                            <a:cxn ang="0">
                              <a:pos x="connsiteX30" y="connsiteY30"/>
                            </a:cxn>
                            <a:cxn ang="0">
                              <a:pos x="connsiteX31" y="connsiteY31"/>
                            </a:cxn>
                            <a:cxn ang="0">
                              <a:pos x="connsiteX32" y="connsiteY32"/>
                            </a:cxn>
                            <a:cxn ang="0">
                              <a:pos x="connsiteX33" y="connsiteY33"/>
                            </a:cxn>
                            <a:cxn ang="0">
                              <a:pos x="connsiteX34" y="connsiteY34"/>
                            </a:cxn>
                            <a:cxn ang="0">
                              <a:pos x="connsiteX35" y="connsiteY35"/>
                            </a:cxn>
                            <a:cxn ang="0">
                              <a:pos x="connsiteX36" y="connsiteY36"/>
                            </a:cxn>
                            <a:cxn ang="0">
                              <a:pos x="connsiteX37" y="connsiteY37"/>
                            </a:cxn>
                            <a:cxn ang="0">
                              <a:pos x="connsiteX38" y="connsiteY38"/>
                            </a:cxn>
                            <a:cxn ang="0">
                              <a:pos x="connsiteX39" y="connsiteY39"/>
                            </a:cxn>
                            <a:cxn ang="0">
                              <a:pos x="connsiteX40" y="connsiteY40"/>
                            </a:cxn>
                            <a:cxn ang="0">
                              <a:pos x="connsiteX41" y="connsiteY41"/>
                            </a:cxn>
                            <a:cxn ang="0">
                              <a:pos x="connsiteX42" y="connsiteY42"/>
                            </a:cxn>
                            <a:cxn ang="0">
                              <a:pos x="connsiteX43" y="connsiteY43"/>
                            </a:cxn>
                            <a:cxn ang="0">
                              <a:pos x="connsiteX44" y="connsiteY44"/>
                            </a:cxn>
                            <a:cxn ang="0">
                              <a:pos x="connsiteX45" y="connsiteY45"/>
                            </a:cxn>
                            <a:cxn ang="0">
                              <a:pos x="connsiteX46" y="connsiteY46"/>
                            </a:cxn>
                            <a:cxn ang="0">
                              <a:pos x="connsiteX47" y="connsiteY47"/>
                            </a:cxn>
                            <a:cxn ang="0">
                              <a:pos x="connsiteX48" y="connsiteY48"/>
                            </a:cxn>
                            <a:cxn ang="0">
                              <a:pos x="connsiteX49" y="connsiteY49"/>
                            </a:cxn>
                            <a:cxn ang="0">
                              <a:pos x="connsiteX50" y="connsiteY50"/>
                            </a:cxn>
                            <a:cxn ang="0">
                              <a:pos x="connsiteX51" y="connsiteY51"/>
                            </a:cxn>
                            <a:cxn ang="0">
                              <a:pos x="connsiteX52" y="connsiteY52"/>
                            </a:cxn>
                            <a:cxn ang="0">
                              <a:pos x="connsiteX53" y="connsiteY53"/>
                            </a:cxn>
                            <a:cxn ang="0">
                              <a:pos x="connsiteX54" y="connsiteY54"/>
                            </a:cxn>
                            <a:cxn ang="0">
                              <a:pos x="connsiteX55" y="connsiteY55"/>
                            </a:cxn>
                            <a:cxn ang="0">
                              <a:pos x="connsiteX56" y="connsiteY56"/>
                            </a:cxn>
                            <a:cxn ang="0">
                              <a:pos x="connsiteX57" y="connsiteY57"/>
                            </a:cxn>
                            <a:cxn ang="0">
                              <a:pos x="connsiteX58" y="connsiteY58"/>
                            </a:cxn>
                            <a:cxn ang="0">
                              <a:pos x="connsiteX59" y="connsiteY59"/>
                            </a:cxn>
                            <a:cxn ang="0">
                              <a:pos x="connsiteX60" y="connsiteY60"/>
                            </a:cxn>
                            <a:cxn ang="0">
                              <a:pos x="connsiteX61" y="connsiteY61"/>
                            </a:cxn>
                            <a:cxn ang="0">
                              <a:pos x="connsiteX62" y="connsiteY62"/>
                            </a:cxn>
                            <a:cxn ang="0">
                              <a:pos x="connsiteX63" y="connsiteY63"/>
                            </a:cxn>
                            <a:cxn ang="0">
                              <a:pos x="connsiteX64" y="connsiteY64"/>
                            </a:cxn>
                            <a:cxn ang="0">
                              <a:pos x="connsiteX65" y="connsiteY65"/>
                            </a:cxn>
                            <a:cxn ang="0">
                              <a:pos x="connsiteX66" y="connsiteY66"/>
                            </a:cxn>
                            <a:cxn ang="0">
                              <a:pos x="connsiteX67" y="connsiteY67"/>
                            </a:cxn>
                            <a:cxn ang="0">
                              <a:pos x="connsiteX68" y="connsiteY68"/>
                            </a:cxn>
                            <a:cxn ang="0">
                              <a:pos x="connsiteX69" y="connsiteY69"/>
                            </a:cxn>
                            <a:cxn ang="0">
                              <a:pos x="connsiteX70" y="connsiteY70"/>
                            </a:cxn>
                            <a:cxn ang="0">
                              <a:pos x="connsiteX71" y="connsiteY71"/>
                            </a:cxn>
                            <a:cxn ang="0">
                              <a:pos x="connsiteX72" y="connsiteY72"/>
                            </a:cxn>
                            <a:cxn ang="0">
                              <a:pos x="connsiteX73" y="connsiteY73"/>
                            </a:cxn>
                            <a:cxn ang="0">
                              <a:pos x="connsiteX74" y="connsiteY74"/>
                            </a:cxn>
                            <a:cxn ang="0">
                              <a:pos x="connsiteX75" y="connsiteY75"/>
                            </a:cxn>
                            <a:cxn ang="0">
                              <a:pos x="connsiteX76" y="connsiteY76"/>
                            </a:cxn>
                            <a:cxn ang="0">
                              <a:pos x="connsiteX77" y="connsiteY77"/>
                            </a:cxn>
                            <a:cxn ang="0">
                              <a:pos x="connsiteX78" y="connsiteY78"/>
                            </a:cxn>
                            <a:cxn ang="0">
                              <a:pos x="connsiteX79" y="connsiteY79"/>
                            </a:cxn>
                            <a:cxn ang="0">
                              <a:pos x="connsiteX80" y="connsiteY80"/>
                            </a:cxn>
                            <a:cxn ang="0">
                              <a:pos x="connsiteX81" y="connsiteY81"/>
                            </a:cxn>
                            <a:cxn ang="0">
                              <a:pos x="connsiteX82" y="connsiteY82"/>
                            </a:cxn>
                            <a:cxn ang="0">
                              <a:pos x="connsiteX83" y="connsiteY83"/>
                            </a:cxn>
                            <a:cxn ang="0">
                              <a:pos x="connsiteX84" y="connsiteY84"/>
                            </a:cxn>
                            <a:cxn ang="0">
                              <a:pos x="connsiteX85" y="connsiteY85"/>
                            </a:cxn>
                            <a:cxn ang="0">
                              <a:pos x="connsiteX86" y="connsiteY86"/>
                            </a:cxn>
                            <a:cxn ang="0">
                              <a:pos x="connsiteX87" y="connsiteY87"/>
                            </a:cxn>
                            <a:cxn ang="0">
                              <a:pos x="connsiteX88" y="connsiteY88"/>
                            </a:cxn>
                            <a:cxn ang="0">
                              <a:pos x="connsiteX89" y="connsiteY89"/>
                            </a:cxn>
                            <a:cxn ang="0">
                              <a:pos x="connsiteX90" y="connsiteY90"/>
                            </a:cxn>
                            <a:cxn ang="0">
                              <a:pos x="connsiteX91" y="connsiteY91"/>
                            </a:cxn>
                            <a:cxn ang="0">
                              <a:pos x="connsiteX92" y="connsiteY92"/>
                            </a:cxn>
                            <a:cxn ang="0">
                              <a:pos x="connsiteX93" y="connsiteY93"/>
                            </a:cxn>
                            <a:cxn ang="0">
                              <a:pos x="connsiteX94" y="connsiteY94"/>
                            </a:cxn>
                            <a:cxn ang="0">
                              <a:pos x="connsiteX95" y="connsiteY95"/>
                            </a:cxn>
                            <a:cxn ang="0">
                              <a:pos x="connsiteX96" y="connsiteY96"/>
                            </a:cxn>
                            <a:cxn ang="0">
                              <a:pos x="connsiteX97" y="connsiteY97"/>
                            </a:cxn>
                            <a:cxn ang="0">
                              <a:pos x="connsiteX98" y="connsiteY98"/>
                            </a:cxn>
                            <a:cxn ang="0">
                              <a:pos x="connsiteX99" y="connsiteY99"/>
                            </a:cxn>
                            <a:cxn ang="0">
                              <a:pos x="connsiteX100" y="connsiteY100"/>
                            </a:cxn>
                            <a:cxn ang="0">
                              <a:pos x="connsiteX101" y="connsiteY101"/>
                            </a:cxn>
                            <a:cxn ang="0">
                              <a:pos x="connsiteX102" y="connsiteY102"/>
                            </a:cxn>
                            <a:cxn ang="0">
                              <a:pos x="connsiteX103" y="connsiteY103"/>
                            </a:cxn>
                            <a:cxn ang="0">
                              <a:pos x="connsiteX104" y="connsiteY104"/>
                            </a:cxn>
                            <a:cxn ang="0">
                              <a:pos x="connsiteX105" y="connsiteY105"/>
                            </a:cxn>
                            <a:cxn ang="0">
                              <a:pos x="connsiteX106" y="connsiteY106"/>
                            </a:cxn>
                            <a:cxn ang="0">
                              <a:pos x="connsiteX107" y="connsiteY107"/>
                            </a:cxn>
                            <a:cxn ang="0">
                              <a:pos x="connsiteX108" y="connsiteY108"/>
                            </a:cxn>
                            <a:cxn ang="0">
                              <a:pos x="connsiteX109" y="connsiteY109"/>
                            </a:cxn>
                            <a:cxn ang="0">
                              <a:pos x="connsiteX110" y="connsiteY110"/>
                            </a:cxn>
                            <a:cxn ang="0">
                              <a:pos x="connsiteX111" y="connsiteY111"/>
                            </a:cxn>
                            <a:cxn ang="0">
                              <a:pos x="connsiteX112" y="connsiteY112"/>
                            </a:cxn>
                            <a:cxn ang="0">
                              <a:pos x="connsiteX113" y="connsiteY113"/>
                            </a:cxn>
                            <a:cxn ang="0">
                              <a:pos x="connsiteX114" y="connsiteY114"/>
                            </a:cxn>
                            <a:cxn ang="0">
                              <a:pos x="connsiteX115" y="connsiteY115"/>
                            </a:cxn>
                            <a:cxn ang="0">
                              <a:pos x="connsiteX116" y="connsiteY116"/>
                            </a:cxn>
                            <a:cxn ang="0">
                              <a:pos x="connsiteX117" y="connsiteY117"/>
                            </a:cxn>
                            <a:cxn ang="0">
                              <a:pos x="connsiteX118" y="connsiteY118"/>
                            </a:cxn>
                            <a:cxn ang="0">
                              <a:pos x="connsiteX119" y="connsiteY119"/>
                            </a:cxn>
                            <a:cxn ang="0">
                              <a:pos x="connsiteX120" y="connsiteY120"/>
                            </a:cxn>
                            <a:cxn ang="0">
                              <a:pos x="connsiteX121" y="connsiteY121"/>
                            </a:cxn>
                            <a:cxn ang="0">
                              <a:pos x="connsiteX122" y="connsiteY122"/>
                            </a:cxn>
                            <a:cxn ang="0">
                              <a:pos x="connsiteX123" y="connsiteY123"/>
                            </a:cxn>
                            <a:cxn ang="0">
                              <a:pos x="connsiteX124" y="connsiteY124"/>
                            </a:cxn>
                            <a:cxn ang="0">
                              <a:pos x="connsiteX125" y="connsiteY125"/>
                            </a:cxn>
                            <a:cxn ang="0">
                              <a:pos x="connsiteX126" y="connsiteY126"/>
                            </a:cxn>
                            <a:cxn ang="0">
                              <a:pos x="connsiteX127" y="connsiteY127"/>
                            </a:cxn>
                            <a:cxn ang="0">
                              <a:pos x="connsiteX128" y="connsiteY128"/>
                            </a:cxn>
                            <a:cxn ang="0">
                              <a:pos x="connsiteX129" y="connsiteY129"/>
                            </a:cxn>
                            <a:cxn ang="0">
                              <a:pos x="connsiteX130" y="connsiteY130"/>
                            </a:cxn>
                            <a:cxn ang="0">
                              <a:pos x="connsiteX131" y="connsiteY131"/>
                            </a:cxn>
                            <a:cxn ang="0">
                              <a:pos x="connsiteX132" y="connsiteY132"/>
                            </a:cxn>
                            <a:cxn ang="0">
                              <a:pos x="connsiteX133" y="connsiteY133"/>
                            </a:cxn>
                            <a:cxn ang="0">
                              <a:pos x="connsiteX134" y="connsiteY134"/>
                            </a:cxn>
                            <a:cxn ang="0">
                              <a:pos x="connsiteX135" y="connsiteY135"/>
                            </a:cxn>
                            <a:cxn ang="0">
                              <a:pos x="connsiteX136" y="connsiteY136"/>
                            </a:cxn>
                            <a:cxn ang="0">
                              <a:pos x="connsiteX137" y="connsiteY137"/>
                            </a:cxn>
                            <a:cxn ang="0">
                              <a:pos x="connsiteX138" y="connsiteY138"/>
                            </a:cxn>
                            <a:cxn ang="0">
                              <a:pos x="connsiteX139" y="connsiteY139"/>
                            </a:cxn>
                            <a:cxn ang="0">
                              <a:pos x="connsiteX140" y="connsiteY140"/>
                            </a:cxn>
                            <a:cxn ang="0">
                              <a:pos x="connsiteX141" y="connsiteY141"/>
                            </a:cxn>
                            <a:cxn ang="0">
                              <a:pos x="connsiteX142" y="connsiteY142"/>
                            </a:cxn>
                            <a:cxn ang="0">
                              <a:pos x="connsiteX143" y="connsiteY143"/>
                            </a:cxn>
                            <a:cxn ang="0">
                              <a:pos x="connsiteX144" y="connsiteY144"/>
                            </a:cxn>
                            <a:cxn ang="0">
                              <a:pos x="connsiteX145" y="connsiteY145"/>
                            </a:cxn>
                            <a:cxn ang="0">
                              <a:pos x="connsiteX146" y="connsiteY146"/>
                            </a:cxn>
                            <a:cxn ang="0">
                              <a:pos x="connsiteX147" y="connsiteY147"/>
                            </a:cxn>
                            <a:cxn ang="0">
                              <a:pos x="connsiteX148" y="connsiteY148"/>
                            </a:cxn>
                            <a:cxn ang="0">
                              <a:pos x="connsiteX149" y="connsiteY149"/>
                            </a:cxn>
                            <a:cxn ang="0">
                              <a:pos x="connsiteX150" y="connsiteY150"/>
                            </a:cxn>
                            <a:cxn ang="0">
                              <a:pos x="connsiteX151" y="connsiteY151"/>
                            </a:cxn>
                            <a:cxn ang="0">
                              <a:pos x="connsiteX152" y="connsiteY152"/>
                            </a:cxn>
                            <a:cxn ang="0">
                              <a:pos x="connsiteX153" y="connsiteY153"/>
                            </a:cxn>
                            <a:cxn ang="0">
                              <a:pos x="connsiteX154" y="connsiteY154"/>
                            </a:cxn>
                            <a:cxn ang="0">
                              <a:pos x="connsiteX155" y="connsiteY155"/>
                            </a:cxn>
                            <a:cxn ang="0">
                              <a:pos x="connsiteX156" y="connsiteY156"/>
                            </a:cxn>
                            <a:cxn ang="0">
                              <a:pos x="connsiteX157" y="connsiteY157"/>
                            </a:cxn>
                            <a:cxn ang="0">
                              <a:pos x="connsiteX158" y="connsiteY158"/>
                            </a:cxn>
                            <a:cxn ang="0">
                              <a:pos x="connsiteX159" y="connsiteY159"/>
                            </a:cxn>
                            <a:cxn ang="0">
                              <a:pos x="connsiteX160" y="connsiteY160"/>
                            </a:cxn>
                            <a:cxn ang="0">
                              <a:pos x="connsiteX161" y="connsiteY161"/>
                            </a:cxn>
                            <a:cxn ang="0">
                              <a:pos x="connsiteX162" y="connsiteY162"/>
                            </a:cxn>
                            <a:cxn ang="0">
                              <a:pos x="connsiteX163" y="connsiteY163"/>
                            </a:cxn>
                            <a:cxn ang="0">
                              <a:pos x="connsiteX164" y="connsiteY164"/>
                            </a:cxn>
                            <a:cxn ang="0">
                              <a:pos x="connsiteX165" y="connsiteY165"/>
                            </a:cxn>
                            <a:cxn ang="0">
                              <a:pos x="connsiteX166" y="connsiteY166"/>
                            </a:cxn>
                            <a:cxn ang="0">
                              <a:pos x="connsiteX167" y="connsiteY167"/>
                            </a:cxn>
                            <a:cxn ang="0">
                              <a:pos x="connsiteX168" y="connsiteY168"/>
                            </a:cxn>
                            <a:cxn ang="0">
                              <a:pos x="connsiteX169" y="connsiteY169"/>
                            </a:cxn>
                            <a:cxn ang="0">
                              <a:pos x="connsiteX170" y="connsiteY170"/>
                            </a:cxn>
                            <a:cxn ang="0">
                              <a:pos x="connsiteX171" y="connsiteY171"/>
                            </a:cxn>
                            <a:cxn ang="0">
                              <a:pos x="connsiteX172" y="connsiteY172"/>
                            </a:cxn>
                            <a:cxn ang="0">
                              <a:pos x="connsiteX173" y="connsiteY173"/>
                            </a:cxn>
                            <a:cxn ang="0">
                              <a:pos x="connsiteX174" y="connsiteY174"/>
                            </a:cxn>
                            <a:cxn ang="0">
                              <a:pos x="connsiteX175" y="connsiteY175"/>
                            </a:cxn>
                            <a:cxn ang="0">
                              <a:pos x="connsiteX176" y="connsiteY176"/>
                            </a:cxn>
                            <a:cxn ang="0">
                              <a:pos x="connsiteX177" y="connsiteY177"/>
                            </a:cxn>
                            <a:cxn ang="0">
                              <a:pos x="connsiteX178" y="connsiteY178"/>
                            </a:cxn>
                            <a:cxn ang="0">
                              <a:pos x="connsiteX179" y="connsiteY179"/>
                            </a:cxn>
                            <a:cxn ang="0">
                              <a:pos x="connsiteX180" y="connsiteY180"/>
                            </a:cxn>
                            <a:cxn ang="0">
                              <a:pos x="connsiteX181" y="connsiteY181"/>
                            </a:cxn>
                            <a:cxn ang="0">
                              <a:pos x="connsiteX182" y="connsiteY182"/>
                            </a:cxn>
                            <a:cxn ang="0">
                              <a:pos x="connsiteX183" y="connsiteY183"/>
                            </a:cxn>
                            <a:cxn ang="0">
                              <a:pos x="connsiteX184" y="connsiteY184"/>
                            </a:cxn>
                            <a:cxn ang="0">
                              <a:pos x="connsiteX185" y="connsiteY185"/>
                            </a:cxn>
                            <a:cxn ang="0">
                              <a:pos x="connsiteX186" y="connsiteY186"/>
                            </a:cxn>
                            <a:cxn ang="0">
                              <a:pos x="connsiteX187" y="connsiteY187"/>
                            </a:cxn>
                            <a:cxn ang="0">
                              <a:pos x="connsiteX188" y="connsiteY188"/>
                            </a:cxn>
                            <a:cxn ang="0">
                              <a:pos x="connsiteX189" y="connsiteY189"/>
                            </a:cxn>
                            <a:cxn ang="0">
                              <a:pos x="connsiteX190" y="connsiteY190"/>
                            </a:cxn>
                            <a:cxn ang="0">
                              <a:pos x="connsiteX191" y="connsiteY191"/>
                            </a:cxn>
                            <a:cxn ang="0">
                              <a:pos x="connsiteX192" y="connsiteY192"/>
                            </a:cxn>
                            <a:cxn ang="0">
                              <a:pos x="connsiteX193" y="connsiteY193"/>
                            </a:cxn>
                            <a:cxn ang="0">
                              <a:pos x="connsiteX194" y="connsiteY194"/>
                            </a:cxn>
                            <a:cxn ang="0">
                              <a:pos x="connsiteX195" y="connsiteY195"/>
                            </a:cxn>
                            <a:cxn ang="0">
                              <a:pos x="connsiteX196" y="connsiteY196"/>
                            </a:cxn>
                            <a:cxn ang="0">
                              <a:pos x="connsiteX197" y="connsiteY197"/>
                            </a:cxn>
                            <a:cxn ang="0">
                              <a:pos x="connsiteX198" y="connsiteY198"/>
                            </a:cxn>
                            <a:cxn ang="0">
                              <a:pos x="connsiteX199" y="connsiteY199"/>
                            </a:cxn>
                            <a:cxn ang="0">
                              <a:pos x="connsiteX200" y="connsiteY200"/>
                            </a:cxn>
                            <a:cxn ang="0">
                              <a:pos x="connsiteX201" y="connsiteY201"/>
                            </a:cxn>
                            <a:cxn ang="0">
                              <a:pos x="connsiteX202" y="connsiteY202"/>
                            </a:cxn>
                            <a:cxn ang="0">
                              <a:pos x="connsiteX203" y="connsiteY203"/>
                            </a:cxn>
                            <a:cxn ang="0">
                              <a:pos x="connsiteX204" y="connsiteY204"/>
                            </a:cxn>
                            <a:cxn ang="0">
                              <a:pos x="connsiteX205" y="connsiteY205"/>
                            </a:cxn>
                            <a:cxn ang="0">
                              <a:pos x="connsiteX206" y="connsiteY206"/>
                            </a:cxn>
                            <a:cxn ang="0">
                              <a:pos x="connsiteX207" y="connsiteY207"/>
                            </a:cxn>
                            <a:cxn ang="0">
                              <a:pos x="connsiteX208" y="connsiteY208"/>
                            </a:cxn>
                            <a:cxn ang="0">
                              <a:pos x="connsiteX209" y="connsiteY209"/>
                            </a:cxn>
                            <a:cxn ang="0">
                              <a:pos x="connsiteX210" y="connsiteY210"/>
                            </a:cxn>
                            <a:cxn ang="0">
                              <a:pos x="connsiteX211" y="connsiteY211"/>
                            </a:cxn>
                            <a:cxn ang="0">
                              <a:pos x="connsiteX212" y="connsiteY212"/>
                            </a:cxn>
                            <a:cxn ang="0">
                              <a:pos x="connsiteX213" y="connsiteY213"/>
                            </a:cxn>
                            <a:cxn ang="0">
                              <a:pos x="connsiteX214" y="connsiteY214"/>
                            </a:cxn>
                            <a:cxn ang="0">
                              <a:pos x="connsiteX215" y="connsiteY215"/>
                            </a:cxn>
                            <a:cxn ang="0">
                              <a:pos x="connsiteX216" y="connsiteY216"/>
                            </a:cxn>
                            <a:cxn ang="0">
                              <a:pos x="connsiteX217" y="connsiteY217"/>
                            </a:cxn>
                            <a:cxn ang="0">
                              <a:pos x="connsiteX218" y="connsiteY218"/>
                            </a:cxn>
                            <a:cxn ang="0">
                              <a:pos x="connsiteX219" y="connsiteY219"/>
                            </a:cxn>
                            <a:cxn ang="0">
                              <a:pos x="connsiteX220" y="connsiteY220"/>
                            </a:cxn>
                            <a:cxn ang="0">
                              <a:pos x="connsiteX221" y="connsiteY221"/>
                            </a:cxn>
                            <a:cxn ang="0">
                              <a:pos x="connsiteX222" y="connsiteY222"/>
                            </a:cxn>
                            <a:cxn ang="0">
                              <a:pos x="connsiteX223" y="connsiteY223"/>
                            </a:cxn>
                            <a:cxn ang="0">
                              <a:pos x="connsiteX224" y="connsiteY224"/>
                            </a:cxn>
                            <a:cxn ang="0">
                              <a:pos x="connsiteX225" y="connsiteY225"/>
                            </a:cxn>
                            <a:cxn ang="0">
                              <a:pos x="connsiteX226" y="connsiteY226"/>
                            </a:cxn>
                            <a:cxn ang="0">
                              <a:pos x="connsiteX227" y="connsiteY227"/>
                            </a:cxn>
                            <a:cxn ang="0">
                              <a:pos x="connsiteX228" y="connsiteY228"/>
                            </a:cxn>
                            <a:cxn ang="0">
                              <a:pos x="connsiteX229" y="connsiteY229"/>
                            </a:cxn>
                            <a:cxn ang="0">
                              <a:pos x="connsiteX230" y="connsiteY230"/>
                            </a:cxn>
                            <a:cxn ang="0">
                              <a:pos x="connsiteX231" y="connsiteY231"/>
                            </a:cxn>
                            <a:cxn ang="0">
                              <a:pos x="connsiteX232" y="connsiteY232"/>
                            </a:cxn>
                            <a:cxn ang="0">
                              <a:pos x="connsiteX233" y="connsiteY233"/>
                            </a:cxn>
                            <a:cxn ang="0">
                              <a:pos x="connsiteX234" y="connsiteY234"/>
                            </a:cxn>
                            <a:cxn ang="0">
                              <a:pos x="connsiteX235" y="connsiteY235"/>
                            </a:cxn>
                            <a:cxn ang="0">
                              <a:pos x="connsiteX236" y="connsiteY236"/>
                            </a:cxn>
                            <a:cxn ang="0">
                              <a:pos x="connsiteX237" y="connsiteY237"/>
                            </a:cxn>
                            <a:cxn ang="0">
                              <a:pos x="connsiteX238" y="connsiteY238"/>
                            </a:cxn>
                            <a:cxn ang="0">
                              <a:pos x="connsiteX239" y="connsiteY239"/>
                            </a:cxn>
                            <a:cxn ang="0">
                              <a:pos x="connsiteX240" y="connsiteY240"/>
                            </a:cxn>
                            <a:cxn ang="0">
                              <a:pos x="connsiteX241" y="connsiteY241"/>
                            </a:cxn>
                            <a:cxn ang="0">
                              <a:pos x="connsiteX242" y="connsiteY242"/>
                            </a:cxn>
                            <a:cxn ang="0">
                              <a:pos x="connsiteX243" y="connsiteY243"/>
                            </a:cxn>
                            <a:cxn ang="0">
                              <a:pos x="connsiteX244" y="connsiteY244"/>
                            </a:cxn>
                            <a:cxn ang="0">
                              <a:pos x="connsiteX245" y="connsiteY245"/>
                            </a:cxn>
                            <a:cxn ang="0">
                              <a:pos x="connsiteX246" y="connsiteY246"/>
                            </a:cxn>
                            <a:cxn ang="0">
                              <a:pos x="connsiteX247" y="connsiteY247"/>
                            </a:cxn>
                            <a:cxn ang="0">
                              <a:pos x="connsiteX248" y="connsiteY248"/>
                            </a:cxn>
                            <a:cxn ang="0">
                              <a:pos x="connsiteX249" y="connsiteY249"/>
                            </a:cxn>
                            <a:cxn ang="0">
                              <a:pos x="connsiteX250" y="connsiteY250"/>
                            </a:cxn>
                            <a:cxn ang="0">
                              <a:pos x="connsiteX251" y="connsiteY251"/>
                            </a:cxn>
                            <a:cxn ang="0">
                              <a:pos x="connsiteX252" y="connsiteY252"/>
                            </a:cxn>
                            <a:cxn ang="0">
                              <a:pos x="connsiteX253" y="connsiteY253"/>
                            </a:cxn>
                            <a:cxn ang="0">
                              <a:pos x="connsiteX254" y="connsiteY254"/>
                            </a:cxn>
                            <a:cxn ang="0">
                              <a:pos x="connsiteX255" y="connsiteY255"/>
                            </a:cxn>
                            <a:cxn ang="0">
                              <a:pos x="connsiteX256" y="connsiteY256"/>
                            </a:cxn>
                            <a:cxn ang="0">
                              <a:pos x="connsiteX257" y="connsiteY257"/>
                            </a:cxn>
                            <a:cxn ang="0">
                              <a:pos x="connsiteX258" y="connsiteY258"/>
                            </a:cxn>
                            <a:cxn ang="0">
                              <a:pos x="connsiteX259" y="connsiteY259"/>
                            </a:cxn>
                            <a:cxn ang="0">
                              <a:pos x="connsiteX260" y="connsiteY260"/>
                            </a:cxn>
                            <a:cxn ang="0">
                              <a:pos x="connsiteX261" y="connsiteY261"/>
                            </a:cxn>
                            <a:cxn ang="0">
                              <a:pos x="connsiteX262" y="connsiteY262"/>
                            </a:cxn>
                            <a:cxn ang="0">
                              <a:pos x="connsiteX263" y="connsiteY263"/>
                            </a:cxn>
                            <a:cxn ang="0">
                              <a:pos x="connsiteX264" y="connsiteY264"/>
                            </a:cxn>
                            <a:cxn ang="0">
                              <a:pos x="connsiteX265" y="connsiteY265"/>
                            </a:cxn>
                            <a:cxn ang="0">
                              <a:pos x="connsiteX266" y="connsiteY266"/>
                            </a:cxn>
                            <a:cxn ang="0">
                              <a:pos x="connsiteX267" y="connsiteY267"/>
                            </a:cxn>
                            <a:cxn ang="0">
                              <a:pos x="connsiteX268" y="connsiteY268"/>
                            </a:cxn>
                            <a:cxn ang="0">
                              <a:pos x="connsiteX269" y="connsiteY269"/>
                            </a:cxn>
                            <a:cxn ang="0">
                              <a:pos x="connsiteX270" y="connsiteY270"/>
                            </a:cxn>
                            <a:cxn ang="0">
                              <a:pos x="connsiteX271" y="connsiteY271"/>
                            </a:cxn>
                            <a:cxn ang="0">
                              <a:pos x="connsiteX272" y="connsiteY272"/>
                            </a:cxn>
                            <a:cxn ang="0">
                              <a:pos x="connsiteX273" y="connsiteY273"/>
                            </a:cxn>
                            <a:cxn ang="0">
                              <a:pos x="connsiteX274" y="connsiteY274"/>
                            </a:cxn>
                            <a:cxn ang="0">
                              <a:pos x="connsiteX275" y="connsiteY275"/>
                            </a:cxn>
                            <a:cxn ang="0">
                              <a:pos x="connsiteX276" y="connsiteY276"/>
                            </a:cxn>
                            <a:cxn ang="0">
                              <a:pos x="connsiteX277" y="connsiteY277"/>
                            </a:cxn>
                            <a:cxn ang="0">
                              <a:pos x="connsiteX278" y="connsiteY278"/>
                            </a:cxn>
                            <a:cxn ang="0">
                              <a:pos x="connsiteX279" y="connsiteY279"/>
                            </a:cxn>
                            <a:cxn ang="0">
                              <a:pos x="connsiteX280" y="connsiteY280"/>
                            </a:cxn>
                            <a:cxn ang="0">
                              <a:pos x="connsiteX281" y="connsiteY281"/>
                            </a:cxn>
                            <a:cxn ang="0">
                              <a:pos x="connsiteX282" y="connsiteY282"/>
                            </a:cxn>
                            <a:cxn ang="0">
                              <a:pos x="connsiteX283" y="connsiteY283"/>
                            </a:cxn>
                            <a:cxn ang="0">
                              <a:pos x="connsiteX284" y="connsiteY284"/>
                            </a:cxn>
                            <a:cxn ang="0">
                              <a:pos x="connsiteX285" y="connsiteY285"/>
                            </a:cxn>
                            <a:cxn ang="0">
                              <a:pos x="connsiteX286" y="connsiteY286"/>
                            </a:cxn>
                            <a:cxn ang="0">
                              <a:pos x="connsiteX287" y="connsiteY287"/>
                            </a:cxn>
                            <a:cxn ang="0">
                              <a:pos x="connsiteX288" y="connsiteY288"/>
                            </a:cxn>
                            <a:cxn ang="0">
                              <a:pos x="connsiteX289" y="connsiteY289"/>
                            </a:cxn>
                            <a:cxn ang="0">
                              <a:pos x="connsiteX290" y="connsiteY290"/>
                            </a:cxn>
                            <a:cxn ang="0">
                              <a:pos x="connsiteX291" y="connsiteY291"/>
                            </a:cxn>
                            <a:cxn ang="0">
                              <a:pos x="connsiteX292" y="connsiteY292"/>
                            </a:cxn>
                            <a:cxn ang="0">
                              <a:pos x="connsiteX293" y="connsiteY293"/>
                            </a:cxn>
                            <a:cxn ang="0">
                              <a:pos x="connsiteX294" y="connsiteY294"/>
                            </a:cxn>
                            <a:cxn ang="0">
                              <a:pos x="connsiteX295" y="connsiteY295"/>
                            </a:cxn>
                            <a:cxn ang="0">
                              <a:pos x="connsiteX296" y="connsiteY296"/>
                            </a:cxn>
                            <a:cxn ang="0">
                              <a:pos x="connsiteX297" y="connsiteY297"/>
                            </a:cxn>
                            <a:cxn ang="0">
                              <a:pos x="connsiteX298" y="connsiteY298"/>
                            </a:cxn>
                            <a:cxn ang="0">
                              <a:pos x="connsiteX299" y="connsiteY299"/>
                            </a:cxn>
                            <a:cxn ang="0">
                              <a:pos x="connsiteX300" y="connsiteY300"/>
                            </a:cxn>
                            <a:cxn ang="0">
                              <a:pos x="connsiteX301" y="connsiteY301"/>
                            </a:cxn>
                            <a:cxn ang="0">
                              <a:pos x="connsiteX302" y="connsiteY302"/>
                            </a:cxn>
                            <a:cxn ang="0">
                              <a:pos x="connsiteX303" y="connsiteY303"/>
                            </a:cxn>
                            <a:cxn ang="0">
                              <a:pos x="connsiteX304" y="connsiteY304"/>
                            </a:cxn>
                            <a:cxn ang="0">
                              <a:pos x="connsiteX305" y="connsiteY305"/>
                            </a:cxn>
                            <a:cxn ang="0">
                              <a:pos x="connsiteX306" y="connsiteY306"/>
                            </a:cxn>
                            <a:cxn ang="0">
                              <a:pos x="connsiteX307" y="connsiteY307"/>
                            </a:cxn>
                            <a:cxn ang="0">
                              <a:pos x="connsiteX308" y="connsiteY308"/>
                            </a:cxn>
                            <a:cxn ang="0">
                              <a:pos x="connsiteX309" y="connsiteY309"/>
                            </a:cxn>
                            <a:cxn ang="0">
                              <a:pos x="connsiteX310" y="connsiteY310"/>
                            </a:cxn>
                            <a:cxn ang="0">
                              <a:pos x="connsiteX311" y="connsiteY311"/>
                            </a:cxn>
                            <a:cxn ang="0">
                              <a:pos x="connsiteX312" y="connsiteY312"/>
                            </a:cxn>
                            <a:cxn ang="0">
                              <a:pos x="connsiteX313" y="connsiteY313"/>
                            </a:cxn>
                            <a:cxn ang="0">
                              <a:pos x="connsiteX314" y="connsiteY314"/>
                            </a:cxn>
                            <a:cxn ang="0">
                              <a:pos x="connsiteX315" y="connsiteY315"/>
                            </a:cxn>
                            <a:cxn ang="0">
                              <a:pos x="connsiteX316" y="connsiteY316"/>
                            </a:cxn>
                            <a:cxn ang="0">
                              <a:pos x="connsiteX317" y="connsiteY317"/>
                            </a:cxn>
                            <a:cxn ang="0">
                              <a:pos x="connsiteX318" y="connsiteY318"/>
                            </a:cxn>
                            <a:cxn ang="0">
                              <a:pos x="connsiteX319" y="connsiteY319"/>
                            </a:cxn>
                            <a:cxn ang="0">
                              <a:pos x="connsiteX320" y="connsiteY320"/>
                            </a:cxn>
                            <a:cxn ang="0">
                              <a:pos x="connsiteX321" y="connsiteY321"/>
                            </a:cxn>
                            <a:cxn ang="0">
                              <a:pos x="connsiteX322" y="connsiteY322"/>
                            </a:cxn>
                            <a:cxn ang="0">
                              <a:pos x="connsiteX323" y="connsiteY323"/>
                            </a:cxn>
                            <a:cxn ang="0">
                              <a:pos x="connsiteX324" y="connsiteY324"/>
                            </a:cxn>
                            <a:cxn ang="0">
                              <a:pos x="connsiteX325" y="connsiteY325"/>
                            </a:cxn>
                            <a:cxn ang="0">
                              <a:pos x="connsiteX326" y="connsiteY326"/>
                            </a:cxn>
                            <a:cxn ang="0">
                              <a:pos x="connsiteX327" y="connsiteY327"/>
                            </a:cxn>
                            <a:cxn ang="0">
                              <a:pos x="connsiteX328" y="connsiteY328"/>
                            </a:cxn>
                            <a:cxn ang="0">
                              <a:pos x="connsiteX329" y="connsiteY329"/>
                            </a:cxn>
                            <a:cxn ang="0">
                              <a:pos x="connsiteX330" y="connsiteY330"/>
                            </a:cxn>
                            <a:cxn ang="0">
                              <a:pos x="connsiteX331" y="connsiteY331"/>
                            </a:cxn>
                            <a:cxn ang="0">
                              <a:pos x="connsiteX332" y="connsiteY332"/>
                            </a:cxn>
                            <a:cxn ang="0">
                              <a:pos x="connsiteX333" y="connsiteY333"/>
                            </a:cxn>
                            <a:cxn ang="0">
                              <a:pos x="connsiteX334" y="connsiteY334"/>
                            </a:cxn>
                            <a:cxn ang="0">
                              <a:pos x="connsiteX335" y="connsiteY335"/>
                            </a:cxn>
                            <a:cxn ang="0">
                              <a:pos x="connsiteX336" y="connsiteY336"/>
                            </a:cxn>
                            <a:cxn ang="0">
                              <a:pos x="connsiteX337" y="connsiteY337"/>
                            </a:cxn>
                            <a:cxn ang="0">
                              <a:pos x="connsiteX338" y="connsiteY338"/>
                            </a:cxn>
                            <a:cxn ang="0">
                              <a:pos x="connsiteX339" y="connsiteY339"/>
                            </a:cxn>
                            <a:cxn ang="0">
                              <a:pos x="connsiteX340" y="connsiteY340"/>
                            </a:cxn>
                            <a:cxn ang="0">
                              <a:pos x="connsiteX341" y="connsiteY341"/>
                            </a:cxn>
                            <a:cxn ang="0">
                              <a:pos x="connsiteX342" y="connsiteY342"/>
                            </a:cxn>
                            <a:cxn ang="0">
                              <a:pos x="connsiteX343" y="connsiteY343"/>
                            </a:cxn>
                            <a:cxn ang="0">
                              <a:pos x="connsiteX344" y="connsiteY344"/>
                            </a:cxn>
                            <a:cxn ang="0">
                              <a:pos x="connsiteX345" y="connsiteY345"/>
                            </a:cxn>
                            <a:cxn ang="0">
                              <a:pos x="connsiteX346" y="connsiteY346"/>
                            </a:cxn>
                            <a:cxn ang="0">
                              <a:pos x="connsiteX347" y="connsiteY347"/>
                            </a:cxn>
                            <a:cxn ang="0">
                              <a:pos x="connsiteX348" y="connsiteY348"/>
                            </a:cxn>
                            <a:cxn ang="0">
                              <a:pos x="connsiteX349" y="connsiteY349"/>
                            </a:cxn>
                            <a:cxn ang="0">
                              <a:pos x="connsiteX350" y="connsiteY350"/>
                            </a:cxn>
                            <a:cxn ang="0">
                              <a:pos x="connsiteX351" y="connsiteY351"/>
                            </a:cxn>
                            <a:cxn ang="0">
                              <a:pos x="connsiteX352" y="connsiteY352"/>
                            </a:cxn>
                            <a:cxn ang="0">
                              <a:pos x="connsiteX353" y="connsiteY353"/>
                            </a:cxn>
                            <a:cxn ang="0">
                              <a:pos x="connsiteX354" y="connsiteY354"/>
                            </a:cxn>
                            <a:cxn ang="0">
                              <a:pos x="connsiteX355" y="connsiteY355"/>
                            </a:cxn>
                            <a:cxn ang="0">
                              <a:pos x="connsiteX356" y="connsiteY356"/>
                            </a:cxn>
                            <a:cxn ang="0">
                              <a:pos x="connsiteX357" y="connsiteY357"/>
                            </a:cxn>
                            <a:cxn ang="0">
                              <a:pos x="connsiteX358" y="connsiteY358"/>
                            </a:cxn>
                            <a:cxn ang="0">
                              <a:pos x="connsiteX359" y="connsiteY359"/>
                            </a:cxn>
                            <a:cxn ang="0">
                              <a:pos x="connsiteX360" y="connsiteY360"/>
                            </a:cxn>
                            <a:cxn ang="0">
                              <a:pos x="connsiteX361" y="connsiteY361"/>
                            </a:cxn>
                            <a:cxn ang="0">
                              <a:pos x="connsiteX362" y="connsiteY362"/>
                            </a:cxn>
                            <a:cxn ang="0">
                              <a:pos x="connsiteX363" y="connsiteY363"/>
                            </a:cxn>
                            <a:cxn ang="0">
                              <a:pos x="connsiteX364" y="connsiteY364"/>
                            </a:cxn>
                            <a:cxn ang="0">
                              <a:pos x="connsiteX365" y="connsiteY365"/>
                            </a:cxn>
                            <a:cxn ang="0">
                              <a:pos x="connsiteX366" y="connsiteY366"/>
                            </a:cxn>
                            <a:cxn ang="0">
                              <a:pos x="connsiteX367" y="connsiteY367"/>
                            </a:cxn>
                            <a:cxn ang="0">
                              <a:pos x="connsiteX368" y="connsiteY368"/>
                            </a:cxn>
                            <a:cxn ang="0">
                              <a:pos x="connsiteX369" y="connsiteY369"/>
                            </a:cxn>
                            <a:cxn ang="0">
                              <a:pos x="connsiteX370" y="connsiteY370"/>
                            </a:cxn>
                            <a:cxn ang="0">
                              <a:pos x="connsiteX371" y="connsiteY371"/>
                            </a:cxn>
                            <a:cxn ang="0">
                              <a:pos x="connsiteX372" y="connsiteY372"/>
                            </a:cxn>
                            <a:cxn ang="0">
                              <a:pos x="connsiteX373" y="connsiteY373"/>
                            </a:cxn>
                            <a:cxn ang="0">
                              <a:pos x="connsiteX374" y="connsiteY374"/>
                            </a:cxn>
                            <a:cxn ang="0">
                              <a:pos x="connsiteX375" y="connsiteY375"/>
                            </a:cxn>
                            <a:cxn ang="0">
                              <a:pos x="connsiteX376" y="connsiteY376"/>
                            </a:cxn>
                            <a:cxn ang="0">
                              <a:pos x="connsiteX377" y="connsiteY377"/>
                            </a:cxn>
                            <a:cxn ang="0">
                              <a:pos x="connsiteX378" y="connsiteY378"/>
                            </a:cxn>
                            <a:cxn ang="0">
                              <a:pos x="connsiteX379" y="connsiteY379"/>
                            </a:cxn>
                            <a:cxn ang="0">
                              <a:pos x="connsiteX380" y="connsiteY380"/>
                            </a:cxn>
                            <a:cxn ang="0">
                              <a:pos x="connsiteX381" y="connsiteY381"/>
                            </a:cxn>
                            <a:cxn ang="0">
                              <a:pos x="connsiteX382" y="connsiteY382"/>
                            </a:cxn>
                            <a:cxn ang="0">
                              <a:pos x="connsiteX383" y="connsiteY383"/>
                            </a:cxn>
                            <a:cxn ang="0">
                              <a:pos x="connsiteX384" y="connsiteY384"/>
                            </a:cxn>
                            <a:cxn ang="0">
                              <a:pos x="connsiteX385" y="connsiteY385"/>
                            </a:cxn>
                            <a:cxn ang="0">
                              <a:pos x="connsiteX386" y="connsiteY386"/>
                            </a:cxn>
                            <a:cxn ang="0">
                              <a:pos x="connsiteX387" y="connsiteY387"/>
                            </a:cxn>
                            <a:cxn ang="0">
                              <a:pos x="connsiteX388" y="connsiteY388"/>
                            </a:cxn>
                            <a:cxn ang="0">
                              <a:pos x="connsiteX389" y="connsiteY389"/>
                            </a:cxn>
                            <a:cxn ang="0">
                              <a:pos x="connsiteX390" y="connsiteY390"/>
                            </a:cxn>
                            <a:cxn ang="0">
                              <a:pos x="connsiteX391" y="connsiteY391"/>
                            </a:cxn>
                            <a:cxn ang="0">
                              <a:pos x="connsiteX392" y="connsiteY392"/>
                            </a:cxn>
                            <a:cxn ang="0">
                              <a:pos x="connsiteX393" y="connsiteY393"/>
                            </a:cxn>
                            <a:cxn ang="0">
                              <a:pos x="connsiteX394" y="connsiteY394"/>
                            </a:cxn>
                            <a:cxn ang="0">
                              <a:pos x="connsiteX395" y="connsiteY395"/>
                            </a:cxn>
                            <a:cxn ang="0">
                              <a:pos x="connsiteX396" y="connsiteY396"/>
                            </a:cxn>
                            <a:cxn ang="0">
                              <a:pos x="connsiteX397" y="connsiteY397"/>
                            </a:cxn>
                            <a:cxn ang="0">
                              <a:pos x="connsiteX398" y="connsiteY398"/>
                            </a:cxn>
                            <a:cxn ang="0">
                              <a:pos x="connsiteX399" y="connsiteY399"/>
                            </a:cxn>
                            <a:cxn ang="0">
                              <a:pos x="connsiteX400" y="connsiteY400"/>
                            </a:cxn>
                            <a:cxn ang="0">
                              <a:pos x="connsiteX401" y="connsiteY401"/>
                            </a:cxn>
                            <a:cxn ang="0">
                              <a:pos x="connsiteX402" y="connsiteY402"/>
                            </a:cxn>
                            <a:cxn ang="0">
                              <a:pos x="connsiteX403" y="connsiteY403"/>
                            </a:cxn>
                            <a:cxn ang="0">
                              <a:pos x="connsiteX404" y="connsiteY404"/>
                            </a:cxn>
                            <a:cxn ang="0">
                              <a:pos x="connsiteX405" y="connsiteY405"/>
                            </a:cxn>
                            <a:cxn ang="0">
                              <a:pos x="connsiteX406" y="connsiteY406"/>
                            </a:cxn>
                            <a:cxn ang="0">
                              <a:pos x="connsiteX407" y="connsiteY407"/>
                            </a:cxn>
                            <a:cxn ang="0">
                              <a:pos x="connsiteX408" y="connsiteY408"/>
                            </a:cxn>
                            <a:cxn ang="0">
                              <a:pos x="connsiteX409" y="connsiteY409"/>
                            </a:cxn>
                            <a:cxn ang="0">
                              <a:pos x="connsiteX410" y="connsiteY410"/>
                            </a:cxn>
                            <a:cxn ang="0">
                              <a:pos x="connsiteX411" y="connsiteY411"/>
                            </a:cxn>
                            <a:cxn ang="0">
                              <a:pos x="connsiteX412" y="connsiteY412"/>
                            </a:cxn>
                            <a:cxn ang="0">
                              <a:pos x="connsiteX413" y="connsiteY413"/>
                            </a:cxn>
                            <a:cxn ang="0">
                              <a:pos x="connsiteX414" y="connsiteY414"/>
                            </a:cxn>
                            <a:cxn ang="0">
                              <a:pos x="connsiteX415" y="connsiteY415"/>
                            </a:cxn>
                            <a:cxn ang="0">
                              <a:pos x="connsiteX416" y="connsiteY416"/>
                            </a:cxn>
                            <a:cxn ang="0">
                              <a:pos x="connsiteX417" y="connsiteY417"/>
                            </a:cxn>
                            <a:cxn ang="0">
                              <a:pos x="connsiteX418" y="connsiteY418"/>
                            </a:cxn>
                            <a:cxn ang="0">
                              <a:pos x="connsiteX419" y="connsiteY419"/>
                            </a:cxn>
                            <a:cxn ang="0">
                              <a:pos x="connsiteX420" y="connsiteY420"/>
                            </a:cxn>
                            <a:cxn ang="0">
                              <a:pos x="connsiteX421" y="connsiteY421"/>
                            </a:cxn>
                            <a:cxn ang="0">
                              <a:pos x="connsiteX422" y="connsiteY422"/>
                            </a:cxn>
                            <a:cxn ang="0">
                              <a:pos x="connsiteX423" y="connsiteY423"/>
                            </a:cxn>
                            <a:cxn ang="0">
                              <a:pos x="connsiteX424" y="connsiteY424"/>
                            </a:cxn>
                          </a:cxnLst>
                          <a:rect l="l" t="t" r="r" b="b"/>
                          <a:pathLst>
                            <a:path w="2994958" h="3036014" fill="none" extrusionOk="0">
                              <a:moveTo>
                                <a:pt x="1258585" y="1135295"/>
                              </a:moveTo>
                              <a:cubicBezTo>
                                <a:pt x="1259515" y="1132502"/>
                                <a:pt x="1250955" y="1117839"/>
                                <a:pt x="1248311" y="1109609"/>
                              </a:cubicBezTo>
                              <a:cubicBezTo>
                                <a:pt x="1244454" y="1101795"/>
                                <a:pt x="1226156" y="1078317"/>
                                <a:pt x="1222625" y="1073650"/>
                              </a:cubicBezTo>
                              <a:cubicBezTo>
                                <a:pt x="1219753" y="1068577"/>
                                <a:pt x="1217091" y="1063099"/>
                                <a:pt x="1212351" y="1058239"/>
                              </a:cubicBezTo>
                              <a:cubicBezTo>
                                <a:pt x="1207251" y="1054735"/>
                                <a:pt x="1202812" y="1052035"/>
                                <a:pt x="1196940" y="1047964"/>
                              </a:cubicBezTo>
                              <a:cubicBezTo>
                                <a:pt x="1195700" y="1041523"/>
                                <a:pt x="1194598" y="1033292"/>
                                <a:pt x="1191803" y="1027416"/>
                              </a:cubicBezTo>
                              <a:cubicBezTo>
                                <a:pt x="1188552" y="1017251"/>
                                <a:pt x="1181115" y="1010409"/>
                                <a:pt x="1176391" y="1001731"/>
                              </a:cubicBezTo>
                              <a:cubicBezTo>
                                <a:pt x="1169133" y="985080"/>
                                <a:pt x="1161238" y="970878"/>
                                <a:pt x="1155843" y="955497"/>
                              </a:cubicBezTo>
                              <a:cubicBezTo>
                                <a:pt x="1154774" y="956227"/>
                                <a:pt x="1144376" y="917590"/>
                                <a:pt x="1140432" y="909263"/>
                              </a:cubicBezTo>
                              <a:cubicBezTo>
                                <a:pt x="1137018" y="897276"/>
                                <a:pt x="1135578" y="888313"/>
                                <a:pt x="1130158" y="878441"/>
                              </a:cubicBezTo>
                              <a:cubicBezTo>
                                <a:pt x="1124507" y="871133"/>
                                <a:pt x="1119156" y="865232"/>
                                <a:pt x="1114746" y="857893"/>
                              </a:cubicBezTo>
                              <a:cubicBezTo>
                                <a:pt x="1088515" y="812298"/>
                                <a:pt x="1113881" y="843327"/>
                                <a:pt x="1094198" y="811659"/>
                              </a:cubicBezTo>
                              <a:cubicBezTo>
                                <a:pt x="1070803" y="782785"/>
                                <a:pt x="1082991" y="805991"/>
                                <a:pt x="1068513" y="770562"/>
                              </a:cubicBezTo>
                              <a:cubicBezTo>
                                <a:pt x="1060498" y="752643"/>
                                <a:pt x="1064624" y="750170"/>
                                <a:pt x="1053102" y="729466"/>
                              </a:cubicBezTo>
                              <a:cubicBezTo>
                                <a:pt x="1049953" y="725852"/>
                                <a:pt x="1046415" y="723219"/>
                                <a:pt x="1042827" y="719191"/>
                              </a:cubicBezTo>
                              <a:cubicBezTo>
                                <a:pt x="1037869" y="713870"/>
                                <a:pt x="1036009" y="709631"/>
                                <a:pt x="1032553" y="703780"/>
                              </a:cubicBezTo>
                              <a:cubicBezTo>
                                <a:pt x="1028828" y="696834"/>
                                <a:pt x="1025887" y="689221"/>
                                <a:pt x="1022279" y="683232"/>
                              </a:cubicBezTo>
                              <a:cubicBezTo>
                                <a:pt x="1018661" y="677719"/>
                                <a:pt x="1014426" y="672239"/>
                                <a:pt x="1012005" y="667821"/>
                              </a:cubicBezTo>
                              <a:cubicBezTo>
                                <a:pt x="1009703" y="661058"/>
                                <a:pt x="1005146" y="654036"/>
                                <a:pt x="1001731" y="647272"/>
                              </a:cubicBezTo>
                              <a:cubicBezTo>
                                <a:pt x="998872" y="642809"/>
                                <a:pt x="994351" y="636337"/>
                                <a:pt x="991457" y="631861"/>
                              </a:cubicBezTo>
                              <a:cubicBezTo>
                                <a:pt x="954647" y="557389"/>
                                <a:pt x="983022" y="583582"/>
                                <a:pt x="950360" y="554805"/>
                              </a:cubicBezTo>
                              <a:cubicBezTo>
                                <a:pt x="946389" y="544600"/>
                                <a:pt x="945824" y="537863"/>
                                <a:pt x="940086" y="529120"/>
                              </a:cubicBezTo>
                              <a:cubicBezTo>
                                <a:pt x="934713" y="521060"/>
                                <a:pt x="919536" y="508571"/>
                                <a:pt x="919537" y="508571"/>
                              </a:cubicBezTo>
                              <a:cubicBezTo>
                                <a:pt x="915400" y="498029"/>
                                <a:pt x="908978" y="489232"/>
                                <a:pt x="904126" y="477749"/>
                              </a:cubicBezTo>
                              <a:cubicBezTo>
                                <a:pt x="897670" y="461318"/>
                                <a:pt x="901901" y="456130"/>
                                <a:pt x="893852" y="441789"/>
                              </a:cubicBezTo>
                              <a:cubicBezTo>
                                <a:pt x="891015" y="436287"/>
                                <a:pt x="886006" y="431431"/>
                                <a:pt x="883578" y="426378"/>
                              </a:cubicBezTo>
                              <a:cubicBezTo>
                                <a:pt x="879119" y="418008"/>
                                <a:pt x="873087" y="408630"/>
                                <a:pt x="868167" y="400693"/>
                              </a:cubicBezTo>
                              <a:cubicBezTo>
                                <a:pt x="853549" y="354530"/>
                                <a:pt x="877564" y="403550"/>
                                <a:pt x="852755" y="369870"/>
                              </a:cubicBezTo>
                              <a:cubicBezTo>
                                <a:pt x="845953" y="360244"/>
                                <a:pt x="842862" y="350374"/>
                                <a:pt x="837344" y="339048"/>
                              </a:cubicBezTo>
                              <a:cubicBezTo>
                                <a:pt x="832657" y="329277"/>
                                <a:pt x="827462" y="320975"/>
                                <a:pt x="821933" y="313362"/>
                              </a:cubicBezTo>
                              <a:cubicBezTo>
                                <a:pt x="819612" y="309568"/>
                                <a:pt x="819932" y="303181"/>
                                <a:pt x="816796" y="297951"/>
                              </a:cubicBezTo>
                              <a:cubicBezTo>
                                <a:pt x="811842" y="289018"/>
                                <a:pt x="808120" y="281441"/>
                                <a:pt x="801385" y="272266"/>
                              </a:cubicBezTo>
                              <a:cubicBezTo>
                                <a:pt x="800428" y="262143"/>
                                <a:pt x="800052" y="251657"/>
                                <a:pt x="796248" y="241443"/>
                              </a:cubicBezTo>
                              <a:cubicBezTo>
                                <a:pt x="795178" y="236850"/>
                                <a:pt x="790630" y="231981"/>
                                <a:pt x="791111" y="226032"/>
                              </a:cubicBezTo>
                              <a:cubicBezTo>
                                <a:pt x="791319" y="189211"/>
                                <a:pt x="791950" y="180392"/>
                                <a:pt x="811659" y="154113"/>
                              </a:cubicBezTo>
                              <a:cubicBezTo>
                                <a:pt x="815876" y="148251"/>
                                <a:pt x="821561" y="142299"/>
                                <a:pt x="827070" y="138702"/>
                              </a:cubicBezTo>
                              <a:cubicBezTo>
                                <a:pt x="831375" y="135569"/>
                                <a:pt x="837727" y="135333"/>
                                <a:pt x="842481" y="133564"/>
                              </a:cubicBezTo>
                              <a:cubicBezTo>
                                <a:pt x="849217" y="130224"/>
                                <a:pt x="856451" y="127481"/>
                                <a:pt x="863030" y="123290"/>
                              </a:cubicBezTo>
                              <a:cubicBezTo>
                                <a:pt x="871028" y="118883"/>
                                <a:pt x="879942" y="110160"/>
                                <a:pt x="888715" y="107879"/>
                              </a:cubicBezTo>
                              <a:cubicBezTo>
                                <a:pt x="895679" y="104858"/>
                                <a:pt x="902382" y="104858"/>
                                <a:pt x="909263" y="102742"/>
                              </a:cubicBezTo>
                              <a:cubicBezTo>
                                <a:pt x="921346" y="100928"/>
                                <a:pt x="928238" y="94231"/>
                                <a:pt x="940086" y="92468"/>
                              </a:cubicBezTo>
                              <a:cubicBezTo>
                                <a:pt x="948655" y="89844"/>
                                <a:pt x="957645" y="91124"/>
                                <a:pt x="965771" y="87331"/>
                              </a:cubicBezTo>
                              <a:cubicBezTo>
                                <a:pt x="979640" y="82657"/>
                                <a:pt x="996890" y="79048"/>
                                <a:pt x="1012005" y="71920"/>
                              </a:cubicBezTo>
                              <a:cubicBezTo>
                                <a:pt x="1018972" y="68358"/>
                                <a:pt x="1024470" y="62651"/>
                                <a:pt x="1032553" y="61645"/>
                              </a:cubicBezTo>
                              <a:cubicBezTo>
                                <a:pt x="1042689" y="57685"/>
                                <a:pt x="1052747" y="59600"/>
                                <a:pt x="1063376" y="56508"/>
                              </a:cubicBezTo>
                              <a:cubicBezTo>
                                <a:pt x="1071850" y="55364"/>
                                <a:pt x="1079134" y="51811"/>
                                <a:pt x="1089061" y="51371"/>
                              </a:cubicBezTo>
                              <a:cubicBezTo>
                                <a:pt x="1109986" y="44599"/>
                                <a:pt x="1141427" y="48999"/>
                                <a:pt x="1160980" y="41097"/>
                              </a:cubicBezTo>
                              <a:cubicBezTo>
                                <a:pt x="1169990" y="38718"/>
                                <a:pt x="1178180" y="32931"/>
                                <a:pt x="1186666" y="30823"/>
                              </a:cubicBezTo>
                              <a:cubicBezTo>
                                <a:pt x="1195809" y="27338"/>
                                <a:pt x="1207529" y="26409"/>
                                <a:pt x="1217488" y="25686"/>
                              </a:cubicBezTo>
                              <a:cubicBezTo>
                                <a:pt x="1223842" y="25207"/>
                                <a:pt x="1231926" y="22802"/>
                                <a:pt x="1238036" y="20549"/>
                              </a:cubicBezTo>
                              <a:cubicBezTo>
                                <a:pt x="1243476" y="18976"/>
                                <a:pt x="1248640" y="15985"/>
                                <a:pt x="1253448" y="15412"/>
                              </a:cubicBezTo>
                              <a:cubicBezTo>
                                <a:pt x="1315478" y="4351"/>
                                <a:pt x="1330725" y="5635"/>
                                <a:pt x="1392149" y="0"/>
                              </a:cubicBezTo>
                              <a:cubicBezTo>
                                <a:pt x="1499718" y="-14492"/>
                                <a:pt x="1609153" y="24519"/>
                                <a:pt x="1643866" y="5138"/>
                              </a:cubicBezTo>
                              <a:cubicBezTo>
                                <a:pt x="1657261" y="4111"/>
                                <a:pt x="1667251" y="10738"/>
                                <a:pt x="1679825" y="10275"/>
                              </a:cubicBezTo>
                              <a:cubicBezTo>
                                <a:pt x="1696676" y="13921"/>
                                <a:pt x="1715787" y="16212"/>
                                <a:pt x="1731196" y="15412"/>
                              </a:cubicBezTo>
                              <a:cubicBezTo>
                                <a:pt x="1739275" y="19120"/>
                                <a:pt x="1748312" y="23357"/>
                                <a:pt x="1756881" y="25686"/>
                              </a:cubicBezTo>
                              <a:cubicBezTo>
                                <a:pt x="1765382" y="29426"/>
                                <a:pt x="1775168" y="28038"/>
                                <a:pt x="1782567" y="30823"/>
                              </a:cubicBezTo>
                              <a:cubicBezTo>
                                <a:pt x="1786975" y="32380"/>
                                <a:pt x="1793223" y="35290"/>
                                <a:pt x="1797978" y="35960"/>
                              </a:cubicBezTo>
                              <a:cubicBezTo>
                                <a:pt x="1806396" y="37273"/>
                                <a:pt x="1818670" y="39476"/>
                                <a:pt x="1828800" y="41097"/>
                              </a:cubicBezTo>
                              <a:cubicBezTo>
                                <a:pt x="1857077" y="47374"/>
                                <a:pt x="1846715" y="47093"/>
                                <a:pt x="1880171" y="56508"/>
                              </a:cubicBezTo>
                              <a:cubicBezTo>
                                <a:pt x="1906321" y="66153"/>
                                <a:pt x="1939379" y="66068"/>
                                <a:pt x="1967502" y="66782"/>
                              </a:cubicBezTo>
                              <a:cubicBezTo>
                                <a:pt x="2008226" y="89129"/>
                                <a:pt x="1973425" y="73611"/>
                                <a:pt x="2034284" y="82194"/>
                              </a:cubicBezTo>
                              <a:cubicBezTo>
                                <a:pt x="2047181" y="83151"/>
                                <a:pt x="2076862" y="94550"/>
                                <a:pt x="2085654" y="97605"/>
                              </a:cubicBezTo>
                              <a:cubicBezTo>
                                <a:pt x="2092960" y="100180"/>
                                <a:pt x="2102611" y="103414"/>
                                <a:pt x="2111340" y="107879"/>
                              </a:cubicBezTo>
                              <a:cubicBezTo>
                                <a:pt x="2115870" y="111364"/>
                                <a:pt x="2121483" y="114990"/>
                                <a:pt x="2126751" y="118153"/>
                              </a:cubicBezTo>
                              <a:cubicBezTo>
                                <a:pt x="2134184" y="122477"/>
                                <a:pt x="2141753" y="123611"/>
                                <a:pt x="2147299" y="128427"/>
                              </a:cubicBezTo>
                              <a:cubicBezTo>
                                <a:pt x="2153125" y="132754"/>
                                <a:pt x="2156658" y="139602"/>
                                <a:pt x="2162711" y="143839"/>
                              </a:cubicBezTo>
                              <a:cubicBezTo>
                                <a:pt x="2182138" y="159703"/>
                                <a:pt x="2182694" y="151627"/>
                                <a:pt x="2208944" y="169524"/>
                              </a:cubicBezTo>
                              <a:cubicBezTo>
                                <a:pt x="2214853" y="172211"/>
                                <a:pt x="2217354" y="180175"/>
                                <a:pt x="2224355" y="184935"/>
                              </a:cubicBezTo>
                              <a:cubicBezTo>
                                <a:pt x="2229321" y="188708"/>
                                <a:pt x="2235138" y="190671"/>
                                <a:pt x="2239767" y="195209"/>
                              </a:cubicBezTo>
                              <a:cubicBezTo>
                                <a:pt x="2245610" y="201032"/>
                                <a:pt x="2253200" y="207461"/>
                                <a:pt x="2260315" y="210621"/>
                              </a:cubicBezTo>
                              <a:cubicBezTo>
                                <a:pt x="2270042" y="217481"/>
                                <a:pt x="2278862" y="220872"/>
                                <a:pt x="2286000" y="226032"/>
                              </a:cubicBezTo>
                              <a:cubicBezTo>
                                <a:pt x="2290968" y="229106"/>
                                <a:pt x="2296829" y="233022"/>
                                <a:pt x="2301412" y="236306"/>
                              </a:cubicBezTo>
                              <a:cubicBezTo>
                                <a:pt x="2308102" y="239829"/>
                                <a:pt x="2314459" y="242973"/>
                                <a:pt x="2321960" y="246580"/>
                              </a:cubicBezTo>
                              <a:cubicBezTo>
                                <a:pt x="2329782" y="252466"/>
                                <a:pt x="2339039" y="261076"/>
                                <a:pt x="2347645" y="267129"/>
                              </a:cubicBezTo>
                              <a:cubicBezTo>
                                <a:pt x="2351494" y="270196"/>
                                <a:pt x="2353939" y="274227"/>
                                <a:pt x="2357920" y="277403"/>
                              </a:cubicBezTo>
                              <a:cubicBezTo>
                                <a:pt x="2366953" y="283904"/>
                                <a:pt x="2375193" y="285504"/>
                                <a:pt x="2383605" y="292814"/>
                              </a:cubicBezTo>
                              <a:cubicBezTo>
                                <a:pt x="2391660" y="297504"/>
                                <a:pt x="2400302" y="306637"/>
                                <a:pt x="2409290" y="313362"/>
                              </a:cubicBezTo>
                              <a:cubicBezTo>
                                <a:pt x="2419469" y="320853"/>
                                <a:pt x="2431873" y="326353"/>
                                <a:pt x="2440113" y="333911"/>
                              </a:cubicBezTo>
                              <a:cubicBezTo>
                                <a:pt x="2447037" y="339771"/>
                                <a:pt x="2451852" y="347720"/>
                                <a:pt x="2460661" y="354459"/>
                              </a:cubicBezTo>
                              <a:cubicBezTo>
                                <a:pt x="2467023" y="360485"/>
                                <a:pt x="2473593" y="363722"/>
                                <a:pt x="2481209" y="369870"/>
                              </a:cubicBezTo>
                              <a:cubicBezTo>
                                <a:pt x="2492688" y="376781"/>
                                <a:pt x="2502142" y="388930"/>
                                <a:pt x="2512032" y="395555"/>
                              </a:cubicBezTo>
                              <a:cubicBezTo>
                                <a:pt x="2517206" y="399705"/>
                                <a:pt x="2522610" y="402683"/>
                                <a:pt x="2527443" y="405830"/>
                              </a:cubicBezTo>
                              <a:cubicBezTo>
                                <a:pt x="2531904" y="410569"/>
                                <a:pt x="2537243" y="417749"/>
                                <a:pt x="2542854" y="421241"/>
                              </a:cubicBezTo>
                              <a:cubicBezTo>
                                <a:pt x="2552023" y="427933"/>
                                <a:pt x="2559722" y="434499"/>
                                <a:pt x="2568540" y="441789"/>
                              </a:cubicBezTo>
                              <a:cubicBezTo>
                                <a:pt x="2575920" y="448150"/>
                                <a:pt x="2582420" y="455329"/>
                                <a:pt x="2589088" y="462338"/>
                              </a:cubicBezTo>
                              <a:cubicBezTo>
                                <a:pt x="2595610" y="467130"/>
                                <a:pt x="2602292" y="471633"/>
                                <a:pt x="2609636" y="477749"/>
                              </a:cubicBezTo>
                              <a:cubicBezTo>
                                <a:pt x="2613505" y="480905"/>
                                <a:pt x="2616373" y="484976"/>
                                <a:pt x="2619911" y="488023"/>
                              </a:cubicBezTo>
                              <a:cubicBezTo>
                                <a:pt x="2624608" y="492682"/>
                                <a:pt x="2631608" y="494555"/>
                                <a:pt x="2635322" y="498297"/>
                              </a:cubicBezTo>
                              <a:cubicBezTo>
                                <a:pt x="2643566" y="505333"/>
                                <a:pt x="2651259" y="512246"/>
                                <a:pt x="2661007" y="518845"/>
                              </a:cubicBezTo>
                              <a:cubicBezTo>
                                <a:pt x="2677495" y="546418"/>
                                <a:pt x="2653224" y="517070"/>
                                <a:pt x="2686693" y="549668"/>
                              </a:cubicBezTo>
                              <a:cubicBezTo>
                                <a:pt x="2713969" y="588961"/>
                                <a:pt x="2674751" y="553634"/>
                                <a:pt x="2712378" y="580490"/>
                              </a:cubicBezTo>
                              <a:cubicBezTo>
                                <a:pt x="2714285" y="584969"/>
                                <a:pt x="2718683" y="590376"/>
                                <a:pt x="2717515" y="595902"/>
                              </a:cubicBezTo>
                              <a:cubicBezTo>
                                <a:pt x="2715663" y="605302"/>
                                <a:pt x="2689387" y="629490"/>
                                <a:pt x="2686693" y="631861"/>
                              </a:cubicBezTo>
                              <a:cubicBezTo>
                                <a:pt x="2682636" y="636075"/>
                                <a:pt x="2676169" y="638661"/>
                                <a:pt x="2671281" y="642135"/>
                              </a:cubicBezTo>
                              <a:cubicBezTo>
                                <a:pt x="2665547" y="647247"/>
                                <a:pt x="2661411" y="652148"/>
                                <a:pt x="2655870" y="657546"/>
                              </a:cubicBezTo>
                              <a:cubicBezTo>
                                <a:pt x="2648660" y="663103"/>
                                <a:pt x="2618887" y="680755"/>
                                <a:pt x="2614773" y="683232"/>
                              </a:cubicBezTo>
                              <a:cubicBezTo>
                                <a:pt x="2599319" y="714592"/>
                                <a:pt x="2614459" y="689558"/>
                                <a:pt x="2573677" y="714054"/>
                              </a:cubicBezTo>
                              <a:cubicBezTo>
                                <a:pt x="2566188" y="717985"/>
                                <a:pt x="2560693" y="725466"/>
                                <a:pt x="2553129" y="729466"/>
                              </a:cubicBezTo>
                              <a:cubicBezTo>
                                <a:pt x="2544925" y="734227"/>
                                <a:pt x="2536726" y="734879"/>
                                <a:pt x="2527443" y="739740"/>
                              </a:cubicBezTo>
                              <a:cubicBezTo>
                                <a:pt x="2518495" y="743080"/>
                                <a:pt x="2512296" y="749783"/>
                                <a:pt x="2501758" y="755151"/>
                              </a:cubicBezTo>
                              <a:cubicBezTo>
                                <a:pt x="2496537" y="757635"/>
                                <a:pt x="2491602" y="757311"/>
                                <a:pt x="2486346" y="760288"/>
                              </a:cubicBezTo>
                              <a:cubicBezTo>
                                <a:pt x="2466112" y="768618"/>
                                <a:pt x="2452428" y="780788"/>
                                <a:pt x="2434976" y="791111"/>
                              </a:cubicBezTo>
                              <a:cubicBezTo>
                                <a:pt x="2427985" y="794598"/>
                                <a:pt x="2420654" y="797310"/>
                                <a:pt x="2414427" y="801385"/>
                              </a:cubicBezTo>
                              <a:cubicBezTo>
                                <a:pt x="2406589" y="806801"/>
                                <a:pt x="2401926" y="811678"/>
                                <a:pt x="2393879" y="816796"/>
                              </a:cubicBezTo>
                              <a:cubicBezTo>
                                <a:pt x="2387355" y="819472"/>
                                <a:pt x="2379901" y="823047"/>
                                <a:pt x="2373331" y="827070"/>
                              </a:cubicBezTo>
                              <a:cubicBezTo>
                                <a:pt x="2337610" y="848309"/>
                                <a:pt x="2373140" y="842880"/>
                                <a:pt x="2342508" y="847618"/>
                              </a:cubicBezTo>
                              <a:cubicBezTo>
                                <a:pt x="2337283" y="855408"/>
                                <a:pt x="2329840" y="862602"/>
                                <a:pt x="2321960" y="868167"/>
                              </a:cubicBezTo>
                              <a:cubicBezTo>
                                <a:pt x="2298542" y="888420"/>
                                <a:pt x="2286789" y="893148"/>
                                <a:pt x="2265452" y="909263"/>
                              </a:cubicBezTo>
                              <a:cubicBezTo>
                                <a:pt x="2255456" y="923955"/>
                                <a:pt x="2254278" y="927791"/>
                                <a:pt x="2239767" y="940086"/>
                              </a:cubicBezTo>
                              <a:cubicBezTo>
                                <a:pt x="2226514" y="950929"/>
                                <a:pt x="2198670" y="970908"/>
                                <a:pt x="2198670" y="970908"/>
                              </a:cubicBezTo>
                              <a:cubicBezTo>
                                <a:pt x="2185622" y="990520"/>
                                <a:pt x="2187160" y="991435"/>
                                <a:pt x="2162711" y="1006868"/>
                              </a:cubicBezTo>
                              <a:cubicBezTo>
                                <a:pt x="2158579" y="1009341"/>
                                <a:pt x="2152492" y="1010358"/>
                                <a:pt x="2147299" y="1012005"/>
                              </a:cubicBezTo>
                              <a:cubicBezTo>
                                <a:pt x="2143319" y="1017662"/>
                                <a:pt x="2137947" y="1022741"/>
                                <a:pt x="2131888" y="1027416"/>
                              </a:cubicBezTo>
                              <a:cubicBezTo>
                                <a:pt x="2124571" y="1031777"/>
                                <a:pt x="2117694" y="1031568"/>
                                <a:pt x="2111340" y="1037690"/>
                              </a:cubicBezTo>
                              <a:cubicBezTo>
                                <a:pt x="2079965" y="1063859"/>
                                <a:pt x="2120927" y="1044887"/>
                                <a:pt x="2085654" y="1058239"/>
                              </a:cubicBezTo>
                              <a:cubicBezTo>
                                <a:pt x="2080498" y="1061551"/>
                                <a:pt x="2074398" y="1064154"/>
                                <a:pt x="2070243" y="1068513"/>
                              </a:cubicBezTo>
                              <a:cubicBezTo>
                                <a:pt x="2065721" y="1072943"/>
                                <a:pt x="2065443" y="1080261"/>
                                <a:pt x="2059969" y="1083924"/>
                              </a:cubicBezTo>
                              <a:cubicBezTo>
                                <a:pt x="2055550" y="1087493"/>
                                <a:pt x="2049760" y="1087233"/>
                                <a:pt x="2044558" y="1089061"/>
                              </a:cubicBezTo>
                              <a:cubicBezTo>
                                <a:pt x="2037328" y="1094168"/>
                                <a:pt x="2029984" y="1098443"/>
                                <a:pt x="2024009" y="1104472"/>
                              </a:cubicBezTo>
                              <a:cubicBezTo>
                                <a:pt x="2018318" y="1107834"/>
                                <a:pt x="2015247" y="1116224"/>
                                <a:pt x="2008598" y="1119884"/>
                              </a:cubicBezTo>
                              <a:cubicBezTo>
                                <a:pt x="2003085" y="1123130"/>
                                <a:pt x="1999079" y="1123554"/>
                                <a:pt x="1993187" y="1125021"/>
                              </a:cubicBezTo>
                              <a:cubicBezTo>
                                <a:pt x="1987681" y="1130565"/>
                                <a:pt x="1984427" y="1139685"/>
                                <a:pt x="1977776" y="1145569"/>
                              </a:cubicBezTo>
                              <a:cubicBezTo>
                                <a:pt x="1971968" y="1150049"/>
                                <a:pt x="1963508" y="1149756"/>
                                <a:pt x="1957227" y="1155843"/>
                              </a:cubicBezTo>
                              <a:cubicBezTo>
                                <a:pt x="1926942" y="1193084"/>
                                <a:pt x="1971537" y="1171683"/>
                                <a:pt x="1931542" y="1181529"/>
                              </a:cubicBezTo>
                              <a:cubicBezTo>
                                <a:pt x="1917514" y="1193832"/>
                                <a:pt x="1908071" y="1215924"/>
                                <a:pt x="1890445" y="1222625"/>
                              </a:cubicBezTo>
                              <a:cubicBezTo>
                                <a:pt x="1873784" y="1231592"/>
                                <a:pt x="1858029" y="1239369"/>
                                <a:pt x="1844212" y="1253448"/>
                              </a:cubicBezTo>
                              <a:cubicBezTo>
                                <a:pt x="1841084" y="1259051"/>
                                <a:pt x="1837678" y="1263254"/>
                                <a:pt x="1833937" y="1268859"/>
                              </a:cubicBezTo>
                              <a:cubicBezTo>
                                <a:pt x="1838088" y="1272107"/>
                                <a:pt x="1840417" y="1276468"/>
                                <a:pt x="1844212" y="1279133"/>
                              </a:cubicBezTo>
                              <a:cubicBezTo>
                                <a:pt x="1863902" y="1291760"/>
                                <a:pt x="1887944" y="1278451"/>
                                <a:pt x="1905857" y="1273996"/>
                              </a:cubicBezTo>
                              <a:cubicBezTo>
                                <a:pt x="1967579" y="1247554"/>
                                <a:pt x="1914819" y="1272279"/>
                                <a:pt x="1972639" y="1253448"/>
                              </a:cubicBezTo>
                              <a:cubicBezTo>
                                <a:pt x="1981775" y="1250107"/>
                                <a:pt x="1992939" y="1244015"/>
                                <a:pt x="2003461" y="1243173"/>
                              </a:cubicBezTo>
                              <a:cubicBezTo>
                                <a:pt x="2021802" y="1241382"/>
                                <a:pt x="2040478" y="1241337"/>
                                <a:pt x="2044558" y="1238036"/>
                              </a:cubicBezTo>
                              <a:cubicBezTo>
                                <a:pt x="2101376" y="1213860"/>
                                <a:pt x="2017609" y="1235780"/>
                                <a:pt x="2085654" y="1227762"/>
                              </a:cubicBezTo>
                              <a:cubicBezTo>
                                <a:pt x="2096238" y="1224753"/>
                                <a:pt x="2104957" y="1222629"/>
                                <a:pt x="2116477" y="1217488"/>
                              </a:cubicBezTo>
                              <a:cubicBezTo>
                                <a:pt x="2120893" y="1214786"/>
                                <a:pt x="2129935" y="1212066"/>
                                <a:pt x="2131888" y="1212351"/>
                              </a:cubicBezTo>
                              <a:cubicBezTo>
                                <a:pt x="2136061" y="1211124"/>
                                <a:pt x="2143147" y="1209120"/>
                                <a:pt x="2147299" y="1207214"/>
                              </a:cubicBezTo>
                              <a:cubicBezTo>
                                <a:pt x="2155859" y="1203348"/>
                                <a:pt x="2164097" y="1199490"/>
                                <a:pt x="2172985" y="1196940"/>
                              </a:cubicBezTo>
                              <a:cubicBezTo>
                                <a:pt x="2186695" y="1193673"/>
                                <a:pt x="2200187" y="1190054"/>
                                <a:pt x="2214081" y="1186666"/>
                              </a:cubicBezTo>
                              <a:cubicBezTo>
                                <a:pt x="2221413" y="1184872"/>
                                <a:pt x="2229724" y="1183718"/>
                                <a:pt x="2234630" y="1181529"/>
                              </a:cubicBezTo>
                              <a:cubicBezTo>
                                <a:pt x="2240566" y="1177880"/>
                                <a:pt x="2247688" y="1176093"/>
                                <a:pt x="2255178" y="1171254"/>
                              </a:cubicBezTo>
                              <a:cubicBezTo>
                                <a:pt x="2262445" y="1167280"/>
                                <a:pt x="2272747" y="1159070"/>
                                <a:pt x="2280863" y="1155843"/>
                              </a:cubicBezTo>
                              <a:cubicBezTo>
                                <a:pt x="2349370" y="1106010"/>
                                <a:pt x="2243999" y="1184090"/>
                                <a:pt x="2332234" y="1140432"/>
                              </a:cubicBezTo>
                              <a:cubicBezTo>
                                <a:pt x="2423172" y="1095939"/>
                                <a:pt x="2327660" y="1132943"/>
                                <a:pt x="2404153" y="1109609"/>
                              </a:cubicBezTo>
                              <a:cubicBezTo>
                                <a:pt x="2410931" y="1106880"/>
                                <a:pt x="2417868" y="1103440"/>
                                <a:pt x="2424702" y="1099335"/>
                              </a:cubicBezTo>
                              <a:cubicBezTo>
                                <a:pt x="2430788" y="1096394"/>
                                <a:pt x="2433984" y="1091535"/>
                                <a:pt x="2440113" y="1089061"/>
                              </a:cubicBezTo>
                              <a:cubicBezTo>
                                <a:pt x="2452520" y="1083031"/>
                                <a:pt x="2496417" y="1072532"/>
                                <a:pt x="2506895" y="1068513"/>
                              </a:cubicBezTo>
                              <a:cubicBezTo>
                                <a:pt x="2564173" y="1024377"/>
                                <a:pt x="2484718" y="1079034"/>
                                <a:pt x="2558266" y="1047964"/>
                              </a:cubicBezTo>
                              <a:cubicBezTo>
                                <a:pt x="2563319" y="1045887"/>
                                <a:pt x="2567933" y="1041612"/>
                                <a:pt x="2573677" y="1037690"/>
                              </a:cubicBezTo>
                              <a:cubicBezTo>
                                <a:pt x="2581214" y="1034369"/>
                                <a:pt x="2590348" y="1031660"/>
                                <a:pt x="2599362" y="1027416"/>
                              </a:cubicBezTo>
                              <a:cubicBezTo>
                                <a:pt x="2613127" y="1021349"/>
                                <a:pt x="2630269" y="1015592"/>
                                <a:pt x="2640459" y="1006868"/>
                              </a:cubicBezTo>
                              <a:cubicBezTo>
                                <a:pt x="2647888" y="1001211"/>
                                <a:pt x="2654168" y="995121"/>
                                <a:pt x="2661007" y="991457"/>
                              </a:cubicBezTo>
                              <a:cubicBezTo>
                                <a:pt x="2668122" y="988307"/>
                                <a:pt x="2675374" y="987612"/>
                                <a:pt x="2681555" y="986320"/>
                              </a:cubicBezTo>
                              <a:cubicBezTo>
                                <a:pt x="2691745" y="978510"/>
                                <a:pt x="2712778" y="964777"/>
                                <a:pt x="2722652" y="960634"/>
                              </a:cubicBezTo>
                              <a:cubicBezTo>
                                <a:pt x="2729945" y="958165"/>
                                <a:pt x="2736518" y="959070"/>
                                <a:pt x="2743200" y="955497"/>
                              </a:cubicBezTo>
                              <a:cubicBezTo>
                                <a:pt x="2750651" y="953552"/>
                                <a:pt x="2762376" y="949365"/>
                                <a:pt x="2768886" y="945223"/>
                              </a:cubicBezTo>
                              <a:cubicBezTo>
                                <a:pt x="2775528" y="942712"/>
                                <a:pt x="2778510" y="938039"/>
                                <a:pt x="2784297" y="934949"/>
                              </a:cubicBezTo>
                              <a:cubicBezTo>
                                <a:pt x="2793262" y="932195"/>
                                <a:pt x="2801470" y="927964"/>
                                <a:pt x="2809982" y="924675"/>
                              </a:cubicBezTo>
                              <a:cubicBezTo>
                                <a:pt x="2842290" y="913195"/>
                                <a:pt x="2835981" y="915260"/>
                                <a:pt x="2866490" y="909263"/>
                              </a:cubicBezTo>
                              <a:cubicBezTo>
                                <a:pt x="2877659" y="911766"/>
                                <a:pt x="2889108" y="909857"/>
                                <a:pt x="2902450" y="914400"/>
                              </a:cubicBezTo>
                              <a:cubicBezTo>
                                <a:pt x="2909241" y="916021"/>
                                <a:pt x="2914346" y="920672"/>
                                <a:pt x="2917861" y="924675"/>
                              </a:cubicBezTo>
                              <a:cubicBezTo>
                                <a:pt x="2925530" y="931887"/>
                                <a:pt x="2934755" y="952575"/>
                                <a:pt x="2938409" y="960634"/>
                              </a:cubicBezTo>
                              <a:cubicBezTo>
                                <a:pt x="2943064" y="978466"/>
                                <a:pt x="2945443" y="995338"/>
                                <a:pt x="2948684" y="1012005"/>
                              </a:cubicBezTo>
                              <a:cubicBezTo>
                                <a:pt x="2956053" y="1034379"/>
                                <a:pt x="2951522" y="1021961"/>
                                <a:pt x="2958958" y="1047964"/>
                              </a:cubicBezTo>
                              <a:cubicBezTo>
                                <a:pt x="2962601" y="1106438"/>
                                <a:pt x="2963049" y="1113254"/>
                                <a:pt x="2969232" y="1166117"/>
                              </a:cubicBezTo>
                              <a:cubicBezTo>
                                <a:pt x="2971429" y="1176324"/>
                                <a:pt x="2972224" y="1190613"/>
                                <a:pt x="2974369" y="1202077"/>
                              </a:cubicBezTo>
                              <a:cubicBezTo>
                                <a:pt x="2979685" y="1220003"/>
                                <a:pt x="2984352" y="1235926"/>
                                <a:pt x="2989780" y="1253448"/>
                              </a:cubicBezTo>
                              <a:cubicBezTo>
                                <a:pt x="2995987" y="1480063"/>
                                <a:pt x="2999150" y="1503217"/>
                                <a:pt x="2989780" y="1720922"/>
                              </a:cubicBezTo>
                              <a:cubicBezTo>
                                <a:pt x="2988843" y="1753834"/>
                                <a:pt x="2982939" y="1760258"/>
                                <a:pt x="2974369" y="1792841"/>
                              </a:cubicBezTo>
                              <a:cubicBezTo>
                                <a:pt x="2971693" y="1800030"/>
                                <a:pt x="2970153" y="1810271"/>
                                <a:pt x="2969232" y="1818526"/>
                              </a:cubicBezTo>
                              <a:cubicBezTo>
                                <a:pt x="2968004" y="1823440"/>
                                <a:pt x="2965321" y="1829087"/>
                                <a:pt x="2964095" y="1833938"/>
                              </a:cubicBezTo>
                              <a:cubicBezTo>
                                <a:pt x="2960442" y="1845108"/>
                                <a:pt x="2961376" y="1853569"/>
                                <a:pt x="2958958" y="1864760"/>
                              </a:cubicBezTo>
                              <a:cubicBezTo>
                                <a:pt x="2958314" y="1870195"/>
                                <a:pt x="2955366" y="1875459"/>
                                <a:pt x="2953821" y="1880171"/>
                              </a:cubicBezTo>
                              <a:cubicBezTo>
                                <a:pt x="2953016" y="1887451"/>
                                <a:pt x="2950673" y="1893745"/>
                                <a:pt x="2948684" y="1900720"/>
                              </a:cubicBezTo>
                              <a:cubicBezTo>
                                <a:pt x="2947657" y="1905508"/>
                                <a:pt x="2944973" y="1911749"/>
                                <a:pt x="2943546" y="1916131"/>
                              </a:cubicBezTo>
                              <a:cubicBezTo>
                                <a:pt x="2940813" y="1930684"/>
                                <a:pt x="2937423" y="1943698"/>
                                <a:pt x="2933272" y="1957227"/>
                              </a:cubicBezTo>
                              <a:cubicBezTo>
                                <a:pt x="2931766" y="1962590"/>
                                <a:pt x="2929706" y="1967873"/>
                                <a:pt x="2928135" y="1972639"/>
                              </a:cubicBezTo>
                              <a:cubicBezTo>
                                <a:pt x="2916964" y="2012122"/>
                                <a:pt x="2929761" y="1985052"/>
                                <a:pt x="2912724" y="2018872"/>
                              </a:cubicBezTo>
                              <a:cubicBezTo>
                                <a:pt x="2882156" y="2082949"/>
                                <a:pt x="2915499" y="1986232"/>
                                <a:pt x="2902450" y="2075380"/>
                              </a:cubicBezTo>
                              <a:cubicBezTo>
                                <a:pt x="2902013" y="2081200"/>
                                <a:pt x="2899067" y="2085723"/>
                                <a:pt x="2897313" y="2090791"/>
                              </a:cubicBezTo>
                              <a:cubicBezTo>
                                <a:pt x="2894819" y="2098410"/>
                                <a:pt x="2896012" y="2107382"/>
                                <a:pt x="2892176" y="2116477"/>
                              </a:cubicBezTo>
                              <a:cubicBezTo>
                                <a:pt x="2885073" y="2139603"/>
                                <a:pt x="2882427" y="2137597"/>
                                <a:pt x="2876764" y="2157573"/>
                              </a:cubicBezTo>
                              <a:cubicBezTo>
                                <a:pt x="2871085" y="2180931"/>
                                <a:pt x="2872219" y="2192127"/>
                                <a:pt x="2861353" y="2214081"/>
                              </a:cubicBezTo>
                              <a:cubicBezTo>
                                <a:pt x="2854187" y="2225371"/>
                                <a:pt x="2845106" y="2239398"/>
                                <a:pt x="2840805" y="2255178"/>
                              </a:cubicBezTo>
                              <a:cubicBezTo>
                                <a:pt x="2838747" y="2261968"/>
                                <a:pt x="2838343" y="2268008"/>
                                <a:pt x="2835668" y="2275726"/>
                              </a:cubicBezTo>
                              <a:cubicBezTo>
                                <a:pt x="2825433" y="2301646"/>
                                <a:pt x="2818387" y="2309255"/>
                                <a:pt x="2804845" y="2332234"/>
                              </a:cubicBezTo>
                              <a:cubicBezTo>
                                <a:pt x="2786085" y="2369146"/>
                                <a:pt x="2804553" y="2341950"/>
                                <a:pt x="2779160" y="2373331"/>
                              </a:cubicBezTo>
                              <a:cubicBezTo>
                                <a:pt x="2777712" y="2378238"/>
                                <a:pt x="2777504" y="2383464"/>
                                <a:pt x="2774023" y="2388742"/>
                              </a:cubicBezTo>
                              <a:cubicBezTo>
                                <a:pt x="2766757" y="2398428"/>
                                <a:pt x="2748337" y="2414427"/>
                                <a:pt x="2748337" y="2414427"/>
                              </a:cubicBezTo>
                              <a:cubicBezTo>
                                <a:pt x="2729275" y="2478065"/>
                                <a:pt x="2754374" y="2405811"/>
                                <a:pt x="2717515" y="2460661"/>
                              </a:cubicBezTo>
                              <a:cubicBezTo>
                                <a:pt x="2713906" y="2464581"/>
                                <a:pt x="2716056" y="2471982"/>
                                <a:pt x="2712378" y="2476072"/>
                              </a:cubicBezTo>
                              <a:cubicBezTo>
                                <a:pt x="2707249" y="2485427"/>
                                <a:pt x="2698669" y="2490675"/>
                                <a:pt x="2691830" y="2496621"/>
                              </a:cubicBezTo>
                              <a:cubicBezTo>
                                <a:pt x="2636551" y="2551137"/>
                                <a:pt x="2716427" y="2496513"/>
                                <a:pt x="2655870" y="2542854"/>
                              </a:cubicBezTo>
                              <a:cubicBezTo>
                                <a:pt x="2654035" y="2547965"/>
                                <a:pt x="2654693" y="2553610"/>
                                <a:pt x="2650733" y="2558266"/>
                              </a:cubicBezTo>
                              <a:cubicBezTo>
                                <a:pt x="2628105" y="2587248"/>
                                <a:pt x="2618468" y="2588002"/>
                                <a:pt x="2594225" y="2609636"/>
                              </a:cubicBezTo>
                              <a:cubicBezTo>
                                <a:pt x="2586801" y="2614719"/>
                                <a:pt x="2580948" y="2624434"/>
                                <a:pt x="2573677" y="2630185"/>
                              </a:cubicBezTo>
                              <a:cubicBezTo>
                                <a:pt x="2568600" y="2635167"/>
                                <a:pt x="2562839" y="2635896"/>
                                <a:pt x="2558266" y="2640459"/>
                              </a:cubicBezTo>
                              <a:cubicBezTo>
                                <a:pt x="2533582" y="2661366"/>
                                <a:pt x="2554444" y="2652471"/>
                                <a:pt x="2527443" y="2661007"/>
                              </a:cubicBezTo>
                              <a:cubicBezTo>
                                <a:pt x="2480804" y="2696964"/>
                                <a:pt x="2501654" y="2683743"/>
                                <a:pt x="2460661" y="2707241"/>
                              </a:cubicBezTo>
                              <a:cubicBezTo>
                                <a:pt x="2457604" y="2712013"/>
                                <a:pt x="2455248" y="2718330"/>
                                <a:pt x="2450387" y="2722652"/>
                              </a:cubicBezTo>
                              <a:cubicBezTo>
                                <a:pt x="2444347" y="2725562"/>
                                <a:pt x="2417638" y="2734449"/>
                                <a:pt x="2409290" y="2738063"/>
                              </a:cubicBezTo>
                              <a:cubicBezTo>
                                <a:pt x="2401922" y="2736433"/>
                                <a:pt x="2394815" y="2733761"/>
                                <a:pt x="2388742" y="2732926"/>
                              </a:cubicBezTo>
                              <a:cubicBezTo>
                                <a:pt x="2373215" y="2728148"/>
                                <a:pt x="2342508" y="2717516"/>
                                <a:pt x="2342508" y="2717515"/>
                              </a:cubicBezTo>
                              <a:cubicBezTo>
                                <a:pt x="2318290" y="2681714"/>
                                <a:pt x="2347917" y="2718554"/>
                                <a:pt x="2311686" y="2691830"/>
                              </a:cubicBezTo>
                              <a:cubicBezTo>
                                <a:pt x="2300130" y="2682374"/>
                                <a:pt x="2288680" y="2668601"/>
                                <a:pt x="2275726" y="2655870"/>
                              </a:cubicBezTo>
                              <a:cubicBezTo>
                                <a:pt x="2269730" y="2648278"/>
                                <a:pt x="2268511" y="2645952"/>
                                <a:pt x="2260315" y="2640459"/>
                              </a:cubicBezTo>
                              <a:cubicBezTo>
                                <a:pt x="2254812" y="2628091"/>
                                <a:pt x="2256100" y="2619690"/>
                                <a:pt x="2244904" y="2609636"/>
                              </a:cubicBezTo>
                              <a:cubicBezTo>
                                <a:pt x="2239262" y="2603217"/>
                                <a:pt x="2232336" y="2600348"/>
                                <a:pt x="2224355" y="2594225"/>
                              </a:cubicBezTo>
                              <a:cubicBezTo>
                                <a:pt x="2214754" y="2575269"/>
                                <a:pt x="2215470" y="2574280"/>
                                <a:pt x="2203807" y="2558266"/>
                              </a:cubicBezTo>
                              <a:cubicBezTo>
                                <a:pt x="2195189" y="2543120"/>
                                <a:pt x="2183382" y="2530940"/>
                                <a:pt x="2172985" y="2517169"/>
                              </a:cubicBezTo>
                              <a:cubicBezTo>
                                <a:pt x="2166783" y="2506394"/>
                                <a:pt x="2161421" y="2487577"/>
                                <a:pt x="2152436" y="2476072"/>
                              </a:cubicBezTo>
                              <a:cubicBezTo>
                                <a:pt x="2147337" y="2465549"/>
                                <a:pt x="2135770" y="2456685"/>
                                <a:pt x="2131888" y="2445250"/>
                              </a:cubicBezTo>
                              <a:cubicBezTo>
                                <a:pt x="2120109" y="2426039"/>
                                <a:pt x="2113816" y="2416473"/>
                                <a:pt x="2111340" y="2404153"/>
                              </a:cubicBezTo>
                              <a:cubicBezTo>
                                <a:pt x="2106071" y="2393600"/>
                                <a:pt x="2101892" y="2381734"/>
                                <a:pt x="2095929" y="2373331"/>
                              </a:cubicBezTo>
                              <a:cubicBezTo>
                                <a:pt x="2077953" y="2343972"/>
                                <a:pt x="2054268" y="2320161"/>
                                <a:pt x="2044558" y="2291138"/>
                              </a:cubicBezTo>
                              <a:cubicBezTo>
                                <a:pt x="2040606" y="2285209"/>
                                <a:pt x="2038385" y="2276666"/>
                                <a:pt x="2034284" y="2270589"/>
                              </a:cubicBezTo>
                              <a:cubicBezTo>
                                <a:pt x="2029918" y="2261959"/>
                                <a:pt x="2019939" y="2252870"/>
                                <a:pt x="2013735" y="2244904"/>
                              </a:cubicBezTo>
                              <a:cubicBezTo>
                                <a:pt x="2009339" y="2238773"/>
                                <a:pt x="2006944" y="2231416"/>
                                <a:pt x="2003461" y="2224355"/>
                              </a:cubicBezTo>
                              <a:cubicBezTo>
                                <a:pt x="1997073" y="2213322"/>
                                <a:pt x="1989040" y="2208793"/>
                                <a:pt x="1982913" y="2198670"/>
                              </a:cubicBezTo>
                              <a:cubicBezTo>
                                <a:pt x="1961913" y="2174035"/>
                                <a:pt x="1983052" y="2191433"/>
                                <a:pt x="1962364" y="2172985"/>
                              </a:cubicBezTo>
                              <a:cubicBezTo>
                                <a:pt x="1954446" y="2147638"/>
                                <a:pt x="1961735" y="2162670"/>
                                <a:pt x="1941816" y="2137025"/>
                              </a:cubicBezTo>
                              <a:cubicBezTo>
                                <a:pt x="1937638" y="2131571"/>
                                <a:pt x="1935630" y="2126353"/>
                                <a:pt x="1931542" y="2121614"/>
                              </a:cubicBezTo>
                              <a:cubicBezTo>
                                <a:pt x="1925993" y="2116541"/>
                                <a:pt x="1920646" y="2111274"/>
                                <a:pt x="1916131" y="2106203"/>
                              </a:cubicBezTo>
                              <a:cubicBezTo>
                                <a:pt x="1911551" y="2101274"/>
                                <a:pt x="1910205" y="2095733"/>
                                <a:pt x="1905857" y="2090791"/>
                              </a:cubicBezTo>
                              <a:cubicBezTo>
                                <a:pt x="1842742" y="2016280"/>
                                <a:pt x="1910755" y="2095354"/>
                                <a:pt x="1869897" y="2049695"/>
                              </a:cubicBezTo>
                              <a:cubicBezTo>
                                <a:pt x="1859075" y="2037047"/>
                                <a:pt x="1849998" y="2022734"/>
                                <a:pt x="1839075" y="2008598"/>
                              </a:cubicBezTo>
                              <a:cubicBezTo>
                                <a:pt x="1834764" y="2000629"/>
                                <a:pt x="1830501" y="1993854"/>
                                <a:pt x="1823663" y="1988050"/>
                              </a:cubicBezTo>
                              <a:cubicBezTo>
                                <a:pt x="1824591" y="2015460"/>
                                <a:pt x="1824886" y="2032739"/>
                                <a:pt x="1833937" y="2059969"/>
                              </a:cubicBezTo>
                              <a:cubicBezTo>
                                <a:pt x="1838951" y="2075119"/>
                                <a:pt x="1841603" y="2081160"/>
                                <a:pt x="1849349" y="2095929"/>
                              </a:cubicBezTo>
                              <a:cubicBezTo>
                                <a:pt x="1853110" y="2117200"/>
                                <a:pt x="1853975" y="2140261"/>
                                <a:pt x="1859623" y="2157573"/>
                              </a:cubicBezTo>
                              <a:cubicBezTo>
                                <a:pt x="1861210" y="2162754"/>
                                <a:pt x="1862610" y="2167596"/>
                                <a:pt x="1864760" y="2172985"/>
                              </a:cubicBezTo>
                              <a:cubicBezTo>
                                <a:pt x="1870400" y="2182851"/>
                                <a:pt x="1877501" y="2202245"/>
                                <a:pt x="1880171" y="2214081"/>
                              </a:cubicBezTo>
                              <a:cubicBezTo>
                                <a:pt x="1883049" y="2221334"/>
                                <a:pt x="1882776" y="2230905"/>
                                <a:pt x="1885308" y="2239767"/>
                              </a:cubicBezTo>
                              <a:cubicBezTo>
                                <a:pt x="1910348" y="2321959"/>
                                <a:pt x="1880929" y="2217205"/>
                                <a:pt x="1900720" y="2275726"/>
                              </a:cubicBezTo>
                              <a:cubicBezTo>
                                <a:pt x="1901738" y="2283495"/>
                                <a:pt x="1903648" y="2289304"/>
                                <a:pt x="1905857" y="2296275"/>
                              </a:cubicBezTo>
                              <a:cubicBezTo>
                                <a:pt x="1908433" y="2304927"/>
                                <a:pt x="1908100" y="2313323"/>
                                <a:pt x="1910994" y="2321960"/>
                              </a:cubicBezTo>
                              <a:cubicBezTo>
                                <a:pt x="1913434" y="2332366"/>
                                <a:pt x="1923454" y="2342212"/>
                                <a:pt x="1926405" y="2352782"/>
                              </a:cubicBezTo>
                              <a:cubicBezTo>
                                <a:pt x="1931514" y="2360912"/>
                                <a:pt x="1932017" y="2373652"/>
                                <a:pt x="1936679" y="2383605"/>
                              </a:cubicBezTo>
                              <a:cubicBezTo>
                                <a:pt x="1945394" y="2399948"/>
                                <a:pt x="1967501" y="2429840"/>
                                <a:pt x="1967502" y="2429839"/>
                              </a:cubicBezTo>
                              <a:cubicBezTo>
                                <a:pt x="1969475" y="2440081"/>
                                <a:pt x="1971361" y="2450575"/>
                                <a:pt x="1977776" y="2460661"/>
                              </a:cubicBezTo>
                              <a:cubicBezTo>
                                <a:pt x="2001144" y="2513463"/>
                                <a:pt x="1975847" y="2448458"/>
                                <a:pt x="1998324" y="2506895"/>
                              </a:cubicBezTo>
                              <a:cubicBezTo>
                                <a:pt x="2000161" y="2513397"/>
                                <a:pt x="2005789" y="2521713"/>
                                <a:pt x="2008598" y="2527443"/>
                              </a:cubicBezTo>
                              <a:cubicBezTo>
                                <a:pt x="2040980" y="2596570"/>
                                <a:pt x="1992600" y="2508149"/>
                                <a:pt x="2034284" y="2583951"/>
                              </a:cubicBezTo>
                              <a:cubicBezTo>
                                <a:pt x="2036444" y="2595338"/>
                                <a:pt x="2038196" y="2604363"/>
                                <a:pt x="2039421" y="2614773"/>
                              </a:cubicBezTo>
                              <a:cubicBezTo>
                                <a:pt x="2044729" y="2638795"/>
                                <a:pt x="2042379" y="2627741"/>
                                <a:pt x="2049695" y="2650733"/>
                              </a:cubicBezTo>
                              <a:cubicBezTo>
                                <a:pt x="2052324" y="2658454"/>
                                <a:pt x="2052992" y="2663845"/>
                                <a:pt x="2054832" y="2671281"/>
                              </a:cubicBezTo>
                              <a:cubicBezTo>
                                <a:pt x="2061235" y="2692195"/>
                                <a:pt x="2065457" y="2702771"/>
                                <a:pt x="2070243" y="2722652"/>
                              </a:cubicBezTo>
                              <a:cubicBezTo>
                                <a:pt x="2072559" y="2734664"/>
                                <a:pt x="2071728" y="2745156"/>
                                <a:pt x="2075380" y="2758612"/>
                              </a:cubicBezTo>
                              <a:cubicBezTo>
                                <a:pt x="2077490" y="2775846"/>
                                <a:pt x="2082084" y="2790206"/>
                                <a:pt x="2085654" y="2809982"/>
                              </a:cubicBezTo>
                              <a:cubicBezTo>
                                <a:pt x="2087991" y="2813099"/>
                                <a:pt x="2087655" y="2825008"/>
                                <a:pt x="2090791" y="2835668"/>
                              </a:cubicBezTo>
                              <a:cubicBezTo>
                                <a:pt x="2085780" y="2865025"/>
                                <a:pt x="2098804" y="2938253"/>
                                <a:pt x="2059969" y="2964095"/>
                              </a:cubicBezTo>
                              <a:cubicBezTo>
                                <a:pt x="2055619" y="2967567"/>
                                <a:pt x="2049389" y="2966532"/>
                                <a:pt x="2044558" y="2969232"/>
                              </a:cubicBezTo>
                              <a:cubicBezTo>
                                <a:pt x="2037291" y="2972018"/>
                                <a:pt x="2030309" y="2976668"/>
                                <a:pt x="2024009" y="2979506"/>
                              </a:cubicBezTo>
                              <a:cubicBezTo>
                                <a:pt x="2019244" y="2981651"/>
                                <a:pt x="2013624" y="2983163"/>
                                <a:pt x="2008598" y="2984643"/>
                              </a:cubicBezTo>
                              <a:cubicBezTo>
                                <a:pt x="1993905" y="2990123"/>
                                <a:pt x="1986776" y="2997665"/>
                                <a:pt x="1972639" y="3000054"/>
                              </a:cubicBezTo>
                              <a:cubicBezTo>
                                <a:pt x="1960376" y="3002636"/>
                                <a:pt x="1948358" y="3002293"/>
                                <a:pt x="1936679" y="3005191"/>
                              </a:cubicBezTo>
                              <a:cubicBezTo>
                                <a:pt x="1863312" y="3004145"/>
                                <a:pt x="2003796" y="3010689"/>
                                <a:pt x="1880171" y="3015466"/>
                              </a:cubicBezTo>
                              <a:cubicBezTo>
                                <a:pt x="1851824" y="3019595"/>
                                <a:pt x="1818572" y="3022891"/>
                                <a:pt x="1787704" y="3025740"/>
                              </a:cubicBezTo>
                              <a:cubicBezTo>
                                <a:pt x="1764735" y="3027254"/>
                                <a:pt x="1740565" y="3030955"/>
                                <a:pt x="1715785" y="3030877"/>
                              </a:cubicBezTo>
                              <a:cubicBezTo>
                                <a:pt x="1635538" y="3040822"/>
                                <a:pt x="1546718" y="3032352"/>
                                <a:pt x="1469205" y="3036014"/>
                              </a:cubicBezTo>
                              <a:cubicBezTo>
                                <a:pt x="1445163" y="3031888"/>
                                <a:pt x="1315412" y="3033138"/>
                                <a:pt x="1284270" y="3025740"/>
                              </a:cubicBezTo>
                              <a:cubicBezTo>
                                <a:pt x="1156280" y="3019272"/>
                                <a:pt x="1281064" y="3029108"/>
                                <a:pt x="1186666" y="3000054"/>
                              </a:cubicBezTo>
                              <a:cubicBezTo>
                                <a:pt x="1177261" y="2999151"/>
                                <a:pt x="1169793" y="2997281"/>
                                <a:pt x="1160980" y="2994917"/>
                              </a:cubicBezTo>
                              <a:cubicBezTo>
                                <a:pt x="1081225" y="2964003"/>
                                <a:pt x="1142725" y="2988859"/>
                                <a:pt x="1089061" y="2974369"/>
                              </a:cubicBezTo>
                              <a:cubicBezTo>
                                <a:pt x="1063612" y="2958384"/>
                                <a:pt x="1087950" y="2970595"/>
                                <a:pt x="1042827" y="2958958"/>
                              </a:cubicBezTo>
                              <a:cubicBezTo>
                                <a:pt x="1037458" y="2957852"/>
                                <a:pt x="1032781" y="2954100"/>
                                <a:pt x="1027416" y="2953821"/>
                              </a:cubicBezTo>
                              <a:cubicBezTo>
                                <a:pt x="1017492" y="2952015"/>
                                <a:pt x="1008193" y="2949401"/>
                                <a:pt x="996594" y="2948684"/>
                              </a:cubicBezTo>
                              <a:cubicBezTo>
                                <a:pt x="986706" y="2946531"/>
                                <a:pt x="979134" y="2940049"/>
                                <a:pt x="970908" y="2938409"/>
                              </a:cubicBezTo>
                              <a:cubicBezTo>
                                <a:pt x="960240" y="2935542"/>
                                <a:pt x="949074" y="2933791"/>
                                <a:pt x="940086" y="2928135"/>
                              </a:cubicBezTo>
                              <a:cubicBezTo>
                                <a:pt x="917999" y="2913879"/>
                                <a:pt x="931161" y="2918829"/>
                                <a:pt x="904126" y="2912724"/>
                              </a:cubicBezTo>
                              <a:cubicBezTo>
                                <a:pt x="896845" y="2909101"/>
                                <a:pt x="890981" y="2904037"/>
                                <a:pt x="883578" y="2902450"/>
                              </a:cubicBezTo>
                              <a:cubicBezTo>
                                <a:pt x="877300" y="2899834"/>
                                <a:pt x="869158" y="2900919"/>
                                <a:pt x="863030" y="2897313"/>
                              </a:cubicBezTo>
                              <a:cubicBezTo>
                                <a:pt x="850801" y="2892852"/>
                                <a:pt x="845452" y="2880024"/>
                                <a:pt x="832207" y="2876764"/>
                              </a:cubicBezTo>
                              <a:cubicBezTo>
                                <a:pt x="807038" y="2866946"/>
                                <a:pt x="790398" y="2861316"/>
                                <a:pt x="765425" y="2845942"/>
                              </a:cubicBezTo>
                              <a:cubicBezTo>
                                <a:pt x="756766" y="2840513"/>
                                <a:pt x="748958" y="2835305"/>
                                <a:pt x="739740" y="2830531"/>
                              </a:cubicBezTo>
                              <a:cubicBezTo>
                                <a:pt x="731264" y="2825855"/>
                                <a:pt x="727139" y="2818664"/>
                                <a:pt x="719191" y="2815120"/>
                              </a:cubicBezTo>
                              <a:cubicBezTo>
                                <a:pt x="711190" y="2810524"/>
                                <a:pt x="702299" y="2812837"/>
                                <a:pt x="693506" y="2809982"/>
                              </a:cubicBezTo>
                              <a:cubicBezTo>
                                <a:pt x="689619" y="2804203"/>
                                <a:pt x="687971" y="2798487"/>
                                <a:pt x="683232" y="2794571"/>
                              </a:cubicBezTo>
                              <a:cubicBezTo>
                                <a:pt x="660154" y="2779314"/>
                                <a:pt x="650797" y="2776217"/>
                                <a:pt x="626724" y="2768886"/>
                              </a:cubicBezTo>
                              <a:cubicBezTo>
                                <a:pt x="619412" y="2763887"/>
                                <a:pt x="613450" y="2758358"/>
                                <a:pt x="606176" y="2753475"/>
                              </a:cubicBezTo>
                              <a:cubicBezTo>
                                <a:pt x="580283" y="2721914"/>
                                <a:pt x="612069" y="2753976"/>
                                <a:pt x="570216" y="2722652"/>
                              </a:cubicBezTo>
                              <a:cubicBezTo>
                                <a:pt x="554987" y="2712109"/>
                                <a:pt x="523982" y="2691829"/>
                                <a:pt x="523982" y="2691830"/>
                              </a:cubicBezTo>
                              <a:cubicBezTo>
                                <a:pt x="514245" y="2676707"/>
                                <a:pt x="512962" y="2673290"/>
                                <a:pt x="498297" y="2661007"/>
                              </a:cubicBezTo>
                              <a:cubicBezTo>
                                <a:pt x="492725" y="2657776"/>
                                <a:pt x="487406" y="2654745"/>
                                <a:pt x="482886" y="2650733"/>
                              </a:cubicBezTo>
                              <a:cubicBezTo>
                                <a:pt x="467563" y="2638153"/>
                                <a:pt x="458652" y="2624876"/>
                                <a:pt x="446926" y="2614773"/>
                              </a:cubicBezTo>
                              <a:cubicBezTo>
                                <a:pt x="436889" y="2607861"/>
                                <a:pt x="429068" y="2603572"/>
                                <a:pt x="421241" y="2594225"/>
                              </a:cubicBezTo>
                              <a:cubicBezTo>
                                <a:pt x="417069" y="2589786"/>
                                <a:pt x="414900" y="2582770"/>
                                <a:pt x="410967" y="2578814"/>
                              </a:cubicBezTo>
                              <a:cubicBezTo>
                                <a:pt x="406905" y="2575460"/>
                                <a:pt x="400168" y="2573020"/>
                                <a:pt x="395555" y="2568540"/>
                              </a:cubicBezTo>
                              <a:cubicBezTo>
                                <a:pt x="342924" y="2521912"/>
                                <a:pt x="385274" y="2559033"/>
                                <a:pt x="354459" y="2532580"/>
                              </a:cubicBezTo>
                              <a:cubicBezTo>
                                <a:pt x="349296" y="2524990"/>
                                <a:pt x="339048" y="2513538"/>
                                <a:pt x="339048" y="2501758"/>
                              </a:cubicBezTo>
                              <a:cubicBezTo>
                                <a:pt x="338751" y="2488216"/>
                                <a:pt x="337558" y="2477086"/>
                                <a:pt x="344185" y="2465798"/>
                              </a:cubicBezTo>
                              <a:cubicBezTo>
                                <a:pt x="355094" y="2449511"/>
                                <a:pt x="366857" y="2444197"/>
                                <a:pt x="380144" y="2429839"/>
                              </a:cubicBezTo>
                              <a:cubicBezTo>
                                <a:pt x="393881" y="2416187"/>
                                <a:pt x="385940" y="2420361"/>
                                <a:pt x="405830" y="2414427"/>
                              </a:cubicBezTo>
                              <a:cubicBezTo>
                                <a:pt x="423569" y="2400425"/>
                                <a:pt x="440960" y="2397926"/>
                                <a:pt x="452063" y="2378468"/>
                              </a:cubicBezTo>
                              <a:cubicBezTo>
                                <a:pt x="455703" y="2373001"/>
                                <a:pt x="458297" y="2367700"/>
                                <a:pt x="462337" y="2363057"/>
                              </a:cubicBezTo>
                              <a:cubicBezTo>
                                <a:pt x="503467" y="2327698"/>
                                <a:pt x="474052" y="2354634"/>
                                <a:pt x="513708" y="2332234"/>
                              </a:cubicBezTo>
                              <a:cubicBezTo>
                                <a:pt x="522620" y="2326432"/>
                                <a:pt x="529512" y="2319260"/>
                                <a:pt x="539394" y="2311686"/>
                              </a:cubicBezTo>
                              <a:cubicBezTo>
                                <a:pt x="545616" y="2308871"/>
                                <a:pt x="553364" y="2305604"/>
                                <a:pt x="559942" y="2301412"/>
                              </a:cubicBezTo>
                              <a:cubicBezTo>
                                <a:pt x="596734" y="2280194"/>
                                <a:pt x="571179" y="2289638"/>
                                <a:pt x="606176" y="2270589"/>
                              </a:cubicBezTo>
                              <a:cubicBezTo>
                                <a:pt x="610927" y="2269033"/>
                                <a:pt x="615803" y="2268110"/>
                                <a:pt x="621587" y="2265452"/>
                              </a:cubicBezTo>
                              <a:cubicBezTo>
                                <a:pt x="629211" y="2261867"/>
                                <a:pt x="635417" y="2258671"/>
                                <a:pt x="642135" y="2255178"/>
                              </a:cubicBezTo>
                              <a:cubicBezTo>
                                <a:pt x="661716" y="2220217"/>
                                <a:pt x="632132" y="2254115"/>
                                <a:pt x="667821" y="2234630"/>
                              </a:cubicBezTo>
                              <a:cubicBezTo>
                                <a:pt x="688810" y="2224402"/>
                                <a:pt x="703395" y="2208326"/>
                                <a:pt x="719191" y="2193533"/>
                              </a:cubicBezTo>
                              <a:cubicBezTo>
                                <a:pt x="730439" y="2187006"/>
                                <a:pt x="740213" y="2181867"/>
                                <a:pt x="750014" y="2172985"/>
                              </a:cubicBezTo>
                              <a:cubicBezTo>
                                <a:pt x="757630" y="2165130"/>
                                <a:pt x="762430" y="2158437"/>
                                <a:pt x="770562" y="2152436"/>
                              </a:cubicBezTo>
                              <a:cubicBezTo>
                                <a:pt x="784905" y="2138292"/>
                                <a:pt x="799888" y="2129778"/>
                                <a:pt x="816796" y="2116477"/>
                              </a:cubicBezTo>
                              <a:cubicBezTo>
                                <a:pt x="827419" y="2110006"/>
                                <a:pt x="833785" y="2102386"/>
                                <a:pt x="842481" y="2095929"/>
                              </a:cubicBezTo>
                              <a:cubicBezTo>
                                <a:pt x="848608" y="2090517"/>
                                <a:pt x="857910" y="2086767"/>
                                <a:pt x="863030" y="2080517"/>
                              </a:cubicBezTo>
                              <a:cubicBezTo>
                                <a:pt x="878838" y="2064376"/>
                                <a:pt x="889094" y="2048592"/>
                                <a:pt x="904126" y="2039421"/>
                              </a:cubicBezTo>
                              <a:cubicBezTo>
                                <a:pt x="908944" y="2035668"/>
                                <a:pt x="915442" y="2034217"/>
                                <a:pt x="919537" y="2029146"/>
                              </a:cubicBezTo>
                              <a:cubicBezTo>
                                <a:pt x="927869" y="2019514"/>
                                <a:pt x="932878" y="2011568"/>
                                <a:pt x="940086" y="2003461"/>
                              </a:cubicBezTo>
                              <a:cubicBezTo>
                                <a:pt x="947839" y="1994431"/>
                                <a:pt x="957402" y="1987806"/>
                                <a:pt x="965771" y="1977776"/>
                              </a:cubicBezTo>
                              <a:cubicBezTo>
                                <a:pt x="1026429" y="1905340"/>
                                <a:pt x="967535" y="1968157"/>
                                <a:pt x="1001731" y="1931542"/>
                              </a:cubicBezTo>
                              <a:cubicBezTo>
                                <a:pt x="1003372" y="1926345"/>
                                <a:pt x="1004213" y="1919761"/>
                                <a:pt x="1006868" y="1916131"/>
                              </a:cubicBezTo>
                              <a:cubicBezTo>
                                <a:pt x="1010633" y="1910099"/>
                                <a:pt x="1018655" y="1909692"/>
                                <a:pt x="1022279" y="1905857"/>
                              </a:cubicBezTo>
                              <a:cubicBezTo>
                                <a:pt x="1026002" y="1902497"/>
                                <a:pt x="1029644" y="1899061"/>
                                <a:pt x="1032553" y="1895582"/>
                              </a:cubicBezTo>
                              <a:cubicBezTo>
                                <a:pt x="1027518" y="1893246"/>
                                <a:pt x="1023393" y="1885422"/>
                                <a:pt x="1017142" y="1885308"/>
                              </a:cubicBezTo>
                              <a:cubicBezTo>
                                <a:pt x="1000357" y="1884569"/>
                                <a:pt x="977787" y="1901025"/>
                                <a:pt x="965771" y="1905857"/>
                              </a:cubicBezTo>
                              <a:cubicBezTo>
                                <a:pt x="960564" y="1907894"/>
                                <a:pt x="955681" y="1908789"/>
                                <a:pt x="950360" y="1910994"/>
                              </a:cubicBezTo>
                              <a:cubicBezTo>
                                <a:pt x="942154" y="1915278"/>
                                <a:pt x="937961" y="1921660"/>
                                <a:pt x="929812" y="1926405"/>
                              </a:cubicBezTo>
                              <a:cubicBezTo>
                                <a:pt x="886700" y="1953350"/>
                                <a:pt x="931958" y="1892810"/>
                                <a:pt x="863030" y="1962364"/>
                              </a:cubicBezTo>
                              <a:cubicBezTo>
                                <a:pt x="859441" y="1966559"/>
                                <a:pt x="856982" y="1970247"/>
                                <a:pt x="852755" y="1972639"/>
                              </a:cubicBezTo>
                              <a:cubicBezTo>
                                <a:pt x="839901" y="1980692"/>
                                <a:pt x="826263" y="1986130"/>
                                <a:pt x="811659" y="1993187"/>
                              </a:cubicBezTo>
                              <a:cubicBezTo>
                                <a:pt x="777255" y="2017261"/>
                                <a:pt x="823850" y="1992996"/>
                                <a:pt x="775699" y="2018872"/>
                              </a:cubicBezTo>
                              <a:cubicBezTo>
                                <a:pt x="770741" y="2022898"/>
                                <a:pt x="766311" y="2027091"/>
                                <a:pt x="760288" y="2029146"/>
                              </a:cubicBezTo>
                              <a:cubicBezTo>
                                <a:pt x="738209" y="2040602"/>
                                <a:pt x="722850" y="2037876"/>
                                <a:pt x="703780" y="2049695"/>
                              </a:cubicBezTo>
                              <a:cubicBezTo>
                                <a:pt x="696126" y="2053502"/>
                                <a:pt x="690432" y="2060881"/>
                                <a:pt x="683232" y="2065106"/>
                              </a:cubicBezTo>
                              <a:cubicBezTo>
                                <a:pt x="674441" y="2069596"/>
                                <a:pt x="667106" y="2071097"/>
                                <a:pt x="657546" y="2075380"/>
                              </a:cubicBezTo>
                              <a:cubicBezTo>
                                <a:pt x="649610" y="2078488"/>
                                <a:pt x="639952" y="2085790"/>
                                <a:pt x="631861" y="2090791"/>
                              </a:cubicBezTo>
                              <a:cubicBezTo>
                                <a:pt x="622061" y="2095024"/>
                                <a:pt x="610239" y="2099750"/>
                                <a:pt x="601039" y="2106203"/>
                              </a:cubicBezTo>
                              <a:cubicBezTo>
                                <a:pt x="593857" y="2110107"/>
                                <a:pt x="586464" y="2116146"/>
                                <a:pt x="580490" y="2121614"/>
                              </a:cubicBezTo>
                              <a:cubicBezTo>
                                <a:pt x="573834" y="2125475"/>
                                <a:pt x="566135" y="2126591"/>
                                <a:pt x="559942" y="2131888"/>
                              </a:cubicBezTo>
                              <a:cubicBezTo>
                                <a:pt x="552422" y="2136461"/>
                                <a:pt x="545728" y="2142436"/>
                                <a:pt x="539394" y="2147299"/>
                              </a:cubicBezTo>
                              <a:cubicBezTo>
                                <a:pt x="526206" y="2157817"/>
                                <a:pt x="511181" y="2159813"/>
                                <a:pt x="498297" y="2167848"/>
                              </a:cubicBezTo>
                              <a:cubicBezTo>
                                <a:pt x="493071" y="2171387"/>
                                <a:pt x="488318" y="2175159"/>
                                <a:pt x="482886" y="2178122"/>
                              </a:cubicBezTo>
                              <a:cubicBezTo>
                                <a:pt x="458284" y="2192738"/>
                                <a:pt x="463267" y="2186080"/>
                                <a:pt x="436652" y="2198670"/>
                              </a:cubicBezTo>
                              <a:cubicBezTo>
                                <a:pt x="425580" y="2201679"/>
                                <a:pt x="415642" y="2208972"/>
                                <a:pt x="405830" y="2214081"/>
                              </a:cubicBezTo>
                              <a:cubicBezTo>
                                <a:pt x="395367" y="2219481"/>
                                <a:pt x="383641" y="2219491"/>
                                <a:pt x="375007" y="2224355"/>
                              </a:cubicBezTo>
                              <a:cubicBezTo>
                                <a:pt x="364886" y="2227985"/>
                                <a:pt x="359470" y="2236018"/>
                                <a:pt x="349322" y="2239767"/>
                              </a:cubicBezTo>
                              <a:cubicBezTo>
                                <a:pt x="336819" y="2247908"/>
                                <a:pt x="321727" y="2247159"/>
                                <a:pt x="308225" y="2255178"/>
                              </a:cubicBezTo>
                              <a:cubicBezTo>
                                <a:pt x="255728" y="2281159"/>
                                <a:pt x="308324" y="2262571"/>
                                <a:pt x="261991" y="2275726"/>
                              </a:cubicBezTo>
                              <a:cubicBezTo>
                                <a:pt x="256745" y="2279342"/>
                                <a:pt x="252213" y="2284083"/>
                                <a:pt x="246580" y="2286000"/>
                              </a:cubicBezTo>
                              <a:cubicBezTo>
                                <a:pt x="241901" y="2288320"/>
                                <a:pt x="234957" y="2288904"/>
                                <a:pt x="231169" y="2291138"/>
                              </a:cubicBezTo>
                              <a:cubicBezTo>
                                <a:pt x="223092" y="2297355"/>
                                <a:pt x="214075" y="2305242"/>
                                <a:pt x="205484" y="2311686"/>
                              </a:cubicBezTo>
                              <a:cubicBezTo>
                                <a:pt x="200589" y="2315453"/>
                                <a:pt x="194974" y="2318298"/>
                                <a:pt x="190072" y="2321960"/>
                              </a:cubicBezTo>
                              <a:cubicBezTo>
                                <a:pt x="185313" y="2312178"/>
                                <a:pt x="172067" y="2297563"/>
                                <a:pt x="169524" y="2286000"/>
                              </a:cubicBezTo>
                              <a:cubicBezTo>
                                <a:pt x="167362" y="2270185"/>
                                <a:pt x="166476" y="2254184"/>
                                <a:pt x="164387" y="2239767"/>
                              </a:cubicBezTo>
                              <a:cubicBezTo>
                                <a:pt x="164213" y="2232340"/>
                                <a:pt x="159884" y="2225685"/>
                                <a:pt x="159250" y="2219218"/>
                              </a:cubicBezTo>
                              <a:cubicBezTo>
                                <a:pt x="156993" y="2208272"/>
                                <a:pt x="157188" y="2199638"/>
                                <a:pt x="154113" y="2188396"/>
                              </a:cubicBezTo>
                              <a:cubicBezTo>
                                <a:pt x="150723" y="2177579"/>
                                <a:pt x="141613" y="2159813"/>
                                <a:pt x="138702" y="2147299"/>
                              </a:cubicBezTo>
                              <a:cubicBezTo>
                                <a:pt x="131112" y="2119652"/>
                                <a:pt x="138627" y="2124795"/>
                                <a:pt x="123290" y="2101066"/>
                              </a:cubicBezTo>
                              <a:cubicBezTo>
                                <a:pt x="95699" y="2054336"/>
                                <a:pt x="134522" y="2143200"/>
                                <a:pt x="102742" y="2070243"/>
                              </a:cubicBezTo>
                              <a:cubicBezTo>
                                <a:pt x="92212" y="2009821"/>
                                <a:pt x="97922" y="2056505"/>
                                <a:pt x="92468" y="2018872"/>
                              </a:cubicBezTo>
                              <a:cubicBezTo>
                                <a:pt x="90037" y="2013109"/>
                                <a:pt x="90390" y="2005195"/>
                                <a:pt x="87331" y="1998324"/>
                              </a:cubicBezTo>
                              <a:cubicBezTo>
                                <a:pt x="83922" y="1993338"/>
                                <a:pt x="80041" y="1988937"/>
                                <a:pt x="77057" y="1982913"/>
                              </a:cubicBezTo>
                              <a:cubicBezTo>
                                <a:pt x="74567" y="1977809"/>
                                <a:pt x="73996" y="1973550"/>
                                <a:pt x="71920" y="1967502"/>
                              </a:cubicBezTo>
                              <a:cubicBezTo>
                                <a:pt x="72481" y="1945922"/>
                                <a:pt x="69978" y="1929340"/>
                                <a:pt x="66782" y="1910994"/>
                              </a:cubicBezTo>
                              <a:cubicBezTo>
                                <a:pt x="66421" y="1900345"/>
                                <a:pt x="61625" y="1891962"/>
                                <a:pt x="56508" y="1880171"/>
                              </a:cubicBezTo>
                              <a:cubicBezTo>
                                <a:pt x="26416" y="1817762"/>
                                <a:pt x="80900" y="1907919"/>
                                <a:pt x="35960" y="1823663"/>
                              </a:cubicBezTo>
                              <a:cubicBezTo>
                                <a:pt x="33359" y="1818831"/>
                                <a:pt x="32135" y="1813616"/>
                                <a:pt x="30823" y="1808252"/>
                              </a:cubicBezTo>
                              <a:cubicBezTo>
                                <a:pt x="8823" y="1740907"/>
                                <a:pt x="26130" y="1768908"/>
                                <a:pt x="10275" y="1731196"/>
                              </a:cubicBezTo>
                              <a:cubicBezTo>
                                <a:pt x="2996" y="1691127"/>
                                <a:pt x="2642" y="1609103"/>
                                <a:pt x="0" y="1582221"/>
                              </a:cubicBezTo>
                              <a:cubicBezTo>
                                <a:pt x="5729" y="1485522"/>
                                <a:pt x="-10769" y="1384661"/>
                                <a:pt x="5137" y="1294544"/>
                              </a:cubicBezTo>
                              <a:cubicBezTo>
                                <a:pt x="7660" y="1225181"/>
                                <a:pt x="3854" y="1245522"/>
                                <a:pt x="20549" y="1202077"/>
                              </a:cubicBezTo>
                              <a:cubicBezTo>
                                <a:pt x="25800" y="1184127"/>
                                <a:pt x="24502" y="1174355"/>
                                <a:pt x="30823" y="1155843"/>
                              </a:cubicBezTo>
                              <a:cubicBezTo>
                                <a:pt x="31982" y="1150471"/>
                                <a:pt x="33634" y="1145427"/>
                                <a:pt x="35960" y="1140432"/>
                              </a:cubicBezTo>
                              <a:cubicBezTo>
                                <a:pt x="36032" y="1130395"/>
                                <a:pt x="36342" y="1120824"/>
                                <a:pt x="41097" y="1109609"/>
                              </a:cubicBezTo>
                              <a:cubicBezTo>
                                <a:pt x="44214" y="1099768"/>
                                <a:pt x="51890" y="1092064"/>
                                <a:pt x="56508" y="1083924"/>
                              </a:cubicBezTo>
                              <a:cubicBezTo>
                                <a:pt x="59790" y="1075757"/>
                                <a:pt x="62987" y="1065774"/>
                                <a:pt x="66782" y="1058239"/>
                              </a:cubicBezTo>
                              <a:cubicBezTo>
                                <a:pt x="70585" y="1048714"/>
                                <a:pt x="73196" y="1037641"/>
                                <a:pt x="77057" y="1027416"/>
                              </a:cubicBezTo>
                              <a:cubicBezTo>
                                <a:pt x="80573" y="1019486"/>
                                <a:pt x="84453" y="1011609"/>
                                <a:pt x="87331" y="1001731"/>
                              </a:cubicBezTo>
                              <a:cubicBezTo>
                                <a:pt x="92707" y="989010"/>
                                <a:pt x="94260" y="971883"/>
                                <a:pt x="97605" y="960634"/>
                              </a:cubicBezTo>
                              <a:cubicBezTo>
                                <a:pt x="101257" y="951820"/>
                                <a:pt x="103249" y="944132"/>
                                <a:pt x="107879" y="934949"/>
                              </a:cubicBezTo>
                              <a:cubicBezTo>
                                <a:pt x="110025" y="928170"/>
                                <a:pt x="109287" y="921560"/>
                                <a:pt x="113016" y="914400"/>
                              </a:cubicBezTo>
                              <a:cubicBezTo>
                                <a:pt x="118446" y="900774"/>
                                <a:pt x="130898" y="890629"/>
                                <a:pt x="133564" y="873304"/>
                              </a:cubicBezTo>
                              <a:cubicBezTo>
                                <a:pt x="144802" y="839678"/>
                                <a:pt x="133630" y="863151"/>
                                <a:pt x="154113" y="821933"/>
                              </a:cubicBezTo>
                              <a:cubicBezTo>
                                <a:pt x="157895" y="813347"/>
                                <a:pt x="160458" y="804908"/>
                                <a:pt x="164387" y="796248"/>
                              </a:cubicBezTo>
                              <a:cubicBezTo>
                                <a:pt x="170806" y="782341"/>
                                <a:pt x="184935" y="755151"/>
                                <a:pt x="184935" y="755151"/>
                              </a:cubicBezTo>
                              <a:cubicBezTo>
                                <a:pt x="186048" y="747649"/>
                                <a:pt x="190856" y="720241"/>
                                <a:pt x="195209" y="708917"/>
                              </a:cubicBezTo>
                              <a:cubicBezTo>
                                <a:pt x="197547" y="703854"/>
                                <a:pt x="201891" y="702203"/>
                                <a:pt x="205484" y="698643"/>
                              </a:cubicBezTo>
                              <a:cubicBezTo>
                                <a:pt x="210769" y="688829"/>
                                <a:pt x="208081" y="675632"/>
                                <a:pt x="215758" y="667821"/>
                              </a:cubicBezTo>
                              <a:cubicBezTo>
                                <a:pt x="228798" y="657804"/>
                                <a:pt x="237320" y="649032"/>
                                <a:pt x="246580" y="636998"/>
                              </a:cubicBezTo>
                              <a:cubicBezTo>
                                <a:pt x="250043" y="632057"/>
                                <a:pt x="252746" y="626973"/>
                                <a:pt x="256854" y="621587"/>
                              </a:cubicBezTo>
                              <a:cubicBezTo>
                                <a:pt x="289393" y="592126"/>
                                <a:pt x="242217" y="634195"/>
                                <a:pt x="277403" y="595902"/>
                              </a:cubicBezTo>
                              <a:cubicBezTo>
                                <a:pt x="279128" y="591079"/>
                                <a:pt x="278921" y="585089"/>
                                <a:pt x="282540" y="580490"/>
                              </a:cubicBezTo>
                              <a:cubicBezTo>
                                <a:pt x="290992" y="569282"/>
                                <a:pt x="302500" y="560236"/>
                                <a:pt x="313362" y="549668"/>
                              </a:cubicBezTo>
                              <a:cubicBezTo>
                                <a:pt x="320791" y="542320"/>
                                <a:pt x="327398" y="535699"/>
                                <a:pt x="333911" y="529120"/>
                              </a:cubicBezTo>
                              <a:cubicBezTo>
                                <a:pt x="337081" y="524026"/>
                                <a:pt x="339189" y="517739"/>
                                <a:pt x="344185" y="513708"/>
                              </a:cubicBezTo>
                              <a:cubicBezTo>
                                <a:pt x="354674" y="501274"/>
                                <a:pt x="369799" y="493889"/>
                                <a:pt x="380144" y="477749"/>
                              </a:cubicBezTo>
                              <a:cubicBezTo>
                                <a:pt x="406212" y="445525"/>
                                <a:pt x="376346" y="484164"/>
                                <a:pt x="405830" y="452063"/>
                              </a:cubicBezTo>
                              <a:cubicBezTo>
                                <a:pt x="449698" y="412210"/>
                                <a:pt x="424710" y="427307"/>
                                <a:pt x="457200" y="410967"/>
                              </a:cubicBezTo>
                              <a:cubicBezTo>
                                <a:pt x="460762" y="405840"/>
                                <a:pt x="461050" y="397244"/>
                                <a:pt x="467475" y="395555"/>
                              </a:cubicBezTo>
                              <a:cubicBezTo>
                                <a:pt x="478633" y="394804"/>
                                <a:pt x="489382" y="399158"/>
                                <a:pt x="498297" y="400693"/>
                              </a:cubicBezTo>
                              <a:cubicBezTo>
                                <a:pt x="518535" y="405453"/>
                                <a:pt x="523039" y="413123"/>
                                <a:pt x="544531" y="426378"/>
                              </a:cubicBezTo>
                              <a:cubicBezTo>
                                <a:pt x="571676" y="441816"/>
                                <a:pt x="563960" y="439198"/>
                                <a:pt x="585627" y="446926"/>
                              </a:cubicBezTo>
                              <a:cubicBezTo>
                                <a:pt x="608554" y="482741"/>
                                <a:pt x="581509" y="437686"/>
                                <a:pt x="616450" y="472612"/>
                              </a:cubicBezTo>
                              <a:cubicBezTo>
                                <a:pt x="654582" y="497677"/>
                                <a:pt x="608951" y="478552"/>
                                <a:pt x="642135" y="493160"/>
                              </a:cubicBezTo>
                              <a:cubicBezTo>
                                <a:pt x="649380" y="501829"/>
                                <a:pt x="655099" y="509646"/>
                                <a:pt x="662684" y="518845"/>
                              </a:cubicBezTo>
                              <a:cubicBezTo>
                                <a:pt x="665674" y="523146"/>
                                <a:pt x="670180" y="525525"/>
                                <a:pt x="672958" y="529120"/>
                              </a:cubicBezTo>
                              <a:cubicBezTo>
                                <a:pt x="675800" y="533378"/>
                                <a:pt x="678231" y="540463"/>
                                <a:pt x="683232" y="544531"/>
                              </a:cubicBezTo>
                              <a:cubicBezTo>
                                <a:pt x="689348" y="551969"/>
                                <a:pt x="698036" y="557568"/>
                                <a:pt x="703780" y="565079"/>
                              </a:cubicBezTo>
                              <a:cubicBezTo>
                                <a:pt x="712079" y="573155"/>
                                <a:pt x="716521" y="586744"/>
                                <a:pt x="724329" y="595902"/>
                              </a:cubicBezTo>
                              <a:cubicBezTo>
                                <a:pt x="729008" y="600688"/>
                                <a:pt x="734311" y="606011"/>
                                <a:pt x="739740" y="611313"/>
                              </a:cubicBezTo>
                              <a:cubicBezTo>
                                <a:pt x="747355" y="619522"/>
                                <a:pt x="760812" y="636791"/>
                                <a:pt x="765425" y="647272"/>
                              </a:cubicBezTo>
                              <a:cubicBezTo>
                                <a:pt x="771350" y="655038"/>
                                <a:pt x="774154" y="666585"/>
                                <a:pt x="780836" y="672958"/>
                              </a:cubicBezTo>
                              <a:cubicBezTo>
                                <a:pt x="789074" y="685963"/>
                                <a:pt x="801383" y="694541"/>
                                <a:pt x="811659" y="703780"/>
                              </a:cubicBezTo>
                              <a:cubicBezTo>
                                <a:pt x="816728" y="708804"/>
                                <a:pt x="822687" y="714093"/>
                                <a:pt x="827070" y="719191"/>
                              </a:cubicBezTo>
                              <a:cubicBezTo>
                                <a:pt x="855827" y="785717"/>
                                <a:pt x="778593" y="680023"/>
                                <a:pt x="868167" y="765425"/>
                              </a:cubicBezTo>
                              <a:cubicBezTo>
                                <a:pt x="875852" y="774848"/>
                                <a:pt x="882146" y="781475"/>
                                <a:pt x="888715" y="791111"/>
                              </a:cubicBezTo>
                              <a:cubicBezTo>
                                <a:pt x="894255" y="795967"/>
                                <a:pt x="899304" y="800776"/>
                                <a:pt x="904126" y="806522"/>
                              </a:cubicBezTo>
                              <a:cubicBezTo>
                                <a:pt x="908326" y="811540"/>
                                <a:pt x="909983" y="818492"/>
                                <a:pt x="914400" y="821933"/>
                              </a:cubicBezTo>
                              <a:cubicBezTo>
                                <a:pt x="925232" y="831003"/>
                                <a:pt x="936244" y="840955"/>
                                <a:pt x="945223" y="852755"/>
                              </a:cubicBezTo>
                              <a:cubicBezTo>
                                <a:pt x="969966" y="885759"/>
                                <a:pt x="941232" y="855028"/>
                                <a:pt x="970908" y="883578"/>
                              </a:cubicBezTo>
                              <a:cubicBezTo>
                                <a:pt x="976597" y="890742"/>
                                <a:pt x="980760" y="896645"/>
                                <a:pt x="986320" y="904126"/>
                              </a:cubicBezTo>
                              <a:cubicBezTo>
                                <a:pt x="991285" y="909849"/>
                                <a:pt x="997329" y="914044"/>
                                <a:pt x="1001731" y="919538"/>
                              </a:cubicBezTo>
                              <a:cubicBezTo>
                                <a:pt x="1006294" y="924425"/>
                                <a:pt x="1008436" y="931485"/>
                                <a:pt x="1012005" y="934949"/>
                              </a:cubicBezTo>
                              <a:cubicBezTo>
                                <a:pt x="1016695" y="938411"/>
                                <a:pt x="1023366" y="940987"/>
                                <a:pt x="1027416" y="945223"/>
                              </a:cubicBezTo>
                              <a:cubicBezTo>
                                <a:pt x="1035444" y="953106"/>
                                <a:pt x="1039993" y="962150"/>
                                <a:pt x="1047964" y="970908"/>
                              </a:cubicBezTo>
                              <a:cubicBezTo>
                                <a:pt x="1066129" y="990856"/>
                                <a:pt x="1079047" y="1003234"/>
                                <a:pt x="1099335" y="1017142"/>
                              </a:cubicBezTo>
                              <a:cubicBezTo>
                                <a:pt x="1107042" y="1023520"/>
                                <a:pt x="1117570" y="1027988"/>
                                <a:pt x="1125021" y="1032553"/>
                              </a:cubicBezTo>
                              <a:cubicBezTo>
                                <a:pt x="1144486" y="1062449"/>
                                <a:pt x="1125018" y="1040024"/>
                                <a:pt x="1150706" y="1058239"/>
                              </a:cubicBezTo>
                              <a:cubicBezTo>
                                <a:pt x="1155266" y="1062668"/>
                                <a:pt x="1160965" y="1069803"/>
                                <a:pt x="1166117" y="1073650"/>
                              </a:cubicBezTo>
                              <a:cubicBezTo>
                                <a:pt x="1190593" y="1094846"/>
                                <a:pt x="1190824" y="1093663"/>
                                <a:pt x="1217488" y="1109609"/>
                              </a:cubicBezTo>
                              <a:cubicBezTo>
                                <a:pt x="1253186" y="1154592"/>
                                <a:pt x="1210128" y="1099636"/>
                                <a:pt x="1243173" y="1135295"/>
                              </a:cubicBezTo>
                              <a:cubicBezTo>
                                <a:pt x="1261861" y="1154309"/>
                                <a:pt x="1257822" y="1139385"/>
                                <a:pt x="1258585" y="1135295"/>
                              </a:cubicBezTo>
                              <a:close/>
                            </a:path>
                            <a:path w="2994958" h="3036014" stroke="0" extrusionOk="0">
                              <a:moveTo>
                                <a:pt x="1258585" y="1135295"/>
                              </a:moveTo>
                              <a:cubicBezTo>
                                <a:pt x="1258550" y="1130465"/>
                                <a:pt x="1251553" y="1118188"/>
                                <a:pt x="1248311" y="1109609"/>
                              </a:cubicBezTo>
                              <a:cubicBezTo>
                                <a:pt x="1245373" y="1101774"/>
                                <a:pt x="1225366" y="1079108"/>
                                <a:pt x="1222625" y="1073650"/>
                              </a:cubicBezTo>
                              <a:cubicBezTo>
                                <a:pt x="1218218" y="1069424"/>
                                <a:pt x="1216688" y="1062767"/>
                                <a:pt x="1212351" y="1058239"/>
                              </a:cubicBezTo>
                              <a:cubicBezTo>
                                <a:pt x="1207348" y="1053524"/>
                                <a:pt x="1202380" y="1051534"/>
                                <a:pt x="1196940" y="1047964"/>
                              </a:cubicBezTo>
                              <a:cubicBezTo>
                                <a:pt x="1195618" y="1041161"/>
                                <a:pt x="1194996" y="1033199"/>
                                <a:pt x="1191803" y="1027416"/>
                              </a:cubicBezTo>
                              <a:cubicBezTo>
                                <a:pt x="1186267" y="1018065"/>
                                <a:pt x="1180828" y="1010847"/>
                                <a:pt x="1176391" y="1001731"/>
                              </a:cubicBezTo>
                              <a:cubicBezTo>
                                <a:pt x="1167630" y="983928"/>
                                <a:pt x="1161188" y="972966"/>
                                <a:pt x="1155843" y="955497"/>
                              </a:cubicBezTo>
                              <a:cubicBezTo>
                                <a:pt x="1156338" y="955748"/>
                                <a:pt x="1144491" y="917342"/>
                                <a:pt x="1140432" y="909263"/>
                              </a:cubicBezTo>
                              <a:cubicBezTo>
                                <a:pt x="1136465" y="898901"/>
                                <a:pt x="1138248" y="888407"/>
                                <a:pt x="1130158" y="878441"/>
                              </a:cubicBezTo>
                              <a:cubicBezTo>
                                <a:pt x="1125371" y="872113"/>
                                <a:pt x="1118980" y="866165"/>
                                <a:pt x="1114746" y="857893"/>
                              </a:cubicBezTo>
                              <a:cubicBezTo>
                                <a:pt x="1091417" y="815633"/>
                                <a:pt x="1118531" y="850368"/>
                                <a:pt x="1094198" y="811659"/>
                              </a:cubicBezTo>
                              <a:cubicBezTo>
                                <a:pt x="1075294" y="778415"/>
                                <a:pt x="1083415" y="800395"/>
                                <a:pt x="1068513" y="770562"/>
                              </a:cubicBezTo>
                              <a:cubicBezTo>
                                <a:pt x="1059725" y="752075"/>
                                <a:pt x="1064805" y="750431"/>
                                <a:pt x="1053102" y="729466"/>
                              </a:cubicBezTo>
                              <a:cubicBezTo>
                                <a:pt x="1050524" y="725249"/>
                                <a:pt x="1045798" y="722860"/>
                                <a:pt x="1042827" y="719191"/>
                              </a:cubicBezTo>
                              <a:cubicBezTo>
                                <a:pt x="1039027" y="713601"/>
                                <a:pt x="1034750" y="709646"/>
                                <a:pt x="1032553" y="703780"/>
                              </a:cubicBezTo>
                              <a:cubicBezTo>
                                <a:pt x="1028099" y="698302"/>
                                <a:pt x="1026587" y="690260"/>
                                <a:pt x="1022279" y="683232"/>
                              </a:cubicBezTo>
                              <a:cubicBezTo>
                                <a:pt x="1019186" y="678573"/>
                                <a:pt x="1015640" y="672842"/>
                                <a:pt x="1012005" y="667821"/>
                              </a:cubicBezTo>
                              <a:cubicBezTo>
                                <a:pt x="1007858" y="661724"/>
                                <a:pt x="1004011" y="654002"/>
                                <a:pt x="1001731" y="647272"/>
                              </a:cubicBezTo>
                              <a:cubicBezTo>
                                <a:pt x="998994" y="642557"/>
                                <a:pt x="993606" y="637700"/>
                                <a:pt x="991457" y="631861"/>
                              </a:cubicBezTo>
                              <a:cubicBezTo>
                                <a:pt x="957394" y="552382"/>
                                <a:pt x="975649" y="587598"/>
                                <a:pt x="950360" y="554805"/>
                              </a:cubicBezTo>
                              <a:cubicBezTo>
                                <a:pt x="947195" y="546467"/>
                                <a:pt x="944621" y="538543"/>
                                <a:pt x="940086" y="529120"/>
                              </a:cubicBezTo>
                              <a:cubicBezTo>
                                <a:pt x="934713" y="521060"/>
                                <a:pt x="919536" y="508570"/>
                                <a:pt x="919537" y="508571"/>
                              </a:cubicBezTo>
                              <a:cubicBezTo>
                                <a:pt x="915475" y="498634"/>
                                <a:pt x="908316" y="486828"/>
                                <a:pt x="904126" y="477749"/>
                              </a:cubicBezTo>
                              <a:cubicBezTo>
                                <a:pt x="898502" y="461893"/>
                                <a:pt x="901062" y="456792"/>
                                <a:pt x="893852" y="441789"/>
                              </a:cubicBezTo>
                              <a:cubicBezTo>
                                <a:pt x="891040" y="436425"/>
                                <a:pt x="886501" y="430514"/>
                                <a:pt x="883578" y="426378"/>
                              </a:cubicBezTo>
                              <a:cubicBezTo>
                                <a:pt x="879032" y="417351"/>
                                <a:pt x="874228" y="407651"/>
                                <a:pt x="868167" y="400693"/>
                              </a:cubicBezTo>
                              <a:cubicBezTo>
                                <a:pt x="853446" y="352098"/>
                                <a:pt x="872787" y="399472"/>
                                <a:pt x="852755" y="369870"/>
                              </a:cubicBezTo>
                              <a:cubicBezTo>
                                <a:pt x="846391" y="360284"/>
                                <a:pt x="843103" y="349835"/>
                                <a:pt x="837344" y="339048"/>
                              </a:cubicBezTo>
                              <a:cubicBezTo>
                                <a:pt x="834072" y="329983"/>
                                <a:pt x="826217" y="322970"/>
                                <a:pt x="821933" y="313362"/>
                              </a:cubicBezTo>
                              <a:cubicBezTo>
                                <a:pt x="820398" y="308773"/>
                                <a:pt x="818960" y="301953"/>
                                <a:pt x="816796" y="297951"/>
                              </a:cubicBezTo>
                              <a:cubicBezTo>
                                <a:pt x="813219" y="289049"/>
                                <a:pt x="806762" y="281077"/>
                                <a:pt x="801385" y="272266"/>
                              </a:cubicBezTo>
                              <a:cubicBezTo>
                                <a:pt x="800784" y="263056"/>
                                <a:pt x="798673" y="252013"/>
                                <a:pt x="796248" y="241443"/>
                              </a:cubicBezTo>
                              <a:cubicBezTo>
                                <a:pt x="795474" y="236554"/>
                                <a:pt x="790643" y="230822"/>
                                <a:pt x="791111" y="226032"/>
                              </a:cubicBezTo>
                              <a:cubicBezTo>
                                <a:pt x="790844" y="190567"/>
                                <a:pt x="793518" y="180217"/>
                                <a:pt x="811659" y="154113"/>
                              </a:cubicBezTo>
                              <a:cubicBezTo>
                                <a:pt x="816234" y="148070"/>
                                <a:pt x="820625" y="142017"/>
                                <a:pt x="827070" y="138702"/>
                              </a:cubicBezTo>
                              <a:cubicBezTo>
                                <a:pt x="831284" y="135833"/>
                                <a:pt x="837552" y="136414"/>
                                <a:pt x="842481" y="133564"/>
                              </a:cubicBezTo>
                              <a:cubicBezTo>
                                <a:pt x="849269" y="130260"/>
                                <a:pt x="856964" y="126329"/>
                                <a:pt x="863030" y="123290"/>
                              </a:cubicBezTo>
                              <a:cubicBezTo>
                                <a:pt x="872389" y="119217"/>
                                <a:pt x="881085" y="112190"/>
                                <a:pt x="888715" y="107879"/>
                              </a:cubicBezTo>
                              <a:cubicBezTo>
                                <a:pt x="893865" y="105488"/>
                                <a:pt x="902469" y="103681"/>
                                <a:pt x="909263" y="102742"/>
                              </a:cubicBezTo>
                              <a:cubicBezTo>
                                <a:pt x="919747" y="98506"/>
                                <a:pt x="929766" y="93706"/>
                                <a:pt x="940086" y="92468"/>
                              </a:cubicBezTo>
                              <a:cubicBezTo>
                                <a:pt x="946974" y="90887"/>
                                <a:pt x="957658" y="89291"/>
                                <a:pt x="965771" y="87331"/>
                              </a:cubicBezTo>
                              <a:cubicBezTo>
                                <a:pt x="983875" y="80913"/>
                                <a:pt x="998732" y="79088"/>
                                <a:pt x="1012005" y="71920"/>
                              </a:cubicBezTo>
                              <a:cubicBezTo>
                                <a:pt x="1018878" y="68403"/>
                                <a:pt x="1025581" y="62483"/>
                                <a:pt x="1032553" y="61645"/>
                              </a:cubicBezTo>
                              <a:cubicBezTo>
                                <a:pt x="1042261" y="59986"/>
                                <a:pt x="1052328" y="57513"/>
                                <a:pt x="1063376" y="56508"/>
                              </a:cubicBezTo>
                              <a:cubicBezTo>
                                <a:pt x="1072680" y="55521"/>
                                <a:pt x="1079928" y="52743"/>
                                <a:pt x="1089061" y="51371"/>
                              </a:cubicBezTo>
                              <a:cubicBezTo>
                                <a:pt x="1106876" y="49237"/>
                                <a:pt x="1139853" y="46946"/>
                                <a:pt x="1160980" y="41097"/>
                              </a:cubicBezTo>
                              <a:cubicBezTo>
                                <a:pt x="1169077" y="38720"/>
                                <a:pt x="1177743" y="33637"/>
                                <a:pt x="1186666" y="30823"/>
                              </a:cubicBezTo>
                              <a:cubicBezTo>
                                <a:pt x="1195494" y="27012"/>
                                <a:pt x="1208970" y="27883"/>
                                <a:pt x="1217488" y="25686"/>
                              </a:cubicBezTo>
                              <a:cubicBezTo>
                                <a:pt x="1224034" y="24265"/>
                                <a:pt x="1230483" y="22824"/>
                                <a:pt x="1238036" y="20549"/>
                              </a:cubicBezTo>
                              <a:cubicBezTo>
                                <a:pt x="1242607" y="18320"/>
                                <a:pt x="1248192" y="15379"/>
                                <a:pt x="1253448" y="15412"/>
                              </a:cubicBezTo>
                              <a:cubicBezTo>
                                <a:pt x="1314479" y="6222"/>
                                <a:pt x="1330171" y="5551"/>
                                <a:pt x="1392149" y="0"/>
                              </a:cubicBezTo>
                              <a:cubicBezTo>
                                <a:pt x="1480464" y="15612"/>
                                <a:pt x="1604876" y="17056"/>
                                <a:pt x="1643866" y="5138"/>
                              </a:cubicBezTo>
                              <a:cubicBezTo>
                                <a:pt x="1653897" y="5211"/>
                                <a:pt x="1667742" y="7350"/>
                                <a:pt x="1679825" y="10275"/>
                              </a:cubicBezTo>
                              <a:cubicBezTo>
                                <a:pt x="1697773" y="10646"/>
                                <a:pt x="1715995" y="11700"/>
                                <a:pt x="1731196" y="15412"/>
                              </a:cubicBezTo>
                              <a:cubicBezTo>
                                <a:pt x="1739870" y="18760"/>
                                <a:pt x="1748693" y="22491"/>
                                <a:pt x="1756881" y="25686"/>
                              </a:cubicBezTo>
                              <a:cubicBezTo>
                                <a:pt x="1765384" y="28988"/>
                                <a:pt x="1775193" y="27678"/>
                                <a:pt x="1782567" y="30823"/>
                              </a:cubicBezTo>
                              <a:cubicBezTo>
                                <a:pt x="1788173" y="32158"/>
                                <a:pt x="1792627" y="33973"/>
                                <a:pt x="1797978" y="35960"/>
                              </a:cubicBezTo>
                              <a:cubicBezTo>
                                <a:pt x="1807382" y="38303"/>
                                <a:pt x="1818682" y="39169"/>
                                <a:pt x="1828800" y="41097"/>
                              </a:cubicBezTo>
                              <a:cubicBezTo>
                                <a:pt x="1858566" y="47915"/>
                                <a:pt x="1845349" y="46247"/>
                                <a:pt x="1880171" y="56508"/>
                              </a:cubicBezTo>
                              <a:cubicBezTo>
                                <a:pt x="1908826" y="63313"/>
                                <a:pt x="1940982" y="65358"/>
                                <a:pt x="1967502" y="66782"/>
                              </a:cubicBezTo>
                              <a:cubicBezTo>
                                <a:pt x="2006029" y="84334"/>
                                <a:pt x="1975936" y="72173"/>
                                <a:pt x="2034284" y="82194"/>
                              </a:cubicBezTo>
                              <a:cubicBezTo>
                                <a:pt x="2048120" y="84361"/>
                                <a:pt x="2076984" y="95142"/>
                                <a:pt x="2085654" y="97605"/>
                              </a:cubicBezTo>
                              <a:cubicBezTo>
                                <a:pt x="2093053" y="100593"/>
                                <a:pt x="2104343" y="103673"/>
                                <a:pt x="2111340" y="107879"/>
                              </a:cubicBezTo>
                              <a:cubicBezTo>
                                <a:pt x="2116853" y="110240"/>
                                <a:pt x="2121859" y="114750"/>
                                <a:pt x="2126751" y="118153"/>
                              </a:cubicBezTo>
                              <a:cubicBezTo>
                                <a:pt x="2133619" y="122391"/>
                                <a:pt x="2142366" y="123948"/>
                                <a:pt x="2147299" y="128427"/>
                              </a:cubicBezTo>
                              <a:cubicBezTo>
                                <a:pt x="2154085" y="131753"/>
                                <a:pt x="2157271" y="138858"/>
                                <a:pt x="2162711" y="143839"/>
                              </a:cubicBezTo>
                              <a:cubicBezTo>
                                <a:pt x="2182509" y="160237"/>
                                <a:pt x="2182904" y="151869"/>
                                <a:pt x="2208944" y="169524"/>
                              </a:cubicBezTo>
                              <a:cubicBezTo>
                                <a:pt x="2215274" y="173654"/>
                                <a:pt x="2218829" y="179956"/>
                                <a:pt x="2224355" y="184935"/>
                              </a:cubicBezTo>
                              <a:cubicBezTo>
                                <a:pt x="2228652" y="187903"/>
                                <a:pt x="2234888" y="192710"/>
                                <a:pt x="2239767" y="195209"/>
                              </a:cubicBezTo>
                              <a:cubicBezTo>
                                <a:pt x="2246444" y="200117"/>
                                <a:pt x="2253132" y="204257"/>
                                <a:pt x="2260315" y="210621"/>
                              </a:cubicBezTo>
                              <a:cubicBezTo>
                                <a:pt x="2268308" y="215887"/>
                                <a:pt x="2277345" y="220962"/>
                                <a:pt x="2286000" y="226032"/>
                              </a:cubicBezTo>
                              <a:cubicBezTo>
                                <a:pt x="2291407" y="229406"/>
                                <a:pt x="2296667" y="233154"/>
                                <a:pt x="2301412" y="236306"/>
                              </a:cubicBezTo>
                              <a:cubicBezTo>
                                <a:pt x="2308286" y="240202"/>
                                <a:pt x="2316050" y="242631"/>
                                <a:pt x="2321960" y="246580"/>
                              </a:cubicBezTo>
                              <a:cubicBezTo>
                                <a:pt x="2330540" y="254301"/>
                                <a:pt x="2341103" y="258974"/>
                                <a:pt x="2347645" y="267129"/>
                              </a:cubicBezTo>
                              <a:cubicBezTo>
                                <a:pt x="2350626" y="269955"/>
                                <a:pt x="2353945" y="274534"/>
                                <a:pt x="2357920" y="277403"/>
                              </a:cubicBezTo>
                              <a:cubicBezTo>
                                <a:pt x="2365874" y="284468"/>
                                <a:pt x="2376294" y="287811"/>
                                <a:pt x="2383605" y="292814"/>
                              </a:cubicBezTo>
                              <a:cubicBezTo>
                                <a:pt x="2392633" y="298903"/>
                                <a:pt x="2401087" y="305716"/>
                                <a:pt x="2409290" y="313362"/>
                              </a:cubicBezTo>
                              <a:cubicBezTo>
                                <a:pt x="2421491" y="321135"/>
                                <a:pt x="2429572" y="326742"/>
                                <a:pt x="2440113" y="333911"/>
                              </a:cubicBezTo>
                              <a:cubicBezTo>
                                <a:pt x="2447331" y="340574"/>
                                <a:pt x="2454904" y="348362"/>
                                <a:pt x="2460661" y="354459"/>
                              </a:cubicBezTo>
                              <a:cubicBezTo>
                                <a:pt x="2468373" y="359487"/>
                                <a:pt x="2474084" y="363880"/>
                                <a:pt x="2481209" y="369870"/>
                              </a:cubicBezTo>
                              <a:cubicBezTo>
                                <a:pt x="2490651" y="380668"/>
                                <a:pt x="2501816" y="387775"/>
                                <a:pt x="2512032" y="395555"/>
                              </a:cubicBezTo>
                              <a:cubicBezTo>
                                <a:pt x="2515757" y="399497"/>
                                <a:pt x="2522767" y="402679"/>
                                <a:pt x="2527443" y="405830"/>
                              </a:cubicBezTo>
                              <a:cubicBezTo>
                                <a:pt x="2531818" y="410693"/>
                                <a:pt x="2537048" y="417855"/>
                                <a:pt x="2542854" y="421241"/>
                              </a:cubicBezTo>
                              <a:cubicBezTo>
                                <a:pt x="2550716" y="428368"/>
                                <a:pt x="2559596" y="434928"/>
                                <a:pt x="2568540" y="441789"/>
                              </a:cubicBezTo>
                              <a:cubicBezTo>
                                <a:pt x="2576093" y="447168"/>
                                <a:pt x="2580721" y="455325"/>
                                <a:pt x="2589088" y="462338"/>
                              </a:cubicBezTo>
                              <a:cubicBezTo>
                                <a:pt x="2595910" y="469628"/>
                                <a:pt x="2603301" y="472933"/>
                                <a:pt x="2609636" y="477749"/>
                              </a:cubicBezTo>
                              <a:cubicBezTo>
                                <a:pt x="2613814" y="480625"/>
                                <a:pt x="2616066" y="485697"/>
                                <a:pt x="2619911" y="488023"/>
                              </a:cubicBezTo>
                              <a:cubicBezTo>
                                <a:pt x="2625228" y="492582"/>
                                <a:pt x="2631235" y="493757"/>
                                <a:pt x="2635322" y="498297"/>
                              </a:cubicBezTo>
                              <a:cubicBezTo>
                                <a:pt x="2643132" y="505222"/>
                                <a:pt x="2654558" y="512434"/>
                                <a:pt x="2661007" y="518845"/>
                              </a:cubicBezTo>
                              <a:cubicBezTo>
                                <a:pt x="2676257" y="555813"/>
                                <a:pt x="2657220" y="513161"/>
                                <a:pt x="2686693" y="549668"/>
                              </a:cubicBezTo>
                              <a:cubicBezTo>
                                <a:pt x="2723610" y="595251"/>
                                <a:pt x="2675332" y="554632"/>
                                <a:pt x="2712378" y="580490"/>
                              </a:cubicBezTo>
                              <a:cubicBezTo>
                                <a:pt x="2714341" y="585784"/>
                                <a:pt x="2719141" y="590018"/>
                                <a:pt x="2717515" y="595902"/>
                              </a:cubicBezTo>
                              <a:cubicBezTo>
                                <a:pt x="2716159" y="604983"/>
                                <a:pt x="2689506" y="629340"/>
                                <a:pt x="2686693" y="631861"/>
                              </a:cubicBezTo>
                              <a:cubicBezTo>
                                <a:pt x="2682344" y="635690"/>
                                <a:pt x="2676031" y="638279"/>
                                <a:pt x="2671281" y="642135"/>
                              </a:cubicBezTo>
                              <a:cubicBezTo>
                                <a:pt x="2666629" y="646669"/>
                                <a:pt x="2661751" y="652405"/>
                                <a:pt x="2655870" y="657546"/>
                              </a:cubicBezTo>
                              <a:cubicBezTo>
                                <a:pt x="2648955" y="662732"/>
                                <a:pt x="2618286" y="680951"/>
                                <a:pt x="2614773" y="683232"/>
                              </a:cubicBezTo>
                              <a:cubicBezTo>
                                <a:pt x="2599077" y="711488"/>
                                <a:pt x="2616947" y="686685"/>
                                <a:pt x="2573677" y="714054"/>
                              </a:cubicBezTo>
                              <a:cubicBezTo>
                                <a:pt x="2565675" y="718623"/>
                                <a:pt x="2559519" y="724906"/>
                                <a:pt x="2553129" y="729466"/>
                              </a:cubicBezTo>
                              <a:cubicBezTo>
                                <a:pt x="2544927" y="733457"/>
                                <a:pt x="2536055" y="736259"/>
                                <a:pt x="2527443" y="739740"/>
                              </a:cubicBezTo>
                              <a:cubicBezTo>
                                <a:pt x="2518015" y="744690"/>
                                <a:pt x="2510605" y="751704"/>
                                <a:pt x="2501758" y="755151"/>
                              </a:cubicBezTo>
                              <a:cubicBezTo>
                                <a:pt x="2495842" y="757410"/>
                                <a:pt x="2491130" y="757344"/>
                                <a:pt x="2486346" y="760288"/>
                              </a:cubicBezTo>
                              <a:cubicBezTo>
                                <a:pt x="2467377" y="770901"/>
                                <a:pt x="2451157" y="783058"/>
                                <a:pt x="2434976" y="791111"/>
                              </a:cubicBezTo>
                              <a:cubicBezTo>
                                <a:pt x="2428245" y="794862"/>
                                <a:pt x="2421755" y="797015"/>
                                <a:pt x="2414427" y="801385"/>
                              </a:cubicBezTo>
                              <a:cubicBezTo>
                                <a:pt x="2408325" y="804675"/>
                                <a:pt x="2402414" y="812082"/>
                                <a:pt x="2393879" y="816796"/>
                              </a:cubicBezTo>
                              <a:cubicBezTo>
                                <a:pt x="2387192" y="821795"/>
                                <a:pt x="2380615" y="822837"/>
                                <a:pt x="2373331" y="827070"/>
                              </a:cubicBezTo>
                              <a:cubicBezTo>
                                <a:pt x="2332953" y="851351"/>
                                <a:pt x="2374394" y="835815"/>
                                <a:pt x="2342508" y="847618"/>
                              </a:cubicBezTo>
                              <a:cubicBezTo>
                                <a:pt x="2337459" y="853752"/>
                                <a:pt x="2329385" y="861240"/>
                                <a:pt x="2321960" y="868167"/>
                              </a:cubicBezTo>
                              <a:cubicBezTo>
                                <a:pt x="2301453" y="888181"/>
                                <a:pt x="2287777" y="894874"/>
                                <a:pt x="2265452" y="909263"/>
                              </a:cubicBezTo>
                              <a:cubicBezTo>
                                <a:pt x="2255454" y="924799"/>
                                <a:pt x="2253620" y="928560"/>
                                <a:pt x="2239767" y="940086"/>
                              </a:cubicBezTo>
                              <a:cubicBezTo>
                                <a:pt x="2226514" y="950929"/>
                                <a:pt x="2198670" y="970908"/>
                                <a:pt x="2198670" y="970908"/>
                              </a:cubicBezTo>
                              <a:cubicBezTo>
                                <a:pt x="2185722" y="990267"/>
                                <a:pt x="2187214" y="991599"/>
                                <a:pt x="2162711" y="1006868"/>
                              </a:cubicBezTo>
                              <a:cubicBezTo>
                                <a:pt x="2158486" y="1009283"/>
                                <a:pt x="2152601" y="1009745"/>
                                <a:pt x="2147299" y="1012005"/>
                              </a:cubicBezTo>
                              <a:cubicBezTo>
                                <a:pt x="2142519" y="1016739"/>
                                <a:pt x="2136578" y="1022765"/>
                                <a:pt x="2131888" y="1027416"/>
                              </a:cubicBezTo>
                              <a:cubicBezTo>
                                <a:pt x="2124638" y="1030967"/>
                                <a:pt x="2117513" y="1032690"/>
                                <a:pt x="2111340" y="1037690"/>
                              </a:cubicBezTo>
                              <a:cubicBezTo>
                                <a:pt x="2083851" y="1064457"/>
                                <a:pt x="2122703" y="1048308"/>
                                <a:pt x="2085654" y="1058239"/>
                              </a:cubicBezTo>
                              <a:cubicBezTo>
                                <a:pt x="2080631" y="1062861"/>
                                <a:pt x="2074735" y="1064018"/>
                                <a:pt x="2070243" y="1068513"/>
                              </a:cubicBezTo>
                              <a:cubicBezTo>
                                <a:pt x="2065557" y="1073103"/>
                                <a:pt x="2064444" y="1080034"/>
                                <a:pt x="2059969" y="1083924"/>
                              </a:cubicBezTo>
                              <a:cubicBezTo>
                                <a:pt x="2056097" y="1087693"/>
                                <a:pt x="2049982" y="1087324"/>
                                <a:pt x="2044558" y="1089061"/>
                              </a:cubicBezTo>
                              <a:cubicBezTo>
                                <a:pt x="2037652" y="1092649"/>
                                <a:pt x="2029619" y="1099894"/>
                                <a:pt x="2024009" y="1104472"/>
                              </a:cubicBezTo>
                              <a:cubicBezTo>
                                <a:pt x="2019843" y="1109204"/>
                                <a:pt x="2015399" y="1117061"/>
                                <a:pt x="2008598" y="1119884"/>
                              </a:cubicBezTo>
                              <a:cubicBezTo>
                                <a:pt x="2003393" y="1123473"/>
                                <a:pt x="1998941" y="1123024"/>
                                <a:pt x="1993187" y="1125021"/>
                              </a:cubicBezTo>
                              <a:cubicBezTo>
                                <a:pt x="1987375" y="1131659"/>
                                <a:pt x="1984185" y="1139836"/>
                                <a:pt x="1977776" y="1145569"/>
                              </a:cubicBezTo>
                              <a:cubicBezTo>
                                <a:pt x="1971907" y="1149299"/>
                                <a:pt x="1962970" y="1150590"/>
                                <a:pt x="1957227" y="1155843"/>
                              </a:cubicBezTo>
                              <a:cubicBezTo>
                                <a:pt x="1922443" y="1193451"/>
                                <a:pt x="1968618" y="1171815"/>
                                <a:pt x="1931542" y="1181529"/>
                              </a:cubicBezTo>
                              <a:cubicBezTo>
                                <a:pt x="1917253" y="1197356"/>
                                <a:pt x="1909223" y="1211598"/>
                                <a:pt x="1890445" y="1222625"/>
                              </a:cubicBezTo>
                              <a:cubicBezTo>
                                <a:pt x="1872864" y="1229125"/>
                                <a:pt x="1856866" y="1238253"/>
                                <a:pt x="1844212" y="1253448"/>
                              </a:cubicBezTo>
                              <a:cubicBezTo>
                                <a:pt x="1840504" y="1258006"/>
                                <a:pt x="1837748" y="1264542"/>
                                <a:pt x="1833937" y="1268859"/>
                              </a:cubicBezTo>
                              <a:cubicBezTo>
                                <a:pt x="1837392" y="1272461"/>
                                <a:pt x="1840537" y="1277358"/>
                                <a:pt x="1844212" y="1279133"/>
                              </a:cubicBezTo>
                              <a:cubicBezTo>
                                <a:pt x="1863294" y="1290507"/>
                                <a:pt x="1887539" y="1281371"/>
                                <a:pt x="1905857" y="1273996"/>
                              </a:cubicBezTo>
                              <a:cubicBezTo>
                                <a:pt x="1981276" y="1257562"/>
                                <a:pt x="1918314" y="1274746"/>
                                <a:pt x="1972639" y="1253448"/>
                              </a:cubicBezTo>
                              <a:cubicBezTo>
                                <a:pt x="1981783" y="1251514"/>
                                <a:pt x="1992166" y="1244524"/>
                                <a:pt x="2003461" y="1243173"/>
                              </a:cubicBezTo>
                              <a:cubicBezTo>
                                <a:pt x="2019264" y="1239563"/>
                                <a:pt x="2033244" y="1242778"/>
                                <a:pt x="2044558" y="1238036"/>
                              </a:cubicBezTo>
                              <a:cubicBezTo>
                                <a:pt x="2095005" y="1212208"/>
                                <a:pt x="2017286" y="1234517"/>
                                <a:pt x="2085654" y="1227762"/>
                              </a:cubicBezTo>
                              <a:cubicBezTo>
                                <a:pt x="2096207" y="1225458"/>
                                <a:pt x="2106971" y="1220338"/>
                                <a:pt x="2116477" y="1217488"/>
                              </a:cubicBezTo>
                              <a:cubicBezTo>
                                <a:pt x="2120485" y="1215702"/>
                                <a:pt x="2125937" y="1213764"/>
                                <a:pt x="2131888" y="1212351"/>
                              </a:cubicBezTo>
                              <a:cubicBezTo>
                                <a:pt x="2137513" y="1211428"/>
                                <a:pt x="2142431" y="1208820"/>
                                <a:pt x="2147299" y="1207214"/>
                              </a:cubicBezTo>
                              <a:cubicBezTo>
                                <a:pt x="2155999" y="1204355"/>
                                <a:pt x="2163984" y="1199760"/>
                                <a:pt x="2172985" y="1196940"/>
                              </a:cubicBezTo>
                              <a:cubicBezTo>
                                <a:pt x="2186442" y="1193697"/>
                                <a:pt x="2199789" y="1192489"/>
                                <a:pt x="2214081" y="1186666"/>
                              </a:cubicBezTo>
                              <a:cubicBezTo>
                                <a:pt x="2220881" y="1186296"/>
                                <a:pt x="2230573" y="1183583"/>
                                <a:pt x="2234630" y="1181529"/>
                              </a:cubicBezTo>
                              <a:cubicBezTo>
                                <a:pt x="2242764" y="1177481"/>
                                <a:pt x="2247686" y="1175150"/>
                                <a:pt x="2255178" y="1171254"/>
                              </a:cubicBezTo>
                              <a:cubicBezTo>
                                <a:pt x="2263071" y="1166122"/>
                                <a:pt x="2270843" y="1159553"/>
                                <a:pt x="2280863" y="1155843"/>
                              </a:cubicBezTo>
                              <a:cubicBezTo>
                                <a:pt x="2341454" y="1133749"/>
                                <a:pt x="2226721" y="1199309"/>
                                <a:pt x="2332234" y="1140432"/>
                              </a:cubicBezTo>
                              <a:cubicBezTo>
                                <a:pt x="2434971" y="1089471"/>
                                <a:pt x="2321714" y="1136142"/>
                                <a:pt x="2404153" y="1109609"/>
                              </a:cubicBezTo>
                              <a:cubicBezTo>
                                <a:pt x="2412129" y="1106118"/>
                                <a:pt x="2417900" y="1103039"/>
                                <a:pt x="2424702" y="1099335"/>
                              </a:cubicBezTo>
                              <a:cubicBezTo>
                                <a:pt x="2430456" y="1095668"/>
                                <a:pt x="2434635" y="1090395"/>
                                <a:pt x="2440113" y="1089061"/>
                              </a:cubicBezTo>
                              <a:cubicBezTo>
                                <a:pt x="2452344" y="1082883"/>
                                <a:pt x="2492851" y="1073178"/>
                                <a:pt x="2506895" y="1068513"/>
                              </a:cubicBezTo>
                              <a:cubicBezTo>
                                <a:pt x="2572112" y="1028892"/>
                                <a:pt x="2485438" y="1067517"/>
                                <a:pt x="2558266" y="1047964"/>
                              </a:cubicBezTo>
                              <a:cubicBezTo>
                                <a:pt x="2564906" y="1045574"/>
                                <a:pt x="2568401" y="1040713"/>
                                <a:pt x="2573677" y="1037690"/>
                              </a:cubicBezTo>
                              <a:cubicBezTo>
                                <a:pt x="2582304" y="1033061"/>
                                <a:pt x="2590925" y="1031774"/>
                                <a:pt x="2599362" y="1027416"/>
                              </a:cubicBezTo>
                              <a:cubicBezTo>
                                <a:pt x="2611704" y="1020076"/>
                                <a:pt x="2629476" y="1017195"/>
                                <a:pt x="2640459" y="1006868"/>
                              </a:cubicBezTo>
                              <a:cubicBezTo>
                                <a:pt x="2648330" y="1000846"/>
                                <a:pt x="2653496" y="996268"/>
                                <a:pt x="2661007" y="991457"/>
                              </a:cubicBezTo>
                              <a:cubicBezTo>
                                <a:pt x="2668096" y="988814"/>
                                <a:pt x="2675773" y="987694"/>
                                <a:pt x="2681555" y="986320"/>
                              </a:cubicBezTo>
                              <a:cubicBezTo>
                                <a:pt x="2692077" y="979067"/>
                                <a:pt x="2712611" y="964228"/>
                                <a:pt x="2722652" y="960634"/>
                              </a:cubicBezTo>
                              <a:cubicBezTo>
                                <a:pt x="2729269" y="958071"/>
                                <a:pt x="2736869" y="957778"/>
                                <a:pt x="2743200" y="955497"/>
                              </a:cubicBezTo>
                              <a:cubicBezTo>
                                <a:pt x="2752082" y="950937"/>
                                <a:pt x="2760464" y="949258"/>
                                <a:pt x="2768886" y="945223"/>
                              </a:cubicBezTo>
                              <a:cubicBezTo>
                                <a:pt x="2773799" y="943261"/>
                                <a:pt x="2778389" y="937937"/>
                                <a:pt x="2784297" y="934949"/>
                              </a:cubicBezTo>
                              <a:cubicBezTo>
                                <a:pt x="2791689" y="932144"/>
                                <a:pt x="2800577" y="928840"/>
                                <a:pt x="2809982" y="924675"/>
                              </a:cubicBezTo>
                              <a:cubicBezTo>
                                <a:pt x="2841550" y="912870"/>
                                <a:pt x="2835542" y="916407"/>
                                <a:pt x="2866490" y="909263"/>
                              </a:cubicBezTo>
                              <a:cubicBezTo>
                                <a:pt x="2878481" y="910285"/>
                                <a:pt x="2890678" y="910644"/>
                                <a:pt x="2902450" y="914400"/>
                              </a:cubicBezTo>
                              <a:cubicBezTo>
                                <a:pt x="2908066" y="916084"/>
                                <a:pt x="2914039" y="920771"/>
                                <a:pt x="2917861" y="924675"/>
                              </a:cubicBezTo>
                              <a:cubicBezTo>
                                <a:pt x="2923611" y="931760"/>
                                <a:pt x="2934097" y="952551"/>
                                <a:pt x="2938409" y="960634"/>
                              </a:cubicBezTo>
                              <a:cubicBezTo>
                                <a:pt x="2942884" y="980141"/>
                                <a:pt x="2943511" y="996340"/>
                                <a:pt x="2948684" y="1012005"/>
                              </a:cubicBezTo>
                              <a:cubicBezTo>
                                <a:pt x="2956397" y="1032026"/>
                                <a:pt x="2952730" y="1022210"/>
                                <a:pt x="2958958" y="1047964"/>
                              </a:cubicBezTo>
                              <a:cubicBezTo>
                                <a:pt x="2962475" y="1108077"/>
                                <a:pt x="2961854" y="1114611"/>
                                <a:pt x="2969232" y="1166117"/>
                              </a:cubicBezTo>
                              <a:cubicBezTo>
                                <a:pt x="2970576" y="1178100"/>
                                <a:pt x="2973520" y="1189796"/>
                                <a:pt x="2974369" y="1202077"/>
                              </a:cubicBezTo>
                              <a:cubicBezTo>
                                <a:pt x="2977584" y="1221699"/>
                                <a:pt x="2986920" y="1237638"/>
                                <a:pt x="2989780" y="1253448"/>
                              </a:cubicBezTo>
                              <a:cubicBezTo>
                                <a:pt x="2996062" y="1478013"/>
                                <a:pt x="2997686" y="1499175"/>
                                <a:pt x="2989780" y="1720922"/>
                              </a:cubicBezTo>
                              <a:cubicBezTo>
                                <a:pt x="2987252" y="1753032"/>
                                <a:pt x="2982869" y="1759969"/>
                                <a:pt x="2974369" y="1792841"/>
                              </a:cubicBezTo>
                              <a:cubicBezTo>
                                <a:pt x="2972255" y="1801855"/>
                                <a:pt x="2971556" y="1809881"/>
                                <a:pt x="2969232" y="1818526"/>
                              </a:cubicBezTo>
                              <a:cubicBezTo>
                                <a:pt x="2967191" y="1823157"/>
                                <a:pt x="2965162" y="1828572"/>
                                <a:pt x="2964095" y="1833938"/>
                              </a:cubicBezTo>
                              <a:cubicBezTo>
                                <a:pt x="2960437" y="1843475"/>
                                <a:pt x="2963017" y="1854257"/>
                                <a:pt x="2958958" y="1864760"/>
                              </a:cubicBezTo>
                              <a:cubicBezTo>
                                <a:pt x="2957444" y="1869938"/>
                                <a:pt x="2955095" y="1874240"/>
                                <a:pt x="2953821" y="1880171"/>
                              </a:cubicBezTo>
                              <a:cubicBezTo>
                                <a:pt x="2951478" y="1886811"/>
                                <a:pt x="2951076" y="1894157"/>
                                <a:pt x="2948684" y="1900720"/>
                              </a:cubicBezTo>
                              <a:cubicBezTo>
                                <a:pt x="2948135" y="1905923"/>
                                <a:pt x="2944194" y="1911173"/>
                                <a:pt x="2943546" y="1916131"/>
                              </a:cubicBezTo>
                              <a:cubicBezTo>
                                <a:pt x="2940492" y="1931118"/>
                                <a:pt x="2937416" y="1943999"/>
                                <a:pt x="2933272" y="1957227"/>
                              </a:cubicBezTo>
                              <a:cubicBezTo>
                                <a:pt x="2930800" y="1961854"/>
                                <a:pt x="2929504" y="1966541"/>
                                <a:pt x="2928135" y="1972639"/>
                              </a:cubicBezTo>
                              <a:cubicBezTo>
                                <a:pt x="2916039" y="2016338"/>
                                <a:pt x="2927071" y="1982351"/>
                                <a:pt x="2912724" y="2018872"/>
                              </a:cubicBezTo>
                              <a:cubicBezTo>
                                <a:pt x="2895124" y="2065577"/>
                                <a:pt x="2931049" y="1971458"/>
                                <a:pt x="2902450" y="2075380"/>
                              </a:cubicBezTo>
                              <a:cubicBezTo>
                                <a:pt x="2901669" y="2081651"/>
                                <a:pt x="2898011" y="2086136"/>
                                <a:pt x="2897313" y="2090791"/>
                              </a:cubicBezTo>
                              <a:cubicBezTo>
                                <a:pt x="2895365" y="2099162"/>
                                <a:pt x="2894920" y="2108099"/>
                                <a:pt x="2892176" y="2116477"/>
                              </a:cubicBezTo>
                              <a:cubicBezTo>
                                <a:pt x="2885346" y="2140160"/>
                                <a:pt x="2881883" y="2137461"/>
                                <a:pt x="2876764" y="2157573"/>
                              </a:cubicBezTo>
                              <a:cubicBezTo>
                                <a:pt x="2868949" y="2179590"/>
                                <a:pt x="2872631" y="2191758"/>
                                <a:pt x="2861353" y="2214081"/>
                              </a:cubicBezTo>
                              <a:cubicBezTo>
                                <a:pt x="2853686" y="2227550"/>
                                <a:pt x="2846060" y="2240036"/>
                                <a:pt x="2840805" y="2255178"/>
                              </a:cubicBezTo>
                              <a:cubicBezTo>
                                <a:pt x="2839383" y="2262397"/>
                                <a:pt x="2838723" y="2267917"/>
                                <a:pt x="2835668" y="2275726"/>
                              </a:cubicBezTo>
                              <a:cubicBezTo>
                                <a:pt x="2823810" y="2301645"/>
                                <a:pt x="2818068" y="2307616"/>
                                <a:pt x="2804845" y="2332234"/>
                              </a:cubicBezTo>
                              <a:cubicBezTo>
                                <a:pt x="2784514" y="2368947"/>
                                <a:pt x="2802740" y="2336227"/>
                                <a:pt x="2779160" y="2373331"/>
                              </a:cubicBezTo>
                              <a:cubicBezTo>
                                <a:pt x="2777829" y="2378819"/>
                                <a:pt x="2777600" y="2383890"/>
                                <a:pt x="2774023" y="2388742"/>
                              </a:cubicBezTo>
                              <a:cubicBezTo>
                                <a:pt x="2766758" y="2398428"/>
                                <a:pt x="2748337" y="2414426"/>
                                <a:pt x="2748337" y="2414427"/>
                              </a:cubicBezTo>
                              <a:cubicBezTo>
                                <a:pt x="2727664" y="2473872"/>
                                <a:pt x="2746348" y="2415147"/>
                                <a:pt x="2717515" y="2460661"/>
                              </a:cubicBezTo>
                              <a:cubicBezTo>
                                <a:pt x="2714330" y="2464594"/>
                                <a:pt x="2715885" y="2472479"/>
                                <a:pt x="2712378" y="2476072"/>
                              </a:cubicBezTo>
                              <a:cubicBezTo>
                                <a:pt x="2706951" y="2484510"/>
                                <a:pt x="2699089" y="2489120"/>
                                <a:pt x="2691830" y="2496621"/>
                              </a:cubicBezTo>
                              <a:cubicBezTo>
                                <a:pt x="2636080" y="2548526"/>
                                <a:pt x="2703422" y="2490692"/>
                                <a:pt x="2655870" y="2542854"/>
                              </a:cubicBezTo>
                              <a:cubicBezTo>
                                <a:pt x="2654054" y="2548756"/>
                                <a:pt x="2654332" y="2553848"/>
                                <a:pt x="2650733" y="2558266"/>
                              </a:cubicBezTo>
                              <a:cubicBezTo>
                                <a:pt x="2629499" y="2588127"/>
                                <a:pt x="2617429" y="2587088"/>
                                <a:pt x="2594225" y="2609636"/>
                              </a:cubicBezTo>
                              <a:cubicBezTo>
                                <a:pt x="2586018" y="2617286"/>
                                <a:pt x="2581073" y="2624004"/>
                                <a:pt x="2573677" y="2630185"/>
                              </a:cubicBezTo>
                              <a:cubicBezTo>
                                <a:pt x="2568862" y="2634310"/>
                                <a:pt x="2564002" y="2636777"/>
                                <a:pt x="2558266" y="2640459"/>
                              </a:cubicBezTo>
                              <a:cubicBezTo>
                                <a:pt x="2533251" y="2658139"/>
                                <a:pt x="2556290" y="2649390"/>
                                <a:pt x="2527443" y="2661007"/>
                              </a:cubicBezTo>
                              <a:cubicBezTo>
                                <a:pt x="2477740" y="2699398"/>
                                <a:pt x="2498420" y="2684574"/>
                                <a:pt x="2460661" y="2707241"/>
                              </a:cubicBezTo>
                              <a:cubicBezTo>
                                <a:pt x="2457999" y="2713122"/>
                                <a:pt x="2454807" y="2719592"/>
                                <a:pt x="2450387" y="2722652"/>
                              </a:cubicBezTo>
                              <a:cubicBezTo>
                                <a:pt x="2446147" y="2726108"/>
                                <a:pt x="2418949" y="2734037"/>
                                <a:pt x="2409290" y="2738063"/>
                              </a:cubicBezTo>
                              <a:cubicBezTo>
                                <a:pt x="2402713" y="2736852"/>
                                <a:pt x="2395801" y="2734705"/>
                                <a:pt x="2388742" y="2732926"/>
                              </a:cubicBezTo>
                              <a:cubicBezTo>
                                <a:pt x="2373215" y="2728149"/>
                                <a:pt x="2342508" y="2717516"/>
                                <a:pt x="2342508" y="2717515"/>
                              </a:cubicBezTo>
                              <a:cubicBezTo>
                                <a:pt x="2318111" y="2683451"/>
                                <a:pt x="2348672" y="2722299"/>
                                <a:pt x="2311686" y="2691830"/>
                              </a:cubicBezTo>
                              <a:cubicBezTo>
                                <a:pt x="2299173" y="2680961"/>
                                <a:pt x="2288945" y="2665321"/>
                                <a:pt x="2275726" y="2655870"/>
                              </a:cubicBezTo>
                              <a:cubicBezTo>
                                <a:pt x="2271485" y="2649308"/>
                                <a:pt x="2266517" y="2645670"/>
                                <a:pt x="2260315" y="2640459"/>
                              </a:cubicBezTo>
                              <a:cubicBezTo>
                                <a:pt x="2257127" y="2627343"/>
                                <a:pt x="2256296" y="2619826"/>
                                <a:pt x="2244904" y="2609636"/>
                              </a:cubicBezTo>
                              <a:cubicBezTo>
                                <a:pt x="2238468" y="2604394"/>
                                <a:pt x="2232115" y="2599180"/>
                                <a:pt x="2224355" y="2594225"/>
                              </a:cubicBezTo>
                              <a:cubicBezTo>
                                <a:pt x="2214809" y="2575167"/>
                                <a:pt x="2215424" y="2574310"/>
                                <a:pt x="2203807" y="2558266"/>
                              </a:cubicBezTo>
                              <a:cubicBezTo>
                                <a:pt x="2193298" y="2543068"/>
                                <a:pt x="2179073" y="2531515"/>
                                <a:pt x="2172985" y="2517169"/>
                              </a:cubicBezTo>
                              <a:cubicBezTo>
                                <a:pt x="2168045" y="2502724"/>
                                <a:pt x="2162143" y="2487685"/>
                                <a:pt x="2152436" y="2476072"/>
                              </a:cubicBezTo>
                              <a:cubicBezTo>
                                <a:pt x="2146889" y="2464026"/>
                                <a:pt x="2136459" y="2456248"/>
                                <a:pt x="2131888" y="2445250"/>
                              </a:cubicBezTo>
                              <a:cubicBezTo>
                                <a:pt x="2131873" y="2438160"/>
                                <a:pt x="2119959" y="2414020"/>
                                <a:pt x="2111340" y="2404153"/>
                              </a:cubicBezTo>
                              <a:cubicBezTo>
                                <a:pt x="2106104" y="2394038"/>
                                <a:pt x="2102257" y="2381559"/>
                                <a:pt x="2095929" y="2373331"/>
                              </a:cubicBezTo>
                              <a:cubicBezTo>
                                <a:pt x="2077009" y="2345981"/>
                                <a:pt x="2057177" y="2315459"/>
                                <a:pt x="2044558" y="2291138"/>
                              </a:cubicBezTo>
                              <a:cubicBezTo>
                                <a:pt x="2041666" y="2284854"/>
                                <a:pt x="2038207" y="2277970"/>
                                <a:pt x="2034284" y="2270589"/>
                              </a:cubicBezTo>
                              <a:cubicBezTo>
                                <a:pt x="2028219" y="2261656"/>
                                <a:pt x="2020866" y="2252153"/>
                                <a:pt x="2013735" y="2244904"/>
                              </a:cubicBezTo>
                              <a:cubicBezTo>
                                <a:pt x="2009815" y="2238320"/>
                                <a:pt x="2007915" y="2231156"/>
                                <a:pt x="2003461" y="2224355"/>
                              </a:cubicBezTo>
                              <a:cubicBezTo>
                                <a:pt x="1996394" y="2215113"/>
                                <a:pt x="1991489" y="2208148"/>
                                <a:pt x="1982913" y="2198670"/>
                              </a:cubicBezTo>
                              <a:cubicBezTo>
                                <a:pt x="1962572" y="2170651"/>
                                <a:pt x="1982602" y="2190654"/>
                                <a:pt x="1962364" y="2172985"/>
                              </a:cubicBezTo>
                              <a:cubicBezTo>
                                <a:pt x="1954363" y="2147897"/>
                                <a:pt x="1961428" y="2164090"/>
                                <a:pt x="1941816" y="2137025"/>
                              </a:cubicBezTo>
                              <a:cubicBezTo>
                                <a:pt x="1937649" y="2131733"/>
                                <a:pt x="1935215" y="2127006"/>
                                <a:pt x="1931542" y="2121614"/>
                              </a:cubicBezTo>
                              <a:cubicBezTo>
                                <a:pt x="1926603" y="2116293"/>
                                <a:pt x="1921630" y="2111734"/>
                                <a:pt x="1916131" y="2106203"/>
                              </a:cubicBezTo>
                              <a:cubicBezTo>
                                <a:pt x="1911822" y="2100377"/>
                                <a:pt x="1909551" y="2094693"/>
                                <a:pt x="1905857" y="2090791"/>
                              </a:cubicBezTo>
                              <a:cubicBezTo>
                                <a:pt x="1835594" y="2016816"/>
                                <a:pt x="1902788" y="2098986"/>
                                <a:pt x="1869897" y="2049695"/>
                              </a:cubicBezTo>
                              <a:cubicBezTo>
                                <a:pt x="1860616" y="2036041"/>
                                <a:pt x="1847632" y="2021372"/>
                                <a:pt x="1839075" y="2008598"/>
                              </a:cubicBezTo>
                              <a:cubicBezTo>
                                <a:pt x="1831153" y="2001164"/>
                                <a:pt x="1827542" y="1993718"/>
                                <a:pt x="1823663" y="1988050"/>
                              </a:cubicBezTo>
                              <a:cubicBezTo>
                                <a:pt x="1826895" y="2016568"/>
                                <a:pt x="1826424" y="2032591"/>
                                <a:pt x="1833937" y="2059969"/>
                              </a:cubicBezTo>
                              <a:cubicBezTo>
                                <a:pt x="1836222" y="2074947"/>
                                <a:pt x="1842092" y="2081451"/>
                                <a:pt x="1849349" y="2095929"/>
                              </a:cubicBezTo>
                              <a:cubicBezTo>
                                <a:pt x="1851693" y="2114172"/>
                                <a:pt x="1853114" y="2140001"/>
                                <a:pt x="1859623" y="2157573"/>
                              </a:cubicBezTo>
                              <a:cubicBezTo>
                                <a:pt x="1861104" y="2162416"/>
                                <a:pt x="1862917" y="2167441"/>
                                <a:pt x="1864760" y="2172985"/>
                              </a:cubicBezTo>
                              <a:cubicBezTo>
                                <a:pt x="1868014" y="2181100"/>
                                <a:pt x="1876456" y="2202072"/>
                                <a:pt x="1880171" y="2214081"/>
                              </a:cubicBezTo>
                              <a:cubicBezTo>
                                <a:pt x="1882486" y="2222719"/>
                                <a:pt x="1883790" y="2230679"/>
                                <a:pt x="1885308" y="2239767"/>
                              </a:cubicBezTo>
                              <a:cubicBezTo>
                                <a:pt x="1907327" y="2323716"/>
                                <a:pt x="1871037" y="2208245"/>
                                <a:pt x="1900720" y="2275726"/>
                              </a:cubicBezTo>
                              <a:cubicBezTo>
                                <a:pt x="1902340" y="2282792"/>
                                <a:pt x="1903942" y="2288427"/>
                                <a:pt x="1905857" y="2296275"/>
                              </a:cubicBezTo>
                              <a:cubicBezTo>
                                <a:pt x="1907512" y="2303650"/>
                                <a:pt x="1907418" y="2314623"/>
                                <a:pt x="1910994" y="2321960"/>
                              </a:cubicBezTo>
                              <a:cubicBezTo>
                                <a:pt x="1916803" y="2333357"/>
                                <a:pt x="1920575" y="2342939"/>
                                <a:pt x="1926405" y="2352782"/>
                              </a:cubicBezTo>
                              <a:cubicBezTo>
                                <a:pt x="1930621" y="2364471"/>
                                <a:pt x="1931420" y="2371923"/>
                                <a:pt x="1936679" y="2383605"/>
                              </a:cubicBezTo>
                              <a:cubicBezTo>
                                <a:pt x="1945396" y="2399947"/>
                                <a:pt x="1967502" y="2429838"/>
                                <a:pt x="1967502" y="2429839"/>
                              </a:cubicBezTo>
                              <a:cubicBezTo>
                                <a:pt x="1970231" y="2438121"/>
                                <a:pt x="1971924" y="2450340"/>
                                <a:pt x="1977776" y="2460661"/>
                              </a:cubicBezTo>
                              <a:cubicBezTo>
                                <a:pt x="2000886" y="2520134"/>
                                <a:pt x="1977114" y="2445294"/>
                                <a:pt x="1998324" y="2506895"/>
                              </a:cubicBezTo>
                              <a:cubicBezTo>
                                <a:pt x="2001303" y="2513610"/>
                                <a:pt x="2005791" y="2519558"/>
                                <a:pt x="2008598" y="2527443"/>
                              </a:cubicBezTo>
                              <a:cubicBezTo>
                                <a:pt x="2052032" y="2601403"/>
                                <a:pt x="1990865" y="2520684"/>
                                <a:pt x="2034284" y="2583951"/>
                              </a:cubicBezTo>
                              <a:cubicBezTo>
                                <a:pt x="2034554" y="2594781"/>
                                <a:pt x="2037223" y="2604227"/>
                                <a:pt x="2039421" y="2614773"/>
                              </a:cubicBezTo>
                              <a:cubicBezTo>
                                <a:pt x="2045289" y="2640602"/>
                                <a:pt x="2043036" y="2627520"/>
                                <a:pt x="2049695" y="2650733"/>
                              </a:cubicBezTo>
                              <a:cubicBezTo>
                                <a:pt x="2051058" y="2657068"/>
                                <a:pt x="2053163" y="2664137"/>
                                <a:pt x="2054832" y="2671281"/>
                              </a:cubicBezTo>
                              <a:cubicBezTo>
                                <a:pt x="2061323" y="2691082"/>
                                <a:pt x="2066047" y="2702224"/>
                                <a:pt x="2070243" y="2722652"/>
                              </a:cubicBezTo>
                              <a:cubicBezTo>
                                <a:pt x="2070465" y="2735547"/>
                                <a:pt x="2075037" y="2747352"/>
                                <a:pt x="2075380" y="2758612"/>
                              </a:cubicBezTo>
                              <a:cubicBezTo>
                                <a:pt x="2081364" y="2774540"/>
                                <a:pt x="2083037" y="2791372"/>
                                <a:pt x="2085654" y="2809982"/>
                              </a:cubicBezTo>
                              <a:cubicBezTo>
                                <a:pt x="2088481" y="2822132"/>
                                <a:pt x="2088895" y="2823433"/>
                                <a:pt x="2090791" y="2835668"/>
                              </a:cubicBezTo>
                              <a:cubicBezTo>
                                <a:pt x="2089546" y="2868530"/>
                                <a:pt x="2093516" y="2931617"/>
                                <a:pt x="2059969" y="2964095"/>
                              </a:cubicBezTo>
                              <a:cubicBezTo>
                                <a:pt x="2055250" y="2967933"/>
                                <a:pt x="2049308" y="2967254"/>
                                <a:pt x="2044558" y="2969232"/>
                              </a:cubicBezTo>
                              <a:cubicBezTo>
                                <a:pt x="2037676" y="2971878"/>
                                <a:pt x="2030175" y="2976034"/>
                                <a:pt x="2024009" y="2979506"/>
                              </a:cubicBezTo>
                              <a:cubicBezTo>
                                <a:pt x="2018801" y="2982121"/>
                                <a:pt x="2013397" y="2982580"/>
                                <a:pt x="2008598" y="2984643"/>
                              </a:cubicBezTo>
                              <a:cubicBezTo>
                                <a:pt x="1993508" y="2992034"/>
                                <a:pt x="1987562" y="2997725"/>
                                <a:pt x="1972639" y="3000054"/>
                              </a:cubicBezTo>
                              <a:cubicBezTo>
                                <a:pt x="1962463" y="3001793"/>
                                <a:pt x="1948461" y="3002836"/>
                                <a:pt x="1936679" y="3005191"/>
                              </a:cubicBezTo>
                              <a:cubicBezTo>
                                <a:pt x="1868653" y="3014767"/>
                                <a:pt x="1992555" y="2997187"/>
                                <a:pt x="1880171" y="3015466"/>
                              </a:cubicBezTo>
                              <a:cubicBezTo>
                                <a:pt x="1849817" y="3017857"/>
                                <a:pt x="1818050" y="3018018"/>
                                <a:pt x="1787704" y="3025740"/>
                              </a:cubicBezTo>
                              <a:cubicBezTo>
                                <a:pt x="1765303" y="3029871"/>
                                <a:pt x="1738786" y="3028274"/>
                                <a:pt x="1715785" y="3030877"/>
                              </a:cubicBezTo>
                              <a:cubicBezTo>
                                <a:pt x="1632200" y="3019977"/>
                                <a:pt x="1546134" y="3035323"/>
                                <a:pt x="1469205" y="3036014"/>
                              </a:cubicBezTo>
                              <a:cubicBezTo>
                                <a:pt x="1451950" y="3035091"/>
                                <a:pt x="1321180" y="3029894"/>
                                <a:pt x="1284270" y="3025740"/>
                              </a:cubicBezTo>
                              <a:cubicBezTo>
                                <a:pt x="1162429" y="3009975"/>
                                <a:pt x="1302942" y="3020951"/>
                                <a:pt x="1186666" y="3000054"/>
                              </a:cubicBezTo>
                              <a:cubicBezTo>
                                <a:pt x="1179689" y="2999071"/>
                                <a:pt x="1170425" y="2995936"/>
                                <a:pt x="1160980" y="2994917"/>
                              </a:cubicBezTo>
                              <a:cubicBezTo>
                                <a:pt x="1075996" y="2968870"/>
                                <a:pt x="1150752" y="2985838"/>
                                <a:pt x="1089061" y="2974369"/>
                              </a:cubicBezTo>
                              <a:cubicBezTo>
                                <a:pt x="1063217" y="2952070"/>
                                <a:pt x="1083251" y="2963504"/>
                                <a:pt x="1042827" y="2958958"/>
                              </a:cubicBezTo>
                              <a:cubicBezTo>
                                <a:pt x="1037171" y="2957056"/>
                                <a:pt x="1032606" y="2954714"/>
                                <a:pt x="1027416" y="2953821"/>
                              </a:cubicBezTo>
                              <a:cubicBezTo>
                                <a:pt x="1016816" y="2952147"/>
                                <a:pt x="1007544" y="2951033"/>
                                <a:pt x="996594" y="2948684"/>
                              </a:cubicBezTo>
                              <a:cubicBezTo>
                                <a:pt x="988630" y="2945770"/>
                                <a:pt x="978694" y="2941815"/>
                                <a:pt x="970908" y="2938409"/>
                              </a:cubicBezTo>
                              <a:cubicBezTo>
                                <a:pt x="960109" y="2935314"/>
                                <a:pt x="948944" y="2934118"/>
                                <a:pt x="940086" y="2928135"/>
                              </a:cubicBezTo>
                              <a:cubicBezTo>
                                <a:pt x="919410" y="2913165"/>
                                <a:pt x="930954" y="2919250"/>
                                <a:pt x="904126" y="2912724"/>
                              </a:cubicBezTo>
                              <a:cubicBezTo>
                                <a:pt x="897130" y="2908945"/>
                                <a:pt x="890475" y="2905089"/>
                                <a:pt x="883578" y="2902450"/>
                              </a:cubicBezTo>
                              <a:cubicBezTo>
                                <a:pt x="876357" y="2900227"/>
                                <a:pt x="868469" y="2900532"/>
                                <a:pt x="863030" y="2897313"/>
                              </a:cubicBezTo>
                              <a:cubicBezTo>
                                <a:pt x="852850" y="2891600"/>
                                <a:pt x="843024" y="2882574"/>
                                <a:pt x="832207" y="2876764"/>
                              </a:cubicBezTo>
                              <a:cubicBezTo>
                                <a:pt x="807521" y="2867952"/>
                                <a:pt x="790335" y="2862811"/>
                                <a:pt x="765425" y="2845942"/>
                              </a:cubicBezTo>
                              <a:cubicBezTo>
                                <a:pt x="757732" y="2841372"/>
                                <a:pt x="749276" y="2836587"/>
                                <a:pt x="739740" y="2830531"/>
                              </a:cubicBezTo>
                              <a:cubicBezTo>
                                <a:pt x="731844" y="2826775"/>
                                <a:pt x="725761" y="2819460"/>
                                <a:pt x="719191" y="2815120"/>
                              </a:cubicBezTo>
                              <a:cubicBezTo>
                                <a:pt x="710804" y="2811220"/>
                                <a:pt x="703294" y="2811225"/>
                                <a:pt x="693506" y="2809982"/>
                              </a:cubicBezTo>
                              <a:cubicBezTo>
                                <a:pt x="689934" y="2804838"/>
                                <a:pt x="687923" y="2798390"/>
                                <a:pt x="683232" y="2794571"/>
                              </a:cubicBezTo>
                              <a:cubicBezTo>
                                <a:pt x="664202" y="2777905"/>
                                <a:pt x="646824" y="2776208"/>
                                <a:pt x="626724" y="2768886"/>
                              </a:cubicBezTo>
                              <a:cubicBezTo>
                                <a:pt x="619139" y="2764621"/>
                                <a:pt x="612829" y="2759553"/>
                                <a:pt x="606176" y="2753475"/>
                              </a:cubicBezTo>
                              <a:cubicBezTo>
                                <a:pt x="572458" y="2729431"/>
                                <a:pt x="605532" y="2755776"/>
                                <a:pt x="570216" y="2722652"/>
                              </a:cubicBezTo>
                              <a:cubicBezTo>
                                <a:pt x="554988" y="2712109"/>
                                <a:pt x="523982" y="2691829"/>
                                <a:pt x="523982" y="2691830"/>
                              </a:cubicBezTo>
                              <a:cubicBezTo>
                                <a:pt x="513698" y="2676249"/>
                                <a:pt x="513198" y="2673357"/>
                                <a:pt x="498297" y="2661007"/>
                              </a:cubicBezTo>
                              <a:cubicBezTo>
                                <a:pt x="493370" y="2657072"/>
                                <a:pt x="487503" y="2654687"/>
                                <a:pt x="482886" y="2650733"/>
                              </a:cubicBezTo>
                              <a:cubicBezTo>
                                <a:pt x="472299" y="2638196"/>
                                <a:pt x="458784" y="2625753"/>
                                <a:pt x="446926" y="2614773"/>
                              </a:cubicBezTo>
                              <a:cubicBezTo>
                                <a:pt x="439668" y="2609315"/>
                                <a:pt x="428672" y="2601809"/>
                                <a:pt x="421241" y="2594225"/>
                              </a:cubicBezTo>
                              <a:cubicBezTo>
                                <a:pt x="417014" y="2589887"/>
                                <a:pt x="416016" y="2583669"/>
                                <a:pt x="410967" y="2578814"/>
                              </a:cubicBezTo>
                              <a:cubicBezTo>
                                <a:pt x="406728" y="2574317"/>
                                <a:pt x="400283" y="2572719"/>
                                <a:pt x="395555" y="2568540"/>
                              </a:cubicBezTo>
                              <a:cubicBezTo>
                                <a:pt x="350600" y="2524525"/>
                                <a:pt x="387991" y="2548652"/>
                                <a:pt x="354459" y="2532580"/>
                              </a:cubicBezTo>
                              <a:cubicBezTo>
                                <a:pt x="349433" y="2523310"/>
                                <a:pt x="338709" y="2511941"/>
                                <a:pt x="339048" y="2501758"/>
                              </a:cubicBezTo>
                              <a:cubicBezTo>
                                <a:pt x="339293" y="2489525"/>
                                <a:pt x="338446" y="2476711"/>
                                <a:pt x="344185" y="2465798"/>
                              </a:cubicBezTo>
                              <a:cubicBezTo>
                                <a:pt x="353628" y="2448122"/>
                                <a:pt x="368532" y="2441049"/>
                                <a:pt x="380144" y="2429839"/>
                              </a:cubicBezTo>
                              <a:cubicBezTo>
                                <a:pt x="394518" y="2415949"/>
                                <a:pt x="384654" y="2421097"/>
                                <a:pt x="405830" y="2414427"/>
                              </a:cubicBezTo>
                              <a:cubicBezTo>
                                <a:pt x="423649" y="2403246"/>
                                <a:pt x="441871" y="2393461"/>
                                <a:pt x="452063" y="2378468"/>
                              </a:cubicBezTo>
                              <a:cubicBezTo>
                                <a:pt x="455396" y="2373224"/>
                                <a:pt x="458151" y="2367675"/>
                                <a:pt x="462337" y="2363057"/>
                              </a:cubicBezTo>
                              <a:cubicBezTo>
                                <a:pt x="509218" y="2323905"/>
                                <a:pt x="481262" y="2360087"/>
                                <a:pt x="513708" y="2332234"/>
                              </a:cubicBezTo>
                              <a:cubicBezTo>
                                <a:pt x="523203" y="2326368"/>
                                <a:pt x="529814" y="2317955"/>
                                <a:pt x="539394" y="2311686"/>
                              </a:cubicBezTo>
                              <a:cubicBezTo>
                                <a:pt x="545780" y="2307620"/>
                                <a:pt x="553573" y="2305523"/>
                                <a:pt x="559942" y="2301412"/>
                              </a:cubicBezTo>
                              <a:cubicBezTo>
                                <a:pt x="591972" y="2279481"/>
                                <a:pt x="569922" y="2289769"/>
                                <a:pt x="606176" y="2270589"/>
                              </a:cubicBezTo>
                              <a:cubicBezTo>
                                <a:pt x="611535" y="2268156"/>
                                <a:pt x="617033" y="2266632"/>
                                <a:pt x="621587" y="2265452"/>
                              </a:cubicBezTo>
                              <a:cubicBezTo>
                                <a:pt x="629287" y="2262757"/>
                                <a:pt x="635255" y="2258389"/>
                                <a:pt x="642135" y="2255178"/>
                              </a:cubicBezTo>
                              <a:cubicBezTo>
                                <a:pt x="671712" y="2219651"/>
                                <a:pt x="638332" y="2260502"/>
                                <a:pt x="667821" y="2234630"/>
                              </a:cubicBezTo>
                              <a:cubicBezTo>
                                <a:pt x="685374" y="2221985"/>
                                <a:pt x="703426" y="2208375"/>
                                <a:pt x="719191" y="2193533"/>
                              </a:cubicBezTo>
                              <a:cubicBezTo>
                                <a:pt x="729972" y="2186479"/>
                                <a:pt x="740982" y="2180942"/>
                                <a:pt x="750014" y="2172985"/>
                              </a:cubicBezTo>
                              <a:cubicBezTo>
                                <a:pt x="758524" y="2166951"/>
                                <a:pt x="761639" y="2157965"/>
                                <a:pt x="770562" y="2152436"/>
                              </a:cubicBezTo>
                              <a:cubicBezTo>
                                <a:pt x="787583" y="2138911"/>
                                <a:pt x="802116" y="2129117"/>
                                <a:pt x="816796" y="2116477"/>
                              </a:cubicBezTo>
                              <a:cubicBezTo>
                                <a:pt x="825381" y="2109388"/>
                                <a:pt x="832725" y="2104127"/>
                                <a:pt x="842481" y="2095929"/>
                              </a:cubicBezTo>
                              <a:cubicBezTo>
                                <a:pt x="848301" y="2089978"/>
                                <a:pt x="856428" y="2086103"/>
                                <a:pt x="863030" y="2080517"/>
                              </a:cubicBezTo>
                              <a:cubicBezTo>
                                <a:pt x="879220" y="2069059"/>
                                <a:pt x="886640" y="2052175"/>
                                <a:pt x="904126" y="2039421"/>
                              </a:cubicBezTo>
                              <a:cubicBezTo>
                                <a:pt x="909411" y="2035740"/>
                                <a:pt x="914872" y="2033327"/>
                                <a:pt x="919537" y="2029146"/>
                              </a:cubicBezTo>
                              <a:cubicBezTo>
                                <a:pt x="927642" y="2021183"/>
                                <a:pt x="932819" y="2013652"/>
                                <a:pt x="940086" y="2003461"/>
                              </a:cubicBezTo>
                              <a:cubicBezTo>
                                <a:pt x="947387" y="1994049"/>
                                <a:pt x="957774" y="1988559"/>
                                <a:pt x="965771" y="1977776"/>
                              </a:cubicBezTo>
                              <a:cubicBezTo>
                                <a:pt x="1020072" y="1912367"/>
                                <a:pt x="955915" y="1976132"/>
                                <a:pt x="1001731" y="1931542"/>
                              </a:cubicBezTo>
                              <a:cubicBezTo>
                                <a:pt x="1003025" y="1927343"/>
                                <a:pt x="1003601" y="1920335"/>
                                <a:pt x="1006868" y="1916131"/>
                              </a:cubicBezTo>
                              <a:cubicBezTo>
                                <a:pt x="1010296" y="1911708"/>
                                <a:pt x="1017650" y="1908987"/>
                                <a:pt x="1022279" y="1905857"/>
                              </a:cubicBezTo>
                              <a:cubicBezTo>
                                <a:pt x="1025878" y="1902643"/>
                                <a:pt x="1028935" y="1898845"/>
                                <a:pt x="1032553" y="1895582"/>
                              </a:cubicBezTo>
                              <a:cubicBezTo>
                                <a:pt x="1026546" y="1891754"/>
                                <a:pt x="1023187" y="1885008"/>
                                <a:pt x="1017142" y="1885308"/>
                              </a:cubicBezTo>
                              <a:cubicBezTo>
                                <a:pt x="1002091" y="1885292"/>
                                <a:pt x="980296" y="1899567"/>
                                <a:pt x="965771" y="1905857"/>
                              </a:cubicBezTo>
                              <a:cubicBezTo>
                                <a:pt x="961437" y="1908469"/>
                                <a:pt x="955554" y="1908653"/>
                                <a:pt x="950360" y="1910994"/>
                              </a:cubicBezTo>
                              <a:cubicBezTo>
                                <a:pt x="943747" y="1917626"/>
                                <a:pt x="936855" y="1921441"/>
                                <a:pt x="929812" y="1926405"/>
                              </a:cubicBezTo>
                              <a:cubicBezTo>
                                <a:pt x="891503" y="1949179"/>
                                <a:pt x="925246" y="1887991"/>
                                <a:pt x="863030" y="1962364"/>
                              </a:cubicBezTo>
                              <a:cubicBezTo>
                                <a:pt x="859005" y="1965361"/>
                                <a:pt x="856583" y="1969533"/>
                                <a:pt x="852755" y="1972639"/>
                              </a:cubicBezTo>
                              <a:cubicBezTo>
                                <a:pt x="838983" y="1979235"/>
                                <a:pt x="825049" y="1986108"/>
                                <a:pt x="811659" y="1993187"/>
                              </a:cubicBezTo>
                              <a:cubicBezTo>
                                <a:pt x="780013" y="2022369"/>
                                <a:pt x="817475" y="1982352"/>
                                <a:pt x="775699" y="2018872"/>
                              </a:cubicBezTo>
                              <a:cubicBezTo>
                                <a:pt x="771180" y="2023075"/>
                                <a:pt x="765355" y="2025871"/>
                                <a:pt x="760288" y="2029146"/>
                              </a:cubicBezTo>
                              <a:cubicBezTo>
                                <a:pt x="740307" y="2037528"/>
                                <a:pt x="723878" y="2037787"/>
                                <a:pt x="703780" y="2049695"/>
                              </a:cubicBezTo>
                              <a:cubicBezTo>
                                <a:pt x="695665" y="2054729"/>
                                <a:pt x="690859" y="2062097"/>
                                <a:pt x="683232" y="2065106"/>
                              </a:cubicBezTo>
                              <a:cubicBezTo>
                                <a:pt x="674509" y="2069641"/>
                                <a:pt x="666618" y="2072474"/>
                                <a:pt x="657546" y="2075380"/>
                              </a:cubicBezTo>
                              <a:cubicBezTo>
                                <a:pt x="648168" y="2081107"/>
                                <a:pt x="640892" y="2086685"/>
                                <a:pt x="631861" y="2090791"/>
                              </a:cubicBezTo>
                              <a:cubicBezTo>
                                <a:pt x="622052" y="2098393"/>
                                <a:pt x="609662" y="2099826"/>
                                <a:pt x="601039" y="2106203"/>
                              </a:cubicBezTo>
                              <a:cubicBezTo>
                                <a:pt x="594501" y="2109466"/>
                                <a:pt x="587686" y="2118424"/>
                                <a:pt x="580490" y="2121614"/>
                              </a:cubicBezTo>
                              <a:cubicBezTo>
                                <a:pt x="573979" y="2125829"/>
                                <a:pt x="566193" y="2127835"/>
                                <a:pt x="559942" y="2131888"/>
                              </a:cubicBezTo>
                              <a:cubicBezTo>
                                <a:pt x="553399" y="2137409"/>
                                <a:pt x="546634" y="2141553"/>
                                <a:pt x="539394" y="2147299"/>
                              </a:cubicBezTo>
                              <a:cubicBezTo>
                                <a:pt x="525906" y="2154934"/>
                                <a:pt x="510732" y="2158214"/>
                                <a:pt x="498297" y="2167848"/>
                              </a:cubicBezTo>
                              <a:cubicBezTo>
                                <a:pt x="493477" y="2171439"/>
                                <a:pt x="489159" y="2175477"/>
                                <a:pt x="482886" y="2178122"/>
                              </a:cubicBezTo>
                              <a:cubicBezTo>
                                <a:pt x="458308" y="2191219"/>
                                <a:pt x="463313" y="2186085"/>
                                <a:pt x="436652" y="2198670"/>
                              </a:cubicBezTo>
                              <a:cubicBezTo>
                                <a:pt x="426500" y="2205290"/>
                                <a:pt x="416131" y="2210014"/>
                                <a:pt x="405830" y="2214081"/>
                              </a:cubicBezTo>
                              <a:cubicBezTo>
                                <a:pt x="394965" y="2218551"/>
                                <a:pt x="385919" y="2218948"/>
                                <a:pt x="375007" y="2224355"/>
                              </a:cubicBezTo>
                              <a:cubicBezTo>
                                <a:pt x="366040" y="2227192"/>
                                <a:pt x="356490" y="2235888"/>
                                <a:pt x="349322" y="2239767"/>
                              </a:cubicBezTo>
                              <a:cubicBezTo>
                                <a:pt x="335819" y="2246516"/>
                                <a:pt x="320897" y="2246731"/>
                                <a:pt x="308225" y="2255178"/>
                              </a:cubicBezTo>
                              <a:cubicBezTo>
                                <a:pt x="259419" y="2278404"/>
                                <a:pt x="307336" y="2263444"/>
                                <a:pt x="261991" y="2275726"/>
                              </a:cubicBezTo>
                              <a:cubicBezTo>
                                <a:pt x="256609" y="2279803"/>
                                <a:pt x="252631" y="2283152"/>
                                <a:pt x="246580" y="2286000"/>
                              </a:cubicBezTo>
                              <a:cubicBezTo>
                                <a:pt x="241542" y="2287497"/>
                                <a:pt x="235732" y="2288620"/>
                                <a:pt x="231169" y="2291138"/>
                              </a:cubicBezTo>
                              <a:cubicBezTo>
                                <a:pt x="221650" y="2297410"/>
                                <a:pt x="214492" y="2304840"/>
                                <a:pt x="205484" y="2311686"/>
                              </a:cubicBezTo>
                              <a:cubicBezTo>
                                <a:pt x="201621" y="2315061"/>
                                <a:pt x="195697" y="2318978"/>
                                <a:pt x="190072" y="2321960"/>
                              </a:cubicBezTo>
                              <a:cubicBezTo>
                                <a:pt x="185369" y="2312816"/>
                                <a:pt x="172462" y="2295714"/>
                                <a:pt x="169524" y="2286000"/>
                              </a:cubicBezTo>
                              <a:cubicBezTo>
                                <a:pt x="167712" y="2272732"/>
                                <a:pt x="166000" y="2253759"/>
                                <a:pt x="164387" y="2239767"/>
                              </a:cubicBezTo>
                              <a:cubicBezTo>
                                <a:pt x="163265" y="2232560"/>
                                <a:pt x="160248" y="2225403"/>
                                <a:pt x="159250" y="2219218"/>
                              </a:cubicBezTo>
                              <a:cubicBezTo>
                                <a:pt x="156252" y="2209383"/>
                                <a:pt x="156195" y="2198955"/>
                                <a:pt x="154113" y="2188396"/>
                              </a:cubicBezTo>
                              <a:cubicBezTo>
                                <a:pt x="150273" y="2176795"/>
                                <a:pt x="142628" y="2157987"/>
                                <a:pt x="138702" y="2147299"/>
                              </a:cubicBezTo>
                              <a:cubicBezTo>
                                <a:pt x="130564" y="2119899"/>
                                <a:pt x="139018" y="2124466"/>
                                <a:pt x="123290" y="2101066"/>
                              </a:cubicBezTo>
                              <a:cubicBezTo>
                                <a:pt x="85739" y="2056247"/>
                                <a:pt x="136671" y="2146660"/>
                                <a:pt x="102742" y="2070243"/>
                              </a:cubicBezTo>
                              <a:cubicBezTo>
                                <a:pt x="95241" y="2007729"/>
                                <a:pt x="103164" y="2050449"/>
                                <a:pt x="92468" y="2018872"/>
                              </a:cubicBezTo>
                              <a:cubicBezTo>
                                <a:pt x="89846" y="2012438"/>
                                <a:pt x="90457" y="2004962"/>
                                <a:pt x="87331" y="1998324"/>
                              </a:cubicBezTo>
                              <a:cubicBezTo>
                                <a:pt x="84310" y="1992179"/>
                                <a:pt x="80314" y="1987970"/>
                                <a:pt x="77057" y="1982913"/>
                              </a:cubicBezTo>
                              <a:cubicBezTo>
                                <a:pt x="74560" y="1978912"/>
                                <a:pt x="73825" y="1972900"/>
                                <a:pt x="71920" y="1967502"/>
                              </a:cubicBezTo>
                              <a:cubicBezTo>
                                <a:pt x="71283" y="1951844"/>
                                <a:pt x="67716" y="1929147"/>
                                <a:pt x="66782" y="1910994"/>
                              </a:cubicBezTo>
                              <a:cubicBezTo>
                                <a:pt x="65514" y="1900296"/>
                                <a:pt x="59578" y="1889776"/>
                                <a:pt x="56508" y="1880171"/>
                              </a:cubicBezTo>
                              <a:cubicBezTo>
                                <a:pt x="30899" y="1815794"/>
                                <a:pt x="69230" y="1929642"/>
                                <a:pt x="35960" y="1823663"/>
                              </a:cubicBezTo>
                              <a:cubicBezTo>
                                <a:pt x="34023" y="1818158"/>
                                <a:pt x="32127" y="1814378"/>
                                <a:pt x="30823" y="1808252"/>
                              </a:cubicBezTo>
                              <a:cubicBezTo>
                                <a:pt x="17031" y="1745616"/>
                                <a:pt x="21267" y="1766626"/>
                                <a:pt x="10275" y="1731196"/>
                              </a:cubicBezTo>
                              <a:cubicBezTo>
                                <a:pt x="6449" y="1697493"/>
                                <a:pt x="1481" y="1613215"/>
                                <a:pt x="0" y="1582221"/>
                              </a:cubicBezTo>
                              <a:cubicBezTo>
                                <a:pt x="4077" y="1471059"/>
                                <a:pt x="2891" y="1392178"/>
                                <a:pt x="5137" y="1294544"/>
                              </a:cubicBezTo>
                              <a:cubicBezTo>
                                <a:pt x="9206" y="1227879"/>
                                <a:pt x="4559" y="1245679"/>
                                <a:pt x="20549" y="1202077"/>
                              </a:cubicBezTo>
                              <a:cubicBezTo>
                                <a:pt x="23856" y="1185945"/>
                                <a:pt x="25314" y="1174556"/>
                                <a:pt x="30823" y="1155843"/>
                              </a:cubicBezTo>
                              <a:cubicBezTo>
                                <a:pt x="32134" y="1150239"/>
                                <a:pt x="34997" y="1145370"/>
                                <a:pt x="35960" y="1140432"/>
                              </a:cubicBezTo>
                              <a:cubicBezTo>
                                <a:pt x="36926" y="1129295"/>
                                <a:pt x="37421" y="1121109"/>
                                <a:pt x="41097" y="1109609"/>
                              </a:cubicBezTo>
                              <a:cubicBezTo>
                                <a:pt x="43888" y="1099105"/>
                                <a:pt x="52113" y="1091322"/>
                                <a:pt x="56508" y="1083924"/>
                              </a:cubicBezTo>
                              <a:cubicBezTo>
                                <a:pt x="61295" y="1075189"/>
                                <a:pt x="63307" y="1067271"/>
                                <a:pt x="66782" y="1058239"/>
                              </a:cubicBezTo>
                              <a:cubicBezTo>
                                <a:pt x="70616" y="1047703"/>
                                <a:pt x="71921" y="1038604"/>
                                <a:pt x="77057" y="1027416"/>
                              </a:cubicBezTo>
                              <a:cubicBezTo>
                                <a:pt x="79081" y="1019668"/>
                                <a:pt x="83782" y="1011307"/>
                                <a:pt x="87331" y="1001731"/>
                              </a:cubicBezTo>
                              <a:cubicBezTo>
                                <a:pt x="90253" y="986017"/>
                                <a:pt x="92612" y="973949"/>
                                <a:pt x="97605" y="960634"/>
                              </a:cubicBezTo>
                              <a:cubicBezTo>
                                <a:pt x="101151" y="952395"/>
                                <a:pt x="103545" y="942813"/>
                                <a:pt x="107879" y="934949"/>
                              </a:cubicBezTo>
                              <a:cubicBezTo>
                                <a:pt x="110454" y="928411"/>
                                <a:pt x="110494" y="921513"/>
                                <a:pt x="113016" y="914400"/>
                              </a:cubicBezTo>
                              <a:cubicBezTo>
                                <a:pt x="118011" y="899676"/>
                                <a:pt x="131146" y="888051"/>
                                <a:pt x="133564" y="873304"/>
                              </a:cubicBezTo>
                              <a:cubicBezTo>
                                <a:pt x="142186" y="835281"/>
                                <a:pt x="130199" y="869711"/>
                                <a:pt x="154113" y="821933"/>
                              </a:cubicBezTo>
                              <a:cubicBezTo>
                                <a:pt x="158568" y="813612"/>
                                <a:pt x="159318" y="804629"/>
                                <a:pt x="164387" y="796248"/>
                              </a:cubicBezTo>
                              <a:cubicBezTo>
                                <a:pt x="170805" y="782341"/>
                                <a:pt x="184935" y="755151"/>
                                <a:pt x="184935" y="755151"/>
                              </a:cubicBezTo>
                              <a:cubicBezTo>
                                <a:pt x="187125" y="749118"/>
                                <a:pt x="189724" y="718289"/>
                                <a:pt x="195209" y="708917"/>
                              </a:cubicBezTo>
                              <a:cubicBezTo>
                                <a:pt x="197792" y="704722"/>
                                <a:pt x="202270" y="702514"/>
                                <a:pt x="205484" y="698643"/>
                              </a:cubicBezTo>
                              <a:cubicBezTo>
                                <a:pt x="208683" y="688730"/>
                                <a:pt x="207571" y="676102"/>
                                <a:pt x="215758" y="667821"/>
                              </a:cubicBezTo>
                              <a:cubicBezTo>
                                <a:pt x="226309" y="659605"/>
                                <a:pt x="236558" y="648941"/>
                                <a:pt x="246580" y="636998"/>
                              </a:cubicBezTo>
                              <a:cubicBezTo>
                                <a:pt x="250030" y="631490"/>
                                <a:pt x="253101" y="625779"/>
                                <a:pt x="256854" y="621587"/>
                              </a:cubicBezTo>
                              <a:cubicBezTo>
                                <a:pt x="290507" y="588820"/>
                                <a:pt x="255380" y="642118"/>
                                <a:pt x="277403" y="595902"/>
                              </a:cubicBezTo>
                              <a:cubicBezTo>
                                <a:pt x="279212" y="591092"/>
                                <a:pt x="279719" y="584942"/>
                                <a:pt x="282540" y="580490"/>
                              </a:cubicBezTo>
                              <a:cubicBezTo>
                                <a:pt x="291842" y="569254"/>
                                <a:pt x="302871" y="560658"/>
                                <a:pt x="313362" y="549668"/>
                              </a:cubicBezTo>
                              <a:cubicBezTo>
                                <a:pt x="318372" y="542622"/>
                                <a:pt x="328317" y="536360"/>
                                <a:pt x="333911" y="529120"/>
                              </a:cubicBezTo>
                              <a:cubicBezTo>
                                <a:pt x="336886" y="523862"/>
                                <a:pt x="340886" y="517664"/>
                                <a:pt x="344185" y="513708"/>
                              </a:cubicBezTo>
                              <a:cubicBezTo>
                                <a:pt x="354925" y="504166"/>
                                <a:pt x="369077" y="491953"/>
                                <a:pt x="380144" y="477749"/>
                              </a:cubicBezTo>
                              <a:cubicBezTo>
                                <a:pt x="400734" y="449653"/>
                                <a:pt x="376251" y="477554"/>
                                <a:pt x="405830" y="452063"/>
                              </a:cubicBezTo>
                              <a:cubicBezTo>
                                <a:pt x="450720" y="405370"/>
                                <a:pt x="417758" y="427428"/>
                                <a:pt x="457200" y="410967"/>
                              </a:cubicBezTo>
                              <a:cubicBezTo>
                                <a:pt x="461082" y="406698"/>
                                <a:pt x="460824" y="397726"/>
                                <a:pt x="467475" y="395555"/>
                              </a:cubicBezTo>
                              <a:cubicBezTo>
                                <a:pt x="477635" y="392731"/>
                                <a:pt x="487293" y="398313"/>
                                <a:pt x="498297" y="400693"/>
                              </a:cubicBezTo>
                              <a:cubicBezTo>
                                <a:pt x="520090" y="405402"/>
                                <a:pt x="524039" y="411885"/>
                                <a:pt x="544531" y="426378"/>
                              </a:cubicBezTo>
                              <a:cubicBezTo>
                                <a:pt x="571118" y="443189"/>
                                <a:pt x="561791" y="439165"/>
                                <a:pt x="585627" y="446926"/>
                              </a:cubicBezTo>
                              <a:cubicBezTo>
                                <a:pt x="608910" y="479470"/>
                                <a:pt x="573479" y="444269"/>
                                <a:pt x="616450" y="472612"/>
                              </a:cubicBezTo>
                              <a:cubicBezTo>
                                <a:pt x="652642" y="499528"/>
                                <a:pt x="604590" y="482798"/>
                                <a:pt x="642135" y="493160"/>
                              </a:cubicBezTo>
                              <a:cubicBezTo>
                                <a:pt x="649501" y="503249"/>
                                <a:pt x="657532" y="509868"/>
                                <a:pt x="662684" y="518845"/>
                              </a:cubicBezTo>
                              <a:cubicBezTo>
                                <a:pt x="666348" y="523006"/>
                                <a:pt x="670114" y="525250"/>
                                <a:pt x="672958" y="529120"/>
                              </a:cubicBezTo>
                              <a:cubicBezTo>
                                <a:pt x="676957" y="534441"/>
                                <a:pt x="679213" y="539102"/>
                                <a:pt x="683232" y="544531"/>
                              </a:cubicBezTo>
                              <a:cubicBezTo>
                                <a:pt x="689529" y="552472"/>
                                <a:pt x="697590" y="558777"/>
                                <a:pt x="703780" y="565079"/>
                              </a:cubicBezTo>
                              <a:cubicBezTo>
                                <a:pt x="711483" y="574897"/>
                                <a:pt x="715101" y="588653"/>
                                <a:pt x="724329" y="595902"/>
                              </a:cubicBezTo>
                              <a:cubicBezTo>
                                <a:pt x="730657" y="601584"/>
                                <a:pt x="734545" y="606934"/>
                                <a:pt x="739740" y="611313"/>
                              </a:cubicBezTo>
                              <a:cubicBezTo>
                                <a:pt x="747052" y="621636"/>
                                <a:pt x="758986" y="638169"/>
                                <a:pt x="765425" y="647272"/>
                              </a:cubicBezTo>
                              <a:cubicBezTo>
                                <a:pt x="769560" y="654276"/>
                                <a:pt x="774675" y="665907"/>
                                <a:pt x="780836" y="672958"/>
                              </a:cubicBezTo>
                              <a:cubicBezTo>
                                <a:pt x="790150" y="685221"/>
                                <a:pt x="801711" y="696301"/>
                                <a:pt x="811659" y="703780"/>
                              </a:cubicBezTo>
                              <a:cubicBezTo>
                                <a:pt x="816897" y="709069"/>
                                <a:pt x="823103" y="713327"/>
                                <a:pt x="827070" y="719191"/>
                              </a:cubicBezTo>
                              <a:cubicBezTo>
                                <a:pt x="870318" y="759373"/>
                                <a:pt x="800854" y="674486"/>
                                <a:pt x="868167" y="765425"/>
                              </a:cubicBezTo>
                              <a:cubicBezTo>
                                <a:pt x="874913" y="774656"/>
                                <a:pt x="879772" y="783346"/>
                                <a:pt x="888715" y="791111"/>
                              </a:cubicBezTo>
                              <a:cubicBezTo>
                                <a:pt x="894936" y="796488"/>
                                <a:pt x="899657" y="801397"/>
                                <a:pt x="904126" y="806522"/>
                              </a:cubicBezTo>
                              <a:cubicBezTo>
                                <a:pt x="908442" y="811538"/>
                                <a:pt x="910152" y="817834"/>
                                <a:pt x="914400" y="821933"/>
                              </a:cubicBezTo>
                              <a:cubicBezTo>
                                <a:pt x="922556" y="830748"/>
                                <a:pt x="936599" y="840249"/>
                                <a:pt x="945223" y="852755"/>
                              </a:cubicBezTo>
                              <a:cubicBezTo>
                                <a:pt x="969184" y="886630"/>
                                <a:pt x="941295" y="847506"/>
                                <a:pt x="970908" y="883578"/>
                              </a:cubicBezTo>
                              <a:cubicBezTo>
                                <a:pt x="977939" y="890563"/>
                                <a:pt x="980692" y="898360"/>
                                <a:pt x="986320" y="904126"/>
                              </a:cubicBezTo>
                              <a:cubicBezTo>
                                <a:pt x="990034" y="910613"/>
                                <a:pt x="995792" y="914064"/>
                                <a:pt x="1001731" y="919538"/>
                              </a:cubicBezTo>
                              <a:cubicBezTo>
                                <a:pt x="1006189" y="924132"/>
                                <a:pt x="1007838" y="930754"/>
                                <a:pt x="1012005" y="934949"/>
                              </a:cubicBezTo>
                              <a:cubicBezTo>
                                <a:pt x="1016273" y="939747"/>
                                <a:pt x="1023474" y="941055"/>
                                <a:pt x="1027416" y="945223"/>
                              </a:cubicBezTo>
                              <a:cubicBezTo>
                                <a:pt x="1035351" y="952660"/>
                                <a:pt x="1041850" y="962405"/>
                                <a:pt x="1047964" y="970908"/>
                              </a:cubicBezTo>
                              <a:cubicBezTo>
                                <a:pt x="1066261" y="989715"/>
                                <a:pt x="1078700" y="1004687"/>
                                <a:pt x="1099335" y="1017142"/>
                              </a:cubicBezTo>
                              <a:cubicBezTo>
                                <a:pt x="1107085" y="1022569"/>
                                <a:pt x="1117955" y="1027424"/>
                                <a:pt x="1125021" y="1032553"/>
                              </a:cubicBezTo>
                              <a:cubicBezTo>
                                <a:pt x="1144491" y="1061019"/>
                                <a:pt x="1122463" y="1032006"/>
                                <a:pt x="1150706" y="1058239"/>
                              </a:cubicBezTo>
                              <a:cubicBezTo>
                                <a:pt x="1155899" y="1064035"/>
                                <a:pt x="1159756" y="1068761"/>
                                <a:pt x="1166117" y="1073650"/>
                              </a:cubicBezTo>
                              <a:cubicBezTo>
                                <a:pt x="1190323" y="1095072"/>
                                <a:pt x="1190652" y="1093283"/>
                                <a:pt x="1217488" y="1109609"/>
                              </a:cubicBezTo>
                              <a:cubicBezTo>
                                <a:pt x="1248721" y="1145931"/>
                                <a:pt x="1209362" y="1099641"/>
                                <a:pt x="1243173" y="1135295"/>
                              </a:cubicBezTo>
                              <a:cubicBezTo>
                                <a:pt x="1261285" y="1153655"/>
                                <a:pt x="1258020" y="1139927"/>
                                <a:pt x="1258585" y="1135295"/>
                              </a:cubicBezTo>
                              <a:close/>
                            </a:path>
                          </a:pathLst>
                        </a:custGeom>
                        <ask:type>
                          <ask:lineSketchNone/>
                        </ask:type>
                      </ask:lineSketchStyleProps>
                    </a:ext>
                  </a:extLst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" name="椭圆 20">
                  <a:extLst>
                    <a:ext uri="{FF2B5EF4-FFF2-40B4-BE49-F238E27FC236}">
                      <a16:creationId xmlns:a16="http://schemas.microsoft.com/office/drawing/2014/main" id="{38ED67D6-5431-3DE7-FEB5-2A309F6CF67F}"/>
                    </a:ext>
                  </a:extLst>
                </p:cNvPr>
                <p:cNvSpPr/>
                <p:nvPr/>
              </p:nvSpPr>
              <p:spPr>
                <a:xfrm>
                  <a:off x="4802520" y="1942545"/>
                  <a:ext cx="362081" cy="362081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>
                      <a:lumMod val="50000"/>
                    </a:schemeClr>
                  </a:solidFill>
                  <a:extLst>
                    <a:ext uri="{C807C97D-BFC1-408E-A445-0C87EB9F89A2}">
                      <ask:lineSketchStyleProps xmlns:ask="http://schemas.microsoft.com/office/drawing/2018/sketchyshapes" sd="1219033472">
                        <a:custGeom>
                          <a:avLst/>
                          <a:gdLst>
                            <a:gd name="connsiteX0" fmla="*/ 0 w 362081"/>
                            <a:gd name="connsiteY0" fmla="*/ 181041 h 362081"/>
                            <a:gd name="connsiteX1" fmla="*/ 181041 w 362081"/>
                            <a:gd name="connsiteY1" fmla="*/ 0 h 362081"/>
                            <a:gd name="connsiteX2" fmla="*/ 362082 w 362081"/>
                            <a:gd name="connsiteY2" fmla="*/ 181041 h 362081"/>
                            <a:gd name="connsiteX3" fmla="*/ 181041 w 362081"/>
                            <a:gd name="connsiteY3" fmla="*/ 362082 h 362081"/>
                            <a:gd name="connsiteX4" fmla="*/ 0 w 362081"/>
                            <a:gd name="connsiteY4" fmla="*/ 181041 h 362081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  <a:cxn ang="0">
                              <a:pos x="connsiteX4" y="connsiteY4"/>
                            </a:cxn>
                          </a:cxnLst>
                          <a:rect l="l" t="t" r="r" b="b"/>
                          <a:pathLst>
                            <a:path w="362081" h="362081" fill="none" extrusionOk="0">
                              <a:moveTo>
                                <a:pt x="0" y="181041"/>
                              </a:moveTo>
                              <a:cubicBezTo>
                                <a:pt x="13836" y="82696"/>
                                <a:pt x="84591" y="-7276"/>
                                <a:pt x="181041" y="0"/>
                              </a:cubicBezTo>
                              <a:cubicBezTo>
                                <a:pt x="269959" y="-1695"/>
                                <a:pt x="358665" y="84272"/>
                                <a:pt x="362082" y="181041"/>
                              </a:cubicBezTo>
                              <a:cubicBezTo>
                                <a:pt x="361510" y="275572"/>
                                <a:pt x="276044" y="369007"/>
                                <a:pt x="181041" y="362082"/>
                              </a:cubicBezTo>
                              <a:cubicBezTo>
                                <a:pt x="89709" y="366927"/>
                                <a:pt x="8867" y="283159"/>
                                <a:pt x="0" y="181041"/>
                              </a:cubicBezTo>
                              <a:close/>
                            </a:path>
                            <a:path w="362081" h="362081" stroke="0" extrusionOk="0">
                              <a:moveTo>
                                <a:pt x="0" y="181041"/>
                              </a:moveTo>
                              <a:cubicBezTo>
                                <a:pt x="-3632" y="78815"/>
                                <a:pt x="74037" y="2634"/>
                                <a:pt x="181041" y="0"/>
                              </a:cubicBezTo>
                              <a:cubicBezTo>
                                <a:pt x="295848" y="3120"/>
                                <a:pt x="360436" y="81107"/>
                                <a:pt x="362082" y="181041"/>
                              </a:cubicBezTo>
                              <a:cubicBezTo>
                                <a:pt x="348015" y="294764"/>
                                <a:pt x="279960" y="367981"/>
                                <a:pt x="181041" y="362082"/>
                              </a:cubicBezTo>
                              <a:cubicBezTo>
                                <a:pt x="63665" y="352568"/>
                                <a:pt x="9695" y="285659"/>
                                <a:pt x="0" y="181041"/>
                              </a:cubicBezTo>
                              <a:close/>
                            </a:path>
                          </a:pathLst>
                        </a:custGeom>
                        <ask:type>
                          <ask:lineSketchNone/>
                        </ask:type>
                      </ask:lineSketchStyleProps>
                    </a:ext>
                  </a:extLst>
                </a:ln>
                <a:effectLst>
                  <a:softEdge rad="12700"/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2" name="椭圆 21">
                  <a:extLst>
                    <a:ext uri="{FF2B5EF4-FFF2-40B4-BE49-F238E27FC236}">
                      <a16:creationId xmlns:a16="http://schemas.microsoft.com/office/drawing/2014/main" id="{CAB475C1-9395-9A90-90A2-FC59E28D079E}"/>
                    </a:ext>
                  </a:extLst>
                </p:cNvPr>
                <p:cNvSpPr/>
                <p:nvPr/>
              </p:nvSpPr>
              <p:spPr>
                <a:xfrm>
                  <a:off x="4864813" y="1457008"/>
                  <a:ext cx="364081" cy="283579"/>
                </a:xfrm>
                <a:prstGeom prst="ellipse">
                  <a:avLst/>
                </a:prstGeom>
                <a:solidFill>
                  <a:srgbClr val="FA7F6F"/>
                </a:solidFill>
                <a:ln>
                  <a:solidFill>
                    <a:schemeClr val="bg1">
                      <a:lumMod val="50000"/>
                    </a:schemeClr>
                  </a:solidFill>
                  <a:extLst>
                    <a:ext uri="{C807C97D-BFC1-408E-A445-0C87EB9F89A2}">
                      <ask:lineSketchStyleProps xmlns:ask="http://schemas.microsoft.com/office/drawing/2018/sketchyshapes" sd="1219033472">
                        <a:custGeom>
                          <a:avLst/>
                          <a:gdLst>
                            <a:gd name="connsiteX0" fmla="*/ 0 w 364081"/>
                            <a:gd name="connsiteY0" fmla="*/ 141790 h 283579"/>
                            <a:gd name="connsiteX1" fmla="*/ 182041 w 364081"/>
                            <a:gd name="connsiteY1" fmla="*/ 0 h 283579"/>
                            <a:gd name="connsiteX2" fmla="*/ 364082 w 364081"/>
                            <a:gd name="connsiteY2" fmla="*/ 141790 h 283579"/>
                            <a:gd name="connsiteX3" fmla="*/ 182041 w 364081"/>
                            <a:gd name="connsiteY3" fmla="*/ 283580 h 283579"/>
                            <a:gd name="connsiteX4" fmla="*/ 0 w 364081"/>
                            <a:gd name="connsiteY4" fmla="*/ 141790 h 283579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  <a:cxn ang="0">
                              <a:pos x="connsiteX4" y="connsiteY4"/>
                            </a:cxn>
                          </a:cxnLst>
                          <a:rect l="l" t="t" r="r" b="b"/>
                          <a:pathLst>
                            <a:path w="364081" h="283579" fill="none" extrusionOk="0">
                              <a:moveTo>
                                <a:pt x="0" y="141790"/>
                              </a:moveTo>
                              <a:cubicBezTo>
                                <a:pt x="13613" y="65097"/>
                                <a:pt x="85422" y="-8066"/>
                                <a:pt x="182041" y="0"/>
                              </a:cubicBezTo>
                              <a:cubicBezTo>
                                <a:pt x="274421" y="-1249"/>
                                <a:pt x="359489" y="67806"/>
                                <a:pt x="364082" y="141790"/>
                              </a:cubicBezTo>
                              <a:cubicBezTo>
                                <a:pt x="363114" y="210869"/>
                                <a:pt x="270903" y="299807"/>
                                <a:pt x="182041" y="283580"/>
                              </a:cubicBezTo>
                              <a:cubicBezTo>
                                <a:pt x="84115" y="285042"/>
                                <a:pt x="1934" y="220563"/>
                                <a:pt x="0" y="141790"/>
                              </a:cubicBezTo>
                              <a:close/>
                            </a:path>
                            <a:path w="364081" h="283579" stroke="0" extrusionOk="0">
                              <a:moveTo>
                                <a:pt x="0" y="141790"/>
                              </a:moveTo>
                              <a:cubicBezTo>
                                <a:pt x="-12751" y="55617"/>
                                <a:pt x="72941" y="3214"/>
                                <a:pt x="182041" y="0"/>
                              </a:cubicBezTo>
                              <a:cubicBezTo>
                                <a:pt x="290339" y="1634"/>
                                <a:pt x="348952" y="63963"/>
                                <a:pt x="364082" y="141790"/>
                              </a:cubicBezTo>
                              <a:cubicBezTo>
                                <a:pt x="352353" y="231552"/>
                                <a:pt x="279904" y="298366"/>
                                <a:pt x="182041" y="283580"/>
                              </a:cubicBezTo>
                              <a:cubicBezTo>
                                <a:pt x="68121" y="276258"/>
                                <a:pt x="12696" y="226164"/>
                                <a:pt x="0" y="141790"/>
                              </a:cubicBezTo>
                              <a:close/>
                            </a:path>
                          </a:pathLst>
                        </a:custGeom>
                        <ask:type>
                          <ask:lineSketchNone/>
                        </ask:type>
                      </ask:lineSketchStyleProps>
                    </a:ext>
                  </a:extLst>
                </a:ln>
                <a:effectLst>
                  <a:softEdge rad="12700"/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3" name="椭圆 22">
                  <a:extLst>
                    <a:ext uri="{FF2B5EF4-FFF2-40B4-BE49-F238E27FC236}">
                      <a16:creationId xmlns:a16="http://schemas.microsoft.com/office/drawing/2014/main" id="{030F55CC-BA1F-516A-5138-E6BBECB5DD79}"/>
                    </a:ext>
                  </a:extLst>
                </p:cNvPr>
                <p:cNvSpPr/>
                <p:nvPr/>
              </p:nvSpPr>
              <p:spPr>
                <a:xfrm>
                  <a:off x="4704511" y="2504466"/>
                  <a:ext cx="364081" cy="283579"/>
                </a:xfrm>
                <a:prstGeom prst="ellipse">
                  <a:avLst/>
                </a:prstGeom>
                <a:solidFill>
                  <a:srgbClr val="FA7F6F"/>
                </a:solidFill>
                <a:ln>
                  <a:solidFill>
                    <a:schemeClr val="bg1">
                      <a:lumMod val="50000"/>
                    </a:schemeClr>
                  </a:solidFill>
                  <a:extLst>
                    <a:ext uri="{C807C97D-BFC1-408E-A445-0C87EB9F89A2}">
                      <ask:lineSketchStyleProps xmlns:ask="http://schemas.microsoft.com/office/drawing/2018/sketchyshapes" sd="1219033472">
                        <a:custGeom>
                          <a:avLst/>
                          <a:gdLst>
                            <a:gd name="connsiteX0" fmla="*/ 0 w 364081"/>
                            <a:gd name="connsiteY0" fmla="*/ 141790 h 283579"/>
                            <a:gd name="connsiteX1" fmla="*/ 182041 w 364081"/>
                            <a:gd name="connsiteY1" fmla="*/ 0 h 283579"/>
                            <a:gd name="connsiteX2" fmla="*/ 364082 w 364081"/>
                            <a:gd name="connsiteY2" fmla="*/ 141790 h 283579"/>
                            <a:gd name="connsiteX3" fmla="*/ 182041 w 364081"/>
                            <a:gd name="connsiteY3" fmla="*/ 283580 h 283579"/>
                            <a:gd name="connsiteX4" fmla="*/ 0 w 364081"/>
                            <a:gd name="connsiteY4" fmla="*/ 141790 h 283579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  <a:cxn ang="0">
                              <a:pos x="connsiteX4" y="connsiteY4"/>
                            </a:cxn>
                          </a:cxnLst>
                          <a:rect l="l" t="t" r="r" b="b"/>
                          <a:pathLst>
                            <a:path w="364081" h="283579" fill="none" extrusionOk="0">
                              <a:moveTo>
                                <a:pt x="0" y="141790"/>
                              </a:moveTo>
                              <a:cubicBezTo>
                                <a:pt x="13613" y="65097"/>
                                <a:pt x="85422" y="-8066"/>
                                <a:pt x="182041" y="0"/>
                              </a:cubicBezTo>
                              <a:cubicBezTo>
                                <a:pt x="274421" y="-1249"/>
                                <a:pt x="359489" y="67806"/>
                                <a:pt x="364082" y="141790"/>
                              </a:cubicBezTo>
                              <a:cubicBezTo>
                                <a:pt x="363114" y="210869"/>
                                <a:pt x="270903" y="299807"/>
                                <a:pt x="182041" y="283580"/>
                              </a:cubicBezTo>
                              <a:cubicBezTo>
                                <a:pt x="84115" y="285042"/>
                                <a:pt x="1934" y="220563"/>
                                <a:pt x="0" y="141790"/>
                              </a:cubicBezTo>
                              <a:close/>
                            </a:path>
                            <a:path w="364081" h="283579" stroke="0" extrusionOk="0">
                              <a:moveTo>
                                <a:pt x="0" y="141790"/>
                              </a:moveTo>
                              <a:cubicBezTo>
                                <a:pt x="-12751" y="55617"/>
                                <a:pt x="72941" y="3214"/>
                                <a:pt x="182041" y="0"/>
                              </a:cubicBezTo>
                              <a:cubicBezTo>
                                <a:pt x="290339" y="1634"/>
                                <a:pt x="348952" y="63963"/>
                                <a:pt x="364082" y="141790"/>
                              </a:cubicBezTo>
                              <a:cubicBezTo>
                                <a:pt x="352353" y="231552"/>
                                <a:pt x="279904" y="298366"/>
                                <a:pt x="182041" y="283580"/>
                              </a:cubicBezTo>
                              <a:cubicBezTo>
                                <a:pt x="68121" y="276258"/>
                                <a:pt x="12696" y="226164"/>
                                <a:pt x="0" y="141790"/>
                              </a:cubicBezTo>
                              <a:close/>
                            </a:path>
                          </a:pathLst>
                        </a:custGeom>
                        <ask:type>
                          <ask:lineSketchNone/>
                        </ask:type>
                      </ask:lineSketchStyleProps>
                    </a:ext>
                  </a:extLst>
                </a:ln>
                <a:effectLst>
                  <a:softEdge rad="12700"/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4" name="椭圆 23">
                  <a:extLst>
                    <a:ext uri="{FF2B5EF4-FFF2-40B4-BE49-F238E27FC236}">
                      <a16:creationId xmlns:a16="http://schemas.microsoft.com/office/drawing/2014/main" id="{69A01B15-1258-E8DF-D0EE-9C6CAA7F1AB0}"/>
                    </a:ext>
                  </a:extLst>
                </p:cNvPr>
                <p:cNvSpPr/>
                <p:nvPr/>
              </p:nvSpPr>
              <p:spPr>
                <a:xfrm>
                  <a:off x="5340812" y="2021047"/>
                  <a:ext cx="364081" cy="283579"/>
                </a:xfrm>
                <a:prstGeom prst="ellipse">
                  <a:avLst/>
                </a:prstGeom>
                <a:solidFill>
                  <a:srgbClr val="FA7F6F"/>
                </a:solidFill>
                <a:ln>
                  <a:solidFill>
                    <a:schemeClr val="bg1">
                      <a:lumMod val="50000"/>
                    </a:schemeClr>
                  </a:solidFill>
                  <a:extLst>
                    <a:ext uri="{C807C97D-BFC1-408E-A445-0C87EB9F89A2}">
                      <ask:lineSketchStyleProps xmlns:ask="http://schemas.microsoft.com/office/drawing/2018/sketchyshapes" sd="1219033472">
                        <a:custGeom>
                          <a:avLst/>
                          <a:gdLst>
                            <a:gd name="connsiteX0" fmla="*/ 0 w 364081"/>
                            <a:gd name="connsiteY0" fmla="*/ 141790 h 283579"/>
                            <a:gd name="connsiteX1" fmla="*/ 182041 w 364081"/>
                            <a:gd name="connsiteY1" fmla="*/ 0 h 283579"/>
                            <a:gd name="connsiteX2" fmla="*/ 364082 w 364081"/>
                            <a:gd name="connsiteY2" fmla="*/ 141790 h 283579"/>
                            <a:gd name="connsiteX3" fmla="*/ 182041 w 364081"/>
                            <a:gd name="connsiteY3" fmla="*/ 283580 h 283579"/>
                            <a:gd name="connsiteX4" fmla="*/ 0 w 364081"/>
                            <a:gd name="connsiteY4" fmla="*/ 141790 h 283579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  <a:cxn ang="0">
                              <a:pos x="connsiteX4" y="connsiteY4"/>
                            </a:cxn>
                          </a:cxnLst>
                          <a:rect l="l" t="t" r="r" b="b"/>
                          <a:pathLst>
                            <a:path w="364081" h="283579" fill="none" extrusionOk="0">
                              <a:moveTo>
                                <a:pt x="0" y="141790"/>
                              </a:moveTo>
                              <a:cubicBezTo>
                                <a:pt x="13613" y="65097"/>
                                <a:pt x="85422" y="-8066"/>
                                <a:pt x="182041" y="0"/>
                              </a:cubicBezTo>
                              <a:cubicBezTo>
                                <a:pt x="274421" y="-1249"/>
                                <a:pt x="359489" y="67806"/>
                                <a:pt x="364082" y="141790"/>
                              </a:cubicBezTo>
                              <a:cubicBezTo>
                                <a:pt x="363114" y="210869"/>
                                <a:pt x="270903" y="299807"/>
                                <a:pt x="182041" y="283580"/>
                              </a:cubicBezTo>
                              <a:cubicBezTo>
                                <a:pt x="84115" y="285042"/>
                                <a:pt x="1934" y="220563"/>
                                <a:pt x="0" y="141790"/>
                              </a:cubicBezTo>
                              <a:close/>
                            </a:path>
                            <a:path w="364081" h="283579" stroke="0" extrusionOk="0">
                              <a:moveTo>
                                <a:pt x="0" y="141790"/>
                              </a:moveTo>
                              <a:cubicBezTo>
                                <a:pt x="-12751" y="55617"/>
                                <a:pt x="72941" y="3214"/>
                                <a:pt x="182041" y="0"/>
                              </a:cubicBezTo>
                              <a:cubicBezTo>
                                <a:pt x="290339" y="1634"/>
                                <a:pt x="348952" y="63963"/>
                                <a:pt x="364082" y="141790"/>
                              </a:cubicBezTo>
                              <a:cubicBezTo>
                                <a:pt x="352353" y="231552"/>
                                <a:pt x="279904" y="298366"/>
                                <a:pt x="182041" y="283580"/>
                              </a:cubicBezTo>
                              <a:cubicBezTo>
                                <a:pt x="68121" y="276258"/>
                                <a:pt x="12696" y="226164"/>
                                <a:pt x="0" y="141790"/>
                              </a:cubicBezTo>
                              <a:close/>
                            </a:path>
                          </a:pathLst>
                        </a:custGeom>
                        <ask:type>
                          <ask:lineSketchNone/>
                        </ask:type>
                      </ask:lineSketchStyleProps>
                    </a:ext>
                  </a:extLst>
                </a:ln>
                <a:effectLst>
                  <a:softEdge rad="12700"/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5" name="椭圆 24">
                  <a:extLst>
                    <a:ext uri="{FF2B5EF4-FFF2-40B4-BE49-F238E27FC236}">
                      <a16:creationId xmlns:a16="http://schemas.microsoft.com/office/drawing/2014/main" id="{21517F70-BA8C-81A9-E007-427CE4CE4378}"/>
                    </a:ext>
                  </a:extLst>
                </p:cNvPr>
                <p:cNvSpPr/>
                <p:nvPr/>
              </p:nvSpPr>
              <p:spPr>
                <a:xfrm>
                  <a:off x="4264635" y="1875333"/>
                  <a:ext cx="364081" cy="283579"/>
                </a:xfrm>
                <a:prstGeom prst="ellipse">
                  <a:avLst/>
                </a:prstGeom>
                <a:solidFill>
                  <a:srgbClr val="FA7F6F"/>
                </a:solidFill>
                <a:ln>
                  <a:solidFill>
                    <a:schemeClr val="bg1">
                      <a:lumMod val="50000"/>
                    </a:schemeClr>
                  </a:solidFill>
                  <a:extLst>
                    <a:ext uri="{C807C97D-BFC1-408E-A445-0C87EB9F89A2}">
                      <ask:lineSketchStyleProps xmlns:ask="http://schemas.microsoft.com/office/drawing/2018/sketchyshapes" sd="1219033472">
                        <a:custGeom>
                          <a:avLst/>
                          <a:gdLst>
                            <a:gd name="connsiteX0" fmla="*/ 0 w 364081"/>
                            <a:gd name="connsiteY0" fmla="*/ 141790 h 283579"/>
                            <a:gd name="connsiteX1" fmla="*/ 182041 w 364081"/>
                            <a:gd name="connsiteY1" fmla="*/ 0 h 283579"/>
                            <a:gd name="connsiteX2" fmla="*/ 364082 w 364081"/>
                            <a:gd name="connsiteY2" fmla="*/ 141790 h 283579"/>
                            <a:gd name="connsiteX3" fmla="*/ 182041 w 364081"/>
                            <a:gd name="connsiteY3" fmla="*/ 283580 h 283579"/>
                            <a:gd name="connsiteX4" fmla="*/ 0 w 364081"/>
                            <a:gd name="connsiteY4" fmla="*/ 141790 h 283579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  <a:cxn ang="0">
                              <a:pos x="connsiteX4" y="connsiteY4"/>
                            </a:cxn>
                          </a:cxnLst>
                          <a:rect l="l" t="t" r="r" b="b"/>
                          <a:pathLst>
                            <a:path w="364081" h="283579" fill="none" extrusionOk="0">
                              <a:moveTo>
                                <a:pt x="0" y="141790"/>
                              </a:moveTo>
                              <a:cubicBezTo>
                                <a:pt x="13613" y="65097"/>
                                <a:pt x="85422" y="-8066"/>
                                <a:pt x="182041" y="0"/>
                              </a:cubicBezTo>
                              <a:cubicBezTo>
                                <a:pt x="274421" y="-1249"/>
                                <a:pt x="359489" y="67806"/>
                                <a:pt x="364082" y="141790"/>
                              </a:cubicBezTo>
                              <a:cubicBezTo>
                                <a:pt x="363114" y="210869"/>
                                <a:pt x="270903" y="299807"/>
                                <a:pt x="182041" y="283580"/>
                              </a:cubicBezTo>
                              <a:cubicBezTo>
                                <a:pt x="84115" y="285042"/>
                                <a:pt x="1934" y="220563"/>
                                <a:pt x="0" y="141790"/>
                              </a:cubicBezTo>
                              <a:close/>
                            </a:path>
                            <a:path w="364081" h="283579" stroke="0" extrusionOk="0">
                              <a:moveTo>
                                <a:pt x="0" y="141790"/>
                              </a:moveTo>
                              <a:cubicBezTo>
                                <a:pt x="-12751" y="55617"/>
                                <a:pt x="72941" y="3214"/>
                                <a:pt x="182041" y="0"/>
                              </a:cubicBezTo>
                              <a:cubicBezTo>
                                <a:pt x="290339" y="1634"/>
                                <a:pt x="348952" y="63963"/>
                                <a:pt x="364082" y="141790"/>
                              </a:cubicBezTo>
                              <a:cubicBezTo>
                                <a:pt x="352353" y="231552"/>
                                <a:pt x="279904" y="298366"/>
                                <a:pt x="182041" y="283580"/>
                              </a:cubicBezTo>
                              <a:cubicBezTo>
                                <a:pt x="68121" y="276258"/>
                                <a:pt x="12696" y="226164"/>
                                <a:pt x="0" y="141790"/>
                              </a:cubicBezTo>
                              <a:close/>
                            </a:path>
                          </a:pathLst>
                        </a:custGeom>
                        <ask:type>
                          <ask:lineSketchNone/>
                        </ask:type>
                      </ask:lineSketchStyleProps>
                    </a:ext>
                  </a:extLst>
                </a:ln>
                <a:effectLst>
                  <a:softEdge rad="12700"/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F2F57F3F-5E0F-77C5-B68D-B9E146DBF353}"/>
                </a:ext>
              </a:extLst>
            </p:cNvPr>
            <p:cNvSpPr txBox="1"/>
            <p:nvPr/>
          </p:nvSpPr>
          <p:spPr>
            <a:xfrm>
              <a:off x="376321" y="1658641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cs typeface="+mn-ea"/>
                  <a:sym typeface="+mn-lt"/>
                </a:rPr>
                <a:t>B</a:t>
              </a:r>
              <a:endParaRPr lang="zh-CN" altLang="en-US" sz="1600" b="1" dirty="0">
                <a:cs typeface="+mn-ea"/>
                <a:sym typeface="+mn-lt"/>
              </a:endParaRPr>
            </a:p>
          </p:txBody>
        </p: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7FC8B8EB-3128-1C45-1C91-D4DB0B0D20E5}"/>
                </a:ext>
              </a:extLst>
            </p:cNvPr>
            <p:cNvGrpSpPr/>
            <p:nvPr/>
          </p:nvGrpSpPr>
          <p:grpSpPr>
            <a:xfrm>
              <a:off x="749112" y="1720196"/>
              <a:ext cx="4791482" cy="978666"/>
              <a:chOff x="894255" y="2547510"/>
              <a:chExt cx="4791482" cy="978666"/>
            </a:xfrm>
          </p:grpSpPr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A70F3EEB-0971-B3DD-B010-CF62EE75D1F1}"/>
                  </a:ext>
                </a:extLst>
              </p:cNvPr>
              <p:cNvSpPr txBox="1"/>
              <p:nvPr/>
            </p:nvSpPr>
            <p:spPr>
              <a:xfrm>
                <a:off x="2064061" y="2547510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d7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822947D0-1387-C22F-80C6-16E7C8AF758C}"/>
                  </a:ext>
                </a:extLst>
              </p:cNvPr>
              <p:cNvSpPr txBox="1"/>
              <p:nvPr/>
            </p:nvSpPr>
            <p:spPr>
              <a:xfrm>
                <a:off x="2778789" y="254751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d10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9DF7BB73-D529-BA46-5067-1EE826F71E97}"/>
                  </a:ext>
                </a:extLst>
              </p:cNvPr>
              <p:cNvSpPr txBox="1"/>
              <p:nvPr/>
            </p:nvSpPr>
            <p:spPr>
              <a:xfrm>
                <a:off x="4350066" y="254751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d18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8CE69781-4364-B3C3-8B90-98C526511A4E}"/>
                  </a:ext>
                </a:extLst>
              </p:cNvPr>
              <p:cNvSpPr txBox="1"/>
              <p:nvPr/>
            </p:nvSpPr>
            <p:spPr>
              <a:xfrm>
                <a:off x="3548666" y="254751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d14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3BA776C9-6588-438F-0C14-10961597B0A0}"/>
                  </a:ext>
                </a:extLst>
              </p:cNvPr>
              <p:cNvSpPr txBox="1"/>
              <p:nvPr/>
            </p:nvSpPr>
            <p:spPr>
              <a:xfrm>
                <a:off x="5109690" y="254751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d22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F97B0E22-9D7C-59AE-19FE-14A258FBCAEA}"/>
                  </a:ext>
                </a:extLst>
              </p:cNvPr>
              <p:cNvSpPr txBox="1"/>
              <p:nvPr/>
            </p:nvSpPr>
            <p:spPr>
              <a:xfrm>
                <a:off x="1340936" y="2547510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cs typeface="+mn-ea"/>
                    <a:sym typeface="+mn-lt"/>
                  </a:rPr>
                  <a:t>d3</a:t>
                </a:r>
                <a:endParaRPr lang="zh-CN" altLang="en-US" sz="1200" dirty="0">
                  <a:cs typeface="+mn-ea"/>
                  <a:sym typeface="+mn-lt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F1502AB7-6195-3121-3D58-576A84FCD878}"/>
                  </a:ext>
                </a:extLst>
              </p:cNvPr>
              <p:cNvSpPr txBox="1"/>
              <p:nvPr/>
            </p:nvSpPr>
            <p:spPr>
              <a:xfrm rot="16200000">
                <a:off x="829654" y="3010813"/>
                <a:ext cx="3754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/>
                  <a:t>IB4</a:t>
                </a:r>
                <a:endParaRPr lang="zh-CN" altLang="en-US" sz="1000" dirty="0"/>
              </a:p>
            </p:txBody>
          </p:sp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0D11938F-44BD-53E8-B8D4-661947450B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11171" y="2806176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68" name="图片 67">
                <a:extLst>
                  <a:ext uri="{FF2B5EF4-FFF2-40B4-BE49-F238E27FC236}">
                    <a16:creationId xmlns:a16="http://schemas.microsoft.com/office/drawing/2014/main" id="{474D05BB-C32C-D9B0-5A92-370783EE61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47882" y="2806176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76" name="图片 75">
                <a:extLst>
                  <a:ext uri="{FF2B5EF4-FFF2-40B4-BE49-F238E27FC236}">
                    <a16:creationId xmlns:a16="http://schemas.microsoft.com/office/drawing/2014/main" id="{9AFF9641-CCFD-9ECD-8EE7-2424BF7FA8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4460" y="2799673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78" name="图片 77">
                <a:extLst>
                  <a:ext uri="{FF2B5EF4-FFF2-40B4-BE49-F238E27FC236}">
                    <a16:creationId xmlns:a16="http://schemas.microsoft.com/office/drawing/2014/main" id="{5B5C30FF-F5C7-BC6F-6561-5D6E9EDC91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37749" y="2796520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80" name="图片 79">
                <a:extLst>
                  <a:ext uri="{FF2B5EF4-FFF2-40B4-BE49-F238E27FC236}">
                    <a16:creationId xmlns:a16="http://schemas.microsoft.com/office/drawing/2014/main" id="{795660E6-8A41-D8E9-02E9-16130485F6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01038" y="2796205"/>
                <a:ext cx="721410" cy="720000"/>
              </a:xfrm>
              <a:prstGeom prst="rect">
                <a:avLst/>
              </a:prstGeom>
            </p:spPr>
          </p:pic>
          <p:pic>
            <p:nvPicPr>
              <p:cNvPr id="86" name="图片 85">
                <a:extLst>
                  <a:ext uri="{FF2B5EF4-FFF2-40B4-BE49-F238E27FC236}">
                    <a16:creationId xmlns:a16="http://schemas.microsoft.com/office/drawing/2014/main" id="{535B8D79-E3C5-4775-597D-C34ACD8171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65737" y="279888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95" name="图片 94">
                <a:extLst>
                  <a:ext uri="{FF2B5EF4-FFF2-40B4-BE49-F238E27FC236}">
                    <a16:creationId xmlns:a16="http://schemas.microsoft.com/office/drawing/2014/main" id="{79D2ECA0-7D7D-8B0B-D4D1-AB7717A8BA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34147" y="2796205"/>
                <a:ext cx="720000" cy="720000"/>
              </a:xfrm>
              <a:prstGeom prst="rect">
                <a:avLst/>
              </a:prstGeom>
            </p:spPr>
          </p:pic>
        </p:grp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C37CE2CC-BF80-21F7-28FA-7E6FC4AB685C}"/>
              </a:ext>
            </a:extLst>
          </p:cNvPr>
          <p:cNvSpPr txBox="1"/>
          <p:nvPr/>
        </p:nvSpPr>
        <p:spPr>
          <a:xfrm>
            <a:off x="372524" y="3066120"/>
            <a:ext cx="5741750" cy="18864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Figure S2. CNV progress after laser treatment.</a:t>
            </a:r>
            <a:endParaRPr lang="zh-CN" altLang="zh-CN" sz="1200" kern="100" dirty="0">
              <a:effectLst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200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(A) Workflow for CNV area analyses on flat-mounted choroid collected at different time points after laser treatment. (B) Representative laser-induced CNV stained with anti-isolectin-B4 (IB4, red) in the mouse eye at different times. Scale bar, 50 </a:t>
            </a:r>
            <a:r>
              <a:rPr lang="en-US" altLang="zh-CN" sz="1200" kern="100" dirty="0" err="1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200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200" kern="100" dirty="0">
              <a:effectLst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28962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文本框 51">
            <a:extLst>
              <a:ext uri="{FF2B5EF4-FFF2-40B4-BE49-F238E27FC236}">
                <a16:creationId xmlns:a16="http://schemas.microsoft.com/office/drawing/2014/main" id="{8AF0478F-E9F9-3FBB-7702-FD63D2B99DA4}"/>
              </a:ext>
            </a:extLst>
          </p:cNvPr>
          <p:cNvSpPr txBox="1"/>
          <p:nvPr/>
        </p:nvSpPr>
        <p:spPr>
          <a:xfrm>
            <a:off x="294826" y="1773968"/>
            <a:ext cx="5986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 b="1">
                <a:cs typeface="+mn-ea"/>
              </a:defRPr>
            </a:lvl1pPr>
          </a:lstStyle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79E232C9-EC1D-B31C-E412-2D0C011291A5}"/>
              </a:ext>
            </a:extLst>
          </p:cNvPr>
          <p:cNvSpPr txBox="1"/>
          <p:nvPr/>
        </p:nvSpPr>
        <p:spPr>
          <a:xfrm>
            <a:off x="294826" y="372751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 b="1">
                <a:cs typeface="+mn-ea"/>
              </a:defRPr>
            </a:lvl1pPr>
          </a:lstStyle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8A36EE0-9B5D-A375-F401-C048C7EFE49C}"/>
              </a:ext>
            </a:extLst>
          </p:cNvPr>
          <p:cNvSpPr txBox="1"/>
          <p:nvPr/>
        </p:nvSpPr>
        <p:spPr>
          <a:xfrm>
            <a:off x="339939" y="45776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A</a:t>
            </a:r>
            <a:endParaRPr lang="zh-CN" altLang="en-US" sz="1600" b="1" dirty="0">
              <a:cs typeface="+mn-ea"/>
              <a:sym typeface="+mn-lt"/>
            </a:endParaRPr>
          </a:p>
        </p:txBody>
      </p:sp>
      <p:pic>
        <p:nvPicPr>
          <p:cNvPr id="79" name="图片 78">
            <a:extLst>
              <a:ext uri="{FF2B5EF4-FFF2-40B4-BE49-F238E27FC236}">
                <a16:creationId xmlns:a16="http://schemas.microsoft.com/office/drawing/2014/main" id="{229FF818-9B29-5066-CC93-A2A3DB2F1F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149" y="511754"/>
            <a:ext cx="6078239" cy="134733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123224C9-DAED-4DC0-68B1-CEFF93D42991}"/>
              </a:ext>
            </a:extLst>
          </p:cNvPr>
          <p:cNvSpPr txBox="1"/>
          <p:nvPr/>
        </p:nvSpPr>
        <p:spPr>
          <a:xfrm>
            <a:off x="122797" y="5307527"/>
            <a:ext cx="6336591" cy="29944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. </a:t>
            </a:r>
            <a:r>
              <a:rPr lang="en-US" altLang="zh-CN" sz="1200" b="1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I</a:t>
            </a:r>
            <a:r>
              <a:rPr lang="en-US" altLang="zh-CN" sz="1200" b="1" dirty="0"/>
              <a:t>nflammation analysis in laser-induced CNV mice with a single AAV-delivered Nme</a:t>
            </a:r>
            <a:r>
              <a:rPr lang="en-US" altLang="zh-CN" sz="1200" b="1" baseline="-25000" dirty="0"/>
              <a:t>2</a:t>
            </a:r>
            <a:r>
              <a:rPr lang="en-US" altLang="zh-CN" sz="1200" b="1" dirty="0"/>
              <a:t>Cas9 targeting </a:t>
            </a:r>
            <a:r>
              <a:rPr lang="en-US" altLang="zh-CN" sz="1200" b="1" i="1" dirty="0"/>
              <a:t>Vegfa </a:t>
            </a:r>
            <a:r>
              <a:rPr lang="en-US" altLang="zh-CN" sz="1200" b="1" dirty="0"/>
              <a:t>treatment.</a:t>
            </a:r>
            <a:endParaRPr lang="zh-CN" altLang="zh-CN" sz="1200" b="1" dirty="0"/>
          </a:p>
          <a:p>
            <a:pPr algn="just">
              <a:lnSpc>
                <a:spcPct val="200000"/>
              </a:lnSpc>
            </a:pP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1200" b="0" dirty="0"/>
              <a:t>Schematic illustration of inflammation and oxidative responses analysis in laser-induced CNV mice. 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(B) Expression of inflammatory factors were 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easured 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y real-time PCR 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in the RPE/choroid complex. Error bars indicate </a:t>
            </a:r>
            <a:r>
              <a:rPr lang="en-US" altLang="zh-CN" sz="12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.e.m.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(n=3). Unpaired Student’s t-tests, **P&lt;0.01; ***P&lt;0.001; ns, not significant. </a:t>
            </a:r>
            <a:r>
              <a:rPr lang="en-US" altLang="zh-CN" sz="1200" kern="100" dirty="0">
                <a:ea typeface="等线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Representative images of laser-induced CNV stained with anti-Cd11b (purple), anti-IB4 antibody (red) in the mouse eyes injected with AAV8-GFP or AAV8-Nme</a:t>
            </a:r>
            <a:r>
              <a:rPr lang="en-US" altLang="zh-CN" sz="1200" kern="100" baseline="-250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9-</a:t>
            </a:r>
            <a:r>
              <a:rPr lang="en-US" altLang="zh-CN" sz="1200" i="1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Vegfa 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(+ 1 x 10</a:t>
            </a:r>
            <a:r>
              <a:rPr lang="en-US" altLang="zh-CN" sz="1200" kern="100" baseline="300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vg AAV8-GFP) (green). Scale bar, 100 </a:t>
            </a:r>
            <a:r>
              <a:rPr lang="en-US" altLang="zh-CN" sz="1200" kern="100" dirty="0" err="1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2B8455A0-ADEF-571A-2DC4-573F34ACC5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149" y="3855926"/>
            <a:ext cx="4641273" cy="1471353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DCB3F02F-5B9E-95EB-5D29-0AB130A75EC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149" y="1902158"/>
            <a:ext cx="1563624" cy="1868424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C25A372E-0B30-23D3-1983-C126C377368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1096" y="1902158"/>
            <a:ext cx="1563624" cy="186842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45CFAE1C-3CB7-3D14-0716-12050C0E4F8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1043" y="1902158"/>
            <a:ext cx="1563624" cy="18684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03157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C1C49C4-A2DF-A55F-FFC3-2165912E2AA6}"/>
              </a:ext>
            </a:extLst>
          </p:cNvPr>
          <p:cNvSpPr txBox="1"/>
          <p:nvPr/>
        </p:nvSpPr>
        <p:spPr>
          <a:xfrm>
            <a:off x="291857" y="3986892"/>
            <a:ext cx="6167531" cy="298972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lnSpc>
                <a:spcPct val="200000"/>
              </a:lnSpc>
              <a:defRPr sz="1200" b="1" kern="100">
                <a:effectLst/>
                <a:ea typeface="等线" panose="02010600030101010101" pitchFamily="2" charset="-122"/>
                <a:cs typeface="Times New Roman" panose="02020603050405020304" pitchFamily="18" charset="0"/>
              </a:defRPr>
            </a:lvl1pPr>
          </a:lstStyle>
          <a:p>
            <a:pPr algn="just">
              <a:lnSpc>
                <a:spcPct val="200000"/>
              </a:lnSpc>
            </a:pPr>
            <a:r>
              <a:rPr lang="en-US" altLang="zh-CN" dirty="0"/>
              <a:t>Figure S4. Oxidative responses analysis in </a:t>
            </a:r>
            <a:r>
              <a:rPr lang="en-US" altLang="zh-CN" sz="1200" b="1" dirty="0"/>
              <a:t>laser-induced CNV mice with a single AAV-delivered Nme</a:t>
            </a:r>
            <a:r>
              <a:rPr lang="en-US" altLang="zh-CN" sz="1200" b="1" baseline="-25000" dirty="0"/>
              <a:t>2</a:t>
            </a:r>
            <a:r>
              <a:rPr lang="en-US" altLang="zh-CN" sz="1200" b="1" dirty="0"/>
              <a:t>Cas9 targeting </a:t>
            </a:r>
            <a:r>
              <a:rPr lang="en-US" altLang="zh-CN" sz="1200" b="1" i="1" dirty="0"/>
              <a:t>Vegfa </a:t>
            </a:r>
            <a:r>
              <a:rPr lang="en-US" altLang="zh-CN" sz="1200" b="1" dirty="0"/>
              <a:t>treatment.</a:t>
            </a:r>
            <a:endParaRPr lang="zh-CN" altLang="zh-CN" sz="1200" b="1" dirty="0"/>
          </a:p>
          <a:p>
            <a:r>
              <a:rPr lang="en-US" altLang="zh-CN" b="0" dirty="0"/>
              <a:t>(A), (B) 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Expression of oxidative responses-associated factors </a:t>
            </a:r>
            <a:r>
              <a:rPr lang="en-US" altLang="zh-CN" sz="1200" b="0" i="1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if1α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b="0" dirty="0">
                <a:latin typeface="Arial" panose="020B0604020202020204" pitchFamily="34" charset="0"/>
              </a:rPr>
              <a:t>and</a:t>
            </a:r>
            <a:r>
              <a:rPr lang="zh-CN" altLang="en-US" b="0" dirty="0">
                <a:latin typeface="Arial" panose="020B0604020202020204" pitchFamily="34" charset="0"/>
              </a:rPr>
              <a:t> </a:t>
            </a:r>
            <a:r>
              <a:rPr lang="en-US" altLang="zh-CN" b="0" i="1" dirty="0">
                <a:latin typeface="Arial" panose="020B0604020202020204" pitchFamily="34" charset="0"/>
              </a:rPr>
              <a:t>Ca9</a:t>
            </a:r>
            <a:r>
              <a:rPr lang="en-US" altLang="zh-CN" b="0" dirty="0">
                <a:latin typeface="Arial" panose="020B0604020202020204" pitchFamily="34" charset="0"/>
              </a:rPr>
              <a:t> 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were </a:t>
            </a:r>
            <a:r>
              <a:rPr lang="en-US" altLang="zh-CN" sz="1200" b="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easured 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by real-time PCR </a:t>
            </a:r>
            <a:r>
              <a:rPr lang="en-US" altLang="zh-CN" sz="1200" b="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in the RPE/choroid complex. Error bars indicate </a:t>
            </a:r>
            <a:r>
              <a:rPr lang="en-US" altLang="zh-CN" sz="1200" b="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.e.m.</a:t>
            </a:r>
            <a:r>
              <a:rPr lang="en-US" altLang="zh-CN" sz="1200" b="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(n=3). Unpaired Student’s t-tests, **P&lt;0.01.</a:t>
            </a:r>
            <a:r>
              <a:rPr lang="en-US" altLang="zh-CN" sz="1200" b="0" kern="100" dirty="0"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b="0" dirty="0"/>
              <a:t>(C)</a:t>
            </a:r>
            <a:r>
              <a:rPr lang="en-US" altLang="zh-CN" sz="1000" b="0" dirty="0">
                <a:latin typeface="Arial" panose="020B0604020202020204" pitchFamily="34" charset="0"/>
              </a:rPr>
              <a:t> 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e images of laser-induced CNV stained with anti-Hif1</a:t>
            </a:r>
            <a:r>
              <a:rPr lang="el-GR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α</a:t>
            </a:r>
            <a:r>
              <a:rPr lang="en-US" altLang="zh-CN" b="0" dirty="0"/>
              <a:t> or 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nti-Ca9 </a:t>
            </a:r>
            <a:r>
              <a:rPr lang="en-US" altLang="zh-CN" b="0" dirty="0"/>
              <a:t>(D)</a:t>
            </a:r>
            <a:r>
              <a:rPr lang="en-US" altLang="zh-CN" b="0" dirty="0">
                <a:latin typeface="Arial" panose="020B0604020202020204" pitchFamily="34" charset="0"/>
              </a:rPr>
              <a:t> (purple)</a:t>
            </a:r>
            <a:r>
              <a:rPr lang="en-US" altLang="zh-CN" b="0" dirty="0"/>
              <a:t> </a:t>
            </a:r>
            <a:r>
              <a:rPr lang="en-US" altLang="zh-CN" b="0" dirty="0">
                <a:latin typeface="Arial" panose="020B0604020202020204" pitchFamily="34" charset="0"/>
              </a:rPr>
              <a:t>anti-IB4 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ntibody (red) in the mouse eyes injected with AAV8-GFP or AAV8-Nme</a:t>
            </a:r>
            <a:r>
              <a:rPr lang="en-US" altLang="zh-CN" sz="1200" b="0" kern="100" baseline="-250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9-</a:t>
            </a:r>
            <a:r>
              <a:rPr lang="en-US" altLang="zh-CN" sz="1200" b="0" i="1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Vegfa 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(+ 1 x 10</a:t>
            </a:r>
            <a:r>
              <a:rPr lang="en-US" altLang="zh-CN" sz="1200" b="0" kern="100" baseline="300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vg AAV8-GFP) (green). Scale bar, 100 </a:t>
            </a:r>
            <a:r>
              <a:rPr lang="en-US" altLang="zh-CN" sz="1200" b="0" kern="100" dirty="0" err="1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200" b="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endParaRPr lang="en-US" altLang="zh-CN" b="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79E232C9-EC1D-B31C-E412-2D0C011291A5}"/>
              </a:ext>
            </a:extLst>
          </p:cNvPr>
          <p:cNvSpPr txBox="1"/>
          <p:nvPr/>
        </p:nvSpPr>
        <p:spPr>
          <a:xfrm>
            <a:off x="291857" y="232718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 b="1">
                <a:cs typeface="+mn-ea"/>
              </a:defRPr>
            </a:lvl1pPr>
          </a:lstStyle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8A36EE0-9B5D-A375-F401-C048C7EFE49C}"/>
              </a:ext>
            </a:extLst>
          </p:cNvPr>
          <p:cNvSpPr txBox="1"/>
          <p:nvPr/>
        </p:nvSpPr>
        <p:spPr>
          <a:xfrm>
            <a:off x="339939" y="45776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A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A5A26DA-61F6-454A-A6B3-D10A4C64C6DA}"/>
              </a:ext>
            </a:extLst>
          </p:cNvPr>
          <p:cNvSpPr txBox="1"/>
          <p:nvPr/>
        </p:nvSpPr>
        <p:spPr>
          <a:xfrm>
            <a:off x="1740728" y="45776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 b="1">
                <a:cs typeface="+mn-ea"/>
              </a:defRPr>
            </a:lvl1pPr>
          </a:lstStyle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AB04A70-FD46-CE78-2943-1F121EB4EB78}"/>
              </a:ext>
            </a:extLst>
          </p:cNvPr>
          <p:cNvSpPr txBox="1"/>
          <p:nvPr/>
        </p:nvSpPr>
        <p:spPr>
          <a:xfrm>
            <a:off x="1737759" y="232718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 b="1">
                <a:cs typeface="+mn-ea"/>
              </a:defRPr>
            </a:lvl1pPr>
          </a:lstStyle>
          <a:p>
            <a:r>
              <a:rPr lang="en-US" altLang="zh-CN" dirty="0"/>
              <a:t>D</a:t>
            </a:r>
            <a:endParaRPr lang="zh-CN" altLang="en-US" dirty="0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BA6CC34E-67F8-6EDA-4209-B624A23585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6527" y="2513879"/>
            <a:ext cx="4721629" cy="1460269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5F6656A6-8B2C-4996-0BA7-A7F396AFD76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6527" y="697657"/>
            <a:ext cx="4641273" cy="1476895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5FFEA7BE-B4BF-C819-B920-B29FCC07794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731" y="2321539"/>
            <a:ext cx="1563624" cy="185928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14DC6408-C94C-D697-DCA4-684C090EFBB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700" y="509199"/>
            <a:ext cx="1563624" cy="18684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49027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B1E016C-8E06-ADF0-8E76-99BBC31002D7}"/>
              </a:ext>
            </a:extLst>
          </p:cNvPr>
          <p:cNvSpPr txBox="1"/>
          <p:nvPr/>
        </p:nvSpPr>
        <p:spPr>
          <a:xfrm>
            <a:off x="295322" y="5540827"/>
            <a:ext cx="6117670" cy="29897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Figure S5. Scotopic and photopic ERG responses of CNV mouse model treated with single AAV-delivered Nme</a:t>
            </a:r>
            <a:r>
              <a:rPr lang="en-US" altLang="zh-CN" sz="1200" b="1" kern="100" baseline="-2500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b="1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Cas9 targeting </a:t>
            </a:r>
            <a:r>
              <a:rPr lang="en-US" altLang="zh-CN" sz="1200" b="1" i="1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Vegfa</a:t>
            </a:r>
            <a:r>
              <a:rPr lang="en-US" altLang="zh-CN" sz="1200" b="1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kern="100" dirty="0">
              <a:effectLst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200" kern="10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(A) Schematic illustration of flash ERG responses </a:t>
            </a:r>
            <a:r>
              <a:rPr lang="en-US" altLang="zh-CN" sz="1200" b="0" dirty="0"/>
              <a:t>records at day 11 post AAV injection </a:t>
            </a:r>
            <a:r>
              <a:rPr lang="en-US" altLang="zh-CN" sz="1200" kern="100" dirty="0">
                <a:ea typeface="等线" panose="02010600030101010101" pitchFamily="2" charset="-122"/>
                <a:cs typeface="Times New Roman" panose="02020603050405020304" pitchFamily="18" charset="0"/>
              </a:rPr>
              <a:t>to evaluate retinal function </a:t>
            </a:r>
            <a:r>
              <a:rPr lang="en-US" altLang="zh-CN" sz="1200" dirty="0"/>
              <a:t>in laser-induced CNV mice</a:t>
            </a:r>
            <a:r>
              <a:rPr lang="en-US" altLang="zh-CN" sz="1200" kern="100" dirty="0">
                <a:ea typeface="等线" panose="02010600030101010101" pitchFamily="2" charset="-122"/>
                <a:cs typeface="Times New Roman" panose="02020603050405020304" pitchFamily="18" charset="0"/>
              </a:rPr>
              <a:t>. There was no significant decrease of a-wave of  scotopic wave (B), b-wave of  scotopic wave (C), b-wave of photopic response (D) and 30 Hz flicker response (E) in AAV-Nme</a:t>
            </a:r>
            <a:r>
              <a:rPr lang="en-US" altLang="zh-CN" sz="1200" kern="100" baseline="-25000" dirty="0"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kern="100" dirty="0">
                <a:ea typeface="等线" panose="02010600030101010101" pitchFamily="2" charset="-122"/>
                <a:cs typeface="Times New Roman" panose="02020603050405020304" pitchFamily="18" charset="0"/>
              </a:rPr>
              <a:t>Cas9-</a:t>
            </a:r>
            <a:r>
              <a:rPr lang="en-US" altLang="zh-CN" sz="1200" i="1" kern="100" dirty="0">
                <a:ea typeface="等线" panose="02010600030101010101" pitchFamily="2" charset="-122"/>
                <a:cs typeface="Times New Roman" panose="02020603050405020304" pitchFamily="18" charset="0"/>
              </a:rPr>
              <a:t>Vegfa</a:t>
            </a:r>
            <a:r>
              <a:rPr lang="en-US" altLang="zh-CN" sz="1200" kern="100" dirty="0">
                <a:ea typeface="等线" panose="02010600030101010101" pitchFamily="2" charset="-122"/>
                <a:cs typeface="Times New Roman" panose="02020603050405020304" pitchFamily="18" charset="0"/>
              </a:rPr>
              <a:t>-g4 (n=10) treated mice, compared to CNV mice without injection (n=7). Error bars indicate </a:t>
            </a:r>
            <a:r>
              <a:rPr lang="en-US" altLang="zh-CN" sz="1200" kern="100" dirty="0" err="1">
                <a:ea typeface="等线" panose="02010600030101010101" pitchFamily="2" charset="-122"/>
                <a:cs typeface="Times New Roman" panose="02020603050405020304" pitchFamily="18" charset="0"/>
              </a:rPr>
              <a:t>s.e.m.</a:t>
            </a:r>
            <a:r>
              <a:rPr lang="en-US" altLang="zh-CN" sz="1200" kern="100" dirty="0"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aired Student’s t-tests, ns, not significant. </a:t>
            </a:r>
            <a:endParaRPr lang="en-US" altLang="zh-CN" sz="1200" kern="100" dirty="0"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D7256F04-3D00-4EA9-6141-1CFFF3668A65}"/>
              </a:ext>
            </a:extLst>
          </p:cNvPr>
          <p:cNvSpPr txBox="1"/>
          <p:nvPr/>
        </p:nvSpPr>
        <p:spPr>
          <a:xfrm>
            <a:off x="414636" y="225922"/>
            <a:ext cx="5986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  <a:sym typeface="+mn-lt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  <a:sym typeface="+mn-lt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FC68A9B-BA28-5FDE-BE07-DD9F89C15454}"/>
              </a:ext>
            </a:extLst>
          </p:cNvPr>
          <p:cNvSpPr txBox="1"/>
          <p:nvPr/>
        </p:nvSpPr>
        <p:spPr>
          <a:xfrm>
            <a:off x="441417" y="1658196"/>
            <a:ext cx="5986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  <a:sym typeface="+mn-lt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  <a:sym typeface="+mn-lt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FEDB61E3-5F62-BC60-6DAC-6F1734DB4A2F}"/>
              </a:ext>
            </a:extLst>
          </p:cNvPr>
          <p:cNvSpPr txBox="1"/>
          <p:nvPr/>
        </p:nvSpPr>
        <p:spPr>
          <a:xfrm>
            <a:off x="2440181" y="1668890"/>
            <a:ext cx="5986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  <a:sym typeface="+mn-lt"/>
              </a:rPr>
              <a:t>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  <a:sym typeface="+mn-lt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47BD67AF-560B-EFDD-519D-A68BFB660BCF}"/>
              </a:ext>
            </a:extLst>
          </p:cNvPr>
          <p:cNvSpPr txBox="1"/>
          <p:nvPr/>
        </p:nvSpPr>
        <p:spPr>
          <a:xfrm>
            <a:off x="432181" y="3619258"/>
            <a:ext cx="5986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  <a:sym typeface="+mn-lt"/>
              </a:rPr>
              <a:t>D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  <a:sym typeface="+mn-lt"/>
            </a:endParaRPr>
          </a:p>
        </p:txBody>
      </p:sp>
      <p:pic>
        <p:nvPicPr>
          <p:cNvPr id="67" name="图片 66">
            <a:extLst>
              <a:ext uri="{FF2B5EF4-FFF2-40B4-BE49-F238E27FC236}">
                <a16:creationId xmlns:a16="http://schemas.microsoft.com/office/drawing/2014/main" id="{839DF8F6-AC77-5FE7-DEBB-AFB717FE4E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176" y="355004"/>
            <a:ext cx="4907328" cy="134944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1BF47D6-E857-0C83-F844-A178FEB82A0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916" y="1674588"/>
            <a:ext cx="1819656" cy="202692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72163221-2FD9-2E99-66B4-65EF1AE9EF7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916" y="3788535"/>
            <a:ext cx="1737360" cy="199644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F18C67FE-F037-D7EB-CCFA-D4F5EDA6DB5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176" y="3788535"/>
            <a:ext cx="1984248" cy="1901952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9B1CB9F8-F043-977D-B398-4EC35891622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176" y="1668890"/>
            <a:ext cx="1764792" cy="2026920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C9701814-6E66-CFE0-329C-FC0A62DEB4F3}"/>
              </a:ext>
            </a:extLst>
          </p:cNvPr>
          <p:cNvSpPr txBox="1"/>
          <p:nvPr/>
        </p:nvSpPr>
        <p:spPr>
          <a:xfrm>
            <a:off x="2440181" y="3619258"/>
            <a:ext cx="5986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  <a:sym typeface="+mn-lt"/>
              </a:rPr>
              <a:t>E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  <a:sym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5693397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矩形 42">
            <a:extLst>
              <a:ext uri="{FF2B5EF4-FFF2-40B4-BE49-F238E27FC236}">
                <a16:creationId xmlns:a16="http://schemas.microsoft.com/office/drawing/2014/main" id="{A13C676F-2A7B-4EC8-9E04-A2621BDADD34}"/>
              </a:ext>
            </a:extLst>
          </p:cNvPr>
          <p:cNvSpPr/>
          <p:nvPr/>
        </p:nvSpPr>
        <p:spPr>
          <a:xfrm>
            <a:off x="855554" y="2967486"/>
            <a:ext cx="3896093" cy="316318"/>
          </a:xfrm>
          <a:prstGeom prst="rect">
            <a:avLst/>
          </a:prstGeom>
          <a:noFill/>
        </p:spPr>
        <p:txBody>
          <a:bodyPr wrap="square" lIns="44751" tIns="22376" rIns="44751" bIns="22376" anchor="ctr" anchorCtr="0">
            <a:noAutofit/>
          </a:bodyPr>
          <a:lstStyle/>
          <a:p>
            <a:endParaRPr lang="zh-CN" altLang="en-US" sz="979" b="1" dirty="0">
              <a:cs typeface="+mn-ea"/>
              <a:sym typeface="+mn-lt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2943BCC1-9A87-4668-9C5C-05A763A231DE}"/>
              </a:ext>
            </a:extLst>
          </p:cNvPr>
          <p:cNvSpPr txBox="1"/>
          <p:nvPr/>
        </p:nvSpPr>
        <p:spPr>
          <a:xfrm>
            <a:off x="517580" y="41357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A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4691497A-630D-4C62-9355-0B8F40DFF404}"/>
              </a:ext>
            </a:extLst>
          </p:cNvPr>
          <p:cNvSpPr txBox="1"/>
          <p:nvPr/>
        </p:nvSpPr>
        <p:spPr>
          <a:xfrm>
            <a:off x="586321" y="179859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D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93325EFB-1BC8-40B5-A88B-8088EE408244}"/>
              </a:ext>
            </a:extLst>
          </p:cNvPr>
          <p:cNvSpPr txBox="1"/>
          <p:nvPr/>
        </p:nvSpPr>
        <p:spPr>
          <a:xfrm>
            <a:off x="2151570" y="41505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B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0B720D83-3945-405F-889C-E1CBE63B11D7}"/>
              </a:ext>
            </a:extLst>
          </p:cNvPr>
          <p:cNvSpPr txBox="1"/>
          <p:nvPr/>
        </p:nvSpPr>
        <p:spPr>
          <a:xfrm>
            <a:off x="2128129" y="179508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E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235" name="文本框 234">
            <a:extLst>
              <a:ext uri="{FF2B5EF4-FFF2-40B4-BE49-F238E27FC236}">
                <a16:creationId xmlns:a16="http://schemas.microsoft.com/office/drawing/2014/main" id="{1256E98D-002B-675B-80E7-0F4200E4D650}"/>
              </a:ext>
            </a:extLst>
          </p:cNvPr>
          <p:cNvSpPr txBox="1"/>
          <p:nvPr/>
        </p:nvSpPr>
        <p:spPr>
          <a:xfrm>
            <a:off x="3576162" y="41862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C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241" name="文本框 240">
            <a:extLst>
              <a:ext uri="{FF2B5EF4-FFF2-40B4-BE49-F238E27FC236}">
                <a16:creationId xmlns:a16="http://schemas.microsoft.com/office/drawing/2014/main" id="{94E943C3-4650-1179-8067-073EF090389C}"/>
              </a:ext>
            </a:extLst>
          </p:cNvPr>
          <p:cNvSpPr txBox="1"/>
          <p:nvPr/>
        </p:nvSpPr>
        <p:spPr>
          <a:xfrm>
            <a:off x="3554032" y="178899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F</a:t>
            </a:r>
            <a:endParaRPr lang="zh-CN" altLang="en-US" sz="1600" b="1" dirty="0">
              <a:cs typeface="+mn-ea"/>
              <a:sym typeface="+mn-lt"/>
            </a:endParaRPr>
          </a:p>
        </p:txBody>
      </p:sp>
      <p:pic>
        <p:nvPicPr>
          <p:cNvPr id="199" name="图片 198">
            <a:extLst>
              <a:ext uri="{FF2B5EF4-FFF2-40B4-BE49-F238E27FC236}">
                <a16:creationId xmlns:a16="http://schemas.microsoft.com/office/drawing/2014/main" id="{68F66A46-8A7F-BFE7-3A6C-5BC03C5B1D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9751" y="638491"/>
            <a:ext cx="2775005" cy="1054562"/>
          </a:xfrm>
          <a:prstGeom prst="rect">
            <a:avLst/>
          </a:prstGeom>
        </p:spPr>
      </p:pic>
      <p:pic>
        <p:nvPicPr>
          <p:cNvPr id="200" name="图片 199">
            <a:extLst>
              <a:ext uri="{FF2B5EF4-FFF2-40B4-BE49-F238E27FC236}">
                <a16:creationId xmlns:a16="http://schemas.microsoft.com/office/drawing/2014/main" id="{A2B6D957-5DE2-C977-4ED3-AF9D3F72DA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59751" y="2081555"/>
            <a:ext cx="2715385" cy="105456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CD034ED-512E-8D2F-614E-C69FCD1FD81C}"/>
              </a:ext>
            </a:extLst>
          </p:cNvPr>
          <p:cNvSpPr txBox="1"/>
          <p:nvPr/>
        </p:nvSpPr>
        <p:spPr>
          <a:xfrm>
            <a:off x="517580" y="3167436"/>
            <a:ext cx="3914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G</a:t>
            </a:r>
            <a:endParaRPr lang="zh-CN" altLang="en-US" sz="1600" b="1" dirty="0">
              <a:cs typeface="+mn-ea"/>
              <a:sym typeface="+mn-lt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65F7390-A710-2C3A-91A0-3E96E0ACF980}"/>
              </a:ext>
            </a:extLst>
          </p:cNvPr>
          <p:cNvSpPr txBox="1"/>
          <p:nvPr/>
        </p:nvSpPr>
        <p:spPr>
          <a:xfrm>
            <a:off x="539724" y="556092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cs typeface="+mn-ea"/>
                <a:sym typeface="+mn-lt"/>
              </a:rPr>
              <a:t>H</a:t>
            </a:r>
            <a:endParaRPr lang="zh-CN" altLang="en-US" sz="1600" b="1" dirty="0">
              <a:cs typeface="+mn-ea"/>
              <a:sym typeface="+mn-lt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64A39E73-B2A2-8D0A-7372-C89E3C97757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2916" y="3517909"/>
            <a:ext cx="3291840" cy="2584704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B7A7CAAF-6953-CE8D-1AE7-B36FB4B99D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997" y="5808656"/>
            <a:ext cx="2549236" cy="2305396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DDAF8C4C-AA88-927E-F9DF-2A9D613E7F1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657" y="3339847"/>
            <a:ext cx="2438400" cy="2283229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D2D3AD08-F14A-34B3-B162-E286BDC9A94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2916" y="6011592"/>
            <a:ext cx="3361944" cy="2584704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A681C4C-532C-B500-17BE-481FD368313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8460" y="444314"/>
            <a:ext cx="1880616" cy="145389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30B2D94-320B-FC01-C25B-941816CEAE8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6936" y="2081555"/>
            <a:ext cx="1883664" cy="134721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A525A7D-626A-4BFF-F68E-F15B8CD51F6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580" y="2003427"/>
            <a:ext cx="1615440" cy="1122218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BD3F8EE5-8340-19B2-B2AF-D1BC3EAA0E9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213" y="505596"/>
            <a:ext cx="1717964" cy="1083425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40502764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71D6173-A4EE-997C-6926-57DB5BF2502A}"/>
              </a:ext>
            </a:extLst>
          </p:cNvPr>
          <p:cNvSpPr txBox="1"/>
          <p:nvPr/>
        </p:nvSpPr>
        <p:spPr>
          <a:xfrm>
            <a:off x="559140" y="781618"/>
            <a:ext cx="5722257" cy="55797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Figure S6. Safety assessment of single AAV-mediated Nme</a:t>
            </a:r>
            <a:r>
              <a:rPr lang="en-US" altLang="zh-CN" sz="1200" b="1" kern="1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9 targeting </a:t>
            </a:r>
            <a:r>
              <a:rPr lang="en-US" altLang="zh-CN" sz="12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if1α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2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Vegfr2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in vivo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(A) T7E1 assay showed the cleavage efficiency of AAV8-Nme</a:t>
            </a:r>
            <a:r>
              <a:rPr lang="en-US" altLang="zh-CN" sz="1200" kern="1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9 with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if1α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 in the RPE cell genome of treated mice. Mice that received GFP served as the negative control. +, represented an individual sample.</a:t>
            </a:r>
            <a:r>
              <a:rPr lang="en-US" altLang="zh-CN" sz="1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(B) Indel frequency at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if1α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 site is measured through targeted deep sequencing. Samples with reads over 10,000 were calculated. Error bars indicate </a:t>
            </a:r>
            <a:r>
              <a:rPr lang="en-US" altLang="zh-CN" sz="12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.e.m.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(GFP, n = 4;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if1α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, n </a:t>
            </a:r>
            <a:r>
              <a:rPr lang="zh-CN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≥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11). Unpaired Student’s t-tests, **P&lt;0.01, ***P&lt;0.001. (C) The indel profile induced by Nme</a:t>
            </a:r>
            <a:r>
              <a:rPr lang="en-US" altLang="zh-CN" sz="1200" kern="1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9 with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if1α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  in the genomes of mouse RPE cells. The frequencies of the top 8 were analyzed. +, insertion; –, deletion. (D-F) The same as A-C with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Vegfr2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 substitutes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if1α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. (G, H) The indel ratio of predicted off-target sites in the mouse RPE cells genomes that received AAV8 (9 </a:t>
            </a:r>
            <a:r>
              <a:rPr lang="en-US" altLang="zh-CN" sz="1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x 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VG Nme</a:t>
            </a:r>
            <a:r>
              <a:rPr lang="en-US" altLang="zh-CN" sz="1200" kern="100" baseline="-25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s9 with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if1α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 or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Vegfr2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 + 1</a:t>
            </a:r>
            <a:r>
              <a:rPr lang="en-US" altLang="zh-CN" sz="12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 x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10</a:t>
            </a:r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VG GFP) treatment (GFP, n = 4;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Hif1α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, n = 12; </a:t>
            </a:r>
            <a:r>
              <a:rPr lang="en-US" altLang="zh-CN" sz="12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Vegfr2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-g3, n=9) revealed by targeted deep sequencing. ns, not significant. 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82702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0230BD0C-6432-FAAD-BC72-7CDB7922E71F}"/>
              </a:ext>
            </a:extLst>
          </p:cNvPr>
          <p:cNvSpPr txBox="1"/>
          <p:nvPr/>
        </p:nvSpPr>
        <p:spPr>
          <a:xfrm>
            <a:off x="286034" y="451847"/>
            <a:ext cx="504396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US" altLang="zh-CN" b="1" dirty="0"/>
              <a:t>Supplementary Table S1. List of gRNAs. </a:t>
            </a: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CFAE3260-F0ED-0DC5-AEB6-7D50B90873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3732586"/>
              </p:ext>
            </p:extLst>
          </p:nvPr>
        </p:nvGraphicFramePr>
        <p:xfrm>
          <a:off x="427762" y="955537"/>
          <a:ext cx="5679834" cy="2459990"/>
        </p:xfrm>
        <a:graphic>
          <a:graphicData uri="http://schemas.openxmlformats.org/drawingml/2006/table">
            <a:tbl>
              <a:tblPr/>
              <a:tblGrid>
                <a:gridCol w="1540186">
                  <a:extLst>
                    <a:ext uri="{9D8B030D-6E8A-4147-A177-3AD203B41FA5}">
                      <a16:colId xmlns:a16="http://schemas.microsoft.com/office/drawing/2014/main" val="1132137575"/>
                    </a:ext>
                  </a:extLst>
                </a:gridCol>
                <a:gridCol w="4139648">
                  <a:extLst>
                    <a:ext uri="{9D8B030D-6E8A-4147-A177-3AD203B41FA5}">
                      <a16:colId xmlns:a16="http://schemas.microsoft.com/office/drawing/2014/main" val="2730680665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ctr"/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-gRNA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pacer sequence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105708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1</a:t>
                      </a:r>
                      <a:r>
                        <a:rPr lang="el-GR" sz="1200" i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l-GR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1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GAGGAATGGGTTCACAAATC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713737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1</a:t>
                      </a:r>
                      <a:r>
                        <a:rPr lang="el-GR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l-GR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2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TGAGTTTCAACCCAGACATA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026681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1</a:t>
                      </a:r>
                      <a:r>
                        <a:rPr lang="el-GR" sz="1200" i="1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l-GR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3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GCTTGAGTTTCAACCCAGAC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669846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1</a:t>
                      </a:r>
                      <a:r>
                        <a:rPr lang="el-GR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l-GR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4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TATGACAGTTGCTTGAGTTT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572233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a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1 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CGAGCCCCGACCCCCTCCAC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157212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a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2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GTTCGTTTAACTCAAGCTGC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284678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a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3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CGGGGTACTCCTGGAAGATG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915665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a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4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CCTGGTGGACATCTTCCAGG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895835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r2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1 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GCCTCAATCACTTGGCCGAA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629624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r2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2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CAAACTTGCAGAATTCCACA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253537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r2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3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TGAGATGCTCCAAGGTCAGG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318997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r2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4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GGAGCATCTCATCTGTTACA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40439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04673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7609556D-DF66-FA54-EDB1-8BB445C6B0A5}"/>
              </a:ext>
            </a:extLst>
          </p:cNvPr>
          <p:cNvSpPr txBox="1"/>
          <p:nvPr/>
        </p:nvSpPr>
        <p:spPr>
          <a:xfrm>
            <a:off x="338603" y="235831"/>
            <a:ext cx="479945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US" altLang="zh-CN" b="1" dirty="0"/>
              <a:t>Supplementary Table S2. List of primers. </a:t>
            </a: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0E40351D-E285-3407-B10E-274D165CBD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1270832"/>
              </p:ext>
            </p:extLst>
          </p:nvPr>
        </p:nvGraphicFramePr>
        <p:xfrm>
          <a:off x="393033" y="751875"/>
          <a:ext cx="5844482" cy="4281096"/>
        </p:xfrm>
        <a:graphic>
          <a:graphicData uri="http://schemas.openxmlformats.org/drawingml/2006/table">
            <a:tbl>
              <a:tblPr/>
              <a:tblGrid>
                <a:gridCol w="1496564">
                  <a:extLst>
                    <a:ext uri="{9D8B030D-6E8A-4147-A177-3AD203B41FA5}">
                      <a16:colId xmlns:a16="http://schemas.microsoft.com/office/drawing/2014/main" val="1399654259"/>
                    </a:ext>
                  </a:extLst>
                </a:gridCol>
                <a:gridCol w="2074378">
                  <a:extLst>
                    <a:ext uri="{9D8B030D-6E8A-4147-A177-3AD203B41FA5}">
                      <a16:colId xmlns:a16="http://schemas.microsoft.com/office/drawing/2014/main" val="348270706"/>
                    </a:ext>
                  </a:extLst>
                </a:gridCol>
                <a:gridCol w="2273540">
                  <a:extLst>
                    <a:ext uri="{9D8B030D-6E8A-4147-A177-3AD203B41FA5}">
                      <a16:colId xmlns:a16="http://schemas.microsoft.com/office/drawing/2014/main" val="2033655987"/>
                    </a:ext>
                  </a:extLst>
                </a:gridCol>
              </a:tblGrid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b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escription 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orward 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b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verse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0994176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1</a:t>
                      </a:r>
                      <a:r>
                        <a:rPr lang="el-GR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l-GR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1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TCTTTCCAGCTCCCCTTACC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GACCAAAACTGTTGCCTACTC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6523420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1</a:t>
                      </a:r>
                      <a:r>
                        <a:rPr lang="el-GR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l-GR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2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ATACCAGTACCCCTACCTACC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GCCTCAAGAAACTGAACTAGG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9540198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a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1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CCTCAAATCACTTCGGATTGT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GGTGGAGGTACAGCAGTAAAG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6025959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a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2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GAAGAGTCAAGGTGTGTTGTG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GGTTTTAACACTTGCACCAA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5307910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a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3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TGTTTGGTGTGGAGCTGTAAG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GTTCTCCCAGAGAAAGAGAAG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4956703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r2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1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GGATCCAGATGAATTGCCCTT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ATTGTGCAAGTTAGCCCTTGT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4072474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r2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2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GGGAGTTGGTGTTGTATGAGT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AGGAGTCTATGGTCTCGGAGT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4916765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r2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3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TGGGTTCATGGGAAAAGAACA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CTCAGTGGGACACTTAAAAGA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5118644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f1</a:t>
                      </a:r>
                      <a:r>
                        <a:rPr lang="el-GR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l-GR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3-ontarget-DS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CCTCACAAAAGTGTCTCCTCC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TAAAGGACAAGTCACCACAGG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2943611"/>
                  </a:ext>
                </a:extLst>
              </a:tr>
              <a:tr h="163424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a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4</a:t>
                      </a:r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-DS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ACACAGTGATCAAGTTCATGG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TCACCCTCAACCCCAATTTAG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9229113"/>
                  </a:ext>
                </a:extLst>
              </a:tr>
              <a:tr h="320611">
                <a:tc>
                  <a:txBody>
                    <a:bodyPr/>
                    <a:lstStyle/>
                    <a:p>
                      <a:pPr algn="just"/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Vegfr2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g3</a:t>
                      </a:r>
                      <a:r>
                        <a:rPr lang="en-US" sz="1200" i="1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target-DS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CTTAGAAGCAGAGCTACGGAC</a:t>
                      </a:r>
                      <a:endParaRPr lang="zh-CN" sz="12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CCCTCAGTGGGACACTTAAAA</a:t>
                      </a:r>
                      <a:endParaRPr lang="zh-CN" sz="12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238" marR="6238" marT="623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02111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9208104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SLIDE.ICON" val="#134038;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4qkctisj">
      <a:majorFont>
        <a:latin typeface="Arial" panose="020F0302020204030204"/>
        <a:ea typeface="微软雅黑"/>
        <a:cs typeface=""/>
      </a:majorFont>
      <a:minorFont>
        <a:latin typeface="Arial" panose="020F0502020204030204"/>
        <a:ea typeface="微软雅黑"/>
        <a:cs typeface="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749</TotalTime>
  <Words>1355</Words>
  <Application>Microsoft Office PowerPoint</Application>
  <PresentationFormat>自定义</PresentationFormat>
  <Paragraphs>407</Paragraphs>
  <Slides>10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3" baseType="lpstr">
      <vt:lpstr>等线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胡 思慧</dc:creator>
  <cp:lastModifiedBy>思慧 胡</cp:lastModifiedBy>
  <cp:revision>599</cp:revision>
  <cp:lastPrinted>2022-09-30T01:46:00Z</cp:lastPrinted>
  <dcterms:created xsi:type="dcterms:W3CDTF">2022-02-18T01:43:53Z</dcterms:created>
  <dcterms:modified xsi:type="dcterms:W3CDTF">2023-07-14T01:10:41Z</dcterms:modified>
</cp:coreProperties>
</file>